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57" r:id="rId3"/>
    <p:sldId id="262" r:id="rId4"/>
    <p:sldId id="267" r:id="rId5"/>
    <p:sldId id="265" r:id="rId6"/>
    <p:sldId id="266" r:id="rId7"/>
    <p:sldId id="268" r:id="rId8"/>
    <p:sldId id="271" r:id="rId9"/>
    <p:sldId id="264" r:id="rId10"/>
    <p:sldId id="272" r:id="rId11"/>
  </p:sldIdLst>
  <p:sldSz cx="6858000" cy="9906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D085DC7-27BE-49ED-AA59-AC68119ECF15}" v="83" dt="2024-04-01T18:51:34.97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96" d="100"/>
          <a:sy n="196" d="100"/>
        </p:scale>
        <p:origin x="77" y="11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atil, Gunvant" userId="S::gunvant.patil@ttu.edu::bab2d81c-cb5c-4d5f-9d4d-9ec0ed5664f1" providerId="AD" clId="Web-{2ABA6450-3F9B-C74D-7B5D-EE34994DF3E5}"/>
    <pc:docChg chg="modSld">
      <pc:chgData name="Patil, Gunvant" userId="S::gunvant.patil@ttu.edu::bab2d81c-cb5c-4d5f-9d4d-9ec0ed5664f1" providerId="AD" clId="Web-{2ABA6450-3F9B-C74D-7B5D-EE34994DF3E5}" dt="2023-10-06T22:06:27.209" v="9"/>
      <pc:docMkLst>
        <pc:docMk/>
      </pc:docMkLst>
      <pc:sldChg chg="addSp modSp">
        <pc:chgData name="Patil, Gunvant" userId="S::gunvant.patil@ttu.edu::bab2d81c-cb5c-4d5f-9d4d-9ec0ed5664f1" providerId="AD" clId="Web-{2ABA6450-3F9B-C74D-7B5D-EE34994DF3E5}" dt="2023-10-06T22:06:27.209" v="9"/>
        <pc:sldMkLst>
          <pc:docMk/>
          <pc:sldMk cId="2353496295" sldId="257"/>
        </pc:sldMkLst>
        <pc:spChg chg="add mod">
          <ac:chgData name="Patil, Gunvant" userId="S::gunvant.patil@ttu.edu::bab2d81c-cb5c-4d5f-9d4d-9ec0ed5664f1" providerId="AD" clId="Web-{2ABA6450-3F9B-C74D-7B5D-EE34994DF3E5}" dt="2023-10-06T22:06:27.209" v="9"/>
          <ac:spMkLst>
            <pc:docMk/>
            <pc:sldMk cId="2353496295" sldId="257"/>
            <ac:spMk id="3" creationId="{ABF8712E-97DE-29CA-BB48-754C302D7322}"/>
          </ac:spMkLst>
        </pc:spChg>
        <pc:picChg chg="add mod">
          <ac:chgData name="Patil, Gunvant" userId="S::gunvant.patil@ttu.edu::bab2d81c-cb5c-4d5f-9d4d-9ec0ed5664f1" providerId="AD" clId="Web-{2ABA6450-3F9B-C74D-7B5D-EE34994DF3E5}" dt="2023-10-06T22:06:11.489" v="7" actId="1076"/>
          <ac:picMkLst>
            <pc:docMk/>
            <pc:sldMk cId="2353496295" sldId="257"/>
            <ac:picMk id="2" creationId="{DEE854A1-0563-9309-ED10-743F7D57F25A}"/>
          </ac:picMkLst>
        </pc:picChg>
        <pc:picChg chg="mod">
          <ac:chgData name="Patil, Gunvant" userId="S::gunvant.patil@ttu.edu::bab2d81c-cb5c-4d5f-9d4d-9ec0ed5664f1" providerId="AD" clId="Web-{2ABA6450-3F9B-C74D-7B5D-EE34994DF3E5}" dt="2023-10-06T22:04:24.673" v="3" actId="14100"/>
          <ac:picMkLst>
            <pc:docMk/>
            <pc:sldMk cId="2353496295" sldId="257"/>
            <ac:picMk id="7" creationId="{E389C274-F48A-AD44-02D3-D878D9D08361}"/>
          </ac:picMkLst>
        </pc:picChg>
      </pc:sldChg>
    </pc:docChg>
  </pc:docChgLst>
  <pc:docChgLst>
    <pc:chgData name="Devkar, Vikas" userId="acbd15ec-55d1-4a76-83ac-3f1d82711ed5" providerId="ADAL" clId="{13979A4D-164F-4D95-AB4A-280FAF3364F0}"/>
    <pc:docChg chg="undo custSel addSld delSld modSld sldOrd">
      <pc:chgData name="Devkar, Vikas" userId="acbd15ec-55d1-4a76-83ac-3f1d82711ed5" providerId="ADAL" clId="{13979A4D-164F-4D95-AB4A-280FAF3364F0}" dt="2023-12-14T22:12:47.587" v="88" actId="1076"/>
      <pc:docMkLst>
        <pc:docMk/>
      </pc:docMkLst>
      <pc:sldChg chg="addSp modSp mod">
        <pc:chgData name="Devkar, Vikas" userId="acbd15ec-55d1-4a76-83ac-3f1d82711ed5" providerId="ADAL" clId="{13979A4D-164F-4D95-AB4A-280FAF3364F0}" dt="2023-12-14T16:51:14.029" v="6" actId="1076"/>
        <pc:sldMkLst>
          <pc:docMk/>
          <pc:sldMk cId="1604500440" sldId="256"/>
        </pc:sldMkLst>
        <pc:picChg chg="add mod">
          <ac:chgData name="Devkar, Vikas" userId="acbd15ec-55d1-4a76-83ac-3f1d82711ed5" providerId="ADAL" clId="{13979A4D-164F-4D95-AB4A-280FAF3364F0}" dt="2023-12-14T16:51:14.029" v="6" actId="1076"/>
          <ac:picMkLst>
            <pc:docMk/>
            <pc:sldMk cId="1604500440" sldId="256"/>
            <ac:picMk id="11" creationId="{A6986DA1-314A-E91E-075A-19EEB0C13E02}"/>
          </ac:picMkLst>
        </pc:picChg>
      </pc:sldChg>
      <pc:sldChg chg="modSp mod">
        <pc:chgData name="Devkar, Vikas" userId="acbd15ec-55d1-4a76-83ac-3f1d82711ed5" providerId="ADAL" clId="{13979A4D-164F-4D95-AB4A-280FAF3364F0}" dt="2023-12-14T22:12:47.587" v="88" actId="1076"/>
        <pc:sldMkLst>
          <pc:docMk/>
          <pc:sldMk cId="2353496295" sldId="257"/>
        </pc:sldMkLst>
        <pc:picChg chg="mod">
          <ac:chgData name="Devkar, Vikas" userId="acbd15ec-55d1-4a76-83ac-3f1d82711ed5" providerId="ADAL" clId="{13979A4D-164F-4D95-AB4A-280FAF3364F0}" dt="2023-12-14T22:12:47.587" v="88" actId="1076"/>
          <ac:picMkLst>
            <pc:docMk/>
            <pc:sldMk cId="2353496295" sldId="257"/>
            <ac:picMk id="5" creationId="{BC4B593B-F9F9-3162-DCA4-E49944D47FA7}"/>
          </ac:picMkLst>
        </pc:picChg>
        <pc:picChg chg="mod">
          <ac:chgData name="Devkar, Vikas" userId="acbd15ec-55d1-4a76-83ac-3f1d82711ed5" providerId="ADAL" clId="{13979A4D-164F-4D95-AB4A-280FAF3364F0}" dt="2023-12-14T22:12:44.446" v="87" actId="1076"/>
          <ac:picMkLst>
            <pc:docMk/>
            <pc:sldMk cId="2353496295" sldId="257"/>
            <ac:picMk id="7" creationId="{E389C274-F48A-AD44-02D3-D878D9D08361}"/>
          </ac:picMkLst>
        </pc:picChg>
      </pc:sldChg>
      <pc:sldChg chg="modSp del mod">
        <pc:chgData name="Devkar, Vikas" userId="acbd15ec-55d1-4a76-83ac-3f1d82711ed5" providerId="ADAL" clId="{13979A4D-164F-4D95-AB4A-280FAF3364F0}" dt="2023-12-14T17:11:12.019" v="84" actId="47"/>
        <pc:sldMkLst>
          <pc:docMk/>
          <pc:sldMk cId="2724004559" sldId="259"/>
        </pc:sldMkLst>
        <pc:spChg chg="mod">
          <ac:chgData name="Devkar, Vikas" userId="acbd15ec-55d1-4a76-83ac-3f1d82711ed5" providerId="ADAL" clId="{13979A4D-164F-4D95-AB4A-280FAF3364F0}" dt="2023-12-14T17:10:43.868" v="83" actId="20577"/>
          <ac:spMkLst>
            <pc:docMk/>
            <pc:sldMk cId="2724004559" sldId="259"/>
            <ac:spMk id="5" creationId="{D31E9A7E-14EA-8184-03C5-36B66190F713}"/>
          </ac:spMkLst>
        </pc:spChg>
      </pc:sldChg>
      <pc:sldChg chg="addSp delSp modSp mod">
        <pc:chgData name="Devkar, Vikas" userId="acbd15ec-55d1-4a76-83ac-3f1d82711ed5" providerId="ADAL" clId="{13979A4D-164F-4D95-AB4A-280FAF3364F0}" dt="2023-12-14T17:10:22.803" v="82" actId="20577"/>
        <pc:sldMkLst>
          <pc:docMk/>
          <pc:sldMk cId="1845444862" sldId="265"/>
        </pc:sldMkLst>
        <pc:spChg chg="add mod">
          <ac:chgData name="Devkar, Vikas" userId="acbd15ec-55d1-4a76-83ac-3f1d82711ed5" providerId="ADAL" clId="{13979A4D-164F-4D95-AB4A-280FAF3364F0}" dt="2023-12-14T17:00:55.809" v="50" actId="1076"/>
          <ac:spMkLst>
            <pc:docMk/>
            <pc:sldMk cId="1845444862" sldId="265"/>
            <ac:spMk id="3" creationId="{0E1FCA99-A517-63DD-2962-C2E0926CFB1B}"/>
          </ac:spMkLst>
        </pc:spChg>
        <pc:spChg chg="mod">
          <ac:chgData name="Devkar, Vikas" userId="acbd15ec-55d1-4a76-83ac-3f1d82711ed5" providerId="ADAL" clId="{13979A4D-164F-4D95-AB4A-280FAF3364F0}" dt="2023-12-14T17:10:22.803" v="82" actId="20577"/>
          <ac:spMkLst>
            <pc:docMk/>
            <pc:sldMk cId="1845444862" sldId="265"/>
            <ac:spMk id="4" creationId="{47E1C263-20BF-3010-7C86-6DDDAB808C91}"/>
          </ac:spMkLst>
        </pc:spChg>
        <pc:spChg chg="add del">
          <ac:chgData name="Devkar, Vikas" userId="acbd15ec-55d1-4a76-83ac-3f1d82711ed5" providerId="ADAL" clId="{13979A4D-164F-4D95-AB4A-280FAF3364F0}" dt="2023-12-14T17:00:39.368" v="45" actId="21"/>
          <ac:spMkLst>
            <pc:docMk/>
            <pc:sldMk cId="1845444862" sldId="265"/>
            <ac:spMk id="12" creationId="{54C6866A-4D9A-CF72-6520-DF457DD15155}"/>
          </ac:spMkLst>
        </pc:spChg>
        <pc:picChg chg="add mod">
          <ac:chgData name="Devkar, Vikas" userId="acbd15ec-55d1-4a76-83ac-3f1d82711ed5" providerId="ADAL" clId="{13979A4D-164F-4D95-AB4A-280FAF3364F0}" dt="2023-12-14T17:00:55.809" v="50" actId="1076"/>
          <ac:picMkLst>
            <pc:docMk/>
            <pc:sldMk cId="1845444862" sldId="265"/>
            <ac:picMk id="2" creationId="{28FBD11A-D19F-DB78-8829-8C8157B0FAFF}"/>
          </ac:picMkLst>
        </pc:picChg>
        <pc:picChg chg="mod">
          <ac:chgData name="Devkar, Vikas" userId="acbd15ec-55d1-4a76-83ac-3f1d82711ed5" providerId="ADAL" clId="{13979A4D-164F-4D95-AB4A-280FAF3364F0}" dt="2023-12-14T17:09:33.727" v="73" actId="1076"/>
          <ac:picMkLst>
            <pc:docMk/>
            <pc:sldMk cId="1845444862" sldId="265"/>
            <ac:picMk id="6" creationId="{8918A5F2-2F5A-933D-0122-EE33CC2DE2E0}"/>
          </ac:picMkLst>
        </pc:picChg>
        <pc:picChg chg="add del">
          <ac:chgData name="Devkar, Vikas" userId="acbd15ec-55d1-4a76-83ac-3f1d82711ed5" providerId="ADAL" clId="{13979A4D-164F-4D95-AB4A-280FAF3364F0}" dt="2023-12-14T17:00:39.368" v="45" actId="21"/>
          <ac:picMkLst>
            <pc:docMk/>
            <pc:sldMk cId="1845444862" sldId="265"/>
            <ac:picMk id="8" creationId="{50916439-AA5B-9CE4-DD0A-76378ADBB3D3}"/>
          </ac:picMkLst>
        </pc:picChg>
      </pc:sldChg>
      <pc:sldChg chg="addSp delSp modSp mod">
        <pc:chgData name="Devkar, Vikas" userId="acbd15ec-55d1-4a76-83ac-3f1d82711ed5" providerId="ADAL" clId="{13979A4D-164F-4D95-AB4A-280FAF3364F0}" dt="2023-12-14T17:09:53.698" v="77" actId="1076"/>
        <pc:sldMkLst>
          <pc:docMk/>
          <pc:sldMk cId="417503466" sldId="266"/>
        </pc:sldMkLst>
        <pc:spChg chg="add del mod">
          <ac:chgData name="Devkar, Vikas" userId="acbd15ec-55d1-4a76-83ac-3f1d82711ed5" providerId="ADAL" clId="{13979A4D-164F-4D95-AB4A-280FAF3364F0}" dt="2023-12-14T17:00:26.521" v="42"/>
          <ac:spMkLst>
            <pc:docMk/>
            <pc:sldMk cId="417503466" sldId="266"/>
            <ac:spMk id="3" creationId="{2B4F4504-8C9B-BCC4-A9CD-5C5619E25171}"/>
          </ac:spMkLst>
        </pc:spChg>
        <pc:spChg chg="mod">
          <ac:chgData name="Devkar, Vikas" userId="acbd15ec-55d1-4a76-83ac-3f1d82711ed5" providerId="ADAL" clId="{13979A4D-164F-4D95-AB4A-280FAF3364F0}" dt="2023-12-14T17:09:46.695" v="76" actId="20577"/>
          <ac:spMkLst>
            <pc:docMk/>
            <pc:sldMk cId="417503466" sldId="266"/>
            <ac:spMk id="4" creationId="{F1480AE0-CD30-03E5-6124-496AC4D0B0E4}"/>
          </ac:spMkLst>
        </pc:spChg>
        <pc:spChg chg="add mod">
          <ac:chgData name="Devkar, Vikas" userId="acbd15ec-55d1-4a76-83ac-3f1d82711ed5" providerId="ADAL" clId="{13979A4D-164F-4D95-AB4A-280FAF3364F0}" dt="2023-12-14T17:09:53.698" v="77" actId="1076"/>
          <ac:spMkLst>
            <pc:docMk/>
            <pc:sldMk cId="417503466" sldId="266"/>
            <ac:spMk id="7" creationId="{E1BDD04C-A68A-4796-F239-C8C2E0278FBB}"/>
          </ac:spMkLst>
        </pc:spChg>
        <pc:spChg chg="del">
          <ac:chgData name="Devkar, Vikas" userId="acbd15ec-55d1-4a76-83ac-3f1d82711ed5" providerId="ADAL" clId="{13979A4D-164F-4D95-AB4A-280FAF3364F0}" dt="2023-12-14T17:00:48.994" v="48" actId="21"/>
          <ac:spMkLst>
            <pc:docMk/>
            <pc:sldMk cId="417503466" sldId="266"/>
            <ac:spMk id="8" creationId="{D36503D7-132C-39CD-53DB-B3BB8DCA3639}"/>
          </ac:spMkLst>
        </pc:spChg>
        <pc:spChg chg="del">
          <ac:chgData name="Devkar, Vikas" userId="acbd15ec-55d1-4a76-83ac-3f1d82711ed5" providerId="ADAL" clId="{13979A4D-164F-4D95-AB4A-280FAF3364F0}" dt="2023-12-14T17:09:42.906" v="75" actId="21"/>
          <ac:spMkLst>
            <pc:docMk/>
            <pc:sldMk cId="417503466" sldId="266"/>
            <ac:spMk id="9" creationId="{E4FCE9ED-458C-89A0-6A93-F0531AFB0573}"/>
          </ac:spMkLst>
        </pc:spChg>
        <pc:picChg chg="add del mod">
          <ac:chgData name="Devkar, Vikas" userId="acbd15ec-55d1-4a76-83ac-3f1d82711ed5" providerId="ADAL" clId="{13979A4D-164F-4D95-AB4A-280FAF3364F0}" dt="2023-12-14T17:00:26.521" v="42"/>
          <ac:picMkLst>
            <pc:docMk/>
            <pc:sldMk cId="417503466" sldId="266"/>
            <ac:picMk id="2" creationId="{9F6CD163-C2A7-961A-892A-48244255ED64}"/>
          </ac:picMkLst>
        </pc:picChg>
        <pc:picChg chg="add mod">
          <ac:chgData name="Devkar, Vikas" userId="acbd15ec-55d1-4a76-83ac-3f1d82711ed5" providerId="ADAL" clId="{13979A4D-164F-4D95-AB4A-280FAF3364F0}" dt="2023-12-14T17:09:53.698" v="77" actId="1076"/>
          <ac:picMkLst>
            <pc:docMk/>
            <pc:sldMk cId="417503466" sldId="266"/>
            <ac:picMk id="5" creationId="{A6141967-F6D9-7A68-3840-66656DA838B0}"/>
          </ac:picMkLst>
        </pc:picChg>
        <pc:picChg chg="del mod">
          <ac:chgData name="Devkar, Vikas" userId="acbd15ec-55d1-4a76-83ac-3f1d82711ed5" providerId="ADAL" clId="{13979A4D-164F-4D95-AB4A-280FAF3364F0}" dt="2023-12-14T17:00:48.994" v="48" actId="21"/>
          <ac:picMkLst>
            <pc:docMk/>
            <pc:sldMk cId="417503466" sldId="266"/>
            <ac:picMk id="6" creationId="{3F801622-1A5B-9E90-6B09-EBE70D3390BA}"/>
          </ac:picMkLst>
        </pc:picChg>
        <pc:picChg chg="del mod">
          <ac:chgData name="Devkar, Vikas" userId="acbd15ec-55d1-4a76-83ac-3f1d82711ed5" providerId="ADAL" clId="{13979A4D-164F-4D95-AB4A-280FAF3364F0}" dt="2023-12-14T17:09:42.906" v="75" actId="21"/>
          <ac:picMkLst>
            <pc:docMk/>
            <pc:sldMk cId="417503466" sldId="266"/>
            <ac:picMk id="11" creationId="{0B365F18-644F-B994-95E9-E7CC3C848636}"/>
          </ac:picMkLst>
        </pc:picChg>
      </pc:sldChg>
      <pc:sldChg chg="modSp mod ord">
        <pc:chgData name="Devkar, Vikas" userId="acbd15ec-55d1-4a76-83ac-3f1d82711ed5" providerId="ADAL" clId="{13979A4D-164F-4D95-AB4A-280FAF3364F0}" dt="2023-12-14T17:02:24.330" v="58"/>
        <pc:sldMkLst>
          <pc:docMk/>
          <pc:sldMk cId="1922289499" sldId="267"/>
        </pc:sldMkLst>
        <pc:spChg chg="mod">
          <ac:chgData name="Devkar, Vikas" userId="acbd15ec-55d1-4a76-83ac-3f1d82711ed5" providerId="ADAL" clId="{13979A4D-164F-4D95-AB4A-280FAF3364F0}" dt="2023-12-14T17:02:12.712" v="52" actId="20577"/>
          <ac:spMkLst>
            <pc:docMk/>
            <pc:sldMk cId="1922289499" sldId="267"/>
            <ac:spMk id="8" creationId="{A373B488-B0CF-2144-1213-219AA7C07B87}"/>
          </ac:spMkLst>
        </pc:spChg>
      </pc:sldChg>
      <pc:sldChg chg="modSp mod">
        <pc:chgData name="Devkar, Vikas" userId="acbd15ec-55d1-4a76-83ac-3f1d82711ed5" providerId="ADAL" clId="{13979A4D-164F-4D95-AB4A-280FAF3364F0}" dt="2023-12-14T16:51:49.293" v="9" actId="1076"/>
        <pc:sldMkLst>
          <pc:docMk/>
          <pc:sldMk cId="3436963830" sldId="268"/>
        </pc:sldMkLst>
        <pc:spChg chg="mod">
          <ac:chgData name="Devkar, Vikas" userId="acbd15ec-55d1-4a76-83ac-3f1d82711ed5" providerId="ADAL" clId="{13979A4D-164F-4D95-AB4A-280FAF3364F0}" dt="2023-12-14T16:51:49.293" v="9" actId="1076"/>
          <ac:spMkLst>
            <pc:docMk/>
            <pc:sldMk cId="3436963830" sldId="268"/>
            <ac:spMk id="5" creationId="{E53AD560-8EB7-5789-360B-EDCE368FE1F2}"/>
          </ac:spMkLst>
        </pc:spChg>
        <pc:spChg chg="mod">
          <ac:chgData name="Devkar, Vikas" userId="acbd15ec-55d1-4a76-83ac-3f1d82711ed5" providerId="ADAL" clId="{13979A4D-164F-4D95-AB4A-280FAF3364F0}" dt="2023-12-14T16:51:42.851" v="7" actId="1076"/>
          <ac:spMkLst>
            <pc:docMk/>
            <pc:sldMk cId="3436963830" sldId="268"/>
            <ac:spMk id="6" creationId="{1B8E7A32-B138-666A-04C8-EE82080DB2FF}"/>
          </ac:spMkLst>
        </pc:spChg>
        <pc:spChg chg="mod">
          <ac:chgData name="Devkar, Vikas" userId="acbd15ec-55d1-4a76-83ac-3f1d82711ed5" providerId="ADAL" clId="{13979A4D-164F-4D95-AB4A-280FAF3364F0}" dt="2023-12-14T16:51:46.407" v="8" actId="14100"/>
          <ac:spMkLst>
            <pc:docMk/>
            <pc:sldMk cId="3436963830" sldId="268"/>
            <ac:spMk id="10" creationId="{9D81AC34-D8F7-CFC7-3D87-3384CBD7E1A7}"/>
          </ac:spMkLst>
        </pc:spChg>
      </pc:sldChg>
      <pc:sldChg chg="modSp mod">
        <pc:chgData name="Devkar, Vikas" userId="acbd15ec-55d1-4a76-83ac-3f1d82711ed5" providerId="ADAL" clId="{13979A4D-164F-4D95-AB4A-280FAF3364F0}" dt="2023-12-14T17:07:37.656" v="62" actId="1076"/>
        <pc:sldMkLst>
          <pc:docMk/>
          <pc:sldMk cId="941570768" sldId="271"/>
        </pc:sldMkLst>
        <pc:grpChg chg="mod">
          <ac:chgData name="Devkar, Vikas" userId="acbd15ec-55d1-4a76-83ac-3f1d82711ed5" providerId="ADAL" clId="{13979A4D-164F-4D95-AB4A-280FAF3364F0}" dt="2023-12-14T17:07:37.656" v="62" actId="1076"/>
          <ac:grpSpMkLst>
            <pc:docMk/>
            <pc:sldMk cId="941570768" sldId="271"/>
            <ac:grpSpMk id="10" creationId="{8583F6A4-9124-5271-0AAB-B5DA6B0A3B0A}"/>
          </ac:grpSpMkLst>
        </pc:grpChg>
      </pc:sldChg>
      <pc:sldChg chg="addSp delSp modSp new del mod">
        <pc:chgData name="Devkar, Vikas" userId="acbd15ec-55d1-4a76-83ac-3f1d82711ed5" providerId="ADAL" clId="{13979A4D-164F-4D95-AB4A-280FAF3364F0}" dt="2023-12-14T17:00:24.440" v="41" actId="680"/>
        <pc:sldMkLst>
          <pc:docMk/>
          <pc:sldMk cId="1065117674" sldId="273"/>
        </pc:sldMkLst>
        <pc:spChg chg="add del">
          <ac:chgData name="Devkar, Vikas" userId="acbd15ec-55d1-4a76-83ac-3f1d82711ed5" providerId="ADAL" clId="{13979A4D-164F-4D95-AB4A-280FAF3364F0}" dt="2023-12-14T17:00:21.084" v="40" actId="478"/>
          <ac:spMkLst>
            <pc:docMk/>
            <pc:sldMk cId="1065117674" sldId="273"/>
            <ac:spMk id="2" creationId="{2BFAD0C2-79EB-0BFD-4983-E75F545DEBF9}"/>
          </ac:spMkLst>
        </pc:spChg>
        <pc:spChg chg="add del">
          <ac:chgData name="Devkar, Vikas" userId="acbd15ec-55d1-4a76-83ac-3f1d82711ed5" providerId="ADAL" clId="{13979A4D-164F-4D95-AB4A-280FAF3364F0}" dt="2023-12-14T17:00:21.084" v="40" actId="478"/>
          <ac:spMkLst>
            <pc:docMk/>
            <pc:sldMk cId="1065117674" sldId="273"/>
            <ac:spMk id="3" creationId="{A185DD83-E200-5DB9-A184-DF4DA22399C1}"/>
          </ac:spMkLst>
        </pc:spChg>
        <pc:spChg chg="add del mod">
          <ac:chgData name="Devkar, Vikas" userId="acbd15ec-55d1-4a76-83ac-3f1d82711ed5" providerId="ADAL" clId="{13979A4D-164F-4D95-AB4A-280FAF3364F0}" dt="2023-12-14T17:00:20.623" v="39"/>
          <ac:spMkLst>
            <pc:docMk/>
            <pc:sldMk cId="1065117674" sldId="273"/>
            <ac:spMk id="5" creationId="{DC12CA2C-CA9A-C8C8-02BF-E49E2648B43E}"/>
          </ac:spMkLst>
        </pc:spChg>
        <pc:picChg chg="add del mod">
          <ac:chgData name="Devkar, Vikas" userId="acbd15ec-55d1-4a76-83ac-3f1d82711ed5" providerId="ADAL" clId="{13979A4D-164F-4D95-AB4A-280FAF3364F0}" dt="2023-12-14T17:00:20.623" v="39"/>
          <ac:picMkLst>
            <pc:docMk/>
            <pc:sldMk cId="1065117674" sldId="273"/>
            <ac:picMk id="4" creationId="{CA96F0C1-01DB-8586-2C1B-2382C1AA5F37}"/>
          </ac:picMkLst>
        </pc:picChg>
      </pc:sldChg>
      <pc:sldChg chg="addSp delSp modSp new del mod">
        <pc:chgData name="Devkar, Vikas" userId="acbd15ec-55d1-4a76-83ac-3f1d82711ed5" providerId="ADAL" clId="{13979A4D-164F-4D95-AB4A-280FAF3364F0}" dt="2023-12-14T17:09:38.271" v="74" actId="47"/>
        <pc:sldMkLst>
          <pc:docMk/>
          <pc:sldMk cId="2294430335" sldId="273"/>
        </pc:sldMkLst>
        <pc:spChg chg="del">
          <ac:chgData name="Devkar, Vikas" userId="acbd15ec-55d1-4a76-83ac-3f1d82711ed5" providerId="ADAL" clId="{13979A4D-164F-4D95-AB4A-280FAF3364F0}" dt="2023-12-14T17:00:42.595" v="46" actId="478"/>
          <ac:spMkLst>
            <pc:docMk/>
            <pc:sldMk cId="2294430335" sldId="273"/>
            <ac:spMk id="2" creationId="{2303CA6B-9937-7099-A262-A4E7D3CDE41E}"/>
          </ac:spMkLst>
        </pc:spChg>
        <pc:spChg chg="del">
          <ac:chgData name="Devkar, Vikas" userId="acbd15ec-55d1-4a76-83ac-3f1d82711ed5" providerId="ADAL" clId="{13979A4D-164F-4D95-AB4A-280FAF3364F0}" dt="2023-12-14T17:00:42.595" v="46" actId="478"/>
          <ac:spMkLst>
            <pc:docMk/>
            <pc:sldMk cId="2294430335" sldId="273"/>
            <ac:spMk id="3" creationId="{A630EE3E-3E63-BDE8-278D-593E5E3DF65A}"/>
          </ac:spMkLst>
        </pc:spChg>
        <pc:spChg chg="add del mod">
          <ac:chgData name="Devkar, Vikas" userId="acbd15ec-55d1-4a76-83ac-3f1d82711ed5" providerId="ADAL" clId="{13979A4D-164F-4D95-AB4A-280FAF3364F0}" dt="2023-12-14T17:08:29.158" v="64" actId="21"/>
          <ac:spMkLst>
            <pc:docMk/>
            <pc:sldMk cId="2294430335" sldId="273"/>
            <ac:spMk id="5" creationId="{BA813C18-80D8-76E0-C425-865F848DF557}"/>
          </ac:spMkLst>
        </pc:spChg>
        <pc:picChg chg="add del mod">
          <ac:chgData name="Devkar, Vikas" userId="acbd15ec-55d1-4a76-83ac-3f1d82711ed5" providerId="ADAL" clId="{13979A4D-164F-4D95-AB4A-280FAF3364F0}" dt="2023-12-14T17:08:29.158" v="64" actId="21"/>
          <ac:picMkLst>
            <pc:docMk/>
            <pc:sldMk cId="2294430335" sldId="273"/>
            <ac:picMk id="4" creationId="{1F34648B-889E-93C8-D312-F9AFF3CE581A}"/>
          </ac:picMkLst>
        </pc:picChg>
      </pc:sldChg>
      <pc:sldChg chg="addSp delSp modSp new mod">
        <pc:chgData name="Devkar, Vikas" userId="acbd15ec-55d1-4a76-83ac-3f1d82711ed5" providerId="ADAL" clId="{13979A4D-164F-4D95-AB4A-280FAF3364F0}" dt="2023-12-14T17:10:06.305" v="81" actId="1076"/>
        <pc:sldMkLst>
          <pc:docMk/>
          <pc:sldMk cId="1812129503" sldId="274"/>
        </pc:sldMkLst>
        <pc:spChg chg="del">
          <ac:chgData name="Devkar, Vikas" userId="acbd15ec-55d1-4a76-83ac-3f1d82711ed5" providerId="ADAL" clId="{13979A4D-164F-4D95-AB4A-280FAF3364F0}" dt="2023-12-14T17:09:23.061" v="69" actId="478"/>
          <ac:spMkLst>
            <pc:docMk/>
            <pc:sldMk cId="1812129503" sldId="274"/>
            <ac:spMk id="2" creationId="{B0948482-490B-69C6-9E98-23974C90C8CC}"/>
          </ac:spMkLst>
        </pc:spChg>
        <pc:spChg chg="del">
          <ac:chgData name="Devkar, Vikas" userId="acbd15ec-55d1-4a76-83ac-3f1d82711ed5" providerId="ADAL" clId="{13979A4D-164F-4D95-AB4A-280FAF3364F0}" dt="2023-12-14T17:09:23.061" v="69" actId="478"/>
          <ac:spMkLst>
            <pc:docMk/>
            <pc:sldMk cId="1812129503" sldId="274"/>
            <ac:spMk id="3" creationId="{7488B35C-4200-5BFF-9C72-C5A5FE2B7376}"/>
          </ac:spMkLst>
        </pc:spChg>
        <pc:spChg chg="add mod">
          <ac:chgData name="Devkar, Vikas" userId="acbd15ec-55d1-4a76-83ac-3f1d82711ed5" providerId="ADAL" clId="{13979A4D-164F-4D95-AB4A-280FAF3364F0}" dt="2023-12-14T17:09:29.448" v="72" actId="20577"/>
          <ac:spMkLst>
            <pc:docMk/>
            <pc:sldMk cId="1812129503" sldId="274"/>
            <ac:spMk id="4" creationId="{694444D2-4C36-62C8-7509-DB8D030F0156}"/>
          </ac:spMkLst>
        </pc:spChg>
        <pc:spChg chg="add mod">
          <ac:chgData name="Devkar, Vikas" userId="acbd15ec-55d1-4a76-83ac-3f1d82711ed5" providerId="ADAL" clId="{13979A4D-164F-4D95-AB4A-280FAF3364F0}" dt="2023-12-14T17:10:06.305" v="81" actId="1076"/>
          <ac:spMkLst>
            <pc:docMk/>
            <pc:sldMk cId="1812129503" sldId="274"/>
            <ac:spMk id="5" creationId="{A2ABE8A9-FDB0-B462-124C-3E920E08967B}"/>
          </ac:spMkLst>
        </pc:spChg>
        <pc:picChg chg="add mod">
          <ac:chgData name="Devkar, Vikas" userId="acbd15ec-55d1-4a76-83ac-3f1d82711ed5" providerId="ADAL" clId="{13979A4D-164F-4D95-AB4A-280FAF3364F0}" dt="2023-12-14T17:10:01.856" v="80" actId="14100"/>
          <ac:picMkLst>
            <pc:docMk/>
            <pc:sldMk cId="1812129503" sldId="274"/>
            <ac:picMk id="6" creationId="{9979DCA5-EEA1-FC30-F602-77A243A379CA}"/>
          </ac:picMkLst>
        </pc:picChg>
      </pc:sldChg>
    </pc:docChg>
  </pc:docChgLst>
  <pc:docChgLst>
    <pc:chgData name="Patil, Gunvant" userId="bab2d81c-cb5c-4d5f-9d4d-9ec0ed5664f1" providerId="ADAL" clId="{1F7A9478-7A91-B74C-AD14-3DE7D1AEF19C}"/>
    <pc:docChg chg="modSld">
      <pc:chgData name="Patil, Gunvant" userId="bab2d81c-cb5c-4d5f-9d4d-9ec0ed5664f1" providerId="ADAL" clId="{1F7A9478-7A91-B74C-AD14-3DE7D1AEF19C}" dt="2024-04-01T18:45:32.976" v="37" actId="20577"/>
      <pc:docMkLst>
        <pc:docMk/>
      </pc:docMkLst>
      <pc:sldChg chg="modSp mod">
        <pc:chgData name="Patil, Gunvant" userId="bab2d81c-cb5c-4d5f-9d4d-9ec0ed5664f1" providerId="ADAL" clId="{1F7A9478-7A91-B74C-AD14-3DE7D1AEF19C}" dt="2024-04-01T18:44:15.146" v="5" actId="120"/>
        <pc:sldMkLst>
          <pc:docMk/>
          <pc:sldMk cId="1604500440" sldId="256"/>
        </pc:sldMkLst>
        <pc:spChg chg="mod">
          <ac:chgData name="Patil, Gunvant" userId="bab2d81c-cb5c-4d5f-9d4d-9ec0ed5664f1" providerId="ADAL" clId="{1F7A9478-7A91-B74C-AD14-3DE7D1AEF19C}" dt="2024-04-01T18:44:15.146" v="5" actId="120"/>
          <ac:spMkLst>
            <pc:docMk/>
            <pc:sldMk cId="1604500440" sldId="256"/>
            <ac:spMk id="7" creationId="{A1F18A16-F4AD-BA15-75E0-DBBCAFFB2CCA}"/>
          </ac:spMkLst>
        </pc:spChg>
      </pc:sldChg>
      <pc:sldChg chg="modSp mod">
        <pc:chgData name="Patil, Gunvant" userId="bab2d81c-cb5c-4d5f-9d4d-9ec0ed5664f1" providerId="ADAL" clId="{1F7A9478-7A91-B74C-AD14-3DE7D1AEF19C}" dt="2024-04-01T18:44:28.543" v="10" actId="20577"/>
        <pc:sldMkLst>
          <pc:docMk/>
          <pc:sldMk cId="2353496295" sldId="257"/>
        </pc:sldMkLst>
        <pc:spChg chg="mod">
          <ac:chgData name="Patil, Gunvant" userId="bab2d81c-cb5c-4d5f-9d4d-9ec0ed5664f1" providerId="ADAL" clId="{1F7A9478-7A91-B74C-AD14-3DE7D1AEF19C}" dt="2024-04-01T18:44:28.543" v="10" actId="20577"/>
          <ac:spMkLst>
            <pc:docMk/>
            <pc:sldMk cId="2353496295" sldId="257"/>
            <ac:spMk id="13" creationId="{1E8A8E73-D593-34F9-B40C-79F2F7DDC6DE}"/>
          </ac:spMkLst>
        </pc:spChg>
      </pc:sldChg>
      <pc:sldChg chg="modSp mod">
        <pc:chgData name="Patil, Gunvant" userId="bab2d81c-cb5c-4d5f-9d4d-9ec0ed5664f1" providerId="ADAL" clId="{1F7A9478-7A91-B74C-AD14-3DE7D1AEF19C}" dt="2024-04-01T18:44:39.470" v="17" actId="20577"/>
        <pc:sldMkLst>
          <pc:docMk/>
          <pc:sldMk cId="1437810819" sldId="262"/>
        </pc:sldMkLst>
        <pc:spChg chg="mod">
          <ac:chgData name="Patil, Gunvant" userId="bab2d81c-cb5c-4d5f-9d4d-9ec0ed5664f1" providerId="ADAL" clId="{1F7A9478-7A91-B74C-AD14-3DE7D1AEF19C}" dt="2024-04-01T18:44:39.470" v="17" actId="20577"/>
          <ac:spMkLst>
            <pc:docMk/>
            <pc:sldMk cId="1437810819" sldId="262"/>
            <ac:spMk id="42" creationId="{28F568E8-3645-BB50-A71F-27BA32D8D5C2}"/>
          </ac:spMkLst>
        </pc:spChg>
      </pc:sldChg>
      <pc:sldChg chg="modSp mod">
        <pc:chgData name="Patil, Gunvant" userId="bab2d81c-cb5c-4d5f-9d4d-9ec0ed5664f1" providerId="ADAL" clId="{1F7A9478-7A91-B74C-AD14-3DE7D1AEF19C}" dt="2024-04-01T18:45:19.353" v="30" actId="20577"/>
        <pc:sldMkLst>
          <pc:docMk/>
          <pc:sldMk cId="794843755" sldId="264"/>
        </pc:sldMkLst>
        <pc:spChg chg="mod">
          <ac:chgData name="Patil, Gunvant" userId="bab2d81c-cb5c-4d5f-9d4d-9ec0ed5664f1" providerId="ADAL" clId="{1F7A9478-7A91-B74C-AD14-3DE7D1AEF19C}" dt="2024-04-01T18:45:19.353" v="30" actId="20577"/>
          <ac:spMkLst>
            <pc:docMk/>
            <pc:sldMk cId="794843755" sldId="264"/>
            <ac:spMk id="7" creationId="{61C45261-E6F1-BCD3-70E4-7B438A09B38F}"/>
          </ac:spMkLst>
        </pc:spChg>
      </pc:sldChg>
      <pc:sldChg chg="modSp mod">
        <pc:chgData name="Patil, Gunvant" userId="bab2d81c-cb5c-4d5f-9d4d-9ec0ed5664f1" providerId="ADAL" clId="{1F7A9478-7A91-B74C-AD14-3DE7D1AEF19C}" dt="2024-04-01T18:44:51.185" v="19" actId="113"/>
        <pc:sldMkLst>
          <pc:docMk/>
          <pc:sldMk cId="1845444862" sldId="265"/>
        </pc:sldMkLst>
        <pc:spChg chg="mod">
          <ac:chgData name="Patil, Gunvant" userId="bab2d81c-cb5c-4d5f-9d4d-9ec0ed5664f1" providerId="ADAL" clId="{1F7A9478-7A91-B74C-AD14-3DE7D1AEF19C}" dt="2024-04-01T18:44:51.185" v="19" actId="113"/>
          <ac:spMkLst>
            <pc:docMk/>
            <pc:sldMk cId="1845444862" sldId="265"/>
            <ac:spMk id="4" creationId="{47E1C263-20BF-3010-7C86-6DDDAB808C91}"/>
          </ac:spMkLst>
        </pc:spChg>
      </pc:sldChg>
      <pc:sldChg chg="modSp mod">
        <pc:chgData name="Patil, Gunvant" userId="bab2d81c-cb5c-4d5f-9d4d-9ec0ed5664f1" providerId="ADAL" clId="{1F7A9478-7A91-B74C-AD14-3DE7D1AEF19C}" dt="2024-04-01T18:44:55.928" v="20" actId="113"/>
        <pc:sldMkLst>
          <pc:docMk/>
          <pc:sldMk cId="417503466" sldId="266"/>
        </pc:sldMkLst>
        <pc:spChg chg="mod">
          <ac:chgData name="Patil, Gunvant" userId="bab2d81c-cb5c-4d5f-9d4d-9ec0ed5664f1" providerId="ADAL" clId="{1F7A9478-7A91-B74C-AD14-3DE7D1AEF19C}" dt="2024-04-01T18:44:55.928" v="20" actId="113"/>
          <ac:spMkLst>
            <pc:docMk/>
            <pc:sldMk cId="417503466" sldId="266"/>
            <ac:spMk id="4" creationId="{F1480AE0-CD30-03E5-6124-496AC4D0B0E4}"/>
          </ac:spMkLst>
        </pc:spChg>
      </pc:sldChg>
      <pc:sldChg chg="modSp mod">
        <pc:chgData name="Patil, Gunvant" userId="bab2d81c-cb5c-4d5f-9d4d-9ec0ed5664f1" providerId="ADAL" clId="{1F7A9478-7A91-B74C-AD14-3DE7D1AEF19C}" dt="2024-04-01T18:44:45.392" v="18" actId="113"/>
        <pc:sldMkLst>
          <pc:docMk/>
          <pc:sldMk cId="1922289499" sldId="267"/>
        </pc:sldMkLst>
        <pc:spChg chg="mod">
          <ac:chgData name="Patil, Gunvant" userId="bab2d81c-cb5c-4d5f-9d4d-9ec0ed5664f1" providerId="ADAL" clId="{1F7A9478-7A91-B74C-AD14-3DE7D1AEF19C}" dt="2024-04-01T18:44:45.392" v="18" actId="113"/>
          <ac:spMkLst>
            <pc:docMk/>
            <pc:sldMk cId="1922289499" sldId="267"/>
            <ac:spMk id="8" creationId="{A373B488-B0CF-2144-1213-219AA7C07B87}"/>
          </ac:spMkLst>
        </pc:spChg>
      </pc:sldChg>
      <pc:sldChg chg="modSp mod">
        <pc:chgData name="Patil, Gunvant" userId="bab2d81c-cb5c-4d5f-9d4d-9ec0ed5664f1" providerId="ADAL" clId="{1F7A9478-7A91-B74C-AD14-3DE7D1AEF19C}" dt="2024-04-01T18:45:03.233" v="23" actId="20577"/>
        <pc:sldMkLst>
          <pc:docMk/>
          <pc:sldMk cId="3436963830" sldId="268"/>
        </pc:sldMkLst>
        <pc:spChg chg="mod">
          <ac:chgData name="Patil, Gunvant" userId="bab2d81c-cb5c-4d5f-9d4d-9ec0ed5664f1" providerId="ADAL" clId="{1F7A9478-7A91-B74C-AD14-3DE7D1AEF19C}" dt="2024-04-01T18:45:03.233" v="23" actId="20577"/>
          <ac:spMkLst>
            <pc:docMk/>
            <pc:sldMk cId="3436963830" sldId="268"/>
            <ac:spMk id="4" creationId="{E9ABEC9B-7711-5DEE-1919-B3C572856D23}"/>
          </ac:spMkLst>
        </pc:spChg>
      </pc:sldChg>
      <pc:sldChg chg="modSp mod">
        <pc:chgData name="Patil, Gunvant" userId="bab2d81c-cb5c-4d5f-9d4d-9ec0ed5664f1" providerId="ADAL" clId="{1F7A9478-7A91-B74C-AD14-3DE7D1AEF19C}" dt="2024-04-01T18:45:08.879" v="25" actId="20577"/>
        <pc:sldMkLst>
          <pc:docMk/>
          <pc:sldMk cId="941570768" sldId="271"/>
        </pc:sldMkLst>
        <pc:spChg chg="mod">
          <ac:chgData name="Patil, Gunvant" userId="bab2d81c-cb5c-4d5f-9d4d-9ec0ed5664f1" providerId="ADAL" clId="{1F7A9478-7A91-B74C-AD14-3DE7D1AEF19C}" dt="2024-04-01T18:45:08.879" v="25" actId="20577"/>
          <ac:spMkLst>
            <pc:docMk/>
            <pc:sldMk cId="941570768" sldId="271"/>
            <ac:spMk id="5" creationId="{E880AF6A-641C-F67F-BA37-ED8AA5C0C046}"/>
          </ac:spMkLst>
        </pc:spChg>
      </pc:sldChg>
      <pc:sldChg chg="modSp mod">
        <pc:chgData name="Patil, Gunvant" userId="bab2d81c-cb5c-4d5f-9d4d-9ec0ed5664f1" providerId="ADAL" clId="{1F7A9478-7A91-B74C-AD14-3DE7D1AEF19C}" dt="2024-04-01T18:45:32.976" v="37" actId="20577"/>
        <pc:sldMkLst>
          <pc:docMk/>
          <pc:sldMk cId="772256198" sldId="272"/>
        </pc:sldMkLst>
        <pc:spChg chg="mod">
          <ac:chgData name="Patil, Gunvant" userId="bab2d81c-cb5c-4d5f-9d4d-9ec0ed5664f1" providerId="ADAL" clId="{1F7A9478-7A91-B74C-AD14-3DE7D1AEF19C}" dt="2024-04-01T18:45:32.976" v="37" actId="20577"/>
          <ac:spMkLst>
            <pc:docMk/>
            <pc:sldMk cId="772256198" sldId="272"/>
            <ac:spMk id="2" creationId="{95DE3980-1221-E768-B463-21755D594504}"/>
          </ac:spMkLst>
        </pc:spChg>
      </pc:sldChg>
    </pc:docChg>
  </pc:docChgLst>
  <pc:docChgLst>
    <pc:chgData name="Devkar, Vikas" userId="acbd15ec-55d1-4a76-83ac-3f1d82711ed5" providerId="ADAL" clId="{4C57031F-CE5B-445E-A32C-D89C534CEBBB}"/>
    <pc:docChg chg="undo redo custSel addSld modSld">
      <pc:chgData name="Devkar, Vikas" userId="acbd15ec-55d1-4a76-83ac-3f1d82711ed5" providerId="ADAL" clId="{4C57031F-CE5B-445E-A32C-D89C534CEBBB}" dt="2024-03-05T06:42:39.880" v="676" actId="20577"/>
      <pc:docMkLst>
        <pc:docMk/>
      </pc:docMkLst>
      <pc:sldChg chg="modSp mod">
        <pc:chgData name="Devkar, Vikas" userId="acbd15ec-55d1-4a76-83ac-3f1d82711ed5" providerId="ADAL" clId="{4C57031F-CE5B-445E-A32C-D89C534CEBBB}" dt="2024-03-05T06:28:09.596" v="238" actId="20577"/>
        <pc:sldMkLst>
          <pc:docMk/>
          <pc:sldMk cId="1604500440" sldId="256"/>
        </pc:sldMkLst>
        <pc:spChg chg="mod">
          <ac:chgData name="Devkar, Vikas" userId="acbd15ec-55d1-4a76-83ac-3f1d82711ed5" providerId="ADAL" clId="{4C57031F-CE5B-445E-A32C-D89C534CEBBB}" dt="2024-03-05T06:28:09.596" v="238" actId="20577"/>
          <ac:spMkLst>
            <pc:docMk/>
            <pc:sldMk cId="1604500440" sldId="256"/>
            <ac:spMk id="7" creationId="{A1F18A16-F4AD-BA15-75E0-DBBCAFFB2CCA}"/>
          </ac:spMkLst>
        </pc:spChg>
      </pc:sldChg>
      <pc:sldChg chg="modSp mod">
        <pc:chgData name="Devkar, Vikas" userId="acbd15ec-55d1-4a76-83ac-3f1d82711ed5" providerId="ADAL" clId="{4C57031F-CE5B-445E-A32C-D89C534CEBBB}" dt="2024-03-05T06:42:39.880" v="676" actId="20577"/>
        <pc:sldMkLst>
          <pc:docMk/>
          <pc:sldMk cId="2353496295" sldId="257"/>
        </pc:sldMkLst>
        <pc:spChg chg="mod">
          <ac:chgData name="Devkar, Vikas" userId="acbd15ec-55d1-4a76-83ac-3f1d82711ed5" providerId="ADAL" clId="{4C57031F-CE5B-445E-A32C-D89C534CEBBB}" dt="2024-03-05T06:42:39.880" v="676" actId="20577"/>
          <ac:spMkLst>
            <pc:docMk/>
            <pc:sldMk cId="2353496295" sldId="257"/>
            <ac:spMk id="13" creationId="{1E8A8E73-D593-34F9-B40C-79F2F7DDC6DE}"/>
          </ac:spMkLst>
        </pc:spChg>
      </pc:sldChg>
      <pc:sldChg chg="delSp modSp mod">
        <pc:chgData name="Devkar, Vikas" userId="acbd15ec-55d1-4a76-83ac-3f1d82711ed5" providerId="ADAL" clId="{4C57031F-CE5B-445E-A32C-D89C534CEBBB}" dt="2024-03-05T06:31:48.526" v="379" actId="20577"/>
        <pc:sldMkLst>
          <pc:docMk/>
          <pc:sldMk cId="1437810819" sldId="262"/>
        </pc:sldMkLst>
        <pc:spChg chg="mod">
          <ac:chgData name="Devkar, Vikas" userId="acbd15ec-55d1-4a76-83ac-3f1d82711ed5" providerId="ADAL" clId="{4C57031F-CE5B-445E-A32C-D89C534CEBBB}" dt="2024-03-05T06:29:24.901" v="251" actId="1076"/>
          <ac:spMkLst>
            <pc:docMk/>
            <pc:sldMk cId="1437810819" sldId="262"/>
            <ac:spMk id="39" creationId="{2D981907-DEF4-28AB-4F9E-121EFA7BA0D3}"/>
          </ac:spMkLst>
        </pc:spChg>
        <pc:spChg chg="mod">
          <ac:chgData name="Devkar, Vikas" userId="acbd15ec-55d1-4a76-83ac-3f1d82711ed5" providerId="ADAL" clId="{4C57031F-CE5B-445E-A32C-D89C534CEBBB}" dt="2024-03-05T06:29:29.698" v="252" actId="1076"/>
          <ac:spMkLst>
            <pc:docMk/>
            <pc:sldMk cId="1437810819" sldId="262"/>
            <ac:spMk id="40" creationId="{53751EA1-1890-A682-31A3-D98ECB5B17CD}"/>
          </ac:spMkLst>
        </pc:spChg>
        <pc:spChg chg="del">
          <ac:chgData name="Devkar, Vikas" userId="acbd15ec-55d1-4a76-83ac-3f1d82711ed5" providerId="ADAL" clId="{4C57031F-CE5B-445E-A32C-D89C534CEBBB}" dt="2024-03-04T23:18:07.997" v="77" actId="478"/>
          <ac:spMkLst>
            <pc:docMk/>
            <pc:sldMk cId="1437810819" sldId="262"/>
            <ac:spMk id="41" creationId="{1EE920DF-9EA3-7D7B-F021-BC256925BF39}"/>
          </ac:spMkLst>
        </pc:spChg>
        <pc:spChg chg="mod">
          <ac:chgData name="Devkar, Vikas" userId="acbd15ec-55d1-4a76-83ac-3f1d82711ed5" providerId="ADAL" clId="{4C57031F-CE5B-445E-A32C-D89C534CEBBB}" dt="2024-03-05T06:31:48.526" v="379" actId="20577"/>
          <ac:spMkLst>
            <pc:docMk/>
            <pc:sldMk cId="1437810819" sldId="262"/>
            <ac:spMk id="42" creationId="{28F568E8-3645-BB50-A71F-27BA32D8D5C2}"/>
          </ac:spMkLst>
        </pc:spChg>
        <pc:grpChg chg="mod">
          <ac:chgData name="Devkar, Vikas" userId="acbd15ec-55d1-4a76-83ac-3f1d82711ed5" providerId="ADAL" clId="{4C57031F-CE5B-445E-A32C-D89C534CEBBB}" dt="2024-03-05T06:29:29.698" v="252" actId="1076"/>
          <ac:grpSpMkLst>
            <pc:docMk/>
            <pc:sldMk cId="1437810819" sldId="262"/>
            <ac:grpSpMk id="4" creationId="{4C12F03E-9E8E-ECF2-F61F-6F06DEFF4081}"/>
          </ac:grpSpMkLst>
        </pc:grpChg>
        <pc:picChg chg="mod">
          <ac:chgData name="Devkar, Vikas" userId="acbd15ec-55d1-4a76-83ac-3f1d82711ed5" providerId="ADAL" clId="{4C57031F-CE5B-445E-A32C-D89C534CEBBB}" dt="2024-03-05T06:29:29.698" v="252" actId="1076"/>
          <ac:picMkLst>
            <pc:docMk/>
            <pc:sldMk cId="1437810819" sldId="262"/>
            <ac:picMk id="3" creationId="{A7FE0156-B454-678F-37C3-F9D56CBA9AC0}"/>
          </ac:picMkLst>
        </pc:picChg>
        <pc:picChg chg="del mod">
          <ac:chgData name="Devkar, Vikas" userId="acbd15ec-55d1-4a76-83ac-3f1d82711ed5" providerId="ADAL" clId="{4C57031F-CE5B-445E-A32C-D89C534CEBBB}" dt="2024-03-04T23:18:05.377" v="76" actId="478"/>
          <ac:picMkLst>
            <pc:docMk/>
            <pc:sldMk cId="1437810819" sldId="262"/>
            <ac:picMk id="6" creationId="{700FDA5C-A7F2-2BB3-637E-ACB4A129C13C}"/>
          </ac:picMkLst>
        </pc:picChg>
        <pc:picChg chg="mod">
          <ac:chgData name="Devkar, Vikas" userId="acbd15ec-55d1-4a76-83ac-3f1d82711ed5" providerId="ADAL" clId="{4C57031F-CE5B-445E-A32C-D89C534CEBBB}" dt="2024-03-05T06:29:32.752" v="253" actId="1076"/>
          <ac:picMkLst>
            <pc:docMk/>
            <pc:sldMk cId="1437810819" sldId="262"/>
            <ac:picMk id="8" creationId="{DC6ADC5E-E3E6-698E-6996-F364912B7940}"/>
          </ac:picMkLst>
        </pc:picChg>
      </pc:sldChg>
      <pc:sldChg chg="addSp delSp modSp mod">
        <pc:chgData name="Devkar, Vikas" userId="acbd15ec-55d1-4a76-83ac-3f1d82711ed5" providerId="ADAL" clId="{4C57031F-CE5B-445E-A32C-D89C534CEBBB}" dt="2024-03-05T01:34:10.143" v="214" actId="403"/>
        <pc:sldMkLst>
          <pc:docMk/>
          <pc:sldMk cId="794843755" sldId="264"/>
        </pc:sldMkLst>
        <pc:spChg chg="add del">
          <ac:chgData name="Devkar, Vikas" userId="acbd15ec-55d1-4a76-83ac-3f1d82711ed5" providerId="ADAL" clId="{4C57031F-CE5B-445E-A32C-D89C534CEBBB}" dt="2024-03-04T05:33:23.493" v="9" actId="478"/>
          <ac:spMkLst>
            <pc:docMk/>
            <pc:sldMk cId="794843755" sldId="264"/>
            <ac:spMk id="4" creationId="{7D593560-ACFB-F8C2-73F4-168A14781887}"/>
          </ac:spMkLst>
        </pc:spChg>
        <pc:spChg chg="add del">
          <ac:chgData name="Devkar, Vikas" userId="acbd15ec-55d1-4a76-83ac-3f1d82711ed5" providerId="ADAL" clId="{4C57031F-CE5B-445E-A32C-D89C534CEBBB}" dt="2024-03-04T05:33:23.493" v="9" actId="478"/>
          <ac:spMkLst>
            <pc:docMk/>
            <pc:sldMk cId="794843755" sldId="264"/>
            <ac:spMk id="5" creationId="{92375EEC-00F9-91C1-1612-0917D283BA86}"/>
          </ac:spMkLst>
        </pc:spChg>
        <pc:spChg chg="add mod">
          <ac:chgData name="Devkar, Vikas" userId="acbd15ec-55d1-4a76-83ac-3f1d82711ed5" providerId="ADAL" clId="{4C57031F-CE5B-445E-A32C-D89C534CEBBB}" dt="2024-03-05T01:32:38.005" v="201" actId="164"/>
          <ac:spMkLst>
            <pc:docMk/>
            <pc:sldMk cId="794843755" sldId="264"/>
            <ac:spMk id="6" creationId="{38BCA4B3-CB6B-DD90-0EA4-30EFC0AE81FF}"/>
          </ac:spMkLst>
        </pc:spChg>
        <pc:spChg chg="add del mod">
          <ac:chgData name="Devkar, Vikas" userId="acbd15ec-55d1-4a76-83ac-3f1d82711ed5" providerId="ADAL" clId="{4C57031F-CE5B-445E-A32C-D89C534CEBBB}" dt="2024-03-05T01:34:10.143" v="214" actId="403"/>
          <ac:spMkLst>
            <pc:docMk/>
            <pc:sldMk cId="794843755" sldId="264"/>
            <ac:spMk id="7" creationId="{61C45261-E6F1-BCD3-70E4-7B438A09B38F}"/>
          </ac:spMkLst>
        </pc:spChg>
        <pc:spChg chg="add del mod">
          <ac:chgData name="Devkar, Vikas" userId="acbd15ec-55d1-4a76-83ac-3f1d82711ed5" providerId="ADAL" clId="{4C57031F-CE5B-445E-A32C-D89C534CEBBB}" dt="2024-03-05T01:32:30.122" v="200" actId="478"/>
          <ac:spMkLst>
            <pc:docMk/>
            <pc:sldMk cId="794843755" sldId="264"/>
            <ac:spMk id="8" creationId="{D23A003D-B2E0-0CF2-CDBE-2C4F6D643B6D}"/>
          </ac:spMkLst>
        </pc:spChg>
        <pc:spChg chg="add del mod">
          <ac:chgData name="Devkar, Vikas" userId="acbd15ec-55d1-4a76-83ac-3f1d82711ed5" providerId="ADAL" clId="{4C57031F-CE5B-445E-A32C-D89C534CEBBB}" dt="2024-03-05T01:32:38.005" v="201" actId="164"/>
          <ac:spMkLst>
            <pc:docMk/>
            <pc:sldMk cId="794843755" sldId="264"/>
            <ac:spMk id="9" creationId="{57F3A884-8AEB-07EE-192A-2B1D2FBE1D10}"/>
          </ac:spMkLst>
        </pc:spChg>
        <pc:spChg chg="add mod">
          <ac:chgData name="Devkar, Vikas" userId="acbd15ec-55d1-4a76-83ac-3f1d82711ed5" providerId="ADAL" clId="{4C57031F-CE5B-445E-A32C-D89C534CEBBB}" dt="2024-03-05T01:32:38.005" v="201" actId="164"/>
          <ac:spMkLst>
            <pc:docMk/>
            <pc:sldMk cId="794843755" sldId="264"/>
            <ac:spMk id="10" creationId="{28792D60-7662-2731-A4C5-8568EB29E094}"/>
          </ac:spMkLst>
        </pc:spChg>
        <pc:spChg chg="add mod">
          <ac:chgData name="Devkar, Vikas" userId="acbd15ec-55d1-4a76-83ac-3f1d82711ed5" providerId="ADAL" clId="{4C57031F-CE5B-445E-A32C-D89C534CEBBB}" dt="2024-03-05T01:32:38.005" v="201" actId="164"/>
          <ac:spMkLst>
            <pc:docMk/>
            <pc:sldMk cId="794843755" sldId="264"/>
            <ac:spMk id="11" creationId="{6EB80DB2-23D9-81C0-2F0E-0358E0D1534D}"/>
          </ac:spMkLst>
        </pc:spChg>
        <pc:spChg chg="add del mod">
          <ac:chgData name="Devkar, Vikas" userId="acbd15ec-55d1-4a76-83ac-3f1d82711ed5" providerId="ADAL" clId="{4C57031F-CE5B-445E-A32C-D89C534CEBBB}" dt="2024-03-05T01:28:51.780" v="125" actId="478"/>
          <ac:spMkLst>
            <pc:docMk/>
            <pc:sldMk cId="794843755" sldId="264"/>
            <ac:spMk id="13" creationId="{ECACED82-0DA2-E6AC-8DDE-8A88A5F72AED}"/>
          </ac:spMkLst>
        </pc:spChg>
        <pc:spChg chg="add mod">
          <ac:chgData name="Devkar, Vikas" userId="acbd15ec-55d1-4a76-83ac-3f1d82711ed5" providerId="ADAL" clId="{4C57031F-CE5B-445E-A32C-D89C534CEBBB}" dt="2024-03-05T01:32:38.005" v="201" actId="164"/>
          <ac:spMkLst>
            <pc:docMk/>
            <pc:sldMk cId="794843755" sldId="264"/>
            <ac:spMk id="14" creationId="{F045C686-C040-49CF-69B0-19B5E2D886FA}"/>
          </ac:spMkLst>
        </pc:spChg>
        <pc:spChg chg="add mod">
          <ac:chgData name="Devkar, Vikas" userId="acbd15ec-55d1-4a76-83ac-3f1d82711ed5" providerId="ADAL" clId="{4C57031F-CE5B-445E-A32C-D89C534CEBBB}" dt="2024-03-05T01:32:38.005" v="201" actId="164"/>
          <ac:spMkLst>
            <pc:docMk/>
            <pc:sldMk cId="794843755" sldId="264"/>
            <ac:spMk id="16" creationId="{629E4D14-D7DF-6A89-9284-BAEB693D6150}"/>
          </ac:spMkLst>
        </pc:spChg>
        <pc:spChg chg="add mod">
          <ac:chgData name="Devkar, Vikas" userId="acbd15ec-55d1-4a76-83ac-3f1d82711ed5" providerId="ADAL" clId="{4C57031F-CE5B-445E-A32C-D89C534CEBBB}" dt="2024-03-05T01:32:38.005" v="201" actId="164"/>
          <ac:spMkLst>
            <pc:docMk/>
            <pc:sldMk cId="794843755" sldId="264"/>
            <ac:spMk id="19" creationId="{D7E33E8B-BAE4-1EB3-213B-50151E3A697A}"/>
          </ac:spMkLst>
        </pc:spChg>
        <pc:spChg chg="add mod">
          <ac:chgData name="Devkar, Vikas" userId="acbd15ec-55d1-4a76-83ac-3f1d82711ed5" providerId="ADAL" clId="{4C57031F-CE5B-445E-A32C-D89C534CEBBB}" dt="2024-03-05T01:32:38.005" v="201" actId="164"/>
          <ac:spMkLst>
            <pc:docMk/>
            <pc:sldMk cId="794843755" sldId="264"/>
            <ac:spMk id="20" creationId="{C9124F61-60B2-8DDB-D73F-C6CF7B041092}"/>
          </ac:spMkLst>
        </pc:spChg>
        <pc:spChg chg="add mod">
          <ac:chgData name="Devkar, Vikas" userId="acbd15ec-55d1-4a76-83ac-3f1d82711ed5" providerId="ADAL" clId="{4C57031F-CE5B-445E-A32C-D89C534CEBBB}" dt="2024-03-05T01:32:38.005" v="201" actId="164"/>
          <ac:spMkLst>
            <pc:docMk/>
            <pc:sldMk cId="794843755" sldId="264"/>
            <ac:spMk id="21" creationId="{D7934C8E-9AE4-D638-462C-FF718F6DEBA7}"/>
          </ac:spMkLst>
        </pc:spChg>
        <pc:grpChg chg="add del mod">
          <ac:chgData name="Devkar, Vikas" userId="acbd15ec-55d1-4a76-83ac-3f1d82711ed5" providerId="ADAL" clId="{4C57031F-CE5B-445E-A32C-D89C534CEBBB}" dt="2024-03-05T01:32:38.005" v="201" actId="164"/>
          <ac:grpSpMkLst>
            <pc:docMk/>
            <pc:sldMk cId="794843755" sldId="264"/>
            <ac:grpSpMk id="18" creationId="{EDB99B2A-34CA-9256-80DC-95B9C70BF965}"/>
          </ac:grpSpMkLst>
        </pc:grpChg>
        <pc:grpChg chg="add del mod">
          <ac:chgData name="Devkar, Vikas" userId="acbd15ec-55d1-4a76-83ac-3f1d82711ed5" providerId="ADAL" clId="{4C57031F-CE5B-445E-A32C-D89C534CEBBB}" dt="2024-03-05T01:32:40.116" v="203" actId="21"/>
          <ac:grpSpMkLst>
            <pc:docMk/>
            <pc:sldMk cId="794843755" sldId="264"/>
            <ac:grpSpMk id="22" creationId="{6A30AD5B-F433-E2B2-1C77-6D871F50F4D0}"/>
          </ac:grpSpMkLst>
        </pc:grpChg>
        <pc:picChg chg="add del">
          <ac:chgData name="Devkar, Vikas" userId="acbd15ec-55d1-4a76-83ac-3f1d82711ed5" providerId="ADAL" clId="{4C57031F-CE5B-445E-A32C-D89C534CEBBB}" dt="2024-03-04T05:33:23.493" v="9" actId="478"/>
          <ac:picMkLst>
            <pc:docMk/>
            <pc:sldMk cId="794843755" sldId="264"/>
            <ac:picMk id="2" creationId="{7C34630E-173E-7746-C548-3D3C58E2580A}"/>
          </ac:picMkLst>
        </pc:picChg>
      </pc:sldChg>
      <pc:sldChg chg="addSp delSp modSp mod">
        <pc:chgData name="Devkar, Vikas" userId="acbd15ec-55d1-4a76-83ac-3f1d82711ed5" providerId="ADAL" clId="{4C57031F-CE5B-445E-A32C-D89C534CEBBB}" dt="2024-03-05T06:32:42.970" v="399" actId="1076"/>
        <pc:sldMkLst>
          <pc:docMk/>
          <pc:sldMk cId="3436963830" sldId="268"/>
        </pc:sldMkLst>
        <pc:spChg chg="mod topLvl">
          <ac:chgData name="Devkar, Vikas" userId="acbd15ec-55d1-4a76-83ac-3f1d82711ed5" providerId="ADAL" clId="{4C57031F-CE5B-445E-A32C-D89C534CEBBB}" dt="2024-03-04T23:17:47.530" v="75" actId="165"/>
          <ac:spMkLst>
            <pc:docMk/>
            <pc:sldMk cId="3436963830" sldId="268"/>
            <ac:spMk id="3" creationId="{844CC83F-FB26-61D6-19AD-52B1310FEFF8}"/>
          </ac:spMkLst>
        </pc:spChg>
        <pc:spChg chg="mod">
          <ac:chgData name="Devkar, Vikas" userId="acbd15ec-55d1-4a76-83ac-3f1d82711ed5" providerId="ADAL" clId="{4C57031F-CE5B-445E-A32C-D89C534CEBBB}" dt="2024-03-05T06:32:42.970" v="399" actId="1076"/>
          <ac:spMkLst>
            <pc:docMk/>
            <pc:sldMk cId="3436963830" sldId="268"/>
            <ac:spMk id="4" creationId="{E9ABEC9B-7711-5DEE-1919-B3C572856D23}"/>
          </ac:spMkLst>
        </pc:spChg>
        <pc:spChg chg="mod topLvl">
          <ac:chgData name="Devkar, Vikas" userId="acbd15ec-55d1-4a76-83ac-3f1d82711ed5" providerId="ADAL" clId="{4C57031F-CE5B-445E-A32C-D89C534CEBBB}" dt="2024-03-04T23:17:47.530" v="75" actId="165"/>
          <ac:spMkLst>
            <pc:docMk/>
            <pc:sldMk cId="3436963830" sldId="268"/>
            <ac:spMk id="5" creationId="{8960662B-F76F-2080-DE80-0C3E6D4E7450}"/>
          </ac:spMkLst>
        </pc:spChg>
        <pc:spChg chg="mod topLvl">
          <ac:chgData name="Devkar, Vikas" userId="acbd15ec-55d1-4a76-83ac-3f1d82711ed5" providerId="ADAL" clId="{4C57031F-CE5B-445E-A32C-D89C534CEBBB}" dt="2024-03-04T23:17:47.530" v="75" actId="165"/>
          <ac:spMkLst>
            <pc:docMk/>
            <pc:sldMk cId="3436963830" sldId="268"/>
            <ac:spMk id="6" creationId="{BAD975C2-5195-6554-8FD0-947A298FE51E}"/>
          </ac:spMkLst>
        </pc:spChg>
        <pc:spChg chg="mod">
          <ac:chgData name="Devkar, Vikas" userId="acbd15ec-55d1-4a76-83ac-3f1d82711ed5" providerId="ADAL" clId="{4C57031F-CE5B-445E-A32C-D89C534CEBBB}" dt="2024-03-04T23:15:22.962" v="61" actId="1076"/>
          <ac:spMkLst>
            <pc:docMk/>
            <pc:sldMk cId="3436963830" sldId="268"/>
            <ac:spMk id="9" creationId="{A445E8BB-8C62-23B5-665E-0E77CE890546}"/>
          </ac:spMkLst>
        </pc:spChg>
        <pc:spChg chg="mod topLvl">
          <ac:chgData name="Devkar, Vikas" userId="acbd15ec-55d1-4a76-83ac-3f1d82711ed5" providerId="ADAL" clId="{4C57031F-CE5B-445E-A32C-D89C534CEBBB}" dt="2024-03-04T23:17:47.530" v="75" actId="165"/>
          <ac:spMkLst>
            <pc:docMk/>
            <pc:sldMk cId="3436963830" sldId="268"/>
            <ac:spMk id="10" creationId="{A2A2E485-B177-38CE-A4D3-E66D355631FB}"/>
          </ac:spMkLst>
        </pc:spChg>
        <pc:spChg chg="mod topLvl">
          <ac:chgData name="Devkar, Vikas" userId="acbd15ec-55d1-4a76-83ac-3f1d82711ed5" providerId="ADAL" clId="{4C57031F-CE5B-445E-A32C-D89C534CEBBB}" dt="2024-03-04T23:17:47.530" v="75" actId="165"/>
          <ac:spMkLst>
            <pc:docMk/>
            <pc:sldMk cId="3436963830" sldId="268"/>
            <ac:spMk id="11" creationId="{2E373D25-1465-3B00-6D60-0393E93954B5}"/>
          </ac:spMkLst>
        </pc:spChg>
        <pc:spChg chg="mod topLvl">
          <ac:chgData name="Devkar, Vikas" userId="acbd15ec-55d1-4a76-83ac-3f1d82711ed5" providerId="ADAL" clId="{4C57031F-CE5B-445E-A32C-D89C534CEBBB}" dt="2024-03-04T23:17:47.530" v="75" actId="165"/>
          <ac:spMkLst>
            <pc:docMk/>
            <pc:sldMk cId="3436963830" sldId="268"/>
            <ac:spMk id="12" creationId="{20CC143D-52B9-5A3A-2FE2-1A36A52483C7}"/>
          </ac:spMkLst>
        </pc:spChg>
        <pc:spChg chg="mod topLvl">
          <ac:chgData name="Devkar, Vikas" userId="acbd15ec-55d1-4a76-83ac-3f1d82711ed5" providerId="ADAL" clId="{4C57031F-CE5B-445E-A32C-D89C534CEBBB}" dt="2024-03-04T23:17:47.530" v="75" actId="165"/>
          <ac:spMkLst>
            <pc:docMk/>
            <pc:sldMk cId="3436963830" sldId="268"/>
            <ac:spMk id="13" creationId="{9BF13D69-9B0F-AA2D-89C7-FD50694D357B}"/>
          </ac:spMkLst>
        </pc:spChg>
        <pc:spChg chg="mod">
          <ac:chgData name="Devkar, Vikas" userId="acbd15ec-55d1-4a76-83ac-3f1d82711ed5" providerId="ADAL" clId="{4C57031F-CE5B-445E-A32C-D89C534CEBBB}" dt="2024-03-04T23:15:22.617" v="60" actId="1076"/>
          <ac:spMkLst>
            <pc:docMk/>
            <pc:sldMk cId="3436963830" sldId="268"/>
            <ac:spMk id="15" creationId="{C42B5232-858A-FF08-0929-C04AC307F99E}"/>
          </ac:spMkLst>
        </pc:spChg>
        <pc:spChg chg="mod topLvl">
          <ac:chgData name="Devkar, Vikas" userId="acbd15ec-55d1-4a76-83ac-3f1d82711ed5" providerId="ADAL" clId="{4C57031F-CE5B-445E-A32C-D89C534CEBBB}" dt="2024-03-04T23:17:47.530" v="75" actId="165"/>
          <ac:spMkLst>
            <pc:docMk/>
            <pc:sldMk cId="3436963830" sldId="268"/>
            <ac:spMk id="17" creationId="{D114B789-559F-75F6-8FC6-CA9299F19C0B}"/>
          </ac:spMkLst>
        </pc:spChg>
        <pc:spChg chg="mod topLvl">
          <ac:chgData name="Devkar, Vikas" userId="acbd15ec-55d1-4a76-83ac-3f1d82711ed5" providerId="ADAL" clId="{4C57031F-CE5B-445E-A32C-D89C534CEBBB}" dt="2024-03-04T23:17:47.530" v="75" actId="165"/>
          <ac:spMkLst>
            <pc:docMk/>
            <pc:sldMk cId="3436963830" sldId="268"/>
            <ac:spMk id="18" creationId="{960DF679-7213-653B-F493-8B5F28F4D5E8}"/>
          </ac:spMkLst>
        </pc:spChg>
        <pc:spChg chg="mod topLvl">
          <ac:chgData name="Devkar, Vikas" userId="acbd15ec-55d1-4a76-83ac-3f1d82711ed5" providerId="ADAL" clId="{4C57031F-CE5B-445E-A32C-D89C534CEBBB}" dt="2024-03-04T23:17:47.530" v="75" actId="165"/>
          <ac:spMkLst>
            <pc:docMk/>
            <pc:sldMk cId="3436963830" sldId="268"/>
            <ac:spMk id="19" creationId="{B8E01842-BC3E-B15D-6CCB-C2981BD13501}"/>
          </ac:spMkLst>
        </pc:spChg>
        <pc:spChg chg="mod topLvl">
          <ac:chgData name="Devkar, Vikas" userId="acbd15ec-55d1-4a76-83ac-3f1d82711ed5" providerId="ADAL" clId="{4C57031F-CE5B-445E-A32C-D89C534CEBBB}" dt="2024-03-04T23:17:47.530" v="75" actId="165"/>
          <ac:spMkLst>
            <pc:docMk/>
            <pc:sldMk cId="3436963830" sldId="268"/>
            <ac:spMk id="22" creationId="{4A4ABF86-6944-3665-C48A-F7A09380ECC1}"/>
          </ac:spMkLst>
        </pc:spChg>
        <pc:spChg chg="mod topLvl">
          <ac:chgData name="Devkar, Vikas" userId="acbd15ec-55d1-4a76-83ac-3f1d82711ed5" providerId="ADAL" clId="{4C57031F-CE5B-445E-A32C-D89C534CEBBB}" dt="2024-03-04T23:17:47.530" v="75" actId="165"/>
          <ac:spMkLst>
            <pc:docMk/>
            <pc:sldMk cId="3436963830" sldId="268"/>
            <ac:spMk id="23" creationId="{FB5CF552-A5E3-4F48-1AD1-D0608C575C78}"/>
          </ac:spMkLst>
        </pc:spChg>
        <pc:grpChg chg="add del mod">
          <ac:chgData name="Devkar, Vikas" userId="acbd15ec-55d1-4a76-83ac-3f1d82711ed5" providerId="ADAL" clId="{4C57031F-CE5B-445E-A32C-D89C534CEBBB}" dt="2024-03-04T23:17:47.530" v="75" actId="165"/>
          <ac:grpSpMkLst>
            <pc:docMk/>
            <pc:sldMk cId="3436963830" sldId="268"/>
            <ac:grpSpMk id="27" creationId="{67B25A3F-81F5-AA0C-689D-CB2DEE57F6E2}"/>
          </ac:grpSpMkLst>
        </pc:grpChg>
        <pc:picChg chg="mod topLvl">
          <ac:chgData name="Devkar, Vikas" userId="acbd15ec-55d1-4a76-83ac-3f1d82711ed5" providerId="ADAL" clId="{4C57031F-CE5B-445E-A32C-D89C534CEBBB}" dt="2024-03-04T23:17:47.530" v="75" actId="165"/>
          <ac:picMkLst>
            <pc:docMk/>
            <pc:sldMk cId="3436963830" sldId="268"/>
            <ac:picMk id="14" creationId="{18E808FE-3EC6-BFF3-1185-6BF7863BC5AF}"/>
          </ac:picMkLst>
        </pc:picChg>
        <pc:picChg chg="mod topLvl">
          <ac:chgData name="Devkar, Vikas" userId="acbd15ec-55d1-4a76-83ac-3f1d82711ed5" providerId="ADAL" clId="{4C57031F-CE5B-445E-A32C-D89C534CEBBB}" dt="2024-03-04T23:17:47.530" v="75" actId="165"/>
          <ac:picMkLst>
            <pc:docMk/>
            <pc:sldMk cId="3436963830" sldId="268"/>
            <ac:picMk id="16" creationId="{114B3300-01A6-F68F-BDC5-E897144152B2}"/>
          </ac:picMkLst>
        </pc:picChg>
      </pc:sldChg>
      <pc:sldChg chg="modSp mod">
        <pc:chgData name="Devkar, Vikas" userId="acbd15ec-55d1-4a76-83ac-3f1d82711ed5" providerId="ADAL" clId="{4C57031F-CE5B-445E-A32C-D89C534CEBBB}" dt="2024-03-05T01:34:03.042" v="213" actId="404"/>
        <pc:sldMkLst>
          <pc:docMk/>
          <pc:sldMk cId="941570768" sldId="271"/>
        </pc:sldMkLst>
        <pc:spChg chg="mod">
          <ac:chgData name="Devkar, Vikas" userId="acbd15ec-55d1-4a76-83ac-3f1d82711ed5" providerId="ADAL" clId="{4C57031F-CE5B-445E-A32C-D89C534CEBBB}" dt="2024-03-05T01:34:03.042" v="213" actId="404"/>
          <ac:spMkLst>
            <pc:docMk/>
            <pc:sldMk cId="941570768" sldId="271"/>
            <ac:spMk id="5" creationId="{E880AF6A-641C-F67F-BA37-ED8AA5C0C046}"/>
          </ac:spMkLst>
        </pc:spChg>
      </pc:sldChg>
      <pc:sldChg chg="addSp delSp modSp new mod">
        <pc:chgData name="Devkar, Vikas" userId="acbd15ec-55d1-4a76-83ac-3f1d82711ed5" providerId="ADAL" clId="{4C57031F-CE5B-445E-A32C-D89C534CEBBB}" dt="2024-03-04T05:36:56.995" v="20" actId="1076"/>
        <pc:sldMkLst>
          <pc:docMk/>
          <pc:sldMk cId="772256198" sldId="272"/>
        </pc:sldMkLst>
        <pc:spChg chg="del">
          <ac:chgData name="Devkar, Vikas" userId="acbd15ec-55d1-4a76-83ac-3f1d82711ed5" providerId="ADAL" clId="{4C57031F-CE5B-445E-A32C-D89C534CEBBB}" dt="2024-03-04T05:33:29.044" v="11" actId="478"/>
          <ac:spMkLst>
            <pc:docMk/>
            <pc:sldMk cId="772256198" sldId="272"/>
            <ac:spMk id="2" creationId="{06C3A3B9-D815-BAE8-1CE4-349AA816FAD8}"/>
          </ac:spMkLst>
        </pc:spChg>
        <pc:spChg chg="del">
          <ac:chgData name="Devkar, Vikas" userId="acbd15ec-55d1-4a76-83ac-3f1d82711ed5" providerId="ADAL" clId="{4C57031F-CE5B-445E-A32C-D89C534CEBBB}" dt="2024-03-04T05:33:27.662" v="10" actId="478"/>
          <ac:spMkLst>
            <pc:docMk/>
            <pc:sldMk cId="772256198" sldId="272"/>
            <ac:spMk id="3" creationId="{E737E825-5BAD-8E74-C6A0-C7A1A7ED9C42}"/>
          </ac:spMkLst>
        </pc:spChg>
        <pc:spChg chg="add mod">
          <ac:chgData name="Devkar, Vikas" userId="acbd15ec-55d1-4a76-83ac-3f1d82711ed5" providerId="ADAL" clId="{4C57031F-CE5B-445E-A32C-D89C534CEBBB}" dt="2024-03-04T05:36:56.995" v="20" actId="1076"/>
          <ac:spMkLst>
            <pc:docMk/>
            <pc:sldMk cId="772256198" sldId="272"/>
            <ac:spMk id="4" creationId="{E4C81445-1EAB-00F3-7486-62DEE31864C2}"/>
          </ac:spMkLst>
        </pc:spChg>
        <pc:spChg chg="mod">
          <ac:chgData name="Devkar, Vikas" userId="acbd15ec-55d1-4a76-83ac-3f1d82711ed5" providerId="ADAL" clId="{4C57031F-CE5B-445E-A32C-D89C534CEBBB}" dt="2024-03-04T05:36:09.038" v="12"/>
          <ac:spMkLst>
            <pc:docMk/>
            <pc:sldMk cId="772256198" sldId="272"/>
            <ac:spMk id="6" creationId="{5D17B958-1EE1-0EA3-76AE-6760B4925FC0}"/>
          </ac:spMkLst>
        </pc:spChg>
        <pc:spChg chg="mod">
          <ac:chgData name="Devkar, Vikas" userId="acbd15ec-55d1-4a76-83ac-3f1d82711ed5" providerId="ADAL" clId="{4C57031F-CE5B-445E-A32C-D89C534CEBBB}" dt="2024-03-04T05:36:09.038" v="12"/>
          <ac:spMkLst>
            <pc:docMk/>
            <pc:sldMk cId="772256198" sldId="272"/>
            <ac:spMk id="7" creationId="{123621FA-E058-F15D-98C3-361A69F62216}"/>
          </ac:spMkLst>
        </pc:spChg>
        <pc:spChg chg="add mod">
          <ac:chgData name="Devkar, Vikas" userId="acbd15ec-55d1-4a76-83ac-3f1d82711ed5" providerId="ADAL" clId="{4C57031F-CE5B-445E-A32C-D89C534CEBBB}" dt="2024-03-04T05:36:16.099" v="13" actId="1076"/>
          <ac:spMkLst>
            <pc:docMk/>
            <pc:sldMk cId="772256198" sldId="272"/>
            <ac:spMk id="8" creationId="{E57B8A66-9E60-47EC-F7ED-18211D405291}"/>
          </ac:spMkLst>
        </pc:spChg>
        <pc:spChg chg="mod">
          <ac:chgData name="Devkar, Vikas" userId="acbd15ec-55d1-4a76-83ac-3f1d82711ed5" providerId="ADAL" clId="{4C57031F-CE5B-445E-A32C-D89C534CEBBB}" dt="2024-03-04T05:36:09.038" v="12"/>
          <ac:spMkLst>
            <pc:docMk/>
            <pc:sldMk cId="772256198" sldId="272"/>
            <ac:spMk id="11" creationId="{8CC0804C-C58D-8565-0819-AE4128730A64}"/>
          </ac:spMkLst>
        </pc:spChg>
        <pc:spChg chg="mod">
          <ac:chgData name="Devkar, Vikas" userId="acbd15ec-55d1-4a76-83ac-3f1d82711ed5" providerId="ADAL" clId="{4C57031F-CE5B-445E-A32C-D89C534CEBBB}" dt="2024-03-04T05:36:09.038" v="12"/>
          <ac:spMkLst>
            <pc:docMk/>
            <pc:sldMk cId="772256198" sldId="272"/>
            <ac:spMk id="12" creationId="{2AC9A58C-ED25-F3E1-254A-3BE36BA5018C}"/>
          </ac:spMkLst>
        </pc:spChg>
        <pc:spChg chg="mod">
          <ac:chgData name="Devkar, Vikas" userId="acbd15ec-55d1-4a76-83ac-3f1d82711ed5" providerId="ADAL" clId="{4C57031F-CE5B-445E-A32C-D89C534CEBBB}" dt="2024-03-04T05:36:09.038" v="12"/>
          <ac:spMkLst>
            <pc:docMk/>
            <pc:sldMk cId="772256198" sldId="272"/>
            <ac:spMk id="13" creationId="{39823866-0E42-92D4-9B94-88BD0356A152}"/>
          </ac:spMkLst>
        </pc:spChg>
        <pc:spChg chg="mod">
          <ac:chgData name="Devkar, Vikas" userId="acbd15ec-55d1-4a76-83ac-3f1d82711ed5" providerId="ADAL" clId="{4C57031F-CE5B-445E-A32C-D89C534CEBBB}" dt="2024-03-04T05:36:09.038" v="12"/>
          <ac:spMkLst>
            <pc:docMk/>
            <pc:sldMk cId="772256198" sldId="272"/>
            <ac:spMk id="14" creationId="{0BEC45F6-919B-5ED4-8982-07CE55AFA23B}"/>
          </ac:spMkLst>
        </pc:spChg>
        <pc:spChg chg="add mod">
          <ac:chgData name="Devkar, Vikas" userId="acbd15ec-55d1-4a76-83ac-3f1d82711ed5" providerId="ADAL" clId="{4C57031F-CE5B-445E-A32C-D89C534CEBBB}" dt="2024-03-04T05:36:16.099" v="13" actId="1076"/>
          <ac:spMkLst>
            <pc:docMk/>
            <pc:sldMk cId="772256198" sldId="272"/>
            <ac:spMk id="16" creationId="{D4CEEA4B-3B35-40CC-546B-22586996DDA5}"/>
          </ac:spMkLst>
        </pc:spChg>
        <pc:spChg chg="add mod">
          <ac:chgData name="Devkar, Vikas" userId="acbd15ec-55d1-4a76-83ac-3f1d82711ed5" providerId="ADAL" clId="{4C57031F-CE5B-445E-A32C-D89C534CEBBB}" dt="2024-03-04T05:36:16.099" v="13" actId="1076"/>
          <ac:spMkLst>
            <pc:docMk/>
            <pc:sldMk cId="772256198" sldId="272"/>
            <ac:spMk id="17" creationId="{447966F1-473C-AEFB-276D-3B1100CFCB7F}"/>
          </ac:spMkLst>
        </pc:spChg>
        <pc:spChg chg="add mod">
          <ac:chgData name="Devkar, Vikas" userId="acbd15ec-55d1-4a76-83ac-3f1d82711ed5" providerId="ADAL" clId="{4C57031F-CE5B-445E-A32C-D89C534CEBBB}" dt="2024-03-04T05:36:16.099" v="13" actId="1076"/>
          <ac:spMkLst>
            <pc:docMk/>
            <pc:sldMk cId="772256198" sldId="272"/>
            <ac:spMk id="18" creationId="{C415C4D6-C72F-294C-AEB6-1B0B5D38AFF3}"/>
          </ac:spMkLst>
        </pc:spChg>
        <pc:spChg chg="add mod">
          <ac:chgData name="Devkar, Vikas" userId="acbd15ec-55d1-4a76-83ac-3f1d82711ed5" providerId="ADAL" clId="{4C57031F-CE5B-445E-A32C-D89C534CEBBB}" dt="2024-03-04T05:36:16.099" v="13" actId="1076"/>
          <ac:spMkLst>
            <pc:docMk/>
            <pc:sldMk cId="772256198" sldId="272"/>
            <ac:spMk id="19" creationId="{8955DEA9-AD69-6D12-A5D2-F6AD4D7542C9}"/>
          </ac:spMkLst>
        </pc:spChg>
        <pc:spChg chg="add mod">
          <ac:chgData name="Devkar, Vikas" userId="acbd15ec-55d1-4a76-83ac-3f1d82711ed5" providerId="ADAL" clId="{4C57031F-CE5B-445E-A32C-D89C534CEBBB}" dt="2024-03-04T05:36:16.099" v="13" actId="1076"/>
          <ac:spMkLst>
            <pc:docMk/>
            <pc:sldMk cId="772256198" sldId="272"/>
            <ac:spMk id="20" creationId="{944C9719-4B31-8FD3-89CA-2C18C7858077}"/>
          </ac:spMkLst>
        </pc:spChg>
        <pc:spChg chg="add mod">
          <ac:chgData name="Devkar, Vikas" userId="acbd15ec-55d1-4a76-83ac-3f1d82711ed5" providerId="ADAL" clId="{4C57031F-CE5B-445E-A32C-D89C534CEBBB}" dt="2024-03-04T05:36:16.099" v="13" actId="1076"/>
          <ac:spMkLst>
            <pc:docMk/>
            <pc:sldMk cId="772256198" sldId="272"/>
            <ac:spMk id="21" creationId="{6C062BE2-F528-40C1-6AE7-EB44D8354782}"/>
          </ac:spMkLst>
        </pc:spChg>
        <pc:spChg chg="add mod">
          <ac:chgData name="Devkar, Vikas" userId="acbd15ec-55d1-4a76-83ac-3f1d82711ed5" providerId="ADAL" clId="{4C57031F-CE5B-445E-A32C-D89C534CEBBB}" dt="2024-03-04T05:36:16.099" v="13" actId="1076"/>
          <ac:spMkLst>
            <pc:docMk/>
            <pc:sldMk cId="772256198" sldId="272"/>
            <ac:spMk id="22" creationId="{4EF055B9-3139-1580-6A88-CD9C82F73064}"/>
          </ac:spMkLst>
        </pc:spChg>
        <pc:spChg chg="add mod">
          <ac:chgData name="Devkar, Vikas" userId="acbd15ec-55d1-4a76-83ac-3f1d82711ed5" providerId="ADAL" clId="{4C57031F-CE5B-445E-A32C-D89C534CEBBB}" dt="2024-03-04T05:36:16.099" v="13" actId="1076"/>
          <ac:spMkLst>
            <pc:docMk/>
            <pc:sldMk cId="772256198" sldId="272"/>
            <ac:spMk id="23" creationId="{AF58460E-B6DE-4C5D-BE0B-15D33B3C9924}"/>
          </ac:spMkLst>
        </pc:spChg>
        <pc:spChg chg="mod">
          <ac:chgData name="Devkar, Vikas" userId="acbd15ec-55d1-4a76-83ac-3f1d82711ed5" providerId="ADAL" clId="{4C57031F-CE5B-445E-A32C-D89C534CEBBB}" dt="2024-03-04T05:36:09.038" v="12"/>
          <ac:spMkLst>
            <pc:docMk/>
            <pc:sldMk cId="772256198" sldId="272"/>
            <ac:spMk id="27" creationId="{D57BCDEF-6E0F-0F5F-A093-225BF252614D}"/>
          </ac:spMkLst>
        </pc:spChg>
        <pc:spChg chg="add mod">
          <ac:chgData name="Devkar, Vikas" userId="acbd15ec-55d1-4a76-83ac-3f1d82711ed5" providerId="ADAL" clId="{4C57031F-CE5B-445E-A32C-D89C534CEBBB}" dt="2024-03-04T05:36:16.099" v="13" actId="1076"/>
          <ac:spMkLst>
            <pc:docMk/>
            <pc:sldMk cId="772256198" sldId="272"/>
            <ac:spMk id="34" creationId="{FAFBD998-8BE6-2779-A011-60DE9DC1B3DC}"/>
          </ac:spMkLst>
        </pc:spChg>
        <pc:spChg chg="add mod">
          <ac:chgData name="Devkar, Vikas" userId="acbd15ec-55d1-4a76-83ac-3f1d82711ed5" providerId="ADAL" clId="{4C57031F-CE5B-445E-A32C-D89C534CEBBB}" dt="2024-03-04T05:36:16.099" v="13" actId="1076"/>
          <ac:spMkLst>
            <pc:docMk/>
            <pc:sldMk cId="772256198" sldId="272"/>
            <ac:spMk id="35" creationId="{C3A9FB89-5E86-173D-D67C-10506CCB5D4A}"/>
          </ac:spMkLst>
        </pc:spChg>
        <pc:spChg chg="add mod">
          <ac:chgData name="Devkar, Vikas" userId="acbd15ec-55d1-4a76-83ac-3f1d82711ed5" providerId="ADAL" clId="{4C57031F-CE5B-445E-A32C-D89C534CEBBB}" dt="2024-03-04T05:36:16.099" v="13" actId="1076"/>
          <ac:spMkLst>
            <pc:docMk/>
            <pc:sldMk cId="772256198" sldId="272"/>
            <ac:spMk id="36" creationId="{99078F0F-D8C7-9509-5AA3-395892F1249F}"/>
          </ac:spMkLst>
        </pc:spChg>
        <pc:spChg chg="add mod">
          <ac:chgData name="Devkar, Vikas" userId="acbd15ec-55d1-4a76-83ac-3f1d82711ed5" providerId="ADAL" clId="{4C57031F-CE5B-445E-A32C-D89C534CEBBB}" dt="2024-03-04T05:36:16.099" v="13" actId="1076"/>
          <ac:spMkLst>
            <pc:docMk/>
            <pc:sldMk cId="772256198" sldId="272"/>
            <ac:spMk id="37" creationId="{F7820877-798A-BF31-5206-FEE89DACD1A6}"/>
          </ac:spMkLst>
        </pc:spChg>
        <pc:spChg chg="add mod">
          <ac:chgData name="Devkar, Vikas" userId="acbd15ec-55d1-4a76-83ac-3f1d82711ed5" providerId="ADAL" clId="{4C57031F-CE5B-445E-A32C-D89C534CEBBB}" dt="2024-03-04T05:36:16.099" v="13" actId="1076"/>
          <ac:spMkLst>
            <pc:docMk/>
            <pc:sldMk cId="772256198" sldId="272"/>
            <ac:spMk id="38" creationId="{709FC594-9532-6634-2186-9F66211AE1F7}"/>
          </ac:spMkLst>
        </pc:spChg>
        <pc:spChg chg="add mod">
          <ac:chgData name="Devkar, Vikas" userId="acbd15ec-55d1-4a76-83ac-3f1d82711ed5" providerId="ADAL" clId="{4C57031F-CE5B-445E-A32C-D89C534CEBBB}" dt="2024-03-04T05:36:16.099" v="13" actId="1076"/>
          <ac:spMkLst>
            <pc:docMk/>
            <pc:sldMk cId="772256198" sldId="272"/>
            <ac:spMk id="39" creationId="{C6354B1A-3D7E-2793-B296-A00940812151}"/>
          </ac:spMkLst>
        </pc:spChg>
        <pc:spChg chg="add mod">
          <ac:chgData name="Devkar, Vikas" userId="acbd15ec-55d1-4a76-83ac-3f1d82711ed5" providerId="ADAL" clId="{4C57031F-CE5B-445E-A32C-D89C534CEBBB}" dt="2024-03-04T05:36:16.099" v="13" actId="1076"/>
          <ac:spMkLst>
            <pc:docMk/>
            <pc:sldMk cId="772256198" sldId="272"/>
            <ac:spMk id="40" creationId="{7AD1DEDE-1212-2E0B-7FFF-B0ECA8E8EB8C}"/>
          </ac:spMkLst>
        </pc:spChg>
        <pc:spChg chg="add mod">
          <ac:chgData name="Devkar, Vikas" userId="acbd15ec-55d1-4a76-83ac-3f1d82711ed5" providerId="ADAL" clId="{4C57031F-CE5B-445E-A32C-D89C534CEBBB}" dt="2024-03-04T05:36:16.099" v="13" actId="1076"/>
          <ac:spMkLst>
            <pc:docMk/>
            <pc:sldMk cId="772256198" sldId="272"/>
            <ac:spMk id="41" creationId="{141E5450-3917-22B2-B21F-B9D069AA22BE}"/>
          </ac:spMkLst>
        </pc:spChg>
        <pc:spChg chg="add mod">
          <ac:chgData name="Devkar, Vikas" userId="acbd15ec-55d1-4a76-83ac-3f1d82711ed5" providerId="ADAL" clId="{4C57031F-CE5B-445E-A32C-D89C534CEBBB}" dt="2024-03-04T05:36:16.099" v="13" actId="1076"/>
          <ac:spMkLst>
            <pc:docMk/>
            <pc:sldMk cId="772256198" sldId="272"/>
            <ac:spMk id="42" creationId="{E3E8A54A-32AF-E185-F0C8-8AE13780008A}"/>
          </ac:spMkLst>
        </pc:spChg>
        <pc:spChg chg="add mod">
          <ac:chgData name="Devkar, Vikas" userId="acbd15ec-55d1-4a76-83ac-3f1d82711ed5" providerId="ADAL" clId="{4C57031F-CE5B-445E-A32C-D89C534CEBBB}" dt="2024-03-04T05:36:16.099" v="13" actId="1076"/>
          <ac:spMkLst>
            <pc:docMk/>
            <pc:sldMk cId="772256198" sldId="272"/>
            <ac:spMk id="43" creationId="{68884778-9AA0-6DB5-2A40-E501E0E8ED61}"/>
          </ac:spMkLst>
        </pc:spChg>
        <pc:spChg chg="add mod">
          <ac:chgData name="Devkar, Vikas" userId="acbd15ec-55d1-4a76-83ac-3f1d82711ed5" providerId="ADAL" clId="{4C57031F-CE5B-445E-A32C-D89C534CEBBB}" dt="2024-03-04T05:36:16.099" v="13" actId="1076"/>
          <ac:spMkLst>
            <pc:docMk/>
            <pc:sldMk cId="772256198" sldId="272"/>
            <ac:spMk id="45" creationId="{383EE8E3-DD5D-AEE8-D3F0-71D1CFCBBFCE}"/>
          </ac:spMkLst>
        </pc:spChg>
        <pc:spChg chg="add mod">
          <ac:chgData name="Devkar, Vikas" userId="acbd15ec-55d1-4a76-83ac-3f1d82711ed5" providerId="ADAL" clId="{4C57031F-CE5B-445E-A32C-D89C534CEBBB}" dt="2024-03-04T05:36:16.099" v="13" actId="1076"/>
          <ac:spMkLst>
            <pc:docMk/>
            <pc:sldMk cId="772256198" sldId="272"/>
            <ac:spMk id="46" creationId="{2CBAFBF7-13A2-5347-B1A6-440A099F4BCC}"/>
          </ac:spMkLst>
        </pc:spChg>
        <pc:spChg chg="add mod">
          <ac:chgData name="Devkar, Vikas" userId="acbd15ec-55d1-4a76-83ac-3f1d82711ed5" providerId="ADAL" clId="{4C57031F-CE5B-445E-A32C-D89C534CEBBB}" dt="2024-03-04T05:36:16.099" v="13" actId="1076"/>
          <ac:spMkLst>
            <pc:docMk/>
            <pc:sldMk cId="772256198" sldId="272"/>
            <ac:spMk id="47" creationId="{4DBDEFDC-A96A-DC15-A973-45E469764A2B}"/>
          </ac:spMkLst>
        </pc:spChg>
        <pc:spChg chg="add mod">
          <ac:chgData name="Devkar, Vikas" userId="acbd15ec-55d1-4a76-83ac-3f1d82711ed5" providerId="ADAL" clId="{4C57031F-CE5B-445E-A32C-D89C534CEBBB}" dt="2024-03-04T05:36:16.099" v="13" actId="1076"/>
          <ac:spMkLst>
            <pc:docMk/>
            <pc:sldMk cId="772256198" sldId="272"/>
            <ac:spMk id="48" creationId="{6C705168-5731-8AEB-4AC6-77330158F270}"/>
          </ac:spMkLst>
        </pc:spChg>
        <pc:spChg chg="add mod">
          <ac:chgData name="Devkar, Vikas" userId="acbd15ec-55d1-4a76-83ac-3f1d82711ed5" providerId="ADAL" clId="{4C57031F-CE5B-445E-A32C-D89C534CEBBB}" dt="2024-03-04T05:36:16.099" v="13" actId="1076"/>
          <ac:spMkLst>
            <pc:docMk/>
            <pc:sldMk cId="772256198" sldId="272"/>
            <ac:spMk id="49" creationId="{A1FCD7E7-BC40-1E54-F0C7-70E5829602BA}"/>
          </ac:spMkLst>
        </pc:spChg>
        <pc:spChg chg="add mod">
          <ac:chgData name="Devkar, Vikas" userId="acbd15ec-55d1-4a76-83ac-3f1d82711ed5" providerId="ADAL" clId="{4C57031F-CE5B-445E-A32C-D89C534CEBBB}" dt="2024-03-04T05:36:16.099" v="13" actId="1076"/>
          <ac:spMkLst>
            <pc:docMk/>
            <pc:sldMk cId="772256198" sldId="272"/>
            <ac:spMk id="50" creationId="{129F6921-1EAD-5244-837D-2D002E5558BD}"/>
          </ac:spMkLst>
        </pc:spChg>
        <pc:spChg chg="add mod">
          <ac:chgData name="Devkar, Vikas" userId="acbd15ec-55d1-4a76-83ac-3f1d82711ed5" providerId="ADAL" clId="{4C57031F-CE5B-445E-A32C-D89C534CEBBB}" dt="2024-03-04T05:36:16.099" v="13" actId="1076"/>
          <ac:spMkLst>
            <pc:docMk/>
            <pc:sldMk cId="772256198" sldId="272"/>
            <ac:spMk id="54" creationId="{41CECA81-658A-A7EA-75C9-35EDFD8540B1}"/>
          </ac:spMkLst>
        </pc:spChg>
        <pc:spChg chg="add mod">
          <ac:chgData name="Devkar, Vikas" userId="acbd15ec-55d1-4a76-83ac-3f1d82711ed5" providerId="ADAL" clId="{4C57031F-CE5B-445E-A32C-D89C534CEBBB}" dt="2024-03-04T05:36:16.099" v="13" actId="1076"/>
          <ac:spMkLst>
            <pc:docMk/>
            <pc:sldMk cId="772256198" sldId="272"/>
            <ac:spMk id="55" creationId="{0B957C6F-396F-DD33-BE28-7EA9A96E35F5}"/>
          </ac:spMkLst>
        </pc:spChg>
        <pc:spChg chg="add mod">
          <ac:chgData name="Devkar, Vikas" userId="acbd15ec-55d1-4a76-83ac-3f1d82711ed5" providerId="ADAL" clId="{4C57031F-CE5B-445E-A32C-D89C534CEBBB}" dt="2024-03-04T05:36:16.099" v="13" actId="1076"/>
          <ac:spMkLst>
            <pc:docMk/>
            <pc:sldMk cId="772256198" sldId="272"/>
            <ac:spMk id="56" creationId="{C68065D4-9E2C-56C4-BD4B-034A1F9DB1CC}"/>
          </ac:spMkLst>
        </pc:spChg>
        <pc:spChg chg="add mod">
          <ac:chgData name="Devkar, Vikas" userId="acbd15ec-55d1-4a76-83ac-3f1d82711ed5" providerId="ADAL" clId="{4C57031F-CE5B-445E-A32C-D89C534CEBBB}" dt="2024-03-04T05:36:16.099" v="13" actId="1076"/>
          <ac:spMkLst>
            <pc:docMk/>
            <pc:sldMk cId="772256198" sldId="272"/>
            <ac:spMk id="57" creationId="{3188760C-32E0-6D76-348C-E271EEC907FE}"/>
          </ac:spMkLst>
        </pc:spChg>
        <pc:spChg chg="add mod">
          <ac:chgData name="Devkar, Vikas" userId="acbd15ec-55d1-4a76-83ac-3f1d82711ed5" providerId="ADAL" clId="{4C57031F-CE5B-445E-A32C-D89C534CEBBB}" dt="2024-03-04T05:36:27.548" v="14" actId="1076"/>
          <ac:spMkLst>
            <pc:docMk/>
            <pc:sldMk cId="772256198" sldId="272"/>
            <ac:spMk id="58" creationId="{FE595C0C-3FCE-23A2-FBC5-E48FE30DAB14}"/>
          </ac:spMkLst>
        </pc:spChg>
        <pc:spChg chg="add mod">
          <ac:chgData name="Devkar, Vikas" userId="acbd15ec-55d1-4a76-83ac-3f1d82711ed5" providerId="ADAL" clId="{4C57031F-CE5B-445E-A32C-D89C534CEBBB}" dt="2024-03-04T05:36:16.099" v="13" actId="1076"/>
          <ac:spMkLst>
            <pc:docMk/>
            <pc:sldMk cId="772256198" sldId="272"/>
            <ac:spMk id="59" creationId="{B69D8266-F48A-E479-352B-74E5C3C031AF}"/>
          </ac:spMkLst>
        </pc:spChg>
        <pc:spChg chg="add mod">
          <ac:chgData name="Devkar, Vikas" userId="acbd15ec-55d1-4a76-83ac-3f1d82711ed5" providerId="ADAL" clId="{4C57031F-CE5B-445E-A32C-D89C534CEBBB}" dt="2024-03-04T05:36:16.099" v="13" actId="1076"/>
          <ac:spMkLst>
            <pc:docMk/>
            <pc:sldMk cId="772256198" sldId="272"/>
            <ac:spMk id="60" creationId="{6F598399-95DC-0936-2E57-18C0A621E480}"/>
          </ac:spMkLst>
        </pc:spChg>
        <pc:spChg chg="add mod">
          <ac:chgData name="Devkar, Vikas" userId="acbd15ec-55d1-4a76-83ac-3f1d82711ed5" providerId="ADAL" clId="{4C57031F-CE5B-445E-A32C-D89C534CEBBB}" dt="2024-03-04T05:36:16.099" v="13" actId="1076"/>
          <ac:spMkLst>
            <pc:docMk/>
            <pc:sldMk cId="772256198" sldId="272"/>
            <ac:spMk id="61" creationId="{1FE920F1-C77F-BD93-9C4E-864C876D37EB}"/>
          </ac:spMkLst>
        </pc:spChg>
        <pc:spChg chg="add mod">
          <ac:chgData name="Devkar, Vikas" userId="acbd15ec-55d1-4a76-83ac-3f1d82711ed5" providerId="ADAL" clId="{4C57031F-CE5B-445E-A32C-D89C534CEBBB}" dt="2024-03-04T05:36:16.099" v="13" actId="1076"/>
          <ac:spMkLst>
            <pc:docMk/>
            <pc:sldMk cId="772256198" sldId="272"/>
            <ac:spMk id="62" creationId="{55969B5E-C7A9-22E9-5E9B-024D2E37E2E9}"/>
          </ac:spMkLst>
        </pc:spChg>
        <pc:spChg chg="add mod">
          <ac:chgData name="Devkar, Vikas" userId="acbd15ec-55d1-4a76-83ac-3f1d82711ed5" providerId="ADAL" clId="{4C57031F-CE5B-445E-A32C-D89C534CEBBB}" dt="2024-03-04T05:36:16.099" v="13" actId="1076"/>
          <ac:spMkLst>
            <pc:docMk/>
            <pc:sldMk cId="772256198" sldId="272"/>
            <ac:spMk id="63" creationId="{31571886-81F7-758F-F983-BE0EB9B9BF1F}"/>
          </ac:spMkLst>
        </pc:spChg>
        <pc:spChg chg="add mod">
          <ac:chgData name="Devkar, Vikas" userId="acbd15ec-55d1-4a76-83ac-3f1d82711ed5" providerId="ADAL" clId="{4C57031F-CE5B-445E-A32C-D89C534CEBBB}" dt="2024-03-04T05:36:16.099" v="13" actId="1076"/>
          <ac:spMkLst>
            <pc:docMk/>
            <pc:sldMk cId="772256198" sldId="272"/>
            <ac:spMk id="65" creationId="{B6C5A99C-4691-EBD6-C877-A391DD8EC426}"/>
          </ac:spMkLst>
        </pc:spChg>
        <pc:spChg chg="add mod">
          <ac:chgData name="Devkar, Vikas" userId="acbd15ec-55d1-4a76-83ac-3f1d82711ed5" providerId="ADAL" clId="{4C57031F-CE5B-445E-A32C-D89C534CEBBB}" dt="2024-03-04T05:36:16.099" v="13" actId="1076"/>
          <ac:spMkLst>
            <pc:docMk/>
            <pc:sldMk cId="772256198" sldId="272"/>
            <ac:spMk id="68" creationId="{41D3BC48-3653-6BB1-DCFC-EA8CB476F8D1}"/>
          </ac:spMkLst>
        </pc:spChg>
        <pc:spChg chg="add mod">
          <ac:chgData name="Devkar, Vikas" userId="acbd15ec-55d1-4a76-83ac-3f1d82711ed5" providerId="ADAL" clId="{4C57031F-CE5B-445E-A32C-D89C534CEBBB}" dt="2024-03-04T05:36:16.099" v="13" actId="1076"/>
          <ac:spMkLst>
            <pc:docMk/>
            <pc:sldMk cId="772256198" sldId="272"/>
            <ac:spMk id="70" creationId="{AA63526D-9F3A-46BD-E5DF-3738C1B49E7A}"/>
          </ac:spMkLst>
        </pc:spChg>
        <pc:spChg chg="add mod">
          <ac:chgData name="Devkar, Vikas" userId="acbd15ec-55d1-4a76-83ac-3f1d82711ed5" providerId="ADAL" clId="{4C57031F-CE5B-445E-A32C-D89C534CEBBB}" dt="2024-03-04T05:36:16.099" v="13" actId="1076"/>
          <ac:spMkLst>
            <pc:docMk/>
            <pc:sldMk cId="772256198" sldId="272"/>
            <ac:spMk id="71" creationId="{B5DDA53F-E7D5-46BB-D0A9-2A771AE25E68}"/>
          </ac:spMkLst>
        </pc:spChg>
        <pc:spChg chg="add mod">
          <ac:chgData name="Devkar, Vikas" userId="acbd15ec-55d1-4a76-83ac-3f1d82711ed5" providerId="ADAL" clId="{4C57031F-CE5B-445E-A32C-D89C534CEBBB}" dt="2024-03-04T05:36:16.099" v="13" actId="1076"/>
          <ac:spMkLst>
            <pc:docMk/>
            <pc:sldMk cId="772256198" sldId="272"/>
            <ac:spMk id="72" creationId="{92061860-2EAF-B105-B181-23F50AE89B59}"/>
          </ac:spMkLst>
        </pc:spChg>
        <pc:spChg chg="add mod">
          <ac:chgData name="Devkar, Vikas" userId="acbd15ec-55d1-4a76-83ac-3f1d82711ed5" providerId="ADAL" clId="{4C57031F-CE5B-445E-A32C-D89C534CEBBB}" dt="2024-03-04T05:36:16.099" v="13" actId="1076"/>
          <ac:spMkLst>
            <pc:docMk/>
            <pc:sldMk cId="772256198" sldId="272"/>
            <ac:spMk id="75" creationId="{5149E9FB-09E2-48D3-A5A6-1B405B760B96}"/>
          </ac:spMkLst>
        </pc:spChg>
        <pc:spChg chg="add mod">
          <ac:chgData name="Devkar, Vikas" userId="acbd15ec-55d1-4a76-83ac-3f1d82711ed5" providerId="ADAL" clId="{4C57031F-CE5B-445E-A32C-D89C534CEBBB}" dt="2024-03-04T05:36:16.099" v="13" actId="1076"/>
          <ac:spMkLst>
            <pc:docMk/>
            <pc:sldMk cId="772256198" sldId="272"/>
            <ac:spMk id="76" creationId="{E49FC55B-A918-61CC-D2EC-DBEB794AD0EA}"/>
          </ac:spMkLst>
        </pc:spChg>
        <pc:spChg chg="add mod">
          <ac:chgData name="Devkar, Vikas" userId="acbd15ec-55d1-4a76-83ac-3f1d82711ed5" providerId="ADAL" clId="{4C57031F-CE5B-445E-A32C-D89C534CEBBB}" dt="2024-03-04T05:36:16.099" v="13" actId="1076"/>
          <ac:spMkLst>
            <pc:docMk/>
            <pc:sldMk cId="772256198" sldId="272"/>
            <ac:spMk id="77" creationId="{441EA215-E82E-4EC9-22D2-41ACBB2DD205}"/>
          </ac:spMkLst>
        </pc:spChg>
        <pc:spChg chg="add mod">
          <ac:chgData name="Devkar, Vikas" userId="acbd15ec-55d1-4a76-83ac-3f1d82711ed5" providerId="ADAL" clId="{4C57031F-CE5B-445E-A32C-D89C534CEBBB}" dt="2024-03-04T05:36:16.099" v="13" actId="1076"/>
          <ac:spMkLst>
            <pc:docMk/>
            <pc:sldMk cId="772256198" sldId="272"/>
            <ac:spMk id="78" creationId="{8142A9B5-030B-1CBA-801E-AEC7603D5155}"/>
          </ac:spMkLst>
        </pc:spChg>
        <pc:spChg chg="add mod">
          <ac:chgData name="Devkar, Vikas" userId="acbd15ec-55d1-4a76-83ac-3f1d82711ed5" providerId="ADAL" clId="{4C57031F-CE5B-445E-A32C-D89C534CEBBB}" dt="2024-03-04T05:36:16.099" v="13" actId="1076"/>
          <ac:spMkLst>
            <pc:docMk/>
            <pc:sldMk cId="772256198" sldId="272"/>
            <ac:spMk id="79" creationId="{84BE4B48-9BCB-3CE3-5107-F750B521BC2D}"/>
          </ac:spMkLst>
        </pc:spChg>
        <pc:spChg chg="add mod">
          <ac:chgData name="Devkar, Vikas" userId="acbd15ec-55d1-4a76-83ac-3f1d82711ed5" providerId="ADAL" clId="{4C57031F-CE5B-445E-A32C-D89C534CEBBB}" dt="2024-03-04T05:36:16.099" v="13" actId="1076"/>
          <ac:spMkLst>
            <pc:docMk/>
            <pc:sldMk cId="772256198" sldId="272"/>
            <ac:spMk id="86" creationId="{99178861-325D-989C-506D-0C9F030C6FA1}"/>
          </ac:spMkLst>
        </pc:spChg>
        <pc:spChg chg="add mod">
          <ac:chgData name="Devkar, Vikas" userId="acbd15ec-55d1-4a76-83ac-3f1d82711ed5" providerId="ADAL" clId="{4C57031F-CE5B-445E-A32C-D89C534CEBBB}" dt="2024-03-04T05:36:16.099" v="13" actId="1076"/>
          <ac:spMkLst>
            <pc:docMk/>
            <pc:sldMk cId="772256198" sldId="272"/>
            <ac:spMk id="89" creationId="{B291ED54-A00D-32C9-68D4-BF49BD36CB03}"/>
          </ac:spMkLst>
        </pc:spChg>
        <pc:spChg chg="add mod">
          <ac:chgData name="Devkar, Vikas" userId="acbd15ec-55d1-4a76-83ac-3f1d82711ed5" providerId="ADAL" clId="{4C57031F-CE5B-445E-A32C-D89C534CEBBB}" dt="2024-03-04T05:36:16.099" v="13" actId="1076"/>
          <ac:spMkLst>
            <pc:docMk/>
            <pc:sldMk cId="772256198" sldId="272"/>
            <ac:spMk id="90" creationId="{6B73E9B3-C328-D917-F5C2-F221BA7EF2BC}"/>
          </ac:spMkLst>
        </pc:spChg>
        <pc:spChg chg="add mod">
          <ac:chgData name="Devkar, Vikas" userId="acbd15ec-55d1-4a76-83ac-3f1d82711ed5" providerId="ADAL" clId="{4C57031F-CE5B-445E-A32C-D89C534CEBBB}" dt="2024-03-04T05:36:16.099" v="13" actId="1076"/>
          <ac:spMkLst>
            <pc:docMk/>
            <pc:sldMk cId="772256198" sldId="272"/>
            <ac:spMk id="91" creationId="{FA9566FD-8567-9182-DF9B-D9508D30CBA5}"/>
          </ac:spMkLst>
        </pc:spChg>
        <pc:spChg chg="add mod">
          <ac:chgData name="Devkar, Vikas" userId="acbd15ec-55d1-4a76-83ac-3f1d82711ed5" providerId="ADAL" clId="{4C57031F-CE5B-445E-A32C-D89C534CEBBB}" dt="2024-03-04T05:36:16.099" v="13" actId="1076"/>
          <ac:spMkLst>
            <pc:docMk/>
            <pc:sldMk cId="772256198" sldId="272"/>
            <ac:spMk id="92" creationId="{BBEE995D-067D-D71F-A72C-8B091B60506D}"/>
          </ac:spMkLst>
        </pc:spChg>
        <pc:spChg chg="add mod">
          <ac:chgData name="Devkar, Vikas" userId="acbd15ec-55d1-4a76-83ac-3f1d82711ed5" providerId="ADAL" clId="{4C57031F-CE5B-445E-A32C-D89C534CEBBB}" dt="2024-03-04T05:36:16.099" v="13" actId="1076"/>
          <ac:spMkLst>
            <pc:docMk/>
            <pc:sldMk cId="772256198" sldId="272"/>
            <ac:spMk id="93" creationId="{632098EA-09A0-B2AB-7F64-70BAC02832E0}"/>
          </ac:spMkLst>
        </pc:spChg>
        <pc:spChg chg="add mod">
          <ac:chgData name="Devkar, Vikas" userId="acbd15ec-55d1-4a76-83ac-3f1d82711ed5" providerId="ADAL" clId="{4C57031F-CE5B-445E-A32C-D89C534CEBBB}" dt="2024-03-04T05:36:16.099" v="13" actId="1076"/>
          <ac:spMkLst>
            <pc:docMk/>
            <pc:sldMk cId="772256198" sldId="272"/>
            <ac:spMk id="94" creationId="{B74091A6-AA5D-FB10-7415-3A020024F892}"/>
          </ac:spMkLst>
        </pc:spChg>
        <pc:spChg chg="add mod">
          <ac:chgData name="Devkar, Vikas" userId="acbd15ec-55d1-4a76-83ac-3f1d82711ed5" providerId="ADAL" clId="{4C57031F-CE5B-445E-A32C-D89C534CEBBB}" dt="2024-03-04T05:36:16.099" v="13" actId="1076"/>
          <ac:spMkLst>
            <pc:docMk/>
            <pc:sldMk cId="772256198" sldId="272"/>
            <ac:spMk id="95" creationId="{C382B18E-4434-FA74-7392-AC067C0B0156}"/>
          </ac:spMkLst>
        </pc:spChg>
        <pc:spChg chg="add mod">
          <ac:chgData name="Devkar, Vikas" userId="acbd15ec-55d1-4a76-83ac-3f1d82711ed5" providerId="ADAL" clId="{4C57031F-CE5B-445E-A32C-D89C534CEBBB}" dt="2024-03-04T05:36:16.099" v="13" actId="1076"/>
          <ac:spMkLst>
            <pc:docMk/>
            <pc:sldMk cId="772256198" sldId="272"/>
            <ac:spMk id="96" creationId="{146623D3-BDD6-4765-2BAE-0F74C2FC3EF3}"/>
          </ac:spMkLst>
        </pc:spChg>
        <pc:spChg chg="add mod">
          <ac:chgData name="Devkar, Vikas" userId="acbd15ec-55d1-4a76-83ac-3f1d82711ed5" providerId="ADAL" clId="{4C57031F-CE5B-445E-A32C-D89C534CEBBB}" dt="2024-03-04T05:36:16.099" v="13" actId="1076"/>
          <ac:spMkLst>
            <pc:docMk/>
            <pc:sldMk cId="772256198" sldId="272"/>
            <ac:spMk id="97" creationId="{F9CCDF51-EB4D-0C84-6D81-AA97F499319F}"/>
          </ac:spMkLst>
        </pc:spChg>
        <pc:spChg chg="add mod">
          <ac:chgData name="Devkar, Vikas" userId="acbd15ec-55d1-4a76-83ac-3f1d82711ed5" providerId="ADAL" clId="{4C57031F-CE5B-445E-A32C-D89C534CEBBB}" dt="2024-03-04T05:36:16.099" v="13" actId="1076"/>
          <ac:spMkLst>
            <pc:docMk/>
            <pc:sldMk cId="772256198" sldId="272"/>
            <ac:spMk id="100" creationId="{C214761B-99A9-AAF7-5753-65CE7A011559}"/>
          </ac:spMkLst>
        </pc:spChg>
        <pc:spChg chg="add mod">
          <ac:chgData name="Devkar, Vikas" userId="acbd15ec-55d1-4a76-83ac-3f1d82711ed5" providerId="ADAL" clId="{4C57031F-CE5B-445E-A32C-D89C534CEBBB}" dt="2024-03-04T05:36:16.099" v="13" actId="1076"/>
          <ac:spMkLst>
            <pc:docMk/>
            <pc:sldMk cId="772256198" sldId="272"/>
            <ac:spMk id="101" creationId="{191B14BA-69DF-C37C-381D-00F4AF8F6A74}"/>
          </ac:spMkLst>
        </pc:spChg>
        <pc:spChg chg="add mod">
          <ac:chgData name="Devkar, Vikas" userId="acbd15ec-55d1-4a76-83ac-3f1d82711ed5" providerId="ADAL" clId="{4C57031F-CE5B-445E-A32C-D89C534CEBBB}" dt="2024-03-04T05:36:16.099" v="13" actId="1076"/>
          <ac:spMkLst>
            <pc:docMk/>
            <pc:sldMk cId="772256198" sldId="272"/>
            <ac:spMk id="102" creationId="{EEBC657D-F3F7-DE2B-6113-928A0C21E034}"/>
          </ac:spMkLst>
        </pc:spChg>
        <pc:spChg chg="add mod">
          <ac:chgData name="Devkar, Vikas" userId="acbd15ec-55d1-4a76-83ac-3f1d82711ed5" providerId="ADAL" clId="{4C57031F-CE5B-445E-A32C-D89C534CEBBB}" dt="2024-03-04T05:36:16.099" v="13" actId="1076"/>
          <ac:spMkLst>
            <pc:docMk/>
            <pc:sldMk cId="772256198" sldId="272"/>
            <ac:spMk id="103" creationId="{0C977113-DC69-1B73-9F4D-7BEEEB556F86}"/>
          </ac:spMkLst>
        </pc:spChg>
        <pc:spChg chg="add mod">
          <ac:chgData name="Devkar, Vikas" userId="acbd15ec-55d1-4a76-83ac-3f1d82711ed5" providerId="ADAL" clId="{4C57031F-CE5B-445E-A32C-D89C534CEBBB}" dt="2024-03-04T05:36:16.099" v="13" actId="1076"/>
          <ac:spMkLst>
            <pc:docMk/>
            <pc:sldMk cId="772256198" sldId="272"/>
            <ac:spMk id="105" creationId="{1D4DD1F4-07D5-84CA-6FF1-024A25EE7869}"/>
          </ac:spMkLst>
        </pc:spChg>
        <pc:spChg chg="add mod">
          <ac:chgData name="Devkar, Vikas" userId="acbd15ec-55d1-4a76-83ac-3f1d82711ed5" providerId="ADAL" clId="{4C57031F-CE5B-445E-A32C-D89C534CEBBB}" dt="2024-03-04T05:36:16.099" v="13" actId="1076"/>
          <ac:spMkLst>
            <pc:docMk/>
            <pc:sldMk cId="772256198" sldId="272"/>
            <ac:spMk id="106" creationId="{FCDD1C8B-C4BC-E457-78E5-157D93C57B4E}"/>
          </ac:spMkLst>
        </pc:spChg>
        <pc:spChg chg="add mod">
          <ac:chgData name="Devkar, Vikas" userId="acbd15ec-55d1-4a76-83ac-3f1d82711ed5" providerId="ADAL" clId="{4C57031F-CE5B-445E-A32C-D89C534CEBBB}" dt="2024-03-04T05:36:16.099" v="13" actId="1076"/>
          <ac:spMkLst>
            <pc:docMk/>
            <pc:sldMk cId="772256198" sldId="272"/>
            <ac:spMk id="107" creationId="{9B5A9DAA-C39C-27D8-51D3-8C6578D59E76}"/>
          </ac:spMkLst>
        </pc:spChg>
        <pc:spChg chg="add mod">
          <ac:chgData name="Devkar, Vikas" userId="acbd15ec-55d1-4a76-83ac-3f1d82711ed5" providerId="ADAL" clId="{4C57031F-CE5B-445E-A32C-D89C534CEBBB}" dt="2024-03-04T05:36:16.099" v="13" actId="1076"/>
          <ac:spMkLst>
            <pc:docMk/>
            <pc:sldMk cId="772256198" sldId="272"/>
            <ac:spMk id="108" creationId="{BF35718B-FF44-941D-637B-F7B6DE2ED34A}"/>
          </ac:spMkLst>
        </pc:spChg>
        <pc:spChg chg="add mod">
          <ac:chgData name="Devkar, Vikas" userId="acbd15ec-55d1-4a76-83ac-3f1d82711ed5" providerId="ADAL" clId="{4C57031F-CE5B-445E-A32C-D89C534CEBBB}" dt="2024-03-04T05:36:16.099" v="13" actId="1076"/>
          <ac:spMkLst>
            <pc:docMk/>
            <pc:sldMk cId="772256198" sldId="272"/>
            <ac:spMk id="109" creationId="{BF340F1E-4113-1038-17ED-0D2E322C7875}"/>
          </ac:spMkLst>
        </pc:spChg>
        <pc:spChg chg="add mod">
          <ac:chgData name="Devkar, Vikas" userId="acbd15ec-55d1-4a76-83ac-3f1d82711ed5" providerId="ADAL" clId="{4C57031F-CE5B-445E-A32C-D89C534CEBBB}" dt="2024-03-04T05:36:16.099" v="13" actId="1076"/>
          <ac:spMkLst>
            <pc:docMk/>
            <pc:sldMk cId="772256198" sldId="272"/>
            <ac:spMk id="110" creationId="{D1926AD4-5D61-D851-0DAC-132CE12A7772}"/>
          </ac:spMkLst>
        </pc:spChg>
        <pc:spChg chg="add mod">
          <ac:chgData name="Devkar, Vikas" userId="acbd15ec-55d1-4a76-83ac-3f1d82711ed5" providerId="ADAL" clId="{4C57031F-CE5B-445E-A32C-D89C534CEBBB}" dt="2024-03-04T05:36:16.099" v="13" actId="1076"/>
          <ac:spMkLst>
            <pc:docMk/>
            <pc:sldMk cId="772256198" sldId="272"/>
            <ac:spMk id="112" creationId="{AA232013-8BC4-4CA3-F42E-2FD4639B8F5D}"/>
          </ac:spMkLst>
        </pc:spChg>
        <pc:spChg chg="add mod">
          <ac:chgData name="Devkar, Vikas" userId="acbd15ec-55d1-4a76-83ac-3f1d82711ed5" providerId="ADAL" clId="{4C57031F-CE5B-445E-A32C-D89C534CEBBB}" dt="2024-03-04T05:36:16.099" v="13" actId="1076"/>
          <ac:spMkLst>
            <pc:docMk/>
            <pc:sldMk cId="772256198" sldId="272"/>
            <ac:spMk id="113" creationId="{CC9EF421-C94A-9AB1-840E-F67854226DA4}"/>
          </ac:spMkLst>
        </pc:spChg>
        <pc:spChg chg="add mod">
          <ac:chgData name="Devkar, Vikas" userId="acbd15ec-55d1-4a76-83ac-3f1d82711ed5" providerId="ADAL" clId="{4C57031F-CE5B-445E-A32C-D89C534CEBBB}" dt="2024-03-04T05:36:16.099" v="13" actId="1076"/>
          <ac:spMkLst>
            <pc:docMk/>
            <pc:sldMk cId="772256198" sldId="272"/>
            <ac:spMk id="114" creationId="{05F94BA7-BCCD-8007-809D-BB1416C8C5DA}"/>
          </ac:spMkLst>
        </pc:spChg>
        <pc:spChg chg="add mod">
          <ac:chgData name="Devkar, Vikas" userId="acbd15ec-55d1-4a76-83ac-3f1d82711ed5" providerId="ADAL" clId="{4C57031F-CE5B-445E-A32C-D89C534CEBBB}" dt="2024-03-04T05:36:16.099" v="13" actId="1076"/>
          <ac:spMkLst>
            <pc:docMk/>
            <pc:sldMk cId="772256198" sldId="272"/>
            <ac:spMk id="115" creationId="{57FF72A5-0225-B2BC-3656-D9CE6F3CC0F5}"/>
          </ac:spMkLst>
        </pc:spChg>
        <pc:spChg chg="add mod">
          <ac:chgData name="Devkar, Vikas" userId="acbd15ec-55d1-4a76-83ac-3f1d82711ed5" providerId="ADAL" clId="{4C57031F-CE5B-445E-A32C-D89C534CEBBB}" dt="2024-03-04T05:36:16.099" v="13" actId="1076"/>
          <ac:spMkLst>
            <pc:docMk/>
            <pc:sldMk cId="772256198" sldId="272"/>
            <ac:spMk id="116" creationId="{B41CB5CB-A430-1E41-64E5-44DC2F627A5D}"/>
          </ac:spMkLst>
        </pc:spChg>
        <pc:spChg chg="add mod">
          <ac:chgData name="Devkar, Vikas" userId="acbd15ec-55d1-4a76-83ac-3f1d82711ed5" providerId="ADAL" clId="{4C57031F-CE5B-445E-A32C-D89C534CEBBB}" dt="2024-03-04T05:36:16.099" v="13" actId="1076"/>
          <ac:spMkLst>
            <pc:docMk/>
            <pc:sldMk cId="772256198" sldId="272"/>
            <ac:spMk id="117" creationId="{FE45DF65-70A5-4600-54F8-F66EC8AB06D5}"/>
          </ac:spMkLst>
        </pc:spChg>
        <pc:spChg chg="add mod">
          <ac:chgData name="Devkar, Vikas" userId="acbd15ec-55d1-4a76-83ac-3f1d82711ed5" providerId="ADAL" clId="{4C57031F-CE5B-445E-A32C-D89C534CEBBB}" dt="2024-03-04T05:36:16.099" v="13" actId="1076"/>
          <ac:spMkLst>
            <pc:docMk/>
            <pc:sldMk cId="772256198" sldId="272"/>
            <ac:spMk id="121" creationId="{A7E114D0-F026-5A7E-F48D-DB943DEA8C17}"/>
          </ac:spMkLst>
        </pc:spChg>
        <pc:spChg chg="add mod">
          <ac:chgData name="Devkar, Vikas" userId="acbd15ec-55d1-4a76-83ac-3f1d82711ed5" providerId="ADAL" clId="{4C57031F-CE5B-445E-A32C-D89C534CEBBB}" dt="2024-03-04T05:36:16.099" v="13" actId="1076"/>
          <ac:spMkLst>
            <pc:docMk/>
            <pc:sldMk cId="772256198" sldId="272"/>
            <ac:spMk id="122" creationId="{CE8DDB6C-A0A6-6F0C-B2CD-62A682743534}"/>
          </ac:spMkLst>
        </pc:spChg>
        <pc:spChg chg="add mod">
          <ac:chgData name="Devkar, Vikas" userId="acbd15ec-55d1-4a76-83ac-3f1d82711ed5" providerId="ADAL" clId="{4C57031F-CE5B-445E-A32C-D89C534CEBBB}" dt="2024-03-04T05:36:16.099" v="13" actId="1076"/>
          <ac:spMkLst>
            <pc:docMk/>
            <pc:sldMk cId="772256198" sldId="272"/>
            <ac:spMk id="123" creationId="{F0700D12-B974-9B1A-3EC2-AC31A45F796F}"/>
          </ac:spMkLst>
        </pc:spChg>
        <pc:spChg chg="add mod">
          <ac:chgData name="Devkar, Vikas" userId="acbd15ec-55d1-4a76-83ac-3f1d82711ed5" providerId="ADAL" clId="{4C57031F-CE5B-445E-A32C-D89C534CEBBB}" dt="2024-03-04T05:36:16.099" v="13" actId="1076"/>
          <ac:spMkLst>
            <pc:docMk/>
            <pc:sldMk cId="772256198" sldId="272"/>
            <ac:spMk id="124" creationId="{0FA0DB2B-0C33-E537-DCA5-6C334B0900CB}"/>
          </ac:spMkLst>
        </pc:spChg>
        <pc:spChg chg="add mod">
          <ac:chgData name="Devkar, Vikas" userId="acbd15ec-55d1-4a76-83ac-3f1d82711ed5" providerId="ADAL" clId="{4C57031F-CE5B-445E-A32C-D89C534CEBBB}" dt="2024-03-04T05:36:16.099" v="13" actId="1076"/>
          <ac:spMkLst>
            <pc:docMk/>
            <pc:sldMk cId="772256198" sldId="272"/>
            <ac:spMk id="125" creationId="{79C184B0-B487-7A04-C3D3-214AAD8C2631}"/>
          </ac:spMkLst>
        </pc:spChg>
        <pc:spChg chg="add mod">
          <ac:chgData name="Devkar, Vikas" userId="acbd15ec-55d1-4a76-83ac-3f1d82711ed5" providerId="ADAL" clId="{4C57031F-CE5B-445E-A32C-D89C534CEBBB}" dt="2024-03-04T05:36:16.099" v="13" actId="1076"/>
          <ac:spMkLst>
            <pc:docMk/>
            <pc:sldMk cId="772256198" sldId="272"/>
            <ac:spMk id="132" creationId="{17B70BB7-A4D7-D334-A137-6BCC25E7FAE1}"/>
          </ac:spMkLst>
        </pc:spChg>
        <pc:spChg chg="add mod">
          <ac:chgData name="Devkar, Vikas" userId="acbd15ec-55d1-4a76-83ac-3f1d82711ed5" providerId="ADAL" clId="{4C57031F-CE5B-445E-A32C-D89C534CEBBB}" dt="2024-03-04T05:36:16.099" v="13" actId="1076"/>
          <ac:spMkLst>
            <pc:docMk/>
            <pc:sldMk cId="772256198" sldId="272"/>
            <ac:spMk id="133" creationId="{8E7E6AB2-59E4-88FF-ADD4-8B1D1C2B18BE}"/>
          </ac:spMkLst>
        </pc:spChg>
        <pc:spChg chg="add mod">
          <ac:chgData name="Devkar, Vikas" userId="acbd15ec-55d1-4a76-83ac-3f1d82711ed5" providerId="ADAL" clId="{4C57031F-CE5B-445E-A32C-D89C534CEBBB}" dt="2024-03-04T05:36:16.099" v="13" actId="1076"/>
          <ac:spMkLst>
            <pc:docMk/>
            <pc:sldMk cId="772256198" sldId="272"/>
            <ac:spMk id="134" creationId="{7FEDF0C3-3610-7B89-48F6-390BC0BF684F}"/>
          </ac:spMkLst>
        </pc:spChg>
        <pc:spChg chg="add mod">
          <ac:chgData name="Devkar, Vikas" userId="acbd15ec-55d1-4a76-83ac-3f1d82711ed5" providerId="ADAL" clId="{4C57031F-CE5B-445E-A32C-D89C534CEBBB}" dt="2024-03-04T05:36:16.099" v="13" actId="1076"/>
          <ac:spMkLst>
            <pc:docMk/>
            <pc:sldMk cId="772256198" sldId="272"/>
            <ac:spMk id="135" creationId="{1A6470FD-1041-CE7A-C3B3-6FCE137DA0D0}"/>
          </ac:spMkLst>
        </pc:spChg>
        <pc:spChg chg="add mod">
          <ac:chgData name="Devkar, Vikas" userId="acbd15ec-55d1-4a76-83ac-3f1d82711ed5" providerId="ADAL" clId="{4C57031F-CE5B-445E-A32C-D89C534CEBBB}" dt="2024-03-04T05:36:16.099" v="13" actId="1076"/>
          <ac:spMkLst>
            <pc:docMk/>
            <pc:sldMk cId="772256198" sldId="272"/>
            <ac:spMk id="136" creationId="{007F5810-FD06-49C2-CB20-61D088A7618E}"/>
          </ac:spMkLst>
        </pc:spChg>
        <pc:spChg chg="add mod">
          <ac:chgData name="Devkar, Vikas" userId="acbd15ec-55d1-4a76-83ac-3f1d82711ed5" providerId="ADAL" clId="{4C57031F-CE5B-445E-A32C-D89C534CEBBB}" dt="2024-03-04T05:36:16.099" v="13" actId="1076"/>
          <ac:spMkLst>
            <pc:docMk/>
            <pc:sldMk cId="772256198" sldId="272"/>
            <ac:spMk id="140" creationId="{5A142951-4726-E388-4A7A-10419B2516D9}"/>
          </ac:spMkLst>
        </pc:spChg>
        <pc:spChg chg="add mod">
          <ac:chgData name="Devkar, Vikas" userId="acbd15ec-55d1-4a76-83ac-3f1d82711ed5" providerId="ADAL" clId="{4C57031F-CE5B-445E-A32C-D89C534CEBBB}" dt="2024-03-04T05:36:16.099" v="13" actId="1076"/>
          <ac:spMkLst>
            <pc:docMk/>
            <pc:sldMk cId="772256198" sldId="272"/>
            <ac:spMk id="141" creationId="{F0983390-5016-0C1F-86F7-60D0D5A9AE92}"/>
          </ac:spMkLst>
        </pc:spChg>
        <pc:spChg chg="add mod">
          <ac:chgData name="Devkar, Vikas" userId="acbd15ec-55d1-4a76-83ac-3f1d82711ed5" providerId="ADAL" clId="{4C57031F-CE5B-445E-A32C-D89C534CEBBB}" dt="2024-03-04T05:36:16.099" v="13" actId="1076"/>
          <ac:spMkLst>
            <pc:docMk/>
            <pc:sldMk cId="772256198" sldId="272"/>
            <ac:spMk id="142" creationId="{584B7048-C9A5-AABA-9A83-F9FAACBE98C9}"/>
          </ac:spMkLst>
        </pc:spChg>
        <pc:spChg chg="add mod">
          <ac:chgData name="Devkar, Vikas" userId="acbd15ec-55d1-4a76-83ac-3f1d82711ed5" providerId="ADAL" clId="{4C57031F-CE5B-445E-A32C-D89C534CEBBB}" dt="2024-03-04T05:36:16.099" v="13" actId="1076"/>
          <ac:spMkLst>
            <pc:docMk/>
            <pc:sldMk cId="772256198" sldId="272"/>
            <ac:spMk id="143" creationId="{D56F2D36-C264-3D47-C1C9-FC8BDC45289F}"/>
          </ac:spMkLst>
        </pc:spChg>
        <pc:spChg chg="add mod">
          <ac:chgData name="Devkar, Vikas" userId="acbd15ec-55d1-4a76-83ac-3f1d82711ed5" providerId="ADAL" clId="{4C57031F-CE5B-445E-A32C-D89C534CEBBB}" dt="2024-03-04T05:36:16.099" v="13" actId="1076"/>
          <ac:spMkLst>
            <pc:docMk/>
            <pc:sldMk cId="772256198" sldId="272"/>
            <ac:spMk id="144" creationId="{66626D36-E742-783E-606E-FCCBFA1B0172}"/>
          </ac:spMkLst>
        </pc:spChg>
        <pc:spChg chg="add mod">
          <ac:chgData name="Devkar, Vikas" userId="acbd15ec-55d1-4a76-83ac-3f1d82711ed5" providerId="ADAL" clId="{4C57031F-CE5B-445E-A32C-D89C534CEBBB}" dt="2024-03-04T05:36:16.099" v="13" actId="1076"/>
          <ac:spMkLst>
            <pc:docMk/>
            <pc:sldMk cId="772256198" sldId="272"/>
            <ac:spMk id="145" creationId="{1C1EDB1B-0D00-B6CC-85D9-B61B968B5F33}"/>
          </ac:spMkLst>
        </pc:spChg>
        <pc:spChg chg="add mod">
          <ac:chgData name="Devkar, Vikas" userId="acbd15ec-55d1-4a76-83ac-3f1d82711ed5" providerId="ADAL" clId="{4C57031F-CE5B-445E-A32C-D89C534CEBBB}" dt="2024-03-04T05:36:16.099" v="13" actId="1076"/>
          <ac:spMkLst>
            <pc:docMk/>
            <pc:sldMk cId="772256198" sldId="272"/>
            <ac:spMk id="146" creationId="{AE85E327-F381-1365-F04B-B6858198F5A4}"/>
          </ac:spMkLst>
        </pc:spChg>
        <pc:spChg chg="add mod">
          <ac:chgData name="Devkar, Vikas" userId="acbd15ec-55d1-4a76-83ac-3f1d82711ed5" providerId="ADAL" clId="{4C57031F-CE5B-445E-A32C-D89C534CEBBB}" dt="2024-03-04T05:36:16.099" v="13" actId="1076"/>
          <ac:spMkLst>
            <pc:docMk/>
            <pc:sldMk cId="772256198" sldId="272"/>
            <ac:spMk id="148" creationId="{677026D3-29DE-AE51-C9F2-FE5C2A7978E6}"/>
          </ac:spMkLst>
        </pc:spChg>
        <pc:spChg chg="add mod">
          <ac:chgData name="Devkar, Vikas" userId="acbd15ec-55d1-4a76-83ac-3f1d82711ed5" providerId="ADAL" clId="{4C57031F-CE5B-445E-A32C-D89C534CEBBB}" dt="2024-03-04T05:36:16.099" v="13" actId="1076"/>
          <ac:spMkLst>
            <pc:docMk/>
            <pc:sldMk cId="772256198" sldId="272"/>
            <ac:spMk id="149" creationId="{3253A329-22CE-F47F-1DEB-835B59711B82}"/>
          </ac:spMkLst>
        </pc:spChg>
        <pc:spChg chg="add mod">
          <ac:chgData name="Devkar, Vikas" userId="acbd15ec-55d1-4a76-83ac-3f1d82711ed5" providerId="ADAL" clId="{4C57031F-CE5B-445E-A32C-D89C534CEBBB}" dt="2024-03-04T05:36:16.099" v="13" actId="1076"/>
          <ac:spMkLst>
            <pc:docMk/>
            <pc:sldMk cId="772256198" sldId="272"/>
            <ac:spMk id="152" creationId="{3B3630C6-0947-ABCA-520D-AAB40561376D}"/>
          </ac:spMkLst>
        </pc:spChg>
        <pc:spChg chg="add mod">
          <ac:chgData name="Devkar, Vikas" userId="acbd15ec-55d1-4a76-83ac-3f1d82711ed5" providerId="ADAL" clId="{4C57031F-CE5B-445E-A32C-D89C534CEBBB}" dt="2024-03-04T05:36:16.099" v="13" actId="1076"/>
          <ac:spMkLst>
            <pc:docMk/>
            <pc:sldMk cId="772256198" sldId="272"/>
            <ac:spMk id="153" creationId="{113EDDED-D5CE-66B0-DAAE-8D9A7D6F9F9C}"/>
          </ac:spMkLst>
        </pc:spChg>
        <pc:spChg chg="add mod">
          <ac:chgData name="Devkar, Vikas" userId="acbd15ec-55d1-4a76-83ac-3f1d82711ed5" providerId="ADAL" clId="{4C57031F-CE5B-445E-A32C-D89C534CEBBB}" dt="2024-03-04T05:36:16.099" v="13" actId="1076"/>
          <ac:spMkLst>
            <pc:docMk/>
            <pc:sldMk cId="772256198" sldId="272"/>
            <ac:spMk id="154" creationId="{EDDA5A2E-23A2-BD70-1AA8-098A63B40F6A}"/>
          </ac:spMkLst>
        </pc:spChg>
        <pc:spChg chg="add mod">
          <ac:chgData name="Devkar, Vikas" userId="acbd15ec-55d1-4a76-83ac-3f1d82711ed5" providerId="ADAL" clId="{4C57031F-CE5B-445E-A32C-D89C534CEBBB}" dt="2024-03-04T05:36:16.099" v="13" actId="1076"/>
          <ac:spMkLst>
            <pc:docMk/>
            <pc:sldMk cId="772256198" sldId="272"/>
            <ac:spMk id="155" creationId="{39F0E06D-3AEA-0A66-C061-51D2343069DB}"/>
          </ac:spMkLst>
        </pc:spChg>
        <pc:spChg chg="add mod">
          <ac:chgData name="Devkar, Vikas" userId="acbd15ec-55d1-4a76-83ac-3f1d82711ed5" providerId="ADAL" clId="{4C57031F-CE5B-445E-A32C-D89C534CEBBB}" dt="2024-03-04T05:36:16.099" v="13" actId="1076"/>
          <ac:spMkLst>
            <pc:docMk/>
            <pc:sldMk cId="772256198" sldId="272"/>
            <ac:spMk id="168" creationId="{3A1F7A86-0828-767F-A9BE-0B01BE1851C7}"/>
          </ac:spMkLst>
        </pc:spChg>
        <pc:spChg chg="add mod">
          <ac:chgData name="Devkar, Vikas" userId="acbd15ec-55d1-4a76-83ac-3f1d82711ed5" providerId="ADAL" clId="{4C57031F-CE5B-445E-A32C-D89C534CEBBB}" dt="2024-03-04T05:36:16.099" v="13" actId="1076"/>
          <ac:spMkLst>
            <pc:docMk/>
            <pc:sldMk cId="772256198" sldId="272"/>
            <ac:spMk id="169" creationId="{8AE3D2D3-3DAB-9119-DF31-AF50FD82723E}"/>
          </ac:spMkLst>
        </pc:spChg>
        <pc:spChg chg="add mod">
          <ac:chgData name="Devkar, Vikas" userId="acbd15ec-55d1-4a76-83ac-3f1d82711ed5" providerId="ADAL" clId="{4C57031F-CE5B-445E-A32C-D89C534CEBBB}" dt="2024-03-04T05:36:16.099" v="13" actId="1076"/>
          <ac:spMkLst>
            <pc:docMk/>
            <pc:sldMk cId="772256198" sldId="272"/>
            <ac:spMk id="174" creationId="{B98DE7BB-F231-B6D4-AFE5-04E9E87D96FA}"/>
          </ac:spMkLst>
        </pc:spChg>
        <pc:spChg chg="add mod">
          <ac:chgData name="Devkar, Vikas" userId="acbd15ec-55d1-4a76-83ac-3f1d82711ed5" providerId="ADAL" clId="{4C57031F-CE5B-445E-A32C-D89C534CEBBB}" dt="2024-03-04T05:36:16.099" v="13" actId="1076"/>
          <ac:spMkLst>
            <pc:docMk/>
            <pc:sldMk cId="772256198" sldId="272"/>
            <ac:spMk id="175" creationId="{1CF14F6C-2F05-DF1E-7535-288D7550072F}"/>
          </ac:spMkLst>
        </pc:spChg>
        <pc:spChg chg="mod">
          <ac:chgData name="Devkar, Vikas" userId="acbd15ec-55d1-4a76-83ac-3f1d82711ed5" providerId="ADAL" clId="{4C57031F-CE5B-445E-A32C-D89C534CEBBB}" dt="2024-03-04T05:36:09.038" v="12"/>
          <ac:spMkLst>
            <pc:docMk/>
            <pc:sldMk cId="772256198" sldId="272"/>
            <ac:spMk id="179" creationId="{3C2316BF-2F35-9066-8699-249805EDCF05}"/>
          </ac:spMkLst>
        </pc:spChg>
        <pc:spChg chg="mod">
          <ac:chgData name="Devkar, Vikas" userId="acbd15ec-55d1-4a76-83ac-3f1d82711ed5" providerId="ADAL" clId="{4C57031F-CE5B-445E-A32C-D89C534CEBBB}" dt="2024-03-04T05:36:09.038" v="12"/>
          <ac:spMkLst>
            <pc:docMk/>
            <pc:sldMk cId="772256198" sldId="272"/>
            <ac:spMk id="180" creationId="{B7AD0E85-9C63-C3AF-D997-5C64C922FA6A}"/>
          </ac:spMkLst>
        </pc:spChg>
        <pc:spChg chg="mod">
          <ac:chgData name="Devkar, Vikas" userId="acbd15ec-55d1-4a76-83ac-3f1d82711ed5" providerId="ADAL" clId="{4C57031F-CE5B-445E-A32C-D89C534CEBBB}" dt="2024-03-04T05:36:09.038" v="12"/>
          <ac:spMkLst>
            <pc:docMk/>
            <pc:sldMk cId="772256198" sldId="272"/>
            <ac:spMk id="181" creationId="{F5B4B04F-2168-09E3-933C-52CBB4F66F2D}"/>
          </ac:spMkLst>
        </pc:spChg>
        <pc:spChg chg="mod">
          <ac:chgData name="Devkar, Vikas" userId="acbd15ec-55d1-4a76-83ac-3f1d82711ed5" providerId="ADAL" clId="{4C57031F-CE5B-445E-A32C-D89C534CEBBB}" dt="2024-03-04T05:36:09.038" v="12"/>
          <ac:spMkLst>
            <pc:docMk/>
            <pc:sldMk cId="772256198" sldId="272"/>
            <ac:spMk id="182" creationId="{06891363-7AC5-44F3-5299-B3729136E343}"/>
          </ac:spMkLst>
        </pc:spChg>
        <pc:spChg chg="mod">
          <ac:chgData name="Devkar, Vikas" userId="acbd15ec-55d1-4a76-83ac-3f1d82711ed5" providerId="ADAL" clId="{4C57031F-CE5B-445E-A32C-D89C534CEBBB}" dt="2024-03-04T05:36:09.038" v="12"/>
          <ac:spMkLst>
            <pc:docMk/>
            <pc:sldMk cId="772256198" sldId="272"/>
            <ac:spMk id="183" creationId="{DCA87021-43F7-F57D-E101-82059B3421E9}"/>
          </ac:spMkLst>
        </pc:spChg>
        <pc:spChg chg="mod">
          <ac:chgData name="Devkar, Vikas" userId="acbd15ec-55d1-4a76-83ac-3f1d82711ed5" providerId="ADAL" clId="{4C57031F-CE5B-445E-A32C-D89C534CEBBB}" dt="2024-03-04T05:36:09.038" v="12"/>
          <ac:spMkLst>
            <pc:docMk/>
            <pc:sldMk cId="772256198" sldId="272"/>
            <ac:spMk id="184" creationId="{1A99D993-4FCF-5EC0-8544-2F3F09A34BE1}"/>
          </ac:spMkLst>
        </pc:spChg>
        <pc:spChg chg="mod">
          <ac:chgData name="Devkar, Vikas" userId="acbd15ec-55d1-4a76-83ac-3f1d82711ed5" providerId="ADAL" clId="{4C57031F-CE5B-445E-A32C-D89C534CEBBB}" dt="2024-03-04T05:36:09.038" v="12"/>
          <ac:spMkLst>
            <pc:docMk/>
            <pc:sldMk cId="772256198" sldId="272"/>
            <ac:spMk id="185" creationId="{FFF373F9-B5DC-4CEB-C343-D9E681143E4A}"/>
          </ac:spMkLst>
        </pc:spChg>
        <pc:spChg chg="mod">
          <ac:chgData name="Devkar, Vikas" userId="acbd15ec-55d1-4a76-83ac-3f1d82711ed5" providerId="ADAL" clId="{4C57031F-CE5B-445E-A32C-D89C534CEBBB}" dt="2024-03-04T05:36:09.038" v="12"/>
          <ac:spMkLst>
            <pc:docMk/>
            <pc:sldMk cId="772256198" sldId="272"/>
            <ac:spMk id="186" creationId="{B2472036-C663-5549-294D-8A8B62203808}"/>
          </ac:spMkLst>
        </pc:spChg>
        <pc:spChg chg="mod">
          <ac:chgData name="Devkar, Vikas" userId="acbd15ec-55d1-4a76-83ac-3f1d82711ed5" providerId="ADAL" clId="{4C57031F-CE5B-445E-A32C-D89C534CEBBB}" dt="2024-03-04T05:36:09.038" v="12"/>
          <ac:spMkLst>
            <pc:docMk/>
            <pc:sldMk cId="772256198" sldId="272"/>
            <ac:spMk id="193" creationId="{0995AC17-2FDC-F6D8-46FF-9B41444C27F5}"/>
          </ac:spMkLst>
        </pc:spChg>
        <pc:spChg chg="mod">
          <ac:chgData name="Devkar, Vikas" userId="acbd15ec-55d1-4a76-83ac-3f1d82711ed5" providerId="ADAL" clId="{4C57031F-CE5B-445E-A32C-D89C534CEBBB}" dt="2024-03-04T05:36:09.038" v="12"/>
          <ac:spMkLst>
            <pc:docMk/>
            <pc:sldMk cId="772256198" sldId="272"/>
            <ac:spMk id="194" creationId="{F1E4D521-2FB4-7978-BC62-6C75A275DF07}"/>
          </ac:spMkLst>
        </pc:spChg>
        <pc:spChg chg="mod">
          <ac:chgData name="Devkar, Vikas" userId="acbd15ec-55d1-4a76-83ac-3f1d82711ed5" providerId="ADAL" clId="{4C57031F-CE5B-445E-A32C-D89C534CEBBB}" dt="2024-03-04T05:36:09.038" v="12"/>
          <ac:spMkLst>
            <pc:docMk/>
            <pc:sldMk cId="772256198" sldId="272"/>
            <ac:spMk id="195" creationId="{63C180AD-5918-BE9B-978C-3559CE315EC5}"/>
          </ac:spMkLst>
        </pc:spChg>
        <pc:spChg chg="mod">
          <ac:chgData name="Devkar, Vikas" userId="acbd15ec-55d1-4a76-83ac-3f1d82711ed5" providerId="ADAL" clId="{4C57031F-CE5B-445E-A32C-D89C534CEBBB}" dt="2024-03-04T05:36:09.038" v="12"/>
          <ac:spMkLst>
            <pc:docMk/>
            <pc:sldMk cId="772256198" sldId="272"/>
            <ac:spMk id="196" creationId="{D7A89E11-7A6E-0633-BD31-C4A26C85DFC3}"/>
          </ac:spMkLst>
        </pc:spChg>
        <pc:spChg chg="mod">
          <ac:chgData name="Devkar, Vikas" userId="acbd15ec-55d1-4a76-83ac-3f1d82711ed5" providerId="ADAL" clId="{4C57031F-CE5B-445E-A32C-D89C534CEBBB}" dt="2024-03-04T05:36:09.038" v="12"/>
          <ac:spMkLst>
            <pc:docMk/>
            <pc:sldMk cId="772256198" sldId="272"/>
            <ac:spMk id="197" creationId="{6CB0389D-7F5A-1531-928B-8625613722F6}"/>
          </ac:spMkLst>
        </pc:spChg>
        <pc:spChg chg="mod">
          <ac:chgData name="Devkar, Vikas" userId="acbd15ec-55d1-4a76-83ac-3f1d82711ed5" providerId="ADAL" clId="{4C57031F-CE5B-445E-A32C-D89C534CEBBB}" dt="2024-03-04T05:36:09.038" v="12"/>
          <ac:spMkLst>
            <pc:docMk/>
            <pc:sldMk cId="772256198" sldId="272"/>
            <ac:spMk id="198" creationId="{DB2821F2-68FF-5D61-5202-F7912BA6C348}"/>
          </ac:spMkLst>
        </pc:spChg>
        <pc:grpChg chg="add mod">
          <ac:chgData name="Devkar, Vikas" userId="acbd15ec-55d1-4a76-83ac-3f1d82711ed5" providerId="ADAL" clId="{4C57031F-CE5B-445E-A32C-D89C534CEBBB}" dt="2024-03-04T05:36:16.099" v="13" actId="1076"/>
          <ac:grpSpMkLst>
            <pc:docMk/>
            <pc:sldMk cId="772256198" sldId="272"/>
            <ac:grpSpMk id="9" creationId="{1BDB9C98-C494-2468-7F22-31E5A47C01D7}"/>
          </ac:grpSpMkLst>
        </pc:grpChg>
        <pc:grpChg chg="add mod">
          <ac:chgData name="Devkar, Vikas" userId="acbd15ec-55d1-4a76-83ac-3f1d82711ed5" providerId="ADAL" clId="{4C57031F-CE5B-445E-A32C-D89C534CEBBB}" dt="2024-03-04T05:36:16.099" v="13" actId="1076"/>
          <ac:grpSpMkLst>
            <pc:docMk/>
            <pc:sldMk cId="772256198" sldId="272"/>
            <ac:grpSpMk id="28" creationId="{3D3DE493-6E2A-3F42-DFD1-7CAC893114FD}"/>
          </ac:grpSpMkLst>
        </pc:grpChg>
        <pc:grpChg chg="add mod">
          <ac:chgData name="Devkar, Vikas" userId="acbd15ec-55d1-4a76-83ac-3f1d82711ed5" providerId="ADAL" clId="{4C57031F-CE5B-445E-A32C-D89C534CEBBB}" dt="2024-03-04T05:36:16.099" v="13" actId="1076"/>
          <ac:grpSpMkLst>
            <pc:docMk/>
            <pc:sldMk cId="772256198" sldId="272"/>
            <ac:grpSpMk id="29" creationId="{99F9B234-C49B-88EA-6935-0CACED7CAA5D}"/>
          </ac:grpSpMkLst>
        </pc:grpChg>
        <pc:grpChg chg="add mod">
          <ac:chgData name="Devkar, Vikas" userId="acbd15ec-55d1-4a76-83ac-3f1d82711ed5" providerId="ADAL" clId="{4C57031F-CE5B-445E-A32C-D89C534CEBBB}" dt="2024-03-04T05:36:16.099" v="13" actId="1076"/>
          <ac:grpSpMkLst>
            <pc:docMk/>
            <pc:sldMk cId="772256198" sldId="272"/>
            <ac:grpSpMk id="30" creationId="{F4291BC0-4CB0-79D3-223D-BB3A31726190}"/>
          </ac:grpSpMkLst>
        </pc:grpChg>
        <pc:grpChg chg="add mod">
          <ac:chgData name="Devkar, Vikas" userId="acbd15ec-55d1-4a76-83ac-3f1d82711ed5" providerId="ADAL" clId="{4C57031F-CE5B-445E-A32C-D89C534CEBBB}" dt="2024-03-04T05:36:16.099" v="13" actId="1076"/>
          <ac:grpSpMkLst>
            <pc:docMk/>
            <pc:sldMk cId="772256198" sldId="272"/>
            <ac:grpSpMk id="64" creationId="{52D4E5FA-5738-69AD-F7EA-BFB3BA884351}"/>
          </ac:grpSpMkLst>
        </pc:grpChg>
        <pc:grpChg chg="add mod">
          <ac:chgData name="Devkar, Vikas" userId="acbd15ec-55d1-4a76-83ac-3f1d82711ed5" providerId="ADAL" clId="{4C57031F-CE5B-445E-A32C-D89C534CEBBB}" dt="2024-03-04T05:36:16.099" v="13" actId="1076"/>
          <ac:grpSpMkLst>
            <pc:docMk/>
            <pc:sldMk cId="772256198" sldId="272"/>
            <ac:grpSpMk id="167" creationId="{D842885B-A23B-AB4E-0848-1A587A10C605}"/>
          </ac:grpSpMkLst>
        </pc:grpChg>
        <pc:grpChg chg="add mod">
          <ac:chgData name="Devkar, Vikas" userId="acbd15ec-55d1-4a76-83ac-3f1d82711ed5" providerId="ADAL" clId="{4C57031F-CE5B-445E-A32C-D89C534CEBBB}" dt="2024-03-04T05:36:16.099" v="13" actId="1076"/>
          <ac:grpSpMkLst>
            <pc:docMk/>
            <pc:sldMk cId="772256198" sldId="272"/>
            <ac:grpSpMk id="172" creationId="{CCA67366-4F9F-3433-AD2D-7A02296B820E}"/>
          </ac:grpSpMkLst>
        </pc:grpChg>
        <pc:grpChg chg="add mod">
          <ac:chgData name="Devkar, Vikas" userId="acbd15ec-55d1-4a76-83ac-3f1d82711ed5" providerId="ADAL" clId="{4C57031F-CE5B-445E-A32C-D89C534CEBBB}" dt="2024-03-04T05:36:16.099" v="13" actId="1076"/>
          <ac:grpSpMkLst>
            <pc:docMk/>
            <pc:sldMk cId="772256198" sldId="272"/>
            <ac:grpSpMk id="173" creationId="{9F9C8878-092E-ABBE-B21C-D32282FD2F2F}"/>
          </ac:grpSpMkLst>
        </pc:grpChg>
        <pc:picChg chg="mod">
          <ac:chgData name="Devkar, Vikas" userId="acbd15ec-55d1-4a76-83ac-3f1d82711ed5" providerId="ADAL" clId="{4C57031F-CE5B-445E-A32C-D89C534CEBBB}" dt="2024-03-04T05:36:09.038" v="12"/>
          <ac:picMkLst>
            <pc:docMk/>
            <pc:sldMk cId="772256198" sldId="272"/>
            <ac:picMk id="5" creationId="{67BA1CDC-EEFE-AD8C-D3DF-F549A0719965}"/>
          </ac:picMkLst>
        </pc:picChg>
        <pc:picChg chg="mod">
          <ac:chgData name="Devkar, Vikas" userId="acbd15ec-55d1-4a76-83ac-3f1d82711ed5" providerId="ADAL" clId="{4C57031F-CE5B-445E-A32C-D89C534CEBBB}" dt="2024-03-04T05:36:09.038" v="12"/>
          <ac:picMkLst>
            <pc:docMk/>
            <pc:sldMk cId="772256198" sldId="272"/>
            <ac:picMk id="10" creationId="{878DA4FE-FB76-4218-281C-4E9185D94F6A}"/>
          </ac:picMkLst>
        </pc:picChg>
        <pc:picChg chg="mod">
          <ac:chgData name="Devkar, Vikas" userId="acbd15ec-55d1-4a76-83ac-3f1d82711ed5" providerId="ADAL" clId="{4C57031F-CE5B-445E-A32C-D89C534CEBBB}" dt="2024-03-04T05:36:09.038" v="12"/>
          <ac:picMkLst>
            <pc:docMk/>
            <pc:sldMk cId="772256198" sldId="272"/>
            <ac:picMk id="44" creationId="{A9781AED-3489-1DC9-E3FE-B9A63D310D4C}"/>
          </ac:picMkLst>
        </pc:picChg>
        <pc:cxnChg chg="add mod">
          <ac:chgData name="Devkar, Vikas" userId="acbd15ec-55d1-4a76-83ac-3f1d82711ed5" providerId="ADAL" clId="{4C57031F-CE5B-445E-A32C-D89C534CEBBB}" dt="2024-03-04T05:36:16.099" v="13" actId="1076"/>
          <ac:cxnSpMkLst>
            <pc:docMk/>
            <pc:sldMk cId="772256198" sldId="272"/>
            <ac:cxnSpMk id="51" creationId="{BF4BE863-88CE-4173-E7BD-D64210102CD5}"/>
          </ac:cxnSpMkLst>
        </pc:cxnChg>
        <pc:cxnChg chg="add mod">
          <ac:chgData name="Devkar, Vikas" userId="acbd15ec-55d1-4a76-83ac-3f1d82711ed5" providerId="ADAL" clId="{4C57031F-CE5B-445E-A32C-D89C534CEBBB}" dt="2024-03-04T05:36:16.099" v="13" actId="1076"/>
          <ac:cxnSpMkLst>
            <pc:docMk/>
            <pc:sldMk cId="772256198" sldId="272"/>
            <ac:cxnSpMk id="52" creationId="{31455D91-00D1-1705-1478-F7D0422AB9A8}"/>
          </ac:cxnSpMkLst>
        </pc:cxnChg>
        <pc:cxnChg chg="add mod">
          <ac:chgData name="Devkar, Vikas" userId="acbd15ec-55d1-4a76-83ac-3f1d82711ed5" providerId="ADAL" clId="{4C57031F-CE5B-445E-A32C-D89C534CEBBB}" dt="2024-03-04T05:36:16.099" v="13" actId="1076"/>
          <ac:cxnSpMkLst>
            <pc:docMk/>
            <pc:sldMk cId="772256198" sldId="272"/>
            <ac:cxnSpMk id="53" creationId="{999F1144-E59F-769E-10F8-23609A2A18E4}"/>
          </ac:cxnSpMkLst>
        </pc:cxnChg>
        <pc:cxnChg chg="add mod">
          <ac:chgData name="Devkar, Vikas" userId="acbd15ec-55d1-4a76-83ac-3f1d82711ed5" providerId="ADAL" clId="{4C57031F-CE5B-445E-A32C-D89C534CEBBB}" dt="2024-03-04T05:36:16.099" v="13" actId="1076"/>
          <ac:cxnSpMkLst>
            <pc:docMk/>
            <pc:sldMk cId="772256198" sldId="272"/>
            <ac:cxnSpMk id="66" creationId="{F3BA32AD-87F6-9D23-9EA6-98AEA0369B42}"/>
          </ac:cxnSpMkLst>
        </pc:cxnChg>
        <pc:cxnChg chg="add mod">
          <ac:chgData name="Devkar, Vikas" userId="acbd15ec-55d1-4a76-83ac-3f1d82711ed5" providerId="ADAL" clId="{4C57031F-CE5B-445E-A32C-D89C534CEBBB}" dt="2024-03-04T05:36:16.099" v="13" actId="1076"/>
          <ac:cxnSpMkLst>
            <pc:docMk/>
            <pc:sldMk cId="772256198" sldId="272"/>
            <ac:cxnSpMk id="67" creationId="{7F2D5A69-5068-B3F7-AF48-94CF68B4CBEF}"/>
          </ac:cxnSpMkLst>
        </pc:cxnChg>
        <pc:cxnChg chg="add mod">
          <ac:chgData name="Devkar, Vikas" userId="acbd15ec-55d1-4a76-83ac-3f1d82711ed5" providerId="ADAL" clId="{4C57031F-CE5B-445E-A32C-D89C534CEBBB}" dt="2024-03-04T05:36:16.099" v="13" actId="1076"/>
          <ac:cxnSpMkLst>
            <pc:docMk/>
            <pc:sldMk cId="772256198" sldId="272"/>
            <ac:cxnSpMk id="69" creationId="{9D6EA3D2-B023-7394-3585-A7C6C5EB647B}"/>
          </ac:cxnSpMkLst>
        </pc:cxnChg>
        <pc:cxnChg chg="add mod">
          <ac:chgData name="Devkar, Vikas" userId="acbd15ec-55d1-4a76-83ac-3f1d82711ed5" providerId="ADAL" clId="{4C57031F-CE5B-445E-A32C-D89C534CEBBB}" dt="2024-03-04T05:36:16.099" v="13" actId="1076"/>
          <ac:cxnSpMkLst>
            <pc:docMk/>
            <pc:sldMk cId="772256198" sldId="272"/>
            <ac:cxnSpMk id="80" creationId="{5C455BD6-B96D-730D-43B2-1F3FF384F6D3}"/>
          </ac:cxnSpMkLst>
        </pc:cxnChg>
        <pc:cxnChg chg="add mod">
          <ac:chgData name="Devkar, Vikas" userId="acbd15ec-55d1-4a76-83ac-3f1d82711ed5" providerId="ADAL" clId="{4C57031F-CE5B-445E-A32C-D89C534CEBBB}" dt="2024-03-04T05:36:16.099" v="13" actId="1076"/>
          <ac:cxnSpMkLst>
            <pc:docMk/>
            <pc:sldMk cId="772256198" sldId="272"/>
            <ac:cxnSpMk id="81" creationId="{C8E24B77-3AAB-2F50-EF3D-EEBC9DC0E6D1}"/>
          </ac:cxnSpMkLst>
        </pc:cxnChg>
        <pc:cxnChg chg="add mod">
          <ac:chgData name="Devkar, Vikas" userId="acbd15ec-55d1-4a76-83ac-3f1d82711ed5" providerId="ADAL" clId="{4C57031F-CE5B-445E-A32C-D89C534CEBBB}" dt="2024-03-04T05:36:16.099" v="13" actId="1076"/>
          <ac:cxnSpMkLst>
            <pc:docMk/>
            <pc:sldMk cId="772256198" sldId="272"/>
            <ac:cxnSpMk id="83" creationId="{A75D8204-4317-3B97-9FCB-6B82121E8C23}"/>
          </ac:cxnSpMkLst>
        </pc:cxnChg>
        <pc:cxnChg chg="add mod">
          <ac:chgData name="Devkar, Vikas" userId="acbd15ec-55d1-4a76-83ac-3f1d82711ed5" providerId="ADAL" clId="{4C57031F-CE5B-445E-A32C-D89C534CEBBB}" dt="2024-03-04T05:36:16.099" v="13" actId="1076"/>
          <ac:cxnSpMkLst>
            <pc:docMk/>
            <pc:sldMk cId="772256198" sldId="272"/>
            <ac:cxnSpMk id="84" creationId="{9664F058-FFB3-0CEB-B5CB-8CBC81D52FDF}"/>
          </ac:cxnSpMkLst>
        </pc:cxnChg>
        <pc:cxnChg chg="add mod">
          <ac:chgData name="Devkar, Vikas" userId="acbd15ec-55d1-4a76-83ac-3f1d82711ed5" providerId="ADAL" clId="{4C57031F-CE5B-445E-A32C-D89C534CEBBB}" dt="2024-03-04T05:36:16.099" v="13" actId="1076"/>
          <ac:cxnSpMkLst>
            <pc:docMk/>
            <pc:sldMk cId="772256198" sldId="272"/>
            <ac:cxnSpMk id="85" creationId="{0DB4A719-1C1D-8948-5E35-0E4492317C49}"/>
          </ac:cxnSpMkLst>
        </pc:cxnChg>
        <pc:cxnChg chg="add mod">
          <ac:chgData name="Devkar, Vikas" userId="acbd15ec-55d1-4a76-83ac-3f1d82711ed5" providerId="ADAL" clId="{4C57031F-CE5B-445E-A32C-D89C534CEBBB}" dt="2024-03-04T05:36:16.099" v="13" actId="1076"/>
          <ac:cxnSpMkLst>
            <pc:docMk/>
            <pc:sldMk cId="772256198" sldId="272"/>
            <ac:cxnSpMk id="87" creationId="{05247A6D-6C3C-A7D4-3BDB-C74792D95479}"/>
          </ac:cxnSpMkLst>
        </pc:cxnChg>
        <pc:cxnChg chg="add mod">
          <ac:chgData name="Devkar, Vikas" userId="acbd15ec-55d1-4a76-83ac-3f1d82711ed5" providerId="ADAL" clId="{4C57031F-CE5B-445E-A32C-D89C534CEBBB}" dt="2024-03-04T05:36:16.099" v="13" actId="1076"/>
          <ac:cxnSpMkLst>
            <pc:docMk/>
            <pc:sldMk cId="772256198" sldId="272"/>
            <ac:cxnSpMk id="88" creationId="{832C4FC8-5BA0-ECA8-C93B-CC02FE31BE46}"/>
          </ac:cxnSpMkLst>
        </pc:cxnChg>
        <pc:cxnChg chg="add mod">
          <ac:chgData name="Devkar, Vikas" userId="acbd15ec-55d1-4a76-83ac-3f1d82711ed5" providerId="ADAL" clId="{4C57031F-CE5B-445E-A32C-D89C534CEBBB}" dt="2024-03-04T05:36:16.099" v="13" actId="1076"/>
          <ac:cxnSpMkLst>
            <pc:docMk/>
            <pc:sldMk cId="772256198" sldId="272"/>
            <ac:cxnSpMk id="98" creationId="{9B69124D-11E4-E076-6F65-2DC9EEEEE173}"/>
          </ac:cxnSpMkLst>
        </pc:cxnChg>
        <pc:cxnChg chg="add mod">
          <ac:chgData name="Devkar, Vikas" userId="acbd15ec-55d1-4a76-83ac-3f1d82711ed5" providerId="ADAL" clId="{4C57031F-CE5B-445E-A32C-D89C534CEBBB}" dt="2024-03-04T05:36:16.099" v="13" actId="1076"/>
          <ac:cxnSpMkLst>
            <pc:docMk/>
            <pc:sldMk cId="772256198" sldId="272"/>
            <ac:cxnSpMk id="99" creationId="{37570CE8-861C-77B8-3D81-0C941DE57B50}"/>
          </ac:cxnSpMkLst>
        </pc:cxnChg>
        <pc:cxnChg chg="add mod">
          <ac:chgData name="Devkar, Vikas" userId="acbd15ec-55d1-4a76-83ac-3f1d82711ed5" providerId="ADAL" clId="{4C57031F-CE5B-445E-A32C-D89C534CEBBB}" dt="2024-03-04T05:36:16.099" v="13" actId="1076"/>
          <ac:cxnSpMkLst>
            <pc:docMk/>
            <pc:sldMk cId="772256198" sldId="272"/>
            <ac:cxnSpMk id="111" creationId="{8C771EE0-9B2E-088A-7B33-CD51D0516BDE}"/>
          </ac:cxnSpMkLst>
        </pc:cxnChg>
        <pc:cxnChg chg="add mod">
          <ac:chgData name="Devkar, Vikas" userId="acbd15ec-55d1-4a76-83ac-3f1d82711ed5" providerId="ADAL" clId="{4C57031F-CE5B-445E-A32C-D89C534CEBBB}" dt="2024-03-04T05:36:16.099" v="13" actId="1076"/>
          <ac:cxnSpMkLst>
            <pc:docMk/>
            <pc:sldMk cId="772256198" sldId="272"/>
            <ac:cxnSpMk id="120" creationId="{439AD71C-DEA5-D5C8-A091-459C3ACA3358}"/>
          </ac:cxnSpMkLst>
        </pc:cxnChg>
        <pc:cxnChg chg="add mod">
          <ac:chgData name="Devkar, Vikas" userId="acbd15ec-55d1-4a76-83ac-3f1d82711ed5" providerId="ADAL" clId="{4C57031F-CE5B-445E-A32C-D89C534CEBBB}" dt="2024-03-04T05:36:16.099" v="13" actId="1076"/>
          <ac:cxnSpMkLst>
            <pc:docMk/>
            <pc:sldMk cId="772256198" sldId="272"/>
            <ac:cxnSpMk id="126" creationId="{81F3B27C-ADA7-329D-314A-E15C8E57D403}"/>
          </ac:cxnSpMkLst>
        </pc:cxnChg>
        <pc:cxnChg chg="add mod">
          <ac:chgData name="Devkar, Vikas" userId="acbd15ec-55d1-4a76-83ac-3f1d82711ed5" providerId="ADAL" clId="{4C57031F-CE5B-445E-A32C-D89C534CEBBB}" dt="2024-03-04T05:36:16.099" v="13" actId="1076"/>
          <ac:cxnSpMkLst>
            <pc:docMk/>
            <pc:sldMk cId="772256198" sldId="272"/>
            <ac:cxnSpMk id="128" creationId="{928994EA-F4BC-2FBA-70D5-2B6574960B46}"/>
          </ac:cxnSpMkLst>
        </pc:cxnChg>
        <pc:cxnChg chg="add mod">
          <ac:chgData name="Devkar, Vikas" userId="acbd15ec-55d1-4a76-83ac-3f1d82711ed5" providerId="ADAL" clId="{4C57031F-CE5B-445E-A32C-D89C534CEBBB}" dt="2024-03-04T05:36:16.099" v="13" actId="1076"/>
          <ac:cxnSpMkLst>
            <pc:docMk/>
            <pc:sldMk cId="772256198" sldId="272"/>
            <ac:cxnSpMk id="129" creationId="{213DD5A4-61CF-0BF9-C70D-2305063726EA}"/>
          </ac:cxnSpMkLst>
        </pc:cxnChg>
        <pc:cxnChg chg="add mod">
          <ac:chgData name="Devkar, Vikas" userId="acbd15ec-55d1-4a76-83ac-3f1d82711ed5" providerId="ADAL" clId="{4C57031F-CE5B-445E-A32C-D89C534CEBBB}" dt="2024-03-04T05:36:16.099" v="13" actId="1076"/>
          <ac:cxnSpMkLst>
            <pc:docMk/>
            <pc:sldMk cId="772256198" sldId="272"/>
            <ac:cxnSpMk id="130" creationId="{076191F4-7C70-E2CF-A2A1-018AA4F2D358}"/>
          </ac:cxnSpMkLst>
        </pc:cxnChg>
        <pc:cxnChg chg="add mod">
          <ac:chgData name="Devkar, Vikas" userId="acbd15ec-55d1-4a76-83ac-3f1d82711ed5" providerId="ADAL" clId="{4C57031F-CE5B-445E-A32C-D89C534CEBBB}" dt="2024-03-04T05:36:16.099" v="13" actId="1076"/>
          <ac:cxnSpMkLst>
            <pc:docMk/>
            <pc:sldMk cId="772256198" sldId="272"/>
            <ac:cxnSpMk id="131" creationId="{2B757326-EC7E-D8AF-9BDC-FD1A53667EF2}"/>
          </ac:cxnSpMkLst>
        </pc:cxnChg>
        <pc:cxnChg chg="add mod">
          <ac:chgData name="Devkar, Vikas" userId="acbd15ec-55d1-4a76-83ac-3f1d82711ed5" providerId="ADAL" clId="{4C57031F-CE5B-445E-A32C-D89C534CEBBB}" dt="2024-03-04T05:36:16.099" v="13" actId="1076"/>
          <ac:cxnSpMkLst>
            <pc:docMk/>
            <pc:sldMk cId="772256198" sldId="272"/>
            <ac:cxnSpMk id="147" creationId="{2BF73D87-538D-82F5-3BFA-D603532DCD30}"/>
          </ac:cxnSpMkLst>
        </pc:cxnChg>
        <pc:cxnChg chg="add mod">
          <ac:chgData name="Devkar, Vikas" userId="acbd15ec-55d1-4a76-83ac-3f1d82711ed5" providerId="ADAL" clId="{4C57031F-CE5B-445E-A32C-D89C534CEBBB}" dt="2024-03-04T05:36:16.099" v="13" actId="1076"/>
          <ac:cxnSpMkLst>
            <pc:docMk/>
            <pc:sldMk cId="772256198" sldId="272"/>
            <ac:cxnSpMk id="150" creationId="{3761B818-D2BB-7154-F6D1-6BFFB4DF7BE5}"/>
          </ac:cxnSpMkLst>
        </pc:cxnChg>
        <pc:cxnChg chg="add mod">
          <ac:chgData name="Devkar, Vikas" userId="acbd15ec-55d1-4a76-83ac-3f1d82711ed5" providerId="ADAL" clId="{4C57031F-CE5B-445E-A32C-D89C534CEBBB}" dt="2024-03-04T05:36:16.099" v="13" actId="1076"/>
          <ac:cxnSpMkLst>
            <pc:docMk/>
            <pc:sldMk cId="772256198" sldId="272"/>
            <ac:cxnSpMk id="162" creationId="{9D3761F2-3B57-00E6-A679-6306FD503837}"/>
          </ac:cxnSpMkLst>
        </pc:cxnChg>
        <pc:cxnChg chg="add mod">
          <ac:chgData name="Devkar, Vikas" userId="acbd15ec-55d1-4a76-83ac-3f1d82711ed5" providerId="ADAL" clId="{4C57031F-CE5B-445E-A32C-D89C534CEBBB}" dt="2024-03-04T05:36:16.099" v="13" actId="1076"/>
          <ac:cxnSpMkLst>
            <pc:docMk/>
            <pc:sldMk cId="772256198" sldId="272"/>
            <ac:cxnSpMk id="163" creationId="{65320ACA-0891-45B8-53C4-DACB666CE9FD}"/>
          </ac:cxnSpMkLst>
        </pc:cxnChg>
        <pc:cxnChg chg="add mod">
          <ac:chgData name="Devkar, Vikas" userId="acbd15ec-55d1-4a76-83ac-3f1d82711ed5" providerId="ADAL" clId="{4C57031F-CE5B-445E-A32C-D89C534CEBBB}" dt="2024-03-04T05:36:16.099" v="13" actId="1076"/>
          <ac:cxnSpMkLst>
            <pc:docMk/>
            <pc:sldMk cId="772256198" sldId="272"/>
            <ac:cxnSpMk id="164" creationId="{779EC635-6078-89C8-A702-E010690FCF57}"/>
          </ac:cxnSpMkLst>
        </pc:cxnChg>
        <pc:cxnChg chg="add mod">
          <ac:chgData name="Devkar, Vikas" userId="acbd15ec-55d1-4a76-83ac-3f1d82711ed5" providerId="ADAL" clId="{4C57031F-CE5B-445E-A32C-D89C534CEBBB}" dt="2024-03-04T05:36:16.099" v="13" actId="1076"/>
          <ac:cxnSpMkLst>
            <pc:docMk/>
            <pc:sldMk cId="772256198" sldId="272"/>
            <ac:cxnSpMk id="165" creationId="{FB1CAC9C-3947-939D-146A-5891B6990C16}"/>
          </ac:cxnSpMkLst>
        </pc:cxnChg>
        <pc:cxnChg chg="add mod">
          <ac:chgData name="Devkar, Vikas" userId="acbd15ec-55d1-4a76-83ac-3f1d82711ed5" providerId="ADAL" clId="{4C57031F-CE5B-445E-A32C-D89C534CEBBB}" dt="2024-03-04T05:36:16.099" v="13" actId="1076"/>
          <ac:cxnSpMkLst>
            <pc:docMk/>
            <pc:sldMk cId="772256198" sldId="272"/>
            <ac:cxnSpMk id="166" creationId="{58DD82DD-5C52-92E4-83B8-A7AFEE7416B2}"/>
          </ac:cxnSpMkLst>
        </pc:cxnChg>
        <pc:cxnChg chg="add mod">
          <ac:chgData name="Devkar, Vikas" userId="acbd15ec-55d1-4a76-83ac-3f1d82711ed5" providerId="ADAL" clId="{4C57031F-CE5B-445E-A32C-D89C534CEBBB}" dt="2024-03-04T05:36:16.099" v="13" actId="1076"/>
          <ac:cxnSpMkLst>
            <pc:docMk/>
            <pc:sldMk cId="772256198" sldId="272"/>
            <ac:cxnSpMk id="170" creationId="{EC7F053C-BF84-1B7E-E213-B13C34694E23}"/>
          </ac:cxnSpMkLst>
        </pc:cxnChg>
        <pc:cxnChg chg="add mod">
          <ac:chgData name="Devkar, Vikas" userId="acbd15ec-55d1-4a76-83ac-3f1d82711ed5" providerId="ADAL" clId="{4C57031F-CE5B-445E-A32C-D89C534CEBBB}" dt="2024-03-04T05:36:16.099" v="13" actId="1076"/>
          <ac:cxnSpMkLst>
            <pc:docMk/>
            <pc:sldMk cId="772256198" sldId="272"/>
            <ac:cxnSpMk id="171" creationId="{74ACEDB7-4EF7-0262-991D-D8546F363B90}"/>
          </ac:cxnSpMkLst>
        </pc:cxnChg>
        <pc:cxnChg chg="add mod">
          <ac:chgData name="Devkar, Vikas" userId="acbd15ec-55d1-4a76-83ac-3f1d82711ed5" providerId="ADAL" clId="{4C57031F-CE5B-445E-A32C-D89C534CEBBB}" dt="2024-03-04T05:36:16.099" v="13" actId="1076"/>
          <ac:cxnSpMkLst>
            <pc:docMk/>
            <pc:sldMk cId="772256198" sldId="272"/>
            <ac:cxnSpMk id="176" creationId="{E4431499-2DDB-786A-F271-05E6BFEADBA7}"/>
          </ac:cxnSpMkLst>
        </pc:cxnChg>
        <pc:cxnChg chg="add mod">
          <ac:chgData name="Devkar, Vikas" userId="acbd15ec-55d1-4a76-83ac-3f1d82711ed5" providerId="ADAL" clId="{4C57031F-CE5B-445E-A32C-D89C534CEBBB}" dt="2024-03-04T05:36:16.099" v="13" actId="1076"/>
          <ac:cxnSpMkLst>
            <pc:docMk/>
            <pc:sldMk cId="772256198" sldId="272"/>
            <ac:cxnSpMk id="177" creationId="{276DBD47-2625-A74A-D666-D00AC7BD40DE}"/>
          </ac:cxnSpMkLst>
        </pc:cxnChg>
        <pc:cxnChg chg="add mod">
          <ac:chgData name="Devkar, Vikas" userId="acbd15ec-55d1-4a76-83ac-3f1d82711ed5" providerId="ADAL" clId="{4C57031F-CE5B-445E-A32C-D89C534CEBBB}" dt="2024-03-04T05:36:16.099" v="13" actId="1076"/>
          <ac:cxnSpMkLst>
            <pc:docMk/>
            <pc:sldMk cId="772256198" sldId="272"/>
            <ac:cxnSpMk id="178" creationId="{AA5BA619-00EC-5A69-487B-3EAA442ACF22}"/>
          </ac:cxnSpMkLst>
        </pc:cxnChg>
      </pc:sldChg>
      <pc:sldChg chg="addSp delSp modSp new mod">
        <pc:chgData name="Devkar, Vikas" userId="acbd15ec-55d1-4a76-83ac-3f1d82711ed5" providerId="ADAL" clId="{4C57031F-CE5B-445E-A32C-D89C534CEBBB}" dt="2024-03-05T01:20:44.564" v="79" actId="20577"/>
        <pc:sldMkLst>
          <pc:docMk/>
          <pc:sldMk cId="769830488" sldId="273"/>
        </pc:sldMkLst>
        <pc:spChg chg="del">
          <ac:chgData name="Devkar, Vikas" userId="acbd15ec-55d1-4a76-83ac-3f1d82711ed5" providerId="ADAL" clId="{4C57031F-CE5B-445E-A32C-D89C534CEBBB}" dt="2024-03-04T05:37:46.076" v="22" actId="478"/>
          <ac:spMkLst>
            <pc:docMk/>
            <pc:sldMk cId="769830488" sldId="273"/>
            <ac:spMk id="2" creationId="{ED403F9B-73B8-670C-B792-062D2FF4A59E}"/>
          </ac:spMkLst>
        </pc:spChg>
        <pc:spChg chg="del">
          <ac:chgData name="Devkar, Vikas" userId="acbd15ec-55d1-4a76-83ac-3f1d82711ed5" providerId="ADAL" clId="{4C57031F-CE5B-445E-A32C-D89C534CEBBB}" dt="2024-03-04T05:37:46.076" v="22" actId="478"/>
          <ac:spMkLst>
            <pc:docMk/>
            <pc:sldMk cId="769830488" sldId="273"/>
            <ac:spMk id="3" creationId="{21585AE1-68DF-6C87-69BC-5E4B071F1524}"/>
          </ac:spMkLst>
        </pc:spChg>
        <pc:spChg chg="add mod">
          <ac:chgData name="Devkar, Vikas" userId="acbd15ec-55d1-4a76-83ac-3f1d82711ed5" providerId="ADAL" clId="{4C57031F-CE5B-445E-A32C-D89C534CEBBB}" dt="2024-03-05T01:20:44.564" v="79" actId="20577"/>
          <ac:spMkLst>
            <pc:docMk/>
            <pc:sldMk cId="769830488" sldId="273"/>
            <ac:spMk id="57" creationId="{95DE3980-1221-E768-B463-21755D594504}"/>
          </ac:spMkLst>
        </pc:spChg>
      </pc:sldChg>
    </pc:docChg>
  </pc:docChgLst>
  <pc:docChgLst>
    <pc:chgData name="Dagostino, Leonidas" userId="d42e52ab-e44d-4c88-95a1-c18248a0edcf" providerId="ADAL" clId="{74175628-52F5-4112-87C0-49094FD2745D}"/>
    <pc:docChg chg="undo custSel modSld">
      <pc:chgData name="Dagostino, Leonidas" userId="d42e52ab-e44d-4c88-95a1-c18248a0edcf" providerId="ADAL" clId="{74175628-52F5-4112-87C0-49094FD2745D}" dt="2023-11-20T19:10:48.636" v="82" actId="164"/>
      <pc:docMkLst>
        <pc:docMk/>
      </pc:docMkLst>
      <pc:sldChg chg="addSp delSp modSp mod">
        <pc:chgData name="Dagostino, Leonidas" userId="d42e52ab-e44d-4c88-95a1-c18248a0edcf" providerId="ADAL" clId="{74175628-52F5-4112-87C0-49094FD2745D}" dt="2023-11-20T19:10:48.636" v="82" actId="164"/>
        <pc:sldMkLst>
          <pc:docMk/>
          <pc:sldMk cId="794843755" sldId="264"/>
        </pc:sldMkLst>
        <pc:grpChg chg="add mod">
          <ac:chgData name="Dagostino, Leonidas" userId="d42e52ab-e44d-4c88-95a1-c18248a0edcf" providerId="ADAL" clId="{74175628-52F5-4112-87C0-49094FD2745D}" dt="2023-11-20T19:10:48.636" v="82" actId="164"/>
          <ac:grpSpMkLst>
            <pc:docMk/>
            <pc:sldMk cId="794843755" sldId="264"/>
            <ac:grpSpMk id="18" creationId="{EDB99B2A-34CA-9256-80DC-95B9C70BF965}"/>
          </ac:grpSpMkLst>
        </pc:grpChg>
        <pc:picChg chg="add mod">
          <ac:chgData name="Dagostino, Leonidas" userId="d42e52ab-e44d-4c88-95a1-c18248a0edcf" providerId="ADAL" clId="{74175628-52F5-4112-87C0-49094FD2745D}" dt="2023-11-20T19:10:48.636" v="82" actId="164"/>
          <ac:picMkLst>
            <pc:docMk/>
            <pc:sldMk cId="794843755" sldId="264"/>
            <ac:picMk id="3" creationId="{07755697-DC8E-4A18-1945-E47E8FBBC2F4}"/>
          </ac:picMkLst>
        </pc:picChg>
        <pc:picChg chg="add del mod">
          <ac:chgData name="Dagostino, Leonidas" userId="d42e52ab-e44d-4c88-95a1-c18248a0edcf" providerId="ADAL" clId="{74175628-52F5-4112-87C0-49094FD2745D}" dt="2023-11-20T19:06:29.469" v="28" actId="478"/>
          <ac:picMkLst>
            <pc:docMk/>
            <pc:sldMk cId="794843755" sldId="264"/>
            <ac:picMk id="4" creationId="{D13344BD-BFC3-9178-8503-4C587543DC6E}"/>
          </ac:picMkLst>
        </pc:picChg>
        <pc:picChg chg="del">
          <ac:chgData name="Dagostino, Leonidas" userId="d42e52ab-e44d-4c88-95a1-c18248a0edcf" providerId="ADAL" clId="{74175628-52F5-4112-87C0-49094FD2745D}" dt="2023-11-16T21:38:58.142" v="0" actId="478"/>
          <ac:picMkLst>
            <pc:docMk/>
            <pc:sldMk cId="794843755" sldId="264"/>
            <ac:picMk id="6" creationId="{383E3486-33E6-E294-000A-03F215F6D0BE}"/>
          </ac:picMkLst>
        </pc:picChg>
        <pc:picChg chg="add del mod">
          <ac:chgData name="Dagostino, Leonidas" userId="d42e52ab-e44d-4c88-95a1-c18248a0edcf" providerId="ADAL" clId="{74175628-52F5-4112-87C0-49094FD2745D}" dt="2023-11-20T19:07:14.764" v="35" actId="478"/>
          <ac:picMkLst>
            <pc:docMk/>
            <pc:sldMk cId="794843755" sldId="264"/>
            <ac:picMk id="6" creationId="{7AFA88EB-796B-CF09-CBAF-E93536ED7E72}"/>
          </ac:picMkLst>
        </pc:picChg>
        <pc:picChg chg="add del mod">
          <ac:chgData name="Dagostino, Leonidas" userId="d42e52ab-e44d-4c88-95a1-c18248a0edcf" providerId="ADAL" clId="{74175628-52F5-4112-87C0-49094FD2745D}" dt="2023-11-20T19:07:34.011" v="41" actId="478"/>
          <ac:picMkLst>
            <pc:docMk/>
            <pc:sldMk cId="794843755" sldId="264"/>
            <ac:picMk id="9" creationId="{9FCC10F6-5419-5432-1462-AB21A364E670}"/>
          </ac:picMkLst>
        </pc:picChg>
        <pc:picChg chg="add del mod">
          <ac:chgData name="Dagostino, Leonidas" userId="d42e52ab-e44d-4c88-95a1-c18248a0edcf" providerId="ADAL" clId="{74175628-52F5-4112-87C0-49094FD2745D}" dt="2023-11-20T19:08:02.802" v="47" actId="478"/>
          <ac:picMkLst>
            <pc:docMk/>
            <pc:sldMk cId="794843755" sldId="264"/>
            <ac:picMk id="11" creationId="{C822E7EC-1590-9BF2-5EE2-CB92242524B2}"/>
          </ac:picMkLst>
        </pc:picChg>
        <pc:picChg chg="add del mod">
          <ac:chgData name="Dagostino, Leonidas" userId="d42e52ab-e44d-4c88-95a1-c18248a0edcf" providerId="ADAL" clId="{74175628-52F5-4112-87C0-49094FD2745D}" dt="2023-11-20T19:08:32.634" v="54" actId="478"/>
          <ac:picMkLst>
            <pc:docMk/>
            <pc:sldMk cId="794843755" sldId="264"/>
            <ac:picMk id="13" creationId="{F5F49FD8-3B4C-6DAE-0751-436980AAF400}"/>
          </ac:picMkLst>
        </pc:picChg>
        <pc:picChg chg="add mod">
          <ac:chgData name="Dagostino, Leonidas" userId="d42e52ab-e44d-4c88-95a1-c18248a0edcf" providerId="ADAL" clId="{74175628-52F5-4112-87C0-49094FD2745D}" dt="2023-11-20T19:10:48.636" v="82" actId="164"/>
          <ac:picMkLst>
            <pc:docMk/>
            <pc:sldMk cId="794843755" sldId="264"/>
            <ac:picMk id="15" creationId="{BF1C54FC-3637-A172-3B73-2C58D5331B63}"/>
          </ac:picMkLst>
        </pc:picChg>
        <pc:picChg chg="add mod">
          <ac:chgData name="Dagostino, Leonidas" userId="d42e52ab-e44d-4c88-95a1-c18248a0edcf" providerId="ADAL" clId="{74175628-52F5-4112-87C0-49094FD2745D}" dt="2023-11-20T19:10:48.636" v="82" actId="164"/>
          <ac:picMkLst>
            <pc:docMk/>
            <pc:sldMk cId="794843755" sldId="264"/>
            <ac:picMk id="17" creationId="{143D57FF-D45A-B688-64E5-25D65526FCA9}"/>
          </ac:picMkLst>
        </pc:picChg>
      </pc:sldChg>
      <pc:sldChg chg="addSp delSp modSp mod">
        <pc:chgData name="Dagostino, Leonidas" userId="d42e52ab-e44d-4c88-95a1-c18248a0edcf" providerId="ADAL" clId="{74175628-52F5-4112-87C0-49094FD2745D}" dt="2023-11-17T21:42:58.319" v="18" actId="1076"/>
        <pc:sldMkLst>
          <pc:docMk/>
          <pc:sldMk cId="3436963830" sldId="268"/>
        </pc:sldMkLst>
        <pc:spChg chg="del mod">
          <ac:chgData name="Dagostino, Leonidas" userId="d42e52ab-e44d-4c88-95a1-c18248a0edcf" providerId="ADAL" clId="{74175628-52F5-4112-87C0-49094FD2745D}" dt="2023-11-17T21:42:56.915" v="17" actId="478"/>
          <ac:spMkLst>
            <pc:docMk/>
            <pc:sldMk cId="3436963830" sldId="268"/>
            <ac:spMk id="5" creationId="{56BF8C7B-471C-6ED5-6ADF-6B81D4C729FB}"/>
          </ac:spMkLst>
        </pc:spChg>
        <pc:spChg chg="del">
          <ac:chgData name="Dagostino, Leonidas" userId="d42e52ab-e44d-4c88-95a1-c18248a0edcf" providerId="ADAL" clId="{74175628-52F5-4112-87C0-49094FD2745D}" dt="2023-11-17T21:42:12.605" v="7" actId="478"/>
          <ac:spMkLst>
            <pc:docMk/>
            <pc:sldMk cId="3436963830" sldId="268"/>
            <ac:spMk id="6" creationId="{B8AC7FCE-F5D6-5677-0D99-B5E94C775016}"/>
          </ac:spMkLst>
        </pc:spChg>
        <pc:picChg chg="add mod">
          <ac:chgData name="Dagostino, Leonidas" userId="d42e52ab-e44d-4c88-95a1-c18248a0edcf" providerId="ADAL" clId="{74175628-52F5-4112-87C0-49094FD2745D}" dt="2023-11-17T21:42:16.901" v="10" actId="1076"/>
          <ac:picMkLst>
            <pc:docMk/>
            <pc:sldMk cId="3436963830" sldId="268"/>
            <ac:picMk id="3" creationId="{4107DE74-D307-3C34-2F06-B67A675AB813}"/>
          </ac:picMkLst>
        </pc:picChg>
        <pc:picChg chg="add mod">
          <ac:chgData name="Dagostino, Leonidas" userId="d42e52ab-e44d-4c88-95a1-c18248a0edcf" providerId="ADAL" clId="{74175628-52F5-4112-87C0-49094FD2745D}" dt="2023-11-17T21:42:58.319" v="18" actId="1076"/>
          <ac:picMkLst>
            <pc:docMk/>
            <pc:sldMk cId="3436963830" sldId="268"/>
            <ac:picMk id="8" creationId="{2C15A82C-C92A-35A5-1A80-BC7D1C3488CA}"/>
          </ac:picMkLst>
        </pc:picChg>
      </pc:sldChg>
    </pc:docChg>
  </pc:docChgLst>
  <pc:docChgLst>
    <pc:chgData name="Devkar, Vikas" userId="acbd15ec-55d1-4a76-83ac-3f1d82711ed5" providerId="ADAL" clId="{78938D42-E203-4114-99A5-A750F28ED2D5}"/>
    <pc:docChg chg="custSel modSld">
      <pc:chgData name="Devkar, Vikas" userId="acbd15ec-55d1-4a76-83ac-3f1d82711ed5" providerId="ADAL" clId="{78938D42-E203-4114-99A5-A750F28ED2D5}" dt="2023-09-29T20:46:05.816" v="127" actId="20577"/>
      <pc:docMkLst>
        <pc:docMk/>
      </pc:docMkLst>
      <pc:sldChg chg="addSp modSp mod">
        <pc:chgData name="Devkar, Vikas" userId="acbd15ec-55d1-4a76-83ac-3f1d82711ed5" providerId="ADAL" clId="{78938D42-E203-4114-99A5-A750F28ED2D5}" dt="2023-09-29T20:46:05.816" v="127" actId="20577"/>
        <pc:sldMkLst>
          <pc:docMk/>
          <pc:sldMk cId="1604500440" sldId="256"/>
        </pc:sldMkLst>
        <pc:spChg chg="add mod">
          <ac:chgData name="Devkar, Vikas" userId="acbd15ec-55d1-4a76-83ac-3f1d82711ed5" providerId="ADAL" clId="{78938D42-E203-4114-99A5-A750F28ED2D5}" dt="2023-09-29T20:43:42.583" v="10" actId="1076"/>
          <ac:spMkLst>
            <pc:docMk/>
            <pc:sldMk cId="1604500440" sldId="256"/>
            <ac:spMk id="5" creationId="{267B5775-2EA1-057F-29AE-A0A20F28F365}"/>
          </ac:spMkLst>
        </pc:spChg>
        <pc:spChg chg="add mod">
          <ac:chgData name="Devkar, Vikas" userId="acbd15ec-55d1-4a76-83ac-3f1d82711ed5" providerId="ADAL" clId="{78938D42-E203-4114-99A5-A750F28ED2D5}" dt="2023-09-29T20:44:24.352" v="14" actId="1076"/>
          <ac:spMkLst>
            <pc:docMk/>
            <pc:sldMk cId="1604500440" sldId="256"/>
            <ac:spMk id="6" creationId="{25C1E047-61A8-283D-842B-8E4DB3196396}"/>
          </ac:spMkLst>
        </pc:spChg>
        <pc:spChg chg="add mod">
          <ac:chgData name="Devkar, Vikas" userId="acbd15ec-55d1-4a76-83ac-3f1d82711ed5" providerId="ADAL" clId="{78938D42-E203-4114-99A5-A750F28ED2D5}" dt="2023-09-29T20:45:43.261" v="102" actId="1076"/>
          <ac:spMkLst>
            <pc:docMk/>
            <pc:sldMk cId="1604500440" sldId="256"/>
            <ac:spMk id="7" creationId="{A1F18A16-F4AD-BA15-75E0-DBBCAFFB2CCA}"/>
          </ac:spMkLst>
        </pc:spChg>
        <pc:spChg chg="add mod">
          <ac:chgData name="Devkar, Vikas" userId="acbd15ec-55d1-4a76-83ac-3f1d82711ed5" providerId="ADAL" clId="{78938D42-E203-4114-99A5-A750F28ED2D5}" dt="2023-09-29T20:46:05.816" v="127" actId="20577"/>
          <ac:spMkLst>
            <pc:docMk/>
            <pc:sldMk cId="1604500440" sldId="256"/>
            <ac:spMk id="8" creationId="{D33B83D1-2A7F-FB0B-3DB9-81D3A13B291E}"/>
          </ac:spMkLst>
        </pc:spChg>
        <pc:picChg chg="add mod modCrop">
          <ac:chgData name="Devkar, Vikas" userId="acbd15ec-55d1-4a76-83ac-3f1d82711ed5" providerId="ADAL" clId="{78938D42-E203-4114-99A5-A750F28ED2D5}" dt="2023-09-29T20:45:36.419" v="100" actId="1076"/>
          <ac:picMkLst>
            <pc:docMk/>
            <pc:sldMk cId="1604500440" sldId="256"/>
            <ac:picMk id="4" creationId="{8650781B-AC10-2E14-7193-96FAEFC0AEE0}"/>
          </ac:picMkLst>
        </pc:picChg>
      </pc:sldChg>
    </pc:docChg>
  </pc:docChgLst>
  <pc:docChgLst>
    <pc:chgData name="Patil, Gunvant" userId="bab2d81c-cb5c-4d5f-9d4d-9ec0ed5664f1" providerId="ADAL" clId="{D7752B4A-4D58-274F-8D02-3455EDB62971}"/>
    <pc:docChg chg="custSel modSld">
      <pc:chgData name="Patil, Gunvant" userId="bab2d81c-cb5c-4d5f-9d4d-9ec0ed5664f1" providerId="ADAL" clId="{D7752B4A-4D58-274F-8D02-3455EDB62971}" dt="2024-02-15T22:34:22.199" v="23"/>
      <pc:docMkLst>
        <pc:docMk/>
      </pc:docMkLst>
      <pc:sldChg chg="delSp mod">
        <pc:chgData name="Patil, Gunvant" userId="bab2d81c-cb5c-4d5f-9d4d-9ec0ed5664f1" providerId="ADAL" clId="{D7752B4A-4D58-274F-8D02-3455EDB62971}" dt="2024-01-08T16:33:59.208" v="21" actId="478"/>
        <pc:sldMkLst>
          <pc:docMk/>
          <pc:sldMk cId="1604500440" sldId="256"/>
        </pc:sldMkLst>
        <pc:picChg chg="del">
          <ac:chgData name="Patil, Gunvant" userId="bab2d81c-cb5c-4d5f-9d4d-9ec0ed5664f1" providerId="ADAL" clId="{D7752B4A-4D58-274F-8D02-3455EDB62971}" dt="2024-01-08T16:33:59.208" v="21" actId="478"/>
          <ac:picMkLst>
            <pc:docMk/>
            <pc:sldMk cId="1604500440" sldId="256"/>
            <ac:picMk id="11" creationId="{A6986DA1-314A-E91E-075A-19EEB0C13E02}"/>
          </ac:picMkLst>
        </pc:picChg>
      </pc:sldChg>
      <pc:sldChg chg="addSp modSp mod">
        <pc:chgData name="Patil, Gunvant" userId="bab2d81c-cb5c-4d5f-9d4d-9ec0ed5664f1" providerId="ADAL" clId="{D7752B4A-4D58-274F-8D02-3455EDB62971}" dt="2024-02-15T22:34:22.199" v="23"/>
        <pc:sldMkLst>
          <pc:docMk/>
          <pc:sldMk cId="2353496295" sldId="257"/>
        </pc:sldMkLst>
        <pc:spChg chg="add mod">
          <ac:chgData name="Patil, Gunvant" userId="bab2d81c-cb5c-4d5f-9d4d-9ec0ed5664f1" providerId="ADAL" clId="{D7752B4A-4D58-274F-8D02-3455EDB62971}" dt="2023-12-19T20:58:57.898" v="3" actId="208"/>
          <ac:spMkLst>
            <pc:docMk/>
            <pc:sldMk cId="2353496295" sldId="257"/>
            <ac:spMk id="3" creationId="{816778EE-91FC-3D08-8425-BCBB166A26BA}"/>
          </ac:spMkLst>
        </pc:spChg>
        <pc:spChg chg="add mod">
          <ac:chgData name="Patil, Gunvant" userId="bab2d81c-cb5c-4d5f-9d4d-9ec0ed5664f1" providerId="ADAL" clId="{D7752B4A-4D58-274F-8D02-3455EDB62971}" dt="2023-12-19T20:59:59.013" v="5" actId="1076"/>
          <ac:spMkLst>
            <pc:docMk/>
            <pc:sldMk cId="2353496295" sldId="257"/>
            <ac:spMk id="14" creationId="{6E9AEBEA-469B-7E61-5F36-E87CBD63ED6D}"/>
          </ac:spMkLst>
        </pc:spChg>
        <pc:picChg chg="mod">
          <ac:chgData name="Patil, Gunvant" userId="bab2d81c-cb5c-4d5f-9d4d-9ec0ed5664f1" providerId="ADAL" clId="{D7752B4A-4D58-274F-8D02-3455EDB62971}" dt="2024-02-15T22:34:22.199" v="23"/>
          <ac:picMkLst>
            <pc:docMk/>
            <pc:sldMk cId="2353496295" sldId="257"/>
            <ac:picMk id="8" creationId="{42BD8504-A15A-0C1F-A71B-97100C7768C1}"/>
          </ac:picMkLst>
        </pc:picChg>
        <pc:picChg chg="mod">
          <ac:chgData name="Patil, Gunvant" userId="bab2d81c-cb5c-4d5f-9d4d-9ec0ed5664f1" providerId="ADAL" clId="{D7752B4A-4D58-274F-8D02-3455EDB62971}" dt="2024-02-15T22:34:08.712" v="22"/>
          <ac:picMkLst>
            <pc:docMk/>
            <pc:sldMk cId="2353496295" sldId="257"/>
            <ac:picMk id="11" creationId="{5AE816F1-0434-E091-206B-91B592A351E4}"/>
          </ac:picMkLst>
        </pc:picChg>
      </pc:sldChg>
      <pc:sldChg chg="modSp mod">
        <pc:chgData name="Patil, Gunvant" userId="bab2d81c-cb5c-4d5f-9d4d-9ec0ed5664f1" providerId="ADAL" clId="{D7752B4A-4D58-274F-8D02-3455EDB62971}" dt="2023-12-19T21:00:46.882" v="6" actId="1076"/>
        <pc:sldMkLst>
          <pc:docMk/>
          <pc:sldMk cId="1437810819" sldId="262"/>
        </pc:sldMkLst>
        <pc:picChg chg="mod">
          <ac:chgData name="Patil, Gunvant" userId="bab2d81c-cb5c-4d5f-9d4d-9ec0ed5664f1" providerId="ADAL" clId="{D7752B4A-4D58-274F-8D02-3455EDB62971}" dt="2023-12-19T21:00:46.882" v="6" actId="1076"/>
          <ac:picMkLst>
            <pc:docMk/>
            <pc:sldMk cId="1437810819" sldId="262"/>
            <ac:picMk id="6" creationId="{700FDA5C-A7F2-2BB3-637E-ACB4A129C13C}"/>
          </ac:picMkLst>
        </pc:picChg>
      </pc:sldChg>
      <pc:sldChg chg="addSp modSp mod">
        <pc:chgData name="Patil, Gunvant" userId="bab2d81c-cb5c-4d5f-9d4d-9ec0ed5664f1" providerId="ADAL" clId="{D7752B4A-4D58-274F-8D02-3455EDB62971}" dt="2023-12-19T21:02:38.304" v="20" actId="1076"/>
        <pc:sldMkLst>
          <pc:docMk/>
          <pc:sldMk cId="1922289499" sldId="267"/>
        </pc:sldMkLst>
        <pc:spChg chg="add mod">
          <ac:chgData name="Patil, Gunvant" userId="bab2d81c-cb5c-4d5f-9d4d-9ec0ed5664f1" providerId="ADAL" clId="{D7752B4A-4D58-274F-8D02-3455EDB62971}" dt="2023-12-19T21:02:38.304" v="20" actId="1076"/>
          <ac:spMkLst>
            <pc:docMk/>
            <pc:sldMk cId="1922289499" sldId="267"/>
            <ac:spMk id="3" creationId="{853A69FC-E3DE-DF53-7C7B-54203620809C}"/>
          </ac:spMkLst>
        </pc:spChg>
        <pc:spChg chg="mod">
          <ac:chgData name="Patil, Gunvant" userId="bab2d81c-cb5c-4d5f-9d4d-9ec0ed5664f1" providerId="ADAL" clId="{D7752B4A-4D58-274F-8D02-3455EDB62971}" dt="2023-12-19T21:02:11.490" v="10" actId="1076"/>
          <ac:spMkLst>
            <pc:docMk/>
            <pc:sldMk cId="1922289499" sldId="267"/>
            <ac:spMk id="10" creationId="{B5AED450-D013-032F-CB22-1E452FB97610}"/>
          </ac:spMkLst>
        </pc:spChg>
        <pc:spChg chg="mod">
          <ac:chgData name="Patil, Gunvant" userId="bab2d81c-cb5c-4d5f-9d4d-9ec0ed5664f1" providerId="ADAL" clId="{D7752B4A-4D58-274F-8D02-3455EDB62971}" dt="2023-12-19T21:02:15.306" v="11" actId="1076"/>
          <ac:spMkLst>
            <pc:docMk/>
            <pc:sldMk cId="1922289499" sldId="267"/>
            <ac:spMk id="11" creationId="{50C299BE-1C3F-2925-72B9-F8948525BD30}"/>
          </ac:spMkLst>
        </pc:spChg>
        <pc:picChg chg="add mod">
          <ac:chgData name="Patil, Gunvant" userId="bab2d81c-cb5c-4d5f-9d4d-9ec0ed5664f1" providerId="ADAL" clId="{D7752B4A-4D58-274F-8D02-3455EDB62971}" dt="2023-12-19T21:02:29.622" v="17" actId="14100"/>
          <ac:picMkLst>
            <pc:docMk/>
            <pc:sldMk cId="1922289499" sldId="267"/>
            <ac:picMk id="2" creationId="{2643B9DB-271B-8EEF-6A22-874DD8D20787}"/>
          </ac:picMkLst>
        </pc:picChg>
        <pc:picChg chg="mod">
          <ac:chgData name="Patil, Gunvant" userId="bab2d81c-cb5c-4d5f-9d4d-9ec0ed5664f1" providerId="ADAL" clId="{D7752B4A-4D58-274F-8D02-3455EDB62971}" dt="2023-12-19T21:01:59.823" v="7" actId="14100"/>
          <ac:picMkLst>
            <pc:docMk/>
            <pc:sldMk cId="1922289499" sldId="267"/>
            <ac:picMk id="5" creationId="{AA86745D-3D68-E449-B450-B838D6F49851}"/>
          </ac:picMkLst>
        </pc:picChg>
        <pc:picChg chg="mod">
          <ac:chgData name="Patil, Gunvant" userId="bab2d81c-cb5c-4d5f-9d4d-9ec0ed5664f1" providerId="ADAL" clId="{D7752B4A-4D58-274F-8D02-3455EDB62971}" dt="2023-12-19T21:02:07.156" v="9" actId="14100"/>
          <ac:picMkLst>
            <pc:docMk/>
            <pc:sldMk cId="1922289499" sldId="267"/>
            <ac:picMk id="7" creationId="{60CF31E5-4C3A-F7A3-4BCF-F8236B1D265F}"/>
          </ac:picMkLst>
        </pc:picChg>
      </pc:sldChg>
      <pc:sldChg chg="delSp mod">
        <pc:chgData name="Patil, Gunvant" userId="bab2d81c-cb5c-4d5f-9d4d-9ec0ed5664f1" providerId="ADAL" clId="{D7752B4A-4D58-274F-8D02-3455EDB62971}" dt="2023-12-19T21:02:34.056" v="18" actId="21"/>
        <pc:sldMkLst>
          <pc:docMk/>
          <pc:sldMk cId="1812129503" sldId="274"/>
        </pc:sldMkLst>
        <pc:spChg chg="del">
          <ac:chgData name="Patil, Gunvant" userId="bab2d81c-cb5c-4d5f-9d4d-9ec0ed5664f1" providerId="ADAL" clId="{D7752B4A-4D58-274F-8D02-3455EDB62971}" dt="2023-12-19T21:02:34.056" v="18" actId="21"/>
          <ac:spMkLst>
            <pc:docMk/>
            <pc:sldMk cId="1812129503" sldId="274"/>
            <ac:spMk id="5" creationId="{A2ABE8A9-FDB0-B462-124C-3E920E08967B}"/>
          </ac:spMkLst>
        </pc:spChg>
        <pc:picChg chg="del">
          <ac:chgData name="Patil, Gunvant" userId="bab2d81c-cb5c-4d5f-9d4d-9ec0ed5664f1" providerId="ADAL" clId="{D7752B4A-4D58-274F-8D02-3455EDB62971}" dt="2023-12-19T21:02:19.122" v="12" actId="21"/>
          <ac:picMkLst>
            <pc:docMk/>
            <pc:sldMk cId="1812129503" sldId="274"/>
            <ac:picMk id="6" creationId="{9979DCA5-EEA1-FC30-F602-77A243A379CA}"/>
          </ac:picMkLst>
        </pc:picChg>
      </pc:sldChg>
    </pc:docChg>
  </pc:docChgLst>
  <pc:docChgLst>
    <pc:chgData name="Dagostino, Leonidas" userId="d42e52ab-e44d-4c88-95a1-c18248a0edcf" providerId="ADAL" clId="{EDC8207B-97C4-4321-9B12-D54CB31B68CC}"/>
    <pc:docChg chg="custSel modSld">
      <pc:chgData name="Dagostino, Leonidas" userId="d42e52ab-e44d-4c88-95a1-c18248a0edcf" providerId="ADAL" clId="{EDC8207B-97C4-4321-9B12-D54CB31B68CC}" dt="2024-03-01T21:02:26.241" v="311" actId="1038"/>
      <pc:docMkLst>
        <pc:docMk/>
      </pc:docMkLst>
      <pc:sldChg chg="addSp delSp modSp mod">
        <pc:chgData name="Dagostino, Leonidas" userId="d42e52ab-e44d-4c88-95a1-c18248a0edcf" providerId="ADAL" clId="{EDC8207B-97C4-4321-9B12-D54CB31B68CC}" dt="2024-02-12T18:17:33.870" v="7" actId="1076"/>
        <pc:sldMkLst>
          <pc:docMk/>
          <pc:sldMk cId="1437810819" sldId="262"/>
        </pc:sldMkLst>
        <pc:picChg chg="del mod">
          <ac:chgData name="Dagostino, Leonidas" userId="d42e52ab-e44d-4c88-95a1-c18248a0edcf" providerId="ADAL" clId="{EDC8207B-97C4-4321-9B12-D54CB31B68CC}" dt="2024-02-12T18:17:28.911" v="5" actId="478"/>
          <ac:picMkLst>
            <pc:docMk/>
            <pc:sldMk cId="1437810819" sldId="262"/>
            <ac:picMk id="5" creationId="{7E2E4F8E-3A38-F819-A82D-5F88922F2C59}"/>
          </ac:picMkLst>
        </pc:picChg>
        <pc:picChg chg="add mod">
          <ac:chgData name="Dagostino, Leonidas" userId="d42e52ab-e44d-4c88-95a1-c18248a0edcf" providerId="ADAL" clId="{EDC8207B-97C4-4321-9B12-D54CB31B68CC}" dt="2024-02-12T18:17:33.870" v="7" actId="1076"/>
          <ac:picMkLst>
            <pc:docMk/>
            <pc:sldMk cId="1437810819" sldId="262"/>
            <ac:picMk id="8" creationId="{DC6ADC5E-E3E6-698E-6996-F364912B7940}"/>
          </ac:picMkLst>
        </pc:picChg>
      </pc:sldChg>
      <pc:sldChg chg="addSp modSp mod">
        <pc:chgData name="Dagostino, Leonidas" userId="d42e52ab-e44d-4c88-95a1-c18248a0edcf" providerId="ADAL" clId="{EDC8207B-97C4-4321-9B12-D54CB31B68CC}" dt="2024-03-01T21:02:26.241" v="311" actId="1038"/>
        <pc:sldMkLst>
          <pc:docMk/>
          <pc:sldMk cId="794843755" sldId="264"/>
        </pc:sldMkLst>
        <pc:spChg chg="add mod">
          <ac:chgData name="Dagostino, Leonidas" userId="d42e52ab-e44d-4c88-95a1-c18248a0edcf" providerId="ADAL" clId="{EDC8207B-97C4-4321-9B12-D54CB31B68CC}" dt="2024-03-01T21:02:26.241" v="311" actId="1038"/>
          <ac:spMkLst>
            <pc:docMk/>
            <pc:sldMk cId="794843755" sldId="264"/>
            <ac:spMk id="8" creationId="{D23A003D-B2E0-0CF2-CDBE-2C4F6D643B6D}"/>
          </ac:spMkLst>
        </pc:spChg>
        <pc:spChg chg="add mod">
          <ac:chgData name="Dagostino, Leonidas" userId="d42e52ab-e44d-4c88-95a1-c18248a0edcf" providerId="ADAL" clId="{EDC8207B-97C4-4321-9B12-D54CB31B68CC}" dt="2024-03-01T20:57:09.423" v="291" actId="20577"/>
          <ac:spMkLst>
            <pc:docMk/>
            <pc:sldMk cId="794843755" sldId="264"/>
            <ac:spMk id="9" creationId="{57F3A884-8AEB-07EE-192A-2B1D2FBE1D10}"/>
          </ac:spMkLst>
        </pc:spChg>
      </pc:sldChg>
    </pc:docChg>
  </pc:docChgLst>
  <pc:docChgLst>
    <pc:chgData name="Devkar, Vikas" userId="acbd15ec-55d1-4a76-83ac-3f1d82711ed5" providerId="ADAL" clId="{4D867438-886E-4687-B2D1-7FC85E58D03B}"/>
    <pc:docChg chg="undo custSel delSld modSld">
      <pc:chgData name="Devkar, Vikas" userId="acbd15ec-55d1-4a76-83ac-3f1d82711ed5" providerId="ADAL" clId="{4D867438-886E-4687-B2D1-7FC85E58D03B}" dt="2024-01-26T23:42:09.400" v="963" actId="20577"/>
      <pc:docMkLst>
        <pc:docMk/>
      </pc:docMkLst>
      <pc:sldChg chg="modSp mod">
        <pc:chgData name="Devkar, Vikas" userId="acbd15ec-55d1-4a76-83ac-3f1d82711ed5" providerId="ADAL" clId="{4D867438-886E-4687-B2D1-7FC85E58D03B}" dt="2024-01-26T23:42:09.400" v="963" actId="20577"/>
        <pc:sldMkLst>
          <pc:docMk/>
          <pc:sldMk cId="1604500440" sldId="256"/>
        </pc:sldMkLst>
        <pc:spChg chg="mod">
          <ac:chgData name="Devkar, Vikas" userId="acbd15ec-55d1-4a76-83ac-3f1d82711ed5" providerId="ADAL" clId="{4D867438-886E-4687-B2D1-7FC85E58D03B}" dt="2024-01-24T16:54:02.605" v="577" actId="1076"/>
          <ac:spMkLst>
            <pc:docMk/>
            <pc:sldMk cId="1604500440" sldId="256"/>
            <ac:spMk id="3" creationId="{2896C643-36B3-C720-1176-338AA62D6ED9}"/>
          </ac:spMkLst>
        </pc:spChg>
        <pc:spChg chg="mod">
          <ac:chgData name="Devkar, Vikas" userId="acbd15ec-55d1-4a76-83ac-3f1d82711ed5" providerId="ADAL" clId="{4D867438-886E-4687-B2D1-7FC85E58D03B}" dt="2024-01-24T16:54:27.904" v="579" actId="1076"/>
          <ac:spMkLst>
            <pc:docMk/>
            <pc:sldMk cId="1604500440" sldId="256"/>
            <ac:spMk id="5" creationId="{267B5775-2EA1-057F-29AE-A0A20F28F365}"/>
          </ac:spMkLst>
        </pc:spChg>
        <pc:spChg chg="mod">
          <ac:chgData name="Devkar, Vikas" userId="acbd15ec-55d1-4a76-83ac-3f1d82711ed5" providerId="ADAL" clId="{4D867438-886E-4687-B2D1-7FC85E58D03B}" dt="2024-01-24T16:54:36.632" v="580" actId="1076"/>
          <ac:spMkLst>
            <pc:docMk/>
            <pc:sldMk cId="1604500440" sldId="256"/>
            <ac:spMk id="6" creationId="{25C1E047-61A8-283D-842B-8E4DB3196396}"/>
          </ac:spMkLst>
        </pc:spChg>
        <pc:spChg chg="mod">
          <ac:chgData name="Devkar, Vikas" userId="acbd15ec-55d1-4a76-83ac-3f1d82711ed5" providerId="ADAL" clId="{4D867438-886E-4687-B2D1-7FC85E58D03B}" dt="2024-01-26T23:42:09.400" v="963" actId="20577"/>
          <ac:spMkLst>
            <pc:docMk/>
            <pc:sldMk cId="1604500440" sldId="256"/>
            <ac:spMk id="7" creationId="{A1F18A16-F4AD-BA15-75E0-DBBCAFFB2CCA}"/>
          </ac:spMkLst>
        </pc:spChg>
        <pc:grpChg chg="mod">
          <ac:chgData name="Devkar, Vikas" userId="acbd15ec-55d1-4a76-83ac-3f1d82711ed5" providerId="ADAL" clId="{4D867438-886E-4687-B2D1-7FC85E58D03B}" dt="2024-01-24T16:54:43.181" v="581" actId="1076"/>
          <ac:grpSpMkLst>
            <pc:docMk/>
            <pc:sldMk cId="1604500440" sldId="256"/>
            <ac:grpSpMk id="9" creationId="{D038214F-DF9B-FA33-99CE-D55383CF5013}"/>
          </ac:grpSpMkLst>
        </pc:grpChg>
        <pc:picChg chg="mod">
          <ac:chgData name="Devkar, Vikas" userId="acbd15ec-55d1-4a76-83ac-3f1d82711ed5" providerId="ADAL" clId="{4D867438-886E-4687-B2D1-7FC85E58D03B}" dt="2024-01-24T16:55:35.599" v="588" actId="1076"/>
          <ac:picMkLst>
            <pc:docMk/>
            <pc:sldMk cId="1604500440" sldId="256"/>
            <ac:picMk id="4" creationId="{8650781B-AC10-2E14-7193-96FAEFC0AEE0}"/>
          </ac:picMkLst>
        </pc:picChg>
      </pc:sldChg>
      <pc:sldChg chg="addSp delSp modSp mod">
        <pc:chgData name="Devkar, Vikas" userId="acbd15ec-55d1-4a76-83ac-3f1d82711ed5" providerId="ADAL" clId="{4D867438-886E-4687-B2D1-7FC85E58D03B}" dt="2024-01-24T16:49:06.447" v="542" actId="1076"/>
        <pc:sldMkLst>
          <pc:docMk/>
          <pc:sldMk cId="2353496295" sldId="257"/>
        </pc:sldMkLst>
        <pc:spChg chg="mod">
          <ac:chgData name="Devkar, Vikas" userId="acbd15ec-55d1-4a76-83ac-3f1d82711ed5" providerId="ADAL" clId="{4D867438-886E-4687-B2D1-7FC85E58D03B}" dt="2024-01-24T16:48:59.989" v="541" actId="1076"/>
          <ac:spMkLst>
            <pc:docMk/>
            <pc:sldMk cId="2353496295" sldId="257"/>
            <ac:spMk id="2" creationId="{D6AA2FB8-1CA5-F197-0DE2-487B4877882F}"/>
          </ac:spMkLst>
        </pc:spChg>
        <pc:spChg chg="mod">
          <ac:chgData name="Devkar, Vikas" userId="acbd15ec-55d1-4a76-83ac-3f1d82711ed5" providerId="ADAL" clId="{4D867438-886E-4687-B2D1-7FC85E58D03B}" dt="2024-01-24T16:48:59.989" v="541" actId="1076"/>
          <ac:spMkLst>
            <pc:docMk/>
            <pc:sldMk cId="2353496295" sldId="257"/>
            <ac:spMk id="3" creationId="{816778EE-91FC-3D08-8425-BCBB166A26BA}"/>
          </ac:spMkLst>
        </pc:spChg>
        <pc:spChg chg="mod">
          <ac:chgData name="Devkar, Vikas" userId="acbd15ec-55d1-4a76-83ac-3f1d82711ed5" providerId="ADAL" clId="{4D867438-886E-4687-B2D1-7FC85E58D03B}" dt="2024-01-24T16:48:59.989" v="541" actId="1076"/>
          <ac:spMkLst>
            <pc:docMk/>
            <pc:sldMk cId="2353496295" sldId="257"/>
            <ac:spMk id="12" creationId="{EE11CAC0-AEDE-94C8-41CC-3FE479E6E222}"/>
          </ac:spMkLst>
        </pc:spChg>
        <pc:spChg chg="mod">
          <ac:chgData name="Devkar, Vikas" userId="acbd15ec-55d1-4a76-83ac-3f1d82711ed5" providerId="ADAL" clId="{4D867438-886E-4687-B2D1-7FC85E58D03B}" dt="2024-01-24T16:49:06.447" v="542" actId="1076"/>
          <ac:spMkLst>
            <pc:docMk/>
            <pc:sldMk cId="2353496295" sldId="257"/>
            <ac:spMk id="13" creationId="{1E8A8E73-D593-34F9-B40C-79F2F7DDC6DE}"/>
          </ac:spMkLst>
        </pc:spChg>
        <pc:spChg chg="del">
          <ac:chgData name="Devkar, Vikas" userId="acbd15ec-55d1-4a76-83ac-3f1d82711ed5" providerId="ADAL" clId="{4D867438-886E-4687-B2D1-7FC85E58D03B}" dt="2024-01-05T23:10:33.194" v="8" actId="478"/>
          <ac:spMkLst>
            <pc:docMk/>
            <pc:sldMk cId="2353496295" sldId="257"/>
            <ac:spMk id="14" creationId="{6E9AEBEA-469B-7E61-5F36-E87CBD63ED6D}"/>
          </ac:spMkLst>
        </pc:spChg>
        <pc:spChg chg="add mod">
          <ac:chgData name="Devkar, Vikas" userId="acbd15ec-55d1-4a76-83ac-3f1d82711ed5" providerId="ADAL" clId="{4D867438-886E-4687-B2D1-7FC85E58D03B}" dt="2024-01-24T16:48:59.989" v="541" actId="1076"/>
          <ac:spMkLst>
            <pc:docMk/>
            <pc:sldMk cId="2353496295" sldId="257"/>
            <ac:spMk id="15" creationId="{F9003170-D647-71D3-CF8B-F63811A341C0}"/>
          </ac:spMkLst>
        </pc:spChg>
        <pc:picChg chg="mod">
          <ac:chgData name="Devkar, Vikas" userId="acbd15ec-55d1-4a76-83ac-3f1d82711ed5" providerId="ADAL" clId="{4D867438-886E-4687-B2D1-7FC85E58D03B}" dt="2024-01-24T16:48:59.989" v="541" actId="1076"/>
          <ac:picMkLst>
            <pc:docMk/>
            <pc:sldMk cId="2353496295" sldId="257"/>
            <ac:picMk id="4" creationId="{33EA40E7-3DC9-F6DF-3063-78739A2ED3A9}"/>
          </ac:picMkLst>
        </pc:picChg>
        <pc:picChg chg="mod">
          <ac:chgData name="Devkar, Vikas" userId="acbd15ec-55d1-4a76-83ac-3f1d82711ed5" providerId="ADAL" clId="{4D867438-886E-4687-B2D1-7FC85E58D03B}" dt="2024-01-24T16:48:59.989" v="541" actId="1076"/>
          <ac:picMkLst>
            <pc:docMk/>
            <pc:sldMk cId="2353496295" sldId="257"/>
            <ac:picMk id="5" creationId="{BC4B593B-F9F9-3162-DCA4-E49944D47FA7}"/>
          </ac:picMkLst>
        </pc:picChg>
        <pc:picChg chg="mod">
          <ac:chgData name="Devkar, Vikas" userId="acbd15ec-55d1-4a76-83ac-3f1d82711ed5" providerId="ADAL" clId="{4D867438-886E-4687-B2D1-7FC85E58D03B}" dt="2024-01-24T16:48:59.989" v="541" actId="1076"/>
          <ac:picMkLst>
            <pc:docMk/>
            <pc:sldMk cId="2353496295" sldId="257"/>
            <ac:picMk id="6" creationId="{ACEADD36-435A-706A-0AE9-EBEEFE9AF23F}"/>
          </ac:picMkLst>
        </pc:picChg>
        <pc:picChg chg="mod">
          <ac:chgData name="Devkar, Vikas" userId="acbd15ec-55d1-4a76-83ac-3f1d82711ed5" providerId="ADAL" clId="{4D867438-886E-4687-B2D1-7FC85E58D03B}" dt="2024-01-24T16:48:59.989" v="541" actId="1076"/>
          <ac:picMkLst>
            <pc:docMk/>
            <pc:sldMk cId="2353496295" sldId="257"/>
            <ac:picMk id="7" creationId="{E389C274-F48A-AD44-02D3-D878D9D08361}"/>
          </ac:picMkLst>
        </pc:picChg>
        <pc:picChg chg="mod">
          <ac:chgData name="Devkar, Vikas" userId="acbd15ec-55d1-4a76-83ac-3f1d82711ed5" providerId="ADAL" clId="{4D867438-886E-4687-B2D1-7FC85E58D03B}" dt="2024-01-24T16:48:59.989" v="541" actId="1076"/>
          <ac:picMkLst>
            <pc:docMk/>
            <pc:sldMk cId="2353496295" sldId="257"/>
            <ac:picMk id="8" creationId="{42BD8504-A15A-0C1F-A71B-97100C7768C1}"/>
          </ac:picMkLst>
        </pc:picChg>
        <pc:picChg chg="mod">
          <ac:chgData name="Devkar, Vikas" userId="acbd15ec-55d1-4a76-83ac-3f1d82711ed5" providerId="ADAL" clId="{4D867438-886E-4687-B2D1-7FC85E58D03B}" dt="2024-01-24T16:48:59.989" v="541" actId="1076"/>
          <ac:picMkLst>
            <pc:docMk/>
            <pc:sldMk cId="2353496295" sldId="257"/>
            <ac:picMk id="9" creationId="{1B540D38-7D7A-2DBE-4294-66636BAA9EFB}"/>
          </ac:picMkLst>
        </pc:picChg>
        <pc:picChg chg="mod">
          <ac:chgData name="Devkar, Vikas" userId="acbd15ec-55d1-4a76-83ac-3f1d82711ed5" providerId="ADAL" clId="{4D867438-886E-4687-B2D1-7FC85E58D03B}" dt="2024-01-24T16:48:59.989" v="541" actId="1076"/>
          <ac:picMkLst>
            <pc:docMk/>
            <pc:sldMk cId="2353496295" sldId="257"/>
            <ac:picMk id="10" creationId="{4A96A991-9253-EBE7-A0C6-5E298683CF46}"/>
          </ac:picMkLst>
        </pc:picChg>
        <pc:picChg chg="mod">
          <ac:chgData name="Devkar, Vikas" userId="acbd15ec-55d1-4a76-83ac-3f1d82711ed5" providerId="ADAL" clId="{4D867438-886E-4687-B2D1-7FC85E58D03B}" dt="2024-01-24T16:48:59.989" v="541" actId="1076"/>
          <ac:picMkLst>
            <pc:docMk/>
            <pc:sldMk cId="2353496295" sldId="257"/>
            <ac:picMk id="11" creationId="{5AE816F1-0434-E091-206B-91B592A351E4}"/>
          </ac:picMkLst>
        </pc:picChg>
      </pc:sldChg>
      <pc:sldChg chg="del">
        <pc:chgData name="Devkar, Vikas" userId="acbd15ec-55d1-4a76-83ac-3f1d82711ed5" providerId="ADAL" clId="{4D867438-886E-4687-B2D1-7FC85E58D03B}" dt="2024-01-26T23:36:00.094" v="666" actId="47"/>
        <pc:sldMkLst>
          <pc:docMk/>
          <pc:sldMk cId="2859274678" sldId="258"/>
        </pc:sldMkLst>
      </pc:sldChg>
      <pc:sldChg chg="del">
        <pc:chgData name="Devkar, Vikas" userId="acbd15ec-55d1-4a76-83ac-3f1d82711ed5" providerId="ADAL" clId="{4D867438-886E-4687-B2D1-7FC85E58D03B}" dt="2024-01-26T23:35:58.347" v="665" actId="47"/>
        <pc:sldMkLst>
          <pc:docMk/>
          <pc:sldMk cId="2320068136" sldId="260"/>
        </pc:sldMkLst>
      </pc:sldChg>
      <pc:sldChg chg="del">
        <pc:chgData name="Devkar, Vikas" userId="acbd15ec-55d1-4a76-83ac-3f1d82711ed5" providerId="ADAL" clId="{4D867438-886E-4687-B2D1-7FC85E58D03B}" dt="2024-01-26T23:36:01.062" v="667" actId="47"/>
        <pc:sldMkLst>
          <pc:docMk/>
          <pc:sldMk cId="3233729401" sldId="261"/>
        </pc:sldMkLst>
      </pc:sldChg>
      <pc:sldChg chg="modSp mod">
        <pc:chgData name="Devkar, Vikas" userId="acbd15ec-55d1-4a76-83ac-3f1d82711ed5" providerId="ADAL" clId="{4D867438-886E-4687-B2D1-7FC85E58D03B}" dt="2024-01-24T16:48:41.867" v="540" actId="1076"/>
        <pc:sldMkLst>
          <pc:docMk/>
          <pc:sldMk cId="1437810819" sldId="262"/>
        </pc:sldMkLst>
        <pc:spChg chg="mod">
          <ac:chgData name="Devkar, Vikas" userId="acbd15ec-55d1-4a76-83ac-3f1d82711ed5" providerId="ADAL" clId="{4D867438-886E-4687-B2D1-7FC85E58D03B}" dt="2024-01-24T00:11:12.119" v="452" actId="20577"/>
          <ac:spMkLst>
            <pc:docMk/>
            <pc:sldMk cId="1437810819" sldId="262"/>
            <ac:spMk id="42" creationId="{28F568E8-3645-BB50-A71F-27BA32D8D5C2}"/>
          </ac:spMkLst>
        </pc:spChg>
        <pc:grpChg chg="mod">
          <ac:chgData name="Devkar, Vikas" userId="acbd15ec-55d1-4a76-83ac-3f1d82711ed5" providerId="ADAL" clId="{4D867438-886E-4687-B2D1-7FC85E58D03B}" dt="2024-01-24T16:48:33.756" v="539" actId="1076"/>
          <ac:grpSpMkLst>
            <pc:docMk/>
            <pc:sldMk cId="1437810819" sldId="262"/>
            <ac:grpSpMk id="4" creationId="{4C12F03E-9E8E-ECF2-F61F-6F06DEFF4081}"/>
          </ac:grpSpMkLst>
        </pc:grpChg>
        <pc:picChg chg="mod">
          <ac:chgData name="Devkar, Vikas" userId="acbd15ec-55d1-4a76-83ac-3f1d82711ed5" providerId="ADAL" clId="{4D867438-886E-4687-B2D1-7FC85E58D03B}" dt="2024-01-24T16:48:31.032" v="538" actId="1076"/>
          <ac:picMkLst>
            <pc:docMk/>
            <pc:sldMk cId="1437810819" sldId="262"/>
            <ac:picMk id="3" creationId="{A7FE0156-B454-678F-37C3-F9D56CBA9AC0}"/>
          </ac:picMkLst>
        </pc:picChg>
        <pc:picChg chg="mod">
          <ac:chgData name="Devkar, Vikas" userId="acbd15ec-55d1-4a76-83ac-3f1d82711ed5" providerId="ADAL" clId="{4D867438-886E-4687-B2D1-7FC85E58D03B}" dt="2024-01-24T16:48:41.867" v="540" actId="1076"/>
          <ac:picMkLst>
            <pc:docMk/>
            <pc:sldMk cId="1437810819" sldId="262"/>
            <ac:picMk id="5" creationId="{7E2E4F8E-3A38-F819-A82D-5F88922F2C59}"/>
          </ac:picMkLst>
        </pc:picChg>
      </pc:sldChg>
      <pc:sldChg chg="addSp modSp mod">
        <pc:chgData name="Devkar, Vikas" userId="acbd15ec-55d1-4a76-83ac-3f1d82711ed5" providerId="ADAL" clId="{4D867438-886E-4687-B2D1-7FC85E58D03B}" dt="2024-01-18T06:42:08.828" v="375" actId="1076"/>
        <pc:sldMkLst>
          <pc:docMk/>
          <pc:sldMk cId="794843755" sldId="264"/>
        </pc:sldMkLst>
        <pc:spChg chg="add mod">
          <ac:chgData name="Devkar, Vikas" userId="acbd15ec-55d1-4a76-83ac-3f1d82711ed5" providerId="ADAL" clId="{4D867438-886E-4687-B2D1-7FC85E58D03B}" dt="2024-01-18T06:41:59.155" v="372" actId="1076"/>
          <ac:spMkLst>
            <pc:docMk/>
            <pc:sldMk cId="794843755" sldId="264"/>
            <ac:spMk id="4" creationId="{7D593560-ACFB-F8C2-73F4-168A14781887}"/>
          </ac:spMkLst>
        </pc:spChg>
        <pc:spChg chg="add mod">
          <ac:chgData name="Devkar, Vikas" userId="acbd15ec-55d1-4a76-83ac-3f1d82711ed5" providerId="ADAL" clId="{4D867438-886E-4687-B2D1-7FC85E58D03B}" dt="2024-01-18T06:41:59.155" v="372" actId="1076"/>
          <ac:spMkLst>
            <pc:docMk/>
            <pc:sldMk cId="794843755" sldId="264"/>
            <ac:spMk id="5" creationId="{92375EEC-00F9-91C1-1612-0917D283BA86}"/>
          </ac:spMkLst>
        </pc:spChg>
        <pc:spChg chg="mod">
          <ac:chgData name="Devkar, Vikas" userId="acbd15ec-55d1-4a76-83ac-3f1d82711ed5" providerId="ADAL" clId="{4D867438-886E-4687-B2D1-7FC85E58D03B}" dt="2024-01-09T01:45:56.709" v="153" actId="113"/>
          <ac:spMkLst>
            <pc:docMk/>
            <pc:sldMk cId="794843755" sldId="264"/>
            <ac:spMk id="7" creationId="{61C45261-E6F1-BCD3-70E4-7B438A09B38F}"/>
          </ac:spMkLst>
        </pc:spChg>
        <pc:grpChg chg="mod">
          <ac:chgData name="Devkar, Vikas" userId="acbd15ec-55d1-4a76-83ac-3f1d82711ed5" providerId="ADAL" clId="{4D867438-886E-4687-B2D1-7FC85E58D03B}" dt="2024-01-18T06:42:05.873" v="374" actId="1076"/>
          <ac:grpSpMkLst>
            <pc:docMk/>
            <pc:sldMk cId="794843755" sldId="264"/>
            <ac:grpSpMk id="18" creationId="{EDB99B2A-34CA-9256-80DC-95B9C70BF965}"/>
          </ac:grpSpMkLst>
        </pc:grpChg>
        <pc:picChg chg="mod">
          <ac:chgData name="Devkar, Vikas" userId="acbd15ec-55d1-4a76-83ac-3f1d82711ed5" providerId="ADAL" clId="{4D867438-886E-4687-B2D1-7FC85E58D03B}" dt="2024-01-18T06:42:08.828" v="375" actId="1076"/>
          <ac:picMkLst>
            <pc:docMk/>
            <pc:sldMk cId="794843755" sldId="264"/>
            <ac:picMk id="2" creationId="{7C34630E-173E-7746-C548-3D3C58E2580A}"/>
          </ac:picMkLst>
        </pc:picChg>
      </pc:sldChg>
      <pc:sldChg chg="addSp delSp modSp mod">
        <pc:chgData name="Devkar, Vikas" userId="acbd15ec-55d1-4a76-83ac-3f1d82711ed5" providerId="ADAL" clId="{4D867438-886E-4687-B2D1-7FC85E58D03B}" dt="2024-01-09T02:07:23.090" v="192" actId="20577"/>
        <pc:sldMkLst>
          <pc:docMk/>
          <pc:sldMk cId="1845444862" sldId="265"/>
        </pc:sldMkLst>
        <pc:spChg chg="mod">
          <ac:chgData name="Devkar, Vikas" userId="acbd15ec-55d1-4a76-83ac-3f1d82711ed5" providerId="ADAL" clId="{4D867438-886E-4687-B2D1-7FC85E58D03B}" dt="2024-01-08T06:29:21.568" v="85" actId="1076"/>
          <ac:spMkLst>
            <pc:docMk/>
            <pc:sldMk cId="1845444862" sldId="265"/>
            <ac:spMk id="3" creationId="{0E1FCA99-A517-63DD-2962-C2E0926CFB1B}"/>
          </ac:spMkLst>
        </pc:spChg>
        <pc:spChg chg="mod">
          <ac:chgData name="Devkar, Vikas" userId="acbd15ec-55d1-4a76-83ac-3f1d82711ed5" providerId="ADAL" clId="{4D867438-886E-4687-B2D1-7FC85E58D03B}" dt="2024-01-09T02:07:23.090" v="192" actId="20577"/>
          <ac:spMkLst>
            <pc:docMk/>
            <pc:sldMk cId="1845444862" sldId="265"/>
            <ac:spMk id="4" creationId="{47E1C263-20BF-3010-7C86-6DDDAB808C91}"/>
          </ac:spMkLst>
        </pc:spChg>
        <pc:spChg chg="mod">
          <ac:chgData name="Devkar, Vikas" userId="acbd15ec-55d1-4a76-83ac-3f1d82711ed5" providerId="ADAL" clId="{4D867438-886E-4687-B2D1-7FC85E58D03B}" dt="2024-01-08T06:29:18.343" v="84" actId="1076"/>
          <ac:spMkLst>
            <pc:docMk/>
            <pc:sldMk cId="1845444862" sldId="265"/>
            <ac:spMk id="10" creationId="{E3A8E084-561E-3CC7-26EA-CE7AB3B3808C}"/>
          </ac:spMkLst>
        </pc:spChg>
        <pc:picChg chg="mod">
          <ac:chgData name="Devkar, Vikas" userId="acbd15ec-55d1-4a76-83ac-3f1d82711ed5" providerId="ADAL" clId="{4D867438-886E-4687-B2D1-7FC85E58D03B}" dt="2024-01-08T06:29:24.066" v="86" actId="1076"/>
          <ac:picMkLst>
            <pc:docMk/>
            <pc:sldMk cId="1845444862" sldId="265"/>
            <ac:picMk id="2" creationId="{28FBD11A-D19F-DB78-8829-8C8157B0FAFF}"/>
          </ac:picMkLst>
        </pc:picChg>
        <pc:picChg chg="add del mod">
          <ac:chgData name="Devkar, Vikas" userId="acbd15ec-55d1-4a76-83ac-3f1d82711ed5" providerId="ADAL" clId="{4D867438-886E-4687-B2D1-7FC85E58D03B}" dt="2024-01-08T06:29:10.110" v="81"/>
          <ac:picMkLst>
            <pc:docMk/>
            <pc:sldMk cId="1845444862" sldId="265"/>
            <ac:picMk id="5" creationId="{22F2D531-8093-E21F-1DE0-4ED4FE0FF4A5}"/>
          </ac:picMkLst>
        </pc:picChg>
        <pc:picChg chg="mod">
          <ac:chgData name="Devkar, Vikas" userId="acbd15ec-55d1-4a76-83ac-3f1d82711ed5" providerId="ADAL" clId="{4D867438-886E-4687-B2D1-7FC85E58D03B}" dt="2024-01-08T06:29:10.683" v="82" actId="1076"/>
          <ac:picMkLst>
            <pc:docMk/>
            <pc:sldMk cId="1845444862" sldId="265"/>
            <ac:picMk id="6" creationId="{8918A5F2-2F5A-933D-0122-EE33CC2DE2E0}"/>
          </ac:picMkLst>
        </pc:picChg>
      </pc:sldChg>
      <pc:sldChg chg="modSp mod">
        <pc:chgData name="Devkar, Vikas" userId="acbd15ec-55d1-4a76-83ac-3f1d82711ed5" providerId="ADAL" clId="{4D867438-886E-4687-B2D1-7FC85E58D03B}" dt="2024-01-23T16:20:31.049" v="444" actId="20577"/>
        <pc:sldMkLst>
          <pc:docMk/>
          <pc:sldMk cId="417503466" sldId="266"/>
        </pc:sldMkLst>
        <pc:spChg chg="mod">
          <ac:chgData name="Devkar, Vikas" userId="acbd15ec-55d1-4a76-83ac-3f1d82711ed5" providerId="ADAL" clId="{4D867438-886E-4687-B2D1-7FC85E58D03B}" dt="2024-01-23T16:20:31.049" v="444" actId="20577"/>
          <ac:spMkLst>
            <pc:docMk/>
            <pc:sldMk cId="417503466" sldId="266"/>
            <ac:spMk id="4" creationId="{F1480AE0-CD30-03E5-6124-496AC4D0B0E4}"/>
          </ac:spMkLst>
        </pc:spChg>
      </pc:sldChg>
      <pc:sldChg chg="modSp mod">
        <pc:chgData name="Devkar, Vikas" userId="acbd15ec-55d1-4a76-83ac-3f1d82711ed5" providerId="ADAL" clId="{4D867438-886E-4687-B2D1-7FC85E58D03B}" dt="2024-01-23T16:21:42.399" v="446" actId="20577"/>
        <pc:sldMkLst>
          <pc:docMk/>
          <pc:sldMk cId="1922289499" sldId="267"/>
        </pc:sldMkLst>
        <pc:spChg chg="mod">
          <ac:chgData name="Devkar, Vikas" userId="acbd15ec-55d1-4a76-83ac-3f1d82711ed5" providerId="ADAL" clId="{4D867438-886E-4687-B2D1-7FC85E58D03B}" dt="2024-01-08T06:45:11.117" v="88" actId="1076"/>
          <ac:spMkLst>
            <pc:docMk/>
            <pc:sldMk cId="1922289499" sldId="267"/>
            <ac:spMk id="3" creationId="{853A69FC-E3DE-DF53-7C7B-54203620809C}"/>
          </ac:spMkLst>
        </pc:spChg>
        <pc:spChg chg="mod">
          <ac:chgData name="Devkar, Vikas" userId="acbd15ec-55d1-4a76-83ac-3f1d82711ed5" providerId="ADAL" clId="{4D867438-886E-4687-B2D1-7FC85E58D03B}" dt="2024-01-23T16:21:42.399" v="446" actId="20577"/>
          <ac:spMkLst>
            <pc:docMk/>
            <pc:sldMk cId="1922289499" sldId="267"/>
            <ac:spMk id="8" creationId="{A373B488-B0CF-2144-1213-219AA7C07B87}"/>
          </ac:spMkLst>
        </pc:spChg>
        <pc:spChg chg="mod">
          <ac:chgData name="Devkar, Vikas" userId="acbd15ec-55d1-4a76-83ac-3f1d82711ed5" providerId="ADAL" clId="{4D867438-886E-4687-B2D1-7FC85E58D03B}" dt="2024-01-08T06:45:11.117" v="88" actId="1076"/>
          <ac:spMkLst>
            <pc:docMk/>
            <pc:sldMk cId="1922289499" sldId="267"/>
            <ac:spMk id="10" creationId="{B5AED450-D013-032F-CB22-1E452FB97610}"/>
          </ac:spMkLst>
        </pc:spChg>
        <pc:spChg chg="mod">
          <ac:chgData name="Devkar, Vikas" userId="acbd15ec-55d1-4a76-83ac-3f1d82711ed5" providerId="ADAL" clId="{4D867438-886E-4687-B2D1-7FC85E58D03B}" dt="2024-01-08T06:45:11.117" v="88" actId="1076"/>
          <ac:spMkLst>
            <pc:docMk/>
            <pc:sldMk cId="1922289499" sldId="267"/>
            <ac:spMk id="11" creationId="{50C299BE-1C3F-2925-72B9-F8948525BD30}"/>
          </ac:spMkLst>
        </pc:spChg>
        <pc:picChg chg="mod">
          <ac:chgData name="Devkar, Vikas" userId="acbd15ec-55d1-4a76-83ac-3f1d82711ed5" providerId="ADAL" clId="{4D867438-886E-4687-B2D1-7FC85E58D03B}" dt="2024-01-08T06:45:11.117" v="88" actId="1076"/>
          <ac:picMkLst>
            <pc:docMk/>
            <pc:sldMk cId="1922289499" sldId="267"/>
            <ac:picMk id="2" creationId="{2643B9DB-271B-8EEF-6A22-874DD8D20787}"/>
          </ac:picMkLst>
        </pc:picChg>
        <pc:picChg chg="mod">
          <ac:chgData name="Devkar, Vikas" userId="acbd15ec-55d1-4a76-83ac-3f1d82711ed5" providerId="ADAL" clId="{4D867438-886E-4687-B2D1-7FC85E58D03B}" dt="2024-01-08T06:45:11.117" v="88" actId="1076"/>
          <ac:picMkLst>
            <pc:docMk/>
            <pc:sldMk cId="1922289499" sldId="267"/>
            <ac:picMk id="5" creationId="{AA86745D-3D68-E449-B450-B838D6F49851}"/>
          </ac:picMkLst>
        </pc:picChg>
        <pc:picChg chg="mod">
          <ac:chgData name="Devkar, Vikas" userId="acbd15ec-55d1-4a76-83ac-3f1d82711ed5" providerId="ADAL" clId="{4D867438-886E-4687-B2D1-7FC85E58D03B}" dt="2024-01-08T06:45:11.117" v="88" actId="1076"/>
          <ac:picMkLst>
            <pc:docMk/>
            <pc:sldMk cId="1922289499" sldId="267"/>
            <ac:picMk id="7" creationId="{60CF31E5-4C3A-F7A3-4BCF-F8236B1D265F}"/>
          </ac:picMkLst>
        </pc:picChg>
      </pc:sldChg>
      <pc:sldChg chg="addSp delSp modSp mod">
        <pc:chgData name="Devkar, Vikas" userId="acbd15ec-55d1-4a76-83ac-3f1d82711ed5" providerId="ADAL" clId="{4D867438-886E-4687-B2D1-7FC85E58D03B}" dt="2024-01-24T16:48:01.750" v="536" actId="1076"/>
        <pc:sldMkLst>
          <pc:docMk/>
          <pc:sldMk cId="3436963830" sldId="268"/>
        </pc:sldMkLst>
        <pc:spChg chg="mod">
          <ac:chgData name="Devkar, Vikas" userId="acbd15ec-55d1-4a76-83ac-3f1d82711ed5" providerId="ADAL" clId="{4D867438-886E-4687-B2D1-7FC85E58D03B}" dt="2024-01-24T16:41:36.994" v="496" actId="1076"/>
          <ac:spMkLst>
            <pc:docMk/>
            <pc:sldMk cId="3436963830" sldId="268"/>
            <ac:spMk id="2" creationId="{768ADAE3-6334-88B4-1D66-D57F1415B718}"/>
          </ac:spMkLst>
        </pc:spChg>
        <pc:spChg chg="add mod ord">
          <ac:chgData name="Devkar, Vikas" userId="acbd15ec-55d1-4a76-83ac-3f1d82711ed5" providerId="ADAL" clId="{4D867438-886E-4687-B2D1-7FC85E58D03B}" dt="2024-01-24T16:44:38.499" v="520" actId="1076"/>
          <ac:spMkLst>
            <pc:docMk/>
            <pc:sldMk cId="3436963830" sldId="268"/>
            <ac:spMk id="3" creationId="{844CC83F-FB26-61D6-19AD-52B1310FEFF8}"/>
          </ac:spMkLst>
        </pc:spChg>
        <pc:spChg chg="mod">
          <ac:chgData name="Devkar, Vikas" userId="acbd15ec-55d1-4a76-83ac-3f1d82711ed5" providerId="ADAL" clId="{4D867438-886E-4687-B2D1-7FC85E58D03B}" dt="2024-01-24T16:48:01.750" v="536" actId="1076"/>
          <ac:spMkLst>
            <pc:docMk/>
            <pc:sldMk cId="3436963830" sldId="268"/>
            <ac:spMk id="4" creationId="{E9ABEC9B-7711-5DEE-1919-B3C572856D23}"/>
          </ac:spMkLst>
        </pc:spChg>
        <pc:spChg chg="add mod ord">
          <ac:chgData name="Devkar, Vikas" userId="acbd15ec-55d1-4a76-83ac-3f1d82711ed5" providerId="ADAL" clId="{4D867438-886E-4687-B2D1-7FC85E58D03B}" dt="2024-01-24T16:41:55.743" v="499" actId="164"/>
          <ac:spMkLst>
            <pc:docMk/>
            <pc:sldMk cId="3436963830" sldId="268"/>
            <ac:spMk id="5" creationId="{8960662B-F76F-2080-DE80-0C3E6D4E7450}"/>
          </ac:spMkLst>
        </pc:spChg>
        <pc:spChg chg="del mod">
          <ac:chgData name="Devkar, Vikas" userId="acbd15ec-55d1-4a76-83ac-3f1d82711ed5" providerId="ADAL" clId="{4D867438-886E-4687-B2D1-7FC85E58D03B}" dt="2024-01-18T06:40:22.351" v="359" actId="478"/>
          <ac:spMkLst>
            <pc:docMk/>
            <pc:sldMk cId="3436963830" sldId="268"/>
            <ac:spMk id="5" creationId="{E53AD560-8EB7-5789-360B-EDCE368FE1F2}"/>
          </ac:spMkLst>
        </pc:spChg>
        <pc:spChg chg="del mod">
          <ac:chgData name="Devkar, Vikas" userId="acbd15ec-55d1-4a76-83ac-3f1d82711ed5" providerId="ADAL" clId="{4D867438-886E-4687-B2D1-7FC85E58D03B}" dt="2024-01-18T06:40:20.511" v="358" actId="478"/>
          <ac:spMkLst>
            <pc:docMk/>
            <pc:sldMk cId="3436963830" sldId="268"/>
            <ac:spMk id="6" creationId="{1B8E7A32-B138-666A-04C8-EE82080DB2FF}"/>
          </ac:spMkLst>
        </pc:spChg>
        <pc:spChg chg="add mod ord">
          <ac:chgData name="Devkar, Vikas" userId="acbd15ec-55d1-4a76-83ac-3f1d82711ed5" providerId="ADAL" clId="{4D867438-886E-4687-B2D1-7FC85E58D03B}" dt="2024-01-24T16:41:55.743" v="499" actId="164"/>
          <ac:spMkLst>
            <pc:docMk/>
            <pc:sldMk cId="3436963830" sldId="268"/>
            <ac:spMk id="6" creationId="{BAD975C2-5195-6554-8FD0-947A298FE51E}"/>
          </ac:spMkLst>
        </pc:spChg>
        <pc:spChg chg="mod">
          <ac:chgData name="Devkar, Vikas" userId="acbd15ec-55d1-4a76-83ac-3f1d82711ed5" providerId="ADAL" clId="{4D867438-886E-4687-B2D1-7FC85E58D03B}" dt="2024-01-24T16:46:19.944" v="522" actId="1076"/>
          <ac:spMkLst>
            <pc:docMk/>
            <pc:sldMk cId="3436963830" sldId="268"/>
            <ac:spMk id="7" creationId="{687D80C2-7157-82E2-4F15-E738AACCD512}"/>
          </ac:spMkLst>
        </pc:spChg>
        <pc:spChg chg="add mod ord">
          <ac:chgData name="Devkar, Vikas" userId="acbd15ec-55d1-4a76-83ac-3f1d82711ed5" providerId="ADAL" clId="{4D867438-886E-4687-B2D1-7FC85E58D03B}" dt="2024-01-24T16:45:11.698" v="521" actId="1076"/>
          <ac:spMkLst>
            <pc:docMk/>
            <pc:sldMk cId="3436963830" sldId="268"/>
            <ac:spMk id="9" creationId="{A445E8BB-8C62-23B5-665E-0E77CE890546}"/>
          </ac:spMkLst>
        </pc:spChg>
        <pc:spChg chg="add mod ord">
          <ac:chgData name="Devkar, Vikas" userId="acbd15ec-55d1-4a76-83ac-3f1d82711ed5" providerId="ADAL" clId="{4D867438-886E-4687-B2D1-7FC85E58D03B}" dt="2024-01-24T16:44:30.222" v="519" actId="1076"/>
          <ac:spMkLst>
            <pc:docMk/>
            <pc:sldMk cId="3436963830" sldId="268"/>
            <ac:spMk id="10" creationId="{A2A2E485-B177-38CE-A4D3-E66D355631FB}"/>
          </ac:spMkLst>
        </pc:spChg>
        <pc:spChg chg="add mod">
          <ac:chgData name="Devkar, Vikas" userId="acbd15ec-55d1-4a76-83ac-3f1d82711ed5" providerId="ADAL" clId="{4D867438-886E-4687-B2D1-7FC85E58D03B}" dt="2024-01-24T16:41:55.743" v="499" actId="164"/>
          <ac:spMkLst>
            <pc:docMk/>
            <pc:sldMk cId="3436963830" sldId="268"/>
            <ac:spMk id="11" creationId="{2E373D25-1465-3B00-6D60-0393E93954B5}"/>
          </ac:spMkLst>
        </pc:spChg>
        <pc:spChg chg="add mod">
          <ac:chgData name="Devkar, Vikas" userId="acbd15ec-55d1-4a76-83ac-3f1d82711ed5" providerId="ADAL" clId="{4D867438-886E-4687-B2D1-7FC85E58D03B}" dt="2024-01-24T16:41:55.743" v="499" actId="164"/>
          <ac:spMkLst>
            <pc:docMk/>
            <pc:sldMk cId="3436963830" sldId="268"/>
            <ac:spMk id="12" creationId="{20CC143D-52B9-5A3A-2FE2-1A36A52483C7}"/>
          </ac:spMkLst>
        </pc:spChg>
        <pc:spChg chg="add mod">
          <ac:chgData name="Devkar, Vikas" userId="acbd15ec-55d1-4a76-83ac-3f1d82711ed5" providerId="ADAL" clId="{4D867438-886E-4687-B2D1-7FC85E58D03B}" dt="2024-01-24T16:41:55.743" v="499" actId="164"/>
          <ac:spMkLst>
            <pc:docMk/>
            <pc:sldMk cId="3436963830" sldId="268"/>
            <ac:spMk id="13" creationId="{9BF13D69-9B0F-AA2D-89C7-FD50694D357B}"/>
          </ac:spMkLst>
        </pc:spChg>
        <pc:spChg chg="add mod">
          <ac:chgData name="Devkar, Vikas" userId="acbd15ec-55d1-4a76-83ac-3f1d82711ed5" providerId="ADAL" clId="{4D867438-886E-4687-B2D1-7FC85E58D03B}" dt="2024-01-24T16:41:50.551" v="498" actId="164"/>
          <ac:spMkLst>
            <pc:docMk/>
            <pc:sldMk cId="3436963830" sldId="268"/>
            <ac:spMk id="15" creationId="{C42B5232-858A-FF08-0929-C04AC307F99E}"/>
          </ac:spMkLst>
        </pc:spChg>
        <pc:spChg chg="add mod">
          <ac:chgData name="Devkar, Vikas" userId="acbd15ec-55d1-4a76-83ac-3f1d82711ed5" providerId="ADAL" clId="{4D867438-886E-4687-B2D1-7FC85E58D03B}" dt="2024-01-24T16:41:55.743" v="499" actId="164"/>
          <ac:spMkLst>
            <pc:docMk/>
            <pc:sldMk cId="3436963830" sldId="268"/>
            <ac:spMk id="17" creationId="{D114B789-559F-75F6-8FC6-CA9299F19C0B}"/>
          </ac:spMkLst>
        </pc:spChg>
        <pc:spChg chg="add mod">
          <ac:chgData name="Devkar, Vikas" userId="acbd15ec-55d1-4a76-83ac-3f1d82711ed5" providerId="ADAL" clId="{4D867438-886E-4687-B2D1-7FC85E58D03B}" dt="2024-01-24T16:41:55.743" v="499" actId="164"/>
          <ac:spMkLst>
            <pc:docMk/>
            <pc:sldMk cId="3436963830" sldId="268"/>
            <ac:spMk id="18" creationId="{960DF679-7213-653B-F493-8B5F28F4D5E8}"/>
          </ac:spMkLst>
        </pc:spChg>
        <pc:spChg chg="add mod">
          <ac:chgData name="Devkar, Vikas" userId="acbd15ec-55d1-4a76-83ac-3f1d82711ed5" providerId="ADAL" clId="{4D867438-886E-4687-B2D1-7FC85E58D03B}" dt="2024-01-24T16:41:55.743" v="499" actId="164"/>
          <ac:spMkLst>
            <pc:docMk/>
            <pc:sldMk cId="3436963830" sldId="268"/>
            <ac:spMk id="19" creationId="{B8E01842-BC3E-B15D-6CCB-C2981BD13501}"/>
          </ac:spMkLst>
        </pc:spChg>
        <pc:spChg chg="add mod">
          <ac:chgData name="Devkar, Vikas" userId="acbd15ec-55d1-4a76-83ac-3f1d82711ed5" providerId="ADAL" clId="{4D867438-886E-4687-B2D1-7FC85E58D03B}" dt="2024-01-24T16:41:50.551" v="498" actId="164"/>
          <ac:spMkLst>
            <pc:docMk/>
            <pc:sldMk cId="3436963830" sldId="268"/>
            <ac:spMk id="20" creationId="{584CA6F3-4056-44C8-4705-A020560CEA68}"/>
          </ac:spMkLst>
        </pc:spChg>
        <pc:spChg chg="add mod">
          <ac:chgData name="Devkar, Vikas" userId="acbd15ec-55d1-4a76-83ac-3f1d82711ed5" providerId="ADAL" clId="{4D867438-886E-4687-B2D1-7FC85E58D03B}" dt="2024-01-24T16:41:50.551" v="498" actId="164"/>
          <ac:spMkLst>
            <pc:docMk/>
            <pc:sldMk cId="3436963830" sldId="268"/>
            <ac:spMk id="21" creationId="{F19AB2DB-42E8-1B34-0B27-FFE25348E6BF}"/>
          </ac:spMkLst>
        </pc:spChg>
        <pc:spChg chg="add mod">
          <ac:chgData name="Devkar, Vikas" userId="acbd15ec-55d1-4a76-83ac-3f1d82711ed5" providerId="ADAL" clId="{4D867438-886E-4687-B2D1-7FC85E58D03B}" dt="2024-01-24T16:41:55.743" v="499" actId="164"/>
          <ac:spMkLst>
            <pc:docMk/>
            <pc:sldMk cId="3436963830" sldId="268"/>
            <ac:spMk id="22" creationId="{4A4ABF86-6944-3665-C48A-F7A09380ECC1}"/>
          </ac:spMkLst>
        </pc:spChg>
        <pc:spChg chg="add mod">
          <ac:chgData name="Devkar, Vikas" userId="acbd15ec-55d1-4a76-83ac-3f1d82711ed5" providerId="ADAL" clId="{4D867438-886E-4687-B2D1-7FC85E58D03B}" dt="2024-01-24T16:41:55.743" v="499" actId="164"/>
          <ac:spMkLst>
            <pc:docMk/>
            <pc:sldMk cId="3436963830" sldId="268"/>
            <ac:spMk id="23" creationId="{FB5CF552-A5E3-4F48-1AD1-D0608C575C78}"/>
          </ac:spMkLst>
        </pc:spChg>
        <pc:spChg chg="add mod">
          <ac:chgData name="Devkar, Vikas" userId="acbd15ec-55d1-4a76-83ac-3f1d82711ed5" providerId="ADAL" clId="{4D867438-886E-4687-B2D1-7FC85E58D03B}" dt="2024-01-24T16:41:50.551" v="498" actId="164"/>
          <ac:spMkLst>
            <pc:docMk/>
            <pc:sldMk cId="3436963830" sldId="268"/>
            <ac:spMk id="24" creationId="{A66CC2DF-12A6-0086-DDB5-997D388CA85E}"/>
          </ac:spMkLst>
        </pc:spChg>
        <pc:spChg chg="add mod">
          <ac:chgData name="Devkar, Vikas" userId="acbd15ec-55d1-4a76-83ac-3f1d82711ed5" providerId="ADAL" clId="{4D867438-886E-4687-B2D1-7FC85E58D03B}" dt="2024-01-24T16:41:50.551" v="498" actId="164"/>
          <ac:spMkLst>
            <pc:docMk/>
            <pc:sldMk cId="3436963830" sldId="268"/>
            <ac:spMk id="25" creationId="{808A03A3-9D71-A24D-AC3D-D7C07236328A}"/>
          </ac:spMkLst>
        </pc:spChg>
        <pc:grpChg chg="add mod">
          <ac:chgData name="Devkar, Vikas" userId="acbd15ec-55d1-4a76-83ac-3f1d82711ed5" providerId="ADAL" clId="{4D867438-886E-4687-B2D1-7FC85E58D03B}" dt="2024-01-24T16:46:27.172" v="523" actId="1076"/>
          <ac:grpSpMkLst>
            <pc:docMk/>
            <pc:sldMk cId="3436963830" sldId="268"/>
            <ac:grpSpMk id="26" creationId="{93FF2E7F-9493-4BB3-2936-2A170B084C33}"/>
          </ac:grpSpMkLst>
        </pc:grpChg>
        <pc:grpChg chg="add mod">
          <ac:chgData name="Devkar, Vikas" userId="acbd15ec-55d1-4a76-83ac-3f1d82711ed5" providerId="ADAL" clId="{4D867438-886E-4687-B2D1-7FC85E58D03B}" dt="2024-01-24T16:42:21.301" v="501" actId="1076"/>
          <ac:grpSpMkLst>
            <pc:docMk/>
            <pc:sldMk cId="3436963830" sldId="268"/>
            <ac:grpSpMk id="27" creationId="{67B25A3F-81F5-AA0C-689D-CB2DEE57F6E2}"/>
          </ac:grpSpMkLst>
        </pc:grpChg>
        <pc:picChg chg="mod">
          <ac:chgData name="Devkar, Vikas" userId="acbd15ec-55d1-4a76-83ac-3f1d82711ed5" providerId="ADAL" clId="{4D867438-886E-4687-B2D1-7FC85E58D03B}" dt="2024-01-24T16:41:50.551" v="498" actId="164"/>
          <ac:picMkLst>
            <pc:docMk/>
            <pc:sldMk cId="3436963830" sldId="268"/>
            <ac:picMk id="8" creationId="{BCE986FA-D422-0FE5-E02A-652B88F0FD66}"/>
          </ac:picMkLst>
        </pc:picChg>
        <pc:picChg chg="del">
          <ac:chgData name="Devkar, Vikas" userId="acbd15ec-55d1-4a76-83ac-3f1d82711ed5" providerId="ADAL" clId="{4D867438-886E-4687-B2D1-7FC85E58D03B}" dt="2024-01-18T06:28:09.422" v="193" actId="478"/>
          <ac:picMkLst>
            <pc:docMk/>
            <pc:sldMk cId="3436963830" sldId="268"/>
            <ac:picMk id="11" creationId="{709B9107-548D-AA9B-AFC9-5D027B5CCBD2}"/>
          </ac:picMkLst>
        </pc:picChg>
        <pc:picChg chg="mod">
          <ac:chgData name="Devkar, Vikas" userId="acbd15ec-55d1-4a76-83ac-3f1d82711ed5" providerId="ADAL" clId="{4D867438-886E-4687-B2D1-7FC85E58D03B}" dt="2024-01-24T16:41:55.743" v="499" actId="164"/>
          <ac:picMkLst>
            <pc:docMk/>
            <pc:sldMk cId="3436963830" sldId="268"/>
            <ac:picMk id="14" creationId="{18E808FE-3EC6-BFF3-1185-6BF7863BC5AF}"/>
          </ac:picMkLst>
        </pc:picChg>
        <pc:picChg chg="mod">
          <ac:chgData name="Devkar, Vikas" userId="acbd15ec-55d1-4a76-83ac-3f1d82711ed5" providerId="ADAL" clId="{4D867438-886E-4687-B2D1-7FC85E58D03B}" dt="2024-01-24T16:41:55.743" v="499" actId="164"/>
          <ac:picMkLst>
            <pc:docMk/>
            <pc:sldMk cId="3436963830" sldId="268"/>
            <ac:picMk id="16" creationId="{114B3300-01A6-F68F-BDC5-E897144152B2}"/>
          </ac:picMkLst>
        </pc:picChg>
        <pc:picChg chg="del">
          <ac:chgData name="Devkar, Vikas" userId="acbd15ec-55d1-4a76-83ac-3f1d82711ed5" providerId="ADAL" clId="{4D867438-886E-4687-B2D1-7FC85E58D03B}" dt="2024-01-18T06:37:56.961" v="222" actId="478"/>
          <ac:picMkLst>
            <pc:docMk/>
            <pc:sldMk cId="3436963830" sldId="268"/>
            <ac:picMk id="18" creationId="{7ADC94D0-BBCE-C4DD-4038-983F90E91F95}"/>
          </ac:picMkLst>
        </pc:picChg>
      </pc:sldChg>
      <pc:sldChg chg="del">
        <pc:chgData name="Devkar, Vikas" userId="acbd15ec-55d1-4a76-83ac-3f1d82711ed5" providerId="ADAL" clId="{4D867438-886E-4687-B2D1-7FC85E58D03B}" dt="2024-01-08T06:46:21.431" v="91" actId="47"/>
        <pc:sldMkLst>
          <pc:docMk/>
          <pc:sldMk cId="547294471" sldId="269"/>
        </pc:sldMkLst>
      </pc:sldChg>
      <pc:sldChg chg="addSp delSp modSp mod">
        <pc:chgData name="Devkar, Vikas" userId="acbd15ec-55d1-4a76-83ac-3f1d82711ed5" providerId="ADAL" clId="{4D867438-886E-4687-B2D1-7FC85E58D03B}" dt="2024-01-24T22:59:20.211" v="663" actId="1076"/>
        <pc:sldMkLst>
          <pc:docMk/>
          <pc:sldMk cId="941570768" sldId="271"/>
        </pc:sldMkLst>
        <pc:spChg chg="add del mod">
          <ac:chgData name="Devkar, Vikas" userId="acbd15ec-55d1-4a76-83ac-3f1d82711ed5" providerId="ADAL" clId="{4D867438-886E-4687-B2D1-7FC85E58D03B}" dt="2024-01-23T23:30:28.750" v="447" actId="478"/>
          <ac:spMkLst>
            <pc:docMk/>
            <pc:sldMk cId="941570768" sldId="271"/>
            <ac:spMk id="3" creationId="{4531F32B-7935-28D2-1CAF-3B3E0842FC3D}"/>
          </ac:spMkLst>
        </pc:spChg>
        <pc:spChg chg="add mod">
          <ac:chgData name="Devkar, Vikas" userId="acbd15ec-55d1-4a76-83ac-3f1d82711ed5" providerId="ADAL" clId="{4D867438-886E-4687-B2D1-7FC85E58D03B}" dt="2024-01-24T00:10:53.663" v="451" actId="1076"/>
          <ac:spMkLst>
            <pc:docMk/>
            <pc:sldMk cId="941570768" sldId="271"/>
            <ac:spMk id="4" creationId="{5A0FD055-1CD5-78DC-416B-E345E2A5A95C}"/>
          </ac:spMkLst>
        </pc:spChg>
        <pc:spChg chg="mod">
          <ac:chgData name="Devkar, Vikas" userId="acbd15ec-55d1-4a76-83ac-3f1d82711ed5" providerId="ADAL" clId="{4D867438-886E-4687-B2D1-7FC85E58D03B}" dt="2024-01-08T06:46:27.489" v="93" actId="20577"/>
          <ac:spMkLst>
            <pc:docMk/>
            <pc:sldMk cId="941570768" sldId="271"/>
            <ac:spMk id="5" creationId="{E880AF6A-641C-F67F-BA37-ED8AA5C0C046}"/>
          </ac:spMkLst>
        </pc:spChg>
        <pc:spChg chg="add mod">
          <ac:chgData name="Devkar, Vikas" userId="acbd15ec-55d1-4a76-83ac-3f1d82711ed5" providerId="ADAL" clId="{4D867438-886E-4687-B2D1-7FC85E58D03B}" dt="2024-01-24T00:10:53.663" v="451" actId="1076"/>
          <ac:spMkLst>
            <pc:docMk/>
            <pc:sldMk cId="941570768" sldId="271"/>
            <ac:spMk id="6" creationId="{118E1097-2EE8-F0C1-0DEE-BC2A133B6773}"/>
          </ac:spMkLst>
        </pc:spChg>
        <pc:spChg chg="del">
          <ac:chgData name="Devkar, Vikas" userId="acbd15ec-55d1-4a76-83ac-3f1d82711ed5" providerId="ADAL" clId="{4D867438-886E-4687-B2D1-7FC85E58D03B}" dt="2024-01-24T16:28:39.470" v="457" actId="478"/>
          <ac:spMkLst>
            <pc:docMk/>
            <pc:sldMk cId="941570768" sldId="271"/>
            <ac:spMk id="12" creationId="{6C21EE5F-2525-C72F-E243-6F1E49878457}"/>
          </ac:spMkLst>
        </pc:spChg>
        <pc:spChg chg="del">
          <ac:chgData name="Devkar, Vikas" userId="acbd15ec-55d1-4a76-83ac-3f1d82711ed5" providerId="ADAL" clId="{4D867438-886E-4687-B2D1-7FC85E58D03B}" dt="2024-01-24T16:28:35.328" v="455" actId="478"/>
          <ac:spMkLst>
            <pc:docMk/>
            <pc:sldMk cId="941570768" sldId="271"/>
            <ac:spMk id="13" creationId="{1151CE02-0023-5416-1CA0-844CE92D51EB}"/>
          </ac:spMkLst>
        </pc:spChg>
        <pc:spChg chg="del mod">
          <ac:chgData name="Devkar, Vikas" userId="acbd15ec-55d1-4a76-83ac-3f1d82711ed5" providerId="ADAL" clId="{4D867438-886E-4687-B2D1-7FC85E58D03B}" dt="2024-01-08T07:49:47.002" v="129" actId="478"/>
          <ac:spMkLst>
            <pc:docMk/>
            <pc:sldMk cId="941570768" sldId="271"/>
            <ac:spMk id="14" creationId="{0B049BDC-8487-8CE9-798E-7F4339EDF1B2}"/>
          </ac:spMkLst>
        </pc:spChg>
        <pc:grpChg chg="mod">
          <ac:chgData name="Devkar, Vikas" userId="acbd15ec-55d1-4a76-83ac-3f1d82711ed5" providerId="ADAL" clId="{4D867438-886E-4687-B2D1-7FC85E58D03B}" dt="2024-01-24T22:59:20.211" v="663" actId="1076"/>
          <ac:grpSpMkLst>
            <pc:docMk/>
            <pc:sldMk cId="941570768" sldId="271"/>
            <ac:grpSpMk id="10" creationId="{8583F6A4-9124-5271-0AAB-B5DA6B0A3B0A}"/>
          </ac:grpSpMkLst>
        </pc:grpChg>
        <pc:picChg chg="add del mod">
          <ac:chgData name="Devkar, Vikas" userId="acbd15ec-55d1-4a76-83ac-3f1d82711ed5" providerId="ADAL" clId="{4D867438-886E-4687-B2D1-7FC85E58D03B}" dt="2024-01-23T23:30:30.506" v="448" actId="21"/>
          <ac:picMkLst>
            <pc:docMk/>
            <pc:sldMk cId="941570768" sldId="271"/>
            <ac:picMk id="2" creationId="{6AB605EF-67DD-0F4D-E86A-8C2457E7F3C4}"/>
          </ac:picMkLst>
        </pc:picChg>
      </pc:sldChg>
      <pc:sldChg chg="del">
        <pc:chgData name="Devkar, Vikas" userId="acbd15ec-55d1-4a76-83ac-3f1d82711ed5" providerId="ADAL" clId="{4D867438-886E-4687-B2D1-7FC85E58D03B}" dt="2024-01-26T23:35:46.163" v="664" actId="47"/>
        <pc:sldMkLst>
          <pc:docMk/>
          <pc:sldMk cId="1828619697" sldId="272"/>
        </pc:sldMkLst>
      </pc:sldChg>
      <pc:sldChg chg="del">
        <pc:chgData name="Devkar, Vikas" userId="acbd15ec-55d1-4a76-83ac-3f1d82711ed5" providerId="ADAL" clId="{4D867438-886E-4687-B2D1-7FC85E58D03B}" dt="2024-01-08T06:26:19.064" v="39" actId="47"/>
        <pc:sldMkLst>
          <pc:docMk/>
          <pc:sldMk cId="1812129503" sldId="274"/>
        </pc:sldMkLst>
      </pc:sldChg>
    </pc:docChg>
  </pc:docChgLst>
  <pc:docChgLst>
    <pc:chgData name="Devkar, Vikas" userId="acbd15ec-55d1-4a76-83ac-3f1d82711ed5" providerId="ADAL" clId="{0F0500CC-7EE5-4B6D-A233-78C10B0575F1}"/>
    <pc:docChg chg="undo custSel addSld delSld modSld sldOrd">
      <pc:chgData name="Devkar, Vikas" userId="acbd15ec-55d1-4a76-83ac-3f1d82711ed5" providerId="ADAL" clId="{0F0500CC-7EE5-4B6D-A233-78C10B0575F1}" dt="2023-11-22T18:50:51.486" v="3819" actId="1076"/>
      <pc:docMkLst>
        <pc:docMk/>
      </pc:docMkLst>
      <pc:sldChg chg="addSp modSp add del mod">
        <pc:chgData name="Devkar, Vikas" userId="acbd15ec-55d1-4a76-83ac-3f1d82711ed5" providerId="ADAL" clId="{0F0500CC-7EE5-4B6D-A233-78C10B0575F1}" dt="2023-11-13T19:15:06.642" v="2669" actId="1076"/>
        <pc:sldMkLst>
          <pc:docMk/>
          <pc:sldMk cId="1604500440" sldId="256"/>
        </pc:sldMkLst>
        <pc:spChg chg="add mod">
          <ac:chgData name="Devkar, Vikas" userId="acbd15ec-55d1-4a76-83ac-3f1d82711ed5" providerId="ADAL" clId="{0F0500CC-7EE5-4B6D-A233-78C10B0575F1}" dt="2023-11-13T19:14:18.066" v="2663" actId="164"/>
          <ac:spMkLst>
            <pc:docMk/>
            <pc:sldMk cId="1604500440" sldId="256"/>
            <ac:spMk id="3" creationId="{2896C643-36B3-C720-1176-338AA62D6ED9}"/>
          </ac:spMkLst>
        </pc:spChg>
        <pc:spChg chg="mod">
          <ac:chgData name="Devkar, Vikas" userId="acbd15ec-55d1-4a76-83ac-3f1d82711ed5" providerId="ADAL" clId="{0F0500CC-7EE5-4B6D-A233-78C10B0575F1}" dt="2023-11-13T19:14:54.336" v="2667" actId="1076"/>
          <ac:spMkLst>
            <pc:docMk/>
            <pc:sldMk cId="1604500440" sldId="256"/>
            <ac:spMk id="5" creationId="{267B5775-2EA1-057F-29AE-A0A20F28F365}"/>
          </ac:spMkLst>
        </pc:spChg>
        <pc:spChg chg="mod">
          <ac:chgData name="Devkar, Vikas" userId="acbd15ec-55d1-4a76-83ac-3f1d82711ed5" providerId="ADAL" clId="{0F0500CC-7EE5-4B6D-A233-78C10B0575F1}" dt="2023-11-13T19:14:05.812" v="2661" actId="1076"/>
          <ac:spMkLst>
            <pc:docMk/>
            <pc:sldMk cId="1604500440" sldId="256"/>
            <ac:spMk id="6" creationId="{25C1E047-61A8-283D-842B-8E4DB3196396}"/>
          </ac:spMkLst>
        </pc:spChg>
        <pc:spChg chg="mod">
          <ac:chgData name="Devkar, Vikas" userId="acbd15ec-55d1-4a76-83ac-3f1d82711ed5" providerId="ADAL" clId="{0F0500CC-7EE5-4B6D-A233-78C10B0575F1}" dt="2023-11-13T19:14:42.689" v="2666" actId="1076"/>
          <ac:spMkLst>
            <pc:docMk/>
            <pc:sldMk cId="1604500440" sldId="256"/>
            <ac:spMk id="7" creationId="{A1F18A16-F4AD-BA15-75E0-DBBCAFFB2CCA}"/>
          </ac:spMkLst>
        </pc:spChg>
        <pc:spChg chg="mod">
          <ac:chgData name="Devkar, Vikas" userId="acbd15ec-55d1-4a76-83ac-3f1d82711ed5" providerId="ADAL" clId="{0F0500CC-7EE5-4B6D-A233-78C10B0575F1}" dt="2023-11-13T19:15:06.642" v="2669" actId="1076"/>
          <ac:spMkLst>
            <pc:docMk/>
            <pc:sldMk cId="1604500440" sldId="256"/>
            <ac:spMk id="8" creationId="{D33B83D1-2A7F-FB0B-3DB9-81D3A13B291E}"/>
          </ac:spMkLst>
        </pc:spChg>
        <pc:grpChg chg="add mod">
          <ac:chgData name="Devkar, Vikas" userId="acbd15ec-55d1-4a76-83ac-3f1d82711ed5" providerId="ADAL" clId="{0F0500CC-7EE5-4B6D-A233-78C10B0575F1}" dt="2023-11-13T19:14:21.702" v="2664" actId="1076"/>
          <ac:grpSpMkLst>
            <pc:docMk/>
            <pc:sldMk cId="1604500440" sldId="256"/>
            <ac:grpSpMk id="9" creationId="{D038214F-DF9B-FA33-99CE-D55383CF5013}"/>
          </ac:grpSpMkLst>
        </pc:grpChg>
        <pc:graphicFrameChg chg="add mod">
          <ac:chgData name="Devkar, Vikas" userId="acbd15ec-55d1-4a76-83ac-3f1d82711ed5" providerId="ADAL" clId="{0F0500CC-7EE5-4B6D-A233-78C10B0575F1}" dt="2023-11-13T19:14:18.066" v="2663" actId="164"/>
          <ac:graphicFrameMkLst>
            <pc:docMk/>
            <pc:sldMk cId="1604500440" sldId="256"/>
            <ac:graphicFrameMk id="2" creationId="{779EADC1-3B5D-EFD1-F42B-A656E1ECCFE5}"/>
          </ac:graphicFrameMkLst>
        </pc:graphicFrameChg>
        <pc:picChg chg="mod">
          <ac:chgData name="Devkar, Vikas" userId="acbd15ec-55d1-4a76-83ac-3f1d82711ed5" providerId="ADAL" clId="{0F0500CC-7EE5-4B6D-A233-78C10B0575F1}" dt="2023-10-23T22:01:02.259" v="1222" actId="14100"/>
          <ac:picMkLst>
            <pc:docMk/>
            <pc:sldMk cId="1604500440" sldId="256"/>
            <ac:picMk id="4" creationId="{8650781B-AC10-2E14-7193-96FAEFC0AEE0}"/>
          </ac:picMkLst>
        </pc:picChg>
      </pc:sldChg>
      <pc:sldChg chg="addSp delSp modSp add del mod">
        <pc:chgData name="Devkar, Vikas" userId="acbd15ec-55d1-4a76-83ac-3f1d82711ed5" providerId="ADAL" clId="{0F0500CC-7EE5-4B6D-A233-78C10B0575F1}" dt="2023-11-13T19:53:38.216" v="2755" actId="404"/>
        <pc:sldMkLst>
          <pc:docMk/>
          <pc:sldMk cId="2353496295" sldId="257"/>
        </pc:sldMkLst>
        <pc:spChg chg="add mod">
          <ac:chgData name="Devkar, Vikas" userId="acbd15ec-55d1-4a76-83ac-3f1d82711ed5" providerId="ADAL" clId="{0F0500CC-7EE5-4B6D-A233-78C10B0575F1}" dt="2023-11-13T19:15:29.640" v="2672" actId="1076"/>
          <ac:spMkLst>
            <pc:docMk/>
            <pc:sldMk cId="2353496295" sldId="257"/>
            <ac:spMk id="2" creationId="{D6AA2FB8-1CA5-F197-0DE2-487B4877882F}"/>
          </ac:spMkLst>
        </pc:spChg>
        <pc:spChg chg="del mod">
          <ac:chgData name="Devkar, Vikas" userId="acbd15ec-55d1-4a76-83ac-3f1d82711ed5" providerId="ADAL" clId="{0F0500CC-7EE5-4B6D-A233-78C10B0575F1}" dt="2023-10-12T21:13:10.069" v="176" actId="478"/>
          <ac:spMkLst>
            <pc:docMk/>
            <pc:sldMk cId="2353496295" sldId="257"/>
            <ac:spMk id="3" creationId="{ABF8712E-97DE-29CA-BB48-754C302D7322}"/>
          </ac:spMkLst>
        </pc:spChg>
        <pc:spChg chg="add mod">
          <ac:chgData name="Devkar, Vikas" userId="acbd15ec-55d1-4a76-83ac-3f1d82711ed5" providerId="ADAL" clId="{0F0500CC-7EE5-4B6D-A233-78C10B0575F1}" dt="2023-11-13T19:15:39.126" v="2673" actId="1076"/>
          <ac:spMkLst>
            <pc:docMk/>
            <pc:sldMk cId="2353496295" sldId="257"/>
            <ac:spMk id="12" creationId="{EE11CAC0-AEDE-94C8-41CC-3FE479E6E222}"/>
          </ac:spMkLst>
        </pc:spChg>
        <pc:spChg chg="add mod">
          <ac:chgData name="Devkar, Vikas" userId="acbd15ec-55d1-4a76-83ac-3f1d82711ed5" providerId="ADAL" clId="{0F0500CC-7EE5-4B6D-A233-78C10B0575F1}" dt="2023-11-13T19:53:38.216" v="2755" actId="404"/>
          <ac:spMkLst>
            <pc:docMk/>
            <pc:sldMk cId="2353496295" sldId="257"/>
            <ac:spMk id="13" creationId="{1E8A8E73-D593-34F9-B40C-79F2F7DDC6DE}"/>
          </ac:spMkLst>
        </pc:spChg>
        <pc:picChg chg="del mod">
          <ac:chgData name="Devkar, Vikas" userId="acbd15ec-55d1-4a76-83ac-3f1d82711ed5" providerId="ADAL" clId="{0F0500CC-7EE5-4B6D-A233-78C10B0575F1}" dt="2023-10-09T21:35:22.524" v="13" actId="478"/>
          <ac:picMkLst>
            <pc:docMk/>
            <pc:sldMk cId="2353496295" sldId="257"/>
            <ac:picMk id="2" creationId="{DEE854A1-0563-9309-ED10-743F7D57F25A}"/>
          </ac:picMkLst>
        </pc:picChg>
        <pc:picChg chg="mod">
          <ac:chgData name="Devkar, Vikas" userId="acbd15ec-55d1-4a76-83ac-3f1d82711ed5" providerId="ADAL" clId="{0F0500CC-7EE5-4B6D-A233-78C10B0575F1}" dt="2023-10-10T14:46:28.721" v="120" actId="1076"/>
          <ac:picMkLst>
            <pc:docMk/>
            <pc:sldMk cId="2353496295" sldId="257"/>
            <ac:picMk id="4" creationId="{33EA40E7-3DC9-F6DF-3063-78739A2ED3A9}"/>
          </ac:picMkLst>
        </pc:picChg>
        <pc:picChg chg="mod">
          <ac:chgData name="Devkar, Vikas" userId="acbd15ec-55d1-4a76-83ac-3f1d82711ed5" providerId="ADAL" clId="{0F0500CC-7EE5-4B6D-A233-78C10B0575F1}" dt="2023-10-18T20:32:09.624" v="356" actId="1076"/>
          <ac:picMkLst>
            <pc:docMk/>
            <pc:sldMk cId="2353496295" sldId="257"/>
            <ac:picMk id="5" creationId="{BC4B593B-F9F9-3162-DCA4-E49944D47FA7}"/>
          </ac:picMkLst>
        </pc:picChg>
        <pc:picChg chg="mod">
          <ac:chgData name="Devkar, Vikas" userId="acbd15ec-55d1-4a76-83ac-3f1d82711ed5" providerId="ADAL" clId="{0F0500CC-7EE5-4B6D-A233-78C10B0575F1}" dt="2023-10-10T14:46:28.721" v="120" actId="1076"/>
          <ac:picMkLst>
            <pc:docMk/>
            <pc:sldMk cId="2353496295" sldId="257"/>
            <ac:picMk id="6" creationId="{ACEADD36-435A-706A-0AE9-EBEEFE9AF23F}"/>
          </ac:picMkLst>
        </pc:picChg>
        <pc:picChg chg="mod">
          <ac:chgData name="Devkar, Vikas" userId="acbd15ec-55d1-4a76-83ac-3f1d82711ed5" providerId="ADAL" clId="{0F0500CC-7EE5-4B6D-A233-78C10B0575F1}" dt="2023-10-10T14:46:28.721" v="120" actId="1076"/>
          <ac:picMkLst>
            <pc:docMk/>
            <pc:sldMk cId="2353496295" sldId="257"/>
            <ac:picMk id="7" creationId="{E389C274-F48A-AD44-02D3-D878D9D08361}"/>
          </ac:picMkLst>
        </pc:picChg>
        <pc:picChg chg="mod">
          <ac:chgData name="Devkar, Vikas" userId="acbd15ec-55d1-4a76-83ac-3f1d82711ed5" providerId="ADAL" clId="{0F0500CC-7EE5-4B6D-A233-78C10B0575F1}" dt="2023-10-10T14:44:11.747" v="108" actId="1076"/>
          <ac:picMkLst>
            <pc:docMk/>
            <pc:sldMk cId="2353496295" sldId="257"/>
            <ac:picMk id="8" creationId="{42BD8504-A15A-0C1F-A71B-97100C7768C1}"/>
          </ac:picMkLst>
        </pc:picChg>
        <pc:picChg chg="mod">
          <ac:chgData name="Devkar, Vikas" userId="acbd15ec-55d1-4a76-83ac-3f1d82711ed5" providerId="ADAL" clId="{0F0500CC-7EE5-4B6D-A233-78C10B0575F1}" dt="2023-11-13T19:15:46.948" v="2675" actId="1076"/>
          <ac:picMkLst>
            <pc:docMk/>
            <pc:sldMk cId="2353496295" sldId="257"/>
            <ac:picMk id="9" creationId="{1B540D38-7D7A-2DBE-4294-66636BAA9EFB}"/>
          </ac:picMkLst>
        </pc:picChg>
        <pc:picChg chg="mod">
          <ac:chgData name="Devkar, Vikas" userId="acbd15ec-55d1-4a76-83ac-3f1d82711ed5" providerId="ADAL" clId="{0F0500CC-7EE5-4B6D-A233-78C10B0575F1}" dt="2023-11-13T19:15:46.948" v="2675" actId="1076"/>
          <ac:picMkLst>
            <pc:docMk/>
            <pc:sldMk cId="2353496295" sldId="257"/>
            <ac:picMk id="10" creationId="{4A96A991-9253-EBE7-A0C6-5E298683CF46}"/>
          </ac:picMkLst>
        </pc:picChg>
        <pc:picChg chg="mod">
          <ac:chgData name="Devkar, Vikas" userId="acbd15ec-55d1-4a76-83ac-3f1d82711ed5" providerId="ADAL" clId="{0F0500CC-7EE5-4B6D-A233-78C10B0575F1}" dt="2023-10-10T14:44:11.747" v="108" actId="1076"/>
          <ac:picMkLst>
            <pc:docMk/>
            <pc:sldMk cId="2353496295" sldId="257"/>
            <ac:picMk id="11" creationId="{5AE816F1-0434-E091-206B-91B592A351E4}"/>
          </ac:picMkLst>
        </pc:picChg>
        <pc:picChg chg="add del mod">
          <ac:chgData name="Devkar, Vikas" userId="acbd15ec-55d1-4a76-83ac-3f1d82711ed5" providerId="ADAL" clId="{0F0500CC-7EE5-4B6D-A233-78C10B0575F1}" dt="2023-10-09T21:41:50.474" v="86" actId="478"/>
          <ac:picMkLst>
            <pc:docMk/>
            <pc:sldMk cId="2353496295" sldId="257"/>
            <ac:picMk id="12" creationId="{A960CDFD-AA0E-7C7E-D095-17ECDA7D2FE3}"/>
          </ac:picMkLst>
        </pc:picChg>
      </pc:sldChg>
      <pc:sldChg chg="addSp delSp modSp new add del mod">
        <pc:chgData name="Devkar, Vikas" userId="acbd15ec-55d1-4a76-83ac-3f1d82711ed5" providerId="ADAL" clId="{0F0500CC-7EE5-4B6D-A233-78C10B0575F1}" dt="2023-11-13T19:19:08.764" v="2684" actId="20577"/>
        <pc:sldMkLst>
          <pc:docMk/>
          <pc:sldMk cId="2859274678" sldId="258"/>
        </pc:sldMkLst>
        <pc:spChg chg="del">
          <ac:chgData name="Devkar, Vikas" userId="acbd15ec-55d1-4a76-83ac-3f1d82711ed5" providerId="ADAL" clId="{0F0500CC-7EE5-4B6D-A233-78C10B0575F1}" dt="2023-10-18T20:32:52.396" v="358" actId="478"/>
          <ac:spMkLst>
            <pc:docMk/>
            <pc:sldMk cId="2859274678" sldId="258"/>
            <ac:spMk id="2" creationId="{ED5DC63B-9F72-1AB6-3C41-27FAE167074C}"/>
          </ac:spMkLst>
        </pc:spChg>
        <pc:spChg chg="del">
          <ac:chgData name="Devkar, Vikas" userId="acbd15ec-55d1-4a76-83ac-3f1d82711ed5" providerId="ADAL" clId="{0F0500CC-7EE5-4B6D-A233-78C10B0575F1}" dt="2023-10-18T20:32:52.396" v="358" actId="478"/>
          <ac:spMkLst>
            <pc:docMk/>
            <pc:sldMk cId="2859274678" sldId="258"/>
            <ac:spMk id="3" creationId="{075C6903-4A94-AB0A-1B61-B771AAC5BF79}"/>
          </ac:spMkLst>
        </pc:spChg>
        <pc:spChg chg="add mod">
          <ac:chgData name="Devkar, Vikas" userId="acbd15ec-55d1-4a76-83ac-3f1d82711ed5" providerId="ADAL" clId="{0F0500CC-7EE5-4B6D-A233-78C10B0575F1}" dt="2023-11-13T19:19:08.764" v="2684" actId="20577"/>
          <ac:spMkLst>
            <pc:docMk/>
            <pc:sldMk cId="2859274678" sldId="258"/>
            <ac:spMk id="4" creationId="{31204856-4A32-5BC2-60E8-64EA68B44AD9}"/>
          </ac:spMkLst>
        </pc:spChg>
        <pc:spChg chg="add del mod">
          <ac:chgData name="Devkar, Vikas" userId="acbd15ec-55d1-4a76-83ac-3f1d82711ed5" providerId="ADAL" clId="{0F0500CC-7EE5-4B6D-A233-78C10B0575F1}" dt="2023-10-18T22:50:52.922" v="818" actId="21"/>
          <ac:spMkLst>
            <pc:docMk/>
            <pc:sldMk cId="2859274678" sldId="258"/>
            <ac:spMk id="7" creationId="{89977507-7705-7C58-A0F7-0C5CAD78A355}"/>
          </ac:spMkLst>
        </pc:spChg>
        <pc:spChg chg="add del mod">
          <ac:chgData name="Devkar, Vikas" userId="acbd15ec-55d1-4a76-83ac-3f1d82711ed5" providerId="ADAL" clId="{0F0500CC-7EE5-4B6D-A233-78C10B0575F1}" dt="2023-10-18T22:50:52.922" v="818" actId="21"/>
          <ac:spMkLst>
            <pc:docMk/>
            <pc:sldMk cId="2859274678" sldId="258"/>
            <ac:spMk id="8" creationId="{6FBA1BBD-AE65-0EA8-C3D4-86FCE142A801}"/>
          </ac:spMkLst>
        </pc:spChg>
        <pc:spChg chg="add del mod">
          <ac:chgData name="Devkar, Vikas" userId="acbd15ec-55d1-4a76-83ac-3f1d82711ed5" providerId="ADAL" clId="{0F0500CC-7EE5-4B6D-A233-78C10B0575F1}" dt="2023-10-18T23:09:49.878" v="822" actId="478"/>
          <ac:spMkLst>
            <pc:docMk/>
            <pc:sldMk cId="2859274678" sldId="258"/>
            <ac:spMk id="10" creationId="{8676B2AA-EC11-C13E-C165-92145FAD89E2}"/>
          </ac:spMkLst>
        </pc:spChg>
        <pc:picChg chg="add del mod">
          <ac:chgData name="Devkar, Vikas" userId="acbd15ec-55d1-4a76-83ac-3f1d82711ed5" providerId="ADAL" clId="{0F0500CC-7EE5-4B6D-A233-78C10B0575F1}" dt="2023-10-18T22:50:52.922" v="818" actId="21"/>
          <ac:picMkLst>
            <pc:docMk/>
            <pc:sldMk cId="2859274678" sldId="258"/>
            <ac:picMk id="5" creationId="{C475FA9A-E961-6FFD-ECA7-91D385E9277A}"/>
          </ac:picMkLst>
        </pc:picChg>
        <pc:picChg chg="add del mod">
          <ac:chgData name="Devkar, Vikas" userId="acbd15ec-55d1-4a76-83ac-3f1d82711ed5" providerId="ADAL" clId="{0F0500CC-7EE5-4B6D-A233-78C10B0575F1}" dt="2023-10-18T22:50:52.922" v="818" actId="21"/>
          <ac:picMkLst>
            <pc:docMk/>
            <pc:sldMk cId="2859274678" sldId="258"/>
            <ac:picMk id="6" creationId="{955D560F-A49D-6045-A39E-1DA12B5CE158}"/>
          </ac:picMkLst>
        </pc:picChg>
      </pc:sldChg>
      <pc:sldChg chg="addSp delSp modSp new add del mod ord">
        <pc:chgData name="Devkar, Vikas" userId="acbd15ec-55d1-4a76-83ac-3f1d82711ed5" providerId="ADAL" clId="{0F0500CC-7EE5-4B6D-A233-78C10B0575F1}" dt="2023-11-15T18:12:53.790" v="3255" actId="20577"/>
        <pc:sldMkLst>
          <pc:docMk/>
          <pc:sldMk cId="2724004559" sldId="259"/>
        </pc:sldMkLst>
        <pc:spChg chg="del">
          <ac:chgData name="Devkar, Vikas" userId="acbd15ec-55d1-4a76-83ac-3f1d82711ed5" providerId="ADAL" clId="{0F0500CC-7EE5-4B6D-A233-78C10B0575F1}" dt="2023-10-18T21:47:08.719" v="621" actId="478"/>
          <ac:spMkLst>
            <pc:docMk/>
            <pc:sldMk cId="2724004559" sldId="259"/>
            <ac:spMk id="2" creationId="{1CD2CFA7-FFA0-FBCC-7FA6-4D05B2F81DA8}"/>
          </ac:spMkLst>
        </pc:spChg>
        <pc:spChg chg="del">
          <ac:chgData name="Devkar, Vikas" userId="acbd15ec-55d1-4a76-83ac-3f1d82711ed5" providerId="ADAL" clId="{0F0500CC-7EE5-4B6D-A233-78C10B0575F1}" dt="2023-10-18T21:47:08.719" v="621" actId="478"/>
          <ac:spMkLst>
            <pc:docMk/>
            <pc:sldMk cId="2724004559" sldId="259"/>
            <ac:spMk id="3" creationId="{46FA8576-5EC5-A32C-B7AF-44411DE40467}"/>
          </ac:spMkLst>
        </pc:spChg>
        <pc:spChg chg="add mod">
          <ac:chgData name="Devkar, Vikas" userId="acbd15ec-55d1-4a76-83ac-3f1d82711ed5" providerId="ADAL" clId="{0F0500CC-7EE5-4B6D-A233-78C10B0575F1}" dt="2023-11-13T21:26:54.855" v="2756" actId="1076"/>
          <ac:spMkLst>
            <pc:docMk/>
            <pc:sldMk cId="2724004559" sldId="259"/>
            <ac:spMk id="4" creationId="{8FA8C808-FF3D-E3C4-6235-1E86F7929509}"/>
          </ac:spMkLst>
        </pc:spChg>
        <pc:spChg chg="add mod">
          <ac:chgData name="Devkar, Vikas" userId="acbd15ec-55d1-4a76-83ac-3f1d82711ed5" providerId="ADAL" clId="{0F0500CC-7EE5-4B6D-A233-78C10B0575F1}" dt="2023-11-15T18:12:53.790" v="3255" actId="20577"/>
          <ac:spMkLst>
            <pc:docMk/>
            <pc:sldMk cId="2724004559" sldId="259"/>
            <ac:spMk id="5" creationId="{D31E9A7E-14EA-8184-03C5-36B66190F713}"/>
          </ac:spMkLst>
        </pc:spChg>
        <pc:spChg chg="mod">
          <ac:chgData name="Devkar, Vikas" userId="acbd15ec-55d1-4a76-83ac-3f1d82711ed5" providerId="ADAL" clId="{0F0500CC-7EE5-4B6D-A233-78C10B0575F1}" dt="2023-11-13T17:46:02.566" v="2126" actId="403"/>
          <ac:spMkLst>
            <pc:docMk/>
            <pc:sldMk cId="2724004559" sldId="259"/>
            <ac:spMk id="7" creationId="{848AD072-63FC-D8DE-4A7E-B2495F8F6D49}"/>
          </ac:spMkLst>
        </pc:spChg>
        <pc:spChg chg="mod">
          <ac:chgData name="Devkar, Vikas" userId="acbd15ec-55d1-4a76-83ac-3f1d82711ed5" providerId="ADAL" clId="{0F0500CC-7EE5-4B6D-A233-78C10B0575F1}" dt="2023-11-13T17:46:02.566" v="2126" actId="403"/>
          <ac:spMkLst>
            <pc:docMk/>
            <pc:sldMk cId="2724004559" sldId="259"/>
            <ac:spMk id="8" creationId="{7F840A59-4565-FE7A-ED5C-A1DD816CAA57}"/>
          </ac:spMkLst>
        </pc:spChg>
        <pc:spChg chg="mod">
          <ac:chgData name="Devkar, Vikas" userId="acbd15ec-55d1-4a76-83ac-3f1d82711ed5" providerId="ADAL" clId="{0F0500CC-7EE5-4B6D-A233-78C10B0575F1}" dt="2023-11-13T17:46:02.566" v="2126" actId="403"/>
          <ac:spMkLst>
            <pc:docMk/>
            <pc:sldMk cId="2724004559" sldId="259"/>
            <ac:spMk id="9" creationId="{B98BEAF7-F25A-480C-5E3C-D936E24B45C8}"/>
          </ac:spMkLst>
        </pc:spChg>
        <pc:spChg chg="mod">
          <ac:chgData name="Devkar, Vikas" userId="acbd15ec-55d1-4a76-83ac-3f1d82711ed5" providerId="ADAL" clId="{0F0500CC-7EE5-4B6D-A233-78C10B0575F1}" dt="2023-11-13T17:46:02.566" v="2126" actId="403"/>
          <ac:spMkLst>
            <pc:docMk/>
            <pc:sldMk cId="2724004559" sldId="259"/>
            <ac:spMk id="10" creationId="{4EED17EA-9417-3B49-8046-8845C7D45836}"/>
          </ac:spMkLst>
        </pc:spChg>
        <pc:spChg chg="mod">
          <ac:chgData name="Devkar, Vikas" userId="acbd15ec-55d1-4a76-83ac-3f1d82711ed5" providerId="ADAL" clId="{0F0500CC-7EE5-4B6D-A233-78C10B0575F1}" dt="2023-11-13T17:46:02.566" v="2126" actId="403"/>
          <ac:spMkLst>
            <pc:docMk/>
            <pc:sldMk cId="2724004559" sldId="259"/>
            <ac:spMk id="11" creationId="{19C9D168-5BC2-991D-2F35-28B76D0E4D19}"/>
          </ac:spMkLst>
        </pc:spChg>
        <pc:spChg chg="mod">
          <ac:chgData name="Devkar, Vikas" userId="acbd15ec-55d1-4a76-83ac-3f1d82711ed5" providerId="ADAL" clId="{0F0500CC-7EE5-4B6D-A233-78C10B0575F1}" dt="2023-11-13T17:46:02.566" v="2126" actId="403"/>
          <ac:spMkLst>
            <pc:docMk/>
            <pc:sldMk cId="2724004559" sldId="259"/>
            <ac:spMk id="12" creationId="{9D3FA9FA-3B6A-CEAF-29AD-6B5647BED3A7}"/>
          </ac:spMkLst>
        </pc:spChg>
        <pc:spChg chg="mod">
          <ac:chgData name="Devkar, Vikas" userId="acbd15ec-55d1-4a76-83ac-3f1d82711ed5" providerId="ADAL" clId="{0F0500CC-7EE5-4B6D-A233-78C10B0575F1}" dt="2023-11-13T17:46:02.566" v="2126" actId="403"/>
          <ac:spMkLst>
            <pc:docMk/>
            <pc:sldMk cId="2724004559" sldId="259"/>
            <ac:spMk id="13" creationId="{1E598AD4-31F4-2CB2-AC19-1C034B21D38F}"/>
          </ac:spMkLst>
        </pc:spChg>
        <pc:spChg chg="mod">
          <ac:chgData name="Devkar, Vikas" userId="acbd15ec-55d1-4a76-83ac-3f1d82711ed5" providerId="ADAL" clId="{0F0500CC-7EE5-4B6D-A233-78C10B0575F1}" dt="2023-11-13T17:46:02.566" v="2126" actId="403"/>
          <ac:spMkLst>
            <pc:docMk/>
            <pc:sldMk cId="2724004559" sldId="259"/>
            <ac:spMk id="14" creationId="{CAC88D51-27E2-90E7-A50E-F4D9BAC5E435}"/>
          </ac:spMkLst>
        </pc:spChg>
        <pc:spChg chg="mod">
          <ac:chgData name="Devkar, Vikas" userId="acbd15ec-55d1-4a76-83ac-3f1d82711ed5" providerId="ADAL" clId="{0F0500CC-7EE5-4B6D-A233-78C10B0575F1}" dt="2023-11-13T17:46:02.566" v="2126" actId="403"/>
          <ac:spMkLst>
            <pc:docMk/>
            <pc:sldMk cId="2724004559" sldId="259"/>
            <ac:spMk id="15" creationId="{A975162E-7705-D022-C22B-AC877C92CFAD}"/>
          </ac:spMkLst>
        </pc:spChg>
        <pc:spChg chg="mod">
          <ac:chgData name="Devkar, Vikas" userId="acbd15ec-55d1-4a76-83ac-3f1d82711ed5" providerId="ADAL" clId="{0F0500CC-7EE5-4B6D-A233-78C10B0575F1}" dt="2023-11-13T17:46:02.566" v="2126" actId="403"/>
          <ac:spMkLst>
            <pc:docMk/>
            <pc:sldMk cId="2724004559" sldId="259"/>
            <ac:spMk id="16" creationId="{AFAC6677-D14B-7C9D-B188-E44475440949}"/>
          </ac:spMkLst>
        </pc:spChg>
        <pc:spChg chg="mod">
          <ac:chgData name="Devkar, Vikas" userId="acbd15ec-55d1-4a76-83ac-3f1d82711ed5" providerId="ADAL" clId="{0F0500CC-7EE5-4B6D-A233-78C10B0575F1}" dt="2023-11-13T17:46:02.566" v="2126" actId="403"/>
          <ac:spMkLst>
            <pc:docMk/>
            <pc:sldMk cId="2724004559" sldId="259"/>
            <ac:spMk id="17" creationId="{0B400D66-6538-4F9E-707D-D3C2EF29E2E8}"/>
          </ac:spMkLst>
        </pc:spChg>
        <pc:spChg chg="mod">
          <ac:chgData name="Devkar, Vikas" userId="acbd15ec-55d1-4a76-83ac-3f1d82711ed5" providerId="ADAL" clId="{0F0500CC-7EE5-4B6D-A233-78C10B0575F1}" dt="2023-11-13T17:46:02.566" v="2126" actId="403"/>
          <ac:spMkLst>
            <pc:docMk/>
            <pc:sldMk cId="2724004559" sldId="259"/>
            <ac:spMk id="18" creationId="{1CBC5F0A-FF99-1522-0EAE-AB59F00B14A5}"/>
          </ac:spMkLst>
        </pc:spChg>
        <pc:spChg chg="add mod">
          <ac:chgData name="Devkar, Vikas" userId="acbd15ec-55d1-4a76-83ac-3f1d82711ed5" providerId="ADAL" clId="{0F0500CC-7EE5-4B6D-A233-78C10B0575F1}" dt="2023-11-13T21:27:00.325" v="2759" actId="20577"/>
          <ac:spMkLst>
            <pc:docMk/>
            <pc:sldMk cId="2724004559" sldId="259"/>
            <ac:spMk id="19" creationId="{6FEB86DD-9FF0-258D-57D5-64FC180AF48D}"/>
          </ac:spMkLst>
        </pc:spChg>
        <pc:spChg chg="add mod">
          <ac:chgData name="Devkar, Vikas" userId="acbd15ec-55d1-4a76-83ac-3f1d82711ed5" providerId="ADAL" clId="{0F0500CC-7EE5-4B6D-A233-78C10B0575F1}" dt="2023-11-13T21:27:39.140" v="2825" actId="1076"/>
          <ac:spMkLst>
            <pc:docMk/>
            <pc:sldMk cId="2724004559" sldId="259"/>
            <ac:spMk id="20" creationId="{8BB87B4F-885A-6B18-CF87-42039E4F74CB}"/>
          </ac:spMkLst>
        </pc:spChg>
        <pc:spChg chg="add mod">
          <ac:chgData name="Devkar, Vikas" userId="acbd15ec-55d1-4a76-83ac-3f1d82711ed5" providerId="ADAL" clId="{0F0500CC-7EE5-4B6D-A233-78C10B0575F1}" dt="2023-11-13T21:27:41.976" v="2826" actId="1076"/>
          <ac:spMkLst>
            <pc:docMk/>
            <pc:sldMk cId="2724004559" sldId="259"/>
            <ac:spMk id="21" creationId="{ADBDD286-2ECC-1307-A563-B92F0D5310B5}"/>
          </ac:spMkLst>
        </pc:spChg>
        <pc:grpChg chg="add del mod">
          <ac:chgData name="Devkar, Vikas" userId="acbd15ec-55d1-4a76-83ac-3f1d82711ed5" providerId="ADAL" clId="{0F0500CC-7EE5-4B6D-A233-78C10B0575F1}" dt="2023-11-13T19:18:38.948" v="2680" actId="478"/>
          <ac:grpSpMkLst>
            <pc:docMk/>
            <pc:sldMk cId="2724004559" sldId="259"/>
            <ac:grpSpMk id="6" creationId="{410C6F77-3C37-A6B0-08E9-2E580EB391CD}"/>
          </ac:grpSpMkLst>
        </pc:grpChg>
        <pc:picChg chg="add del mod">
          <ac:chgData name="Devkar, Vikas" userId="acbd15ec-55d1-4a76-83ac-3f1d82711ed5" providerId="ADAL" clId="{0F0500CC-7EE5-4B6D-A233-78C10B0575F1}" dt="2023-11-13T19:03:31.731" v="2560" actId="478"/>
          <ac:picMkLst>
            <pc:docMk/>
            <pc:sldMk cId="2724004559" sldId="259"/>
            <ac:picMk id="3" creationId="{393E8CFF-B6AA-0C0F-7AEA-7876688AB99F}"/>
          </ac:picMkLst>
        </pc:picChg>
      </pc:sldChg>
      <pc:sldChg chg="addSp delSp modSp new add del mod">
        <pc:chgData name="Devkar, Vikas" userId="acbd15ec-55d1-4a76-83ac-3f1d82711ed5" providerId="ADAL" clId="{0F0500CC-7EE5-4B6D-A233-78C10B0575F1}" dt="2023-11-13T19:19:03.257" v="2681" actId="478"/>
        <pc:sldMkLst>
          <pc:docMk/>
          <pc:sldMk cId="2320068136" sldId="260"/>
        </pc:sldMkLst>
        <pc:spChg chg="del">
          <ac:chgData name="Devkar, Vikas" userId="acbd15ec-55d1-4a76-83ac-3f1d82711ed5" providerId="ADAL" clId="{0F0500CC-7EE5-4B6D-A233-78C10B0575F1}" dt="2023-10-18T23:13:35.814" v="940" actId="478"/>
          <ac:spMkLst>
            <pc:docMk/>
            <pc:sldMk cId="2320068136" sldId="260"/>
            <ac:spMk id="2" creationId="{C5F30259-710E-071C-0EB7-B8BED4943401}"/>
          </ac:spMkLst>
        </pc:spChg>
        <pc:spChg chg="del">
          <ac:chgData name="Devkar, Vikas" userId="acbd15ec-55d1-4a76-83ac-3f1d82711ed5" providerId="ADAL" clId="{0F0500CC-7EE5-4B6D-A233-78C10B0575F1}" dt="2023-10-18T23:13:35.814" v="940" actId="478"/>
          <ac:spMkLst>
            <pc:docMk/>
            <pc:sldMk cId="2320068136" sldId="260"/>
            <ac:spMk id="3" creationId="{B03FFA56-EB18-AC94-D476-7BEE8C3A8D11}"/>
          </ac:spMkLst>
        </pc:spChg>
        <pc:spChg chg="add del mod">
          <ac:chgData name="Devkar, Vikas" userId="acbd15ec-55d1-4a76-83ac-3f1d82711ed5" providerId="ADAL" clId="{0F0500CC-7EE5-4B6D-A233-78C10B0575F1}" dt="2023-11-13T19:19:03.257" v="2681" actId="478"/>
          <ac:spMkLst>
            <pc:docMk/>
            <pc:sldMk cId="2320068136" sldId="260"/>
            <ac:spMk id="5" creationId="{616A41C1-4CA0-032F-AC5C-AD80ED56A5D9}"/>
          </ac:spMkLst>
        </pc:spChg>
      </pc:sldChg>
      <pc:sldChg chg="addSp delSp modSp new add del mod ord">
        <pc:chgData name="Devkar, Vikas" userId="acbd15ec-55d1-4a76-83ac-3f1d82711ed5" providerId="ADAL" clId="{0F0500CC-7EE5-4B6D-A233-78C10B0575F1}" dt="2023-11-13T19:19:57.293" v="2690" actId="20577"/>
        <pc:sldMkLst>
          <pc:docMk/>
          <pc:sldMk cId="3233729401" sldId="261"/>
        </pc:sldMkLst>
        <pc:spChg chg="del">
          <ac:chgData name="Devkar, Vikas" userId="acbd15ec-55d1-4a76-83ac-3f1d82711ed5" providerId="ADAL" clId="{0F0500CC-7EE5-4B6D-A233-78C10B0575F1}" dt="2023-10-18T23:17:05.477" v="986" actId="478"/>
          <ac:spMkLst>
            <pc:docMk/>
            <pc:sldMk cId="3233729401" sldId="261"/>
            <ac:spMk id="2" creationId="{2C31261C-61E7-F22D-7202-48D089381F1D}"/>
          </ac:spMkLst>
        </pc:spChg>
        <pc:spChg chg="del">
          <ac:chgData name="Devkar, Vikas" userId="acbd15ec-55d1-4a76-83ac-3f1d82711ed5" providerId="ADAL" clId="{0F0500CC-7EE5-4B6D-A233-78C10B0575F1}" dt="2023-10-18T23:17:05.477" v="986" actId="478"/>
          <ac:spMkLst>
            <pc:docMk/>
            <pc:sldMk cId="3233729401" sldId="261"/>
            <ac:spMk id="3" creationId="{6F3122B2-DD2F-A1C8-F86E-F3D70FD88946}"/>
          </ac:spMkLst>
        </pc:spChg>
        <pc:spChg chg="add mod">
          <ac:chgData name="Devkar, Vikas" userId="acbd15ec-55d1-4a76-83ac-3f1d82711ed5" providerId="ADAL" clId="{0F0500CC-7EE5-4B6D-A233-78C10B0575F1}" dt="2023-11-13T19:19:57.293" v="2690" actId="20577"/>
          <ac:spMkLst>
            <pc:docMk/>
            <pc:sldMk cId="3233729401" sldId="261"/>
            <ac:spMk id="4" creationId="{A659741B-D9D9-C197-AC3F-A48F9C89D368}"/>
          </ac:spMkLst>
        </pc:spChg>
        <pc:picChg chg="add del mod">
          <ac:chgData name="Devkar, Vikas" userId="acbd15ec-55d1-4a76-83ac-3f1d82711ed5" providerId="ADAL" clId="{0F0500CC-7EE5-4B6D-A233-78C10B0575F1}" dt="2023-11-13T19:19:52.727" v="2689" actId="478"/>
          <ac:picMkLst>
            <pc:docMk/>
            <pc:sldMk cId="3233729401" sldId="261"/>
            <ac:picMk id="6" creationId="{4B6DFC15-E2B4-4C97-0DCE-B08BCF944DC3}"/>
          </ac:picMkLst>
        </pc:picChg>
      </pc:sldChg>
      <pc:sldChg chg="addSp delSp modSp new del mod">
        <pc:chgData name="Devkar, Vikas" userId="acbd15ec-55d1-4a76-83ac-3f1d82711ed5" providerId="ADAL" clId="{0F0500CC-7EE5-4B6D-A233-78C10B0575F1}" dt="2023-10-18T23:16:54.317" v="983" actId="47"/>
        <pc:sldMkLst>
          <pc:docMk/>
          <pc:sldMk cId="4019308051" sldId="261"/>
        </pc:sldMkLst>
        <pc:spChg chg="del">
          <ac:chgData name="Devkar, Vikas" userId="acbd15ec-55d1-4a76-83ac-3f1d82711ed5" providerId="ADAL" clId="{0F0500CC-7EE5-4B6D-A233-78C10B0575F1}" dt="2023-10-18T23:16:44.594" v="979" actId="478"/>
          <ac:spMkLst>
            <pc:docMk/>
            <pc:sldMk cId="4019308051" sldId="261"/>
            <ac:spMk id="2" creationId="{A88B5FC8-A963-C7EF-C9E1-485320D137CE}"/>
          </ac:spMkLst>
        </pc:spChg>
        <pc:spChg chg="del">
          <ac:chgData name="Devkar, Vikas" userId="acbd15ec-55d1-4a76-83ac-3f1d82711ed5" providerId="ADAL" clId="{0F0500CC-7EE5-4B6D-A233-78C10B0575F1}" dt="2023-10-18T23:16:44.594" v="979" actId="478"/>
          <ac:spMkLst>
            <pc:docMk/>
            <pc:sldMk cId="4019308051" sldId="261"/>
            <ac:spMk id="3" creationId="{CD54D7AB-62DE-D90E-6344-D022C60BCEEA}"/>
          </ac:spMkLst>
        </pc:spChg>
        <pc:spChg chg="add mod">
          <ac:chgData name="Devkar, Vikas" userId="acbd15ec-55d1-4a76-83ac-3f1d82711ed5" providerId="ADAL" clId="{0F0500CC-7EE5-4B6D-A233-78C10B0575F1}" dt="2023-10-18T23:16:50.535" v="982" actId="1076"/>
          <ac:spMkLst>
            <pc:docMk/>
            <pc:sldMk cId="4019308051" sldId="261"/>
            <ac:spMk id="5" creationId="{F989A860-ADA3-E228-9E4E-9E312EC4CA19}"/>
          </ac:spMkLst>
        </pc:spChg>
      </pc:sldChg>
      <pc:sldChg chg="addSp delSp modSp new add del mod">
        <pc:chgData name="Devkar, Vikas" userId="acbd15ec-55d1-4a76-83ac-3f1d82711ed5" providerId="ADAL" clId="{0F0500CC-7EE5-4B6D-A233-78C10B0575F1}" dt="2023-11-13T19:53:34.462" v="2754" actId="1076"/>
        <pc:sldMkLst>
          <pc:docMk/>
          <pc:sldMk cId="1437810819" sldId="262"/>
        </pc:sldMkLst>
        <pc:spChg chg="del">
          <ac:chgData name="Devkar, Vikas" userId="acbd15ec-55d1-4a76-83ac-3f1d82711ed5" providerId="ADAL" clId="{0F0500CC-7EE5-4B6D-A233-78C10B0575F1}" dt="2023-10-23T22:01:27.108" v="1224" actId="478"/>
          <ac:spMkLst>
            <pc:docMk/>
            <pc:sldMk cId="1437810819" sldId="262"/>
            <ac:spMk id="2" creationId="{DCA7BB03-8FDB-51CC-41DC-9453F468EB27}"/>
          </ac:spMkLst>
        </pc:spChg>
        <pc:spChg chg="del">
          <ac:chgData name="Devkar, Vikas" userId="acbd15ec-55d1-4a76-83ac-3f1d82711ed5" providerId="ADAL" clId="{0F0500CC-7EE5-4B6D-A233-78C10B0575F1}" dt="2023-10-23T22:01:27.108" v="1224" actId="478"/>
          <ac:spMkLst>
            <pc:docMk/>
            <pc:sldMk cId="1437810819" sldId="262"/>
            <ac:spMk id="3" creationId="{46830CF1-0C8D-DD03-592E-9806722922DD}"/>
          </ac:spMkLst>
        </pc:spChg>
        <pc:spChg chg="mod">
          <ac:chgData name="Devkar, Vikas" userId="acbd15ec-55d1-4a76-83ac-3f1d82711ed5" providerId="ADAL" clId="{0F0500CC-7EE5-4B6D-A233-78C10B0575F1}" dt="2023-11-11T22:04:27.225" v="1964" actId="403"/>
          <ac:spMkLst>
            <pc:docMk/>
            <pc:sldMk cId="1437810819" sldId="262"/>
            <ac:spMk id="7" creationId="{5551FD6D-A974-5B2F-06D6-39C5B15287E5}"/>
          </ac:spMkLst>
        </pc:spChg>
        <pc:spChg chg="mod">
          <ac:chgData name="Devkar, Vikas" userId="acbd15ec-55d1-4a76-83ac-3f1d82711ed5" providerId="ADAL" clId="{0F0500CC-7EE5-4B6D-A233-78C10B0575F1}" dt="2023-11-11T22:04:27.225" v="1964" actId="403"/>
          <ac:spMkLst>
            <pc:docMk/>
            <pc:sldMk cId="1437810819" sldId="262"/>
            <ac:spMk id="9" creationId="{FDE99791-FD49-3011-4C78-96B02C0A5A8F}"/>
          </ac:spMkLst>
        </pc:spChg>
        <pc:spChg chg="mod topLvl">
          <ac:chgData name="Devkar, Vikas" userId="acbd15ec-55d1-4a76-83ac-3f1d82711ed5" providerId="ADAL" clId="{0F0500CC-7EE5-4B6D-A233-78C10B0575F1}" dt="2023-10-23T22:08:40.545" v="1310" actId="164"/>
          <ac:spMkLst>
            <pc:docMk/>
            <pc:sldMk cId="1437810819" sldId="262"/>
            <ac:spMk id="10" creationId="{572D9AD7-C498-D14F-58FE-5785D53FC98B}"/>
          </ac:spMkLst>
        </pc:spChg>
        <pc:spChg chg="mod topLvl">
          <ac:chgData name="Devkar, Vikas" userId="acbd15ec-55d1-4a76-83ac-3f1d82711ed5" providerId="ADAL" clId="{0F0500CC-7EE5-4B6D-A233-78C10B0575F1}" dt="2023-10-23T22:08:40.545" v="1310" actId="164"/>
          <ac:spMkLst>
            <pc:docMk/>
            <pc:sldMk cId="1437810819" sldId="262"/>
            <ac:spMk id="11" creationId="{64C99298-B918-1F4C-6FF2-E30B4AC9E917}"/>
          </ac:spMkLst>
        </pc:spChg>
        <pc:spChg chg="mod topLvl">
          <ac:chgData name="Devkar, Vikas" userId="acbd15ec-55d1-4a76-83ac-3f1d82711ed5" providerId="ADAL" clId="{0F0500CC-7EE5-4B6D-A233-78C10B0575F1}" dt="2023-10-23T22:08:40.545" v="1310" actId="164"/>
          <ac:spMkLst>
            <pc:docMk/>
            <pc:sldMk cId="1437810819" sldId="262"/>
            <ac:spMk id="12" creationId="{162D2494-D506-6F76-974D-42F1D54BAB52}"/>
          </ac:spMkLst>
        </pc:spChg>
        <pc:spChg chg="mod topLvl">
          <ac:chgData name="Devkar, Vikas" userId="acbd15ec-55d1-4a76-83ac-3f1d82711ed5" providerId="ADAL" clId="{0F0500CC-7EE5-4B6D-A233-78C10B0575F1}" dt="2023-10-23T22:08:40.545" v="1310" actId="164"/>
          <ac:spMkLst>
            <pc:docMk/>
            <pc:sldMk cId="1437810819" sldId="262"/>
            <ac:spMk id="13" creationId="{27F14563-D788-E725-73DA-F8756FDBB87E}"/>
          </ac:spMkLst>
        </pc:spChg>
        <pc:spChg chg="mod topLvl">
          <ac:chgData name="Devkar, Vikas" userId="acbd15ec-55d1-4a76-83ac-3f1d82711ed5" providerId="ADAL" clId="{0F0500CC-7EE5-4B6D-A233-78C10B0575F1}" dt="2023-10-23T22:08:40.545" v="1310" actId="164"/>
          <ac:spMkLst>
            <pc:docMk/>
            <pc:sldMk cId="1437810819" sldId="262"/>
            <ac:spMk id="14" creationId="{60634B0E-A17C-C245-FDF7-F680F098DDBA}"/>
          </ac:spMkLst>
        </pc:spChg>
        <pc:spChg chg="mod topLvl">
          <ac:chgData name="Devkar, Vikas" userId="acbd15ec-55d1-4a76-83ac-3f1d82711ed5" providerId="ADAL" clId="{0F0500CC-7EE5-4B6D-A233-78C10B0575F1}" dt="2023-10-23T22:08:40.545" v="1310" actId="164"/>
          <ac:spMkLst>
            <pc:docMk/>
            <pc:sldMk cId="1437810819" sldId="262"/>
            <ac:spMk id="15" creationId="{529B81DA-A4C1-F20D-CFBF-CA148322973F}"/>
          </ac:spMkLst>
        </pc:spChg>
        <pc:spChg chg="mod topLvl">
          <ac:chgData name="Devkar, Vikas" userId="acbd15ec-55d1-4a76-83ac-3f1d82711ed5" providerId="ADAL" clId="{0F0500CC-7EE5-4B6D-A233-78C10B0575F1}" dt="2023-10-23T22:08:40.545" v="1310" actId="164"/>
          <ac:spMkLst>
            <pc:docMk/>
            <pc:sldMk cId="1437810819" sldId="262"/>
            <ac:spMk id="16" creationId="{8FD183AA-FE3D-BD0B-FB9D-1CF02C9400E7}"/>
          </ac:spMkLst>
        </pc:spChg>
        <pc:spChg chg="mod topLvl">
          <ac:chgData name="Devkar, Vikas" userId="acbd15ec-55d1-4a76-83ac-3f1d82711ed5" providerId="ADAL" clId="{0F0500CC-7EE5-4B6D-A233-78C10B0575F1}" dt="2023-10-23T22:08:40.545" v="1310" actId="164"/>
          <ac:spMkLst>
            <pc:docMk/>
            <pc:sldMk cId="1437810819" sldId="262"/>
            <ac:spMk id="17" creationId="{51D528C0-4036-832F-8E9C-434B74B58B58}"/>
          </ac:spMkLst>
        </pc:spChg>
        <pc:spChg chg="mod topLvl">
          <ac:chgData name="Devkar, Vikas" userId="acbd15ec-55d1-4a76-83ac-3f1d82711ed5" providerId="ADAL" clId="{0F0500CC-7EE5-4B6D-A233-78C10B0575F1}" dt="2023-10-23T22:08:40.545" v="1310" actId="164"/>
          <ac:spMkLst>
            <pc:docMk/>
            <pc:sldMk cId="1437810819" sldId="262"/>
            <ac:spMk id="18" creationId="{CE9F8BFD-BD00-72E1-9725-3699FEE6A547}"/>
          </ac:spMkLst>
        </pc:spChg>
        <pc:spChg chg="mod topLvl">
          <ac:chgData name="Devkar, Vikas" userId="acbd15ec-55d1-4a76-83ac-3f1d82711ed5" providerId="ADAL" clId="{0F0500CC-7EE5-4B6D-A233-78C10B0575F1}" dt="2023-10-23T22:08:40.545" v="1310" actId="164"/>
          <ac:spMkLst>
            <pc:docMk/>
            <pc:sldMk cId="1437810819" sldId="262"/>
            <ac:spMk id="19" creationId="{A3C1EC31-43DD-6C2C-460D-4318DB89A496}"/>
          </ac:spMkLst>
        </pc:spChg>
        <pc:spChg chg="mod">
          <ac:chgData name="Devkar, Vikas" userId="acbd15ec-55d1-4a76-83ac-3f1d82711ed5" providerId="ADAL" clId="{0F0500CC-7EE5-4B6D-A233-78C10B0575F1}" dt="2023-11-11T22:04:27.225" v="1964" actId="403"/>
          <ac:spMkLst>
            <pc:docMk/>
            <pc:sldMk cId="1437810819" sldId="262"/>
            <ac:spMk id="22" creationId="{F45B774E-352B-D2F0-59CE-3F403547A606}"/>
          </ac:spMkLst>
        </pc:spChg>
        <pc:spChg chg="mod">
          <ac:chgData name="Devkar, Vikas" userId="acbd15ec-55d1-4a76-83ac-3f1d82711ed5" providerId="ADAL" clId="{0F0500CC-7EE5-4B6D-A233-78C10B0575F1}" dt="2023-11-11T22:04:27.225" v="1964" actId="403"/>
          <ac:spMkLst>
            <pc:docMk/>
            <pc:sldMk cId="1437810819" sldId="262"/>
            <ac:spMk id="23" creationId="{B96FC619-0C39-0BD7-3C82-79163AEE558A}"/>
          </ac:spMkLst>
        </pc:spChg>
        <pc:spChg chg="mod">
          <ac:chgData name="Devkar, Vikas" userId="acbd15ec-55d1-4a76-83ac-3f1d82711ed5" providerId="ADAL" clId="{0F0500CC-7EE5-4B6D-A233-78C10B0575F1}" dt="2023-11-11T22:04:27.225" v="1964" actId="403"/>
          <ac:spMkLst>
            <pc:docMk/>
            <pc:sldMk cId="1437810819" sldId="262"/>
            <ac:spMk id="24" creationId="{CF95B481-9423-1BA2-A6AE-3168412DA92C}"/>
          </ac:spMkLst>
        </pc:spChg>
        <pc:spChg chg="mod">
          <ac:chgData name="Devkar, Vikas" userId="acbd15ec-55d1-4a76-83ac-3f1d82711ed5" providerId="ADAL" clId="{0F0500CC-7EE5-4B6D-A233-78C10B0575F1}" dt="2023-11-11T22:04:27.225" v="1964" actId="403"/>
          <ac:spMkLst>
            <pc:docMk/>
            <pc:sldMk cId="1437810819" sldId="262"/>
            <ac:spMk id="25" creationId="{060AC8CA-83D7-B03F-8D61-3B566DDE6E52}"/>
          </ac:spMkLst>
        </pc:spChg>
        <pc:spChg chg="mod">
          <ac:chgData name="Devkar, Vikas" userId="acbd15ec-55d1-4a76-83ac-3f1d82711ed5" providerId="ADAL" clId="{0F0500CC-7EE5-4B6D-A233-78C10B0575F1}" dt="2023-11-11T22:04:27.225" v="1964" actId="403"/>
          <ac:spMkLst>
            <pc:docMk/>
            <pc:sldMk cId="1437810819" sldId="262"/>
            <ac:spMk id="26" creationId="{C2102C78-BD49-0370-8108-0C8BB76C276E}"/>
          </ac:spMkLst>
        </pc:spChg>
        <pc:spChg chg="mod">
          <ac:chgData name="Devkar, Vikas" userId="acbd15ec-55d1-4a76-83ac-3f1d82711ed5" providerId="ADAL" clId="{0F0500CC-7EE5-4B6D-A233-78C10B0575F1}" dt="2023-11-11T22:04:27.225" v="1964" actId="403"/>
          <ac:spMkLst>
            <pc:docMk/>
            <pc:sldMk cId="1437810819" sldId="262"/>
            <ac:spMk id="27" creationId="{04E25290-5D07-D968-2B23-FA447187C6EA}"/>
          </ac:spMkLst>
        </pc:spChg>
        <pc:spChg chg="mod">
          <ac:chgData name="Devkar, Vikas" userId="acbd15ec-55d1-4a76-83ac-3f1d82711ed5" providerId="ADAL" clId="{0F0500CC-7EE5-4B6D-A233-78C10B0575F1}" dt="2023-11-11T22:04:27.225" v="1964" actId="403"/>
          <ac:spMkLst>
            <pc:docMk/>
            <pc:sldMk cId="1437810819" sldId="262"/>
            <ac:spMk id="28" creationId="{61C17996-2D3F-3557-196F-0403431021D7}"/>
          </ac:spMkLst>
        </pc:spChg>
        <pc:spChg chg="mod topLvl">
          <ac:chgData name="Devkar, Vikas" userId="acbd15ec-55d1-4a76-83ac-3f1d82711ed5" providerId="ADAL" clId="{0F0500CC-7EE5-4B6D-A233-78C10B0575F1}" dt="2023-10-23T22:15:39.681" v="1426" actId="164"/>
          <ac:spMkLst>
            <pc:docMk/>
            <pc:sldMk cId="1437810819" sldId="262"/>
            <ac:spMk id="29" creationId="{4DBB424F-5913-E412-A588-AFA9C67D86C7}"/>
          </ac:spMkLst>
        </pc:spChg>
        <pc:spChg chg="mod">
          <ac:chgData name="Devkar, Vikas" userId="acbd15ec-55d1-4a76-83ac-3f1d82711ed5" providerId="ADAL" clId="{0F0500CC-7EE5-4B6D-A233-78C10B0575F1}" dt="2023-11-11T22:04:27.225" v="1964" actId="403"/>
          <ac:spMkLst>
            <pc:docMk/>
            <pc:sldMk cId="1437810819" sldId="262"/>
            <ac:spMk id="29" creationId="{80B6CD38-054E-2E08-C89C-5F5E17A800D2}"/>
          </ac:spMkLst>
        </pc:spChg>
        <pc:spChg chg="mod">
          <ac:chgData name="Devkar, Vikas" userId="acbd15ec-55d1-4a76-83ac-3f1d82711ed5" providerId="ADAL" clId="{0F0500CC-7EE5-4B6D-A233-78C10B0575F1}" dt="2023-11-11T22:04:27.225" v="1964" actId="403"/>
          <ac:spMkLst>
            <pc:docMk/>
            <pc:sldMk cId="1437810819" sldId="262"/>
            <ac:spMk id="30" creationId="{412A6116-AD7C-DDA5-0273-749813721AB6}"/>
          </ac:spMkLst>
        </pc:spChg>
        <pc:spChg chg="mod topLvl">
          <ac:chgData name="Devkar, Vikas" userId="acbd15ec-55d1-4a76-83ac-3f1d82711ed5" providerId="ADAL" clId="{0F0500CC-7EE5-4B6D-A233-78C10B0575F1}" dt="2023-10-23T22:15:39.681" v="1426" actId="164"/>
          <ac:spMkLst>
            <pc:docMk/>
            <pc:sldMk cId="1437810819" sldId="262"/>
            <ac:spMk id="30" creationId="{A2399D78-4350-41C6-824B-4F69AA717661}"/>
          </ac:spMkLst>
        </pc:spChg>
        <pc:spChg chg="mod">
          <ac:chgData name="Devkar, Vikas" userId="acbd15ec-55d1-4a76-83ac-3f1d82711ed5" providerId="ADAL" clId="{0F0500CC-7EE5-4B6D-A233-78C10B0575F1}" dt="2023-11-11T22:04:27.225" v="1964" actId="403"/>
          <ac:spMkLst>
            <pc:docMk/>
            <pc:sldMk cId="1437810819" sldId="262"/>
            <ac:spMk id="31" creationId="{47565931-FFBD-FEF3-8ADB-65035CAF414A}"/>
          </ac:spMkLst>
        </pc:spChg>
        <pc:spChg chg="mod topLvl">
          <ac:chgData name="Devkar, Vikas" userId="acbd15ec-55d1-4a76-83ac-3f1d82711ed5" providerId="ADAL" clId="{0F0500CC-7EE5-4B6D-A233-78C10B0575F1}" dt="2023-10-23T22:15:39.681" v="1426" actId="164"/>
          <ac:spMkLst>
            <pc:docMk/>
            <pc:sldMk cId="1437810819" sldId="262"/>
            <ac:spMk id="31" creationId="{C8AAE5A6-8C2D-12BB-7040-E6BA62A23F8E}"/>
          </ac:spMkLst>
        </pc:spChg>
        <pc:spChg chg="mod topLvl">
          <ac:chgData name="Devkar, Vikas" userId="acbd15ec-55d1-4a76-83ac-3f1d82711ed5" providerId="ADAL" clId="{0F0500CC-7EE5-4B6D-A233-78C10B0575F1}" dt="2023-10-23T22:15:39.681" v="1426" actId="164"/>
          <ac:spMkLst>
            <pc:docMk/>
            <pc:sldMk cId="1437810819" sldId="262"/>
            <ac:spMk id="32" creationId="{A7E127B4-7FD2-6EC8-065E-C68D8A867AF5}"/>
          </ac:spMkLst>
        </pc:spChg>
        <pc:spChg chg="mod topLvl">
          <ac:chgData name="Devkar, Vikas" userId="acbd15ec-55d1-4a76-83ac-3f1d82711ed5" providerId="ADAL" clId="{0F0500CC-7EE5-4B6D-A233-78C10B0575F1}" dt="2023-10-23T22:15:39.681" v="1426" actId="164"/>
          <ac:spMkLst>
            <pc:docMk/>
            <pc:sldMk cId="1437810819" sldId="262"/>
            <ac:spMk id="33" creationId="{B58E0B79-1E3D-AA3E-6522-D6F2AF40FFC1}"/>
          </ac:spMkLst>
        </pc:spChg>
        <pc:spChg chg="mod topLvl">
          <ac:chgData name="Devkar, Vikas" userId="acbd15ec-55d1-4a76-83ac-3f1d82711ed5" providerId="ADAL" clId="{0F0500CC-7EE5-4B6D-A233-78C10B0575F1}" dt="2023-10-23T22:15:39.681" v="1426" actId="164"/>
          <ac:spMkLst>
            <pc:docMk/>
            <pc:sldMk cId="1437810819" sldId="262"/>
            <ac:spMk id="34" creationId="{D945D641-4D99-5DD0-3B46-70AC28EA1207}"/>
          </ac:spMkLst>
        </pc:spChg>
        <pc:spChg chg="mod topLvl">
          <ac:chgData name="Devkar, Vikas" userId="acbd15ec-55d1-4a76-83ac-3f1d82711ed5" providerId="ADAL" clId="{0F0500CC-7EE5-4B6D-A233-78C10B0575F1}" dt="2023-10-23T22:15:39.681" v="1426" actId="164"/>
          <ac:spMkLst>
            <pc:docMk/>
            <pc:sldMk cId="1437810819" sldId="262"/>
            <ac:spMk id="36" creationId="{D1957B79-B74A-BF88-9B2A-863B5E842289}"/>
          </ac:spMkLst>
        </pc:spChg>
        <pc:spChg chg="add del mod">
          <ac:chgData name="Devkar, Vikas" userId="acbd15ec-55d1-4a76-83ac-3f1d82711ed5" providerId="ADAL" clId="{0F0500CC-7EE5-4B6D-A233-78C10B0575F1}" dt="2023-10-24T04:52:28.550" v="1668" actId="478"/>
          <ac:spMkLst>
            <pc:docMk/>
            <pc:sldMk cId="1437810819" sldId="262"/>
            <ac:spMk id="38" creationId="{B5B1FA88-16E0-5070-EC41-DD11215535EF}"/>
          </ac:spMkLst>
        </pc:spChg>
        <pc:spChg chg="add mod">
          <ac:chgData name="Devkar, Vikas" userId="acbd15ec-55d1-4a76-83ac-3f1d82711ed5" providerId="ADAL" clId="{0F0500CC-7EE5-4B6D-A233-78C10B0575F1}" dt="2023-11-13T17:38:20.931" v="2095" actId="20577"/>
          <ac:spMkLst>
            <pc:docMk/>
            <pc:sldMk cId="1437810819" sldId="262"/>
            <ac:spMk id="39" creationId="{2D981907-DEF4-28AB-4F9E-121EFA7BA0D3}"/>
          </ac:spMkLst>
        </pc:spChg>
        <pc:spChg chg="add mod">
          <ac:chgData name="Devkar, Vikas" userId="acbd15ec-55d1-4a76-83ac-3f1d82711ed5" providerId="ADAL" clId="{0F0500CC-7EE5-4B6D-A233-78C10B0575F1}" dt="2023-11-13T17:38:55.964" v="2101" actId="1076"/>
          <ac:spMkLst>
            <pc:docMk/>
            <pc:sldMk cId="1437810819" sldId="262"/>
            <ac:spMk id="40" creationId="{53751EA1-1890-A682-31A3-D98ECB5B17CD}"/>
          </ac:spMkLst>
        </pc:spChg>
        <pc:spChg chg="add mod">
          <ac:chgData name="Devkar, Vikas" userId="acbd15ec-55d1-4a76-83ac-3f1d82711ed5" providerId="ADAL" clId="{0F0500CC-7EE5-4B6D-A233-78C10B0575F1}" dt="2023-11-13T17:38:55.964" v="2101" actId="1076"/>
          <ac:spMkLst>
            <pc:docMk/>
            <pc:sldMk cId="1437810819" sldId="262"/>
            <ac:spMk id="41" creationId="{1EE920DF-9EA3-7D7B-F021-BC256925BF39}"/>
          </ac:spMkLst>
        </pc:spChg>
        <pc:spChg chg="add mod">
          <ac:chgData name="Devkar, Vikas" userId="acbd15ec-55d1-4a76-83ac-3f1d82711ed5" providerId="ADAL" clId="{0F0500CC-7EE5-4B6D-A233-78C10B0575F1}" dt="2023-11-13T19:53:34.462" v="2754" actId="1076"/>
          <ac:spMkLst>
            <pc:docMk/>
            <pc:sldMk cId="1437810819" sldId="262"/>
            <ac:spMk id="42" creationId="{28F568E8-3645-BB50-A71F-27BA32D8D5C2}"/>
          </ac:spMkLst>
        </pc:spChg>
        <pc:grpChg chg="add mod">
          <ac:chgData name="Devkar, Vikas" userId="acbd15ec-55d1-4a76-83ac-3f1d82711ed5" providerId="ADAL" clId="{0F0500CC-7EE5-4B6D-A233-78C10B0575F1}" dt="2023-11-13T17:39:01.694" v="2102" actId="14100"/>
          <ac:grpSpMkLst>
            <pc:docMk/>
            <pc:sldMk cId="1437810819" sldId="262"/>
            <ac:grpSpMk id="4" creationId="{4C12F03E-9E8E-ECF2-F61F-6F06DEFF4081}"/>
          </ac:grpSpMkLst>
        </pc:grpChg>
        <pc:grpChg chg="add del mod">
          <ac:chgData name="Devkar, Vikas" userId="acbd15ec-55d1-4a76-83ac-3f1d82711ed5" providerId="ADAL" clId="{0F0500CC-7EE5-4B6D-A233-78C10B0575F1}" dt="2023-10-23T22:02:15.548" v="1232" actId="165"/>
          <ac:grpSpMkLst>
            <pc:docMk/>
            <pc:sldMk cId="1437810819" sldId="262"/>
            <ac:grpSpMk id="7" creationId="{DED746FE-7E0D-E799-D533-64999FC2CF69}"/>
          </ac:grpSpMkLst>
        </pc:grpChg>
        <pc:grpChg chg="del mod topLvl">
          <ac:chgData name="Devkar, Vikas" userId="acbd15ec-55d1-4a76-83ac-3f1d82711ed5" providerId="ADAL" clId="{0F0500CC-7EE5-4B6D-A233-78C10B0575F1}" dt="2023-10-23T22:05:41.143" v="1274" actId="165"/>
          <ac:grpSpMkLst>
            <pc:docMk/>
            <pc:sldMk cId="1437810819" sldId="262"/>
            <ac:grpSpMk id="9" creationId="{69BBE28C-E16C-488A-6A5F-C5B65BE6D955}"/>
          </ac:grpSpMkLst>
        </pc:grpChg>
        <pc:grpChg chg="add mod">
          <ac:chgData name="Devkar, Vikas" userId="acbd15ec-55d1-4a76-83ac-3f1d82711ed5" providerId="ADAL" clId="{0F0500CC-7EE5-4B6D-A233-78C10B0575F1}" dt="2023-10-23T22:09:15.404" v="1319" actId="164"/>
          <ac:grpSpMkLst>
            <pc:docMk/>
            <pc:sldMk cId="1437810819" sldId="262"/>
            <ac:grpSpMk id="20" creationId="{D804E0EA-7BE4-9B20-572E-D24A886A6D39}"/>
          </ac:grpSpMkLst>
        </pc:grpChg>
        <pc:grpChg chg="add del mod">
          <ac:chgData name="Devkar, Vikas" userId="acbd15ec-55d1-4a76-83ac-3f1d82711ed5" providerId="ADAL" clId="{0F0500CC-7EE5-4B6D-A233-78C10B0575F1}" dt="2023-11-11T22:02:49.184" v="1937" actId="478"/>
          <ac:grpSpMkLst>
            <pc:docMk/>
            <pc:sldMk cId="1437810819" sldId="262"/>
            <ac:grpSpMk id="21" creationId="{BF67635F-77AD-24EE-A02D-1FB5BACF615B}"/>
          </ac:grpSpMkLst>
        </pc:grpChg>
        <pc:grpChg chg="add del mod">
          <ac:chgData name="Devkar, Vikas" userId="acbd15ec-55d1-4a76-83ac-3f1d82711ed5" providerId="ADAL" clId="{0F0500CC-7EE5-4B6D-A233-78C10B0575F1}" dt="2023-10-23T22:13:37.942" v="1392" actId="165"/>
          <ac:grpSpMkLst>
            <pc:docMk/>
            <pc:sldMk cId="1437810819" sldId="262"/>
            <ac:grpSpMk id="22" creationId="{93028128-FDD7-DC4C-B645-298767B36307}"/>
          </ac:grpSpMkLst>
        </pc:grpChg>
        <pc:grpChg chg="add del mod">
          <ac:chgData name="Devkar, Vikas" userId="acbd15ec-55d1-4a76-83ac-3f1d82711ed5" providerId="ADAL" clId="{0F0500CC-7EE5-4B6D-A233-78C10B0575F1}" dt="2023-10-24T04:46:52.102" v="1579" actId="21"/>
          <ac:grpSpMkLst>
            <pc:docMk/>
            <pc:sldMk cId="1437810819" sldId="262"/>
            <ac:grpSpMk id="37" creationId="{31A9341D-59AB-8E38-B7A5-C95A878D565D}"/>
          </ac:grpSpMkLst>
        </pc:grpChg>
        <pc:picChg chg="add mod">
          <ac:chgData name="Devkar, Vikas" userId="acbd15ec-55d1-4a76-83ac-3f1d82711ed5" providerId="ADAL" clId="{0F0500CC-7EE5-4B6D-A233-78C10B0575F1}" dt="2023-11-13T19:16:03.895" v="2678" actId="14100"/>
          <ac:picMkLst>
            <pc:docMk/>
            <pc:sldMk cId="1437810819" sldId="262"/>
            <ac:picMk id="3" creationId="{A7FE0156-B454-678F-37C3-F9D56CBA9AC0}"/>
          </ac:picMkLst>
        </pc:picChg>
        <pc:picChg chg="add mod">
          <ac:chgData name="Devkar, Vikas" userId="acbd15ec-55d1-4a76-83ac-3f1d82711ed5" providerId="ADAL" clId="{0F0500CC-7EE5-4B6D-A233-78C10B0575F1}" dt="2023-11-13T17:38:00.205" v="2093" actId="1076"/>
          <ac:picMkLst>
            <pc:docMk/>
            <pc:sldMk cId="1437810819" sldId="262"/>
            <ac:picMk id="5" creationId="{7E2E4F8E-3A38-F819-A82D-5F88922F2C59}"/>
          </ac:picMkLst>
        </pc:picChg>
        <pc:picChg chg="add mod">
          <ac:chgData name="Devkar, Vikas" userId="acbd15ec-55d1-4a76-83ac-3f1d82711ed5" providerId="ADAL" clId="{0F0500CC-7EE5-4B6D-A233-78C10B0575F1}" dt="2023-11-13T17:38:55.964" v="2101" actId="1076"/>
          <ac:picMkLst>
            <pc:docMk/>
            <pc:sldMk cId="1437810819" sldId="262"/>
            <ac:picMk id="6" creationId="{700FDA5C-A7F2-2BB3-637E-ACB4A129C13C}"/>
          </ac:picMkLst>
        </pc:picChg>
        <pc:picChg chg="mod topLvl">
          <ac:chgData name="Devkar, Vikas" userId="acbd15ec-55d1-4a76-83ac-3f1d82711ed5" providerId="ADAL" clId="{0F0500CC-7EE5-4B6D-A233-78C10B0575F1}" dt="2023-10-23T22:09:15.404" v="1319" actId="164"/>
          <ac:picMkLst>
            <pc:docMk/>
            <pc:sldMk cId="1437810819" sldId="262"/>
            <ac:picMk id="8" creationId="{6FAD1F25-D290-1E55-9EC3-59174FD36A86}"/>
          </ac:picMkLst>
        </pc:picChg>
        <pc:picChg chg="mod topLvl">
          <ac:chgData name="Devkar, Vikas" userId="acbd15ec-55d1-4a76-83ac-3f1d82711ed5" providerId="ADAL" clId="{0F0500CC-7EE5-4B6D-A233-78C10B0575F1}" dt="2023-10-23T22:15:39.681" v="1426" actId="164"/>
          <ac:picMkLst>
            <pc:docMk/>
            <pc:sldMk cId="1437810819" sldId="262"/>
            <ac:picMk id="23" creationId="{8333D7B9-D74F-4A5E-553F-B2CFBDDD0651}"/>
          </ac:picMkLst>
        </pc:picChg>
        <pc:picChg chg="mod topLvl">
          <ac:chgData name="Devkar, Vikas" userId="acbd15ec-55d1-4a76-83ac-3f1d82711ed5" providerId="ADAL" clId="{0F0500CC-7EE5-4B6D-A233-78C10B0575F1}" dt="2023-10-23T22:15:39.681" v="1426" actId="164"/>
          <ac:picMkLst>
            <pc:docMk/>
            <pc:sldMk cId="1437810819" sldId="262"/>
            <ac:picMk id="24" creationId="{74035478-467F-857B-593F-56165F3A76B4}"/>
          </ac:picMkLst>
        </pc:picChg>
        <pc:picChg chg="mod topLvl">
          <ac:chgData name="Devkar, Vikas" userId="acbd15ec-55d1-4a76-83ac-3f1d82711ed5" providerId="ADAL" clId="{0F0500CC-7EE5-4B6D-A233-78C10B0575F1}" dt="2023-10-23T22:15:39.681" v="1426" actId="164"/>
          <ac:picMkLst>
            <pc:docMk/>
            <pc:sldMk cId="1437810819" sldId="262"/>
            <ac:picMk id="25" creationId="{9F45DB89-D445-2991-443F-35526FBCE9BD}"/>
          </ac:picMkLst>
        </pc:picChg>
        <pc:picChg chg="mod topLvl">
          <ac:chgData name="Devkar, Vikas" userId="acbd15ec-55d1-4a76-83ac-3f1d82711ed5" providerId="ADAL" clId="{0F0500CC-7EE5-4B6D-A233-78C10B0575F1}" dt="2023-10-23T22:15:39.681" v="1426" actId="164"/>
          <ac:picMkLst>
            <pc:docMk/>
            <pc:sldMk cId="1437810819" sldId="262"/>
            <ac:picMk id="26" creationId="{12D33C0F-BC2E-DDE7-B4EC-2E10FDCCC86C}"/>
          </ac:picMkLst>
        </pc:picChg>
        <pc:picChg chg="mod topLvl">
          <ac:chgData name="Devkar, Vikas" userId="acbd15ec-55d1-4a76-83ac-3f1d82711ed5" providerId="ADAL" clId="{0F0500CC-7EE5-4B6D-A233-78C10B0575F1}" dt="2023-10-23T22:15:39.681" v="1426" actId="164"/>
          <ac:picMkLst>
            <pc:docMk/>
            <pc:sldMk cId="1437810819" sldId="262"/>
            <ac:picMk id="27" creationId="{D48DCE06-EC40-BA44-249D-C07E74CACFB7}"/>
          </ac:picMkLst>
        </pc:picChg>
        <pc:picChg chg="mod topLvl">
          <ac:chgData name="Devkar, Vikas" userId="acbd15ec-55d1-4a76-83ac-3f1d82711ed5" providerId="ADAL" clId="{0F0500CC-7EE5-4B6D-A233-78C10B0575F1}" dt="2023-10-23T22:15:39.681" v="1426" actId="164"/>
          <ac:picMkLst>
            <pc:docMk/>
            <pc:sldMk cId="1437810819" sldId="262"/>
            <ac:picMk id="28" creationId="{27B5D0C9-9B54-43C6-1A0A-DF0B935975E1}"/>
          </ac:picMkLst>
        </pc:picChg>
        <pc:picChg chg="add del mod">
          <ac:chgData name="Devkar, Vikas" userId="acbd15ec-55d1-4a76-83ac-3f1d82711ed5" providerId="ADAL" clId="{0F0500CC-7EE5-4B6D-A233-78C10B0575F1}" dt="2023-11-11T22:05:47.915" v="1980" actId="478"/>
          <ac:picMkLst>
            <pc:docMk/>
            <pc:sldMk cId="1437810819" sldId="262"/>
            <ac:picMk id="33" creationId="{74D5893A-A51C-F195-5F83-CF6D0B0BA28D}"/>
          </ac:picMkLst>
        </pc:picChg>
        <pc:picChg chg="mod topLvl">
          <ac:chgData name="Devkar, Vikas" userId="acbd15ec-55d1-4a76-83ac-3f1d82711ed5" providerId="ADAL" clId="{0F0500CC-7EE5-4B6D-A233-78C10B0575F1}" dt="2023-10-23T22:15:39.681" v="1426" actId="164"/>
          <ac:picMkLst>
            <pc:docMk/>
            <pc:sldMk cId="1437810819" sldId="262"/>
            <ac:picMk id="35" creationId="{9A6AC184-2F09-2C4A-E36C-148067829683}"/>
          </ac:picMkLst>
        </pc:picChg>
      </pc:sldChg>
      <pc:sldChg chg="addSp delSp modSp new add del mod">
        <pc:chgData name="Devkar, Vikas" userId="acbd15ec-55d1-4a76-83ac-3f1d82711ed5" providerId="ADAL" clId="{0F0500CC-7EE5-4B6D-A233-78C10B0575F1}" dt="2023-11-13T19:52:45.896" v="2744" actId="47"/>
        <pc:sldMkLst>
          <pc:docMk/>
          <pc:sldMk cId="296353250" sldId="263"/>
        </pc:sldMkLst>
        <pc:spChg chg="add del mod">
          <ac:chgData name="Devkar, Vikas" userId="acbd15ec-55d1-4a76-83ac-3f1d82711ed5" providerId="ADAL" clId="{0F0500CC-7EE5-4B6D-A233-78C10B0575F1}" dt="2023-11-09T18:12:27.866" v="1775"/>
          <ac:spMkLst>
            <pc:docMk/>
            <pc:sldMk cId="296353250" sldId="263"/>
            <ac:spMk id="2" creationId="{7171D8A9-E9D1-B027-54FE-D39F2A1FE467}"/>
          </ac:spMkLst>
        </pc:spChg>
        <pc:spChg chg="add mod">
          <ac:chgData name="Devkar, Vikas" userId="acbd15ec-55d1-4a76-83ac-3f1d82711ed5" providerId="ADAL" clId="{0F0500CC-7EE5-4B6D-A233-78C10B0575F1}" dt="2023-11-13T18:44:34.612" v="2305" actId="207"/>
          <ac:spMkLst>
            <pc:docMk/>
            <pc:sldMk cId="296353250" sldId="263"/>
            <ac:spMk id="2" creationId="{D2B5D66D-2AE0-425E-F963-45D7356B6F29}"/>
          </ac:spMkLst>
        </pc:spChg>
        <pc:spChg chg="del">
          <ac:chgData name="Devkar, Vikas" userId="acbd15ec-55d1-4a76-83ac-3f1d82711ed5" providerId="ADAL" clId="{0F0500CC-7EE5-4B6D-A233-78C10B0575F1}" dt="2023-10-24T04:47:00.057" v="1581" actId="478"/>
          <ac:spMkLst>
            <pc:docMk/>
            <pc:sldMk cId="296353250" sldId="263"/>
            <ac:spMk id="2" creationId="{FA3FF588-995B-1463-935F-33476D87C9E4}"/>
          </ac:spMkLst>
        </pc:spChg>
        <pc:spChg chg="add del mod">
          <ac:chgData name="Devkar, Vikas" userId="acbd15ec-55d1-4a76-83ac-3f1d82711ed5" providerId="ADAL" clId="{0F0500CC-7EE5-4B6D-A233-78C10B0575F1}" dt="2023-11-13T18:44:18.188" v="2301" actId="478"/>
          <ac:spMkLst>
            <pc:docMk/>
            <pc:sldMk cId="296353250" sldId="263"/>
            <ac:spMk id="3" creationId="{C41AB3C7-F1AE-2165-0AAE-2020FA147FE3}"/>
          </ac:spMkLst>
        </pc:spChg>
        <pc:spChg chg="del">
          <ac:chgData name="Devkar, Vikas" userId="acbd15ec-55d1-4a76-83ac-3f1d82711ed5" providerId="ADAL" clId="{0F0500CC-7EE5-4B6D-A233-78C10B0575F1}" dt="2023-10-24T04:47:00.057" v="1581" actId="478"/>
          <ac:spMkLst>
            <pc:docMk/>
            <pc:sldMk cId="296353250" sldId="263"/>
            <ac:spMk id="3" creationId="{E6F2FA56-303D-F8C2-D97A-A374B77D1867}"/>
          </ac:spMkLst>
        </pc:spChg>
        <pc:spChg chg="mod topLvl">
          <ac:chgData name="Devkar, Vikas" userId="acbd15ec-55d1-4a76-83ac-3f1d82711ed5" providerId="ADAL" clId="{0F0500CC-7EE5-4B6D-A233-78C10B0575F1}" dt="2023-10-24T04:52:12.399" v="1665" actId="164"/>
          <ac:spMkLst>
            <pc:docMk/>
            <pc:sldMk cId="296353250" sldId="263"/>
            <ac:spMk id="11" creationId="{7512DA5D-9275-CAE4-470A-D0D953DF826D}"/>
          </ac:spMkLst>
        </pc:spChg>
        <pc:spChg chg="mod topLvl">
          <ac:chgData name="Devkar, Vikas" userId="acbd15ec-55d1-4a76-83ac-3f1d82711ed5" providerId="ADAL" clId="{0F0500CC-7EE5-4B6D-A233-78C10B0575F1}" dt="2023-10-24T04:52:12.399" v="1665" actId="164"/>
          <ac:spMkLst>
            <pc:docMk/>
            <pc:sldMk cId="296353250" sldId="263"/>
            <ac:spMk id="12" creationId="{708525AA-5DAE-7613-3070-3EB4CDC42F4A}"/>
          </ac:spMkLst>
        </pc:spChg>
        <pc:spChg chg="mod topLvl">
          <ac:chgData name="Devkar, Vikas" userId="acbd15ec-55d1-4a76-83ac-3f1d82711ed5" providerId="ADAL" clId="{0F0500CC-7EE5-4B6D-A233-78C10B0575F1}" dt="2023-10-24T04:52:12.399" v="1665" actId="164"/>
          <ac:spMkLst>
            <pc:docMk/>
            <pc:sldMk cId="296353250" sldId="263"/>
            <ac:spMk id="13" creationId="{2650E76B-BDEA-31AF-5D5D-D37A5C7D12EC}"/>
          </ac:spMkLst>
        </pc:spChg>
        <pc:spChg chg="mod topLvl">
          <ac:chgData name="Devkar, Vikas" userId="acbd15ec-55d1-4a76-83ac-3f1d82711ed5" providerId="ADAL" clId="{0F0500CC-7EE5-4B6D-A233-78C10B0575F1}" dt="2023-10-24T04:52:12.399" v="1665" actId="164"/>
          <ac:spMkLst>
            <pc:docMk/>
            <pc:sldMk cId="296353250" sldId="263"/>
            <ac:spMk id="14" creationId="{BCDD57E0-C5F0-93F1-6DC6-A580FC2B54D0}"/>
          </ac:spMkLst>
        </pc:spChg>
        <pc:spChg chg="mod topLvl">
          <ac:chgData name="Devkar, Vikas" userId="acbd15ec-55d1-4a76-83ac-3f1d82711ed5" providerId="ADAL" clId="{0F0500CC-7EE5-4B6D-A233-78C10B0575F1}" dt="2023-10-24T04:52:12.399" v="1665" actId="164"/>
          <ac:spMkLst>
            <pc:docMk/>
            <pc:sldMk cId="296353250" sldId="263"/>
            <ac:spMk id="15" creationId="{86678EF4-9F04-7D25-FD2B-2892C025896C}"/>
          </ac:spMkLst>
        </pc:spChg>
        <pc:spChg chg="mod topLvl">
          <ac:chgData name="Devkar, Vikas" userId="acbd15ec-55d1-4a76-83ac-3f1d82711ed5" providerId="ADAL" clId="{0F0500CC-7EE5-4B6D-A233-78C10B0575F1}" dt="2023-10-24T04:52:12.399" v="1665" actId="164"/>
          <ac:spMkLst>
            <pc:docMk/>
            <pc:sldMk cId="296353250" sldId="263"/>
            <ac:spMk id="16" creationId="{197CB6E9-7682-F484-D601-4C863AC5A1F0}"/>
          </ac:spMkLst>
        </pc:spChg>
        <pc:spChg chg="mod topLvl">
          <ac:chgData name="Devkar, Vikas" userId="acbd15ec-55d1-4a76-83ac-3f1d82711ed5" providerId="ADAL" clId="{0F0500CC-7EE5-4B6D-A233-78C10B0575F1}" dt="2023-10-24T04:52:12.399" v="1665" actId="164"/>
          <ac:spMkLst>
            <pc:docMk/>
            <pc:sldMk cId="296353250" sldId="263"/>
            <ac:spMk id="18" creationId="{C68405F2-D5D0-6872-2FF9-FCF27EF61911}"/>
          </ac:spMkLst>
        </pc:spChg>
        <pc:spChg chg="add del mod">
          <ac:chgData name="Devkar, Vikas" userId="acbd15ec-55d1-4a76-83ac-3f1d82711ed5" providerId="ADAL" clId="{0F0500CC-7EE5-4B6D-A233-78C10B0575F1}" dt="2023-11-13T18:13:37.841" v="2185"/>
          <ac:spMkLst>
            <pc:docMk/>
            <pc:sldMk cId="296353250" sldId="263"/>
            <ac:spMk id="20" creationId="{EAB5CDBB-6FB0-2291-51AB-1408E3091E3E}"/>
          </ac:spMkLst>
        </pc:spChg>
        <pc:spChg chg="add mod">
          <ac:chgData name="Devkar, Vikas" userId="acbd15ec-55d1-4a76-83ac-3f1d82711ed5" providerId="ADAL" clId="{0F0500CC-7EE5-4B6D-A233-78C10B0575F1}" dt="2023-11-13T19:13:25.355" v="2655" actId="1076"/>
          <ac:spMkLst>
            <pc:docMk/>
            <pc:sldMk cId="296353250" sldId="263"/>
            <ac:spMk id="24" creationId="{BA02669C-0815-FD5D-6A23-DF1FFC7A0BB9}"/>
          </ac:spMkLst>
        </pc:spChg>
        <pc:grpChg chg="add del mod">
          <ac:chgData name="Devkar, Vikas" userId="acbd15ec-55d1-4a76-83ac-3f1d82711ed5" providerId="ADAL" clId="{0F0500CC-7EE5-4B6D-A233-78C10B0575F1}" dt="2023-10-24T04:47:13.806" v="1586" actId="165"/>
          <ac:grpSpMkLst>
            <pc:docMk/>
            <pc:sldMk cId="296353250" sldId="263"/>
            <ac:grpSpMk id="4" creationId="{2EE3AE1A-B97E-9FC4-ECC9-D160AA94BD73}"/>
          </ac:grpSpMkLst>
        </pc:grpChg>
        <pc:grpChg chg="add del mod">
          <ac:chgData name="Devkar, Vikas" userId="acbd15ec-55d1-4a76-83ac-3f1d82711ed5" providerId="ADAL" clId="{0F0500CC-7EE5-4B6D-A233-78C10B0575F1}" dt="2023-11-09T18:12:20.665" v="1768" actId="478"/>
          <ac:grpSpMkLst>
            <pc:docMk/>
            <pc:sldMk cId="296353250" sldId="263"/>
            <ac:grpSpMk id="19" creationId="{78DE2FF2-5C2D-D1FB-890C-D198E84E9753}"/>
          </ac:grpSpMkLst>
        </pc:grpChg>
        <pc:picChg chg="mod topLvl">
          <ac:chgData name="Devkar, Vikas" userId="acbd15ec-55d1-4a76-83ac-3f1d82711ed5" providerId="ADAL" clId="{0F0500CC-7EE5-4B6D-A233-78C10B0575F1}" dt="2023-10-24T04:52:12.399" v="1665" actId="164"/>
          <ac:picMkLst>
            <pc:docMk/>
            <pc:sldMk cId="296353250" sldId="263"/>
            <ac:picMk id="5" creationId="{731B0A36-389D-01C4-5362-F6FDB1881C56}"/>
          </ac:picMkLst>
        </pc:picChg>
        <pc:picChg chg="mod topLvl">
          <ac:chgData name="Devkar, Vikas" userId="acbd15ec-55d1-4a76-83ac-3f1d82711ed5" providerId="ADAL" clId="{0F0500CC-7EE5-4B6D-A233-78C10B0575F1}" dt="2023-10-24T04:52:12.399" v="1665" actId="164"/>
          <ac:picMkLst>
            <pc:docMk/>
            <pc:sldMk cId="296353250" sldId="263"/>
            <ac:picMk id="6" creationId="{14E78C44-5220-3D7F-2BDA-4A98BF0C7A19}"/>
          </ac:picMkLst>
        </pc:picChg>
        <pc:picChg chg="mod topLvl">
          <ac:chgData name="Devkar, Vikas" userId="acbd15ec-55d1-4a76-83ac-3f1d82711ed5" providerId="ADAL" clId="{0F0500CC-7EE5-4B6D-A233-78C10B0575F1}" dt="2023-10-24T04:52:12.399" v="1665" actId="164"/>
          <ac:picMkLst>
            <pc:docMk/>
            <pc:sldMk cId="296353250" sldId="263"/>
            <ac:picMk id="7" creationId="{54D6B91E-62AA-C0A6-16A3-EC4E1744D138}"/>
          </ac:picMkLst>
        </pc:picChg>
        <pc:picChg chg="mod topLvl">
          <ac:chgData name="Devkar, Vikas" userId="acbd15ec-55d1-4a76-83ac-3f1d82711ed5" providerId="ADAL" clId="{0F0500CC-7EE5-4B6D-A233-78C10B0575F1}" dt="2023-10-24T04:52:12.399" v="1665" actId="164"/>
          <ac:picMkLst>
            <pc:docMk/>
            <pc:sldMk cId="296353250" sldId="263"/>
            <ac:picMk id="8" creationId="{F65A30D6-3DCC-2348-A901-71D07B4FEBE8}"/>
          </ac:picMkLst>
        </pc:picChg>
        <pc:picChg chg="mod topLvl">
          <ac:chgData name="Devkar, Vikas" userId="acbd15ec-55d1-4a76-83ac-3f1d82711ed5" providerId="ADAL" clId="{0F0500CC-7EE5-4B6D-A233-78C10B0575F1}" dt="2023-10-24T04:52:12.399" v="1665" actId="164"/>
          <ac:picMkLst>
            <pc:docMk/>
            <pc:sldMk cId="296353250" sldId="263"/>
            <ac:picMk id="9" creationId="{3C9A4841-B377-6ED5-DAD7-8D5C3A0ED06A}"/>
          </ac:picMkLst>
        </pc:picChg>
        <pc:picChg chg="mod topLvl">
          <ac:chgData name="Devkar, Vikas" userId="acbd15ec-55d1-4a76-83ac-3f1d82711ed5" providerId="ADAL" clId="{0F0500CC-7EE5-4B6D-A233-78C10B0575F1}" dt="2023-10-24T04:52:12.399" v="1665" actId="164"/>
          <ac:picMkLst>
            <pc:docMk/>
            <pc:sldMk cId="296353250" sldId="263"/>
            <ac:picMk id="10" creationId="{C1C0E846-4668-441F-6A9E-C98C765B3649}"/>
          </ac:picMkLst>
        </pc:picChg>
        <pc:picChg chg="mod topLvl">
          <ac:chgData name="Devkar, Vikas" userId="acbd15ec-55d1-4a76-83ac-3f1d82711ed5" providerId="ADAL" clId="{0F0500CC-7EE5-4B6D-A233-78C10B0575F1}" dt="2023-10-24T04:52:12.399" v="1665" actId="164"/>
          <ac:picMkLst>
            <pc:docMk/>
            <pc:sldMk cId="296353250" sldId="263"/>
            <ac:picMk id="17" creationId="{90D9D8F3-280F-4EBD-1171-8D385E39DF14}"/>
          </ac:picMkLst>
        </pc:picChg>
        <pc:picChg chg="add del mod">
          <ac:chgData name="Devkar, Vikas" userId="acbd15ec-55d1-4a76-83ac-3f1d82711ed5" providerId="ADAL" clId="{0F0500CC-7EE5-4B6D-A233-78C10B0575F1}" dt="2023-11-13T19:52:44.070" v="2743" actId="478"/>
          <ac:picMkLst>
            <pc:docMk/>
            <pc:sldMk cId="296353250" sldId="263"/>
            <ac:picMk id="21" creationId="{ACFA6AF3-DA3C-4FA9-3A22-BB86FBF13C1C}"/>
          </ac:picMkLst>
        </pc:picChg>
        <pc:picChg chg="add del mod">
          <ac:chgData name="Devkar, Vikas" userId="acbd15ec-55d1-4a76-83ac-3f1d82711ed5" providerId="ADAL" clId="{0F0500CC-7EE5-4B6D-A233-78C10B0575F1}" dt="2023-11-09T19:46:29.930" v="1884"/>
          <ac:picMkLst>
            <pc:docMk/>
            <pc:sldMk cId="296353250" sldId="263"/>
            <ac:picMk id="23" creationId="{477C4CF8-F2D9-B01C-96C0-917F3E60EEEE}"/>
          </ac:picMkLst>
        </pc:picChg>
      </pc:sldChg>
      <pc:sldChg chg="addSp delSp modSp new add del mod ord">
        <pc:chgData name="Devkar, Vikas" userId="acbd15ec-55d1-4a76-83ac-3f1d82711ed5" providerId="ADAL" clId="{0F0500CC-7EE5-4B6D-A233-78C10B0575F1}" dt="2023-11-20T18:58:07.266" v="3704" actId="1076"/>
        <pc:sldMkLst>
          <pc:docMk/>
          <pc:sldMk cId="794843755" sldId="264"/>
        </pc:sldMkLst>
        <pc:spChg chg="del">
          <ac:chgData name="Devkar, Vikas" userId="acbd15ec-55d1-4a76-83ac-3f1d82711ed5" providerId="ADAL" clId="{0F0500CC-7EE5-4B6D-A233-78C10B0575F1}" dt="2023-11-13T18:12:17.987" v="2145" actId="478"/>
          <ac:spMkLst>
            <pc:docMk/>
            <pc:sldMk cId="794843755" sldId="264"/>
            <ac:spMk id="2" creationId="{EC2525FF-A959-C704-1023-310D995D5464}"/>
          </ac:spMkLst>
        </pc:spChg>
        <pc:spChg chg="del">
          <ac:chgData name="Devkar, Vikas" userId="acbd15ec-55d1-4a76-83ac-3f1d82711ed5" providerId="ADAL" clId="{0F0500CC-7EE5-4B6D-A233-78C10B0575F1}" dt="2023-11-13T18:12:17.987" v="2145" actId="478"/>
          <ac:spMkLst>
            <pc:docMk/>
            <pc:sldMk cId="794843755" sldId="264"/>
            <ac:spMk id="3" creationId="{40C8E9CD-D86D-A7AC-32DA-FE543BC44F95}"/>
          </ac:spMkLst>
        </pc:spChg>
        <pc:spChg chg="add mod">
          <ac:chgData name="Devkar, Vikas" userId="acbd15ec-55d1-4a76-83ac-3f1d82711ed5" providerId="ADAL" clId="{0F0500CC-7EE5-4B6D-A233-78C10B0575F1}" dt="2023-11-16T22:02:34.314" v="3389" actId="20577"/>
          <ac:spMkLst>
            <pc:docMk/>
            <pc:sldMk cId="794843755" sldId="264"/>
            <ac:spMk id="7" creationId="{61C45261-E6F1-BCD3-70E4-7B438A09B38F}"/>
          </ac:spMkLst>
        </pc:spChg>
        <pc:spChg chg="add del mod">
          <ac:chgData name="Devkar, Vikas" userId="acbd15ec-55d1-4a76-83ac-3f1d82711ed5" providerId="ADAL" clId="{0F0500CC-7EE5-4B6D-A233-78C10B0575F1}" dt="2023-11-16T21:59:20.779" v="3375" actId="478"/>
          <ac:spMkLst>
            <pc:docMk/>
            <pc:sldMk cId="794843755" sldId="264"/>
            <ac:spMk id="8" creationId="{C5B6BD01-74C6-7408-70CE-4B3CE5C607DE}"/>
          </ac:spMkLst>
        </pc:spChg>
        <pc:grpChg chg="mod">
          <ac:chgData name="Devkar, Vikas" userId="acbd15ec-55d1-4a76-83ac-3f1d82711ed5" providerId="ADAL" clId="{0F0500CC-7EE5-4B6D-A233-78C10B0575F1}" dt="2023-11-20T18:58:07.266" v="3704" actId="1076"/>
          <ac:grpSpMkLst>
            <pc:docMk/>
            <pc:sldMk cId="794843755" sldId="264"/>
            <ac:grpSpMk id="18" creationId="{EDB99B2A-34CA-9256-80DC-95B9C70BF965}"/>
          </ac:grpSpMkLst>
        </pc:grpChg>
        <pc:picChg chg="mod">
          <ac:chgData name="Devkar, Vikas" userId="acbd15ec-55d1-4a76-83ac-3f1d82711ed5" providerId="ADAL" clId="{0F0500CC-7EE5-4B6D-A233-78C10B0575F1}" dt="2023-11-16T22:05:11.338" v="3391" actId="1076"/>
          <ac:picMkLst>
            <pc:docMk/>
            <pc:sldMk cId="794843755" sldId="264"/>
            <ac:picMk id="3" creationId="{07755697-DC8E-4A18-1945-E47E8FBBC2F4}"/>
          </ac:picMkLst>
        </pc:picChg>
        <pc:picChg chg="add del mod">
          <ac:chgData name="Devkar, Vikas" userId="acbd15ec-55d1-4a76-83ac-3f1d82711ed5" providerId="ADAL" clId="{0F0500CC-7EE5-4B6D-A233-78C10B0575F1}" dt="2023-11-13T18:58:53.520" v="2511" actId="478"/>
          <ac:picMkLst>
            <pc:docMk/>
            <pc:sldMk cId="794843755" sldId="264"/>
            <ac:picMk id="5" creationId="{6947D496-096E-892F-AEF4-05F2D25A2A83}"/>
          </ac:picMkLst>
        </pc:picChg>
        <pc:picChg chg="add mod">
          <ac:chgData name="Devkar, Vikas" userId="acbd15ec-55d1-4a76-83ac-3f1d82711ed5" providerId="ADAL" clId="{0F0500CC-7EE5-4B6D-A233-78C10B0575F1}" dt="2023-11-15T22:50:44.356" v="3271" actId="1076"/>
          <ac:picMkLst>
            <pc:docMk/>
            <pc:sldMk cId="794843755" sldId="264"/>
            <ac:picMk id="6" creationId="{383E3486-33E6-E294-000A-03F215F6D0BE}"/>
          </ac:picMkLst>
        </pc:picChg>
      </pc:sldChg>
      <pc:sldChg chg="addSp delSp modSp new add del mod">
        <pc:chgData name="Devkar, Vikas" userId="acbd15ec-55d1-4a76-83ac-3f1d82711ed5" providerId="ADAL" clId="{0F0500CC-7EE5-4B6D-A233-78C10B0575F1}" dt="2023-11-17T22:14:42.579" v="3697" actId="1076"/>
        <pc:sldMkLst>
          <pc:docMk/>
          <pc:sldMk cId="1845444862" sldId="265"/>
        </pc:sldMkLst>
        <pc:spChg chg="del">
          <ac:chgData name="Devkar, Vikas" userId="acbd15ec-55d1-4a76-83ac-3f1d82711ed5" providerId="ADAL" clId="{0F0500CC-7EE5-4B6D-A233-78C10B0575F1}" dt="2023-11-13T18:15:25.641" v="2190" actId="478"/>
          <ac:spMkLst>
            <pc:docMk/>
            <pc:sldMk cId="1845444862" sldId="265"/>
            <ac:spMk id="2" creationId="{4B8A1D9E-03F7-E1A0-B559-F590BE1DC069}"/>
          </ac:spMkLst>
        </pc:spChg>
        <pc:spChg chg="del">
          <ac:chgData name="Devkar, Vikas" userId="acbd15ec-55d1-4a76-83ac-3f1d82711ed5" providerId="ADAL" clId="{0F0500CC-7EE5-4B6D-A233-78C10B0575F1}" dt="2023-11-13T18:15:25.641" v="2190" actId="478"/>
          <ac:spMkLst>
            <pc:docMk/>
            <pc:sldMk cId="1845444862" sldId="265"/>
            <ac:spMk id="3" creationId="{B2BA7039-74A2-C538-D07C-89C872808CD7}"/>
          </ac:spMkLst>
        </pc:spChg>
        <pc:spChg chg="add mod">
          <ac:chgData name="Devkar, Vikas" userId="acbd15ec-55d1-4a76-83ac-3f1d82711ed5" providerId="ADAL" clId="{0F0500CC-7EE5-4B6D-A233-78C10B0575F1}" dt="2023-11-13T19:53:27.660" v="2752" actId="1076"/>
          <ac:spMkLst>
            <pc:docMk/>
            <pc:sldMk cId="1845444862" sldId="265"/>
            <ac:spMk id="4" creationId="{47E1C263-20BF-3010-7C86-6DDDAB808C91}"/>
          </ac:spMkLst>
        </pc:spChg>
        <pc:spChg chg="add mod">
          <ac:chgData name="Devkar, Vikas" userId="acbd15ec-55d1-4a76-83ac-3f1d82711ed5" providerId="ADAL" clId="{0F0500CC-7EE5-4B6D-A233-78C10B0575F1}" dt="2023-11-13T22:33:12.909" v="3030" actId="1076"/>
          <ac:spMkLst>
            <pc:docMk/>
            <pc:sldMk cId="1845444862" sldId="265"/>
            <ac:spMk id="10" creationId="{E3A8E084-561E-3CC7-26EA-CE7AB3B3808C}"/>
          </ac:spMkLst>
        </pc:spChg>
        <pc:spChg chg="add mod">
          <ac:chgData name="Devkar, Vikas" userId="acbd15ec-55d1-4a76-83ac-3f1d82711ed5" providerId="ADAL" clId="{0F0500CC-7EE5-4B6D-A233-78C10B0575F1}" dt="2023-11-13T19:26:24.274" v="2741" actId="1076"/>
          <ac:spMkLst>
            <pc:docMk/>
            <pc:sldMk cId="1845444862" sldId="265"/>
            <ac:spMk id="12" creationId="{54C6866A-4D9A-CF72-6520-DF457DD15155}"/>
          </ac:spMkLst>
        </pc:spChg>
        <pc:picChg chg="add mod">
          <ac:chgData name="Devkar, Vikas" userId="acbd15ec-55d1-4a76-83ac-3f1d82711ed5" providerId="ADAL" clId="{0F0500CC-7EE5-4B6D-A233-78C10B0575F1}" dt="2023-11-17T22:14:42.579" v="3697" actId="1076"/>
          <ac:picMkLst>
            <pc:docMk/>
            <pc:sldMk cId="1845444862" sldId="265"/>
            <ac:picMk id="6" creationId="{8918A5F2-2F5A-933D-0122-EE33CC2DE2E0}"/>
          </ac:picMkLst>
        </pc:picChg>
        <pc:picChg chg="add mod">
          <ac:chgData name="Devkar, Vikas" userId="acbd15ec-55d1-4a76-83ac-3f1d82711ed5" providerId="ADAL" clId="{0F0500CC-7EE5-4B6D-A233-78C10B0575F1}" dt="2023-11-17T22:14:39.717" v="3696" actId="1076"/>
          <ac:picMkLst>
            <pc:docMk/>
            <pc:sldMk cId="1845444862" sldId="265"/>
            <ac:picMk id="8" creationId="{50916439-AA5B-9CE4-DD0A-76378ADBB3D3}"/>
          </ac:picMkLst>
        </pc:picChg>
      </pc:sldChg>
      <pc:sldChg chg="addSp delSp modSp new mod">
        <pc:chgData name="Devkar, Vikas" userId="acbd15ec-55d1-4a76-83ac-3f1d82711ed5" providerId="ADAL" clId="{0F0500CC-7EE5-4B6D-A233-78C10B0575F1}" dt="2023-11-13T22:33:53.197" v="3037" actId="1076"/>
        <pc:sldMkLst>
          <pc:docMk/>
          <pc:sldMk cId="417503466" sldId="266"/>
        </pc:sldMkLst>
        <pc:spChg chg="del">
          <ac:chgData name="Devkar, Vikas" userId="acbd15ec-55d1-4a76-83ac-3f1d82711ed5" providerId="ADAL" clId="{0F0500CC-7EE5-4B6D-A233-78C10B0575F1}" dt="2023-11-13T18:44:41.678" v="2307" actId="478"/>
          <ac:spMkLst>
            <pc:docMk/>
            <pc:sldMk cId="417503466" sldId="266"/>
            <ac:spMk id="2" creationId="{761E6286-9FAC-E67D-9A42-271D0E22402B}"/>
          </ac:spMkLst>
        </pc:spChg>
        <pc:spChg chg="del">
          <ac:chgData name="Devkar, Vikas" userId="acbd15ec-55d1-4a76-83ac-3f1d82711ed5" providerId="ADAL" clId="{0F0500CC-7EE5-4B6D-A233-78C10B0575F1}" dt="2023-11-13T18:44:41.678" v="2307" actId="478"/>
          <ac:spMkLst>
            <pc:docMk/>
            <pc:sldMk cId="417503466" sldId="266"/>
            <ac:spMk id="3" creationId="{737DA130-3124-A842-3214-BB60F55D59D0}"/>
          </ac:spMkLst>
        </pc:spChg>
        <pc:spChg chg="add mod">
          <ac:chgData name="Devkar, Vikas" userId="acbd15ec-55d1-4a76-83ac-3f1d82711ed5" providerId="ADAL" clId="{0F0500CC-7EE5-4B6D-A233-78C10B0575F1}" dt="2023-11-13T22:31:37.680" v="3024" actId="1076"/>
          <ac:spMkLst>
            <pc:docMk/>
            <pc:sldMk cId="417503466" sldId="266"/>
            <ac:spMk id="4" creationId="{F1480AE0-CD30-03E5-6124-496AC4D0B0E4}"/>
          </ac:spMkLst>
        </pc:spChg>
        <pc:spChg chg="add del mod">
          <ac:chgData name="Devkar, Vikas" userId="acbd15ec-55d1-4a76-83ac-3f1d82711ed5" providerId="ADAL" clId="{0F0500CC-7EE5-4B6D-A233-78C10B0575F1}" dt="2023-11-13T22:33:43.123" v="3035" actId="1076"/>
          <ac:spMkLst>
            <pc:docMk/>
            <pc:sldMk cId="417503466" sldId="266"/>
            <ac:spMk id="8" creationId="{D36503D7-132C-39CD-53DB-B3BB8DCA3639}"/>
          </ac:spMkLst>
        </pc:spChg>
        <pc:spChg chg="add del mod">
          <ac:chgData name="Devkar, Vikas" userId="acbd15ec-55d1-4a76-83ac-3f1d82711ed5" providerId="ADAL" clId="{0F0500CC-7EE5-4B6D-A233-78C10B0575F1}" dt="2023-11-13T22:33:53.197" v="3037" actId="1076"/>
          <ac:spMkLst>
            <pc:docMk/>
            <pc:sldMk cId="417503466" sldId="266"/>
            <ac:spMk id="9" creationId="{E4FCE9ED-458C-89A0-6A93-F0531AFB0573}"/>
          </ac:spMkLst>
        </pc:spChg>
        <pc:picChg chg="add del mod modCrop">
          <ac:chgData name="Devkar, Vikas" userId="acbd15ec-55d1-4a76-83ac-3f1d82711ed5" providerId="ADAL" clId="{0F0500CC-7EE5-4B6D-A233-78C10B0575F1}" dt="2023-11-13T22:33:35.269" v="3034" actId="1076"/>
          <ac:picMkLst>
            <pc:docMk/>
            <pc:sldMk cId="417503466" sldId="266"/>
            <ac:picMk id="6" creationId="{3F801622-1A5B-9E90-6B09-EBE70D3390BA}"/>
          </ac:picMkLst>
        </pc:picChg>
        <pc:picChg chg="add del mod modCrop">
          <ac:chgData name="Devkar, Vikas" userId="acbd15ec-55d1-4a76-83ac-3f1d82711ed5" providerId="ADAL" clId="{0F0500CC-7EE5-4B6D-A233-78C10B0575F1}" dt="2023-11-13T22:33:48.021" v="3036" actId="1076"/>
          <ac:picMkLst>
            <pc:docMk/>
            <pc:sldMk cId="417503466" sldId="266"/>
            <ac:picMk id="11" creationId="{0B365F18-644F-B994-95E9-E7CC3C848636}"/>
          </ac:picMkLst>
        </pc:picChg>
      </pc:sldChg>
      <pc:sldChg chg="addSp delSp modSp new mod">
        <pc:chgData name="Devkar, Vikas" userId="acbd15ec-55d1-4a76-83ac-3f1d82711ed5" providerId="ADAL" clId="{0F0500CC-7EE5-4B6D-A233-78C10B0575F1}" dt="2023-11-13T19:53:06.290" v="2747" actId="20577"/>
        <pc:sldMkLst>
          <pc:docMk/>
          <pc:sldMk cId="1922289499" sldId="267"/>
        </pc:sldMkLst>
        <pc:spChg chg="del">
          <ac:chgData name="Devkar, Vikas" userId="acbd15ec-55d1-4a76-83ac-3f1d82711ed5" providerId="ADAL" clId="{0F0500CC-7EE5-4B6D-A233-78C10B0575F1}" dt="2023-11-13T18:50:18.096" v="2380" actId="478"/>
          <ac:spMkLst>
            <pc:docMk/>
            <pc:sldMk cId="1922289499" sldId="267"/>
            <ac:spMk id="2" creationId="{C9386A07-2445-616C-3B9A-5E47C5222AF4}"/>
          </ac:spMkLst>
        </pc:spChg>
        <pc:spChg chg="del mod">
          <ac:chgData name="Devkar, Vikas" userId="acbd15ec-55d1-4a76-83ac-3f1d82711ed5" providerId="ADAL" clId="{0F0500CC-7EE5-4B6D-A233-78C10B0575F1}" dt="2023-11-13T18:50:18.096" v="2380" actId="478"/>
          <ac:spMkLst>
            <pc:docMk/>
            <pc:sldMk cId="1922289499" sldId="267"/>
            <ac:spMk id="3" creationId="{C1C1C5AE-1812-D149-1277-92A5D54C31D7}"/>
          </ac:spMkLst>
        </pc:spChg>
        <pc:spChg chg="add mod">
          <ac:chgData name="Devkar, Vikas" userId="acbd15ec-55d1-4a76-83ac-3f1d82711ed5" providerId="ADAL" clId="{0F0500CC-7EE5-4B6D-A233-78C10B0575F1}" dt="2023-11-13T19:53:06.290" v="2747" actId="20577"/>
          <ac:spMkLst>
            <pc:docMk/>
            <pc:sldMk cId="1922289499" sldId="267"/>
            <ac:spMk id="8" creationId="{A373B488-B0CF-2144-1213-219AA7C07B87}"/>
          </ac:spMkLst>
        </pc:spChg>
        <pc:spChg chg="add mod">
          <ac:chgData name="Devkar, Vikas" userId="acbd15ec-55d1-4a76-83ac-3f1d82711ed5" providerId="ADAL" clId="{0F0500CC-7EE5-4B6D-A233-78C10B0575F1}" dt="2023-11-13T18:57:00.632" v="2510" actId="403"/>
          <ac:spMkLst>
            <pc:docMk/>
            <pc:sldMk cId="1922289499" sldId="267"/>
            <ac:spMk id="10" creationId="{B5AED450-D013-032F-CB22-1E452FB97610}"/>
          </ac:spMkLst>
        </pc:spChg>
        <pc:spChg chg="add mod">
          <ac:chgData name="Devkar, Vikas" userId="acbd15ec-55d1-4a76-83ac-3f1d82711ed5" providerId="ADAL" clId="{0F0500CC-7EE5-4B6D-A233-78C10B0575F1}" dt="2023-11-13T18:56:57.589" v="2509" actId="403"/>
          <ac:spMkLst>
            <pc:docMk/>
            <pc:sldMk cId="1922289499" sldId="267"/>
            <ac:spMk id="11" creationId="{50C299BE-1C3F-2925-72B9-F8948525BD30}"/>
          </ac:spMkLst>
        </pc:spChg>
        <pc:picChg chg="add mod">
          <ac:chgData name="Devkar, Vikas" userId="acbd15ec-55d1-4a76-83ac-3f1d82711ed5" providerId="ADAL" clId="{0F0500CC-7EE5-4B6D-A233-78C10B0575F1}" dt="2023-11-13T18:53:28.741" v="2449" actId="1076"/>
          <ac:picMkLst>
            <pc:docMk/>
            <pc:sldMk cId="1922289499" sldId="267"/>
            <ac:picMk id="5" creationId="{AA86745D-3D68-E449-B450-B838D6F49851}"/>
          </ac:picMkLst>
        </pc:picChg>
        <pc:picChg chg="add mod">
          <ac:chgData name="Devkar, Vikas" userId="acbd15ec-55d1-4a76-83ac-3f1d82711ed5" providerId="ADAL" clId="{0F0500CC-7EE5-4B6D-A233-78C10B0575F1}" dt="2023-11-13T18:54:14.739" v="2457" actId="1076"/>
          <ac:picMkLst>
            <pc:docMk/>
            <pc:sldMk cId="1922289499" sldId="267"/>
            <ac:picMk id="7" creationId="{60CF31E5-4C3A-F7A3-4BCF-F8236B1D265F}"/>
          </ac:picMkLst>
        </pc:picChg>
      </pc:sldChg>
      <pc:sldChg chg="addSp delSp modSp new mod">
        <pc:chgData name="Devkar, Vikas" userId="acbd15ec-55d1-4a76-83ac-3f1d82711ed5" providerId="ADAL" clId="{0F0500CC-7EE5-4B6D-A233-78C10B0575F1}" dt="2023-11-22T18:50:51.486" v="3819" actId="1076"/>
        <pc:sldMkLst>
          <pc:docMk/>
          <pc:sldMk cId="3436963830" sldId="268"/>
        </pc:sldMkLst>
        <pc:spChg chg="del">
          <ac:chgData name="Devkar, Vikas" userId="acbd15ec-55d1-4a76-83ac-3f1d82711ed5" providerId="ADAL" clId="{0F0500CC-7EE5-4B6D-A233-78C10B0575F1}" dt="2023-11-15T18:06:59.069" v="3043" actId="478"/>
          <ac:spMkLst>
            <pc:docMk/>
            <pc:sldMk cId="3436963830" sldId="268"/>
            <ac:spMk id="2" creationId="{402CD184-7A0E-0244-3640-097AE7D7E84A}"/>
          </ac:spMkLst>
        </pc:spChg>
        <pc:spChg chg="add mod">
          <ac:chgData name="Devkar, Vikas" userId="acbd15ec-55d1-4a76-83ac-3f1d82711ed5" providerId="ADAL" clId="{0F0500CC-7EE5-4B6D-A233-78C10B0575F1}" dt="2023-11-22T18:46:13.055" v="3755" actId="14100"/>
          <ac:spMkLst>
            <pc:docMk/>
            <pc:sldMk cId="3436963830" sldId="268"/>
            <ac:spMk id="2" creationId="{768ADAE3-6334-88B4-1D66-D57F1415B718}"/>
          </ac:spMkLst>
        </pc:spChg>
        <pc:spChg chg="del">
          <ac:chgData name="Devkar, Vikas" userId="acbd15ec-55d1-4a76-83ac-3f1d82711ed5" providerId="ADAL" clId="{0F0500CC-7EE5-4B6D-A233-78C10B0575F1}" dt="2023-11-15T18:06:59.069" v="3043" actId="478"/>
          <ac:spMkLst>
            <pc:docMk/>
            <pc:sldMk cId="3436963830" sldId="268"/>
            <ac:spMk id="3" creationId="{E771D3B8-B889-EE52-4926-AFAE666BB41A}"/>
          </ac:spMkLst>
        </pc:spChg>
        <pc:spChg chg="add mod">
          <ac:chgData name="Devkar, Vikas" userId="acbd15ec-55d1-4a76-83ac-3f1d82711ed5" providerId="ADAL" clId="{0F0500CC-7EE5-4B6D-A233-78C10B0575F1}" dt="2023-11-22T18:45:50.779" v="3749" actId="114"/>
          <ac:spMkLst>
            <pc:docMk/>
            <pc:sldMk cId="3436963830" sldId="268"/>
            <ac:spMk id="4" creationId="{E9ABEC9B-7711-5DEE-1919-B3C572856D23}"/>
          </ac:spMkLst>
        </pc:spChg>
        <pc:spChg chg="add mod">
          <ac:chgData name="Devkar, Vikas" userId="acbd15ec-55d1-4a76-83ac-3f1d82711ed5" providerId="ADAL" clId="{0F0500CC-7EE5-4B6D-A233-78C10B0575F1}" dt="2023-11-17T00:49:17.888" v="3401" actId="20577"/>
          <ac:spMkLst>
            <pc:docMk/>
            <pc:sldMk cId="3436963830" sldId="268"/>
            <ac:spMk id="5" creationId="{56BF8C7B-471C-6ED5-6ADF-6B81D4C729FB}"/>
          </ac:spMkLst>
        </pc:spChg>
        <pc:spChg chg="add mod">
          <ac:chgData name="Devkar, Vikas" userId="acbd15ec-55d1-4a76-83ac-3f1d82711ed5" providerId="ADAL" clId="{0F0500CC-7EE5-4B6D-A233-78C10B0575F1}" dt="2023-11-22T18:49:14.820" v="3808" actId="1076"/>
          <ac:spMkLst>
            <pc:docMk/>
            <pc:sldMk cId="3436963830" sldId="268"/>
            <ac:spMk id="5" creationId="{E53AD560-8EB7-5789-360B-EDCE368FE1F2}"/>
          </ac:spMkLst>
        </pc:spChg>
        <pc:spChg chg="add mod">
          <ac:chgData name="Devkar, Vikas" userId="acbd15ec-55d1-4a76-83ac-3f1d82711ed5" providerId="ADAL" clId="{0F0500CC-7EE5-4B6D-A233-78C10B0575F1}" dt="2023-11-22T18:49:06.448" v="3806" actId="1076"/>
          <ac:spMkLst>
            <pc:docMk/>
            <pc:sldMk cId="3436963830" sldId="268"/>
            <ac:spMk id="6" creationId="{1B8E7A32-B138-666A-04C8-EE82080DB2FF}"/>
          </ac:spMkLst>
        </pc:spChg>
        <pc:spChg chg="add mod">
          <ac:chgData name="Devkar, Vikas" userId="acbd15ec-55d1-4a76-83ac-3f1d82711ed5" providerId="ADAL" clId="{0F0500CC-7EE5-4B6D-A233-78C10B0575F1}" dt="2023-11-17T00:49:16.224" v="3400" actId="20577"/>
          <ac:spMkLst>
            <pc:docMk/>
            <pc:sldMk cId="3436963830" sldId="268"/>
            <ac:spMk id="6" creationId="{B8AC7FCE-F5D6-5677-0D99-B5E94C775016}"/>
          </ac:spMkLst>
        </pc:spChg>
        <pc:spChg chg="add mod">
          <ac:chgData name="Devkar, Vikas" userId="acbd15ec-55d1-4a76-83ac-3f1d82711ed5" providerId="ADAL" clId="{0F0500CC-7EE5-4B6D-A233-78C10B0575F1}" dt="2023-11-22T18:49:11.252" v="3807" actId="1076"/>
          <ac:spMkLst>
            <pc:docMk/>
            <pc:sldMk cId="3436963830" sldId="268"/>
            <ac:spMk id="7" creationId="{687D80C2-7157-82E2-4F15-E738AACCD512}"/>
          </ac:spMkLst>
        </pc:spChg>
        <pc:spChg chg="add mod">
          <ac:chgData name="Devkar, Vikas" userId="acbd15ec-55d1-4a76-83ac-3f1d82711ed5" providerId="ADAL" clId="{0F0500CC-7EE5-4B6D-A233-78C10B0575F1}" dt="2023-11-22T18:50:51.486" v="3819" actId="1076"/>
          <ac:spMkLst>
            <pc:docMk/>
            <pc:sldMk cId="3436963830" sldId="268"/>
            <ac:spMk id="10" creationId="{9D81AC34-D8F7-CFC7-3D87-3384CBD7E1A7}"/>
          </ac:spMkLst>
        </pc:spChg>
        <pc:spChg chg="add mod">
          <ac:chgData name="Devkar, Vikas" userId="acbd15ec-55d1-4a76-83ac-3f1d82711ed5" providerId="ADAL" clId="{0F0500CC-7EE5-4B6D-A233-78C10B0575F1}" dt="2023-11-22T18:50:37.436" v="3814" actId="1076"/>
          <ac:spMkLst>
            <pc:docMk/>
            <pc:sldMk cId="3436963830" sldId="268"/>
            <ac:spMk id="12" creationId="{569A5EF3-DBA6-A05B-D6FC-EF58E81281AE}"/>
          </ac:spMkLst>
        </pc:spChg>
        <pc:picChg chg="del mod">
          <ac:chgData name="Devkar, Vikas" userId="acbd15ec-55d1-4a76-83ac-3f1d82711ed5" providerId="ADAL" clId="{0F0500CC-7EE5-4B6D-A233-78C10B0575F1}" dt="2023-11-22T18:45:53.941" v="3750" actId="478"/>
          <ac:picMkLst>
            <pc:docMk/>
            <pc:sldMk cId="3436963830" sldId="268"/>
            <ac:picMk id="3" creationId="{4107DE74-D307-3C34-2F06-B67A675AB813}"/>
          </ac:picMkLst>
        </pc:picChg>
        <pc:picChg chg="del mod">
          <ac:chgData name="Devkar, Vikas" userId="acbd15ec-55d1-4a76-83ac-3f1d82711ed5" providerId="ADAL" clId="{0F0500CC-7EE5-4B6D-A233-78C10B0575F1}" dt="2023-11-22T18:45:55.607" v="3751" actId="478"/>
          <ac:picMkLst>
            <pc:docMk/>
            <pc:sldMk cId="3436963830" sldId="268"/>
            <ac:picMk id="8" creationId="{2C15A82C-C92A-35A5-1A80-BC7D1C3488CA}"/>
          </ac:picMkLst>
        </pc:picChg>
      </pc:sldChg>
      <pc:sldChg chg="addSp delSp modSp new mod">
        <pc:chgData name="Devkar, Vikas" userId="acbd15ec-55d1-4a76-83ac-3f1d82711ed5" providerId="ADAL" clId="{0F0500CC-7EE5-4B6D-A233-78C10B0575F1}" dt="2023-11-15T23:03:18.957" v="3292" actId="1076"/>
        <pc:sldMkLst>
          <pc:docMk/>
          <pc:sldMk cId="547294471" sldId="269"/>
        </pc:sldMkLst>
        <pc:spChg chg="del">
          <ac:chgData name="Devkar, Vikas" userId="acbd15ec-55d1-4a76-83ac-3f1d82711ed5" providerId="ADAL" clId="{0F0500CC-7EE5-4B6D-A233-78C10B0575F1}" dt="2023-11-15T22:48:33.791" v="3262" actId="478"/>
          <ac:spMkLst>
            <pc:docMk/>
            <pc:sldMk cId="547294471" sldId="269"/>
            <ac:spMk id="2" creationId="{7815143E-3AD3-EE4C-215D-72EA3177B96E}"/>
          </ac:spMkLst>
        </pc:spChg>
        <pc:spChg chg="del">
          <ac:chgData name="Devkar, Vikas" userId="acbd15ec-55d1-4a76-83ac-3f1d82711ed5" providerId="ADAL" clId="{0F0500CC-7EE5-4B6D-A233-78C10B0575F1}" dt="2023-11-15T22:48:33.791" v="3262" actId="478"/>
          <ac:spMkLst>
            <pc:docMk/>
            <pc:sldMk cId="547294471" sldId="269"/>
            <ac:spMk id="3" creationId="{3933AE60-E525-5B90-1079-D355A414215F}"/>
          </ac:spMkLst>
        </pc:spChg>
        <pc:spChg chg="add mod">
          <ac:chgData name="Devkar, Vikas" userId="acbd15ec-55d1-4a76-83ac-3f1d82711ed5" providerId="ADAL" clId="{0F0500CC-7EE5-4B6D-A233-78C10B0575F1}" dt="2023-11-15T23:03:18.957" v="3292" actId="1076"/>
          <ac:spMkLst>
            <pc:docMk/>
            <pc:sldMk cId="547294471" sldId="269"/>
            <ac:spMk id="4" creationId="{16ED1497-D8AA-76D5-50DB-C7B2A621953F}"/>
          </ac:spMkLst>
        </pc:spChg>
      </pc:sldChg>
      <pc:sldChg chg="new del">
        <pc:chgData name="Devkar, Vikas" userId="acbd15ec-55d1-4a76-83ac-3f1d82711ed5" providerId="ADAL" clId="{0F0500CC-7EE5-4B6D-A233-78C10B0575F1}" dt="2023-11-15T22:52:04.121" v="3281" actId="47"/>
        <pc:sldMkLst>
          <pc:docMk/>
          <pc:sldMk cId="1826125044" sldId="270"/>
        </pc:sldMkLst>
      </pc:sldChg>
      <pc:sldChg chg="addSp delSp modSp new mod">
        <pc:chgData name="Devkar, Vikas" userId="acbd15ec-55d1-4a76-83ac-3f1d82711ed5" providerId="ADAL" clId="{0F0500CC-7EE5-4B6D-A233-78C10B0575F1}" dt="2023-11-19T02:03:58.715" v="3699" actId="1076"/>
        <pc:sldMkLst>
          <pc:docMk/>
          <pc:sldMk cId="941570768" sldId="271"/>
        </pc:sldMkLst>
        <pc:spChg chg="del">
          <ac:chgData name="Devkar, Vikas" userId="acbd15ec-55d1-4a76-83ac-3f1d82711ed5" providerId="ADAL" clId="{0F0500CC-7EE5-4B6D-A233-78C10B0575F1}" dt="2023-11-15T23:02:22.633" v="3284" actId="478"/>
          <ac:spMkLst>
            <pc:docMk/>
            <pc:sldMk cId="941570768" sldId="271"/>
            <ac:spMk id="2" creationId="{C5ACD18D-3C07-8138-69BB-82375B1EA8CE}"/>
          </ac:spMkLst>
        </pc:spChg>
        <pc:spChg chg="del">
          <ac:chgData name="Devkar, Vikas" userId="acbd15ec-55d1-4a76-83ac-3f1d82711ed5" providerId="ADAL" clId="{0F0500CC-7EE5-4B6D-A233-78C10B0575F1}" dt="2023-11-15T23:02:21.716" v="3283" actId="478"/>
          <ac:spMkLst>
            <pc:docMk/>
            <pc:sldMk cId="941570768" sldId="271"/>
            <ac:spMk id="3" creationId="{02AE5584-CB04-0C9F-D72F-B9EA4F797060}"/>
          </ac:spMkLst>
        </pc:spChg>
        <pc:spChg chg="add mod">
          <ac:chgData name="Devkar, Vikas" userId="acbd15ec-55d1-4a76-83ac-3f1d82711ed5" providerId="ADAL" clId="{0F0500CC-7EE5-4B6D-A233-78C10B0575F1}" dt="2023-11-17T17:03:27.410" v="3498" actId="1076"/>
          <ac:spMkLst>
            <pc:docMk/>
            <pc:sldMk cId="941570768" sldId="271"/>
            <ac:spMk id="5" creationId="{E880AF6A-641C-F67F-BA37-ED8AA5C0C046}"/>
          </ac:spMkLst>
        </pc:spChg>
        <pc:spChg chg="add del mod">
          <ac:chgData name="Devkar, Vikas" userId="acbd15ec-55d1-4a76-83ac-3f1d82711ed5" providerId="ADAL" clId="{0F0500CC-7EE5-4B6D-A233-78C10B0575F1}" dt="2023-11-15T23:06:21.187" v="3347"/>
          <ac:spMkLst>
            <pc:docMk/>
            <pc:sldMk cId="941570768" sldId="271"/>
            <ac:spMk id="6" creationId="{79678A23-8302-35DB-06E7-1B48A580CE76}"/>
          </ac:spMkLst>
        </pc:spChg>
        <pc:spChg chg="add mod">
          <ac:chgData name="Devkar, Vikas" userId="acbd15ec-55d1-4a76-83ac-3f1d82711ed5" providerId="ADAL" clId="{0F0500CC-7EE5-4B6D-A233-78C10B0575F1}" dt="2023-11-17T16:59:13.561" v="3407" actId="1076"/>
          <ac:spMkLst>
            <pc:docMk/>
            <pc:sldMk cId="941570768" sldId="271"/>
            <ac:spMk id="9" creationId="{90EF4268-024E-FBBB-8A08-51E206243498}"/>
          </ac:spMkLst>
        </pc:spChg>
        <pc:spChg chg="add del mod">
          <ac:chgData name="Devkar, Vikas" userId="acbd15ec-55d1-4a76-83ac-3f1d82711ed5" providerId="ADAL" clId="{0F0500CC-7EE5-4B6D-A233-78C10B0575F1}" dt="2023-11-17T16:59:19.152" v="3410"/>
          <ac:spMkLst>
            <pc:docMk/>
            <pc:sldMk cId="941570768" sldId="271"/>
            <ac:spMk id="11" creationId="{BDA5FED0-9343-A2F6-FA17-A312FB4B4FE6}"/>
          </ac:spMkLst>
        </pc:spChg>
        <pc:spChg chg="add mod">
          <ac:chgData name="Devkar, Vikas" userId="acbd15ec-55d1-4a76-83ac-3f1d82711ed5" providerId="ADAL" clId="{0F0500CC-7EE5-4B6D-A233-78C10B0575F1}" dt="2023-11-17T16:59:33.377" v="3416" actId="1076"/>
          <ac:spMkLst>
            <pc:docMk/>
            <pc:sldMk cId="941570768" sldId="271"/>
            <ac:spMk id="12" creationId="{6C21EE5F-2525-C72F-E243-6F1E49878457}"/>
          </ac:spMkLst>
        </pc:spChg>
        <pc:spChg chg="add mod">
          <ac:chgData name="Devkar, Vikas" userId="acbd15ec-55d1-4a76-83ac-3f1d82711ed5" providerId="ADAL" clId="{0F0500CC-7EE5-4B6D-A233-78C10B0575F1}" dt="2023-11-17T17:02:57.963" v="3481" actId="1076"/>
          <ac:spMkLst>
            <pc:docMk/>
            <pc:sldMk cId="941570768" sldId="271"/>
            <ac:spMk id="13" creationId="{1151CE02-0023-5416-1CA0-844CE92D51EB}"/>
          </ac:spMkLst>
        </pc:spChg>
        <pc:spChg chg="add mod">
          <ac:chgData name="Devkar, Vikas" userId="acbd15ec-55d1-4a76-83ac-3f1d82711ed5" providerId="ADAL" clId="{0F0500CC-7EE5-4B6D-A233-78C10B0575F1}" dt="2023-11-19T02:03:58.715" v="3699" actId="1076"/>
          <ac:spMkLst>
            <pc:docMk/>
            <pc:sldMk cId="941570768" sldId="271"/>
            <ac:spMk id="14" creationId="{0B049BDC-8487-8CE9-798E-7F4339EDF1B2}"/>
          </ac:spMkLst>
        </pc:spChg>
        <pc:grpChg chg="add mod">
          <ac:chgData name="Devkar, Vikas" userId="acbd15ec-55d1-4a76-83ac-3f1d82711ed5" providerId="ADAL" clId="{0F0500CC-7EE5-4B6D-A233-78C10B0575F1}" dt="2023-11-17T17:03:03.296" v="3484" actId="1076"/>
          <ac:grpSpMkLst>
            <pc:docMk/>
            <pc:sldMk cId="941570768" sldId="271"/>
            <ac:grpSpMk id="10" creationId="{8583F6A4-9124-5271-0AAB-B5DA6B0A3B0A}"/>
          </ac:grpSpMkLst>
        </pc:grpChg>
        <pc:picChg chg="add mod modCrop">
          <ac:chgData name="Devkar, Vikas" userId="acbd15ec-55d1-4a76-83ac-3f1d82711ed5" providerId="ADAL" clId="{0F0500CC-7EE5-4B6D-A233-78C10B0575F1}" dt="2023-11-17T16:59:11.513" v="3406" actId="1076"/>
          <ac:picMkLst>
            <pc:docMk/>
            <pc:sldMk cId="941570768" sldId="271"/>
            <ac:picMk id="8" creationId="{F28E4698-B4B2-FBFD-F248-233EAC108335}"/>
          </ac:picMkLst>
        </pc:picChg>
      </pc:sldChg>
      <pc:sldChg chg="addSp delSp modSp new mod">
        <pc:chgData name="Devkar, Vikas" userId="acbd15ec-55d1-4a76-83ac-3f1d82711ed5" providerId="ADAL" clId="{0F0500CC-7EE5-4B6D-A233-78C10B0575F1}" dt="2023-11-17T17:05:55.897" v="3693" actId="403"/>
        <pc:sldMkLst>
          <pc:docMk/>
          <pc:sldMk cId="1828619697" sldId="272"/>
        </pc:sldMkLst>
        <pc:spChg chg="del">
          <ac:chgData name="Devkar, Vikas" userId="acbd15ec-55d1-4a76-83ac-3f1d82711ed5" providerId="ADAL" clId="{0F0500CC-7EE5-4B6D-A233-78C10B0575F1}" dt="2023-11-15T23:05:42.164" v="3342" actId="478"/>
          <ac:spMkLst>
            <pc:docMk/>
            <pc:sldMk cId="1828619697" sldId="272"/>
            <ac:spMk id="2" creationId="{80E84157-F5EA-F235-A7B2-C2EA166111AD}"/>
          </ac:spMkLst>
        </pc:spChg>
        <pc:spChg chg="del">
          <ac:chgData name="Devkar, Vikas" userId="acbd15ec-55d1-4a76-83ac-3f1d82711ed5" providerId="ADAL" clId="{0F0500CC-7EE5-4B6D-A233-78C10B0575F1}" dt="2023-11-15T23:05:42.164" v="3342" actId="478"/>
          <ac:spMkLst>
            <pc:docMk/>
            <pc:sldMk cId="1828619697" sldId="272"/>
            <ac:spMk id="3" creationId="{73E3B5DC-8457-398E-BE37-E1E0D28E9B87}"/>
          </ac:spMkLst>
        </pc:spChg>
        <pc:spChg chg="add mod">
          <ac:chgData name="Devkar, Vikas" userId="acbd15ec-55d1-4a76-83ac-3f1d82711ed5" providerId="ADAL" clId="{0F0500CC-7EE5-4B6D-A233-78C10B0575F1}" dt="2023-11-17T17:05:55.897" v="3693" actId="403"/>
          <ac:spMkLst>
            <pc:docMk/>
            <pc:sldMk cId="1828619697" sldId="272"/>
            <ac:spMk id="4" creationId="{991309F2-0CD3-820F-33C5-31AA05E4EA7E}"/>
          </ac:spMkLst>
        </pc:spChg>
      </pc:sldChg>
    </pc:docChg>
  </pc:docChgLst>
  <pc:docChgLst>
    <pc:chgData name="Dagostino, Leonidas" userId="d42e52ab-e44d-4c88-95a1-c18248a0edcf" providerId="ADAL" clId="{1C6C4CA9-C68C-40AF-ADFC-977E8AF6CEB6}"/>
    <pc:docChg chg="undo custSel modSld">
      <pc:chgData name="Dagostino, Leonidas" userId="d42e52ab-e44d-4c88-95a1-c18248a0edcf" providerId="ADAL" clId="{1C6C4CA9-C68C-40AF-ADFC-977E8AF6CEB6}" dt="2024-03-04T21:19:21.679" v="7" actId="1076"/>
      <pc:docMkLst>
        <pc:docMk/>
      </pc:docMkLst>
      <pc:sldChg chg="modSp mod">
        <pc:chgData name="Dagostino, Leonidas" userId="d42e52ab-e44d-4c88-95a1-c18248a0edcf" providerId="ADAL" clId="{1C6C4CA9-C68C-40AF-ADFC-977E8AF6CEB6}" dt="2024-03-04T21:19:21.679" v="7" actId="1076"/>
        <pc:sldMkLst>
          <pc:docMk/>
          <pc:sldMk cId="794843755" sldId="264"/>
        </pc:sldMkLst>
        <pc:spChg chg="mod">
          <ac:chgData name="Dagostino, Leonidas" userId="d42e52ab-e44d-4c88-95a1-c18248a0edcf" providerId="ADAL" clId="{1C6C4CA9-C68C-40AF-ADFC-977E8AF6CEB6}" dt="2024-03-04T21:18:57.859" v="5" actId="1076"/>
          <ac:spMkLst>
            <pc:docMk/>
            <pc:sldMk cId="794843755" sldId="264"/>
            <ac:spMk id="8" creationId="{D23A003D-B2E0-0CF2-CDBE-2C4F6D643B6D}"/>
          </ac:spMkLst>
        </pc:spChg>
        <pc:spChg chg="mod">
          <ac:chgData name="Dagostino, Leonidas" userId="d42e52ab-e44d-4c88-95a1-c18248a0edcf" providerId="ADAL" clId="{1C6C4CA9-C68C-40AF-ADFC-977E8AF6CEB6}" dt="2024-03-04T21:19:21.679" v="7" actId="1076"/>
          <ac:spMkLst>
            <pc:docMk/>
            <pc:sldMk cId="794843755" sldId="264"/>
            <ac:spMk id="9" creationId="{57F3A884-8AEB-07EE-192A-2B1D2FBE1D10}"/>
          </ac:spMkLst>
        </pc:spChg>
      </pc:sldChg>
    </pc:docChg>
  </pc:docChgLst>
  <pc:docChgLst>
    <pc:chgData name="Dagostino, Leonidas" userId="d42e52ab-e44d-4c88-95a1-c18248a0edcf" providerId="ADAL" clId="{676EA3E2-E41B-4868-8675-CDAFF31BE7BD}"/>
    <pc:docChg chg="custSel modSld sldOrd">
      <pc:chgData name="Dagostino, Leonidas" userId="d42e52ab-e44d-4c88-95a1-c18248a0edcf" providerId="ADAL" clId="{676EA3E2-E41B-4868-8675-CDAFF31BE7BD}" dt="2024-01-10T17:59:42.543" v="50" actId="1076"/>
      <pc:docMkLst>
        <pc:docMk/>
      </pc:docMkLst>
      <pc:sldChg chg="ord">
        <pc:chgData name="Dagostino, Leonidas" userId="d42e52ab-e44d-4c88-95a1-c18248a0edcf" providerId="ADAL" clId="{676EA3E2-E41B-4868-8675-CDAFF31BE7BD}" dt="2024-01-08T21:54:15.213" v="1"/>
        <pc:sldMkLst>
          <pc:docMk/>
          <pc:sldMk cId="1437810819" sldId="262"/>
        </pc:sldMkLst>
      </pc:sldChg>
      <pc:sldChg chg="addSp modSp mod">
        <pc:chgData name="Dagostino, Leonidas" userId="d42e52ab-e44d-4c88-95a1-c18248a0edcf" providerId="ADAL" clId="{676EA3E2-E41B-4868-8675-CDAFF31BE7BD}" dt="2024-01-08T21:54:55.820" v="6" actId="1076"/>
        <pc:sldMkLst>
          <pc:docMk/>
          <pc:sldMk cId="794843755" sldId="264"/>
        </pc:sldMkLst>
        <pc:grpChg chg="mod">
          <ac:chgData name="Dagostino, Leonidas" userId="d42e52ab-e44d-4c88-95a1-c18248a0edcf" providerId="ADAL" clId="{676EA3E2-E41B-4868-8675-CDAFF31BE7BD}" dt="2024-01-08T21:54:49.331" v="2" actId="1076"/>
          <ac:grpSpMkLst>
            <pc:docMk/>
            <pc:sldMk cId="794843755" sldId="264"/>
            <ac:grpSpMk id="18" creationId="{EDB99B2A-34CA-9256-80DC-95B9C70BF965}"/>
          </ac:grpSpMkLst>
        </pc:grpChg>
        <pc:picChg chg="add mod">
          <ac:chgData name="Dagostino, Leonidas" userId="d42e52ab-e44d-4c88-95a1-c18248a0edcf" providerId="ADAL" clId="{676EA3E2-E41B-4868-8675-CDAFF31BE7BD}" dt="2024-01-08T21:54:55.820" v="6" actId="1076"/>
          <ac:picMkLst>
            <pc:docMk/>
            <pc:sldMk cId="794843755" sldId="264"/>
            <ac:picMk id="2" creationId="{7C34630E-173E-7746-C548-3D3C58E2580A}"/>
          </ac:picMkLst>
        </pc:picChg>
      </pc:sldChg>
      <pc:sldChg chg="addSp delSp modSp mod">
        <pc:chgData name="Dagostino, Leonidas" userId="d42e52ab-e44d-4c88-95a1-c18248a0edcf" providerId="ADAL" clId="{676EA3E2-E41B-4868-8675-CDAFF31BE7BD}" dt="2024-01-10T17:59:42.543" v="50" actId="1076"/>
        <pc:sldMkLst>
          <pc:docMk/>
          <pc:sldMk cId="3436963830" sldId="268"/>
        </pc:sldMkLst>
        <pc:spChg chg="mod">
          <ac:chgData name="Dagostino, Leonidas" userId="d42e52ab-e44d-4c88-95a1-c18248a0edcf" providerId="ADAL" clId="{676EA3E2-E41B-4868-8675-CDAFF31BE7BD}" dt="2024-01-10T17:59:12.620" v="45" actId="1076"/>
          <ac:spMkLst>
            <pc:docMk/>
            <pc:sldMk cId="3436963830" sldId="268"/>
            <ac:spMk id="2" creationId="{768ADAE3-6334-88B4-1D66-D57F1415B718}"/>
          </ac:spMkLst>
        </pc:spChg>
        <pc:spChg chg="mod">
          <ac:chgData name="Dagostino, Leonidas" userId="d42e52ab-e44d-4c88-95a1-c18248a0edcf" providerId="ADAL" clId="{676EA3E2-E41B-4868-8675-CDAFF31BE7BD}" dt="2024-01-10T17:59:17.884" v="47" actId="1076"/>
          <ac:spMkLst>
            <pc:docMk/>
            <pc:sldMk cId="3436963830" sldId="268"/>
            <ac:spMk id="5" creationId="{E53AD560-8EB7-5789-360B-EDCE368FE1F2}"/>
          </ac:spMkLst>
        </pc:spChg>
        <pc:spChg chg="mod">
          <ac:chgData name="Dagostino, Leonidas" userId="d42e52ab-e44d-4c88-95a1-c18248a0edcf" providerId="ADAL" clId="{676EA3E2-E41B-4868-8675-CDAFF31BE7BD}" dt="2024-01-10T17:59:12.620" v="45" actId="1076"/>
          <ac:spMkLst>
            <pc:docMk/>
            <pc:sldMk cId="3436963830" sldId="268"/>
            <ac:spMk id="6" creationId="{1B8E7A32-B138-666A-04C8-EE82080DB2FF}"/>
          </ac:spMkLst>
        </pc:spChg>
        <pc:spChg chg="mod">
          <ac:chgData name="Dagostino, Leonidas" userId="d42e52ab-e44d-4c88-95a1-c18248a0edcf" providerId="ADAL" clId="{676EA3E2-E41B-4868-8675-CDAFF31BE7BD}" dt="2024-01-10T17:59:17.884" v="47" actId="1076"/>
          <ac:spMkLst>
            <pc:docMk/>
            <pc:sldMk cId="3436963830" sldId="268"/>
            <ac:spMk id="7" creationId="{687D80C2-7157-82E2-4F15-E738AACCD512}"/>
          </ac:spMkLst>
        </pc:spChg>
        <pc:spChg chg="del">
          <ac:chgData name="Dagostino, Leonidas" userId="d42e52ab-e44d-4c88-95a1-c18248a0edcf" providerId="ADAL" clId="{676EA3E2-E41B-4868-8675-CDAFF31BE7BD}" dt="2024-01-10T17:56:23.216" v="7" actId="478"/>
          <ac:spMkLst>
            <pc:docMk/>
            <pc:sldMk cId="3436963830" sldId="268"/>
            <ac:spMk id="10" creationId="{9D81AC34-D8F7-CFC7-3D87-3384CBD7E1A7}"/>
          </ac:spMkLst>
        </pc:spChg>
        <pc:spChg chg="del mod">
          <ac:chgData name="Dagostino, Leonidas" userId="d42e52ab-e44d-4c88-95a1-c18248a0edcf" providerId="ADAL" clId="{676EA3E2-E41B-4868-8675-CDAFF31BE7BD}" dt="2024-01-10T17:58:27.680" v="27" actId="478"/>
          <ac:spMkLst>
            <pc:docMk/>
            <pc:sldMk cId="3436963830" sldId="268"/>
            <ac:spMk id="12" creationId="{569A5EF3-DBA6-A05B-D6FC-EF58E81281AE}"/>
          </ac:spMkLst>
        </pc:spChg>
        <pc:picChg chg="add mod">
          <ac:chgData name="Dagostino, Leonidas" userId="d42e52ab-e44d-4c88-95a1-c18248a0edcf" providerId="ADAL" clId="{676EA3E2-E41B-4868-8675-CDAFF31BE7BD}" dt="2024-01-10T17:59:12.620" v="45" actId="1076"/>
          <ac:picMkLst>
            <pc:docMk/>
            <pc:sldMk cId="3436963830" sldId="268"/>
            <ac:picMk id="8" creationId="{BCE986FA-D422-0FE5-E02A-652B88F0FD66}"/>
          </ac:picMkLst>
        </pc:picChg>
        <pc:picChg chg="add mod">
          <ac:chgData name="Dagostino, Leonidas" userId="d42e52ab-e44d-4c88-95a1-c18248a0edcf" providerId="ADAL" clId="{676EA3E2-E41B-4868-8675-CDAFF31BE7BD}" dt="2024-01-10T17:59:12.620" v="45" actId="1076"/>
          <ac:picMkLst>
            <pc:docMk/>
            <pc:sldMk cId="3436963830" sldId="268"/>
            <ac:picMk id="11" creationId="{709B9107-548D-AA9B-AFC9-5D027B5CCBD2}"/>
          </ac:picMkLst>
        </pc:picChg>
        <pc:picChg chg="add mod">
          <ac:chgData name="Dagostino, Leonidas" userId="d42e52ab-e44d-4c88-95a1-c18248a0edcf" providerId="ADAL" clId="{676EA3E2-E41B-4868-8675-CDAFF31BE7BD}" dt="2024-01-10T17:59:32.642" v="49" actId="1076"/>
          <ac:picMkLst>
            <pc:docMk/>
            <pc:sldMk cId="3436963830" sldId="268"/>
            <ac:picMk id="14" creationId="{18E808FE-3EC6-BFF3-1185-6BF7863BC5AF}"/>
          </ac:picMkLst>
        </pc:picChg>
        <pc:picChg chg="add mod">
          <ac:chgData name="Dagostino, Leonidas" userId="d42e52ab-e44d-4c88-95a1-c18248a0edcf" providerId="ADAL" clId="{676EA3E2-E41B-4868-8675-CDAFF31BE7BD}" dt="2024-01-10T17:58:57.867" v="43" actId="1076"/>
          <ac:picMkLst>
            <pc:docMk/>
            <pc:sldMk cId="3436963830" sldId="268"/>
            <ac:picMk id="16" creationId="{114B3300-01A6-F68F-BDC5-E897144152B2}"/>
          </ac:picMkLst>
        </pc:picChg>
        <pc:picChg chg="add mod">
          <ac:chgData name="Dagostino, Leonidas" userId="d42e52ab-e44d-4c88-95a1-c18248a0edcf" providerId="ADAL" clId="{676EA3E2-E41B-4868-8675-CDAFF31BE7BD}" dt="2024-01-10T17:59:42.543" v="50" actId="1076"/>
          <ac:picMkLst>
            <pc:docMk/>
            <pc:sldMk cId="3436963830" sldId="268"/>
            <ac:picMk id="18" creationId="{7ADC94D0-BBCE-C4DD-4038-983F90E91F95}"/>
          </ac:picMkLst>
        </pc:picChg>
      </pc:sldChg>
    </pc:docChg>
  </pc:docChgLst>
  <pc:docChgLst>
    <pc:chgData name="Devkar, Vikas" userId="acbd15ec-55d1-4a76-83ac-3f1d82711ed5" providerId="ADAL" clId="{1D085DC7-27BE-49ED-AA59-AC68119ECF15}"/>
    <pc:docChg chg="undo custSel delSld modSld">
      <pc:chgData name="Devkar, Vikas" userId="acbd15ec-55d1-4a76-83ac-3f1d82711ed5" providerId="ADAL" clId="{1D085DC7-27BE-49ED-AA59-AC68119ECF15}" dt="2024-04-01T18:56:29.935" v="1553" actId="1037"/>
      <pc:docMkLst>
        <pc:docMk/>
      </pc:docMkLst>
      <pc:sldChg chg="modSp mod">
        <pc:chgData name="Devkar, Vikas" userId="acbd15ec-55d1-4a76-83ac-3f1d82711ed5" providerId="ADAL" clId="{1D085DC7-27BE-49ED-AA59-AC68119ECF15}" dt="2024-04-01T18:47:00.894" v="1489" actId="113"/>
        <pc:sldMkLst>
          <pc:docMk/>
          <pc:sldMk cId="1604500440" sldId="256"/>
        </pc:sldMkLst>
        <pc:spChg chg="mod">
          <ac:chgData name="Devkar, Vikas" userId="acbd15ec-55d1-4a76-83ac-3f1d82711ed5" providerId="ADAL" clId="{1D085DC7-27BE-49ED-AA59-AC68119ECF15}" dt="2024-03-28T14:53:05.851" v="424" actId="404"/>
          <ac:spMkLst>
            <pc:docMk/>
            <pc:sldMk cId="1604500440" sldId="256"/>
            <ac:spMk id="3" creationId="{2896C643-36B3-C720-1176-338AA62D6ED9}"/>
          </ac:spMkLst>
        </pc:spChg>
        <pc:spChg chg="mod">
          <ac:chgData name="Devkar, Vikas" userId="acbd15ec-55d1-4a76-83ac-3f1d82711ed5" providerId="ADAL" clId="{1D085DC7-27BE-49ED-AA59-AC68119ECF15}" dt="2024-04-01T00:29:04.670" v="1148" actId="1076"/>
          <ac:spMkLst>
            <pc:docMk/>
            <pc:sldMk cId="1604500440" sldId="256"/>
            <ac:spMk id="5" creationId="{267B5775-2EA1-057F-29AE-A0A20F28F365}"/>
          </ac:spMkLst>
        </pc:spChg>
        <pc:spChg chg="mod">
          <ac:chgData name="Devkar, Vikas" userId="acbd15ec-55d1-4a76-83ac-3f1d82711ed5" providerId="ADAL" clId="{1D085DC7-27BE-49ED-AA59-AC68119ECF15}" dt="2024-04-01T00:29:04.670" v="1148" actId="1076"/>
          <ac:spMkLst>
            <pc:docMk/>
            <pc:sldMk cId="1604500440" sldId="256"/>
            <ac:spMk id="6" creationId="{25C1E047-61A8-283D-842B-8E4DB3196396}"/>
          </ac:spMkLst>
        </pc:spChg>
        <pc:spChg chg="mod">
          <ac:chgData name="Devkar, Vikas" userId="acbd15ec-55d1-4a76-83ac-3f1d82711ed5" providerId="ADAL" clId="{1D085DC7-27BE-49ED-AA59-AC68119ECF15}" dt="2024-04-01T18:47:00.894" v="1489" actId="113"/>
          <ac:spMkLst>
            <pc:docMk/>
            <pc:sldMk cId="1604500440" sldId="256"/>
            <ac:spMk id="7" creationId="{A1F18A16-F4AD-BA15-75E0-DBBCAFFB2CCA}"/>
          </ac:spMkLst>
        </pc:spChg>
        <pc:spChg chg="mod">
          <ac:chgData name="Devkar, Vikas" userId="acbd15ec-55d1-4a76-83ac-3f1d82711ed5" providerId="ADAL" clId="{1D085DC7-27BE-49ED-AA59-AC68119ECF15}" dt="2024-03-28T14:53:15.624" v="430" actId="403"/>
          <ac:spMkLst>
            <pc:docMk/>
            <pc:sldMk cId="1604500440" sldId="256"/>
            <ac:spMk id="8" creationId="{D33B83D1-2A7F-FB0B-3DB9-81D3A13B291E}"/>
          </ac:spMkLst>
        </pc:spChg>
        <pc:grpChg chg="mod">
          <ac:chgData name="Devkar, Vikas" userId="acbd15ec-55d1-4a76-83ac-3f1d82711ed5" providerId="ADAL" clId="{1D085DC7-27BE-49ED-AA59-AC68119ECF15}" dt="2024-04-01T00:29:04.670" v="1148" actId="1076"/>
          <ac:grpSpMkLst>
            <pc:docMk/>
            <pc:sldMk cId="1604500440" sldId="256"/>
            <ac:grpSpMk id="9" creationId="{D038214F-DF9B-FA33-99CE-D55383CF5013}"/>
          </ac:grpSpMkLst>
        </pc:grpChg>
        <pc:graphicFrameChg chg="mod">
          <ac:chgData name="Devkar, Vikas" userId="acbd15ec-55d1-4a76-83ac-3f1d82711ed5" providerId="ADAL" clId="{1D085DC7-27BE-49ED-AA59-AC68119ECF15}" dt="2024-03-28T14:53:55.614" v="434" actId="692"/>
          <ac:graphicFrameMkLst>
            <pc:docMk/>
            <pc:sldMk cId="1604500440" sldId="256"/>
            <ac:graphicFrameMk id="2" creationId="{779EADC1-3B5D-EFD1-F42B-A656E1ECCFE5}"/>
          </ac:graphicFrameMkLst>
        </pc:graphicFrameChg>
        <pc:picChg chg="mod">
          <ac:chgData name="Devkar, Vikas" userId="acbd15ec-55d1-4a76-83ac-3f1d82711ed5" providerId="ADAL" clId="{1D085DC7-27BE-49ED-AA59-AC68119ECF15}" dt="2024-04-01T00:29:04.670" v="1148" actId="1076"/>
          <ac:picMkLst>
            <pc:docMk/>
            <pc:sldMk cId="1604500440" sldId="256"/>
            <ac:picMk id="4" creationId="{8650781B-AC10-2E14-7193-96FAEFC0AEE0}"/>
          </ac:picMkLst>
        </pc:picChg>
      </pc:sldChg>
      <pc:sldChg chg="addSp delSp modSp mod">
        <pc:chgData name="Devkar, Vikas" userId="acbd15ec-55d1-4a76-83ac-3f1d82711ed5" providerId="ADAL" clId="{1D085DC7-27BE-49ED-AA59-AC68119ECF15}" dt="2024-04-01T18:49:37.738" v="1498" actId="113"/>
        <pc:sldMkLst>
          <pc:docMk/>
          <pc:sldMk cId="2353496295" sldId="257"/>
        </pc:sldMkLst>
        <pc:spChg chg="mod">
          <ac:chgData name="Devkar, Vikas" userId="acbd15ec-55d1-4a76-83ac-3f1d82711ed5" providerId="ADAL" clId="{1D085DC7-27BE-49ED-AA59-AC68119ECF15}" dt="2024-04-01T00:29:33.315" v="1151" actId="1076"/>
          <ac:spMkLst>
            <pc:docMk/>
            <pc:sldMk cId="2353496295" sldId="257"/>
            <ac:spMk id="2" creationId="{D6AA2FB8-1CA5-F197-0DE2-487B4877882F}"/>
          </ac:spMkLst>
        </pc:spChg>
        <pc:spChg chg="mod">
          <ac:chgData name="Devkar, Vikas" userId="acbd15ec-55d1-4a76-83ac-3f1d82711ed5" providerId="ADAL" clId="{1D085DC7-27BE-49ED-AA59-AC68119ECF15}" dt="2024-04-01T00:29:33.315" v="1151" actId="1076"/>
          <ac:spMkLst>
            <pc:docMk/>
            <pc:sldMk cId="2353496295" sldId="257"/>
            <ac:spMk id="3" creationId="{816778EE-91FC-3D08-8425-BCBB166A26BA}"/>
          </ac:spMkLst>
        </pc:spChg>
        <pc:spChg chg="mod">
          <ac:chgData name="Devkar, Vikas" userId="acbd15ec-55d1-4a76-83ac-3f1d82711ed5" providerId="ADAL" clId="{1D085DC7-27BE-49ED-AA59-AC68119ECF15}" dt="2024-04-01T00:30:17.703" v="1159" actId="1076"/>
          <ac:spMkLst>
            <pc:docMk/>
            <pc:sldMk cId="2353496295" sldId="257"/>
            <ac:spMk id="12" creationId="{EE11CAC0-AEDE-94C8-41CC-3FE479E6E222}"/>
          </ac:spMkLst>
        </pc:spChg>
        <pc:spChg chg="mod">
          <ac:chgData name="Devkar, Vikas" userId="acbd15ec-55d1-4a76-83ac-3f1d82711ed5" providerId="ADAL" clId="{1D085DC7-27BE-49ED-AA59-AC68119ECF15}" dt="2024-04-01T18:49:37.738" v="1498" actId="113"/>
          <ac:spMkLst>
            <pc:docMk/>
            <pc:sldMk cId="2353496295" sldId="257"/>
            <ac:spMk id="13" creationId="{1E8A8E73-D593-34F9-B40C-79F2F7DDC6DE}"/>
          </ac:spMkLst>
        </pc:spChg>
        <pc:spChg chg="add del mod">
          <ac:chgData name="Devkar, Vikas" userId="acbd15ec-55d1-4a76-83ac-3f1d82711ed5" providerId="ADAL" clId="{1D085DC7-27BE-49ED-AA59-AC68119ECF15}" dt="2024-03-28T15:04:43.552" v="686" actId="478"/>
          <ac:spMkLst>
            <pc:docMk/>
            <pc:sldMk cId="2353496295" sldId="257"/>
            <ac:spMk id="14" creationId="{24B28177-4D1A-3E0B-B007-8DD0C1FC913A}"/>
          </ac:spMkLst>
        </pc:spChg>
        <pc:spChg chg="mod">
          <ac:chgData name="Devkar, Vikas" userId="acbd15ec-55d1-4a76-83ac-3f1d82711ed5" providerId="ADAL" clId="{1D085DC7-27BE-49ED-AA59-AC68119ECF15}" dt="2024-04-01T00:30:17.703" v="1159" actId="1076"/>
          <ac:spMkLst>
            <pc:docMk/>
            <pc:sldMk cId="2353496295" sldId="257"/>
            <ac:spMk id="15" creationId="{F9003170-D647-71D3-CF8B-F63811A341C0}"/>
          </ac:spMkLst>
        </pc:spChg>
        <pc:spChg chg="add del mod">
          <ac:chgData name="Devkar, Vikas" userId="acbd15ec-55d1-4a76-83ac-3f1d82711ed5" providerId="ADAL" clId="{1D085DC7-27BE-49ED-AA59-AC68119ECF15}" dt="2024-03-28T15:04:45.859" v="687" actId="478"/>
          <ac:spMkLst>
            <pc:docMk/>
            <pc:sldMk cId="2353496295" sldId="257"/>
            <ac:spMk id="16" creationId="{35323693-1A12-D7B0-4DA2-93FB8A3A567B}"/>
          </ac:spMkLst>
        </pc:spChg>
        <pc:spChg chg="add del mod">
          <ac:chgData name="Devkar, Vikas" userId="acbd15ec-55d1-4a76-83ac-3f1d82711ed5" providerId="ADAL" clId="{1D085DC7-27BE-49ED-AA59-AC68119ECF15}" dt="2024-03-28T15:05:03.545" v="693" actId="478"/>
          <ac:spMkLst>
            <pc:docMk/>
            <pc:sldMk cId="2353496295" sldId="257"/>
            <ac:spMk id="17" creationId="{F96FC886-CDC5-2A7B-0D08-1B017E3E55CF}"/>
          </ac:spMkLst>
        </pc:spChg>
        <pc:spChg chg="add del mod">
          <ac:chgData name="Devkar, Vikas" userId="acbd15ec-55d1-4a76-83ac-3f1d82711ed5" providerId="ADAL" clId="{1D085DC7-27BE-49ED-AA59-AC68119ECF15}" dt="2024-03-28T15:05:05.207" v="694" actId="478"/>
          <ac:spMkLst>
            <pc:docMk/>
            <pc:sldMk cId="2353496295" sldId="257"/>
            <ac:spMk id="18" creationId="{B0379138-9312-A28F-BBD3-2B652849AFDB}"/>
          </ac:spMkLst>
        </pc:spChg>
        <pc:spChg chg="add mod">
          <ac:chgData name="Devkar, Vikas" userId="acbd15ec-55d1-4a76-83ac-3f1d82711ed5" providerId="ADAL" clId="{1D085DC7-27BE-49ED-AA59-AC68119ECF15}" dt="2024-04-01T00:29:33.315" v="1151" actId="1076"/>
          <ac:spMkLst>
            <pc:docMk/>
            <pc:sldMk cId="2353496295" sldId="257"/>
            <ac:spMk id="19" creationId="{1EA374B2-14F2-4536-7E84-18424D1DA4EB}"/>
          </ac:spMkLst>
        </pc:spChg>
        <pc:spChg chg="add mod">
          <ac:chgData name="Devkar, Vikas" userId="acbd15ec-55d1-4a76-83ac-3f1d82711ed5" providerId="ADAL" clId="{1D085DC7-27BE-49ED-AA59-AC68119ECF15}" dt="2024-04-01T00:29:33.315" v="1151" actId="1076"/>
          <ac:spMkLst>
            <pc:docMk/>
            <pc:sldMk cId="2353496295" sldId="257"/>
            <ac:spMk id="20" creationId="{CD67D92E-49AE-E245-FABF-B36F3E3DC670}"/>
          </ac:spMkLst>
        </pc:spChg>
        <pc:spChg chg="add mod">
          <ac:chgData name="Devkar, Vikas" userId="acbd15ec-55d1-4a76-83ac-3f1d82711ed5" providerId="ADAL" clId="{1D085DC7-27BE-49ED-AA59-AC68119ECF15}" dt="2024-04-01T00:30:17.703" v="1159" actId="1076"/>
          <ac:spMkLst>
            <pc:docMk/>
            <pc:sldMk cId="2353496295" sldId="257"/>
            <ac:spMk id="21" creationId="{B60197F2-AF6F-DCBC-166C-37EC30FDF5E3}"/>
          </ac:spMkLst>
        </pc:spChg>
        <pc:spChg chg="add mod">
          <ac:chgData name="Devkar, Vikas" userId="acbd15ec-55d1-4a76-83ac-3f1d82711ed5" providerId="ADAL" clId="{1D085DC7-27BE-49ED-AA59-AC68119ECF15}" dt="2024-04-01T00:30:17.703" v="1159" actId="1076"/>
          <ac:spMkLst>
            <pc:docMk/>
            <pc:sldMk cId="2353496295" sldId="257"/>
            <ac:spMk id="22" creationId="{C3D70D76-B4B6-8731-A53B-D09F9225598C}"/>
          </ac:spMkLst>
        </pc:spChg>
        <pc:picChg chg="mod">
          <ac:chgData name="Devkar, Vikas" userId="acbd15ec-55d1-4a76-83ac-3f1d82711ed5" providerId="ADAL" clId="{1D085DC7-27BE-49ED-AA59-AC68119ECF15}" dt="2024-04-01T00:29:33.315" v="1151" actId="1076"/>
          <ac:picMkLst>
            <pc:docMk/>
            <pc:sldMk cId="2353496295" sldId="257"/>
            <ac:picMk id="4" creationId="{33EA40E7-3DC9-F6DF-3063-78739A2ED3A9}"/>
          </ac:picMkLst>
        </pc:picChg>
        <pc:picChg chg="mod">
          <ac:chgData name="Devkar, Vikas" userId="acbd15ec-55d1-4a76-83ac-3f1d82711ed5" providerId="ADAL" clId="{1D085DC7-27BE-49ED-AA59-AC68119ECF15}" dt="2024-04-01T00:29:33.315" v="1151" actId="1076"/>
          <ac:picMkLst>
            <pc:docMk/>
            <pc:sldMk cId="2353496295" sldId="257"/>
            <ac:picMk id="5" creationId="{BC4B593B-F9F9-3162-DCA4-E49944D47FA7}"/>
          </ac:picMkLst>
        </pc:picChg>
        <pc:picChg chg="mod">
          <ac:chgData name="Devkar, Vikas" userId="acbd15ec-55d1-4a76-83ac-3f1d82711ed5" providerId="ADAL" clId="{1D085DC7-27BE-49ED-AA59-AC68119ECF15}" dt="2024-04-01T00:29:33.315" v="1151" actId="1076"/>
          <ac:picMkLst>
            <pc:docMk/>
            <pc:sldMk cId="2353496295" sldId="257"/>
            <ac:picMk id="6" creationId="{ACEADD36-435A-706A-0AE9-EBEEFE9AF23F}"/>
          </ac:picMkLst>
        </pc:picChg>
        <pc:picChg chg="mod">
          <ac:chgData name="Devkar, Vikas" userId="acbd15ec-55d1-4a76-83ac-3f1d82711ed5" providerId="ADAL" clId="{1D085DC7-27BE-49ED-AA59-AC68119ECF15}" dt="2024-04-01T00:29:33.315" v="1151" actId="1076"/>
          <ac:picMkLst>
            <pc:docMk/>
            <pc:sldMk cId="2353496295" sldId="257"/>
            <ac:picMk id="7" creationId="{E389C274-F48A-AD44-02D3-D878D9D08361}"/>
          </ac:picMkLst>
        </pc:picChg>
        <pc:picChg chg="mod">
          <ac:chgData name="Devkar, Vikas" userId="acbd15ec-55d1-4a76-83ac-3f1d82711ed5" providerId="ADAL" clId="{1D085DC7-27BE-49ED-AA59-AC68119ECF15}" dt="2024-04-01T00:30:17.703" v="1159" actId="1076"/>
          <ac:picMkLst>
            <pc:docMk/>
            <pc:sldMk cId="2353496295" sldId="257"/>
            <ac:picMk id="8" creationId="{42BD8504-A15A-0C1F-A71B-97100C7768C1}"/>
          </ac:picMkLst>
        </pc:picChg>
        <pc:picChg chg="mod">
          <ac:chgData name="Devkar, Vikas" userId="acbd15ec-55d1-4a76-83ac-3f1d82711ed5" providerId="ADAL" clId="{1D085DC7-27BE-49ED-AA59-AC68119ECF15}" dt="2024-04-01T00:30:17.703" v="1159" actId="1076"/>
          <ac:picMkLst>
            <pc:docMk/>
            <pc:sldMk cId="2353496295" sldId="257"/>
            <ac:picMk id="9" creationId="{1B540D38-7D7A-2DBE-4294-66636BAA9EFB}"/>
          </ac:picMkLst>
        </pc:picChg>
        <pc:picChg chg="mod">
          <ac:chgData name="Devkar, Vikas" userId="acbd15ec-55d1-4a76-83ac-3f1d82711ed5" providerId="ADAL" clId="{1D085DC7-27BE-49ED-AA59-AC68119ECF15}" dt="2024-04-01T00:30:17.703" v="1159" actId="1076"/>
          <ac:picMkLst>
            <pc:docMk/>
            <pc:sldMk cId="2353496295" sldId="257"/>
            <ac:picMk id="10" creationId="{4A96A991-9253-EBE7-A0C6-5E298683CF46}"/>
          </ac:picMkLst>
        </pc:picChg>
        <pc:picChg chg="mod">
          <ac:chgData name="Devkar, Vikas" userId="acbd15ec-55d1-4a76-83ac-3f1d82711ed5" providerId="ADAL" clId="{1D085DC7-27BE-49ED-AA59-AC68119ECF15}" dt="2024-04-01T00:30:17.703" v="1159" actId="1076"/>
          <ac:picMkLst>
            <pc:docMk/>
            <pc:sldMk cId="2353496295" sldId="257"/>
            <ac:picMk id="11" creationId="{5AE816F1-0434-E091-206B-91B592A351E4}"/>
          </ac:picMkLst>
        </pc:picChg>
      </pc:sldChg>
      <pc:sldChg chg="modSp mod">
        <pc:chgData name="Devkar, Vikas" userId="acbd15ec-55d1-4a76-83ac-3f1d82711ed5" providerId="ADAL" clId="{1D085DC7-27BE-49ED-AA59-AC68119ECF15}" dt="2024-04-01T18:50:02.775" v="1507" actId="113"/>
        <pc:sldMkLst>
          <pc:docMk/>
          <pc:sldMk cId="1437810819" sldId="262"/>
        </pc:sldMkLst>
        <pc:spChg chg="mod">
          <ac:chgData name="Devkar, Vikas" userId="acbd15ec-55d1-4a76-83ac-3f1d82711ed5" providerId="ADAL" clId="{1D085DC7-27BE-49ED-AA59-AC68119ECF15}" dt="2024-03-28T14:52:05.951" v="415" actId="2711"/>
          <ac:spMkLst>
            <pc:docMk/>
            <pc:sldMk cId="1437810819" sldId="262"/>
            <ac:spMk id="7" creationId="{5551FD6D-A974-5B2F-06D6-39C5B15287E5}"/>
          </ac:spMkLst>
        </pc:spChg>
        <pc:spChg chg="mod">
          <ac:chgData name="Devkar, Vikas" userId="acbd15ec-55d1-4a76-83ac-3f1d82711ed5" providerId="ADAL" clId="{1D085DC7-27BE-49ED-AA59-AC68119ECF15}" dt="2024-03-28T14:52:05.951" v="415" actId="2711"/>
          <ac:spMkLst>
            <pc:docMk/>
            <pc:sldMk cId="1437810819" sldId="262"/>
            <ac:spMk id="9" creationId="{FDE99791-FD49-3011-4C78-96B02C0A5A8F}"/>
          </ac:spMkLst>
        </pc:spChg>
        <pc:spChg chg="mod">
          <ac:chgData name="Devkar, Vikas" userId="acbd15ec-55d1-4a76-83ac-3f1d82711ed5" providerId="ADAL" clId="{1D085DC7-27BE-49ED-AA59-AC68119ECF15}" dt="2024-03-28T14:52:05.951" v="415" actId="2711"/>
          <ac:spMkLst>
            <pc:docMk/>
            <pc:sldMk cId="1437810819" sldId="262"/>
            <ac:spMk id="22" creationId="{F45B774E-352B-D2F0-59CE-3F403547A606}"/>
          </ac:spMkLst>
        </pc:spChg>
        <pc:spChg chg="mod">
          <ac:chgData name="Devkar, Vikas" userId="acbd15ec-55d1-4a76-83ac-3f1d82711ed5" providerId="ADAL" clId="{1D085DC7-27BE-49ED-AA59-AC68119ECF15}" dt="2024-03-28T14:52:05.951" v="415" actId="2711"/>
          <ac:spMkLst>
            <pc:docMk/>
            <pc:sldMk cId="1437810819" sldId="262"/>
            <ac:spMk id="23" creationId="{B96FC619-0C39-0BD7-3C82-79163AEE558A}"/>
          </ac:spMkLst>
        </pc:spChg>
        <pc:spChg chg="mod">
          <ac:chgData name="Devkar, Vikas" userId="acbd15ec-55d1-4a76-83ac-3f1d82711ed5" providerId="ADAL" clId="{1D085DC7-27BE-49ED-AA59-AC68119ECF15}" dt="2024-03-28T14:52:05.951" v="415" actId="2711"/>
          <ac:spMkLst>
            <pc:docMk/>
            <pc:sldMk cId="1437810819" sldId="262"/>
            <ac:spMk id="24" creationId="{CF95B481-9423-1BA2-A6AE-3168412DA92C}"/>
          </ac:spMkLst>
        </pc:spChg>
        <pc:spChg chg="mod">
          <ac:chgData name="Devkar, Vikas" userId="acbd15ec-55d1-4a76-83ac-3f1d82711ed5" providerId="ADAL" clId="{1D085DC7-27BE-49ED-AA59-AC68119ECF15}" dt="2024-03-28T14:52:05.951" v="415" actId="2711"/>
          <ac:spMkLst>
            <pc:docMk/>
            <pc:sldMk cId="1437810819" sldId="262"/>
            <ac:spMk id="25" creationId="{060AC8CA-83D7-B03F-8D61-3B566DDE6E52}"/>
          </ac:spMkLst>
        </pc:spChg>
        <pc:spChg chg="mod">
          <ac:chgData name="Devkar, Vikas" userId="acbd15ec-55d1-4a76-83ac-3f1d82711ed5" providerId="ADAL" clId="{1D085DC7-27BE-49ED-AA59-AC68119ECF15}" dt="2024-03-28T14:52:05.951" v="415" actId="2711"/>
          <ac:spMkLst>
            <pc:docMk/>
            <pc:sldMk cId="1437810819" sldId="262"/>
            <ac:spMk id="26" creationId="{C2102C78-BD49-0370-8108-0C8BB76C276E}"/>
          </ac:spMkLst>
        </pc:spChg>
        <pc:spChg chg="mod">
          <ac:chgData name="Devkar, Vikas" userId="acbd15ec-55d1-4a76-83ac-3f1d82711ed5" providerId="ADAL" clId="{1D085DC7-27BE-49ED-AA59-AC68119ECF15}" dt="2024-03-28T14:52:05.951" v="415" actId="2711"/>
          <ac:spMkLst>
            <pc:docMk/>
            <pc:sldMk cId="1437810819" sldId="262"/>
            <ac:spMk id="27" creationId="{04E25290-5D07-D968-2B23-FA447187C6EA}"/>
          </ac:spMkLst>
        </pc:spChg>
        <pc:spChg chg="mod">
          <ac:chgData name="Devkar, Vikas" userId="acbd15ec-55d1-4a76-83ac-3f1d82711ed5" providerId="ADAL" clId="{1D085DC7-27BE-49ED-AA59-AC68119ECF15}" dt="2024-03-28T14:52:05.951" v="415" actId="2711"/>
          <ac:spMkLst>
            <pc:docMk/>
            <pc:sldMk cId="1437810819" sldId="262"/>
            <ac:spMk id="28" creationId="{61C17996-2D3F-3557-196F-0403431021D7}"/>
          </ac:spMkLst>
        </pc:spChg>
        <pc:spChg chg="mod">
          <ac:chgData name="Devkar, Vikas" userId="acbd15ec-55d1-4a76-83ac-3f1d82711ed5" providerId="ADAL" clId="{1D085DC7-27BE-49ED-AA59-AC68119ECF15}" dt="2024-03-28T14:52:05.951" v="415" actId="2711"/>
          <ac:spMkLst>
            <pc:docMk/>
            <pc:sldMk cId="1437810819" sldId="262"/>
            <ac:spMk id="29" creationId="{80B6CD38-054E-2E08-C89C-5F5E17A800D2}"/>
          </ac:spMkLst>
        </pc:spChg>
        <pc:spChg chg="mod">
          <ac:chgData name="Devkar, Vikas" userId="acbd15ec-55d1-4a76-83ac-3f1d82711ed5" providerId="ADAL" clId="{1D085DC7-27BE-49ED-AA59-AC68119ECF15}" dt="2024-03-28T14:52:05.951" v="415" actId="2711"/>
          <ac:spMkLst>
            <pc:docMk/>
            <pc:sldMk cId="1437810819" sldId="262"/>
            <ac:spMk id="30" creationId="{412A6116-AD7C-DDA5-0273-749813721AB6}"/>
          </ac:spMkLst>
        </pc:spChg>
        <pc:spChg chg="mod">
          <ac:chgData name="Devkar, Vikas" userId="acbd15ec-55d1-4a76-83ac-3f1d82711ed5" providerId="ADAL" clId="{1D085DC7-27BE-49ED-AA59-AC68119ECF15}" dt="2024-03-28T14:52:05.951" v="415" actId="2711"/>
          <ac:spMkLst>
            <pc:docMk/>
            <pc:sldMk cId="1437810819" sldId="262"/>
            <ac:spMk id="31" creationId="{47565931-FFBD-FEF3-8ADB-65035CAF414A}"/>
          </ac:spMkLst>
        </pc:spChg>
        <pc:spChg chg="mod">
          <ac:chgData name="Devkar, Vikas" userId="acbd15ec-55d1-4a76-83ac-3f1d82711ed5" providerId="ADAL" clId="{1D085DC7-27BE-49ED-AA59-AC68119ECF15}" dt="2024-03-28T14:51:57.706" v="414" actId="2711"/>
          <ac:spMkLst>
            <pc:docMk/>
            <pc:sldMk cId="1437810819" sldId="262"/>
            <ac:spMk id="39" creationId="{2D981907-DEF4-28AB-4F9E-121EFA7BA0D3}"/>
          </ac:spMkLst>
        </pc:spChg>
        <pc:spChg chg="mod">
          <ac:chgData name="Devkar, Vikas" userId="acbd15ec-55d1-4a76-83ac-3f1d82711ed5" providerId="ADAL" clId="{1D085DC7-27BE-49ED-AA59-AC68119ECF15}" dt="2024-03-28T14:51:57.706" v="414" actId="2711"/>
          <ac:spMkLst>
            <pc:docMk/>
            <pc:sldMk cId="1437810819" sldId="262"/>
            <ac:spMk id="40" creationId="{53751EA1-1890-A682-31A3-D98ECB5B17CD}"/>
          </ac:spMkLst>
        </pc:spChg>
        <pc:spChg chg="mod">
          <ac:chgData name="Devkar, Vikas" userId="acbd15ec-55d1-4a76-83ac-3f1d82711ed5" providerId="ADAL" clId="{1D085DC7-27BE-49ED-AA59-AC68119ECF15}" dt="2024-04-01T18:50:02.775" v="1507" actId="113"/>
          <ac:spMkLst>
            <pc:docMk/>
            <pc:sldMk cId="1437810819" sldId="262"/>
            <ac:spMk id="42" creationId="{28F568E8-3645-BB50-A71F-27BA32D8D5C2}"/>
          </ac:spMkLst>
        </pc:spChg>
        <pc:picChg chg="mod">
          <ac:chgData name="Devkar, Vikas" userId="acbd15ec-55d1-4a76-83ac-3f1d82711ed5" providerId="ADAL" clId="{1D085DC7-27BE-49ED-AA59-AC68119ECF15}" dt="2024-03-28T14:51:48.459" v="413" actId="1076"/>
          <ac:picMkLst>
            <pc:docMk/>
            <pc:sldMk cId="1437810819" sldId="262"/>
            <ac:picMk id="8" creationId="{DC6ADC5E-E3E6-698E-6996-F364912B7940}"/>
          </ac:picMkLst>
        </pc:picChg>
      </pc:sldChg>
      <pc:sldChg chg="modSp mod">
        <pc:chgData name="Devkar, Vikas" userId="acbd15ec-55d1-4a76-83ac-3f1d82711ed5" providerId="ADAL" clId="{1D085DC7-27BE-49ED-AA59-AC68119ECF15}" dt="2024-04-01T18:51:01.373" v="1525" actId="113"/>
        <pc:sldMkLst>
          <pc:docMk/>
          <pc:sldMk cId="794843755" sldId="264"/>
        </pc:sldMkLst>
        <pc:spChg chg="mod">
          <ac:chgData name="Devkar, Vikas" userId="acbd15ec-55d1-4a76-83ac-3f1d82711ed5" providerId="ADAL" clId="{1D085DC7-27BE-49ED-AA59-AC68119ECF15}" dt="2024-04-01T00:35:10.408" v="1311" actId="1076"/>
          <ac:spMkLst>
            <pc:docMk/>
            <pc:sldMk cId="794843755" sldId="264"/>
            <ac:spMk id="4" creationId="{7D593560-ACFB-F8C2-73F4-168A14781887}"/>
          </ac:spMkLst>
        </pc:spChg>
        <pc:spChg chg="mod">
          <ac:chgData name="Devkar, Vikas" userId="acbd15ec-55d1-4a76-83ac-3f1d82711ed5" providerId="ADAL" clId="{1D085DC7-27BE-49ED-AA59-AC68119ECF15}" dt="2024-04-01T00:34:35.105" v="1301" actId="1076"/>
          <ac:spMkLst>
            <pc:docMk/>
            <pc:sldMk cId="794843755" sldId="264"/>
            <ac:spMk id="5" creationId="{92375EEC-00F9-91C1-1612-0917D283BA86}"/>
          </ac:spMkLst>
        </pc:spChg>
        <pc:spChg chg="mod">
          <ac:chgData name="Devkar, Vikas" userId="acbd15ec-55d1-4a76-83ac-3f1d82711ed5" providerId="ADAL" clId="{1D085DC7-27BE-49ED-AA59-AC68119ECF15}" dt="2024-03-28T15:30:22.027" v="1062" actId="114"/>
          <ac:spMkLst>
            <pc:docMk/>
            <pc:sldMk cId="794843755" sldId="264"/>
            <ac:spMk id="6" creationId="{38BCA4B3-CB6B-DD90-0EA4-30EFC0AE81FF}"/>
          </ac:spMkLst>
        </pc:spChg>
        <pc:spChg chg="mod">
          <ac:chgData name="Devkar, Vikas" userId="acbd15ec-55d1-4a76-83ac-3f1d82711ed5" providerId="ADAL" clId="{1D085DC7-27BE-49ED-AA59-AC68119ECF15}" dt="2024-04-01T18:51:01.373" v="1525" actId="113"/>
          <ac:spMkLst>
            <pc:docMk/>
            <pc:sldMk cId="794843755" sldId="264"/>
            <ac:spMk id="7" creationId="{61C45261-E6F1-BCD3-70E4-7B438A09B38F}"/>
          </ac:spMkLst>
        </pc:spChg>
        <pc:spChg chg="mod">
          <ac:chgData name="Devkar, Vikas" userId="acbd15ec-55d1-4a76-83ac-3f1d82711ed5" providerId="ADAL" clId="{1D085DC7-27BE-49ED-AA59-AC68119ECF15}" dt="2024-03-28T15:30:36.999" v="1065" actId="114"/>
          <ac:spMkLst>
            <pc:docMk/>
            <pc:sldMk cId="794843755" sldId="264"/>
            <ac:spMk id="9" creationId="{57F3A884-8AEB-07EE-192A-2B1D2FBE1D10}"/>
          </ac:spMkLst>
        </pc:spChg>
        <pc:spChg chg="mod">
          <ac:chgData name="Devkar, Vikas" userId="acbd15ec-55d1-4a76-83ac-3f1d82711ed5" providerId="ADAL" clId="{1D085DC7-27BE-49ED-AA59-AC68119ECF15}" dt="2024-03-28T15:30:22.027" v="1062" actId="114"/>
          <ac:spMkLst>
            <pc:docMk/>
            <pc:sldMk cId="794843755" sldId="264"/>
            <ac:spMk id="10" creationId="{28792D60-7662-2731-A4C5-8568EB29E094}"/>
          </ac:spMkLst>
        </pc:spChg>
        <pc:spChg chg="mod">
          <ac:chgData name="Devkar, Vikas" userId="acbd15ec-55d1-4a76-83ac-3f1d82711ed5" providerId="ADAL" clId="{1D085DC7-27BE-49ED-AA59-AC68119ECF15}" dt="2024-03-28T15:30:22.027" v="1062" actId="114"/>
          <ac:spMkLst>
            <pc:docMk/>
            <pc:sldMk cId="794843755" sldId="264"/>
            <ac:spMk id="11" creationId="{6EB80DB2-23D9-81C0-2F0E-0358E0D1534D}"/>
          </ac:spMkLst>
        </pc:spChg>
        <pc:spChg chg="mod">
          <ac:chgData name="Devkar, Vikas" userId="acbd15ec-55d1-4a76-83ac-3f1d82711ed5" providerId="ADAL" clId="{1D085DC7-27BE-49ED-AA59-AC68119ECF15}" dt="2024-03-28T15:30:22.027" v="1062" actId="114"/>
          <ac:spMkLst>
            <pc:docMk/>
            <pc:sldMk cId="794843755" sldId="264"/>
            <ac:spMk id="14" creationId="{F045C686-C040-49CF-69B0-19B5E2D886FA}"/>
          </ac:spMkLst>
        </pc:spChg>
        <pc:spChg chg="mod">
          <ac:chgData name="Devkar, Vikas" userId="acbd15ec-55d1-4a76-83ac-3f1d82711ed5" providerId="ADAL" clId="{1D085DC7-27BE-49ED-AA59-AC68119ECF15}" dt="2024-03-28T15:30:22.027" v="1062" actId="114"/>
          <ac:spMkLst>
            <pc:docMk/>
            <pc:sldMk cId="794843755" sldId="264"/>
            <ac:spMk id="16" creationId="{629E4D14-D7DF-6A89-9284-BAEB693D6150}"/>
          </ac:spMkLst>
        </pc:spChg>
        <pc:spChg chg="mod">
          <ac:chgData name="Devkar, Vikas" userId="acbd15ec-55d1-4a76-83ac-3f1d82711ed5" providerId="ADAL" clId="{1D085DC7-27BE-49ED-AA59-AC68119ECF15}" dt="2024-03-28T15:30:22.027" v="1062" actId="114"/>
          <ac:spMkLst>
            <pc:docMk/>
            <pc:sldMk cId="794843755" sldId="264"/>
            <ac:spMk id="19" creationId="{D7E33E8B-BAE4-1EB3-213B-50151E3A697A}"/>
          </ac:spMkLst>
        </pc:spChg>
        <pc:spChg chg="mod">
          <ac:chgData name="Devkar, Vikas" userId="acbd15ec-55d1-4a76-83ac-3f1d82711ed5" providerId="ADAL" clId="{1D085DC7-27BE-49ED-AA59-AC68119ECF15}" dt="2024-03-28T15:30:31.766" v="1063" actId="114"/>
          <ac:spMkLst>
            <pc:docMk/>
            <pc:sldMk cId="794843755" sldId="264"/>
            <ac:spMk id="20" creationId="{C9124F61-60B2-8DDB-D73F-C6CF7B041092}"/>
          </ac:spMkLst>
        </pc:spChg>
        <pc:spChg chg="mod">
          <ac:chgData name="Devkar, Vikas" userId="acbd15ec-55d1-4a76-83ac-3f1d82711ed5" providerId="ADAL" clId="{1D085DC7-27BE-49ED-AA59-AC68119ECF15}" dt="2024-03-28T15:30:34.287" v="1064" actId="114"/>
          <ac:spMkLst>
            <pc:docMk/>
            <pc:sldMk cId="794843755" sldId="264"/>
            <ac:spMk id="21" creationId="{D7934C8E-9AE4-D638-462C-FF718F6DEBA7}"/>
          </ac:spMkLst>
        </pc:spChg>
        <pc:grpChg chg="mod">
          <ac:chgData name="Devkar, Vikas" userId="acbd15ec-55d1-4a76-83ac-3f1d82711ed5" providerId="ADAL" clId="{1D085DC7-27BE-49ED-AA59-AC68119ECF15}" dt="2024-04-01T00:34:35.105" v="1301" actId="1076"/>
          <ac:grpSpMkLst>
            <pc:docMk/>
            <pc:sldMk cId="794843755" sldId="264"/>
            <ac:grpSpMk id="22" creationId="{6A30AD5B-F433-E2B2-1C77-6D871F50F4D0}"/>
          </ac:grpSpMkLst>
        </pc:grpChg>
        <pc:picChg chg="mod">
          <ac:chgData name="Devkar, Vikas" userId="acbd15ec-55d1-4a76-83ac-3f1d82711ed5" providerId="ADAL" clId="{1D085DC7-27BE-49ED-AA59-AC68119ECF15}" dt="2024-04-01T00:34:35.105" v="1301" actId="1076"/>
          <ac:picMkLst>
            <pc:docMk/>
            <pc:sldMk cId="794843755" sldId="264"/>
            <ac:picMk id="2" creationId="{7C34630E-173E-7746-C548-3D3C58E2580A}"/>
          </ac:picMkLst>
        </pc:picChg>
      </pc:sldChg>
      <pc:sldChg chg="addSp delSp modSp mod">
        <pc:chgData name="Devkar, Vikas" userId="acbd15ec-55d1-4a76-83ac-3f1d82711ed5" providerId="ADAL" clId="{1D085DC7-27BE-49ED-AA59-AC68119ECF15}" dt="2024-04-01T00:45:45.242" v="1476" actId="20577"/>
        <pc:sldMkLst>
          <pc:docMk/>
          <pc:sldMk cId="1845444862" sldId="265"/>
        </pc:sldMkLst>
        <pc:spChg chg="mod">
          <ac:chgData name="Devkar, Vikas" userId="acbd15ec-55d1-4a76-83ac-3f1d82711ed5" providerId="ADAL" clId="{1D085DC7-27BE-49ED-AA59-AC68119ECF15}" dt="2024-04-01T00:31:50.613" v="1175" actId="1076"/>
          <ac:spMkLst>
            <pc:docMk/>
            <pc:sldMk cId="1845444862" sldId="265"/>
            <ac:spMk id="3" creationId="{0E1FCA99-A517-63DD-2962-C2E0926CFB1B}"/>
          </ac:spMkLst>
        </pc:spChg>
        <pc:spChg chg="mod">
          <ac:chgData name="Devkar, Vikas" userId="acbd15ec-55d1-4a76-83ac-3f1d82711ed5" providerId="ADAL" clId="{1D085DC7-27BE-49ED-AA59-AC68119ECF15}" dt="2024-04-01T00:45:45.242" v="1476" actId="20577"/>
          <ac:spMkLst>
            <pc:docMk/>
            <pc:sldMk cId="1845444862" sldId="265"/>
            <ac:spMk id="4" creationId="{47E1C263-20BF-3010-7C86-6DDDAB808C91}"/>
          </ac:spMkLst>
        </pc:spChg>
        <pc:spChg chg="add del mod">
          <ac:chgData name="Devkar, Vikas" userId="acbd15ec-55d1-4a76-83ac-3f1d82711ed5" providerId="ADAL" clId="{1D085DC7-27BE-49ED-AA59-AC68119ECF15}" dt="2024-03-28T15:06:22.484" v="732" actId="478"/>
          <ac:spMkLst>
            <pc:docMk/>
            <pc:sldMk cId="1845444862" sldId="265"/>
            <ac:spMk id="5" creationId="{B588B39B-EE6D-A8CB-D24C-3E1961FE0204}"/>
          </ac:spMkLst>
        </pc:spChg>
        <pc:spChg chg="add del mod">
          <ac:chgData name="Devkar, Vikas" userId="acbd15ec-55d1-4a76-83ac-3f1d82711ed5" providerId="ADAL" clId="{1D085DC7-27BE-49ED-AA59-AC68119ECF15}" dt="2024-03-28T15:06:21.834" v="731" actId="478"/>
          <ac:spMkLst>
            <pc:docMk/>
            <pc:sldMk cId="1845444862" sldId="265"/>
            <ac:spMk id="7" creationId="{078BC610-05A6-45E7-BBB2-AB9232C4B03F}"/>
          </ac:spMkLst>
        </pc:spChg>
        <pc:spChg chg="add del mod">
          <ac:chgData name="Devkar, Vikas" userId="acbd15ec-55d1-4a76-83ac-3f1d82711ed5" providerId="ADAL" clId="{1D085DC7-27BE-49ED-AA59-AC68119ECF15}" dt="2024-03-28T15:06:19.170" v="729" actId="478"/>
          <ac:spMkLst>
            <pc:docMk/>
            <pc:sldMk cId="1845444862" sldId="265"/>
            <ac:spMk id="8" creationId="{30AA3EBF-FEDF-A17C-5583-15EF43AECD70}"/>
          </ac:spMkLst>
        </pc:spChg>
        <pc:spChg chg="add del mod">
          <ac:chgData name="Devkar, Vikas" userId="acbd15ec-55d1-4a76-83ac-3f1d82711ed5" providerId="ADAL" clId="{1D085DC7-27BE-49ED-AA59-AC68119ECF15}" dt="2024-03-28T15:06:19.948" v="730" actId="478"/>
          <ac:spMkLst>
            <pc:docMk/>
            <pc:sldMk cId="1845444862" sldId="265"/>
            <ac:spMk id="9" creationId="{19456EB3-022B-8686-5407-A1FB161B371A}"/>
          </ac:spMkLst>
        </pc:spChg>
        <pc:spChg chg="mod">
          <ac:chgData name="Devkar, Vikas" userId="acbd15ec-55d1-4a76-83ac-3f1d82711ed5" providerId="ADAL" clId="{1D085DC7-27BE-49ED-AA59-AC68119ECF15}" dt="2024-03-28T14:51:28.043" v="407" actId="20577"/>
          <ac:spMkLst>
            <pc:docMk/>
            <pc:sldMk cId="1845444862" sldId="265"/>
            <ac:spMk id="10" creationId="{E3A8E084-561E-3CC7-26EA-CE7AB3B3808C}"/>
          </ac:spMkLst>
        </pc:spChg>
        <pc:spChg chg="add mod">
          <ac:chgData name="Devkar, Vikas" userId="acbd15ec-55d1-4a76-83ac-3f1d82711ed5" providerId="ADAL" clId="{1D085DC7-27BE-49ED-AA59-AC68119ECF15}" dt="2024-04-01T00:31:50.613" v="1175" actId="1076"/>
          <ac:spMkLst>
            <pc:docMk/>
            <pc:sldMk cId="1845444862" sldId="265"/>
            <ac:spMk id="11" creationId="{B2966683-21D0-76A1-166B-13D7A5E2C2EB}"/>
          </ac:spMkLst>
        </pc:spChg>
        <pc:spChg chg="add mod">
          <ac:chgData name="Devkar, Vikas" userId="acbd15ec-55d1-4a76-83ac-3f1d82711ed5" providerId="ADAL" clId="{1D085DC7-27BE-49ED-AA59-AC68119ECF15}" dt="2024-04-01T00:31:50.613" v="1175" actId="1076"/>
          <ac:spMkLst>
            <pc:docMk/>
            <pc:sldMk cId="1845444862" sldId="265"/>
            <ac:spMk id="12" creationId="{DF105A69-ED5A-E6A1-5492-712C35C7ABB6}"/>
          </ac:spMkLst>
        </pc:spChg>
        <pc:spChg chg="add mod">
          <ac:chgData name="Devkar, Vikas" userId="acbd15ec-55d1-4a76-83ac-3f1d82711ed5" providerId="ADAL" clId="{1D085DC7-27BE-49ED-AA59-AC68119ECF15}" dt="2024-03-28T15:06:33.976" v="736" actId="1076"/>
          <ac:spMkLst>
            <pc:docMk/>
            <pc:sldMk cId="1845444862" sldId="265"/>
            <ac:spMk id="13" creationId="{6A9B68CA-D400-36D4-88CB-67F5BB5AE7A3}"/>
          </ac:spMkLst>
        </pc:spChg>
        <pc:spChg chg="add mod">
          <ac:chgData name="Devkar, Vikas" userId="acbd15ec-55d1-4a76-83ac-3f1d82711ed5" providerId="ADAL" clId="{1D085DC7-27BE-49ED-AA59-AC68119ECF15}" dt="2024-03-28T15:06:37.835" v="754" actId="1038"/>
          <ac:spMkLst>
            <pc:docMk/>
            <pc:sldMk cId="1845444862" sldId="265"/>
            <ac:spMk id="14" creationId="{5A725DE5-9187-BA40-134A-A9C92C580A23}"/>
          </ac:spMkLst>
        </pc:spChg>
        <pc:picChg chg="mod modCrop">
          <ac:chgData name="Devkar, Vikas" userId="acbd15ec-55d1-4a76-83ac-3f1d82711ed5" providerId="ADAL" clId="{1D085DC7-27BE-49ED-AA59-AC68119ECF15}" dt="2024-04-01T00:31:50.613" v="1175" actId="1076"/>
          <ac:picMkLst>
            <pc:docMk/>
            <pc:sldMk cId="1845444862" sldId="265"/>
            <ac:picMk id="2" creationId="{28FBD11A-D19F-DB78-8829-8C8157B0FAFF}"/>
          </ac:picMkLst>
        </pc:picChg>
        <pc:picChg chg="mod modCrop">
          <ac:chgData name="Devkar, Vikas" userId="acbd15ec-55d1-4a76-83ac-3f1d82711ed5" providerId="ADAL" clId="{1D085DC7-27BE-49ED-AA59-AC68119ECF15}" dt="2024-03-28T14:50:27.058" v="326" actId="732"/>
          <ac:picMkLst>
            <pc:docMk/>
            <pc:sldMk cId="1845444862" sldId="265"/>
            <ac:picMk id="6" creationId="{8918A5F2-2F5A-933D-0122-EE33CC2DE2E0}"/>
          </ac:picMkLst>
        </pc:picChg>
      </pc:sldChg>
      <pc:sldChg chg="addSp modSp mod">
        <pc:chgData name="Devkar, Vikas" userId="acbd15ec-55d1-4a76-83ac-3f1d82711ed5" providerId="ADAL" clId="{1D085DC7-27BE-49ED-AA59-AC68119ECF15}" dt="2024-04-01T00:45:40.306" v="1475" actId="20577"/>
        <pc:sldMkLst>
          <pc:docMk/>
          <pc:sldMk cId="417503466" sldId="266"/>
        </pc:sldMkLst>
        <pc:spChg chg="add mod">
          <ac:chgData name="Devkar, Vikas" userId="acbd15ec-55d1-4a76-83ac-3f1d82711ed5" providerId="ADAL" clId="{1D085DC7-27BE-49ED-AA59-AC68119ECF15}" dt="2024-03-28T15:04:05.396" v="681" actId="1076"/>
          <ac:spMkLst>
            <pc:docMk/>
            <pc:sldMk cId="417503466" sldId="266"/>
            <ac:spMk id="2" creationId="{947B93A9-A70A-A148-197E-C2100B867378}"/>
          </ac:spMkLst>
        </pc:spChg>
        <pc:spChg chg="add mod">
          <ac:chgData name="Devkar, Vikas" userId="acbd15ec-55d1-4a76-83ac-3f1d82711ed5" providerId="ADAL" clId="{1D085DC7-27BE-49ED-AA59-AC68119ECF15}" dt="2024-03-28T15:04:07.827" v="682" actId="1076"/>
          <ac:spMkLst>
            <pc:docMk/>
            <pc:sldMk cId="417503466" sldId="266"/>
            <ac:spMk id="3" creationId="{34D27793-5376-A222-0EE6-6D27105549A1}"/>
          </ac:spMkLst>
        </pc:spChg>
        <pc:spChg chg="mod">
          <ac:chgData name="Devkar, Vikas" userId="acbd15ec-55d1-4a76-83ac-3f1d82711ed5" providerId="ADAL" clId="{1D085DC7-27BE-49ED-AA59-AC68119ECF15}" dt="2024-04-01T00:45:40.306" v="1475" actId="20577"/>
          <ac:spMkLst>
            <pc:docMk/>
            <pc:sldMk cId="417503466" sldId="266"/>
            <ac:spMk id="4" creationId="{F1480AE0-CD30-03E5-6124-496AC4D0B0E4}"/>
          </ac:spMkLst>
        </pc:spChg>
        <pc:spChg chg="mod">
          <ac:chgData name="Devkar, Vikas" userId="acbd15ec-55d1-4a76-83ac-3f1d82711ed5" providerId="ADAL" clId="{1D085DC7-27BE-49ED-AA59-AC68119ECF15}" dt="2024-04-01T00:32:14.688" v="1191" actId="1037"/>
          <ac:spMkLst>
            <pc:docMk/>
            <pc:sldMk cId="417503466" sldId="266"/>
            <ac:spMk id="7" creationId="{E1BDD04C-A68A-4796-F239-C8C2E0278FBB}"/>
          </ac:spMkLst>
        </pc:spChg>
        <pc:picChg chg="mod modCrop">
          <ac:chgData name="Devkar, Vikas" userId="acbd15ec-55d1-4a76-83ac-3f1d82711ed5" providerId="ADAL" clId="{1D085DC7-27BE-49ED-AA59-AC68119ECF15}" dt="2024-03-28T14:54:32.640" v="438" actId="732"/>
          <ac:picMkLst>
            <pc:docMk/>
            <pc:sldMk cId="417503466" sldId="266"/>
            <ac:picMk id="5" creationId="{A6141967-F6D9-7A68-3840-66656DA838B0}"/>
          </ac:picMkLst>
        </pc:picChg>
      </pc:sldChg>
      <pc:sldChg chg="addSp delSp modSp mod">
        <pc:chgData name="Devkar, Vikas" userId="acbd15ec-55d1-4a76-83ac-3f1d82711ed5" providerId="ADAL" clId="{1D085DC7-27BE-49ED-AA59-AC68119ECF15}" dt="2024-04-01T00:31:32.537" v="1173" actId="1076"/>
        <pc:sldMkLst>
          <pc:docMk/>
          <pc:sldMk cId="1922289499" sldId="267"/>
        </pc:sldMkLst>
        <pc:spChg chg="mod">
          <ac:chgData name="Devkar, Vikas" userId="acbd15ec-55d1-4a76-83ac-3f1d82711ed5" providerId="ADAL" clId="{1D085DC7-27BE-49ED-AA59-AC68119ECF15}" dt="2024-03-28T14:48:28.415" v="264" actId="1076"/>
          <ac:spMkLst>
            <pc:docMk/>
            <pc:sldMk cId="1922289499" sldId="267"/>
            <ac:spMk id="3" creationId="{853A69FC-E3DE-DF53-7C7B-54203620809C}"/>
          </ac:spMkLst>
        </pc:spChg>
        <pc:spChg chg="add del mod">
          <ac:chgData name="Devkar, Vikas" userId="acbd15ec-55d1-4a76-83ac-3f1d82711ed5" providerId="ADAL" clId="{1D085DC7-27BE-49ED-AA59-AC68119ECF15}" dt="2024-03-28T15:05:26.850" v="698" actId="478"/>
          <ac:spMkLst>
            <pc:docMk/>
            <pc:sldMk cId="1922289499" sldId="267"/>
            <ac:spMk id="4" creationId="{BD3A349A-E2FA-F863-D652-530C05C381BD}"/>
          </ac:spMkLst>
        </pc:spChg>
        <pc:spChg chg="add del mod">
          <ac:chgData name="Devkar, Vikas" userId="acbd15ec-55d1-4a76-83ac-3f1d82711ed5" providerId="ADAL" clId="{1D085DC7-27BE-49ED-AA59-AC68119ECF15}" dt="2024-03-28T15:05:27.513" v="699" actId="478"/>
          <ac:spMkLst>
            <pc:docMk/>
            <pc:sldMk cId="1922289499" sldId="267"/>
            <ac:spMk id="6" creationId="{2073BA2D-F70B-608A-7638-3A4660BE3E0E}"/>
          </ac:spMkLst>
        </pc:spChg>
        <pc:spChg chg="mod">
          <ac:chgData name="Devkar, Vikas" userId="acbd15ec-55d1-4a76-83ac-3f1d82711ed5" providerId="ADAL" clId="{1D085DC7-27BE-49ED-AA59-AC68119ECF15}" dt="2024-04-01T00:31:32.537" v="1173" actId="1076"/>
          <ac:spMkLst>
            <pc:docMk/>
            <pc:sldMk cId="1922289499" sldId="267"/>
            <ac:spMk id="8" creationId="{A373B488-B0CF-2144-1213-219AA7C07B87}"/>
          </ac:spMkLst>
        </pc:spChg>
        <pc:spChg chg="add del mod">
          <ac:chgData name="Devkar, Vikas" userId="acbd15ec-55d1-4a76-83ac-3f1d82711ed5" providerId="ADAL" clId="{1D085DC7-27BE-49ED-AA59-AC68119ECF15}" dt="2024-03-28T15:05:28.224" v="700" actId="478"/>
          <ac:spMkLst>
            <pc:docMk/>
            <pc:sldMk cId="1922289499" sldId="267"/>
            <ac:spMk id="9" creationId="{4D6E06A3-EA87-F18B-D507-163A3B23F3E2}"/>
          </ac:spMkLst>
        </pc:spChg>
        <pc:spChg chg="mod">
          <ac:chgData name="Devkar, Vikas" userId="acbd15ec-55d1-4a76-83ac-3f1d82711ed5" providerId="ADAL" clId="{1D085DC7-27BE-49ED-AA59-AC68119ECF15}" dt="2024-03-28T14:48:30.973" v="265" actId="1076"/>
          <ac:spMkLst>
            <pc:docMk/>
            <pc:sldMk cId="1922289499" sldId="267"/>
            <ac:spMk id="10" creationId="{B5AED450-D013-032F-CB22-1E452FB97610}"/>
          </ac:spMkLst>
        </pc:spChg>
        <pc:spChg chg="mod">
          <ac:chgData name="Devkar, Vikas" userId="acbd15ec-55d1-4a76-83ac-3f1d82711ed5" providerId="ADAL" clId="{1D085DC7-27BE-49ED-AA59-AC68119ECF15}" dt="2024-03-28T14:48:32.773" v="266" actId="1076"/>
          <ac:spMkLst>
            <pc:docMk/>
            <pc:sldMk cId="1922289499" sldId="267"/>
            <ac:spMk id="11" creationId="{50C299BE-1C3F-2925-72B9-F8948525BD30}"/>
          </ac:spMkLst>
        </pc:spChg>
        <pc:spChg chg="add del mod">
          <ac:chgData name="Devkar, Vikas" userId="acbd15ec-55d1-4a76-83ac-3f1d82711ed5" providerId="ADAL" clId="{1D085DC7-27BE-49ED-AA59-AC68119ECF15}" dt="2024-03-28T15:05:28.872" v="701" actId="478"/>
          <ac:spMkLst>
            <pc:docMk/>
            <pc:sldMk cId="1922289499" sldId="267"/>
            <ac:spMk id="12" creationId="{78A77FA6-DCF4-E7AB-E6C3-7A2A861021E2}"/>
          </ac:spMkLst>
        </pc:spChg>
        <pc:spChg chg="add del mod">
          <ac:chgData name="Devkar, Vikas" userId="acbd15ec-55d1-4a76-83ac-3f1d82711ed5" providerId="ADAL" clId="{1D085DC7-27BE-49ED-AA59-AC68119ECF15}" dt="2024-03-28T15:05:29.662" v="702" actId="478"/>
          <ac:spMkLst>
            <pc:docMk/>
            <pc:sldMk cId="1922289499" sldId="267"/>
            <ac:spMk id="13" creationId="{5915EBAE-FDC1-571C-8C33-420FD9942D30}"/>
          </ac:spMkLst>
        </pc:spChg>
        <pc:spChg chg="add del mod">
          <ac:chgData name="Devkar, Vikas" userId="acbd15ec-55d1-4a76-83ac-3f1d82711ed5" providerId="ADAL" clId="{1D085DC7-27BE-49ED-AA59-AC68119ECF15}" dt="2024-03-28T15:05:30.373" v="703" actId="478"/>
          <ac:spMkLst>
            <pc:docMk/>
            <pc:sldMk cId="1922289499" sldId="267"/>
            <ac:spMk id="14" creationId="{6C86D4A7-F11D-25C3-4B51-1B48911341F2}"/>
          </ac:spMkLst>
        </pc:spChg>
        <pc:spChg chg="add mod">
          <ac:chgData name="Devkar, Vikas" userId="acbd15ec-55d1-4a76-83ac-3f1d82711ed5" providerId="ADAL" clId="{1D085DC7-27BE-49ED-AA59-AC68119ECF15}" dt="2024-03-28T15:06:09.544" v="726" actId="1037"/>
          <ac:spMkLst>
            <pc:docMk/>
            <pc:sldMk cId="1922289499" sldId="267"/>
            <ac:spMk id="15" creationId="{08F2D0CC-C185-67DD-F939-47DF98C212D5}"/>
          </ac:spMkLst>
        </pc:spChg>
        <pc:spChg chg="add mod">
          <ac:chgData name="Devkar, Vikas" userId="acbd15ec-55d1-4a76-83ac-3f1d82711ed5" providerId="ADAL" clId="{1D085DC7-27BE-49ED-AA59-AC68119ECF15}" dt="2024-03-28T15:06:07.394" v="722" actId="1038"/>
          <ac:spMkLst>
            <pc:docMk/>
            <pc:sldMk cId="1922289499" sldId="267"/>
            <ac:spMk id="16" creationId="{6A6E020C-0615-B183-C26A-550772B53CDD}"/>
          </ac:spMkLst>
        </pc:spChg>
        <pc:spChg chg="add mod">
          <ac:chgData name="Devkar, Vikas" userId="acbd15ec-55d1-4a76-83ac-3f1d82711ed5" providerId="ADAL" clId="{1D085DC7-27BE-49ED-AA59-AC68119ECF15}" dt="2024-03-28T15:06:05.157" v="719" actId="1037"/>
          <ac:spMkLst>
            <pc:docMk/>
            <pc:sldMk cId="1922289499" sldId="267"/>
            <ac:spMk id="17" creationId="{C71765D5-0446-1E41-5E57-A5535276FBC7}"/>
          </ac:spMkLst>
        </pc:spChg>
        <pc:spChg chg="add mod">
          <ac:chgData name="Devkar, Vikas" userId="acbd15ec-55d1-4a76-83ac-3f1d82711ed5" providerId="ADAL" clId="{1D085DC7-27BE-49ED-AA59-AC68119ECF15}" dt="2024-03-28T15:06:02.603" v="715" actId="1038"/>
          <ac:spMkLst>
            <pc:docMk/>
            <pc:sldMk cId="1922289499" sldId="267"/>
            <ac:spMk id="18" creationId="{01E12F72-E81A-6674-EE8E-24CF7C6E0999}"/>
          </ac:spMkLst>
        </pc:spChg>
        <pc:spChg chg="add mod">
          <ac:chgData name="Devkar, Vikas" userId="acbd15ec-55d1-4a76-83ac-3f1d82711ed5" providerId="ADAL" clId="{1D085DC7-27BE-49ED-AA59-AC68119ECF15}" dt="2024-03-28T15:05:49.425" v="709" actId="1076"/>
          <ac:spMkLst>
            <pc:docMk/>
            <pc:sldMk cId="1922289499" sldId="267"/>
            <ac:spMk id="19" creationId="{1388A5AF-7740-49DB-3B68-CAF9E2AACFB9}"/>
          </ac:spMkLst>
        </pc:spChg>
        <pc:spChg chg="add mod">
          <ac:chgData name="Devkar, Vikas" userId="acbd15ec-55d1-4a76-83ac-3f1d82711ed5" providerId="ADAL" clId="{1D085DC7-27BE-49ED-AA59-AC68119ECF15}" dt="2024-03-28T15:05:58.443" v="710" actId="1076"/>
          <ac:spMkLst>
            <pc:docMk/>
            <pc:sldMk cId="1922289499" sldId="267"/>
            <ac:spMk id="20" creationId="{2345B44C-34BF-075B-D926-A52D374933A0}"/>
          </ac:spMkLst>
        </pc:spChg>
        <pc:picChg chg="mod modCrop">
          <ac:chgData name="Devkar, Vikas" userId="acbd15ec-55d1-4a76-83ac-3f1d82711ed5" providerId="ADAL" clId="{1D085DC7-27BE-49ED-AA59-AC68119ECF15}" dt="2024-03-28T14:48:24.616" v="263" actId="1076"/>
          <ac:picMkLst>
            <pc:docMk/>
            <pc:sldMk cId="1922289499" sldId="267"/>
            <ac:picMk id="2" creationId="{2643B9DB-271B-8EEF-6A22-874DD8D20787}"/>
          </ac:picMkLst>
        </pc:picChg>
        <pc:picChg chg="mod modCrop">
          <ac:chgData name="Devkar, Vikas" userId="acbd15ec-55d1-4a76-83ac-3f1d82711ed5" providerId="ADAL" clId="{1D085DC7-27BE-49ED-AA59-AC68119ECF15}" dt="2024-03-28T14:47:31.502" v="251" actId="732"/>
          <ac:picMkLst>
            <pc:docMk/>
            <pc:sldMk cId="1922289499" sldId="267"/>
            <ac:picMk id="5" creationId="{AA86745D-3D68-E449-B450-B838D6F49851}"/>
          </ac:picMkLst>
        </pc:picChg>
        <pc:picChg chg="mod modCrop">
          <ac:chgData name="Devkar, Vikas" userId="acbd15ec-55d1-4a76-83ac-3f1d82711ed5" providerId="ADAL" clId="{1D085DC7-27BE-49ED-AA59-AC68119ECF15}" dt="2024-03-28T14:48:20.695" v="262" actId="1076"/>
          <ac:picMkLst>
            <pc:docMk/>
            <pc:sldMk cId="1922289499" sldId="267"/>
            <ac:picMk id="7" creationId="{60CF31E5-4C3A-F7A3-4BCF-F8236B1D265F}"/>
          </ac:picMkLst>
        </pc:picChg>
      </pc:sldChg>
      <pc:sldChg chg="modSp mod">
        <pc:chgData name="Devkar, Vikas" userId="acbd15ec-55d1-4a76-83ac-3f1d82711ed5" providerId="ADAL" clId="{1D085DC7-27BE-49ED-AA59-AC68119ECF15}" dt="2024-04-01T18:50:34.365" v="1516" actId="113"/>
        <pc:sldMkLst>
          <pc:docMk/>
          <pc:sldMk cId="3436963830" sldId="268"/>
        </pc:sldMkLst>
        <pc:spChg chg="mod">
          <ac:chgData name="Devkar, Vikas" userId="acbd15ec-55d1-4a76-83ac-3f1d82711ed5" providerId="ADAL" clId="{1D085DC7-27BE-49ED-AA59-AC68119ECF15}" dt="2024-04-01T00:33:23.849" v="1289" actId="1036"/>
          <ac:spMkLst>
            <pc:docMk/>
            <pc:sldMk cId="3436963830" sldId="268"/>
            <ac:spMk id="2" creationId="{768ADAE3-6334-88B4-1D66-D57F1415B718}"/>
          </ac:spMkLst>
        </pc:spChg>
        <pc:spChg chg="mod">
          <ac:chgData name="Devkar, Vikas" userId="acbd15ec-55d1-4a76-83ac-3f1d82711ed5" providerId="ADAL" clId="{1D085DC7-27BE-49ED-AA59-AC68119ECF15}" dt="2024-03-28T14:55:24.664" v="449" actId="2711"/>
          <ac:spMkLst>
            <pc:docMk/>
            <pc:sldMk cId="3436963830" sldId="268"/>
            <ac:spMk id="3" creationId="{844CC83F-FB26-61D6-19AD-52B1310FEFF8}"/>
          </ac:spMkLst>
        </pc:spChg>
        <pc:spChg chg="mod">
          <ac:chgData name="Devkar, Vikas" userId="acbd15ec-55d1-4a76-83ac-3f1d82711ed5" providerId="ADAL" clId="{1D085DC7-27BE-49ED-AA59-AC68119ECF15}" dt="2024-04-01T18:50:34.365" v="1516" actId="113"/>
          <ac:spMkLst>
            <pc:docMk/>
            <pc:sldMk cId="3436963830" sldId="268"/>
            <ac:spMk id="4" creationId="{E9ABEC9B-7711-5DEE-1919-B3C572856D23}"/>
          </ac:spMkLst>
        </pc:spChg>
        <pc:spChg chg="mod">
          <ac:chgData name="Devkar, Vikas" userId="acbd15ec-55d1-4a76-83ac-3f1d82711ed5" providerId="ADAL" clId="{1D085DC7-27BE-49ED-AA59-AC68119ECF15}" dt="2024-03-28T14:55:24.664" v="449" actId="2711"/>
          <ac:spMkLst>
            <pc:docMk/>
            <pc:sldMk cId="3436963830" sldId="268"/>
            <ac:spMk id="5" creationId="{8960662B-F76F-2080-DE80-0C3E6D4E7450}"/>
          </ac:spMkLst>
        </pc:spChg>
        <pc:spChg chg="mod">
          <ac:chgData name="Devkar, Vikas" userId="acbd15ec-55d1-4a76-83ac-3f1d82711ed5" providerId="ADAL" clId="{1D085DC7-27BE-49ED-AA59-AC68119ECF15}" dt="2024-03-28T14:55:24.664" v="449" actId="2711"/>
          <ac:spMkLst>
            <pc:docMk/>
            <pc:sldMk cId="3436963830" sldId="268"/>
            <ac:spMk id="6" creationId="{BAD975C2-5195-6554-8FD0-947A298FE51E}"/>
          </ac:spMkLst>
        </pc:spChg>
        <pc:spChg chg="mod">
          <ac:chgData name="Devkar, Vikas" userId="acbd15ec-55d1-4a76-83ac-3f1d82711ed5" providerId="ADAL" clId="{1D085DC7-27BE-49ED-AA59-AC68119ECF15}" dt="2024-04-01T00:33:18.071" v="1274" actId="1036"/>
          <ac:spMkLst>
            <pc:docMk/>
            <pc:sldMk cId="3436963830" sldId="268"/>
            <ac:spMk id="7" creationId="{687D80C2-7157-82E2-4F15-E738AACCD512}"/>
          </ac:spMkLst>
        </pc:spChg>
        <pc:spChg chg="mod">
          <ac:chgData name="Devkar, Vikas" userId="acbd15ec-55d1-4a76-83ac-3f1d82711ed5" providerId="ADAL" clId="{1D085DC7-27BE-49ED-AA59-AC68119ECF15}" dt="2024-03-28T14:55:24.664" v="449" actId="2711"/>
          <ac:spMkLst>
            <pc:docMk/>
            <pc:sldMk cId="3436963830" sldId="268"/>
            <ac:spMk id="9" creationId="{A445E8BB-8C62-23B5-665E-0E77CE890546}"/>
          </ac:spMkLst>
        </pc:spChg>
        <pc:spChg chg="mod">
          <ac:chgData name="Devkar, Vikas" userId="acbd15ec-55d1-4a76-83ac-3f1d82711ed5" providerId="ADAL" clId="{1D085DC7-27BE-49ED-AA59-AC68119ECF15}" dt="2024-03-28T14:55:24.664" v="449" actId="2711"/>
          <ac:spMkLst>
            <pc:docMk/>
            <pc:sldMk cId="3436963830" sldId="268"/>
            <ac:spMk id="10" creationId="{A2A2E485-B177-38CE-A4D3-E66D355631FB}"/>
          </ac:spMkLst>
        </pc:spChg>
        <pc:spChg chg="mod">
          <ac:chgData name="Devkar, Vikas" userId="acbd15ec-55d1-4a76-83ac-3f1d82711ed5" providerId="ADAL" clId="{1D085DC7-27BE-49ED-AA59-AC68119ECF15}" dt="2024-03-28T14:55:24.664" v="449" actId="2711"/>
          <ac:spMkLst>
            <pc:docMk/>
            <pc:sldMk cId="3436963830" sldId="268"/>
            <ac:spMk id="11" creationId="{2E373D25-1465-3B00-6D60-0393E93954B5}"/>
          </ac:spMkLst>
        </pc:spChg>
        <pc:spChg chg="mod">
          <ac:chgData name="Devkar, Vikas" userId="acbd15ec-55d1-4a76-83ac-3f1d82711ed5" providerId="ADAL" clId="{1D085DC7-27BE-49ED-AA59-AC68119ECF15}" dt="2024-03-28T14:55:24.664" v="449" actId="2711"/>
          <ac:spMkLst>
            <pc:docMk/>
            <pc:sldMk cId="3436963830" sldId="268"/>
            <ac:spMk id="12" creationId="{20CC143D-52B9-5A3A-2FE2-1A36A52483C7}"/>
          </ac:spMkLst>
        </pc:spChg>
        <pc:spChg chg="mod">
          <ac:chgData name="Devkar, Vikas" userId="acbd15ec-55d1-4a76-83ac-3f1d82711ed5" providerId="ADAL" clId="{1D085DC7-27BE-49ED-AA59-AC68119ECF15}" dt="2024-03-28T14:55:24.664" v="449" actId="2711"/>
          <ac:spMkLst>
            <pc:docMk/>
            <pc:sldMk cId="3436963830" sldId="268"/>
            <ac:spMk id="13" creationId="{9BF13D69-9B0F-AA2D-89C7-FD50694D357B}"/>
          </ac:spMkLst>
        </pc:spChg>
        <pc:spChg chg="mod">
          <ac:chgData name="Devkar, Vikas" userId="acbd15ec-55d1-4a76-83ac-3f1d82711ed5" providerId="ADAL" clId="{1D085DC7-27BE-49ED-AA59-AC68119ECF15}" dt="2024-03-28T14:55:24.664" v="449" actId="2711"/>
          <ac:spMkLst>
            <pc:docMk/>
            <pc:sldMk cId="3436963830" sldId="268"/>
            <ac:spMk id="15" creationId="{C42B5232-858A-FF08-0929-C04AC307F99E}"/>
          </ac:spMkLst>
        </pc:spChg>
        <pc:spChg chg="mod">
          <ac:chgData name="Devkar, Vikas" userId="acbd15ec-55d1-4a76-83ac-3f1d82711ed5" providerId="ADAL" clId="{1D085DC7-27BE-49ED-AA59-AC68119ECF15}" dt="2024-03-28T14:55:24.664" v="449" actId="2711"/>
          <ac:spMkLst>
            <pc:docMk/>
            <pc:sldMk cId="3436963830" sldId="268"/>
            <ac:spMk id="17" creationId="{D114B789-559F-75F6-8FC6-CA9299F19C0B}"/>
          </ac:spMkLst>
        </pc:spChg>
        <pc:spChg chg="mod">
          <ac:chgData name="Devkar, Vikas" userId="acbd15ec-55d1-4a76-83ac-3f1d82711ed5" providerId="ADAL" clId="{1D085DC7-27BE-49ED-AA59-AC68119ECF15}" dt="2024-03-28T14:55:24.664" v="449" actId="2711"/>
          <ac:spMkLst>
            <pc:docMk/>
            <pc:sldMk cId="3436963830" sldId="268"/>
            <ac:spMk id="18" creationId="{960DF679-7213-653B-F493-8B5F28F4D5E8}"/>
          </ac:spMkLst>
        </pc:spChg>
        <pc:spChg chg="mod">
          <ac:chgData name="Devkar, Vikas" userId="acbd15ec-55d1-4a76-83ac-3f1d82711ed5" providerId="ADAL" clId="{1D085DC7-27BE-49ED-AA59-AC68119ECF15}" dt="2024-03-28T14:55:24.664" v="449" actId="2711"/>
          <ac:spMkLst>
            <pc:docMk/>
            <pc:sldMk cId="3436963830" sldId="268"/>
            <ac:spMk id="19" creationId="{B8E01842-BC3E-B15D-6CCB-C2981BD13501}"/>
          </ac:spMkLst>
        </pc:spChg>
        <pc:spChg chg="mod">
          <ac:chgData name="Devkar, Vikas" userId="acbd15ec-55d1-4a76-83ac-3f1d82711ed5" providerId="ADAL" clId="{1D085DC7-27BE-49ED-AA59-AC68119ECF15}" dt="2024-03-28T14:55:24.664" v="449" actId="2711"/>
          <ac:spMkLst>
            <pc:docMk/>
            <pc:sldMk cId="3436963830" sldId="268"/>
            <ac:spMk id="20" creationId="{584CA6F3-4056-44C8-4705-A020560CEA68}"/>
          </ac:spMkLst>
        </pc:spChg>
        <pc:spChg chg="mod">
          <ac:chgData name="Devkar, Vikas" userId="acbd15ec-55d1-4a76-83ac-3f1d82711ed5" providerId="ADAL" clId="{1D085DC7-27BE-49ED-AA59-AC68119ECF15}" dt="2024-03-28T14:55:24.664" v="449" actId="2711"/>
          <ac:spMkLst>
            <pc:docMk/>
            <pc:sldMk cId="3436963830" sldId="268"/>
            <ac:spMk id="21" creationId="{F19AB2DB-42E8-1B34-0B27-FFE25348E6BF}"/>
          </ac:spMkLst>
        </pc:spChg>
        <pc:spChg chg="mod">
          <ac:chgData name="Devkar, Vikas" userId="acbd15ec-55d1-4a76-83ac-3f1d82711ed5" providerId="ADAL" clId="{1D085DC7-27BE-49ED-AA59-AC68119ECF15}" dt="2024-03-28T14:55:24.664" v="449" actId="2711"/>
          <ac:spMkLst>
            <pc:docMk/>
            <pc:sldMk cId="3436963830" sldId="268"/>
            <ac:spMk id="22" creationId="{4A4ABF86-6944-3665-C48A-F7A09380ECC1}"/>
          </ac:spMkLst>
        </pc:spChg>
        <pc:spChg chg="mod">
          <ac:chgData name="Devkar, Vikas" userId="acbd15ec-55d1-4a76-83ac-3f1d82711ed5" providerId="ADAL" clId="{1D085DC7-27BE-49ED-AA59-AC68119ECF15}" dt="2024-03-28T14:55:24.664" v="449" actId="2711"/>
          <ac:spMkLst>
            <pc:docMk/>
            <pc:sldMk cId="3436963830" sldId="268"/>
            <ac:spMk id="23" creationId="{FB5CF552-A5E3-4F48-1AD1-D0608C575C78}"/>
          </ac:spMkLst>
        </pc:spChg>
        <pc:spChg chg="mod">
          <ac:chgData name="Devkar, Vikas" userId="acbd15ec-55d1-4a76-83ac-3f1d82711ed5" providerId="ADAL" clId="{1D085DC7-27BE-49ED-AA59-AC68119ECF15}" dt="2024-03-28T14:55:24.664" v="449" actId="2711"/>
          <ac:spMkLst>
            <pc:docMk/>
            <pc:sldMk cId="3436963830" sldId="268"/>
            <ac:spMk id="24" creationId="{A66CC2DF-12A6-0086-DDB5-997D388CA85E}"/>
          </ac:spMkLst>
        </pc:spChg>
        <pc:spChg chg="mod">
          <ac:chgData name="Devkar, Vikas" userId="acbd15ec-55d1-4a76-83ac-3f1d82711ed5" providerId="ADAL" clId="{1D085DC7-27BE-49ED-AA59-AC68119ECF15}" dt="2024-03-28T14:55:24.664" v="449" actId="2711"/>
          <ac:spMkLst>
            <pc:docMk/>
            <pc:sldMk cId="3436963830" sldId="268"/>
            <ac:spMk id="25" creationId="{808A03A3-9D71-A24D-AC3D-D7C07236328A}"/>
          </ac:spMkLst>
        </pc:spChg>
        <pc:grpChg chg="mod">
          <ac:chgData name="Devkar, Vikas" userId="acbd15ec-55d1-4a76-83ac-3f1d82711ed5" providerId="ADAL" clId="{1D085DC7-27BE-49ED-AA59-AC68119ECF15}" dt="2024-04-01T00:32:51.268" v="1196" actId="1076"/>
          <ac:grpSpMkLst>
            <pc:docMk/>
            <pc:sldMk cId="3436963830" sldId="268"/>
            <ac:grpSpMk id="26" creationId="{93FF2E7F-9493-4BB3-2936-2A170B084C33}"/>
          </ac:grpSpMkLst>
        </pc:grpChg>
        <pc:grpChg chg="mod">
          <ac:chgData name="Devkar, Vikas" userId="acbd15ec-55d1-4a76-83ac-3f1d82711ed5" providerId="ADAL" clId="{1D085DC7-27BE-49ED-AA59-AC68119ECF15}" dt="2024-04-01T00:32:51.268" v="1196" actId="1076"/>
          <ac:grpSpMkLst>
            <pc:docMk/>
            <pc:sldMk cId="3436963830" sldId="268"/>
            <ac:grpSpMk id="27" creationId="{67B25A3F-81F5-AA0C-689D-CB2DEE57F6E2}"/>
          </ac:grpSpMkLst>
        </pc:grpChg>
      </pc:sldChg>
      <pc:sldChg chg="addSp modSp mod">
        <pc:chgData name="Devkar, Vikas" userId="acbd15ec-55d1-4a76-83ac-3f1d82711ed5" providerId="ADAL" clId="{1D085DC7-27BE-49ED-AA59-AC68119ECF15}" dt="2024-04-01T00:33:57.664" v="1294" actId="14100"/>
        <pc:sldMkLst>
          <pc:docMk/>
          <pc:sldMk cId="941570768" sldId="271"/>
        </pc:sldMkLst>
        <pc:spChg chg="add mod">
          <ac:chgData name="Devkar, Vikas" userId="acbd15ec-55d1-4a76-83ac-3f1d82711ed5" providerId="ADAL" clId="{1D085DC7-27BE-49ED-AA59-AC68119ECF15}" dt="2024-03-28T15:18:43.867" v="1044" actId="164"/>
          <ac:spMkLst>
            <pc:docMk/>
            <pc:sldMk cId="941570768" sldId="271"/>
            <ac:spMk id="2" creationId="{2EB21F62-C436-6564-0995-ABB8D3D259F0}"/>
          </ac:spMkLst>
        </pc:spChg>
        <pc:spChg chg="add mod">
          <ac:chgData name="Devkar, Vikas" userId="acbd15ec-55d1-4a76-83ac-3f1d82711ed5" providerId="ADAL" clId="{1D085DC7-27BE-49ED-AA59-AC68119ECF15}" dt="2024-03-28T15:18:43.867" v="1044" actId="164"/>
          <ac:spMkLst>
            <pc:docMk/>
            <pc:sldMk cId="941570768" sldId="271"/>
            <ac:spMk id="3" creationId="{A0DFAA35-FB71-E974-E3E1-5430C9A1CFA2}"/>
          </ac:spMkLst>
        </pc:spChg>
        <pc:spChg chg="add mod">
          <ac:chgData name="Devkar, Vikas" userId="acbd15ec-55d1-4a76-83ac-3f1d82711ed5" providerId="ADAL" clId="{1D085DC7-27BE-49ED-AA59-AC68119ECF15}" dt="2024-03-28T15:18:43.867" v="1044" actId="164"/>
          <ac:spMkLst>
            <pc:docMk/>
            <pc:sldMk cId="941570768" sldId="271"/>
            <ac:spMk id="4" creationId="{EB706579-382C-91AE-A253-8ABA917D46F5}"/>
          </ac:spMkLst>
        </pc:spChg>
        <pc:spChg chg="mod">
          <ac:chgData name="Devkar, Vikas" userId="acbd15ec-55d1-4a76-83ac-3f1d82711ed5" providerId="ADAL" clId="{1D085DC7-27BE-49ED-AA59-AC68119ECF15}" dt="2024-04-01T00:33:57.664" v="1294" actId="14100"/>
          <ac:spMkLst>
            <pc:docMk/>
            <pc:sldMk cId="941570768" sldId="271"/>
            <ac:spMk id="5" creationId="{E880AF6A-641C-F67F-BA37-ED8AA5C0C046}"/>
          </ac:spMkLst>
        </pc:spChg>
        <pc:grpChg chg="add mod">
          <ac:chgData name="Devkar, Vikas" userId="acbd15ec-55d1-4a76-83ac-3f1d82711ed5" providerId="ADAL" clId="{1D085DC7-27BE-49ED-AA59-AC68119ECF15}" dt="2024-03-28T15:19:20.263" v="1050" actId="1076"/>
          <ac:grpSpMkLst>
            <pc:docMk/>
            <pc:sldMk cId="941570768" sldId="271"/>
            <ac:grpSpMk id="6" creationId="{C8B11F69-8F86-4D40-56A4-13AE39FF4C0B}"/>
          </ac:grpSpMkLst>
        </pc:grpChg>
        <pc:grpChg chg="mod">
          <ac:chgData name="Devkar, Vikas" userId="acbd15ec-55d1-4a76-83ac-3f1d82711ed5" providerId="ADAL" clId="{1D085DC7-27BE-49ED-AA59-AC68119ECF15}" dt="2024-03-28T15:18:43.867" v="1044" actId="164"/>
          <ac:grpSpMkLst>
            <pc:docMk/>
            <pc:sldMk cId="941570768" sldId="271"/>
            <ac:grpSpMk id="10" creationId="{8583F6A4-9124-5271-0AAB-B5DA6B0A3B0A}"/>
          </ac:grpSpMkLst>
        </pc:grpChg>
        <pc:picChg chg="mod modCrop">
          <ac:chgData name="Devkar, Vikas" userId="acbd15ec-55d1-4a76-83ac-3f1d82711ed5" providerId="ADAL" clId="{1D085DC7-27BE-49ED-AA59-AC68119ECF15}" dt="2024-03-28T15:19:32.209" v="1052" actId="732"/>
          <ac:picMkLst>
            <pc:docMk/>
            <pc:sldMk cId="941570768" sldId="271"/>
            <ac:picMk id="8" creationId="{F28E4698-B4B2-FBFD-F248-233EAC108335}"/>
          </ac:picMkLst>
        </pc:picChg>
      </pc:sldChg>
      <pc:sldChg chg="addSp delSp modSp mod">
        <pc:chgData name="Devkar, Vikas" userId="acbd15ec-55d1-4a76-83ac-3f1d82711ed5" providerId="ADAL" clId="{1D085DC7-27BE-49ED-AA59-AC68119ECF15}" dt="2024-04-01T18:56:29.935" v="1553" actId="1037"/>
        <pc:sldMkLst>
          <pc:docMk/>
          <pc:sldMk cId="772256198" sldId="272"/>
        </pc:sldMkLst>
        <pc:spChg chg="add mod">
          <ac:chgData name="Devkar, Vikas" userId="acbd15ec-55d1-4a76-83ac-3f1d82711ed5" providerId="ADAL" clId="{1D085DC7-27BE-49ED-AA59-AC68119ECF15}" dt="2024-04-01T18:51:34.973" v="1536" actId="113"/>
          <ac:spMkLst>
            <pc:docMk/>
            <pc:sldMk cId="772256198" sldId="272"/>
            <ac:spMk id="2" creationId="{95DE3980-1221-E768-B463-21755D594504}"/>
          </ac:spMkLst>
        </pc:spChg>
        <pc:spChg chg="del mod">
          <ac:chgData name="Devkar, Vikas" userId="acbd15ec-55d1-4a76-83ac-3f1d82711ed5" providerId="ADAL" clId="{1D085DC7-27BE-49ED-AA59-AC68119ECF15}" dt="2024-04-01T00:43:17.426" v="1457" actId="478"/>
          <ac:spMkLst>
            <pc:docMk/>
            <pc:sldMk cId="772256198" sldId="272"/>
            <ac:spMk id="4" creationId="{E4C81445-1EAB-00F3-7486-62DEE31864C2}"/>
          </ac:spMkLst>
        </pc:spChg>
        <pc:spChg chg="mod">
          <ac:chgData name="Devkar, Vikas" userId="acbd15ec-55d1-4a76-83ac-3f1d82711ed5" providerId="ADAL" clId="{1D085DC7-27BE-49ED-AA59-AC68119ECF15}" dt="2024-03-28T15:17:30.775" v="1032" actId="1076"/>
          <ac:spMkLst>
            <pc:docMk/>
            <pc:sldMk cId="772256198" sldId="272"/>
            <ac:spMk id="6" creationId="{5D17B958-1EE1-0EA3-76AE-6760B4925FC0}"/>
          </ac:spMkLst>
        </pc:spChg>
        <pc:spChg chg="mod">
          <ac:chgData name="Devkar, Vikas" userId="acbd15ec-55d1-4a76-83ac-3f1d82711ed5" providerId="ADAL" clId="{1D085DC7-27BE-49ED-AA59-AC68119ECF15}" dt="2024-03-28T15:17:34.601" v="1033" actId="1076"/>
          <ac:spMkLst>
            <pc:docMk/>
            <pc:sldMk cId="772256198" sldId="272"/>
            <ac:spMk id="7" creationId="{123621FA-E058-F15D-98C3-361A69F62216}"/>
          </ac:spMkLst>
        </pc:spChg>
        <pc:spChg chg="mod">
          <ac:chgData name="Devkar, Vikas" userId="acbd15ec-55d1-4a76-83ac-3f1d82711ed5" providerId="ADAL" clId="{1D085DC7-27BE-49ED-AA59-AC68119ECF15}" dt="2024-04-01T00:35:30.892" v="1313" actId="1076"/>
          <ac:spMkLst>
            <pc:docMk/>
            <pc:sldMk cId="772256198" sldId="272"/>
            <ac:spMk id="8" creationId="{E57B8A66-9E60-47EC-F7ED-18211D405291}"/>
          </ac:spMkLst>
        </pc:spChg>
        <pc:spChg chg="mod topLvl">
          <ac:chgData name="Devkar, Vikas" userId="acbd15ec-55d1-4a76-83ac-3f1d82711ed5" providerId="ADAL" clId="{1D085DC7-27BE-49ED-AA59-AC68119ECF15}" dt="2024-04-01T00:36:33.806" v="1319" actId="165"/>
          <ac:spMkLst>
            <pc:docMk/>
            <pc:sldMk cId="772256198" sldId="272"/>
            <ac:spMk id="11" creationId="{8CC0804C-C58D-8565-0819-AE4128730A64}"/>
          </ac:spMkLst>
        </pc:spChg>
        <pc:spChg chg="mod">
          <ac:chgData name="Devkar, Vikas" userId="acbd15ec-55d1-4a76-83ac-3f1d82711ed5" providerId="ADAL" clId="{1D085DC7-27BE-49ED-AA59-AC68119ECF15}" dt="2024-03-28T15:17:41.110" v="1034" actId="1076"/>
          <ac:spMkLst>
            <pc:docMk/>
            <pc:sldMk cId="772256198" sldId="272"/>
            <ac:spMk id="12" creationId="{2AC9A58C-ED25-F3E1-254A-3BE36BA5018C}"/>
          </ac:spMkLst>
        </pc:spChg>
        <pc:spChg chg="mod">
          <ac:chgData name="Devkar, Vikas" userId="acbd15ec-55d1-4a76-83ac-3f1d82711ed5" providerId="ADAL" clId="{1D085DC7-27BE-49ED-AA59-AC68119ECF15}" dt="2024-03-28T15:30:59.355" v="1074" actId="1036"/>
          <ac:spMkLst>
            <pc:docMk/>
            <pc:sldMk cId="772256198" sldId="272"/>
            <ac:spMk id="13" creationId="{39823866-0E42-92D4-9B94-88BD0356A152}"/>
          </ac:spMkLst>
        </pc:spChg>
        <pc:spChg chg="mod topLvl">
          <ac:chgData name="Devkar, Vikas" userId="acbd15ec-55d1-4a76-83ac-3f1d82711ed5" providerId="ADAL" clId="{1D085DC7-27BE-49ED-AA59-AC68119ECF15}" dt="2024-04-01T00:37:08.752" v="1325" actId="114"/>
          <ac:spMkLst>
            <pc:docMk/>
            <pc:sldMk cId="772256198" sldId="272"/>
            <ac:spMk id="14" creationId="{0BEC45F6-919B-5ED4-8982-07CE55AFA23B}"/>
          </ac:spMkLst>
        </pc:spChg>
        <pc:spChg chg="del mod">
          <ac:chgData name="Devkar, Vikas" userId="acbd15ec-55d1-4a76-83ac-3f1d82711ed5" providerId="ADAL" clId="{1D085DC7-27BE-49ED-AA59-AC68119ECF15}" dt="2024-03-28T15:17:01.762" v="1021" actId="478"/>
          <ac:spMkLst>
            <pc:docMk/>
            <pc:sldMk cId="772256198" sldId="272"/>
            <ac:spMk id="16" creationId="{D4CEEA4B-3B35-40CC-546B-22586996DDA5}"/>
          </ac:spMkLst>
        </pc:spChg>
        <pc:spChg chg="add del mod">
          <ac:chgData name="Devkar, Vikas" userId="acbd15ec-55d1-4a76-83ac-3f1d82711ed5" providerId="ADAL" clId="{1D085DC7-27BE-49ED-AA59-AC68119ECF15}" dt="2024-04-01T18:56:05.997" v="1542" actId="1037"/>
          <ac:spMkLst>
            <pc:docMk/>
            <pc:sldMk cId="772256198" sldId="272"/>
            <ac:spMk id="17" creationId="{447966F1-473C-AEFB-276D-3B1100CFCB7F}"/>
          </ac:spMkLst>
        </pc:spChg>
        <pc:spChg chg="add del mod">
          <ac:chgData name="Devkar, Vikas" userId="acbd15ec-55d1-4a76-83ac-3f1d82711ed5" providerId="ADAL" clId="{1D085DC7-27BE-49ED-AA59-AC68119ECF15}" dt="2024-04-01T18:56:05.997" v="1542" actId="1037"/>
          <ac:spMkLst>
            <pc:docMk/>
            <pc:sldMk cId="772256198" sldId="272"/>
            <ac:spMk id="18" creationId="{C415C4D6-C72F-294C-AEB6-1B0B5D38AFF3}"/>
          </ac:spMkLst>
        </pc:spChg>
        <pc:spChg chg="add del mod">
          <ac:chgData name="Devkar, Vikas" userId="acbd15ec-55d1-4a76-83ac-3f1d82711ed5" providerId="ADAL" clId="{1D085DC7-27BE-49ED-AA59-AC68119ECF15}" dt="2024-04-01T18:56:05.997" v="1542" actId="1037"/>
          <ac:spMkLst>
            <pc:docMk/>
            <pc:sldMk cId="772256198" sldId="272"/>
            <ac:spMk id="19" creationId="{8955DEA9-AD69-6D12-A5D2-F6AD4D7542C9}"/>
          </ac:spMkLst>
        </pc:spChg>
        <pc:spChg chg="add del mod">
          <ac:chgData name="Devkar, Vikas" userId="acbd15ec-55d1-4a76-83ac-3f1d82711ed5" providerId="ADAL" clId="{1D085DC7-27BE-49ED-AA59-AC68119ECF15}" dt="2024-04-01T18:56:05.997" v="1542" actId="1037"/>
          <ac:spMkLst>
            <pc:docMk/>
            <pc:sldMk cId="772256198" sldId="272"/>
            <ac:spMk id="20" creationId="{944C9719-4B31-8FD3-89CA-2C18C7858077}"/>
          </ac:spMkLst>
        </pc:spChg>
        <pc:spChg chg="add del mod">
          <ac:chgData name="Devkar, Vikas" userId="acbd15ec-55d1-4a76-83ac-3f1d82711ed5" providerId="ADAL" clId="{1D085DC7-27BE-49ED-AA59-AC68119ECF15}" dt="2024-04-01T18:56:05.997" v="1542" actId="1037"/>
          <ac:spMkLst>
            <pc:docMk/>
            <pc:sldMk cId="772256198" sldId="272"/>
            <ac:spMk id="21" creationId="{6C062BE2-F528-40C1-6AE7-EB44D8354782}"/>
          </ac:spMkLst>
        </pc:spChg>
        <pc:spChg chg="add del mod">
          <ac:chgData name="Devkar, Vikas" userId="acbd15ec-55d1-4a76-83ac-3f1d82711ed5" providerId="ADAL" clId="{1D085DC7-27BE-49ED-AA59-AC68119ECF15}" dt="2024-04-01T18:56:05.997" v="1542" actId="1037"/>
          <ac:spMkLst>
            <pc:docMk/>
            <pc:sldMk cId="772256198" sldId="272"/>
            <ac:spMk id="22" creationId="{4EF055B9-3139-1580-6A88-CD9C82F73064}"/>
          </ac:spMkLst>
        </pc:spChg>
        <pc:spChg chg="add del mod">
          <ac:chgData name="Devkar, Vikas" userId="acbd15ec-55d1-4a76-83ac-3f1d82711ed5" providerId="ADAL" clId="{1D085DC7-27BE-49ED-AA59-AC68119ECF15}" dt="2024-04-01T18:56:05.997" v="1542" actId="1037"/>
          <ac:spMkLst>
            <pc:docMk/>
            <pc:sldMk cId="772256198" sldId="272"/>
            <ac:spMk id="23" creationId="{AF58460E-B6DE-4C5D-BE0B-15D33B3C9924}"/>
          </ac:spMkLst>
        </pc:spChg>
        <pc:spChg chg="mod">
          <ac:chgData name="Devkar, Vikas" userId="acbd15ec-55d1-4a76-83ac-3f1d82711ed5" providerId="ADAL" clId="{1D085DC7-27BE-49ED-AA59-AC68119ECF15}" dt="2024-03-28T15:31:02.876" v="1077" actId="1038"/>
          <ac:spMkLst>
            <pc:docMk/>
            <pc:sldMk cId="772256198" sldId="272"/>
            <ac:spMk id="27" creationId="{D57BCDEF-6E0F-0F5F-A093-225BF252614D}"/>
          </ac:spMkLst>
        </pc:spChg>
        <pc:spChg chg="add del mod">
          <ac:chgData name="Devkar, Vikas" userId="acbd15ec-55d1-4a76-83ac-3f1d82711ed5" providerId="ADAL" clId="{1D085DC7-27BE-49ED-AA59-AC68119ECF15}" dt="2024-04-01T18:56:05.997" v="1542" actId="1037"/>
          <ac:spMkLst>
            <pc:docMk/>
            <pc:sldMk cId="772256198" sldId="272"/>
            <ac:spMk id="34" creationId="{FAFBD998-8BE6-2779-A011-60DE9DC1B3DC}"/>
          </ac:spMkLst>
        </pc:spChg>
        <pc:spChg chg="add del mod">
          <ac:chgData name="Devkar, Vikas" userId="acbd15ec-55d1-4a76-83ac-3f1d82711ed5" providerId="ADAL" clId="{1D085DC7-27BE-49ED-AA59-AC68119ECF15}" dt="2024-04-01T18:56:05.997" v="1542" actId="1037"/>
          <ac:spMkLst>
            <pc:docMk/>
            <pc:sldMk cId="772256198" sldId="272"/>
            <ac:spMk id="35" creationId="{C3A9FB89-5E86-173D-D67C-10506CCB5D4A}"/>
          </ac:spMkLst>
        </pc:spChg>
        <pc:spChg chg="mod">
          <ac:chgData name="Devkar, Vikas" userId="acbd15ec-55d1-4a76-83ac-3f1d82711ed5" providerId="ADAL" clId="{1D085DC7-27BE-49ED-AA59-AC68119ECF15}" dt="2024-04-01T00:36:25.143" v="1318" actId="114"/>
          <ac:spMkLst>
            <pc:docMk/>
            <pc:sldMk cId="772256198" sldId="272"/>
            <ac:spMk id="36" creationId="{99078F0F-D8C7-9509-5AA3-395892F1249F}"/>
          </ac:spMkLst>
        </pc:spChg>
        <pc:spChg chg="mod">
          <ac:chgData name="Devkar, Vikas" userId="acbd15ec-55d1-4a76-83ac-3f1d82711ed5" providerId="ADAL" clId="{1D085DC7-27BE-49ED-AA59-AC68119ECF15}" dt="2024-04-01T00:36:25.143" v="1318" actId="114"/>
          <ac:spMkLst>
            <pc:docMk/>
            <pc:sldMk cId="772256198" sldId="272"/>
            <ac:spMk id="37" creationId="{F7820877-798A-BF31-5206-FEE89DACD1A6}"/>
          </ac:spMkLst>
        </pc:spChg>
        <pc:spChg chg="mod">
          <ac:chgData name="Devkar, Vikas" userId="acbd15ec-55d1-4a76-83ac-3f1d82711ed5" providerId="ADAL" clId="{1D085DC7-27BE-49ED-AA59-AC68119ECF15}" dt="2024-04-01T00:36:25.143" v="1318" actId="114"/>
          <ac:spMkLst>
            <pc:docMk/>
            <pc:sldMk cId="772256198" sldId="272"/>
            <ac:spMk id="38" creationId="{709FC594-9532-6634-2186-9F66211AE1F7}"/>
          </ac:spMkLst>
        </pc:spChg>
        <pc:spChg chg="mod">
          <ac:chgData name="Devkar, Vikas" userId="acbd15ec-55d1-4a76-83ac-3f1d82711ed5" providerId="ADAL" clId="{1D085DC7-27BE-49ED-AA59-AC68119ECF15}" dt="2024-04-01T00:36:25.143" v="1318" actId="114"/>
          <ac:spMkLst>
            <pc:docMk/>
            <pc:sldMk cId="772256198" sldId="272"/>
            <ac:spMk id="39" creationId="{C6354B1A-3D7E-2793-B296-A00940812151}"/>
          </ac:spMkLst>
        </pc:spChg>
        <pc:spChg chg="mod">
          <ac:chgData name="Devkar, Vikas" userId="acbd15ec-55d1-4a76-83ac-3f1d82711ed5" providerId="ADAL" clId="{1D085DC7-27BE-49ED-AA59-AC68119ECF15}" dt="2024-04-01T00:36:25.143" v="1318" actId="114"/>
          <ac:spMkLst>
            <pc:docMk/>
            <pc:sldMk cId="772256198" sldId="272"/>
            <ac:spMk id="40" creationId="{7AD1DEDE-1212-2E0B-7FFF-B0ECA8E8EB8C}"/>
          </ac:spMkLst>
        </pc:spChg>
        <pc:spChg chg="mod">
          <ac:chgData name="Devkar, Vikas" userId="acbd15ec-55d1-4a76-83ac-3f1d82711ed5" providerId="ADAL" clId="{1D085DC7-27BE-49ED-AA59-AC68119ECF15}" dt="2024-04-01T00:36:25.143" v="1318" actId="114"/>
          <ac:spMkLst>
            <pc:docMk/>
            <pc:sldMk cId="772256198" sldId="272"/>
            <ac:spMk id="41" creationId="{141E5450-3917-22B2-B21F-B9D069AA22BE}"/>
          </ac:spMkLst>
        </pc:spChg>
        <pc:spChg chg="mod">
          <ac:chgData name="Devkar, Vikas" userId="acbd15ec-55d1-4a76-83ac-3f1d82711ed5" providerId="ADAL" clId="{1D085DC7-27BE-49ED-AA59-AC68119ECF15}" dt="2024-04-01T00:36:25.143" v="1318" actId="114"/>
          <ac:spMkLst>
            <pc:docMk/>
            <pc:sldMk cId="772256198" sldId="272"/>
            <ac:spMk id="42" creationId="{E3E8A54A-32AF-E185-F0C8-8AE13780008A}"/>
          </ac:spMkLst>
        </pc:spChg>
        <pc:spChg chg="mod">
          <ac:chgData name="Devkar, Vikas" userId="acbd15ec-55d1-4a76-83ac-3f1d82711ed5" providerId="ADAL" clId="{1D085DC7-27BE-49ED-AA59-AC68119ECF15}" dt="2024-04-01T00:37:57.572" v="1331" actId="1076"/>
          <ac:spMkLst>
            <pc:docMk/>
            <pc:sldMk cId="772256198" sldId="272"/>
            <ac:spMk id="43" creationId="{68884778-9AA0-6DB5-2A40-E501E0E8ED61}"/>
          </ac:spMkLst>
        </pc:spChg>
        <pc:spChg chg="mod">
          <ac:chgData name="Devkar, Vikas" userId="acbd15ec-55d1-4a76-83ac-3f1d82711ed5" providerId="ADAL" clId="{1D085DC7-27BE-49ED-AA59-AC68119ECF15}" dt="2024-04-01T00:37:57.572" v="1331" actId="1076"/>
          <ac:spMkLst>
            <pc:docMk/>
            <pc:sldMk cId="772256198" sldId="272"/>
            <ac:spMk id="45" creationId="{383EE8E3-DD5D-AEE8-D3F0-71D1CFCBBFCE}"/>
          </ac:spMkLst>
        </pc:spChg>
        <pc:spChg chg="mod">
          <ac:chgData name="Devkar, Vikas" userId="acbd15ec-55d1-4a76-83ac-3f1d82711ed5" providerId="ADAL" clId="{1D085DC7-27BE-49ED-AA59-AC68119ECF15}" dt="2024-04-01T00:37:57.572" v="1331" actId="1076"/>
          <ac:spMkLst>
            <pc:docMk/>
            <pc:sldMk cId="772256198" sldId="272"/>
            <ac:spMk id="46" creationId="{2CBAFBF7-13A2-5347-B1A6-440A099F4BCC}"/>
          </ac:spMkLst>
        </pc:spChg>
        <pc:spChg chg="mod">
          <ac:chgData name="Devkar, Vikas" userId="acbd15ec-55d1-4a76-83ac-3f1d82711ed5" providerId="ADAL" clId="{1D085DC7-27BE-49ED-AA59-AC68119ECF15}" dt="2024-04-01T00:37:57.572" v="1331" actId="1076"/>
          <ac:spMkLst>
            <pc:docMk/>
            <pc:sldMk cId="772256198" sldId="272"/>
            <ac:spMk id="47" creationId="{4DBDEFDC-A96A-DC15-A973-45E469764A2B}"/>
          </ac:spMkLst>
        </pc:spChg>
        <pc:spChg chg="add del mod">
          <ac:chgData name="Devkar, Vikas" userId="acbd15ec-55d1-4a76-83ac-3f1d82711ed5" providerId="ADAL" clId="{1D085DC7-27BE-49ED-AA59-AC68119ECF15}" dt="2024-04-01T00:43:05.508" v="1455" actId="1035"/>
          <ac:spMkLst>
            <pc:docMk/>
            <pc:sldMk cId="772256198" sldId="272"/>
            <ac:spMk id="48" creationId="{6C705168-5731-8AEB-4AC6-77330158F270}"/>
          </ac:spMkLst>
        </pc:spChg>
        <pc:spChg chg="add del mod">
          <ac:chgData name="Devkar, Vikas" userId="acbd15ec-55d1-4a76-83ac-3f1d82711ed5" providerId="ADAL" clId="{1D085DC7-27BE-49ED-AA59-AC68119ECF15}" dt="2024-04-01T00:43:05.508" v="1455" actId="1035"/>
          <ac:spMkLst>
            <pc:docMk/>
            <pc:sldMk cId="772256198" sldId="272"/>
            <ac:spMk id="49" creationId="{A1FCD7E7-BC40-1E54-F0C7-70E5829602BA}"/>
          </ac:spMkLst>
        </pc:spChg>
        <pc:spChg chg="add del mod">
          <ac:chgData name="Devkar, Vikas" userId="acbd15ec-55d1-4a76-83ac-3f1d82711ed5" providerId="ADAL" clId="{1D085DC7-27BE-49ED-AA59-AC68119ECF15}" dt="2024-04-01T00:43:05.508" v="1455" actId="1035"/>
          <ac:spMkLst>
            <pc:docMk/>
            <pc:sldMk cId="772256198" sldId="272"/>
            <ac:spMk id="50" creationId="{129F6921-1EAD-5244-837D-2D002E5558BD}"/>
          </ac:spMkLst>
        </pc:spChg>
        <pc:spChg chg="add del mod">
          <ac:chgData name="Devkar, Vikas" userId="acbd15ec-55d1-4a76-83ac-3f1d82711ed5" providerId="ADAL" clId="{1D085DC7-27BE-49ED-AA59-AC68119ECF15}" dt="2024-04-01T00:43:05.508" v="1455" actId="1035"/>
          <ac:spMkLst>
            <pc:docMk/>
            <pc:sldMk cId="772256198" sldId="272"/>
            <ac:spMk id="54" creationId="{41CECA81-658A-A7EA-75C9-35EDFD8540B1}"/>
          </ac:spMkLst>
        </pc:spChg>
        <pc:spChg chg="add del mod">
          <ac:chgData name="Devkar, Vikas" userId="acbd15ec-55d1-4a76-83ac-3f1d82711ed5" providerId="ADAL" clId="{1D085DC7-27BE-49ED-AA59-AC68119ECF15}" dt="2024-04-01T00:43:05.508" v="1455" actId="1035"/>
          <ac:spMkLst>
            <pc:docMk/>
            <pc:sldMk cId="772256198" sldId="272"/>
            <ac:spMk id="55" creationId="{0B957C6F-396F-DD33-BE28-7EA9A96E35F5}"/>
          </ac:spMkLst>
        </pc:spChg>
        <pc:spChg chg="add del mod">
          <ac:chgData name="Devkar, Vikas" userId="acbd15ec-55d1-4a76-83ac-3f1d82711ed5" providerId="ADAL" clId="{1D085DC7-27BE-49ED-AA59-AC68119ECF15}" dt="2024-04-01T00:43:05.508" v="1455" actId="1035"/>
          <ac:spMkLst>
            <pc:docMk/>
            <pc:sldMk cId="772256198" sldId="272"/>
            <ac:spMk id="56" creationId="{C68065D4-9E2C-56C4-BD4B-034A1F9DB1CC}"/>
          </ac:spMkLst>
        </pc:spChg>
        <pc:spChg chg="add del mod">
          <ac:chgData name="Devkar, Vikas" userId="acbd15ec-55d1-4a76-83ac-3f1d82711ed5" providerId="ADAL" clId="{1D085DC7-27BE-49ED-AA59-AC68119ECF15}" dt="2024-04-01T00:43:05.508" v="1455" actId="1035"/>
          <ac:spMkLst>
            <pc:docMk/>
            <pc:sldMk cId="772256198" sldId="272"/>
            <ac:spMk id="57" creationId="{3188760C-32E0-6D76-348C-E271EEC907FE}"/>
          </ac:spMkLst>
        </pc:spChg>
        <pc:spChg chg="del mod">
          <ac:chgData name="Devkar, Vikas" userId="acbd15ec-55d1-4a76-83ac-3f1d82711ed5" providerId="ADAL" clId="{1D085DC7-27BE-49ED-AA59-AC68119ECF15}" dt="2024-04-01T00:42:22.818" v="1439" actId="478"/>
          <ac:spMkLst>
            <pc:docMk/>
            <pc:sldMk cId="772256198" sldId="272"/>
            <ac:spMk id="58" creationId="{FE595C0C-3FCE-23A2-FBC5-E48FE30DAB14}"/>
          </ac:spMkLst>
        </pc:spChg>
        <pc:spChg chg="mod">
          <ac:chgData name="Devkar, Vikas" userId="acbd15ec-55d1-4a76-83ac-3f1d82711ed5" providerId="ADAL" clId="{1D085DC7-27BE-49ED-AA59-AC68119ECF15}" dt="2024-04-01T00:37:57.572" v="1331" actId="1076"/>
          <ac:spMkLst>
            <pc:docMk/>
            <pc:sldMk cId="772256198" sldId="272"/>
            <ac:spMk id="59" creationId="{B69D8266-F48A-E479-352B-74E5C3C031AF}"/>
          </ac:spMkLst>
        </pc:spChg>
        <pc:spChg chg="add del mod">
          <ac:chgData name="Devkar, Vikas" userId="acbd15ec-55d1-4a76-83ac-3f1d82711ed5" providerId="ADAL" clId="{1D085DC7-27BE-49ED-AA59-AC68119ECF15}" dt="2024-04-01T00:43:05.508" v="1455" actId="1035"/>
          <ac:spMkLst>
            <pc:docMk/>
            <pc:sldMk cId="772256198" sldId="272"/>
            <ac:spMk id="60" creationId="{6F598399-95DC-0936-2E57-18C0A621E480}"/>
          </ac:spMkLst>
        </pc:spChg>
        <pc:spChg chg="add del mod">
          <ac:chgData name="Devkar, Vikas" userId="acbd15ec-55d1-4a76-83ac-3f1d82711ed5" providerId="ADAL" clId="{1D085DC7-27BE-49ED-AA59-AC68119ECF15}" dt="2024-04-01T00:43:05.508" v="1455" actId="1035"/>
          <ac:spMkLst>
            <pc:docMk/>
            <pc:sldMk cId="772256198" sldId="272"/>
            <ac:spMk id="61" creationId="{1FE920F1-C77F-BD93-9C4E-864C876D37EB}"/>
          </ac:spMkLst>
        </pc:spChg>
        <pc:spChg chg="mod">
          <ac:chgData name="Devkar, Vikas" userId="acbd15ec-55d1-4a76-83ac-3f1d82711ed5" providerId="ADAL" clId="{1D085DC7-27BE-49ED-AA59-AC68119ECF15}" dt="2024-04-01T00:37:57.572" v="1331" actId="1076"/>
          <ac:spMkLst>
            <pc:docMk/>
            <pc:sldMk cId="772256198" sldId="272"/>
            <ac:spMk id="62" creationId="{55969B5E-C7A9-22E9-5E9B-024D2E37E2E9}"/>
          </ac:spMkLst>
        </pc:spChg>
        <pc:spChg chg="add del mod">
          <ac:chgData name="Devkar, Vikas" userId="acbd15ec-55d1-4a76-83ac-3f1d82711ed5" providerId="ADAL" clId="{1D085DC7-27BE-49ED-AA59-AC68119ECF15}" dt="2024-04-01T00:43:05.508" v="1455" actId="1035"/>
          <ac:spMkLst>
            <pc:docMk/>
            <pc:sldMk cId="772256198" sldId="272"/>
            <ac:spMk id="63" creationId="{31571886-81F7-758F-F983-BE0EB9B9BF1F}"/>
          </ac:spMkLst>
        </pc:spChg>
        <pc:spChg chg="add del mod">
          <ac:chgData name="Devkar, Vikas" userId="acbd15ec-55d1-4a76-83ac-3f1d82711ed5" providerId="ADAL" clId="{1D085DC7-27BE-49ED-AA59-AC68119ECF15}" dt="2024-04-01T00:43:05.508" v="1455" actId="1035"/>
          <ac:spMkLst>
            <pc:docMk/>
            <pc:sldMk cId="772256198" sldId="272"/>
            <ac:spMk id="65" creationId="{B6C5A99C-4691-EBD6-C877-A391DD8EC426}"/>
          </ac:spMkLst>
        </pc:spChg>
        <pc:spChg chg="mod">
          <ac:chgData name="Devkar, Vikas" userId="acbd15ec-55d1-4a76-83ac-3f1d82711ed5" providerId="ADAL" clId="{1D085DC7-27BE-49ED-AA59-AC68119ECF15}" dt="2024-04-01T00:37:57.572" v="1331" actId="1076"/>
          <ac:spMkLst>
            <pc:docMk/>
            <pc:sldMk cId="772256198" sldId="272"/>
            <ac:spMk id="68" creationId="{41D3BC48-3653-6BB1-DCFC-EA8CB476F8D1}"/>
          </ac:spMkLst>
        </pc:spChg>
        <pc:spChg chg="add del mod">
          <ac:chgData name="Devkar, Vikas" userId="acbd15ec-55d1-4a76-83ac-3f1d82711ed5" providerId="ADAL" clId="{1D085DC7-27BE-49ED-AA59-AC68119ECF15}" dt="2024-04-01T00:43:05.508" v="1455" actId="1035"/>
          <ac:spMkLst>
            <pc:docMk/>
            <pc:sldMk cId="772256198" sldId="272"/>
            <ac:spMk id="70" creationId="{AA63526D-9F3A-46BD-E5DF-3738C1B49E7A}"/>
          </ac:spMkLst>
        </pc:spChg>
        <pc:spChg chg="add del mod">
          <ac:chgData name="Devkar, Vikas" userId="acbd15ec-55d1-4a76-83ac-3f1d82711ed5" providerId="ADAL" clId="{1D085DC7-27BE-49ED-AA59-AC68119ECF15}" dt="2024-04-01T00:43:05.508" v="1455" actId="1035"/>
          <ac:spMkLst>
            <pc:docMk/>
            <pc:sldMk cId="772256198" sldId="272"/>
            <ac:spMk id="71" creationId="{B5DDA53F-E7D5-46BB-D0A9-2A771AE25E68}"/>
          </ac:spMkLst>
        </pc:spChg>
        <pc:spChg chg="mod">
          <ac:chgData name="Devkar, Vikas" userId="acbd15ec-55d1-4a76-83ac-3f1d82711ed5" providerId="ADAL" clId="{1D085DC7-27BE-49ED-AA59-AC68119ECF15}" dt="2024-04-01T00:37:57.572" v="1331" actId="1076"/>
          <ac:spMkLst>
            <pc:docMk/>
            <pc:sldMk cId="772256198" sldId="272"/>
            <ac:spMk id="72" creationId="{92061860-2EAF-B105-B181-23F50AE89B59}"/>
          </ac:spMkLst>
        </pc:spChg>
        <pc:spChg chg="add del mod">
          <ac:chgData name="Devkar, Vikas" userId="acbd15ec-55d1-4a76-83ac-3f1d82711ed5" providerId="ADAL" clId="{1D085DC7-27BE-49ED-AA59-AC68119ECF15}" dt="2024-04-01T00:43:05.508" v="1455" actId="1035"/>
          <ac:spMkLst>
            <pc:docMk/>
            <pc:sldMk cId="772256198" sldId="272"/>
            <ac:spMk id="75" creationId="{5149E9FB-09E2-48D3-A5A6-1B405B760B96}"/>
          </ac:spMkLst>
        </pc:spChg>
        <pc:spChg chg="add del mod">
          <ac:chgData name="Devkar, Vikas" userId="acbd15ec-55d1-4a76-83ac-3f1d82711ed5" providerId="ADAL" clId="{1D085DC7-27BE-49ED-AA59-AC68119ECF15}" dt="2024-04-01T00:43:05.508" v="1455" actId="1035"/>
          <ac:spMkLst>
            <pc:docMk/>
            <pc:sldMk cId="772256198" sldId="272"/>
            <ac:spMk id="76" creationId="{E49FC55B-A918-61CC-D2EC-DBEB794AD0EA}"/>
          </ac:spMkLst>
        </pc:spChg>
        <pc:spChg chg="add del mod">
          <ac:chgData name="Devkar, Vikas" userId="acbd15ec-55d1-4a76-83ac-3f1d82711ed5" providerId="ADAL" clId="{1D085DC7-27BE-49ED-AA59-AC68119ECF15}" dt="2024-04-01T00:43:05.508" v="1455" actId="1035"/>
          <ac:spMkLst>
            <pc:docMk/>
            <pc:sldMk cId="772256198" sldId="272"/>
            <ac:spMk id="77" creationId="{441EA215-E82E-4EC9-22D2-41ACBB2DD205}"/>
          </ac:spMkLst>
        </pc:spChg>
        <pc:spChg chg="add del mod">
          <ac:chgData name="Devkar, Vikas" userId="acbd15ec-55d1-4a76-83ac-3f1d82711ed5" providerId="ADAL" clId="{1D085DC7-27BE-49ED-AA59-AC68119ECF15}" dt="2024-04-01T00:43:05.508" v="1455" actId="1035"/>
          <ac:spMkLst>
            <pc:docMk/>
            <pc:sldMk cId="772256198" sldId="272"/>
            <ac:spMk id="78" creationId="{8142A9B5-030B-1CBA-801E-AEC7603D5155}"/>
          </ac:spMkLst>
        </pc:spChg>
        <pc:spChg chg="add del mod">
          <ac:chgData name="Devkar, Vikas" userId="acbd15ec-55d1-4a76-83ac-3f1d82711ed5" providerId="ADAL" clId="{1D085DC7-27BE-49ED-AA59-AC68119ECF15}" dt="2024-04-01T00:43:05.508" v="1455" actId="1035"/>
          <ac:spMkLst>
            <pc:docMk/>
            <pc:sldMk cId="772256198" sldId="272"/>
            <ac:spMk id="79" creationId="{84BE4B48-9BCB-3CE3-5107-F750B521BC2D}"/>
          </ac:spMkLst>
        </pc:spChg>
        <pc:spChg chg="add del mod">
          <ac:chgData name="Devkar, Vikas" userId="acbd15ec-55d1-4a76-83ac-3f1d82711ed5" providerId="ADAL" clId="{1D085DC7-27BE-49ED-AA59-AC68119ECF15}" dt="2024-04-01T00:43:05.508" v="1455" actId="1035"/>
          <ac:spMkLst>
            <pc:docMk/>
            <pc:sldMk cId="772256198" sldId="272"/>
            <ac:spMk id="86" creationId="{99178861-325D-989C-506D-0C9F030C6FA1}"/>
          </ac:spMkLst>
        </pc:spChg>
        <pc:spChg chg="add del mod">
          <ac:chgData name="Devkar, Vikas" userId="acbd15ec-55d1-4a76-83ac-3f1d82711ed5" providerId="ADAL" clId="{1D085DC7-27BE-49ED-AA59-AC68119ECF15}" dt="2024-04-01T00:43:05.508" v="1455" actId="1035"/>
          <ac:spMkLst>
            <pc:docMk/>
            <pc:sldMk cId="772256198" sldId="272"/>
            <ac:spMk id="89" creationId="{B291ED54-A00D-32C9-68D4-BF49BD36CB03}"/>
          </ac:spMkLst>
        </pc:spChg>
        <pc:spChg chg="add del mod">
          <ac:chgData name="Devkar, Vikas" userId="acbd15ec-55d1-4a76-83ac-3f1d82711ed5" providerId="ADAL" clId="{1D085DC7-27BE-49ED-AA59-AC68119ECF15}" dt="2024-04-01T00:43:05.508" v="1455" actId="1035"/>
          <ac:spMkLst>
            <pc:docMk/>
            <pc:sldMk cId="772256198" sldId="272"/>
            <ac:spMk id="90" creationId="{6B73E9B3-C328-D917-F5C2-F221BA7EF2BC}"/>
          </ac:spMkLst>
        </pc:spChg>
        <pc:spChg chg="add del mod">
          <ac:chgData name="Devkar, Vikas" userId="acbd15ec-55d1-4a76-83ac-3f1d82711ed5" providerId="ADAL" clId="{1D085DC7-27BE-49ED-AA59-AC68119ECF15}" dt="2024-04-01T00:43:05.508" v="1455" actId="1035"/>
          <ac:spMkLst>
            <pc:docMk/>
            <pc:sldMk cId="772256198" sldId="272"/>
            <ac:spMk id="91" creationId="{FA9566FD-8567-9182-DF9B-D9508D30CBA5}"/>
          </ac:spMkLst>
        </pc:spChg>
        <pc:spChg chg="add del mod">
          <ac:chgData name="Devkar, Vikas" userId="acbd15ec-55d1-4a76-83ac-3f1d82711ed5" providerId="ADAL" clId="{1D085DC7-27BE-49ED-AA59-AC68119ECF15}" dt="2024-04-01T00:43:05.508" v="1455" actId="1035"/>
          <ac:spMkLst>
            <pc:docMk/>
            <pc:sldMk cId="772256198" sldId="272"/>
            <ac:spMk id="92" creationId="{BBEE995D-067D-D71F-A72C-8B091B60506D}"/>
          </ac:spMkLst>
        </pc:spChg>
        <pc:spChg chg="add del mod">
          <ac:chgData name="Devkar, Vikas" userId="acbd15ec-55d1-4a76-83ac-3f1d82711ed5" providerId="ADAL" clId="{1D085DC7-27BE-49ED-AA59-AC68119ECF15}" dt="2024-04-01T00:43:05.508" v="1455" actId="1035"/>
          <ac:spMkLst>
            <pc:docMk/>
            <pc:sldMk cId="772256198" sldId="272"/>
            <ac:spMk id="93" creationId="{632098EA-09A0-B2AB-7F64-70BAC02832E0}"/>
          </ac:spMkLst>
        </pc:spChg>
        <pc:spChg chg="add del mod">
          <ac:chgData name="Devkar, Vikas" userId="acbd15ec-55d1-4a76-83ac-3f1d82711ed5" providerId="ADAL" clId="{1D085DC7-27BE-49ED-AA59-AC68119ECF15}" dt="2024-04-01T00:43:05.508" v="1455" actId="1035"/>
          <ac:spMkLst>
            <pc:docMk/>
            <pc:sldMk cId="772256198" sldId="272"/>
            <ac:spMk id="94" creationId="{B74091A6-AA5D-FB10-7415-3A020024F892}"/>
          </ac:spMkLst>
        </pc:spChg>
        <pc:spChg chg="add del mod">
          <ac:chgData name="Devkar, Vikas" userId="acbd15ec-55d1-4a76-83ac-3f1d82711ed5" providerId="ADAL" clId="{1D085DC7-27BE-49ED-AA59-AC68119ECF15}" dt="2024-04-01T00:43:05.508" v="1455" actId="1035"/>
          <ac:spMkLst>
            <pc:docMk/>
            <pc:sldMk cId="772256198" sldId="272"/>
            <ac:spMk id="95" creationId="{C382B18E-4434-FA74-7392-AC067C0B0156}"/>
          </ac:spMkLst>
        </pc:spChg>
        <pc:spChg chg="add del mod">
          <ac:chgData name="Devkar, Vikas" userId="acbd15ec-55d1-4a76-83ac-3f1d82711ed5" providerId="ADAL" clId="{1D085DC7-27BE-49ED-AA59-AC68119ECF15}" dt="2024-04-01T00:43:05.508" v="1455" actId="1035"/>
          <ac:spMkLst>
            <pc:docMk/>
            <pc:sldMk cId="772256198" sldId="272"/>
            <ac:spMk id="96" creationId="{146623D3-BDD6-4765-2BAE-0F74C2FC3EF3}"/>
          </ac:spMkLst>
        </pc:spChg>
        <pc:spChg chg="add del mod">
          <ac:chgData name="Devkar, Vikas" userId="acbd15ec-55d1-4a76-83ac-3f1d82711ed5" providerId="ADAL" clId="{1D085DC7-27BE-49ED-AA59-AC68119ECF15}" dt="2024-04-01T00:43:05.508" v="1455" actId="1035"/>
          <ac:spMkLst>
            <pc:docMk/>
            <pc:sldMk cId="772256198" sldId="272"/>
            <ac:spMk id="97" creationId="{F9CCDF51-EB4D-0C84-6D81-AA97F499319F}"/>
          </ac:spMkLst>
        </pc:spChg>
        <pc:spChg chg="add del mod">
          <ac:chgData name="Devkar, Vikas" userId="acbd15ec-55d1-4a76-83ac-3f1d82711ed5" providerId="ADAL" clId="{1D085DC7-27BE-49ED-AA59-AC68119ECF15}" dt="2024-04-01T00:43:05.508" v="1455" actId="1035"/>
          <ac:spMkLst>
            <pc:docMk/>
            <pc:sldMk cId="772256198" sldId="272"/>
            <ac:spMk id="100" creationId="{C214761B-99A9-AAF7-5753-65CE7A011559}"/>
          </ac:spMkLst>
        </pc:spChg>
        <pc:spChg chg="add del mod">
          <ac:chgData name="Devkar, Vikas" userId="acbd15ec-55d1-4a76-83ac-3f1d82711ed5" providerId="ADAL" clId="{1D085DC7-27BE-49ED-AA59-AC68119ECF15}" dt="2024-04-01T00:43:05.508" v="1455" actId="1035"/>
          <ac:spMkLst>
            <pc:docMk/>
            <pc:sldMk cId="772256198" sldId="272"/>
            <ac:spMk id="101" creationId="{191B14BA-69DF-C37C-381D-00F4AF8F6A74}"/>
          </ac:spMkLst>
        </pc:spChg>
        <pc:spChg chg="add del mod">
          <ac:chgData name="Devkar, Vikas" userId="acbd15ec-55d1-4a76-83ac-3f1d82711ed5" providerId="ADAL" clId="{1D085DC7-27BE-49ED-AA59-AC68119ECF15}" dt="2024-04-01T00:43:05.508" v="1455" actId="1035"/>
          <ac:spMkLst>
            <pc:docMk/>
            <pc:sldMk cId="772256198" sldId="272"/>
            <ac:spMk id="102" creationId="{EEBC657D-F3F7-DE2B-6113-928A0C21E034}"/>
          </ac:spMkLst>
        </pc:spChg>
        <pc:spChg chg="add del mod">
          <ac:chgData name="Devkar, Vikas" userId="acbd15ec-55d1-4a76-83ac-3f1d82711ed5" providerId="ADAL" clId="{1D085DC7-27BE-49ED-AA59-AC68119ECF15}" dt="2024-04-01T00:43:05.508" v="1455" actId="1035"/>
          <ac:spMkLst>
            <pc:docMk/>
            <pc:sldMk cId="772256198" sldId="272"/>
            <ac:spMk id="103" creationId="{0C977113-DC69-1B73-9F4D-7BEEEB556F86}"/>
          </ac:spMkLst>
        </pc:spChg>
        <pc:spChg chg="add del mod">
          <ac:chgData name="Devkar, Vikas" userId="acbd15ec-55d1-4a76-83ac-3f1d82711ed5" providerId="ADAL" clId="{1D085DC7-27BE-49ED-AA59-AC68119ECF15}" dt="2024-04-01T00:43:05.508" v="1455" actId="1035"/>
          <ac:spMkLst>
            <pc:docMk/>
            <pc:sldMk cId="772256198" sldId="272"/>
            <ac:spMk id="105" creationId="{1D4DD1F4-07D5-84CA-6FF1-024A25EE7869}"/>
          </ac:spMkLst>
        </pc:spChg>
        <pc:spChg chg="add del mod">
          <ac:chgData name="Devkar, Vikas" userId="acbd15ec-55d1-4a76-83ac-3f1d82711ed5" providerId="ADAL" clId="{1D085DC7-27BE-49ED-AA59-AC68119ECF15}" dt="2024-04-01T00:43:05.508" v="1455" actId="1035"/>
          <ac:spMkLst>
            <pc:docMk/>
            <pc:sldMk cId="772256198" sldId="272"/>
            <ac:spMk id="106" creationId="{FCDD1C8B-C4BC-E457-78E5-157D93C57B4E}"/>
          </ac:spMkLst>
        </pc:spChg>
        <pc:spChg chg="add del mod">
          <ac:chgData name="Devkar, Vikas" userId="acbd15ec-55d1-4a76-83ac-3f1d82711ed5" providerId="ADAL" clId="{1D085DC7-27BE-49ED-AA59-AC68119ECF15}" dt="2024-04-01T00:43:05.508" v="1455" actId="1035"/>
          <ac:spMkLst>
            <pc:docMk/>
            <pc:sldMk cId="772256198" sldId="272"/>
            <ac:spMk id="107" creationId="{9B5A9DAA-C39C-27D8-51D3-8C6578D59E76}"/>
          </ac:spMkLst>
        </pc:spChg>
        <pc:spChg chg="add del mod">
          <ac:chgData name="Devkar, Vikas" userId="acbd15ec-55d1-4a76-83ac-3f1d82711ed5" providerId="ADAL" clId="{1D085DC7-27BE-49ED-AA59-AC68119ECF15}" dt="2024-04-01T00:43:05.508" v="1455" actId="1035"/>
          <ac:spMkLst>
            <pc:docMk/>
            <pc:sldMk cId="772256198" sldId="272"/>
            <ac:spMk id="108" creationId="{BF35718B-FF44-941D-637B-F7B6DE2ED34A}"/>
          </ac:spMkLst>
        </pc:spChg>
        <pc:spChg chg="add del mod">
          <ac:chgData name="Devkar, Vikas" userId="acbd15ec-55d1-4a76-83ac-3f1d82711ed5" providerId="ADAL" clId="{1D085DC7-27BE-49ED-AA59-AC68119ECF15}" dt="2024-04-01T00:43:05.508" v="1455" actId="1035"/>
          <ac:spMkLst>
            <pc:docMk/>
            <pc:sldMk cId="772256198" sldId="272"/>
            <ac:spMk id="109" creationId="{BF340F1E-4113-1038-17ED-0D2E322C7875}"/>
          </ac:spMkLst>
        </pc:spChg>
        <pc:spChg chg="add del mod">
          <ac:chgData name="Devkar, Vikas" userId="acbd15ec-55d1-4a76-83ac-3f1d82711ed5" providerId="ADAL" clId="{1D085DC7-27BE-49ED-AA59-AC68119ECF15}" dt="2024-04-01T00:43:05.508" v="1455" actId="1035"/>
          <ac:spMkLst>
            <pc:docMk/>
            <pc:sldMk cId="772256198" sldId="272"/>
            <ac:spMk id="110" creationId="{D1926AD4-5D61-D851-0DAC-132CE12A7772}"/>
          </ac:spMkLst>
        </pc:spChg>
        <pc:spChg chg="add del mod">
          <ac:chgData name="Devkar, Vikas" userId="acbd15ec-55d1-4a76-83ac-3f1d82711ed5" providerId="ADAL" clId="{1D085DC7-27BE-49ED-AA59-AC68119ECF15}" dt="2024-04-01T00:43:05.508" v="1455" actId="1035"/>
          <ac:spMkLst>
            <pc:docMk/>
            <pc:sldMk cId="772256198" sldId="272"/>
            <ac:spMk id="112" creationId="{AA232013-8BC4-4CA3-F42E-2FD4639B8F5D}"/>
          </ac:spMkLst>
        </pc:spChg>
        <pc:spChg chg="add del mod">
          <ac:chgData name="Devkar, Vikas" userId="acbd15ec-55d1-4a76-83ac-3f1d82711ed5" providerId="ADAL" clId="{1D085DC7-27BE-49ED-AA59-AC68119ECF15}" dt="2024-04-01T00:43:05.508" v="1455" actId="1035"/>
          <ac:spMkLst>
            <pc:docMk/>
            <pc:sldMk cId="772256198" sldId="272"/>
            <ac:spMk id="113" creationId="{CC9EF421-C94A-9AB1-840E-F67854226DA4}"/>
          </ac:spMkLst>
        </pc:spChg>
        <pc:spChg chg="add del mod">
          <ac:chgData name="Devkar, Vikas" userId="acbd15ec-55d1-4a76-83ac-3f1d82711ed5" providerId="ADAL" clId="{1D085DC7-27BE-49ED-AA59-AC68119ECF15}" dt="2024-04-01T00:43:05.508" v="1455" actId="1035"/>
          <ac:spMkLst>
            <pc:docMk/>
            <pc:sldMk cId="772256198" sldId="272"/>
            <ac:spMk id="114" creationId="{05F94BA7-BCCD-8007-809D-BB1416C8C5DA}"/>
          </ac:spMkLst>
        </pc:spChg>
        <pc:spChg chg="add del mod">
          <ac:chgData name="Devkar, Vikas" userId="acbd15ec-55d1-4a76-83ac-3f1d82711ed5" providerId="ADAL" clId="{1D085DC7-27BE-49ED-AA59-AC68119ECF15}" dt="2024-04-01T00:43:05.508" v="1455" actId="1035"/>
          <ac:spMkLst>
            <pc:docMk/>
            <pc:sldMk cId="772256198" sldId="272"/>
            <ac:spMk id="115" creationId="{57FF72A5-0225-B2BC-3656-D9CE6F3CC0F5}"/>
          </ac:spMkLst>
        </pc:spChg>
        <pc:spChg chg="add del mod">
          <ac:chgData name="Devkar, Vikas" userId="acbd15ec-55d1-4a76-83ac-3f1d82711ed5" providerId="ADAL" clId="{1D085DC7-27BE-49ED-AA59-AC68119ECF15}" dt="2024-04-01T00:43:05.508" v="1455" actId="1035"/>
          <ac:spMkLst>
            <pc:docMk/>
            <pc:sldMk cId="772256198" sldId="272"/>
            <ac:spMk id="116" creationId="{B41CB5CB-A430-1E41-64E5-44DC2F627A5D}"/>
          </ac:spMkLst>
        </pc:spChg>
        <pc:spChg chg="add del mod">
          <ac:chgData name="Devkar, Vikas" userId="acbd15ec-55d1-4a76-83ac-3f1d82711ed5" providerId="ADAL" clId="{1D085DC7-27BE-49ED-AA59-AC68119ECF15}" dt="2024-04-01T00:43:05.508" v="1455" actId="1035"/>
          <ac:spMkLst>
            <pc:docMk/>
            <pc:sldMk cId="772256198" sldId="272"/>
            <ac:spMk id="117" creationId="{FE45DF65-70A5-4600-54F8-F66EC8AB06D5}"/>
          </ac:spMkLst>
        </pc:spChg>
        <pc:spChg chg="add del mod">
          <ac:chgData name="Devkar, Vikas" userId="acbd15ec-55d1-4a76-83ac-3f1d82711ed5" providerId="ADAL" clId="{1D085DC7-27BE-49ED-AA59-AC68119ECF15}" dt="2024-04-01T00:43:05.508" v="1455" actId="1035"/>
          <ac:spMkLst>
            <pc:docMk/>
            <pc:sldMk cId="772256198" sldId="272"/>
            <ac:spMk id="121" creationId="{A7E114D0-F026-5A7E-F48D-DB943DEA8C17}"/>
          </ac:spMkLst>
        </pc:spChg>
        <pc:spChg chg="add del mod">
          <ac:chgData name="Devkar, Vikas" userId="acbd15ec-55d1-4a76-83ac-3f1d82711ed5" providerId="ADAL" clId="{1D085DC7-27BE-49ED-AA59-AC68119ECF15}" dt="2024-04-01T00:43:05.508" v="1455" actId="1035"/>
          <ac:spMkLst>
            <pc:docMk/>
            <pc:sldMk cId="772256198" sldId="272"/>
            <ac:spMk id="122" creationId="{CE8DDB6C-A0A6-6F0C-B2CD-62A682743534}"/>
          </ac:spMkLst>
        </pc:spChg>
        <pc:spChg chg="add del mod">
          <ac:chgData name="Devkar, Vikas" userId="acbd15ec-55d1-4a76-83ac-3f1d82711ed5" providerId="ADAL" clId="{1D085DC7-27BE-49ED-AA59-AC68119ECF15}" dt="2024-04-01T00:43:05.508" v="1455" actId="1035"/>
          <ac:spMkLst>
            <pc:docMk/>
            <pc:sldMk cId="772256198" sldId="272"/>
            <ac:spMk id="123" creationId="{F0700D12-B974-9B1A-3EC2-AC31A45F796F}"/>
          </ac:spMkLst>
        </pc:spChg>
        <pc:spChg chg="add del mod">
          <ac:chgData name="Devkar, Vikas" userId="acbd15ec-55d1-4a76-83ac-3f1d82711ed5" providerId="ADAL" clId="{1D085DC7-27BE-49ED-AA59-AC68119ECF15}" dt="2024-04-01T00:43:05.508" v="1455" actId="1035"/>
          <ac:spMkLst>
            <pc:docMk/>
            <pc:sldMk cId="772256198" sldId="272"/>
            <ac:spMk id="124" creationId="{0FA0DB2B-0C33-E537-DCA5-6C334B0900CB}"/>
          </ac:spMkLst>
        </pc:spChg>
        <pc:spChg chg="add del mod">
          <ac:chgData name="Devkar, Vikas" userId="acbd15ec-55d1-4a76-83ac-3f1d82711ed5" providerId="ADAL" clId="{1D085DC7-27BE-49ED-AA59-AC68119ECF15}" dt="2024-04-01T00:43:05.508" v="1455" actId="1035"/>
          <ac:spMkLst>
            <pc:docMk/>
            <pc:sldMk cId="772256198" sldId="272"/>
            <ac:spMk id="125" creationId="{79C184B0-B487-7A04-C3D3-214AAD8C2631}"/>
          </ac:spMkLst>
        </pc:spChg>
        <pc:spChg chg="add del mod">
          <ac:chgData name="Devkar, Vikas" userId="acbd15ec-55d1-4a76-83ac-3f1d82711ed5" providerId="ADAL" clId="{1D085DC7-27BE-49ED-AA59-AC68119ECF15}" dt="2024-04-01T00:43:05.508" v="1455" actId="1035"/>
          <ac:spMkLst>
            <pc:docMk/>
            <pc:sldMk cId="772256198" sldId="272"/>
            <ac:spMk id="132" creationId="{17B70BB7-A4D7-D334-A137-6BCC25E7FAE1}"/>
          </ac:spMkLst>
        </pc:spChg>
        <pc:spChg chg="add del mod">
          <ac:chgData name="Devkar, Vikas" userId="acbd15ec-55d1-4a76-83ac-3f1d82711ed5" providerId="ADAL" clId="{1D085DC7-27BE-49ED-AA59-AC68119ECF15}" dt="2024-04-01T00:43:05.508" v="1455" actId="1035"/>
          <ac:spMkLst>
            <pc:docMk/>
            <pc:sldMk cId="772256198" sldId="272"/>
            <ac:spMk id="133" creationId="{8E7E6AB2-59E4-88FF-ADD4-8B1D1C2B18BE}"/>
          </ac:spMkLst>
        </pc:spChg>
        <pc:spChg chg="add del mod">
          <ac:chgData name="Devkar, Vikas" userId="acbd15ec-55d1-4a76-83ac-3f1d82711ed5" providerId="ADAL" clId="{1D085DC7-27BE-49ED-AA59-AC68119ECF15}" dt="2024-04-01T00:43:05.508" v="1455" actId="1035"/>
          <ac:spMkLst>
            <pc:docMk/>
            <pc:sldMk cId="772256198" sldId="272"/>
            <ac:spMk id="134" creationId="{7FEDF0C3-3610-7B89-48F6-390BC0BF684F}"/>
          </ac:spMkLst>
        </pc:spChg>
        <pc:spChg chg="add del mod">
          <ac:chgData name="Devkar, Vikas" userId="acbd15ec-55d1-4a76-83ac-3f1d82711ed5" providerId="ADAL" clId="{1D085DC7-27BE-49ED-AA59-AC68119ECF15}" dt="2024-04-01T00:43:05.508" v="1455" actId="1035"/>
          <ac:spMkLst>
            <pc:docMk/>
            <pc:sldMk cId="772256198" sldId="272"/>
            <ac:spMk id="135" creationId="{1A6470FD-1041-CE7A-C3B3-6FCE137DA0D0}"/>
          </ac:spMkLst>
        </pc:spChg>
        <pc:spChg chg="add del mod">
          <ac:chgData name="Devkar, Vikas" userId="acbd15ec-55d1-4a76-83ac-3f1d82711ed5" providerId="ADAL" clId="{1D085DC7-27BE-49ED-AA59-AC68119ECF15}" dt="2024-04-01T00:43:05.508" v="1455" actId="1035"/>
          <ac:spMkLst>
            <pc:docMk/>
            <pc:sldMk cId="772256198" sldId="272"/>
            <ac:spMk id="136" creationId="{007F5810-FD06-49C2-CB20-61D088A7618E}"/>
          </ac:spMkLst>
        </pc:spChg>
        <pc:spChg chg="add del mod">
          <ac:chgData name="Devkar, Vikas" userId="acbd15ec-55d1-4a76-83ac-3f1d82711ed5" providerId="ADAL" clId="{1D085DC7-27BE-49ED-AA59-AC68119ECF15}" dt="2024-04-01T00:43:05.508" v="1455" actId="1035"/>
          <ac:spMkLst>
            <pc:docMk/>
            <pc:sldMk cId="772256198" sldId="272"/>
            <ac:spMk id="140" creationId="{5A142951-4726-E388-4A7A-10419B2516D9}"/>
          </ac:spMkLst>
        </pc:spChg>
        <pc:spChg chg="add del mod">
          <ac:chgData name="Devkar, Vikas" userId="acbd15ec-55d1-4a76-83ac-3f1d82711ed5" providerId="ADAL" clId="{1D085DC7-27BE-49ED-AA59-AC68119ECF15}" dt="2024-04-01T00:43:05.508" v="1455" actId="1035"/>
          <ac:spMkLst>
            <pc:docMk/>
            <pc:sldMk cId="772256198" sldId="272"/>
            <ac:spMk id="141" creationId="{F0983390-5016-0C1F-86F7-60D0D5A9AE92}"/>
          </ac:spMkLst>
        </pc:spChg>
        <pc:spChg chg="add del mod">
          <ac:chgData name="Devkar, Vikas" userId="acbd15ec-55d1-4a76-83ac-3f1d82711ed5" providerId="ADAL" clId="{1D085DC7-27BE-49ED-AA59-AC68119ECF15}" dt="2024-04-01T00:43:05.508" v="1455" actId="1035"/>
          <ac:spMkLst>
            <pc:docMk/>
            <pc:sldMk cId="772256198" sldId="272"/>
            <ac:spMk id="142" creationId="{584B7048-C9A5-AABA-9A83-F9FAACBE98C9}"/>
          </ac:spMkLst>
        </pc:spChg>
        <pc:spChg chg="add del mod">
          <ac:chgData name="Devkar, Vikas" userId="acbd15ec-55d1-4a76-83ac-3f1d82711ed5" providerId="ADAL" clId="{1D085DC7-27BE-49ED-AA59-AC68119ECF15}" dt="2024-04-01T00:43:05.508" v="1455" actId="1035"/>
          <ac:spMkLst>
            <pc:docMk/>
            <pc:sldMk cId="772256198" sldId="272"/>
            <ac:spMk id="143" creationId="{D56F2D36-C264-3D47-C1C9-FC8BDC45289F}"/>
          </ac:spMkLst>
        </pc:spChg>
        <pc:spChg chg="add del mod">
          <ac:chgData name="Devkar, Vikas" userId="acbd15ec-55d1-4a76-83ac-3f1d82711ed5" providerId="ADAL" clId="{1D085DC7-27BE-49ED-AA59-AC68119ECF15}" dt="2024-04-01T00:43:05.508" v="1455" actId="1035"/>
          <ac:spMkLst>
            <pc:docMk/>
            <pc:sldMk cId="772256198" sldId="272"/>
            <ac:spMk id="144" creationId="{66626D36-E742-783E-606E-FCCBFA1B0172}"/>
          </ac:spMkLst>
        </pc:spChg>
        <pc:spChg chg="add del mod">
          <ac:chgData name="Devkar, Vikas" userId="acbd15ec-55d1-4a76-83ac-3f1d82711ed5" providerId="ADAL" clId="{1D085DC7-27BE-49ED-AA59-AC68119ECF15}" dt="2024-04-01T00:43:05.508" v="1455" actId="1035"/>
          <ac:spMkLst>
            <pc:docMk/>
            <pc:sldMk cId="772256198" sldId="272"/>
            <ac:spMk id="145" creationId="{1C1EDB1B-0D00-B6CC-85D9-B61B968B5F33}"/>
          </ac:spMkLst>
        </pc:spChg>
        <pc:spChg chg="add del mod">
          <ac:chgData name="Devkar, Vikas" userId="acbd15ec-55d1-4a76-83ac-3f1d82711ed5" providerId="ADAL" clId="{1D085DC7-27BE-49ED-AA59-AC68119ECF15}" dt="2024-04-01T00:43:05.508" v="1455" actId="1035"/>
          <ac:spMkLst>
            <pc:docMk/>
            <pc:sldMk cId="772256198" sldId="272"/>
            <ac:spMk id="146" creationId="{AE85E327-F381-1365-F04B-B6858198F5A4}"/>
          </ac:spMkLst>
        </pc:spChg>
        <pc:spChg chg="add del mod">
          <ac:chgData name="Devkar, Vikas" userId="acbd15ec-55d1-4a76-83ac-3f1d82711ed5" providerId="ADAL" clId="{1D085DC7-27BE-49ED-AA59-AC68119ECF15}" dt="2024-04-01T00:43:05.508" v="1455" actId="1035"/>
          <ac:spMkLst>
            <pc:docMk/>
            <pc:sldMk cId="772256198" sldId="272"/>
            <ac:spMk id="148" creationId="{677026D3-29DE-AE51-C9F2-FE5C2A7978E6}"/>
          </ac:spMkLst>
        </pc:spChg>
        <pc:spChg chg="add del mod">
          <ac:chgData name="Devkar, Vikas" userId="acbd15ec-55d1-4a76-83ac-3f1d82711ed5" providerId="ADAL" clId="{1D085DC7-27BE-49ED-AA59-AC68119ECF15}" dt="2024-04-01T00:43:05.508" v="1455" actId="1035"/>
          <ac:spMkLst>
            <pc:docMk/>
            <pc:sldMk cId="772256198" sldId="272"/>
            <ac:spMk id="149" creationId="{3253A329-22CE-F47F-1DEB-835B59711B82}"/>
          </ac:spMkLst>
        </pc:spChg>
        <pc:spChg chg="add del mod">
          <ac:chgData name="Devkar, Vikas" userId="acbd15ec-55d1-4a76-83ac-3f1d82711ed5" providerId="ADAL" clId="{1D085DC7-27BE-49ED-AA59-AC68119ECF15}" dt="2024-04-01T00:43:05.508" v="1455" actId="1035"/>
          <ac:spMkLst>
            <pc:docMk/>
            <pc:sldMk cId="772256198" sldId="272"/>
            <ac:spMk id="152" creationId="{3B3630C6-0947-ABCA-520D-AAB40561376D}"/>
          </ac:spMkLst>
        </pc:spChg>
        <pc:spChg chg="add del mod">
          <ac:chgData name="Devkar, Vikas" userId="acbd15ec-55d1-4a76-83ac-3f1d82711ed5" providerId="ADAL" clId="{1D085DC7-27BE-49ED-AA59-AC68119ECF15}" dt="2024-04-01T00:43:05.508" v="1455" actId="1035"/>
          <ac:spMkLst>
            <pc:docMk/>
            <pc:sldMk cId="772256198" sldId="272"/>
            <ac:spMk id="153" creationId="{113EDDED-D5CE-66B0-DAAE-8D9A7D6F9F9C}"/>
          </ac:spMkLst>
        </pc:spChg>
        <pc:spChg chg="add del mod">
          <ac:chgData name="Devkar, Vikas" userId="acbd15ec-55d1-4a76-83ac-3f1d82711ed5" providerId="ADAL" clId="{1D085DC7-27BE-49ED-AA59-AC68119ECF15}" dt="2024-04-01T00:43:05.508" v="1455" actId="1035"/>
          <ac:spMkLst>
            <pc:docMk/>
            <pc:sldMk cId="772256198" sldId="272"/>
            <ac:spMk id="154" creationId="{EDDA5A2E-23A2-BD70-1AA8-098A63B40F6A}"/>
          </ac:spMkLst>
        </pc:spChg>
        <pc:spChg chg="add del mod">
          <ac:chgData name="Devkar, Vikas" userId="acbd15ec-55d1-4a76-83ac-3f1d82711ed5" providerId="ADAL" clId="{1D085DC7-27BE-49ED-AA59-AC68119ECF15}" dt="2024-04-01T00:43:05.508" v="1455" actId="1035"/>
          <ac:spMkLst>
            <pc:docMk/>
            <pc:sldMk cId="772256198" sldId="272"/>
            <ac:spMk id="155" creationId="{39F0E06D-3AEA-0A66-C061-51D2343069DB}"/>
          </ac:spMkLst>
        </pc:spChg>
        <pc:spChg chg="add del mod">
          <ac:chgData name="Devkar, Vikas" userId="acbd15ec-55d1-4a76-83ac-3f1d82711ed5" providerId="ADAL" clId="{1D085DC7-27BE-49ED-AA59-AC68119ECF15}" dt="2024-04-01T00:43:05.508" v="1455" actId="1035"/>
          <ac:spMkLst>
            <pc:docMk/>
            <pc:sldMk cId="772256198" sldId="272"/>
            <ac:spMk id="168" creationId="{3A1F7A86-0828-767F-A9BE-0B01BE1851C7}"/>
          </ac:spMkLst>
        </pc:spChg>
        <pc:spChg chg="add del mod">
          <ac:chgData name="Devkar, Vikas" userId="acbd15ec-55d1-4a76-83ac-3f1d82711ed5" providerId="ADAL" clId="{1D085DC7-27BE-49ED-AA59-AC68119ECF15}" dt="2024-04-01T00:43:05.508" v="1455" actId="1035"/>
          <ac:spMkLst>
            <pc:docMk/>
            <pc:sldMk cId="772256198" sldId="272"/>
            <ac:spMk id="169" creationId="{8AE3D2D3-3DAB-9119-DF31-AF50FD82723E}"/>
          </ac:spMkLst>
        </pc:spChg>
        <pc:spChg chg="add del mod">
          <ac:chgData name="Devkar, Vikas" userId="acbd15ec-55d1-4a76-83ac-3f1d82711ed5" providerId="ADAL" clId="{1D085DC7-27BE-49ED-AA59-AC68119ECF15}" dt="2024-04-01T00:43:05.508" v="1455" actId="1035"/>
          <ac:spMkLst>
            <pc:docMk/>
            <pc:sldMk cId="772256198" sldId="272"/>
            <ac:spMk id="174" creationId="{B98DE7BB-F231-B6D4-AFE5-04E9E87D96FA}"/>
          </ac:spMkLst>
        </pc:spChg>
        <pc:spChg chg="add del mod">
          <ac:chgData name="Devkar, Vikas" userId="acbd15ec-55d1-4a76-83ac-3f1d82711ed5" providerId="ADAL" clId="{1D085DC7-27BE-49ED-AA59-AC68119ECF15}" dt="2024-04-01T00:43:05.508" v="1455" actId="1035"/>
          <ac:spMkLst>
            <pc:docMk/>
            <pc:sldMk cId="772256198" sldId="272"/>
            <ac:spMk id="175" creationId="{1CF14F6C-2F05-DF1E-7535-288D7550072F}"/>
          </ac:spMkLst>
        </pc:spChg>
        <pc:spChg chg="mod">
          <ac:chgData name="Devkar, Vikas" userId="acbd15ec-55d1-4a76-83ac-3f1d82711ed5" providerId="ADAL" clId="{1D085DC7-27BE-49ED-AA59-AC68119ECF15}" dt="2024-03-28T15:13:43.726" v="960" actId="2711"/>
          <ac:spMkLst>
            <pc:docMk/>
            <pc:sldMk cId="772256198" sldId="272"/>
            <ac:spMk id="179" creationId="{3C2316BF-2F35-9066-8699-249805EDCF05}"/>
          </ac:spMkLst>
        </pc:spChg>
        <pc:spChg chg="mod">
          <ac:chgData name="Devkar, Vikas" userId="acbd15ec-55d1-4a76-83ac-3f1d82711ed5" providerId="ADAL" clId="{1D085DC7-27BE-49ED-AA59-AC68119ECF15}" dt="2024-03-28T15:13:43.726" v="960" actId="2711"/>
          <ac:spMkLst>
            <pc:docMk/>
            <pc:sldMk cId="772256198" sldId="272"/>
            <ac:spMk id="180" creationId="{B7AD0E85-9C63-C3AF-D997-5C64C922FA6A}"/>
          </ac:spMkLst>
        </pc:spChg>
        <pc:spChg chg="mod">
          <ac:chgData name="Devkar, Vikas" userId="acbd15ec-55d1-4a76-83ac-3f1d82711ed5" providerId="ADAL" clId="{1D085DC7-27BE-49ED-AA59-AC68119ECF15}" dt="2024-03-28T15:13:43.726" v="960" actId="2711"/>
          <ac:spMkLst>
            <pc:docMk/>
            <pc:sldMk cId="772256198" sldId="272"/>
            <ac:spMk id="181" creationId="{F5B4B04F-2168-09E3-933C-52CBB4F66F2D}"/>
          </ac:spMkLst>
        </pc:spChg>
        <pc:spChg chg="mod">
          <ac:chgData name="Devkar, Vikas" userId="acbd15ec-55d1-4a76-83ac-3f1d82711ed5" providerId="ADAL" clId="{1D085DC7-27BE-49ED-AA59-AC68119ECF15}" dt="2024-03-28T15:13:43.726" v="960" actId="2711"/>
          <ac:spMkLst>
            <pc:docMk/>
            <pc:sldMk cId="772256198" sldId="272"/>
            <ac:spMk id="182" creationId="{06891363-7AC5-44F3-5299-B3729136E343}"/>
          </ac:spMkLst>
        </pc:spChg>
        <pc:spChg chg="mod">
          <ac:chgData name="Devkar, Vikas" userId="acbd15ec-55d1-4a76-83ac-3f1d82711ed5" providerId="ADAL" clId="{1D085DC7-27BE-49ED-AA59-AC68119ECF15}" dt="2024-03-28T15:13:43.726" v="960" actId="2711"/>
          <ac:spMkLst>
            <pc:docMk/>
            <pc:sldMk cId="772256198" sldId="272"/>
            <ac:spMk id="183" creationId="{DCA87021-43F7-F57D-E101-82059B3421E9}"/>
          </ac:spMkLst>
        </pc:spChg>
        <pc:spChg chg="mod">
          <ac:chgData name="Devkar, Vikas" userId="acbd15ec-55d1-4a76-83ac-3f1d82711ed5" providerId="ADAL" clId="{1D085DC7-27BE-49ED-AA59-AC68119ECF15}" dt="2024-03-28T15:13:43.726" v="960" actId="2711"/>
          <ac:spMkLst>
            <pc:docMk/>
            <pc:sldMk cId="772256198" sldId="272"/>
            <ac:spMk id="184" creationId="{1A99D993-4FCF-5EC0-8544-2F3F09A34BE1}"/>
          </ac:spMkLst>
        </pc:spChg>
        <pc:spChg chg="mod">
          <ac:chgData name="Devkar, Vikas" userId="acbd15ec-55d1-4a76-83ac-3f1d82711ed5" providerId="ADAL" clId="{1D085DC7-27BE-49ED-AA59-AC68119ECF15}" dt="2024-03-28T15:13:43.726" v="960" actId="2711"/>
          <ac:spMkLst>
            <pc:docMk/>
            <pc:sldMk cId="772256198" sldId="272"/>
            <ac:spMk id="185" creationId="{FFF373F9-B5DC-4CEB-C343-D9E681143E4A}"/>
          </ac:spMkLst>
        </pc:spChg>
        <pc:spChg chg="mod">
          <ac:chgData name="Devkar, Vikas" userId="acbd15ec-55d1-4a76-83ac-3f1d82711ed5" providerId="ADAL" clId="{1D085DC7-27BE-49ED-AA59-AC68119ECF15}" dt="2024-03-28T15:13:43.726" v="960" actId="2711"/>
          <ac:spMkLst>
            <pc:docMk/>
            <pc:sldMk cId="772256198" sldId="272"/>
            <ac:spMk id="186" creationId="{B2472036-C663-5549-294D-8A8B62203808}"/>
          </ac:spMkLst>
        </pc:spChg>
        <pc:spChg chg="mod">
          <ac:chgData name="Devkar, Vikas" userId="acbd15ec-55d1-4a76-83ac-3f1d82711ed5" providerId="ADAL" clId="{1D085DC7-27BE-49ED-AA59-AC68119ECF15}" dt="2024-03-28T15:17:19.363" v="1030" actId="404"/>
          <ac:spMkLst>
            <pc:docMk/>
            <pc:sldMk cId="772256198" sldId="272"/>
            <ac:spMk id="193" creationId="{0995AC17-2FDC-F6D8-46FF-9B41444C27F5}"/>
          </ac:spMkLst>
        </pc:spChg>
        <pc:spChg chg="mod">
          <ac:chgData name="Devkar, Vikas" userId="acbd15ec-55d1-4a76-83ac-3f1d82711ed5" providerId="ADAL" clId="{1D085DC7-27BE-49ED-AA59-AC68119ECF15}" dt="2024-03-28T15:17:19.363" v="1030" actId="404"/>
          <ac:spMkLst>
            <pc:docMk/>
            <pc:sldMk cId="772256198" sldId="272"/>
            <ac:spMk id="194" creationId="{F1E4D521-2FB4-7978-BC62-6C75A275DF07}"/>
          </ac:spMkLst>
        </pc:spChg>
        <pc:spChg chg="mod">
          <ac:chgData name="Devkar, Vikas" userId="acbd15ec-55d1-4a76-83ac-3f1d82711ed5" providerId="ADAL" clId="{1D085DC7-27BE-49ED-AA59-AC68119ECF15}" dt="2024-03-28T15:17:19.363" v="1030" actId="404"/>
          <ac:spMkLst>
            <pc:docMk/>
            <pc:sldMk cId="772256198" sldId="272"/>
            <ac:spMk id="195" creationId="{63C180AD-5918-BE9B-978C-3559CE315EC5}"/>
          </ac:spMkLst>
        </pc:spChg>
        <pc:spChg chg="mod">
          <ac:chgData name="Devkar, Vikas" userId="acbd15ec-55d1-4a76-83ac-3f1d82711ed5" providerId="ADAL" clId="{1D085DC7-27BE-49ED-AA59-AC68119ECF15}" dt="2024-03-28T15:17:19.363" v="1030" actId="404"/>
          <ac:spMkLst>
            <pc:docMk/>
            <pc:sldMk cId="772256198" sldId="272"/>
            <ac:spMk id="196" creationId="{D7A89E11-7A6E-0633-BD31-C4A26C85DFC3}"/>
          </ac:spMkLst>
        </pc:spChg>
        <pc:spChg chg="mod">
          <ac:chgData name="Devkar, Vikas" userId="acbd15ec-55d1-4a76-83ac-3f1d82711ed5" providerId="ADAL" clId="{1D085DC7-27BE-49ED-AA59-AC68119ECF15}" dt="2024-03-28T15:17:19.363" v="1030" actId="404"/>
          <ac:spMkLst>
            <pc:docMk/>
            <pc:sldMk cId="772256198" sldId="272"/>
            <ac:spMk id="197" creationId="{6CB0389D-7F5A-1531-928B-8625613722F6}"/>
          </ac:spMkLst>
        </pc:spChg>
        <pc:spChg chg="mod">
          <ac:chgData name="Devkar, Vikas" userId="acbd15ec-55d1-4a76-83ac-3f1d82711ed5" providerId="ADAL" clId="{1D085DC7-27BE-49ED-AA59-AC68119ECF15}" dt="2024-03-28T15:17:19.363" v="1030" actId="404"/>
          <ac:spMkLst>
            <pc:docMk/>
            <pc:sldMk cId="772256198" sldId="272"/>
            <ac:spMk id="198" creationId="{DB2821F2-68FF-5D61-5202-F7912BA6C348}"/>
          </ac:spMkLst>
        </pc:spChg>
        <pc:grpChg chg="del mod">
          <ac:chgData name="Devkar, Vikas" userId="acbd15ec-55d1-4a76-83ac-3f1d82711ed5" providerId="ADAL" clId="{1D085DC7-27BE-49ED-AA59-AC68119ECF15}" dt="2024-04-01T00:36:33.806" v="1319" actId="165"/>
          <ac:grpSpMkLst>
            <pc:docMk/>
            <pc:sldMk cId="772256198" sldId="272"/>
            <ac:grpSpMk id="9" creationId="{1BDB9C98-C494-2468-7F22-31E5A47C01D7}"/>
          </ac:grpSpMkLst>
        </pc:grpChg>
        <pc:grpChg chg="add del mod">
          <ac:chgData name="Devkar, Vikas" userId="acbd15ec-55d1-4a76-83ac-3f1d82711ed5" providerId="ADAL" clId="{1D085DC7-27BE-49ED-AA59-AC68119ECF15}" dt="2024-04-01T00:43:05.508" v="1455" actId="1035"/>
          <ac:grpSpMkLst>
            <pc:docMk/>
            <pc:sldMk cId="772256198" sldId="272"/>
            <ac:grpSpMk id="28" creationId="{3D3DE493-6E2A-3F42-DFD1-7CAC893114FD}"/>
          </ac:grpSpMkLst>
        </pc:grpChg>
        <pc:grpChg chg="add del mod">
          <ac:chgData name="Devkar, Vikas" userId="acbd15ec-55d1-4a76-83ac-3f1d82711ed5" providerId="ADAL" clId="{1D085DC7-27BE-49ED-AA59-AC68119ECF15}" dt="2024-04-01T00:43:05.508" v="1455" actId="1035"/>
          <ac:grpSpMkLst>
            <pc:docMk/>
            <pc:sldMk cId="772256198" sldId="272"/>
            <ac:grpSpMk id="29" creationId="{99F9B234-C49B-88EA-6935-0CACED7CAA5D}"/>
          </ac:grpSpMkLst>
        </pc:grpChg>
        <pc:grpChg chg="add del mod">
          <ac:chgData name="Devkar, Vikas" userId="acbd15ec-55d1-4a76-83ac-3f1d82711ed5" providerId="ADAL" clId="{1D085DC7-27BE-49ED-AA59-AC68119ECF15}" dt="2024-04-01T00:43:05.508" v="1455" actId="1035"/>
          <ac:grpSpMkLst>
            <pc:docMk/>
            <pc:sldMk cId="772256198" sldId="272"/>
            <ac:grpSpMk id="30" creationId="{F4291BC0-4CB0-79D3-223D-BB3A31726190}"/>
          </ac:grpSpMkLst>
        </pc:grpChg>
        <pc:grpChg chg="add del mod">
          <ac:chgData name="Devkar, Vikas" userId="acbd15ec-55d1-4a76-83ac-3f1d82711ed5" providerId="ADAL" clId="{1D085DC7-27BE-49ED-AA59-AC68119ECF15}" dt="2024-04-01T00:43:05.508" v="1455" actId="1035"/>
          <ac:grpSpMkLst>
            <pc:docMk/>
            <pc:sldMk cId="772256198" sldId="272"/>
            <ac:grpSpMk id="64" creationId="{52D4E5FA-5738-69AD-F7EA-BFB3BA884351}"/>
          </ac:grpSpMkLst>
        </pc:grpChg>
        <pc:grpChg chg="add del mod">
          <ac:chgData name="Devkar, Vikas" userId="acbd15ec-55d1-4a76-83ac-3f1d82711ed5" providerId="ADAL" clId="{1D085DC7-27BE-49ED-AA59-AC68119ECF15}" dt="2024-04-01T00:43:05.508" v="1455" actId="1035"/>
          <ac:grpSpMkLst>
            <pc:docMk/>
            <pc:sldMk cId="772256198" sldId="272"/>
            <ac:grpSpMk id="167" creationId="{D842885B-A23B-AB4E-0848-1A587A10C605}"/>
          </ac:grpSpMkLst>
        </pc:grpChg>
        <pc:grpChg chg="add del mod">
          <ac:chgData name="Devkar, Vikas" userId="acbd15ec-55d1-4a76-83ac-3f1d82711ed5" providerId="ADAL" clId="{1D085DC7-27BE-49ED-AA59-AC68119ECF15}" dt="2024-04-01T00:43:05.508" v="1455" actId="1035"/>
          <ac:grpSpMkLst>
            <pc:docMk/>
            <pc:sldMk cId="772256198" sldId="272"/>
            <ac:grpSpMk id="172" creationId="{CCA67366-4F9F-3433-AD2D-7A02296B820E}"/>
          </ac:grpSpMkLst>
        </pc:grpChg>
        <pc:grpChg chg="add del mod">
          <ac:chgData name="Devkar, Vikas" userId="acbd15ec-55d1-4a76-83ac-3f1d82711ed5" providerId="ADAL" clId="{1D085DC7-27BE-49ED-AA59-AC68119ECF15}" dt="2024-04-01T00:43:05.508" v="1455" actId="1035"/>
          <ac:grpSpMkLst>
            <pc:docMk/>
            <pc:sldMk cId="772256198" sldId="272"/>
            <ac:grpSpMk id="173" creationId="{9F9C8878-092E-ABBE-B21C-D32282FD2F2F}"/>
          </ac:grpSpMkLst>
        </pc:grpChg>
        <pc:picChg chg="mod topLvl">
          <ac:chgData name="Devkar, Vikas" userId="acbd15ec-55d1-4a76-83ac-3f1d82711ed5" providerId="ADAL" clId="{1D085DC7-27BE-49ED-AA59-AC68119ECF15}" dt="2024-04-01T00:36:33.806" v="1319" actId="165"/>
          <ac:picMkLst>
            <pc:docMk/>
            <pc:sldMk cId="772256198" sldId="272"/>
            <ac:picMk id="5" creationId="{67BA1CDC-EEFE-AD8C-D3DF-F549A0719965}"/>
          </ac:picMkLst>
        </pc:picChg>
        <pc:picChg chg="mod topLvl">
          <ac:chgData name="Devkar, Vikas" userId="acbd15ec-55d1-4a76-83ac-3f1d82711ed5" providerId="ADAL" clId="{1D085DC7-27BE-49ED-AA59-AC68119ECF15}" dt="2024-04-01T00:38:19.237" v="1332" actId="1076"/>
          <ac:picMkLst>
            <pc:docMk/>
            <pc:sldMk cId="772256198" sldId="272"/>
            <ac:picMk id="10" creationId="{878DA4FE-FB76-4218-281C-4E9185D94F6A}"/>
          </ac:picMkLst>
        </pc:picChg>
        <pc:picChg chg="mod topLvl">
          <ac:chgData name="Devkar, Vikas" userId="acbd15ec-55d1-4a76-83ac-3f1d82711ed5" providerId="ADAL" clId="{1D085DC7-27BE-49ED-AA59-AC68119ECF15}" dt="2024-04-01T18:56:29.935" v="1553" actId="1037"/>
          <ac:picMkLst>
            <pc:docMk/>
            <pc:sldMk cId="772256198" sldId="272"/>
            <ac:picMk id="44" creationId="{A9781AED-3489-1DC9-E3FE-B9A63D310D4C}"/>
          </ac:picMkLst>
        </pc:picChg>
        <pc:cxnChg chg="add del mod">
          <ac:chgData name="Devkar, Vikas" userId="acbd15ec-55d1-4a76-83ac-3f1d82711ed5" providerId="ADAL" clId="{1D085DC7-27BE-49ED-AA59-AC68119ECF15}" dt="2024-04-01T00:43:05.508" v="1455" actId="1035"/>
          <ac:cxnSpMkLst>
            <pc:docMk/>
            <pc:sldMk cId="772256198" sldId="272"/>
            <ac:cxnSpMk id="51" creationId="{BF4BE863-88CE-4173-E7BD-D64210102CD5}"/>
          </ac:cxnSpMkLst>
        </pc:cxnChg>
        <pc:cxnChg chg="add del mod">
          <ac:chgData name="Devkar, Vikas" userId="acbd15ec-55d1-4a76-83ac-3f1d82711ed5" providerId="ADAL" clId="{1D085DC7-27BE-49ED-AA59-AC68119ECF15}" dt="2024-04-01T00:43:05.508" v="1455" actId="1035"/>
          <ac:cxnSpMkLst>
            <pc:docMk/>
            <pc:sldMk cId="772256198" sldId="272"/>
            <ac:cxnSpMk id="52" creationId="{31455D91-00D1-1705-1478-F7D0422AB9A8}"/>
          </ac:cxnSpMkLst>
        </pc:cxnChg>
        <pc:cxnChg chg="add del mod">
          <ac:chgData name="Devkar, Vikas" userId="acbd15ec-55d1-4a76-83ac-3f1d82711ed5" providerId="ADAL" clId="{1D085DC7-27BE-49ED-AA59-AC68119ECF15}" dt="2024-04-01T00:43:05.508" v="1455" actId="1035"/>
          <ac:cxnSpMkLst>
            <pc:docMk/>
            <pc:sldMk cId="772256198" sldId="272"/>
            <ac:cxnSpMk id="53" creationId="{999F1144-E59F-769E-10F8-23609A2A18E4}"/>
          </ac:cxnSpMkLst>
        </pc:cxnChg>
        <pc:cxnChg chg="add del mod">
          <ac:chgData name="Devkar, Vikas" userId="acbd15ec-55d1-4a76-83ac-3f1d82711ed5" providerId="ADAL" clId="{1D085DC7-27BE-49ED-AA59-AC68119ECF15}" dt="2024-04-01T00:43:05.508" v="1455" actId="1035"/>
          <ac:cxnSpMkLst>
            <pc:docMk/>
            <pc:sldMk cId="772256198" sldId="272"/>
            <ac:cxnSpMk id="66" creationId="{F3BA32AD-87F6-9D23-9EA6-98AEA0369B42}"/>
          </ac:cxnSpMkLst>
        </pc:cxnChg>
        <pc:cxnChg chg="add del mod">
          <ac:chgData name="Devkar, Vikas" userId="acbd15ec-55d1-4a76-83ac-3f1d82711ed5" providerId="ADAL" clId="{1D085DC7-27BE-49ED-AA59-AC68119ECF15}" dt="2024-04-01T00:43:05.508" v="1455" actId="1035"/>
          <ac:cxnSpMkLst>
            <pc:docMk/>
            <pc:sldMk cId="772256198" sldId="272"/>
            <ac:cxnSpMk id="67" creationId="{7F2D5A69-5068-B3F7-AF48-94CF68B4CBEF}"/>
          </ac:cxnSpMkLst>
        </pc:cxnChg>
        <pc:cxnChg chg="add del mod">
          <ac:chgData name="Devkar, Vikas" userId="acbd15ec-55d1-4a76-83ac-3f1d82711ed5" providerId="ADAL" clId="{1D085DC7-27BE-49ED-AA59-AC68119ECF15}" dt="2024-04-01T00:43:05.508" v="1455" actId="1035"/>
          <ac:cxnSpMkLst>
            <pc:docMk/>
            <pc:sldMk cId="772256198" sldId="272"/>
            <ac:cxnSpMk id="69" creationId="{9D6EA3D2-B023-7394-3585-A7C6C5EB647B}"/>
          </ac:cxnSpMkLst>
        </pc:cxnChg>
        <pc:cxnChg chg="add del mod">
          <ac:chgData name="Devkar, Vikas" userId="acbd15ec-55d1-4a76-83ac-3f1d82711ed5" providerId="ADAL" clId="{1D085DC7-27BE-49ED-AA59-AC68119ECF15}" dt="2024-04-01T00:43:05.508" v="1455" actId="1035"/>
          <ac:cxnSpMkLst>
            <pc:docMk/>
            <pc:sldMk cId="772256198" sldId="272"/>
            <ac:cxnSpMk id="80" creationId="{5C455BD6-B96D-730D-43B2-1F3FF384F6D3}"/>
          </ac:cxnSpMkLst>
        </pc:cxnChg>
        <pc:cxnChg chg="add del mod">
          <ac:chgData name="Devkar, Vikas" userId="acbd15ec-55d1-4a76-83ac-3f1d82711ed5" providerId="ADAL" clId="{1D085DC7-27BE-49ED-AA59-AC68119ECF15}" dt="2024-04-01T00:43:05.508" v="1455" actId="1035"/>
          <ac:cxnSpMkLst>
            <pc:docMk/>
            <pc:sldMk cId="772256198" sldId="272"/>
            <ac:cxnSpMk id="81" creationId="{C8E24B77-3AAB-2F50-EF3D-EEBC9DC0E6D1}"/>
          </ac:cxnSpMkLst>
        </pc:cxnChg>
        <pc:cxnChg chg="add del mod">
          <ac:chgData name="Devkar, Vikas" userId="acbd15ec-55d1-4a76-83ac-3f1d82711ed5" providerId="ADAL" clId="{1D085DC7-27BE-49ED-AA59-AC68119ECF15}" dt="2024-04-01T00:43:05.508" v="1455" actId="1035"/>
          <ac:cxnSpMkLst>
            <pc:docMk/>
            <pc:sldMk cId="772256198" sldId="272"/>
            <ac:cxnSpMk id="83" creationId="{A75D8204-4317-3B97-9FCB-6B82121E8C23}"/>
          </ac:cxnSpMkLst>
        </pc:cxnChg>
        <pc:cxnChg chg="add del mod">
          <ac:chgData name="Devkar, Vikas" userId="acbd15ec-55d1-4a76-83ac-3f1d82711ed5" providerId="ADAL" clId="{1D085DC7-27BE-49ED-AA59-AC68119ECF15}" dt="2024-04-01T00:43:05.508" v="1455" actId="1035"/>
          <ac:cxnSpMkLst>
            <pc:docMk/>
            <pc:sldMk cId="772256198" sldId="272"/>
            <ac:cxnSpMk id="84" creationId="{9664F058-FFB3-0CEB-B5CB-8CBC81D52FDF}"/>
          </ac:cxnSpMkLst>
        </pc:cxnChg>
        <pc:cxnChg chg="add del mod">
          <ac:chgData name="Devkar, Vikas" userId="acbd15ec-55d1-4a76-83ac-3f1d82711ed5" providerId="ADAL" clId="{1D085DC7-27BE-49ED-AA59-AC68119ECF15}" dt="2024-04-01T00:43:05.508" v="1455" actId="1035"/>
          <ac:cxnSpMkLst>
            <pc:docMk/>
            <pc:sldMk cId="772256198" sldId="272"/>
            <ac:cxnSpMk id="85" creationId="{0DB4A719-1C1D-8948-5E35-0E4492317C49}"/>
          </ac:cxnSpMkLst>
        </pc:cxnChg>
        <pc:cxnChg chg="add del mod">
          <ac:chgData name="Devkar, Vikas" userId="acbd15ec-55d1-4a76-83ac-3f1d82711ed5" providerId="ADAL" clId="{1D085DC7-27BE-49ED-AA59-AC68119ECF15}" dt="2024-04-01T00:43:05.508" v="1455" actId="1035"/>
          <ac:cxnSpMkLst>
            <pc:docMk/>
            <pc:sldMk cId="772256198" sldId="272"/>
            <ac:cxnSpMk id="87" creationId="{05247A6D-6C3C-A7D4-3BDB-C74792D95479}"/>
          </ac:cxnSpMkLst>
        </pc:cxnChg>
        <pc:cxnChg chg="add del mod">
          <ac:chgData name="Devkar, Vikas" userId="acbd15ec-55d1-4a76-83ac-3f1d82711ed5" providerId="ADAL" clId="{1D085DC7-27BE-49ED-AA59-AC68119ECF15}" dt="2024-04-01T00:43:05.508" v="1455" actId="1035"/>
          <ac:cxnSpMkLst>
            <pc:docMk/>
            <pc:sldMk cId="772256198" sldId="272"/>
            <ac:cxnSpMk id="88" creationId="{832C4FC8-5BA0-ECA8-C93B-CC02FE31BE46}"/>
          </ac:cxnSpMkLst>
        </pc:cxnChg>
        <pc:cxnChg chg="add del mod">
          <ac:chgData name="Devkar, Vikas" userId="acbd15ec-55d1-4a76-83ac-3f1d82711ed5" providerId="ADAL" clId="{1D085DC7-27BE-49ED-AA59-AC68119ECF15}" dt="2024-04-01T00:43:05.508" v="1455" actId="1035"/>
          <ac:cxnSpMkLst>
            <pc:docMk/>
            <pc:sldMk cId="772256198" sldId="272"/>
            <ac:cxnSpMk id="98" creationId="{9B69124D-11E4-E076-6F65-2DC9EEEEE173}"/>
          </ac:cxnSpMkLst>
        </pc:cxnChg>
        <pc:cxnChg chg="add del mod">
          <ac:chgData name="Devkar, Vikas" userId="acbd15ec-55d1-4a76-83ac-3f1d82711ed5" providerId="ADAL" clId="{1D085DC7-27BE-49ED-AA59-AC68119ECF15}" dt="2024-04-01T00:43:05.508" v="1455" actId="1035"/>
          <ac:cxnSpMkLst>
            <pc:docMk/>
            <pc:sldMk cId="772256198" sldId="272"/>
            <ac:cxnSpMk id="99" creationId="{37570CE8-861C-77B8-3D81-0C941DE57B50}"/>
          </ac:cxnSpMkLst>
        </pc:cxnChg>
        <pc:cxnChg chg="add del mod">
          <ac:chgData name="Devkar, Vikas" userId="acbd15ec-55d1-4a76-83ac-3f1d82711ed5" providerId="ADAL" clId="{1D085DC7-27BE-49ED-AA59-AC68119ECF15}" dt="2024-04-01T00:43:05.508" v="1455" actId="1035"/>
          <ac:cxnSpMkLst>
            <pc:docMk/>
            <pc:sldMk cId="772256198" sldId="272"/>
            <ac:cxnSpMk id="111" creationId="{8C771EE0-9B2E-088A-7B33-CD51D0516BDE}"/>
          </ac:cxnSpMkLst>
        </pc:cxnChg>
        <pc:cxnChg chg="add del mod">
          <ac:chgData name="Devkar, Vikas" userId="acbd15ec-55d1-4a76-83ac-3f1d82711ed5" providerId="ADAL" clId="{1D085DC7-27BE-49ED-AA59-AC68119ECF15}" dt="2024-04-01T00:43:05.508" v="1455" actId="1035"/>
          <ac:cxnSpMkLst>
            <pc:docMk/>
            <pc:sldMk cId="772256198" sldId="272"/>
            <ac:cxnSpMk id="120" creationId="{439AD71C-DEA5-D5C8-A091-459C3ACA3358}"/>
          </ac:cxnSpMkLst>
        </pc:cxnChg>
        <pc:cxnChg chg="add del mod">
          <ac:chgData name="Devkar, Vikas" userId="acbd15ec-55d1-4a76-83ac-3f1d82711ed5" providerId="ADAL" clId="{1D085DC7-27BE-49ED-AA59-AC68119ECF15}" dt="2024-04-01T00:43:05.508" v="1455" actId="1035"/>
          <ac:cxnSpMkLst>
            <pc:docMk/>
            <pc:sldMk cId="772256198" sldId="272"/>
            <ac:cxnSpMk id="126" creationId="{81F3B27C-ADA7-329D-314A-E15C8E57D403}"/>
          </ac:cxnSpMkLst>
        </pc:cxnChg>
        <pc:cxnChg chg="add del mod">
          <ac:chgData name="Devkar, Vikas" userId="acbd15ec-55d1-4a76-83ac-3f1d82711ed5" providerId="ADAL" clId="{1D085DC7-27BE-49ED-AA59-AC68119ECF15}" dt="2024-04-01T00:43:05.508" v="1455" actId="1035"/>
          <ac:cxnSpMkLst>
            <pc:docMk/>
            <pc:sldMk cId="772256198" sldId="272"/>
            <ac:cxnSpMk id="128" creationId="{928994EA-F4BC-2FBA-70D5-2B6574960B46}"/>
          </ac:cxnSpMkLst>
        </pc:cxnChg>
        <pc:cxnChg chg="add del mod">
          <ac:chgData name="Devkar, Vikas" userId="acbd15ec-55d1-4a76-83ac-3f1d82711ed5" providerId="ADAL" clId="{1D085DC7-27BE-49ED-AA59-AC68119ECF15}" dt="2024-04-01T00:43:05.508" v="1455" actId="1035"/>
          <ac:cxnSpMkLst>
            <pc:docMk/>
            <pc:sldMk cId="772256198" sldId="272"/>
            <ac:cxnSpMk id="129" creationId="{213DD5A4-61CF-0BF9-C70D-2305063726EA}"/>
          </ac:cxnSpMkLst>
        </pc:cxnChg>
        <pc:cxnChg chg="add del mod">
          <ac:chgData name="Devkar, Vikas" userId="acbd15ec-55d1-4a76-83ac-3f1d82711ed5" providerId="ADAL" clId="{1D085DC7-27BE-49ED-AA59-AC68119ECF15}" dt="2024-04-01T00:43:05.508" v="1455" actId="1035"/>
          <ac:cxnSpMkLst>
            <pc:docMk/>
            <pc:sldMk cId="772256198" sldId="272"/>
            <ac:cxnSpMk id="130" creationId="{076191F4-7C70-E2CF-A2A1-018AA4F2D358}"/>
          </ac:cxnSpMkLst>
        </pc:cxnChg>
        <pc:cxnChg chg="add del mod">
          <ac:chgData name="Devkar, Vikas" userId="acbd15ec-55d1-4a76-83ac-3f1d82711ed5" providerId="ADAL" clId="{1D085DC7-27BE-49ED-AA59-AC68119ECF15}" dt="2024-04-01T00:43:05.508" v="1455" actId="1035"/>
          <ac:cxnSpMkLst>
            <pc:docMk/>
            <pc:sldMk cId="772256198" sldId="272"/>
            <ac:cxnSpMk id="131" creationId="{2B757326-EC7E-D8AF-9BDC-FD1A53667EF2}"/>
          </ac:cxnSpMkLst>
        </pc:cxnChg>
        <pc:cxnChg chg="add del mod">
          <ac:chgData name="Devkar, Vikas" userId="acbd15ec-55d1-4a76-83ac-3f1d82711ed5" providerId="ADAL" clId="{1D085DC7-27BE-49ED-AA59-AC68119ECF15}" dt="2024-04-01T00:43:05.508" v="1455" actId="1035"/>
          <ac:cxnSpMkLst>
            <pc:docMk/>
            <pc:sldMk cId="772256198" sldId="272"/>
            <ac:cxnSpMk id="147" creationId="{2BF73D87-538D-82F5-3BFA-D603532DCD30}"/>
          </ac:cxnSpMkLst>
        </pc:cxnChg>
        <pc:cxnChg chg="add del mod">
          <ac:chgData name="Devkar, Vikas" userId="acbd15ec-55d1-4a76-83ac-3f1d82711ed5" providerId="ADAL" clId="{1D085DC7-27BE-49ED-AA59-AC68119ECF15}" dt="2024-04-01T00:43:05.508" v="1455" actId="1035"/>
          <ac:cxnSpMkLst>
            <pc:docMk/>
            <pc:sldMk cId="772256198" sldId="272"/>
            <ac:cxnSpMk id="150" creationId="{3761B818-D2BB-7154-F6D1-6BFFB4DF7BE5}"/>
          </ac:cxnSpMkLst>
        </pc:cxnChg>
        <pc:cxnChg chg="add del mod">
          <ac:chgData name="Devkar, Vikas" userId="acbd15ec-55d1-4a76-83ac-3f1d82711ed5" providerId="ADAL" clId="{1D085DC7-27BE-49ED-AA59-AC68119ECF15}" dt="2024-04-01T00:43:05.508" v="1455" actId="1035"/>
          <ac:cxnSpMkLst>
            <pc:docMk/>
            <pc:sldMk cId="772256198" sldId="272"/>
            <ac:cxnSpMk id="162" creationId="{9D3761F2-3B57-00E6-A679-6306FD503837}"/>
          </ac:cxnSpMkLst>
        </pc:cxnChg>
        <pc:cxnChg chg="add del mod">
          <ac:chgData name="Devkar, Vikas" userId="acbd15ec-55d1-4a76-83ac-3f1d82711ed5" providerId="ADAL" clId="{1D085DC7-27BE-49ED-AA59-AC68119ECF15}" dt="2024-04-01T00:43:05.508" v="1455" actId="1035"/>
          <ac:cxnSpMkLst>
            <pc:docMk/>
            <pc:sldMk cId="772256198" sldId="272"/>
            <ac:cxnSpMk id="163" creationId="{65320ACA-0891-45B8-53C4-DACB666CE9FD}"/>
          </ac:cxnSpMkLst>
        </pc:cxnChg>
        <pc:cxnChg chg="add del mod">
          <ac:chgData name="Devkar, Vikas" userId="acbd15ec-55d1-4a76-83ac-3f1d82711ed5" providerId="ADAL" clId="{1D085DC7-27BE-49ED-AA59-AC68119ECF15}" dt="2024-04-01T00:43:05.508" v="1455" actId="1035"/>
          <ac:cxnSpMkLst>
            <pc:docMk/>
            <pc:sldMk cId="772256198" sldId="272"/>
            <ac:cxnSpMk id="164" creationId="{779EC635-6078-89C8-A702-E010690FCF57}"/>
          </ac:cxnSpMkLst>
        </pc:cxnChg>
        <pc:cxnChg chg="add del mod">
          <ac:chgData name="Devkar, Vikas" userId="acbd15ec-55d1-4a76-83ac-3f1d82711ed5" providerId="ADAL" clId="{1D085DC7-27BE-49ED-AA59-AC68119ECF15}" dt="2024-04-01T00:43:05.508" v="1455" actId="1035"/>
          <ac:cxnSpMkLst>
            <pc:docMk/>
            <pc:sldMk cId="772256198" sldId="272"/>
            <ac:cxnSpMk id="165" creationId="{FB1CAC9C-3947-939D-146A-5891B6990C16}"/>
          </ac:cxnSpMkLst>
        </pc:cxnChg>
        <pc:cxnChg chg="add del mod">
          <ac:chgData name="Devkar, Vikas" userId="acbd15ec-55d1-4a76-83ac-3f1d82711ed5" providerId="ADAL" clId="{1D085DC7-27BE-49ED-AA59-AC68119ECF15}" dt="2024-04-01T00:43:05.508" v="1455" actId="1035"/>
          <ac:cxnSpMkLst>
            <pc:docMk/>
            <pc:sldMk cId="772256198" sldId="272"/>
            <ac:cxnSpMk id="166" creationId="{58DD82DD-5C52-92E4-83B8-A7AFEE7416B2}"/>
          </ac:cxnSpMkLst>
        </pc:cxnChg>
        <pc:cxnChg chg="add del mod">
          <ac:chgData name="Devkar, Vikas" userId="acbd15ec-55d1-4a76-83ac-3f1d82711ed5" providerId="ADAL" clId="{1D085DC7-27BE-49ED-AA59-AC68119ECF15}" dt="2024-04-01T00:43:05.508" v="1455" actId="1035"/>
          <ac:cxnSpMkLst>
            <pc:docMk/>
            <pc:sldMk cId="772256198" sldId="272"/>
            <ac:cxnSpMk id="170" creationId="{EC7F053C-BF84-1B7E-E213-B13C34694E23}"/>
          </ac:cxnSpMkLst>
        </pc:cxnChg>
        <pc:cxnChg chg="add del mod">
          <ac:chgData name="Devkar, Vikas" userId="acbd15ec-55d1-4a76-83ac-3f1d82711ed5" providerId="ADAL" clId="{1D085DC7-27BE-49ED-AA59-AC68119ECF15}" dt="2024-04-01T00:43:05.508" v="1455" actId="1035"/>
          <ac:cxnSpMkLst>
            <pc:docMk/>
            <pc:sldMk cId="772256198" sldId="272"/>
            <ac:cxnSpMk id="171" creationId="{74ACEDB7-4EF7-0262-991D-D8546F363B90}"/>
          </ac:cxnSpMkLst>
        </pc:cxnChg>
        <pc:cxnChg chg="add del mod">
          <ac:chgData name="Devkar, Vikas" userId="acbd15ec-55d1-4a76-83ac-3f1d82711ed5" providerId="ADAL" clId="{1D085DC7-27BE-49ED-AA59-AC68119ECF15}" dt="2024-04-01T00:43:05.508" v="1455" actId="1035"/>
          <ac:cxnSpMkLst>
            <pc:docMk/>
            <pc:sldMk cId="772256198" sldId="272"/>
            <ac:cxnSpMk id="176" creationId="{E4431499-2DDB-786A-F271-05E6BFEADBA7}"/>
          </ac:cxnSpMkLst>
        </pc:cxnChg>
        <pc:cxnChg chg="add del mod">
          <ac:chgData name="Devkar, Vikas" userId="acbd15ec-55d1-4a76-83ac-3f1d82711ed5" providerId="ADAL" clId="{1D085DC7-27BE-49ED-AA59-AC68119ECF15}" dt="2024-04-01T00:43:05.508" v="1455" actId="1035"/>
          <ac:cxnSpMkLst>
            <pc:docMk/>
            <pc:sldMk cId="772256198" sldId="272"/>
            <ac:cxnSpMk id="177" creationId="{276DBD47-2625-A74A-D666-D00AC7BD40DE}"/>
          </ac:cxnSpMkLst>
        </pc:cxnChg>
        <pc:cxnChg chg="add del mod">
          <ac:chgData name="Devkar, Vikas" userId="acbd15ec-55d1-4a76-83ac-3f1d82711ed5" providerId="ADAL" clId="{1D085DC7-27BE-49ED-AA59-AC68119ECF15}" dt="2024-04-01T00:43:05.508" v="1455" actId="1035"/>
          <ac:cxnSpMkLst>
            <pc:docMk/>
            <pc:sldMk cId="772256198" sldId="272"/>
            <ac:cxnSpMk id="178" creationId="{AA5BA619-00EC-5A69-487B-3EAA442ACF22}"/>
          </ac:cxnSpMkLst>
        </pc:cxnChg>
      </pc:sldChg>
      <pc:sldChg chg="delSp modSp del mod">
        <pc:chgData name="Devkar, Vikas" userId="acbd15ec-55d1-4a76-83ac-3f1d82711ed5" providerId="ADAL" clId="{1D085DC7-27BE-49ED-AA59-AC68119ECF15}" dt="2024-04-01T00:45:21.261" v="1474" actId="47"/>
        <pc:sldMkLst>
          <pc:docMk/>
          <pc:sldMk cId="769830488" sldId="273"/>
        </pc:sldMkLst>
        <pc:spChg chg="del mod">
          <ac:chgData name="Devkar, Vikas" userId="acbd15ec-55d1-4a76-83ac-3f1d82711ed5" providerId="ADAL" clId="{1D085DC7-27BE-49ED-AA59-AC68119ECF15}" dt="2024-04-01T00:40:32.925" v="1398" actId="21"/>
          <ac:spMkLst>
            <pc:docMk/>
            <pc:sldMk cId="769830488" sldId="273"/>
            <ac:spMk id="57" creationId="{95DE3980-1221-E768-B463-21755D594504}"/>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texastechuniversity-my.sharepoint.com/personal/gunvant_patil_ttu_edu/Documents/TTU/2.%20Manuscripts/1.%20Draft/2.%20Si%20snRNAseq/4.%20Data/Si%20content%20by%20XRF%20in%20hydroponic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9130410605454"/>
          <c:y val="2.7824314513877256E-2"/>
          <c:w val="0.80281012278126251"/>
          <c:h val="0.87998587942464634"/>
        </c:manualLayout>
      </c:layout>
      <c:barChart>
        <c:barDir val="col"/>
        <c:grouping val="clustered"/>
        <c:varyColors val="0"/>
        <c:ser>
          <c:idx val="0"/>
          <c:order val="0"/>
          <c:spPr>
            <a:solidFill>
              <a:schemeClr val="tx1">
                <a:lumMod val="65000"/>
                <a:lumOff val="35000"/>
              </a:schemeClr>
            </a:solidFill>
            <a:ln>
              <a:solidFill>
                <a:schemeClr val="tx1"/>
              </a:solidFill>
            </a:ln>
            <a:effectLst/>
          </c:spPr>
          <c:invertIfNegative val="0"/>
          <c:dPt>
            <c:idx val="0"/>
            <c:invertIfNegative val="0"/>
            <c:bubble3D val="0"/>
            <c:spPr>
              <a:solidFill>
                <a:schemeClr val="bg1">
                  <a:lumMod val="65000"/>
                </a:schemeClr>
              </a:solidFill>
              <a:ln>
                <a:solidFill>
                  <a:schemeClr val="tx1"/>
                </a:solidFill>
              </a:ln>
              <a:effectLst/>
            </c:spPr>
            <c:extLst>
              <c:ext xmlns:c16="http://schemas.microsoft.com/office/drawing/2014/chart" uri="{C3380CC4-5D6E-409C-BE32-E72D297353CC}">
                <c16:uniqueId val="{00000001-6E5B-43BC-803B-EFFBCF42FC1D}"/>
              </c:ext>
            </c:extLst>
          </c:dPt>
          <c:errBars>
            <c:errBarType val="both"/>
            <c:errValType val="cust"/>
            <c:noEndCap val="0"/>
            <c:plus>
              <c:numRef>
                <c:f>Sheet1!$H$13:$H$14</c:f>
                <c:numCache>
                  <c:formatCode>General</c:formatCode>
                  <c:ptCount val="2"/>
                  <c:pt idx="0">
                    <c:v>1E-4</c:v>
                  </c:pt>
                  <c:pt idx="1">
                    <c:v>1436.7206757056144</c:v>
                  </c:pt>
                </c:numCache>
              </c:numRef>
            </c:plus>
            <c:minus>
              <c:numRef>
                <c:f>Sheet1!$H$13:$H$14</c:f>
                <c:numCache>
                  <c:formatCode>General</c:formatCode>
                  <c:ptCount val="2"/>
                  <c:pt idx="0">
                    <c:v>1E-4</c:v>
                  </c:pt>
                  <c:pt idx="1">
                    <c:v>1436.7206757056144</c:v>
                  </c:pt>
                </c:numCache>
              </c:numRef>
            </c:minus>
            <c:spPr>
              <a:noFill/>
              <a:ln w="9525" cap="flat" cmpd="sng" algn="ctr">
                <a:solidFill>
                  <a:schemeClr val="tx1"/>
                </a:solidFill>
                <a:round/>
              </a:ln>
              <a:effectLst/>
            </c:spPr>
          </c:errBars>
          <c:cat>
            <c:strRef>
              <c:f>Sheet1!$F$13:$F$14</c:f>
              <c:strCache>
                <c:ptCount val="2"/>
                <c:pt idx="0">
                  <c:v>Si-</c:v>
                </c:pt>
                <c:pt idx="1">
                  <c:v>Si+</c:v>
                </c:pt>
              </c:strCache>
            </c:strRef>
          </c:cat>
          <c:val>
            <c:numRef>
              <c:f>Sheet1!$G$13:$G$14</c:f>
              <c:numCache>
                <c:formatCode>General</c:formatCode>
                <c:ptCount val="2"/>
                <c:pt idx="0">
                  <c:v>0</c:v>
                </c:pt>
                <c:pt idx="1">
                  <c:v>5301.6</c:v>
                </c:pt>
              </c:numCache>
            </c:numRef>
          </c:val>
          <c:extLst>
            <c:ext xmlns:c16="http://schemas.microsoft.com/office/drawing/2014/chart" uri="{C3380CC4-5D6E-409C-BE32-E72D297353CC}">
              <c16:uniqueId val="{00000002-6E5B-43BC-803B-EFFBCF42FC1D}"/>
            </c:ext>
          </c:extLst>
        </c:ser>
        <c:dLbls>
          <c:showLegendKey val="0"/>
          <c:showVal val="0"/>
          <c:showCatName val="0"/>
          <c:showSerName val="0"/>
          <c:showPercent val="0"/>
          <c:showBubbleSize val="0"/>
        </c:dLbls>
        <c:gapWidth val="219"/>
        <c:overlap val="-27"/>
        <c:axId val="33228288"/>
        <c:axId val="33227808"/>
      </c:barChart>
      <c:catAx>
        <c:axId val="33228288"/>
        <c:scaling>
          <c:orientation val="minMax"/>
        </c:scaling>
        <c:delete val="0"/>
        <c:axPos val="b"/>
        <c:numFmt formatCode="General" sourceLinked="1"/>
        <c:majorTickMark val="out"/>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Helvetica" panose="020B0604020202020204" pitchFamily="34" charset="0"/>
                <a:ea typeface="+mn-ea"/>
                <a:cs typeface="Helvetica" panose="020B0604020202020204" pitchFamily="34" charset="0"/>
              </a:defRPr>
            </a:pPr>
            <a:endParaRPr lang="en-US"/>
          </a:p>
        </c:txPr>
        <c:crossAx val="33227808"/>
        <c:crosses val="autoZero"/>
        <c:auto val="1"/>
        <c:lblAlgn val="ctr"/>
        <c:lblOffset val="100"/>
        <c:noMultiLvlLbl val="0"/>
      </c:catAx>
      <c:valAx>
        <c:axId val="33227808"/>
        <c:scaling>
          <c:orientation val="minMax"/>
          <c:min val="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33228288"/>
        <c:crosses val="autoZero"/>
        <c:crossBetween val="between"/>
      </c:valAx>
      <c:spPr>
        <a:noFill/>
        <a:ln>
          <a:solidFill>
            <a:sysClr val="windowText" lastClr="000000"/>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A96E3999-7395-44F2-AC6F-0DEFB504A5B7}" type="datetimeFigureOut">
              <a:rPr lang="en-US" smtClean="0"/>
              <a:t>4/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39187689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96E3999-7395-44F2-AC6F-0DEFB504A5B7}" type="datetimeFigureOut">
              <a:rPr lang="en-US" smtClean="0"/>
              <a:t>4/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23581381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96E3999-7395-44F2-AC6F-0DEFB504A5B7}" type="datetimeFigureOut">
              <a:rPr lang="en-US" smtClean="0"/>
              <a:t>4/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30726082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96E3999-7395-44F2-AC6F-0DEFB504A5B7}" type="datetimeFigureOut">
              <a:rPr lang="en-US" smtClean="0"/>
              <a:t>4/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13287498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6E3999-7395-44F2-AC6F-0DEFB504A5B7}" type="datetimeFigureOut">
              <a:rPr lang="en-US" smtClean="0"/>
              <a:t>4/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29999418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96E3999-7395-44F2-AC6F-0DEFB504A5B7}" type="datetimeFigureOut">
              <a:rPr lang="en-US" smtClean="0"/>
              <a:t>4/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21365309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96E3999-7395-44F2-AC6F-0DEFB504A5B7}" type="datetimeFigureOut">
              <a:rPr lang="en-US" smtClean="0"/>
              <a:t>4/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19632441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96E3999-7395-44F2-AC6F-0DEFB504A5B7}" type="datetimeFigureOut">
              <a:rPr lang="en-US" smtClean="0"/>
              <a:t>4/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3539640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6E3999-7395-44F2-AC6F-0DEFB504A5B7}" type="datetimeFigureOut">
              <a:rPr lang="en-US" smtClean="0"/>
              <a:t>4/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23311322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6E3999-7395-44F2-AC6F-0DEFB504A5B7}" type="datetimeFigureOut">
              <a:rPr lang="en-US" smtClean="0"/>
              <a:t>4/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5140908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6E3999-7395-44F2-AC6F-0DEFB504A5B7}" type="datetimeFigureOut">
              <a:rPr lang="en-US" smtClean="0"/>
              <a:t>4/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3BEA9AE-2E58-42DC-B12E-C560DC58D4BF}" type="slidenum">
              <a:rPr lang="en-US" smtClean="0"/>
              <a:t>‹#›</a:t>
            </a:fld>
            <a:endParaRPr lang="en-US"/>
          </a:p>
        </p:txBody>
      </p:sp>
    </p:spTree>
    <p:extLst>
      <p:ext uri="{BB962C8B-B14F-4D97-AF65-F5344CB8AC3E}">
        <p14:creationId xmlns:p14="http://schemas.microsoft.com/office/powerpoint/2010/main" val="40542216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96E3999-7395-44F2-AC6F-0DEFB504A5B7}" type="datetimeFigureOut">
              <a:rPr lang="en-US" smtClean="0"/>
              <a:t>4/1/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3BEA9AE-2E58-42DC-B12E-C560DC58D4BF}" type="slidenum">
              <a:rPr lang="en-US" smtClean="0"/>
              <a:t>‹#›</a:t>
            </a:fld>
            <a:endParaRPr lang="en-US"/>
          </a:p>
        </p:txBody>
      </p:sp>
    </p:spTree>
    <p:extLst>
      <p:ext uri="{BB962C8B-B14F-4D97-AF65-F5344CB8AC3E}">
        <p14:creationId xmlns:p14="http://schemas.microsoft.com/office/powerpoint/2010/main" val="18059126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 Id="rId4" Type="http://schemas.openxmlformats.org/officeDocument/2006/relationships/image" Target="../media/image28.png"/></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10" Type="http://schemas.microsoft.com/office/2007/relationships/hdphoto" Target="../media/hdphoto1.wdp"/><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4" Type="http://schemas.openxmlformats.org/officeDocument/2006/relationships/image" Target="../media/image14.jpeg"/></Relationships>
</file>

<file path=ppt/slides/_rels/slide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 Id="rId4" Type="http://schemas.openxmlformats.org/officeDocument/2006/relationships/image" Target="../media/image20.png"/></Relationships>
</file>

<file path=ppt/slides/_rels/slide8.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 Id="rId5" Type="http://schemas.openxmlformats.org/officeDocument/2006/relationships/image" Target="../media/image25.png"/><Relationship Id="rId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Two containers with plants in them&#10;&#10;Description automatically generated">
            <a:extLst>
              <a:ext uri="{FF2B5EF4-FFF2-40B4-BE49-F238E27FC236}">
                <a16:creationId xmlns:a16="http://schemas.microsoft.com/office/drawing/2014/main" id="{8650781B-AC10-2E14-7193-96FAEFC0AEE0}"/>
              </a:ext>
            </a:extLst>
          </p:cNvPr>
          <p:cNvPicPr>
            <a:picLocks noChangeAspect="1"/>
          </p:cNvPicPr>
          <p:nvPr/>
        </p:nvPicPr>
        <p:blipFill rotWithShape="1">
          <a:blip r:embed="rId2"/>
          <a:srcRect l="3027" t="17432" r="3996" b="5885"/>
          <a:stretch/>
        </p:blipFill>
        <p:spPr>
          <a:xfrm>
            <a:off x="571702" y="826718"/>
            <a:ext cx="5771343" cy="3583967"/>
          </a:xfrm>
          <a:prstGeom prst="rect">
            <a:avLst/>
          </a:prstGeom>
        </p:spPr>
      </p:pic>
      <p:sp>
        <p:nvSpPr>
          <p:cNvPr id="5" name="TextBox 4">
            <a:extLst>
              <a:ext uri="{FF2B5EF4-FFF2-40B4-BE49-F238E27FC236}">
                <a16:creationId xmlns:a16="http://schemas.microsoft.com/office/drawing/2014/main" id="{267B5775-2EA1-057F-29AE-A0A20F28F365}"/>
              </a:ext>
            </a:extLst>
          </p:cNvPr>
          <p:cNvSpPr txBox="1"/>
          <p:nvPr/>
        </p:nvSpPr>
        <p:spPr>
          <a:xfrm>
            <a:off x="156761" y="314062"/>
            <a:ext cx="414941"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A</a:t>
            </a:r>
          </a:p>
        </p:txBody>
      </p:sp>
      <p:sp>
        <p:nvSpPr>
          <p:cNvPr id="6" name="TextBox 5">
            <a:extLst>
              <a:ext uri="{FF2B5EF4-FFF2-40B4-BE49-F238E27FC236}">
                <a16:creationId xmlns:a16="http://schemas.microsoft.com/office/drawing/2014/main" id="{25C1E047-61A8-283D-842B-8E4DB3196396}"/>
              </a:ext>
            </a:extLst>
          </p:cNvPr>
          <p:cNvSpPr txBox="1"/>
          <p:nvPr/>
        </p:nvSpPr>
        <p:spPr>
          <a:xfrm>
            <a:off x="159749" y="4646343"/>
            <a:ext cx="414941"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B</a:t>
            </a:r>
          </a:p>
        </p:txBody>
      </p:sp>
      <p:sp>
        <p:nvSpPr>
          <p:cNvPr id="7" name="TextBox 6">
            <a:extLst>
              <a:ext uri="{FF2B5EF4-FFF2-40B4-BE49-F238E27FC236}">
                <a16:creationId xmlns:a16="http://schemas.microsoft.com/office/drawing/2014/main" id="{A1F18A16-F4AD-BA15-75E0-DBBCAFFB2CCA}"/>
              </a:ext>
            </a:extLst>
          </p:cNvPr>
          <p:cNvSpPr txBox="1"/>
          <p:nvPr/>
        </p:nvSpPr>
        <p:spPr>
          <a:xfrm>
            <a:off x="156761" y="7972248"/>
            <a:ext cx="6400799" cy="922368"/>
          </a:xfrm>
          <a:prstGeom prst="rect">
            <a:avLst/>
          </a:prstGeom>
          <a:noFill/>
        </p:spPr>
        <p:txBody>
          <a:bodyPr wrap="square" rtlCol="0">
            <a:spAutoFit/>
          </a:bodyPr>
          <a:lstStyle/>
          <a:p>
            <a:r>
              <a:rPr lang="en-US" sz="1398" b="1">
                <a:latin typeface="Times New Roman" panose="02020603050405020304" pitchFamily="18" charset="0"/>
                <a:cs typeface="Times New Roman" panose="02020603050405020304" pitchFamily="18" charset="0"/>
              </a:rPr>
              <a:t>Supplementary figure S1. Silicon treatment to Soybean </a:t>
            </a:r>
            <a:r>
              <a:rPr lang="en-US" sz="1398" b="1" i="1">
                <a:latin typeface="Times New Roman" panose="02020603050405020304" pitchFamily="18" charset="0"/>
                <a:cs typeface="Times New Roman" panose="02020603050405020304" pitchFamily="18" charset="0"/>
              </a:rPr>
              <a:t>cv. </a:t>
            </a:r>
            <a:r>
              <a:rPr lang="en-US" sz="1398" b="1" i="1" err="1">
                <a:latin typeface="Times New Roman" panose="02020603050405020304" pitchFamily="18" charset="0"/>
                <a:cs typeface="Times New Roman" panose="02020603050405020304" pitchFamily="18" charset="0"/>
              </a:rPr>
              <a:t>Hikmok</a:t>
            </a:r>
            <a:r>
              <a:rPr lang="en-US" sz="1398" b="1" i="1">
                <a:latin typeface="Times New Roman" panose="02020603050405020304" pitchFamily="18" charset="0"/>
                <a:cs typeface="Times New Roman" panose="02020603050405020304" pitchFamily="18" charset="0"/>
              </a:rPr>
              <a:t> </a:t>
            </a:r>
            <a:r>
              <a:rPr lang="en-US" sz="1398" b="1">
                <a:latin typeface="Times New Roman" panose="02020603050405020304" pitchFamily="18" charset="0"/>
                <a:cs typeface="Times New Roman" panose="02020603050405020304" pitchFamily="18" charset="0"/>
              </a:rPr>
              <a:t>in hydroponic system. (</a:t>
            </a:r>
            <a:r>
              <a:rPr lang="en-US" sz="1200" b="1">
                <a:latin typeface="Times New Roman" panose="02020603050405020304" pitchFamily="18" charset="0"/>
                <a:cs typeface="Times New Roman" panose="02020603050405020304" pitchFamily="18" charset="0"/>
              </a:rPr>
              <a:t>A) </a:t>
            </a:r>
            <a:r>
              <a:rPr lang="en-US" sz="1200">
                <a:latin typeface="Times New Roman" panose="02020603050405020304" pitchFamily="18" charset="0"/>
                <a:cs typeface="Times New Roman" panose="02020603050405020304" pitchFamily="18" charset="0"/>
              </a:rPr>
              <a:t>Soybean plants were grown in aerated hydroponic system in half-strength </a:t>
            </a:r>
            <a:r>
              <a:rPr lang="en-US" sz="1200" err="1">
                <a:latin typeface="Times New Roman" panose="02020603050405020304" pitchFamily="18" charset="0"/>
                <a:cs typeface="Times New Roman" panose="02020603050405020304" pitchFamily="18" charset="0"/>
              </a:rPr>
              <a:t>hogland</a:t>
            </a:r>
            <a:r>
              <a:rPr lang="en-US" sz="1200">
                <a:latin typeface="Times New Roman" panose="02020603050405020304" pitchFamily="18" charset="0"/>
                <a:cs typeface="Times New Roman" panose="02020603050405020304" pitchFamily="18" charset="0"/>
              </a:rPr>
              <a:t> media, pH 5.7. </a:t>
            </a:r>
            <a:r>
              <a:rPr lang="en-US" sz="1200" b="1">
                <a:latin typeface="Times New Roman" panose="02020603050405020304" pitchFamily="18" charset="0"/>
                <a:cs typeface="Times New Roman" panose="02020603050405020304" pitchFamily="18" charset="0"/>
              </a:rPr>
              <a:t>(B) </a:t>
            </a:r>
            <a:r>
              <a:rPr lang="en-US" sz="1200">
                <a:latin typeface="Times New Roman" panose="02020603050405020304" pitchFamily="18" charset="0"/>
                <a:cs typeface="Times New Roman" panose="02020603050405020304" pitchFamily="18" charset="0"/>
              </a:rPr>
              <a:t>Si content detected by XRF in leaves of Si (-) and Si (+) treated soybean plants grown hydroponically</a:t>
            </a:r>
            <a:r>
              <a:rPr lang="en-US" sz="1398">
                <a:latin typeface="Times New Roman" panose="02020603050405020304" pitchFamily="18" charset="0"/>
                <a:cs typeface="Times New Roman" panose="02020603050405020304" pitchFamily="18" charset="0"/>
              </a:rPr>
              <a:t>. </a:t>
            </a:r>
          </a:p>
        </p:txBody>
      </p:sp>
      <p:grpSp>
        <p:nvGrpSpPr>
          <p:cNvPr id="9" name="Group 8">
            <a:extLst>
              <a:ext uri="{FF2B5EF4-FFF2-40B4-BE49-F238E27FC236}">
                <a16:creationId xmlns:a16="http://schemas.microsoft.com/office/drawing/2014/main" id="{D038214F-DF9B-FA33-99CE-D55383CF5013}"/>
              </a:ext>
            </a:extLst>
          </p:cNvPr>
          <p:cNvGrpSpPr/>
          <p:nvPr/>
        </p:nvGrpSpPr>
        <p:grpSpPr>
          <a:xfrm>
            <a:off x="1685189" y="4784842"/>
            <a:ext cx="3113709" cy="2753201"/>
            <a:chOff x="1394396" y="4641110"/>
            <a:chExt cx="3113709" cy="2753201"/>
          </a:xfrm>
        </p:grpSpPr>
        <p:sp>
          <p:nvSpPr>
            <p:cNvPr id="8" name="TextBox 7">
              <a:extLst>
                <a:ext uri="{FF2B5EF4-FFF2-40B4-BE49-F238E27FC236}">
                  <a16:creationId xmlns:a16="http://schemas.microsoft.com/office/drawing/2014/main" id="{D33B83D1-2A7F-FB0B-3DB9-81D3A13B291E}"/>
                </a:ext>
              </a:extLst>
            </p:cNvPr>
            <p:cNvSpPr txBox="1"/>
            <p:nvPr/>
          </p:nvSpPr>
          <p:spPr>
            <a:xfrm>
              <a:off x="2055786" y="7148090"/>
              <a:ext cx="2452319" cy="246221"/>
            </a:xfrm>
            <a:prstGeom prst="rect">
              <a:avLst/>
            </a:prstGeom>
            <a:noFill/>
          </p:spPr>
          <p:txBody>
            <a:bodyPr wrap="square" rtlCol="0">
              <a:spAutoFit/>
            </a:bodyPr>
            <a:lstStyle/>
            <a:p>
              <a:r>
                <a:rPr lang="en-US" sz="1000" b="1">
                  <a:latin typeface="Helvetica" panose="020B0604020202020204" pitchFamily="34" charset="0"/>
                  <a:cs typeface="Helvetica" panose="020B0604020202020204" pitchFamily="34" charset="0"/>
                </a:rPr>
                <a:t>Si content estimation by XRF</a:t>
              </a:r>
            </a:p>
          </p:txBody>
        </p:sp>
        <p:graphicFrame>
          <p:nvGraphicFramePr>
            <p:cNvPr id="2" name="Chart 1">
              <a:extLst>
                <a:ext uri="{FF2B5EF4-FFF2-40B4-BE49-F238E27FC236}">
                  <a16:creationId xmlns:a16="http://schemas.microsoft.com/office/drawing/2014/main" id="{779EADC1-3B5D-EFD1-F42B-A656E1ECCFE5}"/>
                </a:ext>
              </a:extLst>
            </p:cNvPr>
            <p:cNvGraphicFramePr>
              <a:graphicFrameLocks/>
            </p:cNvGraphicFramePr>
            <p:nvPr>
              <p:extLst>
                <p:ext uri="{D42A27DB-BD31-4B8C-83A1-F6EECF244321}">
                  <p14:modId xmlns:p14="http://schemas.microsoft.com/office/powerpoint/2010/main" val="284039794"/>
                </p:ext>
              </p:extLst>
            </p:nvPr>
          </p:nvGraphicFramePr>
          <p:xfrm>
            <a:off x="1656006" y="4641110"/>
            <a:ext cx="2852099" cy="2506980"/>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a:extLst>
                <a:ext uri="{FF2B5EF4-FFF2-40B4-BE49-F238E27FC236}">
                  <a16:creationId xmlns:a16="http://schemas.microsoft.com/office/drawing/2014/main" id="{2896C643-36B3-C720-1176-338AA62D6ED9}"/>
                </a:ext>
              </a:extLst>
            </p:cNvPr>
            <p:cNvSpPr txBox="1"/>
            <p:nvPr/>
          </p:nvSpPr>
          <p:spPr>
            <a:xfrm rot="16200000">
              <a:off x="844475" y="5771488"/>
              <a:ext cx="1346064" cy="246221"/>
            </a:xfrm>
            <a:prstGeom prst="rect">
              <a:avLst/>
            </a:prstGeom>
            <a:noFill/>
          </p:spPr>
          <p:txBody>
            <a:bodyPr wrap="square" rtlCol="0">
              <a:spAutoFit/>
            </a:bodyPr>
            <a:lstStyle/>
            <a:p>
              <a:r>
                <a:rPr lang="en-US" sz="1000">
                  <a:latin typeface="Helvetica" panose="020B0604020202020204" pitchFamily="34" charset="0"/>
                  <a:cs typeface="Helvetica" panose="020B0604020202020204" pitchFamily="34" charset="0"/>
                </a:rPr>
                <a:t>Si content (PPM)</a:t>
              </a:r>
            </a:p>
          </p:txBody>
        </p:sp>
      </p:grpSp>
    </p:spTree>
    <p:extLst>
      <p:ext uri="{BB962C8B-B14F-4D97-AF65-F5344CB8AC3E}">
        <p14:creationId xmlns:p14="http://schemas.microsoft.com/office/powerpoint/2010/main" val="16045004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57B8A66-9E60-47EC-F7ED-18211D405291}"/>
              </a:ext>
            </a:extLst>
          </p:cNvPr>
          <p:cNvSpPr txBox="1"/>
          <p:nvPr/>
        </p:nvSpPr>
        <p:spPr>
          <a:xfrm>
            <a:off x="129008" y="0"/>
            <a:ext cx="387096"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A</a:t>
            </a:r>
          </a:p>
        </p:txBody>
      </p:sp>
      <p:sp>
        <p:nvSpPr>
          <p:cNvPr id="48" name="Rectangle: Rounded Corners 47">
            <a:extLst>
              <a:ext uri="{FF2B5EF4-FFF2-40B4-BE49-F238E27FC236}">
                <a16:creationId xmlns:a16="http://schemas.microsoft.com/office/drawing/2014/main" id="{6C705168-5731-8AEB-4AC6-77330158F270}"/>
              </a:ext>
            </a:extLst>
          </p:cNvPr>
          <p:cNvSpPr/>
          <p:nvPr/>
        </p:nvSpPr>
        <p:spPr>
          <a:xfrm>
            <a:off x="1061425" y="3418121"/>
            <a:ext cx="4528765" cy="4197386"/>
          </a:xfrm>
          <a:prstGeom prst="roundRect">
            <a:avLst/>
          </a:prstGeom>
          <a:solidFill>
            <a:schemeClr val="bg1">
              <a:lumMod val="95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49" name="Oval 48">
            <a:extLst>
              <a:ext uri="{FF2B5EF4-FFF2-40B4-BE49-F238E27FC236}">
                <a16:creationId xmlns:a16="http://schemas.microsoft.com/office/drawing/2014/main" id="{A1FCD7E7-BC40-1E54-F0C7-70E5829602BA}"/>
              </a:ext>
            </a:extLst>
          </p:cNvPr>
          <p:cNvSpPr/>
          <p:nvPr/>
        </p:nvSpPr>
        <p:spPr>
          <a:xfrm>
            <a:off x="1510488" y="3508226"/>
            <a:ext cx="1413581" cy="1690502"/>
          </a:xfrm>
          <a:prstGeom prst="ellipse">
            <a:avLst/>
          </a:prstGeom>
          <a:solidFill>
            <a:schemeClr val="accent6">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50" name="Oval 49">
            <a:extLst>
              <a:ext uri="{FF2B5EF4-FFF2-40B4-BE49-F238E27FC236}">
                <a16:creationId xmlns:a16="http://schemas.microsoft.com/office/drawing/2014/main" id="{129F6921-1EAD-5244-837D-2D002E5558BD}"/>
              </a:ext>
            </a:extLst>
          </p:cNvPr>
          <p:cNvSpPr/>
          <p:nvPr/>
        </p:nvSpPr>
        <p:spPr>
          <a:xfrm>
            <a:off x="2501181" y="6438014"/>
            <a:ext cx="2373707" cy="1077118"/>
          </a:xfrm>
          <a:prstGeom prst="ellipse">
            <a:avLst/>
          </a:prstGeom>
          <a:gradFill flip="none" rotWithShape="1">
            <a:gsLst>
              <a:gs pos="0">
                <a:srgbClr val="F8766D">
                  <a:tint val="66000"/>
                  <a:satMod val="160000"/>
                </a:srgbClr>
              </a:gs>
              <a:gs pos="50000">
                <a:srgbClr val="F8766D">
                  <a:tint val="44500"/>
                  <a:satMod val="160000"/>
                </a:srgbClr>
              </a:gs>
              <a:gs pos="100000">
                <a:srgbClr val="F8766D">
                  <a:tint val="23500"/>
                  <a:satMod val="160000"/>
                </a:srgbClr>
              </a:gs>
            </a:gsLst>
            <a:lin ang="2700000" scaled="1"/>
            <a:tileRect/>
          </a:gra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cxnSp>
        <p:nvCxnSpPr>
          <p:cNvPr id="51" name="Straight Arrow Connector 50">
            <a:extLst>
              <a:ext uri="{FF2B5EF4-FFF2-40B4-BE49-F238E27FC236}">
                <a16:creationId xmlns:a16="http://schemas.microsoft.com/office/drawing/2014/main" id="{BF4BE863-88CE-4173-E7BD-D64210102CD5}"/>
              </a:ext>
            </a:extLst>
          </p:cNvPr>
          <p:cNvCxnSpPr>
            <a:cxnSpLocks/>
          </p:cNvCxnSpPr>
          <p:nvPr/>
        </p:nvCxnSpPr>
        <p:spPr>
          <a:xfrm>
            <a:off x="3846456" y="6829750"/>
            <a:ext cx="27139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31455D91-00D1-1705-1478-F7D0422AB9A8}"/>
              </a:ext>
            </a:extLst>
          </p:cNvPr>
          <p:cNvCxnSpPr>
            <a:cxnSpLocks/>
          </p:cNvCxnSpPr>
          <p:nvPr/>
        </p:nvCxnSpPr>
        <p:spPr>
          <a:xfrm flipV="1">
            <a:off x="1578488" y="5149260"/>
            <a:ext cx="368942" cy="1955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999F1144-E59F-769E-10F8-23609A2A18E4}"/>
              </a:ext>
            </a:extLst>
          </p:cNvPr>
          <p:cNvCxnSpPr>
            <a:cxnSpLocks/>
          </p:cNvCxnSpPr>
          <p:nvPr/>
        </p:nvCxnSpPr>
        <p:spPr>
          <a:xfrm>
            <a:off x="1653571" y="5609586"/>
            <a:ext cx="305322" cy="301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4" name="Rectangle 53">
            <a:extLst>
              <a:ext uri="{FF2B5EF4-FFF2-40B4-BE49-F238E27FC236}">
                <a16:creationId xmlns:a16="http://schemas.microsoft.com/office/drawing/2014/main" id="{41CECA81-658A-A7EA-75C9-35EDFD8540B1}"/>
              </a:ext>
            </a:extLst>
          </p:cNvPr>
          <p:cNvSpPr/>
          <p:nvPr/>
        </p:nvSpPr>
        <p:spPr>
          <a:xfrm rot="16200000">
            <a:off x="3271450" y="5239938"/>
            <a:ext cx="364491" cy="11301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55" name="Rectangle 54">
            <a:extLst>
              <a:ext uri="{FF2B5EF4-FFF2-40B4-BE49-F238E27FC236}">
                <a16:creationId xmlns:a16="http://schemas.microsoft.com/office/drawing/2014/main" id="{0B957C6F-396F-DD33-BE28-7EA9A96E35F5}"/>
              </a:ext>
            </a:extLst>
          </p:cNvPr>
          <p:cNvSpPr/>
          <p:nvPr/>
        </p:nvSpPr>
        <p:spPr>
          <a:xfrm>
            <a:off x="2732331" y="5751043"/>
            <a:ext cx="279253" cy="11301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56" name="Rectangle 55">
            <a:extLst>
              <a:ext uri="{FF2B5EF4-FFF2-40B4-BE49-F238E27FC236}">
                <a16:creationId xmlns:a16="http://schemas.microsoft.com/office/drawing/2014/main" id="{C68065D4-9E2C-56C4-BD4B-034A1F9DB1CC}"/>
              </a:ext>
            </a:extLst>
          </p:cNvPr>
          <p:cNvSpPr/>
          <p:nvPr/>
        </p:nvSpPr>
        <p:spPr>
          <a:xfrm>
            <a:off x="4507376" y="4718202"/>
            <a:ext cx="382753" cy="162043"/>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57" name="TextBox 56">
            <a:extLst>
              <a:ext uri="{FF2B5EF4-FFF2-40B4-BE49-F238E27FC236}">
                <a16:creationId xmlns:a16="http://schemas.microsoft.com/office/drawing/2014/main" id="{3188760C-32E0-6D76-348C-E271EEC907FE}"/>
              </a:ext>
            </a:extLst>
          </p:cNvPr>
          <p:cNvSpPr txBox="1"/>
          <p:nvPr/>
        </p:nvSpPr>
        <p:spPr>
          <a:xfrm>
            <a:off x="129008" y="3138110"/>
            <a:ext cx="387096"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B</a:t>
            </a:r>
          </a:p>
        </p:txBody>
      </p:sp>
      <p:sp>
        <p:nvSpPr>
          <p:cNvPr id="60" name="TextBox 59">
            <a:extLst>
              <a:ext uri="{FF2B5EF4-FFF2-40B4-BE49-F238E27FC236}">
                <a16:creationId xmlns:a16="http://schemas.microsoft.com/office/drawing/2014/main" id="{6F598399-95DC-0936-2E57-18C0A621E480}"/>
              </a:ext>
            </a:extLst>
          </p:cNvPr>
          <p:cNvSpPr txBox="1"/>
          <p:nvPr/>
        </p:nvSpPr>
        <p:spPr>
          <a:xfrm>
            <a:off x="1722248" y="3794419"/>
            <a:ext cx="1431874" cy="230832"/>
          </a:xfrm>
          <a:prstGeom prst="rect">
            <a:avLst/>
          </a:prstGeom>
          <a:noFill/>
        </p:spPr>
        <p:txBody>
          <a:bodyPr wrap="square">
            <a:spAutoFit/>
          </a:bodyPr>
          <a:lstStyle/>
          <a:p>
            <a:r>
              <a:rPr lang="en-US" sz="900">
                <a:latin typeface="Helvetica" panose="020B0604020202020204" pitchFamily="34" charset="0"/>
                <a:cs typeface="Helvetica" panose="020B0604020202020204" pitchFamily="34" charset="0"/>
              </a:rPr>
              <a:t>Shikimate pathway </a:t>
            </a:r>
          </a:p>
        </p:txBody>
      </p:sp>
      <p:sp>
        <p:nvSpPr>
          <p:cNvPr id="61" name="TextBox 60">
            <a:extLst>
              <a:ext uri="{FF2B5EF4-FFF2-40B4-BE49-F238E27FC236}">
                <a16:creationId xmlns:a16="http://schemas.microsoft.com/office/drawing/2014/main" id="{1FE920F1-C77F-BD93-9C4E-864C876D37EB}"/>
              </a:ext>
            </a:extLst>
          </p:cNvPr>
          <p:cNvSpPr txBox="1"/>
          <p:nvPr/>
        </p:nvSpPr>
        <p:spPr>
          <a:xfrm>
            <a:off x="1953741" y="4121604"/>
            <a:ext cx="874112" cy="230832"/>
          </a:xfrm>
          <a:prstGeom prst="rect">
            <a:avLst/>
          </a:prstGeom>
          <a:noFill/>
        </p:spPr>
        <p:txBody>
          <a:bodyPr wrap="square">
            <a:spAutoFit/>
          </a:bodyPr>
          <a:lstStyle/>
          <a:p>
            <a:r>
              <a:rPr lang="en-US" sz="900" err="1">
                <a:latin typeface="Helvetica" panose="020B0604020202020204" pitchFamily="34" charset="0"/>
                <a:cs typeface="Helvetica" panose="020B0604020202020204" pitchFamily="34" charset="0"/>
              </a:rPr>
              <a:t>Chorismate</a:t>
            </a:r>
            <a:r>
              <a:rPr lang="en-US" sz="900">
                <a:latin typeface="Helvetica" panose="020B0604020202020204" pitchFamily="34" charset="0"/>
                <a:cs typeface="Helvetica" panose="020B0604020202020204" pitchFamily="34" charset="0"/>
              </a:rPr>
              <a:t> </a:t>
            </a:r>
          </a:p>
        </p:txBody>
      </p:sp>
      <p:sp>
        <p:nvSpPr>
          <p:cNvPr id="63" name="TextBox 62">
            <a:extLst>
              <a:ext uri="{FF2B5EF4-FFF2-40B4-BE49-F238E27FC236}">
                <a16:creationId xmlns:a16="http://schemas.microsoft.com/office/drawing/2014/main" id="{31571886-81F7-758F-F983-BE0EB9B9BF1F}"/>
              </a:ext>
            </a:extLst>
          </p:cNvPr>
          <p:cNvSpPr txBox="1"/>
          <p:nvPr/>
        </p:nvSpPr>
        <p:spPr>
          <a:xfrm>
            <a:off x="1800952" y="5707840"/>
            <a:ext cx="1118965" cy="369332"/>
          </a:xfrm>
          <a:prstGeom prst="rect">
            <a:avLst/>
          </a:prstGeom>
          <a:noFill/>
        </p:spPr>
        <p:txBody>
          <a:bodyPr wrap="square">
            <a:spAutoFit/>
          </a:bodyPr>
          <a:lstStyle/>
          <a:p>
            <a:r>
              <a:rPr lang="en-US" sz="900" err="1">
                <a:latin typeface="Helvetica" panose="020B0604020202020204" pitchFamily="34" charset="0"/>
                <a:cs typeface="Helvetica" panose="020B0604020202020204" pitchFamily="34" charset="0"/>
              </a:rPr>
              <a:t>Isochorismoyl</a:t>
            </a:r>
            <a:r>
              <a:rPr lang="en-US" sz="900">
                <a:latin typeface="Helvetica" panose="020B0604020202020204" pitchFamily="34" charset="0"/>
                <a:cs typeface="Helvetica" panose="020B0604020202020204" pitchFamily="34" charset="0"/>
              </a:rPr>
              <a:t>-</a:t>
            </a:r>
          </a:p>
          <a:p>
            <a:r>
              <a:rPr lang="en-US" sz="900">
                <a:latin typeface="Helvetica" panose="020B0604020202020204" pitchFamily="34" charset="0"/>
                <a:cs typeface="Helvetica" panose="020B0604020202020204" pitchFamily="34" charset="0"/>
              </a:rPr>
              <a:t>glutamate A/B  </a:t>
            </a:r>
          </a:p>
        </p:txBody>
      </p:sp>
      <p:grpSp>
        <p:nvGrpSpPr>
          <p:cNvPr id="64" name="Group 63">
            <a:extLst>
              <a:ext uri="{FF2B5EF4-FFF2-40B4-BE49-F238E27FC236}">
                <a16:creationId xmlns:a16="http://schemas.microsoft.com/office/drawing/2014/main" id="{52D4E5FA-5738-69AD-F7EA-BFB3BA884351}"/>
              </a:ext>
            </a:extLst>
          </p:cNvPr>
          <p:cNvGrpSpPr/>
          <p:nvPr/>
        </p:nvGrpSpPr>
        <p:grpSpPr>
          <a:xfrm>
            <a:off x="1783654" y="4423935"/>
            <a:ext cx="452481" cy="215444"/>
            <a:chOff x="1947102" y="1519061"/>
            <a:chExt cx="452481" cy="215444"/>
          </a:xfrm>
        </p:grpSpPr>
        <p:sp>
          <p:nvSpPr>
            <p:cNvPr id="185" name="Rectangle 184">
              <a:extLst>
                <a:ext uri="{FF2B5EF4-FFF2-40B4-BE49-F238E27FC236}">
                  <a16:creationId xmlns:a16="http://schemas.microsoft.com/office/drawing/2014/main" id="{FFF373F9-B5DC-4CEB-C343-D9E681143E4A}"/>
                </a:ext>
              </a:extLst>
            </p:cNvPr>
            <p:cNvSpPr/>
            <p:nvPr/>
          </p:nvSpPr>
          <p:spPr>
            <a:xfrm>
              <a:off x="1947102" y="1523451"/>
              <a:ext cx="452481" cy="180238"/>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86" name="TextBox 185">
              <a:extLst>
                <a:ext uri="{FF2B5EF4-FFF2-40B4-BE49-F238E27FC236}">
                  <a16:creationId xmlns:a16="http://schemas.microsoft.com/office/drawing/2014/main" id="{B2472036-C663-5549-294D-8A8B62203808}"/>
                </a:ext>
              </a:extLst>
            </p:cNvPr>
            <p:cNvSpPr txBox="1"/>
            <p:nvPr/>
          </p:nvSpPr>
          <p:spPr>
            <a:xfrm>
              <a:off x="2003486" y="1519061"/>
              <a:ext cx="371807"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ICS</a:t>
              </a:r>
            </a:p>
          </p:txBody>
        </p:sp>
      </p:grpSp>
      <p:sp>
        <p:nvSpPr>
          <p:cNvPr id="65" name="Oval 64">
            <a:extLst>
              <a:ext uri="{FF2B5EF4-FFF2-40B4-BE49-F238E27FC236}">
                <a16:creationId xmlns:a16="http://schemas.microsoft.com/office/drawing/2014/main" id="{B6C5A99C-4691-EBD6-C877-A391DD8EC426}"/>
              </a:ext>
            </a:extLst>
          </p:cNvPr>
          <p:cNvSpPr/>
          <p:nvPr/>
        </p:nvSpPr>
        <p:spPr>
          <a:xfrm>
            <a:off x="1938220" y="4328296"/>
            <a:ext cx="73152" cy="73152"/>
          </a:xfrm>
          <a:prstGeom prst="ellipse">
            <a:avLst/>
          </a:prstGeom>
          <a:solidFill>
            <a:srgbClr val="C49A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cxnSp>
        <p:nvCxnSpPr>
          <p:cNvPr id="66" name="Straight Arrow Connector 65">
            <a:extLst>
              <a:ext uri="{FF2B5EF4-FFF2-40B4-BE49-F238E27FC236}">
                <a16:creationId xmlns:a16="http://schemas.microsoft.com/office/drawing/2014/main" id="{F3BA32AD-87F6-9D23-9EA6-98AEA0369B42}"/>
              </a:ext>
            </a:extLst>
          </p:cNvPr>
          <p:cNvCxnSpPr>
            <a:cxnSpLocks/>
          </p:cNvCxnSpPr>
          <p:nvPr/>
        </p:nvCxnSpPr>
        <p:spPr>
          <a:xfrm>
            <a:off x="2277259" y="3999894"/>
            <a:ext cx="0" cy="1828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a:extLst>
              <a:ext uri="{FF2B5EF4-FFF2-40B4-BE49-F238E27FC236}">
                <a16:creationId xmlns:a16="http://schemas.microsoft.com/office/drawing/2014/main" id="{7F2D5A69-5068-B3F7-AF48-94CF68B4CBEF}"/>
              </a:ext>
            </a:extLst>
          </p:cNvPr>
          <p:cNvCxnSpPr>
            <a:cxnSpLocks/>
          </p:cNvCxnSpPr>
          <p:nvPr/>
        </p:nvCxnSpPr>
        <p:spPr>
          <a:xfrm flipH="1">
            <a:off x="2268563" y="4335400"/>
            <a:ext cx="1430" cy="4134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9D6EA3D2-B023-7394-3585-A7C6C5EB647B}"/>
              </a:ext>
            </a:extLst>
          </p:cNvPr>
          <p:cNvCxnSpPr>
            <a:cxnSpLocks/>
          </p:cNvCxnSpPr>
          <p:nvPr/>
        </p:nvCxnSpPr>
        <p:spPr>
          <a:xfrm>
            <a:off x="2636319" y="5888478"/>
            <a:ext cx="64008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0" name="TextBox 69">
            <a:extLst>
              <a:ext uri="{FF2B5EF4-FFF2-40B4-BE49-F238E27FC236}">
                <a16:creationId xmlns:a16="http://schemas.microsoft.com/office/drawing/2014/main" id="{AA63526D-9F3A-46BD-E5DF-3738C1B49E7A}"/>
              </a:ext>
            </a:extLst>
          </p:cNvPr>
          <p:cNvSpPr txBox="1"/>
          <p:nvPr/>
        </p:nvSpPr>
        <p:spPr>
          <a:xfrm>
            <a:off x="4502694" y="4111963"/>
            <a:ext cx="1027502" cy="230832"/>
          </a:xfrm>
          <a:prstGeom prst="rect">
            <a:avLst/>
          </a:prstGeom>
          <a:noFill/>
        </p:spPr>
        <p:txBody>
          <a:bodyPr wrap="square">
            <a:spAutoFit/>
          </a:bodyPr>
          <a:lstStyle/>
          <a:p>
            <a:pPr algn="ctr"/>
            <a:r>
              <a:rPr lang="en-US" sz="900" err="1">
                <a:latin typeface="Helvetica" panose="020B0604020202020204" pitchFamily="34" charset="0"/>
                <a:cs typeface="Helvetica" panose="020B0604020202020204" pitchFamily="34" charset="0"/>
              </a:rPr>
              <a:t>Chorismate</a:t>
            </a:r>
            <a:r>
              <a:rPr lang="en-US" sz="900">
                <a:latin typeface="Helvetica" panose="020B0604020202020204" pitchFamily="34" charset="0"/>
                <a:cs typeface="Helvetica" panose="020B0604020202020204" pitchFamily="34" charset="0"/>
              </a:rPr>
              <a:t> </a:t>
            </a:r>
          </a:p>
        </p:txBody>
      </p:sp>
      <p:sp>
        <p:nvSpPr>
          <p:cNvPr id="71" name="TextBox 70">
            <a:extLst>
              <a:ext uri="{FF2B5EF4-FFF2-40B4-BE49-F238E27FC236}">
                <a16:creationId xmlns:a16="http://schemas.microsoft.com/office/drawing/2014/main" id="{B5DDA53F-E7D5-46BB-D0A9-2A771AE25E68}"/>
              </a:ext>
            </a:extLst>
          </p:cNvPr>
          <p:cNvSpPr txBox="1"/>
          <p:nvPr/>
        </p:nvSpPr>
        <p:spPr>
          <a:xfrm>
            <a:off x="4474349" y="4405880"/>
            <a:ext cx="1222296" cy="230832"/>
          </a:xfrm>
          <a:prstGeom prst="rect">
            <a:avLst/>
          </a:prstGeom>
          <a:noFill/>
        </p:spPr>
        <p:txBody>
          <a:bodyPr wrap="square">
            <a:spAutoFit/>
          </a:bodyPr>
          <a:lstStyle/>
          <a:p>
            <a:pPr algn="ctr"/>
            <a:r>
              <a:rPr lang="en-US" sz="900">
                <a:latin typeface="Helvetica" panose="020B0604020202020204" pitchFamily="34" charset="0"/>
                <a:cs typeface="Helvetica" panose="020B0604020202020204" pitchFamily="34" charset="0"/>
              </a:rPr>
              <a:t>Phenylalanine</a:t>
            </a:r>
          </a:p>
        </p:txBody>
      </p:sp>
      <p:sp>
        <p:nvSpPr>
          <p:cNvPr id="75" name="TextBox 74">
            <a:extLst>
              <a:ext uri="{FF2B5EF4-FFF2-40B4-BE49-F238E27FC236}">
                <a16:creationId xmlns:a16="http://schemas.microsoft.com/office/drawing/2014/main" id="{5149E9FB-09E2-48D3-A5A6-1B405B760B96}"/>
              </a:ext>
            </a:extLst>
          </p:cNvPr>
          <p:cNvSpPr txBox="1"/>
          <p:nvPr/>
        </p:nvSpPr>
        <p:spPr>
          <a:xfrm>
            <a:off x="4565819" y="5748640"/>
            <a:ext cx="980780" cy="230832"/>
          </a:xfrm>
          <a:prstGeom prst="rect">
            <a:avLst/>
          </a:prstGeom>
          <a:noFill/>
        </p:spPr>
        <p:txBody>
          <a:bodyPr wrap="square">
            <a:spAutoFit/>
          </a:bodyPr>
          <a:lstStyle/>
          <a:p>
            <a:pPr algn="ctr"/>
            <a:r>
              <a:rPr lang="en-US" sz="900">
                <a:latin typeface="Helvetica" panose="020B0604020202020204" pitchFamily="34" charset="0"/>
                <a:cs typeface="Helvetica" panose="020B0604020202020204" pitchFamily="34" charset="0"/>
              </a:rPr>
              <a:t>Benzoic acid</a:t>
            </a:r>
          </a:p>
        </p:txBody>
      </p:sp>
      <p:sp>
        <p:nvSpPr>
          <p:cNvPr id="76" name="TextBox 75">
            <a:extLst>
              <a:ext uri="{FF2B5EF4-FFF2-40B4-BE49-F238E27FC236}">
                <a16:creationId xmlns:a16="http://schemas.microsoft.com/office/drawing/2014/main" id="{E49FC55B-A918-61CC-D2EC-DBEB794AD0EA}"/>
              </a:ext>
            </a:extLst>
          </p:cNvPr>
          <p:cNvSpPr txBox="1"/>
          <p:nvPr/>
        </p:nvSpPr>
        <p:spPr>
          <a:xfrm>
            <a:off x="1859585" y="3620732"/>
            <a:ext cx="800792" cy="215444"/>
          </a:xfrm>
          <a:prstGeom prst="rect">
            <a:avLst/>
          </a:prstGeom>
          <a:noFill/>
        </p:spPr>
        <p:txBody>
          <a:bodyPr wrap="square">
            <a:spAutoFit/>
          </a:bodyPr>
          <a:lstStyle/>
          <a:p>
            <a:r>
              <a:rPr lang="en-US" sz="800" b="1">
                <a:latin typeface="Helvetica" panose="020B0604020202020204" pitchFamily="34" charset="0"/>
                <a:cs typeface="Helvetica" panose="020B0604020202020204" pitchFamily="34" charset="0"/>
              </a:rPr>
              <a:t>Chloroplast</a:t>
            </a:r>
          </a:p>
        </p:txBody>
      </p:sp>
      <p:sp>
        <p:nvSpPr>
          <p:cNvPr id="77" name="TextBox 76">
            <a:extLst>
              <a:ext uri="{FF2B5EF4-FFF2-40B4-BE49-F238E27FC236}">
                <a16:creationId xmlns:a16="http://schemas.microsoft.com/office/drawing/2014/main" id="{441EA215-E82E-4EC9-22D2-41ACBB2DD205}"/>
              </a:ext>
            </a:extLst>
          </p:cNvPr>
          <p:cNvSpPr txBox="1"/>
          <p:nvPr/>
        </p:nvSpPr>
        <p:spPr>
          <a:xfrm>
            <a:off x="3373852" y="3666350"/>
            <a:ext cx="869850" cy="230832"/>
          </a:xfrm>
          <a:prstGeom prst="rect">
            <a:avLst/>
          </a:prstGeom>
          <a:noFill/>
        </p:spPr>
        <p:txBody>
          <a:bodyPr wrap="square">
            <a:spAutoFit/>
          </a:bodyPr>
          <a:lstStyle/>
          <a:p>
            <a:r>
              <a:rPr lang="en-US" sz="900" b="1">
                <a:latin typeface="Helvetica" panose="020B0604020202020204" pitchFamily="34" charset="0"/>
                <a:cs typeface="Helvetica" panose="020B0604020202020204" pitchFamily="34" charset="0"/>
              </a:rPr>
              <a:t>Cytoplasm</a:t>
            </a:r>
          </a:p>
        </p:txBody>
      </p:sp>
      <p:sp>
        <p:nvSpPr>
          <p:cNvPr id="78" name="TextBox 77">
            <a:extLst>
              <a:ext uri="{FF2B5EF4-FFF2-40B4-BE49-F238E27FC236}">
                <a16:creationId xmlns:a16="http://schemas.microsoft.com/office/drawing/2014/main" id="{8142A9B5-030B-1CBA-801E-AEC7603D5155}"/>
              </a:ext>
            </a:extLst>
          </p:cNvPr>
          <p:cNvSpPr txBox="1"/>
          <p:nvPr/>
        </p:nvSpPr>
        <p:spPr>
          <a:xfrm>
            <a:off x="3463234" y="7286541"/>
            <a:ext cx="733005" cy="230832"/>
          </a:xfrm>
          <a:prstGeom prst="rect">
            <a:avLst/>
          </a:prstGeom>
          <a:noFill/>
        </p:spPr>
        <p:txBody>
          <a:bodyPr wrap="square">
            <a:spAutoFit/>
          </a:bodyPr>
          <a:lstStyle/>
          <a:p>
            <a:r>
              <a:rPr lang="en-US" sz="900" b="1">
                <a:latin typeface="Helvetica" panose="020B0604020202020204" pitchFamily="34" charset="0"/>
                <a:cs typeface="Helvetica" panose="020B0604020202020204" pitchFamily="34" charset="0"/>
              </a:rPr>
              <a:t>Nucleus</a:t>
            </a:r>
          </a:p>
        </p:txBody>
      </p:sp>
      <p:sp>
        <p:nvSpPr>
          <p:cNvPr id="79" name="TextBox 78">
            <a:extLst>
              <a:ext uri="{FF2B5EF4-FFF2-40B4-BE49-F238E27FC236}">
                <a16:creationId xmlns:a16="http://schemas.microsoft.com/office/drawing/2014/main" id="{84BE4B48-9BCB-3CE3-5107-F750B521BC2D}"/>
              </a:ext>
            </a:extLst>
          </p:cNvPr>
          <p:cNvSpPr txBox="1"/>
          <p:nvPr/>
        </p:nvSpPr>
        <p:spPr>
          <a:xfrm>
            <a:off x="3197449" y="5750273"/>
            <a:ext cx="893222" cy="400110"/>
          </a:xfrm>
          <a:prstGeom prst="rect">
            <a:avLst/>
          </a:prstGeom>
          <a:noFill/>
        </p:spPr>
        <p:txBody>
          <a:bodyPr wrap="square">
            <a:spAutoFit/>
          </a:bodyPr>
          <a:lstStyle/>
          <a:p>
            <a:pPr algn="ctr"/>
            <a:r>
              <a:rPr lang="en-US" sz="1000" b="1">
                <a:latin typeface="Helvetica" panose="020B0604020202020204" pitchFamily="34" charset="0"/>
                <a:cs typeface="Helvetica" panose="020B0604020202020204" pitchFamily="34" charset="0"/>
              </a:rPr>
              <a:t>Salicylic acid</a:t>
            </a:r>
          </a:p>
        </p:txBody>
      </p:sp>
      <p:cxnSp>
        <p:nvCxnSpPr>
          <p:cNvPr id="80" name="Straight Arrow Connector 79">
            <a:extLst>
              <a:ext uri="{FF2B5EF4-FFF2-40B4-BE49-F238E27FC236}">
                <a16:creationId xmlns:a16="http://schemas.microsoft.com/office/drawing/2014/main" id="{5C455BD6-B96D-730D-43B2-1F3FF384F6D3}"/>
              </a:ext>
            </a:extLst>
          </p:cNvPr>
          <p:cNvCxnSpPr>
            <a:cxnSpLocks/>
          </p:cNvCxnSpPr>
          <p:nvPr/>
        </p:nvCxnSpPr>
        <p:spPr>
          <a:xfrm>
            <a:off x="4964258" y="4305043"/>
            <a:ext cx="0" cy="16459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1" name="Straight Arrow Connector 80">
            <a:extLst>
              <a:ext uri="{FF2B5EF4-FFF2-40B4-BE49-F238E27FC236}">
                <a16:creationId xmlns:a16="http://schemas.microsoft.com/office/drawing/2014/main" id="{C8E24B77-3AAB-2F50-EF3D-EEBC9DC0E6D1}"/>
              </a:ext>
            </a:extLst>
          </p:cNvPr>
          <p:cNvCxnSpPr>
            <a:cxnSpLocks/>
          </p:cNvCxnSpPr>
          <p:nvPr/>
        </p:nvCxnSpPr>
        <p:spPr>
          <a:xfrm>
            <a:off x="4955623" y="5026479"/>
            <a:ext cx="8635" cy="50031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A75D8204-4317-3B97-9FCB-6B82121E8C23}"/>
              </a:ext>
            </a:extLst>
          </p:cNvPr>
          <p:cNvCxnSpPr>
            <a:cxnSpLocks/>
          </p:cNvCxnSpPr>
          <p:nvPr/>
        </p:nvCxnSpPr>
        <p:spPr>
          <a:xfrm>
            <a:off x="4955040" y="5631429"/>
            <a:ext cx="0" cy="1828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9664F058-FFB3-0CEB-B5CB-8CBC81D52FDF}"/>
              </a:ext>
            </a:extLst>
          </p:cNvPr>
          <p:cNvCxnSpPr>
            <a:cxnSpLocks/>
          </p:cNvCxnSpPr>
          <p:nvPr/>
        </p:nvCxnSpPr>
        <p:spPr>
          <a:xfrm>
            <a:off x="4964258" y="4620827"/>
            <a:ext cx="0" cy="31971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0DB4A719-1C1D-8948-5E35-0E4492317C49}"/>
              </a:ext>
            </a:extLst>
          </p:cNvPr>
          <p:cNvCxnSpPr>
            <a:cxnSpLocks/>
          </p:cNvCxnSpPr>
          <p:nvPr/>
        </p:nvCxnSpPr>
        <p:spPr>
          <a:xfrm flipH="1" flipV="1">
            <a:off x="4117849" y="5885168"/>
            <a:ext cx="54864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99178861-325D-989C-506D-0C9F030C6FA1}"/>
              </a:ext>
            </a:extLst>
          </p:cNvPr>
          <p:cNvSpPr txBox="1"/>
          <p:nvPr/>
        </p:nvSpPr>
        <p:spPr>
          <a:xfrm>
            <a:off x="2948930" y="4655344"/>
            <a:ext cx="1343792" cy="230832"/>
          </a:xfrm>
          <a:prstGeom prst="rect">
            <a:avLst/>
          </a:prstGeom>
          <a:noFill/>
        </p:spPr>
        <p:txBody>
          <a:bodyPr wrap="square">
            <a:spAutoFit/>
          </a:bodyPr>
          <a:lstStyle/>
          <a:p>
            <a:pPr algn="ctr"/>
            <a:r>
              <a:rPr lang="en-US" sz="900">
                <a:latin typeface="Helvetica" panose="020B0604020202020204" pitchFamily="34" charset="0"/>
                <a:cs typeface="Helvetica" panose="020B0604020202020204" pitchFamily="34" charset="0"/>
              </a:rPr>
              <a:t>Methyl salicylate</a:t>
            </a:r>
          </a:p>
        </p:txBody>
      </p:sp>
      <p:cxnSp>
        <p:nvCxnSpPr>
          <p:cNvPr id="87" name="Straight Arrow Connector 86">
            <a:extLst>
              <a:ext uri="{FF2B5EF4-FFF2-40B4-BE49-F238E27FC236}">
                <a16:creationId xmlns:a16="http://schemas.microsoft.com/office/drawing/2014/main" id="{05247A6D-6C3C-A7D4-3BDB-C74792D95479}"/>
              </a:ext>
            </a:extLst>
          </p:cNvPr>
          <p:cNvCxnSpPr>
            <a:cxnSpLocks/>
          </p:cNvCxnSpPr>
          <p:nvPr/>
        </p:nvCxnSpPr>
        <p:spPr>
          <a:xfrm flipV="1">
            <a:off x="3550001" y="4876790"/>
            <a:ext cx="0" cy="9181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832C4FC8-5BA0-ECA8-C93B-CC02FE31BE46}"/>
              </a:ext>
            </a:extLst>
          </p:cNvPr>
          <p:cNvCxnSpPr>
            <a:cxnSpLocks/>
          </p:cNvCxnSpPr>
          <p:nvPr/>
        </p:nvCxnSpPr>
        <p:spPr>
          <a:xfrm>
            <a:off x="3714829" y="4887419"/>
            <a:ext cx="0" cy="9144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9" name="Rectangle 88">
            <a:extLst>
              <a:ext uri="{FF2B5EF4-FFF2-40B4-BE49-F238E27FC236}">
                <a16:creationId xmlns:a16="http://schemas.microsoft.com/office/drawing/2014/main" id="{B291ED54-A00D-32C9-68D4-BF49BD36CB03}"/>
              </a:ext>
            </a:extLst>
          </p:cNvPr>
          <p:cNvSpPr/>
          <p:nvPr/>
        </p:nvSpPr>
        <p:spPr>
          <a:xfrm>
            <a:off x="3746369" y="5207777"/>
            <a:ext cx="392608" cy="188406"/>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90" name="TextBox 89">
            <a:extLst>
              <a:ext uri="{FF2B5EF4-FFF2-40B4-BE49-F238E27FC236}">
                <a16:creationId xmlns:a16="http://schemas.microsoft.com/office/drawing/2014/main" id="{6B73E9B3-C328-D917-F5C2-F221BA7EF2BC}"/>
              </a:ext>
            </a:extLst>
          </p:cNvPr>
          <p:cNvSpPr txBox="1"/>
          <p:nvPr/>
        </p:nvSpPr>
        <p:spPr>
          <a:xfrm>
            <a:off x="3738141" y="5201556"/>
            <a:ext cx="492552"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MES</a:t>
            </a:r>
          </a:p>
        </p:txBody>
      </p:sp>
      <p:sp>
        <p:nvSpPr>
          <p:cNvPr id="91" name="TextBox 90">
            <a:extLst>
              <a:ext uri="{FF2B5EF4-FFF2-40B4-BE49-F238E27FC236}">
                <a16:creationId xmlns:a16="http://schemas.microsoft.com/office/drawing/2014/main" id="{FA9566FD-8567-9182-DF9B-D9508D30CBA5}"/>
              </a:ext>
            </a:extLst>
          </p:cNvPr>
          <p:cNvSpPr txBox="1"/>
          <p:nvPr/>
        </p:nvSpPr>
        <p:spPr>
          <a:xfrm>
            <a:off x="4519283" y="4703188"/>
            <a:ext cx="389817"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PAL</a:t>
            </a:r>
          </a:p>
        </p:txBody>
      </p:sp>
      <p:sp>
        <p:nvSpPr>
          <p:cNvPr id="92" name="Oval 91">
            <a:extLst>
              <a:ext uri="{FF2B5EF4-FFF2-40B4-BE49-F238E27FC236}">
                <a16:creationId xmlns:a16="http://schemas.microsoft.com/office/drawing/2014/main" id="{BBEE995D-067D-D71F-A72C-8B091B60506D}"/>
              </a:ext>
            </a:extLst>
          </p:cNvPr>
          <p:cNvSpPr/>
          <p:nvPr/>
        </p:nvSpPr>
        <p:spPr>
          <a:xfrm>
            <a:off x="3897732" y="5106074"/>
            <a:ext cx="73152" cy="73152"/>
          </a:xfrm>
          <a:prstGeom prst="ellipse">
            <a:avLst/>
          </a:prstGeom>
          <a:solidFill>
            <a:srgbClr val="C49A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93" name="Oval 92">
            <a:extLst>
              <a:ext uri="{FF2B5EF4-FFF2-40B4-BE49-F238E27FC236}">
                <a16:creationId xmlns:a16="http://schemas.microsoft.com/office/drawing/2014/main" id="{632098EA-09A0-B2AB-7F64-70BAC02832E0}"/>
              </a:ext>
            </a:extLst>
          </p:cNvPr>
          <p:cNvSpPr/>
          <p:nvPr/>
        </p:nvSpPr>
        <p:spPr>
          <a:xfrm>
            <a:off x="4570591" y="4623945"/>
            <a:ext cx="73152" cy="73152"/>
          </a:xfrm>
          <a:prstGeom prst="ellipse">
            <a:avLst/>
          </a:prstGeom>
          <a:solidFill>
            <a:srgbClr val="C49A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94" name="TextBox 93">
            <a:extLst>
              <a:ext uri="{FF2B5EF4-FFF2-40B4-BE49-F238E27FC236}">
                <a16:creationId xmlns:a16="http://schemas.microsoft.com/office/drawing/2014/main" id="{B74091A6-AA5D-FB10-7415-3A020024F892}"/>
              </a:ext>
            </a:extLst>
          </p:cNvPr>
          <p:cNvSpPr txBox="1"/>
          <p:nvPr/>
        </p:nvSpPr>
        <p:spPr>
          <a:xfrm rot="16200000">
            <a:off x="3207588" y="5183057"/>
            <a:ext cx="487426" cy="200055"/>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BSMT1</a:t>
            </a:r>
          </a:p>
        </p:txBody>
      </p:sp>
      <p:sp>
        <p:nvSpPr>
          <p:cNvPr id="95" name="TextBox 94">
            <a:extLst>
              <a:ext uri="{FF2B5EF4-FFF2-40B4-BE49-F238E27FC236}">
                <a16:creationId xmlns:a16="http://schemas.microsoft.com/office/drawing/2014/main" id="{C382B18E-4434-FA74-7392-AC067C0B0156}"/>
              </a:ext>
            </a:extLst>
          </p:cNvPr>
          <p:cNvSpPr txBox="1"/>
          <p:nvPr/>
        </p:nvSpPr>
        <p:spPr>
          <a:xfrm>
            <a:off x="2687366" y="5713779"/>
            <a:ext cx="498379" cy="200055"/>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EPS1</a:t>
            </a:r>
          </a:p>
        </p:txBody>
      </p:sp>
      <p:sp>
        <p:nvSpPr>
          <p:cNvPr id="96" name="Rectangle 95">
            <a:extLst>
              <a:ext uri="{FF2B5EF4-FFF2-40B4-BE49-F238E27FC236}">
                <a16:creationId xmlns:a16="http://schemas.microsoft.com/office/drawing/2014/main" id="{146623D3-BDD6-4765-2BAE-0F74C2FC3EF3}"/>
              </a:ext>
            </a:extLst>
          </p:cNvPr>
          <p:cNvSpPr/>
          <p:nvPr/>
        </p:nvSpPr>
        <p:spPr>
          <a:xfrm>
            <a:off x="1947636" y="5092385"/>
            <a:ext cx="279253" cy="114828"/>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97" name="TextBox 96">
            <a:extLst>
              <a:ext uri="{FF2B5EF4-FFF2-40B4-BE49-F238E27FC236}">
                <a16:creationId xmlns:a16="http://schemas.microsoft.com/office/drawing/2014/main" id="{F9CCDF51-EB4D-0C84-6D81-AA97F499319F}"/>
              </a:ext>
            </a:extLst>
          </p:cNvPr>
          <p:cNvSpPr txBox="1"/>
          <p:nvPr/>
        </p:nvSpPr>
        <p:spPr>
          <a:xfrm>
            <a:off x="1902597" y="4699061"/>
            <a:ext cx="1002691" cy="230832"/>
          </a:xfrm>
          <a:prstGeom prst="rect">
            <a:avLst/>
          </a:prstGeom>
          <a:noFill/>
        </p:spPr>
        <p:txBody>
          <a:bodyPr wrap="square">
            <a:spAutoFit/>
          </a:bodyPr>
          <a:lstStyle/>
          <a:p>
            <a:r>
              <a:rPr lang="en-US" sz="900" err="1">
                <a:latin typeface="Helvetica" panose="020B0604020202020204" pitchFamily="34" charset="0"/>
                <a:cs typeface="Helvetica" panose="020B0604020202020204" pitchFamily="34" charset="0"/>
              </a:rPr>
              <a:t>Isochorismate</a:t>
            </a:r>
            <a:r>
              <a:rPr lang="en-US" sz="900">
                <a:latin typeface="Helvetica" panose="020B0604020202020204" pitchFamily="34" charset="0"/>
                <a:cs typeface="Helvetica" panose="020B0604020202020204" pitchFamily="34" charset="0"/>
              </a:rPr>
              <a:t> </a:t>
            </a:r>
          </a:p>
        </p:txBody>
      </p:sp>
      <p:cxnSp>
        <p:nvCxnSpPr>
          <p:cNvPr id="98" name="Straight Arrow Connector 97">
            <a:extLst>
              <a:ext uri="{FF2B5EF4-FFF2-40B4-BE49-F238E27FC236}">
                <a16:creationId xmlns:a16="http://schemas.microsoft.com/office/drawing/2014/main" id="{9B69124D-11E4-E076-6F65-2DC9EEEEE173}"/>
              </a:ext>
            </a:extLst>
          </p:cNvPr>
          <p:cNvCxnSpPr>
            <a:cxnSpLocks/>
          </p:cNvCxnSpPr>
          <p:nvPr/>
        </p:nvCxnSpPr>
        <p:spPr>
          <a:xfrm>
            <a:off x="2592331" y="4251538"/>
            <a:ext cx="2011680" cy="0"/>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37570CE8-861C-77B8-3D81-0C941DE57B50}"/>
              </a:ext>
            </a:extLst>
          </p:cNvPr>
          <p:cNvCxnSpPr>
            <a:cxnSpLocks/>
          </p:cNvCxnSpPr>
          <p:nvPr/>
        </p:nvCxnSpPr>
        <p:spPr>
          <a:xfrm>
            <a:off x="2270937" y="4887204"/>
            <a:ext cx="0" cy="88493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a16="http://schemas.microsoft.com/office/drawing/2014/main" id="{C214761B-99A9-AAF7-5753-65CE7A011559}"/>
              </a:ext>
            </a:extLst>
          </p:cNvPr>
          <p:cNvSpPr txBox="1"/>
          <p:nvPr/>
        </p:nvSpPr>
        <p:spPr>
          <a:xfrm>
            <a:off x="1892400" y="5057314"/>
            <a:ext cx="399802" cy="307777"/>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EDS5</a:t>
            </a:r>
          </a:p>
        </p:txBody>
      </p:sp>
      <p:sp>
        <p:nvSpPr>
          <p:cNvPr id="101" name="Rectangle 100">
            <a:extLst>
              <a:ext uri="{FF2B5EF4-FFF2-40B4-BE49-F238E27FC236}">
                <a16:creationId xmlns:a16="http://schemas.microsoft.com/office/drawing/2014/main" id="{191B14BA-69DF-C37C-381D-00F4AF8F6A74}"/>
              </a:ext>
            </a:extLst>
          </p:cNvPr>
          <p:cNvSpPr/>
          <p:nvPr/>
        </p:nvSpPr>
        <p:spPr>
          <a:xfrm>
            <a:off x="1956882" y="5553080"/>
            <a:ext cx="279253" cy="11301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02" name="TextBox 101">
            <a:extLst>
              <a:ext uri="{FF2B5EF4-FFF2-40B4-BE49-F238E27FC236}">
                <a16:creationId xmlns:a16="http://schemas.microsoft.com/office/drawing/2014/main" id="{EEBC657D-F3F7-DE2B-6113-928A0C21E034}"/>
              </a:ext>
            </a:extLst>
          </p:cNvPr>
          <p:cNvSpPr txBox="1"/>
          <p:nvPr/>
        </p:nvSpPr>
        <p:spPr>
          <a:xfrm>
            <a:off x="1912147" y="5509560"/>
            <a:ext cx="456118" cy="200055"/>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PBS3</a:t>
            </a:r>
          </a:p>
        </p:txBody>
      </p:sp>
      <p:sp>
        <p:nvSpPr>
          <p:cNvPr id="103" name="Rectangle 102">
            <a:extLst>
              <a:ext uri="{FF2B5EF4-FFF2-40B4-BE49-F238E27FC236}">
                <a16:creationId xmlns:a16="http://schemas.microsoft.com/office/drawing/2014/main" id="{0C977113-DC69-1B73-9F4D-7BEEEB556F86}"/>
              </a:ext>
            </a:extLst>
          </p:cNvPr>
          <p:cNvSpPr/>
          <p:nvPr/>
        </p:nvSpPr>
        <p:spPr>
          <a:xfrm>
            <a:off x="2795341" y="6638392"/>
            <a:ext cx="401267" cy="18545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05" name="Oval 104">
            <a:extLst>
              <a:ext uri="{FF2B5EF4-FFF2-40B4-BE49-F238E27FC236}">
                <a16:creationId xmlns:a16="http://schemas.microsoft.com/office/drawing/2014/main" id="{1D4DD1F4-07D5-84CA-6FF1-024A25EE7869}"/>
              </a:ext>
            </a:extLst>
          </p:cNvPr>
          <p:cNvSpPr/>
          <p:nvPr/>
        </p:nvSpPr>
        <p:spPr>
          <a:xfrm>
            <a:off x="1316747" y="5155754"/>
            <a:ext cx="73152" cy="73152"/>
          </a:xfrm>
          <a:prstGeom prst="ellipse">
            <a:avLst/>
          </a:prstGeom>
          <a:solidFill>
            <a:srgbClr val="53B4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06" name="Oval 105">
            <a:extLst>
              <a:ext uri="{FF2B5EF4-FFF2-40B4-BE49-F238E27FC236}">
                <a16:creationId xmlns:a16="http://schemas.microsoft.com/office/drawing/2014/main" id="{FCDD1C8B-C4BC-E457-78E5-157D93C57B4E}"/>
              </a:ext>
            </a:extLst>
          </p:cNvPr>
          <p:cNvSpPr/>
          <p:nvPr/>
        </p:nvSpPr>
        <p:spPr>
          <a:xfrm>
            <a:off x="1414025" y="5155177"/>
            <a:ext cx="73152" cy="73152"/>
          </a:xfrm>
          <a:prstGeom prst="ellipse">
            <a:avLst/>
          </a:prstGeom>
          <a:solidFill>
            <a:srgbClr val="FB61D7"/>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07" name="Oval 106">
            <a:extLst>
              <a:ext uri="{FF2B5EF4-FFF2-40B4-BE49-F238E27FC236}">
                <a16:creationId xmlns:a16="http://schemas.microsoft.com/office/drawing/2014/main" id="{9B5A9DAA-C39C-27D8-51D3-8C6578D59E76}"/>
              </a:ext>
            </a:extLst>
          </p:cNvPr>
          <p:cNvSpPr/>
          <p:nvPr/>
        </p:nvSpPr>
        <p:spPr>
          <a:xfrm>
            <a:off x="1286187" y="5443198"/>
            <a:ext cx="73152" cy="73152"/>
          </a:xfrm>
          <a:prstGeom prst="ellipse">
            <a:avLst/>
          </a:prstGeom>
          <a:solidFill>
            <a:srgbClr val="53B4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08" name="Oval 107">
            <a:extLst>
              <a:ext uri="{FF2B5EF4-FFF2-40B4-BE49-F238E27FC236}">
                <a16:creationId xmlns:a16="http://schemas.microsoft.com/office/drawing/2014/main" id="{BF35718B-FF44-941D-637B-F7B6DE2ED34A}"/>
              </a:ext>
            </a:extLst>
          </p:cNvPr>
          <p:cNvSpPr/>
          <p:nvPr/>
        </p:nvSpPr>
        <p:spPr>
          <a:xfrm>
            <a:off x="1381436" y="5442741"/>
            <a:ext cx="73152" cy="74928"/>
          </a:xfrm>
          <a:prstGeom prst="ellipse">
            <a:avLst/>
          </a:prstGeom>
          <a:solidFill>
            <a:srgbClr val="FB61D7"/>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09" name="Rectangle 108">
            <a:extLst>
              <a:ext uri="{FF2B5EF4-FFF2-40B4-BE49-F238E27FC236}">
                <a16:creationId xmlns:a16="http://schemas.microsoft.com/office/drawing/2014/main" id="{BF340F1E-4113-1038-17ED-0D2E322C7875}"/>
              </a:ext>
            </a:extLst>
          </p:cNvPr>
          <p:cNvSpPr/>
          <p:nvPr/>
        </p:nvSpPr>
        <p:spPr>
          <a:xfrm>
            <a:off x="3797141" y="6174441"/>
            <a:ext cx="507841" cy="185453"/>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10" name="TextBox 109">
            <a:extLst>
              <a:ext uri="{FF2B5EF4-FFF2-40B4-BE49-F238E27FC236}">
                <a16:creationId xmlns:a16="http://schemas.microsoft.com/office/drawing/2014/main" id="{D1926AD4-5D61-D851-0DAC-132CE12A7772}"/>
              </a:ext>
            </a:extLst>
          </p:cNvPr>
          <p:cNvSpPr txBox="1"/>
          <p:nvPr/>
        </p:nvSpPr>
        <p:spPr>
          <a:xfrm>
            <a:off x="3852289" y="6162423"/>
            <a:ext cx="492552"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NPR3</a:t>
            </a:r>
          </a:p>
        </p:txBody>
      </p:sp>
      <p:cxnSp>
        <p:nvCxnSpPr>
          <p:cNvPr id="111" name="Straight Arrow Connector 110">
            <a:extLst>
              <a:ext uri="{FF2B5EF4-FFF2-40B4-BE49-F238E27FC236}">
                <a16:creationId xmlns:a16="http://schemas.microsoft.com/office/drawing/2014/main" id="{8C771EE0-9B2E-088A-7B33-CD51D0516BDE}"/>
              </a:ext>
            </a:extLst>
          </p:cNvPr>
          <p:cNvCxnSpPr>
            <a:cxnSpLocks/>
          </p:cNvCxnSpPr>
          <p:nvPr/>
        </p:nvCxnSpPr>
        <p:spPr>
          <a:xfrm>
            <a:off x="3397189" y="5951416"/>
            <a:ext cx="0" cy="1828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2" name="Rectangle 111">
            <a:extLst>
              <a:ext uri="{FF2B5EF4-FFF2-40B4-BE49-F238E27FC236}">
                <a16:creationId xmlns:a16="http://schemas.microsoft.com/office/drawing/2014/main" id="{AA232013-8BC4-4CA3-F42E-2FD4639B8F5D}"/>
              </a:ext>
            </a:extLst>
          </p:cNvPr>
          <p:cNvSpPr/>
          <p:nvPr/>
        </p:nvSpPr>
        <p:spPr>
          <a:xfrm>
            <a:off x="3426020" y="6738664"/>
            <a:ext cx="507841" cy="185453"/>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13" name="TextBox 112">
            <a:extLst>
              <a:ext uri="{FF2B5EF4-FFF2-40B4-BE49-F238E27FC236}">
                <a16:creationId xmlns:a16="http://schemas.microsoft.com/office/drawing/2014/main" id="{CC9EF421-C94A-9AB1-840E-F67854226DA4}"/>
              </a:ext>
            </a:extLst>
          </p:cNvPr>
          <p:cNvSpPr txBox="1"/>
          <p:nvPr/>
        </p:nvSpPr>
        <p:spPr>
          <a:xfrm>
            <a:off x="3464956" y="6722028"/>
            <a:ext cx="492552"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NPRs</a:t>
            </a:r>
          </a:p>
        </p:txBody>
      </p:sp>
      <p:sp>
        <p:nvSpPr>
          <p:cNvPr id="114" name="Rectangle 113">
            <a:extLst>
              <a:ext uri="{FF2B5EF4-FFF2-40B4-BE49-F238E27FC236}">
                <a16:creationId xmlns:a16="http://schemas.microsoft.com/office/drawing/2014/main" id="{05F94BA7-BCCD-8007-809D-BB1416C8C5DA}"/>
              </a:ext>
            </a:extLst>
          </p:cNvPr>
          <p:cNvSpPr/>
          <p:nvPr/>
        </p:nvSpPr>
        <p:spPr>
          <a:xfrm>
            <a:off x="4138977" y="6737703"/>
            <a:ext cx="455727" cy="185453"/>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15" name="TextBox 114">
            <a:extLst>
              <a:ext uri="{FF2B5EF4-FFF2-40B4-BE49-F238E27FC236}">
                <a16:creationId xmlns:a16="http://schemas.microsoft.com/office/drawing/2014/main" id="{57FF72A5-0225-B2BC-3656-D9CE6F3CC0F5}"/>
              </a:ext>
            </a:extLst>
          </p:cNvPr>
          <p:cNvSpPr txBox="1"/>
          <p:nvPr/>
        </p:nvSpPr>
        <p:spPr>
          <a:xfrm>
            <a:off x="4148285" y="6725318"/>
            <a:ext cx="455726"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TGAs</a:t>
            </a:r>
          </a:p>
        </p:txBody>
      </p:sp>
      <p:sp>
        <p:nvSpPr>
          <p:cNvPr id="116" name="Rectangle 115">
            <a:extLst>
              <a:ext uri="{FF2B5EF4-FFF2-40B4-BE49-F238E27FC236}">
                <a16:creationId xmlns:a16="http://schemas.microsoft.com/office/drawing/2014/main" id="{B41CB5CB-A430-1E41-64E5-44DC2F627A5D}"/>
              </a:ext>
            </a:extLst>
          </p:cNvPr>
          <p:cNvSpPr/>
          <p:nvPr/>
        </p:nvSpPr>
        <p:spPr>
          <a:xfrm>
            <a:off x="5003099" y="6844539"/>
            <a:ext cx="467445" cy="176510"/>
          </a:xfrm>
          <a:prstGeom prst="rect">
            <a:avLst/>
          </a:prstGeom>
          <a:solidFill>
            <a:srgbClr val="00B0F0"/>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17" name="TextBox 116">
            <a:extLst>
              <a:ext uri="{FF2B5EF4-FFF2-40B4-BE49-F238E27FC236}">
                <a16:creationId xmlns:a16="http://schemas.microsoft.com/office/drawing/2014/main" id="{FE45DF65-70A5-4600-54F8-F66EC8AB06D5}"/>
              </a:ext>
            </a:extLst>
          </p:cNvPr>
          <p:cNvSpPr txBox="1"/>
          <p:nvPr/>
        </p:nvSpPr>
        <p:spPr>
          <a:xfrm>
            <a:off x="5000796" y="6828528"/>
            <a:ext cx="485758"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PR1s</a:t>
            </a:r>
          </a:p>
        </p:txBody>
      </p:sp>
      <p:cxnSp>
        <p:nvCxnSpPr>
          <p:cNvPr id="120" name="Straight Arrow Connector 119">
            <a:extLst>
              <a:ext uri="{FF2B5EF4-FFF2-40B4-BE49-F238E27FC236}">
                <a16:creationId xmlns:a16="http://schemas.microsoft.com/office/drawing/2014/main" id="{439AD71C-DEA5-D5C8-A091-459C3ACA3358}"/>
              </a:ext>
            </a:extLst>
          </p:cNvPr>
          <p:cNvCxnSpPr>
            <a:cxnSpLocks/>
          </p:cNvCxnSpPr>
          <p:nvPr/>
        </p:nvCxnSpPr>
        <p:spPr>
          <a:xfrm>
            <a:off x="3443365" y="6369697"/>
            <a:ext cx="0" cy="3200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1" name="TextBox 120">
            <a:extLst>
              <a:ext uri="{FF2B5EF4-FFF2-40B4-BE49-F238E27FC236}">
                <a16:creationId xmlns:a16="http://schemas.microsoft.com/office/drawing/2014/main" id="{A7E114D0-F026-5A7E-F48D-DB943DEA8C17}"/>
              </a:ext>
            </a:extLst>
          </p:cNvPr>
          <p:cNvSpPr txBox="1"/>
          <p:nvPr/>
        </p:nvSpPr>
        <p:spPr>
          <a:xfrm>
            <a:off x="2732450" y="6628692"/>
            <a:ext cx="537624" cy="200055"/>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NIMINS</a:t>
            </a:r>
          </a:p>
        </p:txBody>
      </p:sp>
      <p:sp>
        <p:nvSpPr>
          <p:cNvPr id="122" name="Rectangle 121">
            <a:extLst>
              <a:ext uri="{FF2B5EF4-FFF2-40B4-BE49-F238E27FC236}">
                <a16:creationId xmlns:a16="http://schemas.microsoft.com/office/drawing/2014/main" id="{CE8DDB6C-A0A6-6F0C-B2CD-62A682743534}"/>
              </a:ext>
            </a:extLst>
          </p:cNvPr>
          <p:cNvSpPr/>
          <p:nvPr/>
        </p:nvSpPr>
        <p:spPr>
          <a:xfrm>
            <a:off x="2643710" y="6924473"/>
            <a:ext cx="381894" cy="18545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23" name="TextBox 122">
            <a:extLst>
              <a:ext uri="{FF2B5EF4-FFF2-40B4-BE49-F238E27FC236}">
                <a16:creationId xmlns:a16="http://schemas.microsoft.com/office/drawing/2014/main" id="{F0700D12-B974-9B1A-3EC2-AC31A45F796F}"/>
              </a:ext>
            </a:extLst>
          </p:cNvPr>
          <p:cNvSpPr txBox="1"/>
          <p:nvPr/>
        </p:nvSpPr>
        <p:spPr>
          <a:xfrm>
            <a:off x="2588632" y="6916748"/>
            <a:ext cx="455726" cy="200055"/>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SUMO</a:t>
            </a:r>
          </a:p>
        </p:txBody>
      </p:sp>
      <p:sp>
        <p:nvSpPr>
          <p:cNvPr id="124" name="Rectangle 123">
            <a:extLst>
              <a:ext uri="{FF2B5EF4-FFF2-40B4-BE49-F238E27FC236}">
                <a16:creationId xmlns:a16="http://schemas.microsoft.com/office/drawing/2014/main" id="{0FA0DB2B-0C33-E537-DCA5-6C334B0900CB}"/>
              </a:ext>
            </a:extLst>
          </p:cNvPr>
          <p:cNvSpPr/>
          <p:nvPr/>
        </p:nvSpPr>
        <p:spPr>
          <a:xfrm>
            <a:off x="2915890" y="7151851"/>
            <a:ext cx="365385" cy="18545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25" name="TextBox 124">
            <a:extLst>
              <a:ext uri="{FF2B5EF4-FFF2-40B4-BE49-F238E27FC236}">
                <a16:creationId xmlns:a16="http://schemas.microsoft.com/office/drawing/2014/main" id="{79C184B0-B487-7A04-C3D3-214AAD8C2631}"/>
              </a:ext>
            </a:extLst>
          </p:cNvPr>
          <p:cNvSpPr txBox="1"/>
          <p:nvPr/>
        </p:nvSpPr>
        <p:spPr>
          <a:xfrm>
            <a:off x="2921454" y="7153159"/>
            <a:ext cx="404354" cy="200055"/>
          </a:xfrm>
          <a:prstGeom prst="rect">
            <a:avLst/>
          </a:prstGeom>
          <a:noFill/>
        </p:spPr>
        <p:txBody>
          <a:bodyPr wrap="square">
            <a:spAutoFit/>
          </a:bodyPr>
          <a:lstStyle/>
          <a:p>
            <a:r>
              <a:rPr lang="en-US" sz="700">
                <a:latin typeface="Helvetica" panose="020B0604020202020204" pitchFamily="34" charset="0"/>
                <a:cs typeface="Helvetica" panose="020B0604020202020204" pitchFamily="34" charset="0"/>
              </a:rPr>
              <a:t>UBP</a:t>
            </a:r>
          </a:p>
        </p:txBody>
      </p:sp>
      <p:cxnSp>
        <p:nvCxnSpPr>
          <p:cNvPr id="126" name="Straight Arrow Connector 125">
            <a:extLst>
              <a:ext uri="{FF2B5EF4-FFF2-40B4-BE49-F238E27FC236}">
                <a16:creationId xmlns:a16="http://schemas.microsoft.com/office/drawing/2014/main" id="{81F3B27C-ADA7-329D-314A-E15C8E57D403}"/>
              </a:ext>
            </a:extLst>
          </p:cNvPr>
          <p:cNvCxnSpPr>
            <a:cxnSpLocks/>
          </p:cNvCxnSpPr>
          <p:nvPr/>
        </p:nvCxnSpPr>
        <p:spPr>
          <a:xfrm>
            <a:off x="4392169" y="6938396"/>
            <a:ext cx="0" cy="1434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8" name="Straight Arrow Connector 127">
            <a:extLst>
              <a:ext uri="{FF2B5EF4-FFF2-40B4-BE49-F238E27FC236}">
                <a16:creationId xmlns:a16="http://schemas.microsoft.com/office/drawing/2014/main" id="{928994EA-F4BC-2FBA-70D5-2B6574960B46}"/>
              </a:ext>
            </a:extLst>
          </p:cNvPr>
          <p:cNvCxnSpPr>
            <a:cxnSpLocks/>
          </p:cNvCxnSpPr>
          <p:nvPr/>
        </p:nvCxnSpPr>
        <p:spPr>
          <a:xfrm flipV="1">
            <a:off x="4592435" y="6939666"/>
            <a:ext cx="411829" cy="26600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9" name="Straight Arrow Connector 128">
            <a:extLst>
              <a:ext uri="{FF2B5EF4-FFF2-40B4-BE49-F238E27FC236}">
                <a16:creationId xmlns:a16="http://schemas.microsoft.com/office/drawing/2014/main" id="{213DD5A4-61CF-0BF9-C70D-2305063726EA}"/>
              </a:ext>
            </a:extLst>
          </p:cNvPr>
          <p:cNvCxnSpPr>
            <a:cxnSpLocks/>
          </p:cNvCxnSpPr>
          <p:nvPr/>
        </p:nvCxnSpPr>
        <p:spPr>
          <a:xfrm flipV="1">
            <a:off x="3126407" y="6923156"/>
            <a:ext cx="304260" cy="229657"/>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0" name="Straight Arrow Connector 129">
            <a:extLst>
              <a:ext uri="{FF2B5EF4-FFF2-40B4-BE49-F238E27FC236}">
                <a16:creationId xmlns:a16="http://schemas.microsoft.com/office/drawing/2014/main" id="{076191F4-7C70-E2CF-A2A1-018AA4F2D358}"/>
              </a:ext>
            </a:extLst>
          </p:cNvPr>
          <p:cNvCxnSpPr>
            <a:cxnSpLocks/>
          </p:cNvCxnSpPr>
          <p:nvPr/>
        </p:nvCxnSpPr>
        <p:spPr>
          <a:xfrm flipV="1">
            <a:off x="3024939" y="6865500"/>
            <a:ext cx="397351" cy="157748"/>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1" name="Straight Arrow Connector 130">
            <a:extLst>
              <a:ext uri="{FF2B5EF4-FFF2-40B4-BE49-F238E27FC236}">
                <a16:creationId xmlns:a16="http://schemas.microsoft.com/office/drawing/2014/main" id="{2B757326-EC7E-D8AF-9BDC-FD1A53667EF2}"/>
              </a:ext>
            </a:extLst>
          </p:cNvPr>
          <p:cNvCxnSpPr>
            <a:cxnSpLocks/>
            <a:endCxn id="112" idx="1"/>
          </p:cNvCxnSpPr>
          <p:nvPr/>
        </p:nvCxnSpPr>
        <p:spPr>
          <a:xfrm>
            <a:off x="3196608" y="6740196"/>
            <a:ext cx="229412" cy="91195"/>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2" name="Oval 131">
            <a:extLst>
              <a:ext uri="{FF2B5EF4-FFF2-40B4-BE49-F238E27FC236}">
                <a16:creationId xmlns:a16="http://schemas.microsoft.com/office/drawing/2014/main" id="{17B70BB7-A4D7-D334-A137-6BCC25E7FAE1}"/>
              </a:ext>
            </a:extLst>
          </p:cNvPr>
          <p:cNvSpPr/>
          <p:nvPr/>
        </p:nvSpPr>
        <p:spPr>
          <a:xfrm>
            <a:off x="4965832" y="6741299"/>
            <a:ext cx="73152" cy="73152"/>
          </a:xfrm>
          <a:prstGeom prst="ellipse">
            <a:avLst/>
          </a:prstGeom>
          <a:solidFill>
            <a:srgbClr val="F8766D"/>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33" name="Oval 132">
            <a:extLst>
              <a:ext uri="{FF2B5EF4-FFF2-40B4-BE49-F238E27FC236}">
                <a16:creationId xmlns:a16="http://schemas.microsoft.com/office/drawing/2014/main" id="{8E7E6AB2-59E4-88FF-ADD4-8B1D1C2B18BE}"/>
              </a:ext>
            </a:extLst>
          </p:cNvPr>
          <p:cNvSpPr/>
          <p:nvPr/>
        </p:nvSpPr>
        <p:spPr>
          <a:xfrm>
            <a:off x="5063621" y="6742211"/>
            <a:ext cx="73152" cy="73152"/>
          </a:xfrm>
          <a:prstGeom prst="ellipse">
            <a:avLst/>
          </a:prstGeom>
          <a:solidFill>
            <a:srgbClr val="53B4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34" name="Oval 133">
            <a:extLst>
              <a:ext uri="{FF2B5EF4-FFF2-40B4-BE49-F238E27FC236}">
                <a16:creationId xmlns:a16="http://schemas.microsoft.com/office/drawing/2014/main" id="{7FEDF0C3-3610-7B89-48F6-390BC0BF684F}"/>
              </a:ext>
            </a:extLst>
          </p:cNvPr>
          <p:cNvSpPr/>
          <p:nvPr/>
        </p:nvSpPr>
        <p:spPr>
          <a:xfrm>
            <a:off x="5157250" y="6744006"/>
            <a:ext cx="73152" cy="73152"/>
          </a:xfrm>
          <a:prstGeom prst="ellipse">
            <a:avLst/>
          </a:prstGeom>
          <a:solidFill>
            <a:srgbClr val="FB61D7"/>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35" name="Oval 134">
            <a:extLst>
              <a:ext uri="{FF2B5EF4-FFF2-40B4-BE49-F238E27FC236}">
                <a16:creationId xmlns:a16="http://schemas.microsoft.com/office/drawing/2014/main" id="{1A6470FD-1041-CE7A-C3B3-6FCE137DA0D0}"/>
              </a:ext>
            </a:extLst>
          </p:cNvPr>
          <p:cNvSpPr/>
          <p:nvPr/>
        </p:nvSpPr>
        <p:spPr>
          <a:xfrm>
            <a:off x="4145739" y="6086570"/>
            <a:ext cx="73152" cy="73152"/>
          </a:xfrm>
          <a:prstGeom prst="ellipse">
            <a:avLst/>
          </a:prstGeom>
          <a:solidFill>
            <a:srgbClr val="00B6EB"/>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36" name="Oval 135">
            <a:extLst>
              <a:ext uri="{FF2B5EF4-FFF2-40B4-BE49-F238E27FC236}">
                <a16:creationId xmlns:a16="http://schemas.microsoft.com/office/drawing/2014/main" id="{007F5810-FD06-49C2-CB20-61D088A7618E}"/>
              </a:ext>
            </a:extLst>
          </p:cNvPr>
          <p:cNvSpPr/>
          <p:nvPr/>
        </p:nvSpPr>
        <p:spPr>
          <a:xfrm>
            <a:off x="4044549" y="6081657"/>
            <a:ext cx="73152" cy="73152"/>
          </a:xfrm>
          <a:prstGeom prst="ellipse">
            <a:avLst/>
          </a:prstGeom>
          <a:solidFill>
            <a:srgbClr val="FB61D7"/>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0" name="Oval 139">
            <a:extLst>
              <a:ext uri="{FF2B5EF4-FFF2-40B4-BE49-F238E27FC236}">
                <a16:creationId xmlns:a16="http://schemas.microsoft.com/office/drawing/2014/main" id="{5A142951-4726-E388-4A7A-10419B2516D9}"/>
              </a:ext>
            </a:extLst>
          </p:cNvPr>
          <p:cNvSpPr/>
          <p:nvPr/>
        </p:nvSpPr>
        <p:spPr>
          <a:xfrm>
            <a:off x="4123088" y="6629579"/>
            <a:ext cx="73152" cy="73152"/>
          </a:xfrm>
          <a:prstGeom prst="ellipse">
            <a:avLst/>
          </a:prstGeom>
          <a:solidFill>
            <a:srgbClr val="F8766D"/>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1" name="Oval 140">
            <a:extLst>
              <a:ext uri="{FF2B5EF4-FFF2-40B4-BE49-F238E27FC236}">
                <a16:creationId xmlns:a16="http://schemas.microsoft.com/office/drawing/2014/main" id="{F0983390-5016-0C1F-86F7-60D0D5A9AE92}"/>
              </a:ext>
            </a:extLst>
          </p:cNvPr>
          <p:cNvSpPr/>
          <p:nvPr/>
        </p:nvSpPr>
        <p:spPr>
          <a:xfrm>
            <a:off x="4220877" y="6630491"/>
            <a:ext cx="73152" cy="73152"/>
          </a:xfrm>
          <a:prstGeom prst="ellipse">
            <a:avLst/>
          </a:prstGeom>
          <a:solidFill>
            <a:srgbClr val="53B4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2" name="Oval 141">
            <a:extLst>
              <a:ext uri="{FF2B5EF4-FFF2-40B4-BE49-F238E27FC236}">
                <a16:creationId xmlns:a16="http://schemas.microsoft.com/office/drawing/2014/main" id="{584B7048-C9A5-AABA-9A83-F9FAACBE98C9}"/>
              </a:ext>
            </a:extLst>
          </p:cNvPr>
          <p:cNvSpPr/>
          <p:nvPr/>
        </p:nvSpPr>
        <p:spPr>
          <a:xfrm>
            <a:off x="4314506" y="6632286"/>
            <a:ext cx="73152" cy="73152"/>
          </a:xfrm>
          <a:prstGeom prst="ellipse">
            <a:avLst/>
          </a:prstGeom>
          <a:solidFill>
            <a:srgbClr val="FB61D7"/>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3" name="Oval 142">
            <a:extLst>
              <a:ext uri="{FF2B5EF4-FFF2-40B4-BE49-F238E27FC236}">
                <a16:creationId xmlns:a16="http://schemas.microsoft.com/office/drawing/2014/main" id="{D56F2D36-C264-3D47-C1C9-FC8BDC45289F}"/>
              </a:ext>
            </a:extLst>
          </p:cNvPr>
          <p:cNvSpPr/>
          <p:nvPr/>
        </p:nvSpPr>
        <p:spPr>
          <a:xfrm>
            <a:off x="4075251" y="7006484"/>
            <a:ext cx="73152" cy="73152"/>
          </a:xfrm>
          <a:prstGeom prst="ellipse">
            <a:avLst/>
          </a:prstGeom>
          <a:solidFill>
            <a:srgbClr val="F8766D"/>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4" name="Oval 143">
            <a:extLst>
              <a:ext uri="{FF2B5EF4-FFF2-40B4-BE49-F238E27FC236}">
                <a16:creationId xmlns:a16="http://schemas.microsoft.com/office/drawing/2014/main" id="{66626D36-E742-783E-606E-FCCBFA1B0172}"/>
              </a:ext>
            </a:extLst>
          </p:cNvPr>
          <p:cNvSpPr/>
          <p:nvPr/>
        </p:nvSpPr>
        <p:spPr>
          <a:xfrm>
            <a:off x="4173040" y="7007396"/>
            <a:ext cx="73152" cy="73152"/>
          </a:xfrm>
          <a:prstGeom prst="ellipse">
            <a:avLst/>
          </a:prstGeom>
          <a:solidFill>
            <a:srgbClr val="53B4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5" name="Oval 144">
            <a:extLst>
              <a:ext uri="{FF2B5EF4-FFF2-40B4-BE49-F238E27FC236}">
                <a16:creationId xmlns:a16="http://schemas.microsoft.com/office/drawing/2014/main" id="{1C1EDB1B-0D00-B6CC-85D9-B61B968B5F33}"/>
              </a:ext>
            </a:extLst>
          </p:cNvPr>
          <p:cNvSpPr/>
          <p:nvPr/>
        </p:nvSpPr>
        <p:spPr>
          <a:xfrm>
            <a:off x="4266669" y="7009191"/>
            <a:ext cx="73152" cy="73152"/>
          </a:xfrm>
          <a:prstGeom prst="ellipse">
            <a:avLst/>
          </a:prstGeom>
          <a:solidFill>
            <a:srgbClr val="FB61D7"/>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46" name="Oval 145">
            <a:extLst>
              <a:ext uri="{FF2B5EF4-FFF2-40B4-BE49-F238E27FC236}">
                <a16:creationId xmlns:a16="http://schemas.microsoft.com/office/drawing/2014/main" id="{AE85E327-F381-1365-F04B-B6858198F5A4}"/>
              </a:ext>
            </a:extLst>
          </p:cNvPr>
          <p:cNvSpPr/>
          <p:nvPr/>
        </p:nvSpPr>
        <p:spPr>
          <a:xfrm>
            <a:off x="4405139" y="6633077"/>
            <a:ext cx="73152" cy="73152"/>
          </a:xfrm>
          <a:prstGeom prst="ellipse">
            <a:avLst/>
          </a:prstGeom>
          <a:solidFill>
            <a:srgbClr val="00C094"/>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cxnSp>
        <p:nvCxnSpPr>
          <p:cNvPr id="147" name="Straight Arrow Connector 146">
            <a:extLst>
              <a:ext uri="{FF2B5EF4-FFF2-40B4-BE49-F238E27FC236}">
                <a16:creationId xmlns:a16="http://schemas.microsoft.com/office/drawing/2014/main" id="{2BF73D87-538D-82F5-3BFA-D603532DCD30}"/>
              </a:ext>
            </a:extLst>
          </p:cNvPr>
          <p:cNvCxnSpPr>
            <a:cxnSpLocks/>
          </p:cNvCxnSpPr>
          <p:nvPr/>
        </p:nvCxnSpPr>
        <p:spPr>
          <a:xfrm>
            <a:off x="3982152" y="5944417"/>
            <a:ext cx="0" cy="1828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8" name="Rectangle 147">
            <a:extLst>
              <a:ext uri="{FF2B5EF4-FFF2-40B4-BE49-F238E27FC236}">
                <a16:creationId xmlns:a16="http://schemas.microsoft.com/office/drawing/2014/main" id="{677026D3-29DE-AE51-C9F2-FE5C2A7978E6}"/>
              </a:ext>
            </a:extLst>
          </p:cNvPr>
          <p:cNvSpPr/>
          <p:nvPr/>
        </p:nvSpPr>
        <p:spPr>
          <a:xfrm>
            <a:off x="3163446" y="6163981"/>
            <a:ext cx="401267" cy="185453"/>
          </a:xfrm>
          <a:prstGeom prst="rect">
            <a:avLst/>
          </a:prstGeom>
          <a:solidFill>
            <a:schemeClr val="accent4">
              <a:lumMod val="20000"/>
              <a:lumOff val="80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49" name="TextBox 148">
            <a:extLst>
              <a:ext uri="{FF2B5EF4-FFF2-40B4-BE49-F238E27FC236}">
                <a16:creationId xmlns:a16="http://schemas.microsoft.com/office/drawing/2014/main" id="{3253A329-22CE-F47F-1DEB-835B59711B82}"/>
              </a:ext>
            </a:extLst>
          </p:cNvPr>
          <p:cNvSpPr txBox="1"/>
          <p:nvPr/>
        </p:nvSpPr>
        <p:spPr>
          <a:xfrm>
            <a:off x="3169348" y="6154253"/>
            <a:ext cx="492552"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NPR1</a:t>
            </a:r>
          </a:p>
        </p:txBody>
      </p:sp>
      <p:cxnSp>
        <p:nvCxnSpPr>
          <p:cNvPr id="150" name="Straight Arrow Connector 149">
            <a:extLst>
              <a:ext uri="{FF2B5EF4-FFF2-40B4-BE49-F238E27FC236}">
                <a16:creationId xmlns:a16="http://schemas.microsoft.com/office/drawing/2014/main" id="{3761B818-D2BB-7154-F6D1-6BFFB4DF7BE5}"/>
              </a:ext>
            </a:extLst>
          </p:cNvPr>
          <p:cNvCxnSpPr>
            <a:cxnSpLocks/>
          </p:cNvCxnSpPr>
          <p:nvPr/>
        </p:nvCxnSpPr>
        <p:spPr>
          <a:xfrm>
            <a:off x="3872207" y="6377867"/>
            <a:ext cx="0" cy="3200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2" name="Oval 151">
            <a:extLst>
              <a:ext uri="{FF2B5EF4-FFF2-40B4-BE49-F238E27FC236}">
                <a16:creationId xmlns:a16="http://schemas.microsoft.com/office/drawing/2014/main" id="{3B3630C6-0947-ABCA-520D-AAB40561376D}"/>
              </a:ext>
            </a:extLst>
          </p:cNvPr>
          <p:cNvSpPr/>
          <p:nvPr/>
        </p:nvSpPr>
        <p:spPr>
          <a:xfrm>
            <a:off x="4243702" y="6080409"/>
            <a:ext cx="73152" cy="73152"/>
          </a:xfrm>
          <a:prstGeom prst="ellipse">
            <a:avLst/>
          </a:prstGeom>
          <a:solidFill>
            <a:srgbClr val="00C094"/>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53" name="Oval 152">
            <a:extLst>
              <a:ext uri="{FF2B5EF4-FFF2-40B4-BE49-F238E27FC236}">
                <a16:creationId xmlns:a16="http://schemas.microsoft.com/office/drawing/2014/main" id="{113EDDED-D5CE-66B0-DAAE-8D9A7D6F9F9C}"/>
              </a:ext>
            </a:extLst>
          </p:cNvPr>
          <p:cNvSpPr/>
          <p:nvPr/>
        </p:nvSpPr>
        <p:spPr>
          <a:xfrm>
            <a:off x="5256430" y="6744256"/>
            <a:ext cx="73152" cy="73152"/>
          </a:xfrm>
          <a:prstGeom prst="ellipse">
            <a:avLst/>
          </a:prstGeom>
          <a:solidFill>
            <a:srgbClr val="C49A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54" name="Oval 153">
            <a:extLst>
              <a:ext uri="{FF2B5EF4-FFF2-40B4-BE49-F238E27FC236}">
                <a16:creationId xmlns:a16="http://schemas.microsoft.com/office/drawing/2014/main" id="{EDDA5A2E-23A2-BD70-1AA8-098A63B40F6A}"/>
              </a:ext>
            </a:extLst>
          </p:cNvPr>
          <p:cNvSpPr/>
          <p:nvPr/>
        </p:nvSpPr>
        <p:spPr>
          <a:xfrm>
            <a:off x="5354219" y="6745168"/>
            <a:ext cx="73152" cy="73152"/>
          </a:xfrm>
          <a:prstGeom prst="ellipse">
            <a:avLst/>
          </a:prstGeom>
          <a:solidFill>
            <a:srgbClr val="00B6EB"/>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55" name="Oval 154">
            <a:extLst>
              <a:ext uri="{FF2B5EF4-FFF2-40B4-BE49-F238E27FC236}">
                <a16:creationId xmlns:a16="http://schemas.microsoft.com/office/drawing/2014/main" id="{39F0E06D-3AEA-0A66-C061-51D2343069DB}"/>
              </a:ext>
            </a:extLst>
          </p:cNvPr>
          <p:cNvSpPr/>
          <p:nvPr/>
        </p:nvSpPr>
        <p:spPr>
          <a:xfrm>
            <a:off x="5447848" y="6746963"/>
            <a:ext cx="73152" cy="73152"/>
          </a:xfrm>
          <a:prstGeom prst="ellipse">
            <a:avLst/>
          </a:prstGeom>
          <a:solidFill>
            <a:srgbClr val="00C094"/>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cxnSp>
        <p:nvCxnSpPr>
          <p:cNvPr id="162" name="Straight Arrow Connector 161">
            <a:extLst>
              <a:ext uri="{FF2B5EF4-FFF2-40B4-BE49-F238E27FC236}">
                <a16:creationId xmlns:a16="http://schemas.microsoft.com/office/drawing/2014/main" id="{9D3761F2-3B57-00E6-A679-6306FD503837}"/>
              </a:ext>
            </a:extLst>
          </p:cNvPr>
          <p:cNvCxnSpPr>
            <a:cxnSpLocks/>
          </p:cNvCxnSpPr>
          <p:nvPr/>
        </p:nvCxnSpPr>
        <p:spPr>
          <a:xfrm flipV="1">
            <a:off x="1527706" y="5382119"/>
            <a:ext cx="0" cy="1525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3" name="Straight Arrow Connector 162">
            <a:extLst>
              <a:ext uri="{FF2B5EF4-FFF2-40B4-BE49-F238E27FC236}">
                <a16:creationId xmlns:a16="http://schemas.microsoft.com/office/drawing/2014/main" id="{65320ACA-0891-45B8-53C4-DACB666CE9FD}"/>
              </a:ext>
            </a:extLst>
          </p:cNvPr>
          <p:cNvCxnSpPr>
            <a:cxnSpLocks/>
          </p:cNvCxnSpPr>
          <p:nvPr/>
        </p:nvCxnSpPr>
        <p:spPr>
          <a:xfrm flipV="1">
            <a:off x="1639761" y="5203577"/>
            <a:ext cx="421617" cy="3595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4" name="Straight Arrow Connector 163">
            <a:extLst>
              <a:ext uri="{FF2B5EF4-FFF2-40B4-BE49-F238E27FC236}">
                <a16:creationId xmlns:a16="http://schemas.microsoft.com/office/drawing/2014/main" id="{779EC635-6078-89C8-A702-E010690FCF57}"/>
              </a:ext>
            </a:extLst>
          </p:cNvPr>
          <p:cNvCxnSpPr>
            <a:cxnSpLocks/>
          </p:cNvCxnSpPr>
          <p:nvPr/>
        </p:nvCxnSpPr>
        <p:spPr>
          <a:xfrm flipV="1">
            <a:off x="1645311" y="4602973"/>
            <a:ext cx="316259" cy="9640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5" name="Straight Arrow Connector 164">
            <a:extLst>
              <a:ext uri="{FF2B5EF4-FFF2-40B4-BE49-F238E27FC236}">
                <a16:creationId xmlns:a16="http://schemas.microsoft.com/office/drawing/2014/main" id="{FB1CAC9C-3947-939D-146A-5891B6990C16}"/>
              </a:ext>
            </a:extLst>
          </p:cNvPr>
          <p:cNvCxnSpPr>
            <a:cxnSpLocks/>
          </p:cNvCxnSpPr>
          <p:nvPr/>
        </p:nvCxnSpPr>
        <p:spPr>
          <a:xfrm>
            <a:off x="1597892" y="5331043"/>
            <a:ext cx="364841" cy="24487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6" name="Straight Arrow Connector 165">
            <a:extLst>
              <a:ext uri="{FF2B5EF4-FFF2-40B4-BE49-F238E27FC236}">
                <a16:creationId xmlns:a16="http://schemas.microsoft.com/office/drawing/2014/main" id="{58DD82DD-5C52-92E4-83B8-A7AFEE7416B2}"/>
              </a:ext>
            </a:extLst>
          </p:cNvPr>
          <p:cNvCxnSpPr>
            <a:cxnSpLocks/>
          </p:cNvCxnSpPr>
          <p:nvPr/>
        </p:nvCxnSpPr>
        <p:spPr>
          <a:xfrm flipV="1">
            <a:off x="1533045" y="4610325"/>
            <a:ext cx="304677" cy="65770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67" name="Group 166">
            <a:extLst>
              <a:ext uri="{FF2B5EF4-FFF2-40B4-BE49-F238E27FC236}">
                <a16:creationId xmlns:a16="http://schemas.microsoft.com/office/drawing/2014/main" id="{D842885B-A23B-AB4E-0848-1A587A10C605}"/>
              </a:ext>
            </a:extLst>
          </p:cNvPr>
          <p:cNvGrpSpPr/>
          <p:nvPr/>
        </p:nvGrpSpPr>
        <p:grpSpPr>
          <a:xfrm>
            <a:off x="1114934" y="5213235"/>
            <a:ext cx="616638" cy="215444"/>
            <a:chOff x="98408" y="2280007"/>
            <a:chExt cx="616638" cy="215444"/>
          </a:xfrm>
        </p:grpSpPr>
        <p:sp>
          <p:nvSpPr>
            <p:cNvPr id="183" name="Rectangle 182">
              <a:extLst>
                <a:ext uri="{FF2B5EF4-FFF2-40B4-BE49-F238E27FC236}">
                  <a16:creationId xmlns:a16="http://schemas.microsoft.com/office/drawing/2014/main" id="{DCA87021-43F7-F57D-E101-82059B3421E9}"/>
                </a:ext>
              </a:extLst>
            </p:cNvPr>
            <p:cNvSpPr/>
            <p:nvPr/>
          </p:nvSpPr>
          <p:spPr>
            <a:xfrm>
              <a:off x="169684" y="2318474"/>
              <a:ext cx="455852" cy="133154"/>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84" name="TextBox 183">
              <a:extLst>
                <a:ext uri="{FF2B5EF4-FFF2-40B4-BE49-F238E27FC236}">
                  <a16:creationId xmlns:a16="http://schemas.microsoft.com/office/drawing/2014/main" id="{1A99D993-4FCF-5EC0-8544-2F3F09A34BE1}"/>
                </a:ext>
              </a:extLst>
            </p:cNvPr>
            <p:cNvSpPr txBox="1"/>
            <p:nvPr/>
          </p:nvSpPr>
          <p:spPr>
            <a:xfrm>
              <a:off x="98408" y="2280007"/>
              <a:ext cx="616638"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WRKY40</a:t>
              </a:r>
            </a:p>
          </p:txBody>
        </p:sp>
      </p:grpSp>
      <p:sp>
        <p:nvSpPr>
          <p:cNvPr id="168" name="Rectangle 167">
            <a:extLst>
              <a:ext uri="{FF2B5EF4-FFF2-40B4-BE49-F238E27FC236}">
                <a16:creationId xmlns:a16="http://schemas.microsoft.com/office/drawing/2014/main" id="{3A1F7A86-0828-767F-A9BE-0B01BE1851C7}"/>
              </a:ext>
            </a:extLst>
          </p:cNvPr>
          <p:cNvSpPr/>
          <p:nvPr/>
        </p:nvSpPr>
        <p:spPr>
          <a:xfrm>
            <a:off x="4103350" y="7108098"/>
            <a:ext cx="493615" cy="185453"/>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69" name="TextBox 168">
            <a:extLst>
              <a:ext uri="{FF2B5EF4-FFF2-40B4-BE49-F238E27FC236}">
                <a16:creationId xmlns:a16="http://schemas.microsoft.com/office/drawing/2014/main" id="{8AE3D2D3-3DAB-9119-DF31-AF50FD82723E}"/>
              </a:ext>
            </a:extLst>
          </p:cNvPr>
          <p:cNvSpPr txBox="1"/>
          <p:nvPr/>
        </p:nvSpPr>
        <p:spPr>
          <a:xfrm>
            <a:off x="4042333" y="7108894"/>
            <a:ext cx="639275"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WRKY70</a:t>
            </a:r>
          </a:p>
        </p:txBody>
      </p:sp>
      <p:cxnSp>
        <p:nvCxnSpPr>
          <p:cNvPr id="170" name="Straight Arrow Connector 169">
            <a:extLst>
              <a:ext uri="{FF2B5EF4-FFF2-40B4-BE49-F238E27FC236}">
                <a16:creationId xmlns:a16="http://schemas.microsoft.com/office/drawing/2014/main" id="{EC7F053C-BF84-1B7E-E213-B13C34694E23}"/>
              </a:ext>
            </a:extLst>
          </p:cNvPr>
          <p:cNvCxnSpPr>
            <a:cxnSpLocks/>
          </p:cNvCxnSpPr>
          <p:nvPr/>
        </p:nvCxnSpPr>
        <p:spPr>
          <a:xfrm>
            <a:off x="1389166" y="5713121"/>
            <a:ext cx="5091" cy="19120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1" name="Straight Arrow Connector 170">
            <a:extLst>
              <a:ext uri="{FF2B5EF4-FFF2-40B4-BE49-F238E27FC236}">
                <a16:creationId xmlns:a16="http://schemas.microsoft.com/office/drawing/2014/main" id="{74ACEDB7-4EF7-0262-991D-D8546F363B90}"/>
              </a:ext>
            </a:extLst>
          </p:cNvPr>
          <p:cNvCxnSpPr>
            <a:cxnSpLocks/>
          </p:cNvCxnSpPr>
          <p:nvPr/>
        </p:nvCxnSpPr>
        <p:spPr>
          <a:xfrm flipV="1">
            <a:off x="1301744" y="5712082"/>
            <a:ext cx="0" cy="19328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72" name="Group 171">
            <a:extLst>
              <a:ext uri="{FF2B5EF4-FFF2-40B4-BE49-F238E27FC236}">
                <a16:creationId xmlns:a16="http://schemas.microsoft.com/office/drawing/2014/main" id="{CCA67366-4F9F-3433-AD2D-7A02296B820E}"/>
              </a:ext>
            </a:extLst>
          </p:cNvPr>
          <p:cNvGrpSpPr/>
          <p:nvPr/>
        </p:nvGrpSpPr>
        <p:grpSpPr>
          <a:xfrm>
            <a:off x="1188231" y="5512619"/>
            <a:ext cx="553170" cy="215445"/>
            <a:chOff x="252115" y="2553150"/>
            <a:chExt cx="553170" cy="193442"/>
          </a:xfrm>
        </p:grpSpPr>
        <p:sp>
          <p:nvSpPr>
            <p:cNvPr id="181" name="Rectangle 180">
              <a:extLst>
                <a:ext uri="{FF2B5EF4-FFF2-40B4-BE49-F238E27FC236}">
                  <a16:creationId xmlns:a16="http://schemas.microsoft.com/office/drawing/2014/main" id="{F5B4B04F-2168-09E3-933C-52CBB4F66F2D}"/>
                </a:ext>
              </a:extLst>
            </p:cNvPr>
            <p:cNvSpPr/>
            <p:nvPr/>
          </p:nvSpPr>
          <p:spPr>
            <a:xfrm>
              <a:off x="252115" y="2570609"/>
              <a:ext cx="484474" cy="161597"/>
            </a:xfrm>
            <a:prstGeom prst="rect">
              <a:avLst/>
            </a:prstGeom>
            <a:solidFill>
              <a:srgbClr val="00B6EB"/>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82" name="TextBox 181">
              <a:extLst>
                <a:ext uri="{FF2B5EF4-FFF2-40B4-BE49-F238E27FC236}">
                  <a16:creationId xmlns:a16="http://schemas.microsoft.com/office/drawing/2014/main" id="{06891363-7AC5-44F3-5299-B3729136E343}"/>
                </a:ext>
              </a:extLst>
            </p:cNvPr>
            <p:cNvSpPr txBox="1"/>
            <p:nvPr/>
          </p:nvSpPr>
          <p:spPr>
            <a:xfrm>
              <a:off x="255513" y="2553150"/>
              <a:ext cx="549772" cy="193442"/>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SARD1</a:t>
              </a:r>
            </a:p>
          </p:txBody>
        </p:sp>
      </p:grpSp>
      <p:grpSp>
        <p:nvGrpSpPr>
          <p:cNvPr id="173" name="Group 172">
            <a:extLst>
              <a:ext uri="{FF2B5EF4-FFF2-40B4-BE49-F238E27FC236}">
                <a16:creationId xmlns:a16="http://schemas.microsoft.com/office/drawing/2014/main" id="{9F9C8878-092E-ABBE-B21C-D32282FD2F2F}"/>
              </a:ext>
            </a:extLst>
          </p:cNvPr>
          <p:cNvGrpSpPr/>
          <p:nvPr/>
        </p:nvGrpSpPr>
        <p:grpSpPr>
          <a:xfrm>
            <a:off x="1203206" y="5874517"/>
            <a:ext cx="472009" cy="215444"/>
            <a:chOff x="3457643" y="6224934"/>
            <a:chExt cx="472009" cy="215444"/>
          </a:xfrm>
        </p:grpSpPr>
        <p:sp>
          <p:nvSpPr>
            <p:cNvPr id="179" name="Rectangle 178">
              <a:extLst>
                <a:ext uri="{FF2B5EF4-FFF2-40B4-BE49-F238E27FC236}">
                  <a16:creationId xmlns:a16="http://schemas.microsoft.com/office/drawing/2014/main" id="{3C2316BF-2F35-9066-8699-249805EDCF05}"/>
                </a:ext>
              </a:extLst>
            </p:cNvPr>
            <p:cNvSpPr/>
            <p:nvPr/>
          </p:nvSpPr>
          <p:spPr>
            <a:xfrm>
              <a:off x="3457643" y="6244401"/>
              <a:ext cx="467445" cy="176510"/>
            </a:xfrm>
            <a:prstGeom prst="rect">
              <a:avLst/>
            </a:prstGeom>
            <a:solidFill>
              <a:srgbClr val="00B0F0"/>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80" name="TextBox 179">
              <a:extLst>
                <a:ext uri="{FF2B5EF4-FFF2-40B4-BE49-F238E27FC236}">
                  <a16:creationId xmlns:a16="http://schemas.microsoft.com/office/drawing/2014/main" id="{B7AD0E85-9C63-C3AF-D997-5C64C922FA6A}"/>
                </a:ext>
              </a:extLst>
            </p:cNvPr>
            <p:cNvSpPr txBox="1"/>
            <p:nvPr/>
          </p:nvSpPr>
          <p:spPr>
            <a:xfrm>
              <a:off x="3457644" y="6224934"/>
              <a:ext cx="472008" cy="215444"/>
            </a:xfrm>
            <a:prstGeom prst="rect">
              <a:avLst/>
            </a:prstGeom>
            <a:noFill/>
          </p:spPr>
          <p:txBody>
            <a:bodyPr wrap="square">
              <a:spAutoFit/>
            </a:bodyPr>
            <a:lstStyle/>
            <a:p>
              <a:r>
                <a:rPr lang="en-US" sz="800">
                  <a:latin typeface="Helvetica" panose="020B0604020202020204" pitchFamily="34" charset="0"/>
                  <a:cs typeface="Helvetica" panose="020B0604020202020204" pitchFamily="34" charset="0"/>
                </a:rPr>
                <a:t>PAD4</a:t>
              </a:r>
            </a:p>
          </p:txBody>
        </p:sp>
      </p:grpSp>
      <p:sp>
        <p:nvSpPr>
          <p:cNvPr id="174" name="Oval 173">
            <a:extLst>
              <a:ext uri="{FF2B5EF4-FFF2-40B4-BE49-F238E27FC236}">
                <a16:creationId xmlns:a16="http://schemas.microsoft.com/office/drawing/2014/main" id="{B98DE7BB-F231-B6D4-AFE5-04E9E87D96FA}"/>
              </a:ext>
            </a:extLst>
          </p:cNvPr>
          <p:cNvSpPr/>
          <p:nvPr/>
        </p:nvSpPr>
        <p:spPr>
          <a:xfrm>
            <a:off x="1535826" y="5794971"/>
            <a:ext cx="71312" cy="71831"/>
          </a:xfrm>
          <a:prstGeom prst="ellipse">
            <a:avLst/>
          </a:prstGeom>
          <a:solidFill>
            <a:srgbClr val="53B4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sp>
        <p:nvSpPr>
          <p:cNvPr id="175" name="Oval 174">
            <a:extLst>
              <a:ext uri="{FF2B5EF4-FFF2-40B4-BE49-F238E27FC236}">
                <a16:creationId xmlns:a16="http://schemas.microsoft.com/office/drawing/2014/main" id="{1CF14F6C-2F05-DF1E-7535-288D7550072F}"/>
              </a:ext>
            </a:extLst>
          </p:cNvPr>
          <p:cNvSpPr/>
          <p:nvPr/>
        </p:nvSpPr>
        <p:spPr>
          <a:xfrm>
            <a:off x="1618384" y="5794971"/>
            <a:ext cx="68912" cy="72247"/>
          </a:xfrm>
          <a:prstGeom prst="ellipse">
            <a:avLst/>
          </a:prstGeom>
          <a:solidFill>
            <a:srgbClr val="00C094"/>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anose="020B0604020202020204" pitchFamily="34" charset="0"/>
              <a:cs typeface="Helvetica" panose="020B0604020202020204" pitchFamily="34" charset="0"/>
            </a:endParaRPr>
          </a:p>
        </p:txBody>
      </p:sp>
      <p:cxnSp>
        <p:nvCxnSpPr>
          <p:cNvPr id="176" name="Straight Arrow Connector 175">
            <a:extLst>
              <a:ext uri="{FF2B5EF4-FFF2-40B4-BE49-F238E27FC236}">
                <a16:creationId xmlns:a16="http://schemas.microsoft.com/office/drawing/2014/main" id="{E4431499-2DDB-786A-F271-05E6BFEADBA7}"/>
              </a:ext>
            </a:extLst>
          </p:cNvPr>
          <p:cNvCxnSpPr>
            <a:cxnSpLocks/>
          </p:cNvCxnSpPr>
          <p:nvPr/>
        </p:nvCxnSpPr>
        <p:spPr>
          <a:xfrm>
            <a:off x="1120228" y="4513364"/>
            <a:ext cx="668720" cy="0"/>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77" name="Straight Connector 176">
            <a:extLst>
              <a:ext uri="{FF2B5EF4-FFF2-40B4-BE49-F238E27FC236}">
                <a16:creationId xmlns:a16="http://schemas.microsoft.com/office/drawing/2014/main" id="{276DBD47-2625-A74A-D666-D00AC7BD40DE}"/>
              </a:ext>
            </a:extLst>
          </p:cNvPr>
          <p:cNvCxnSpPr>
            <a:cxnSpLocks/>
          </p:cNvCxnSpPr>
          <p:nvPr/>
        </p:nvCxnSpPr>
        <p:spPr>
          <a:xfrm>
            <a:off x="1111316" y="4511459"/>
            <a:ext cx="0" cy="1470780"/>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78" name="Straight Connector 177">
            <a:extLst>
              <a:ext uri="{FF2B5EF4-FFF2-40B4-BE49-F238E27FC236}">
                <a16:creationId xmlns:a16="http://schemas.microsoft.com/office/drawing/2014/main" id="{AA5BA619-00EC-5A69-487B-3EAA442ACF22}"/>
              </a:ext>
            </a:extLst>
          </p:cNvPr>
          <p:cNvCxnSpPr>
            <a:cxnSpLocks/>
            <a:stCxn id="180" idx="1"/>
          </p:cNvCxnSpPr>
          <p:nvPr/>
        </p:nvCxnSpPr>
        <p:spPr>
          <a:xfrm flipH="1">
            <a:off x="1120228" y="5982239"/>
            <a:ext cx="82979" cy="0"/>
          </a:xfrm>
          <a:prstGeom prst="line">
            <a:avLst/>
          </a:prstGeom>
          <a:ln>
            <a:prstDash val="dash"/>
          </a:ln>
        </p:spPr>
        <p:style>
          <a:lnRef idx="1">
            <a:schemeClr val="dk1"/>
          </a:lnRef>
          <a:fillRef idx="0">
            <a:schemeClr val="dk1"/>
          </a:fillRef>
          <a:effectRef idx="0">
            <a:schemeClr val="dk1"/>
          </a:effectRef>
          <a:fontRef idx="minor">
            <a:schemeClr val="tx1"/>
          </a:fontRef>
        </p:style>
      </p:cxnSp>
      <p:grpSp>
        <p:nvGrpSpPr>
          <p:cNvPr id="30" name="Group 29">
            <a:extLst>
              <a:ext uri="{FF2B5EF4-FFF2-40B4-BE49-F238E27FC236}">
                <a16:creationId xmlns:a16="http://schemas.microsoft.com/office/drawing/2014/main" id="{F4291BC0-4CB0-79D3-223D-BB3A31726190}"/>
              </a:ext>
            </a:extLst>
          </p:cNvPr>
          <p:cNvGrpSpPr/>
          <p:nvPr/>
        </p:nvGrpSpPr>
        <p:grpSpPr>
          <a:xfrm>
            <a:off x="4103350" y="7632698"/>
            <a:ext cx="928615" cy="215444"/>
            <a:chOff x="5171051" y="6020185"/>
            <a:chExt cx="928615" cy="215444"/>
          </a:xfrm>
        </p:grpSpPr>
        <p:sp>
          <p:nvSpPr>
            <p:cNvPr id="194" name="Oval 193">
              <a:extLst>
                <a:ext uri="{FF2B5EF4-FFF2-40B4-BE49-F238E27FC236}">
                  <a16:creationId xmlns:a16="http://schemas.microsoft.com/office/drawing/2014/main" id="{F1E4D521-2FB4-7978-BC62-6C75A275DF07}"/>
                </a:ext>
              </a:extLst>
            </p:cNvPr>
            <p:cNvSpPr/>
            <p:nvPr/>
          </p:nvSpPr>
          <p:spPr>
            <a:xfrm>
              <a:off x="5995775" y="6071319"/>
              <a:ext cx="103891" cy="105370"/>
            </a:xfrm>
            <a:prstGeom prst="ellipse">
              <a:avLst/>
            </a:prstGeom>
            <a:solidFill>
              <a:srgbClr val="C49A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500">
                  <a:solidFill>
                    <a:schemeClr val="tx1"/>
                  </a:solidFill>
                  <a:latin typeface="Helvetica" panose="020B0604020202020204" pitchFamily="34" charset="0"/>
                  <a:cs typeface="Helvetica" panose="020B0604020202020204" pitchFamily="34" charset="0"/>
                </a:rPr>
                <a:t>3</a:t>
              </a:r>
            </a:p>
          </p:txBody>
        </p:sp>
        <p:sp>
          <p:nvSpPr>
            <p:cNvPr id="12" name="TextBox 11">
              <a:extLst>
                <a:ext uri="{FF2B5EF4-FFF2-40B4-BE49-F238E27FC236}">
                  <a16:creationId xmlns:a16="http://schemas.microsoft.com/office/drawing/2014/main" id="{2AC9A58C-ED25-F3E1-254A-3BE36BA5018C}"/>
                </a:ext>
              </a:extLst>
            </p:cNvPr>
            <p:cNvSpPr txBox="1"/>
            <p:nvPr/>
          </p:nvSpPr>
          <p:spPr>
            <a:xfrm>
              <a:off x="5171051" y="6020185"/>
              <a:ext cx="881973" cy="215444"/>
            </a:xfrm>
            <a:prstGeom prst="rect">
              <a:avLst/>
            </a:prstGeom>
            <a:noFill/>
          </p:spPr>
          <p:txBody>
            <a:bodyPr wrap="none" rtlCol="0">
              <a:spAutoFit/>
            </a:bodyPr>
            <a:lstStyle/>
            <a:p>
              <a:r>
                <a:rPr lang="en-US" sz="800">
                  <a:latin typeface="Helvetica" panose="020B0604020202020204" pitchFamily="34" charset="0"/>
                  <a:cs typeface="Helvetica" panose="020B0604020202020204" pitchFamily="34" charset="0"/>
                </a:rPr>
                <a:t>Mesophyll cells</a:t>
              </a:r>
            </a:p>
          </p:txBody>
        </p:sp>
      </p:grpSp>
      <p:grpSp>
        <p:nvGrpSpPr>
          <p:cNvPr id="28" name="Group 27">
            <a:extLst>
              <a:ext uri="{FF2B5EF4-FFF2-40B4-BE49-F238E27FC236}">
                <a16:creationId xmlns:a16="http://schemas.microsoft.com/office/drawing/2014/main" id="{3D3DE493-6E2A-3F42-DFD1-7CAC893114FD}"/>
              </a:ext>
            </a:extLst>
          </p:cNvPr>
          <p:cNvGrpSpPr/>
          <p:nvPr/>
        </p:nvGrpSpPr>
        <p:grpSpPr>
          <a:xfrm>
            <a:off x="1465613" y="7620032"/>
            <a:ext cx="1156439" cy="215444"/>
            <a:chOff x="5160147" y="5650747"/>
            <a:chExt cx="1156439" cy="215444"/>
          </a:xfrm>
        </p:grpSpPr>
        <p:sp>
          <p:nvSpPr>
            <p:cNvPr id="193" name="Oval 192">
              <a:extLst>
                <a:ext uri="{FF2B5EF4-FFF2-40B4-BE49-F238E27FC236}">
                  <a16:creationId xmlns:a16="http://schemas.microsoft.com/office/drawing/2014/main" id="{0995AC17-2FDC-F6D8-46FF-9B41444C27F5}"/>
                </a:ext>
              </a:extLst>
            </p:cNvPr>
            <p:cNvSpPr/>
            <p:nvPr/>
          </p:nvSpPr>
          <p:spPr>
            <a:xfrm>
              <a:off x="5995775" y="5705162"/>
              <a:ext cx="103891" cy="105370"/>
            </a:xfrm>
            <a:prstGeom prst="ellipse">
              <a:avLst/>
            </a:prstGeom>
            <a:solidFill>
              <a:srgbClr val="F8766D"/>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500">
                  <a:solidFill>
                    <a:schemeClr val="tx1"/>
                  </a:solidFill>
                  <a:latin typeface="Helvetica" panose="020B0604020202020204" pitchFamily="34" charset="0"/>
                  <a:cs typeface="Helvetica" panose="020B0604020202020204" pitchFamily="34" charset="0"/>
                </a:rPr>
                <a:t>1</a:t>
              </a:r>
            </a:p>
          </p:txBody>
        </p:sp>
        <p:sp>
          <p:nvSpPr>
            <p:cNvPr id="196" name="Oval 195">
              <a:extLst>
                <a:ext uri="{FF2B5EF4-FFF2-40B4-BE49-F238E27FC236}">
                  <a16:creationId xmlns:a16="http://schemas.microsoft.com/office/drawing/2014/main" id="{D7A89E11-7A6E-0633-BD31-C4A26C85DFC3}"/>
                </a:ext>
              </a:extLst>
            </p:cNvPr>
            <p:cNvSpPr/>
            <p:nvPr/>
          </p:nvSpPr>
          <p:spPr>
            <a:xfrm>
              <a:off x="6142525" y="5705162"/>
              <a:ext cx="103891" cy="105370"/>
            </a:xfrm>
            <a:prstGeom prst="ellipse">
              <a:avLst/>
            </a:prstGeom>
            <a:solidFill>
              <a:srgbClr val="00C094"/>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500">
                <a:latin typeface="Helvetica" panose="020B0604020202020204" pitchFamily="34" charset="0"/>
                <a:cs typeface="Helvetica" panose="020B0604020202020204" pitchFamily="34" charset="0"/>
              </a:endParaRPr>
            </a:p>
          </p:txBody>
        </p:sp>
        <p:sp>
          <p:nvSpPr>
            <p:cNvPr id="6" name="TextBox 5">
              <a:extLst>
                <a:ext uri="{FF2B5EF4-FFF2-40B4-BE49-F238E27FC236}">
                  <a16:creationId xmlns:a16="http://schemas.microsoft.com/office/drawing/2014/main" id="{5D17B958-1EE1-0EA3-76AE-6760B4925FC0}"/>
                </a:ext>
              </a:extLst>
            </p:cNvPr>
            <p:cNvSpPr txBox="1"/>
            <p:nvPr/>
          </p:nvSpPr>
          <p:spPr>
            <a:xfrm>
              <a:off x="5160147" y="5650747"/>
              <a:ext cx="881973" cy="215444"/>
            </a:xfrm>
            <a:prstGeom prst="rect">
              <a:avLst/>
            </a:prstGeom>
            <a:noFill/>
          </p:spPr>
          <p:txBody>
            <a:bodyPr wrap="none" rtlCol="0">
              <a:spAutoFit/>
            </a:bodyPr>
            <a:lstStyle/>
            <a:p>
              <a:r>
                <a:rPr lang="en-US" sz="800">
                  <a:latin typeface="Helvetica" panose="020B0604020202020204" pitchFamily="34" charset="0"/>
                  <a:cs typeface="Helvetica" panose="020B0604020202020204" pitchFamily="34" charset="0"/>
                </a:rPr>
                <a:t>Epidermal cells</a:t>
              </a:r>
            </a:p>
          </p:txBody>
        </p:sp>
        <p:sp>
          <p:nvSpPr>
            <p:cNvPr id="13" name="TextBox 12">
              <a:extLst>
                <a:ext uri="{FF2B5EF4-FFF2-40B4-BE49-F238E27FC236}">
                  <a16:creationId xmlns:a16="http://schemas.microsoft.com/office/drawing/2014/main" id="{39823866-0E42-92D4-9B94-88BD0356A152}"/>
                </a:ext>
              </a:extLst>
            </p:cNvPr>
            <p:cNvSpPr txBox="1"/>
            <p:nvPr/>
          </p:nvSpPr>
          <p:spPr>
            <a:xfrm>
              <a:off x="6074212" y="5686426"/>
              <a:ext cx="242374" cy="153888"/>
            </a:xfrm>
            <a:prstGeom prst="rect">
              <a:avLst/>
            </a:prstGeom>
            <a:noFill/>
          </p:spPr>
          <p:txBody>
            <a:bodyPr wrap="none" rtlCol="0">
              <a:spAutoFit/>
            </a:bodyPr>
            <a:lstStyle/>
            <a:p>
              <a:r>
                <a:rPr lang="en-US" sz="400">
                  <a:latin typeface="Helvetica" panose="020B0604020202020204" pitchFamily="34" charset="0"/>
                  <a:cs typeface="Helvetica" panose="020B0604020202020204" pitchFamily="34" charset="0"/>
                </a:rPr>
                <a:t>12</a:t>
              </a:r>
              <a:endParaRPr lang="en-US" sz="1400">
                <a:latin typeface="Helvetica" panose="020B0604020202020204" pitchFamily="34" charset="0"/>
                <a:cs typeface="Helvetica" panose="020B0604020202020204" pitchFamily="34" charset="0"/>
              </a:endParaRPr>
            </a:p>
          </p:txBody>
        </p:sp>
      </p:grpSp>
      <p:grpSp>
        <p:nvGrpSpPr>
          <p:cNvPr id="29" name="Group 28">
            <a:extLst>
              <a:ext uri="{FF2B5EF4-FFF2-40B4-BE49-F238E27FC236}">
                <a16:creationId xmlns:a16="http://schemas.microsoft.com/office/drawing/2014/main" id="{99F9B234-C49B-88EA-6935-0CACED7CAA5D}"/>
              </a:ext>
            </a:extLst>
          </p:cNvPr>
          <p:cNvGrpSpPr/>
          <p:nvPr/>
        </p:nvGrpSpPr>
        <p:grpSpPr>
          <a:xfrm>
            <a:off x="2712599" y="7632516"/>
            <a:ext cx="1310974" cy="215444"/>
            <a:chOff x="5075022" y="5830278"/>
            <a:chExt cx="1310974" cy="215444"/>
          </a:xfrm>
        </p:grpSpPr>
        <p:sp>
          <p:nvSpPr>
            <p:cNvPr id="195" name="Oval 194">
              <a:extLst>
                <a:ext uri="{FF2B5EF4-FFF2-40B4-BE49-F238E27FC236}">
                  <a16:creationId xmlns:a16="http://schemas.microsoft.com/office/drawing/2014/main" id="{63C180AD-5918-BE9B-978C-3559CE315EC5}"/>
                </a:ext>
              </a:extLst>
            </p:cNvPr>
            <p:cNvSpPr/>
            <p:nvPr/>
          </p:nvSpPr>
          <p:spPr>
            <a:xfrm>
              <a:off x="6282105" y="5883178"/>
              <a:ext cx="103891" cy="105370"/>
            </a:xfrm>
            <a:prstGeom prst="ellipse">
              <a:avLst/>
            </a:prstGeom>
            <a:solidFill>
              <a:srgbClr val="53B4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500">
                  <a:solidFill>
                    <a:schemeClr val="tx1"/>
                  </a:solidFill>
                  <a:latin typeface="Helvetica" panose="020B0604020202020204" pitchFamily="34" charset="0"/>
                  <a:cs typeface="Helvetica" panose="020B0604020202020204" pitchFamily="34" charset="0"/>
                </a:rPr>
                <a:t>5</a:t>
              </a:r>
            </a:p>
          </p:txBody>
        </p:sp>
        <p:sp>
          <p:nvSpPr>
            <p:cNvPr id="197" name="Oval 196">
              <a:extLst>
                <a:ext uri="{FF2B5EF4-FFF2-40B4-BE49-F238E27FC236}">
                  <a16:creationId xmlns:a16="http://schemas.microsoft.com/office/drawing/2014/main" id="{6CB0389D-7F5A-1531-928B-8625613722F6}"/>
                </a:ext>
              </a:extLst>
            </p:cNvPr>
            <p:cNvSpPr/>
            <p:nvPr/>
          </p:nvSpPr>
          <p:spPr>
            <a:xfrm>
              <a:off x="5995775" y="5884788"/>
              <a:ext cx="103891" cy="105370"/>
            </a:xfrm>
            <a:prstGeom prst="ellipse">
              <a:avLst/>
            </a:prstGeom>
            <a:solidFill>
              <a:srgbClr val="00B6EB"/>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500">
                  <a:solidFill>
                    <a:schemeClr val="tx1"/>
                  </a:solidFill>
                  <a:latin typeface="Helvetica" panose="020B0604020202020204" pitchFamily="34" charset="0"/>
                  <a:cs typeface="Helvetica" panose="020B0604020202020204" pitchFamily="34" charset="0"/>
                </a:rPr>
                <a:t>9</a:t>
              </a:r>
            </a:p>
          </p:txBody>
        </p:sp>
        <p:sp>
          <p:nvSpPr>
            <p:cNvPr id="198" name="Oval 197">
              <a:extLst>
                <a:ext uri="{FF2B5EF4-FFF2-40B4-BE49-F238E27FC236}">
                  <a16:creationId xmlns:a16="http://schemas.microsoft.com/office/drawing/2014/main" id="{DB2821F2-68FF-5D61-5202-F7912BA6C348}"/>
                </a:ext>
              </a:extLst>
            </p:cNvPr>
            <p:cNvSpPr/>
            <p:nvPr/>
          </p:nvSpPr>
          <p:spPr>
            <a:xfrm>
              <a:off x="6142525" y="5883631"/>
              <a:ext cx="103891" cy="105370"/>
            </a:xfrm>
            <a:prstGeom prst="ellipse">
              <a:avLst/>
            </a:prstGeom>
            <a:solidFill>
              <a:srgbClr val="FB61D7"/>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500">
                <a:latin typeface="Helvetica" panose="020B0604020202020204" pitchFamily="34" charset="0"/>
                <a:cs typeface="Helvetica" panose="020B0604020202020204" pitchFamily="34" charset="0"/>
              </a:endParaRPr>
            </a:p>
          </p:txBody>
        </p:sp>
        <p:sp>
          <p:nvSpPr>
            <p:cNvPr id="7" name="TextBox 6">
              <a:extLst>
                <a:ext uri="{FF2B5EF4-FFF2-40B4-BE49-F238E27FC236}">
                  <a16:creationId xmlns:a16="http://schemas.microsoft.com/office/drawing/2014/main" id="{123621FA-E058-F15D-98C3-361A69F62216}"/>
                </a:ext>
              </a:extLst>
            </p:cNvPr>
            <p:cNvSpPr txBox="1"/>
            <p:nvPr/>
          </p:nvSpPr>
          <p:spPr>
            <a:xfrm>
              <a:off x="5075022" y="5830278"/>
              <a:ext cx="963725" cy="215444"/>
            </a:xfrm>
            <a:prstGeom prst="rect">
              <a:avLst/>
            </a:prstGeom>
            <a:noFill/>
          </p:spPr>
          <p:txBody>
            <a:bodyPr wrap="none" rtlCol="0">
              <a:spAutoFit/>
            </a:bodyPr>
            <a:lstStyle/>
            <a:p>
              <a:r>
                <a:rPr lang="en-US" sz="800">
                  <a:latin typeface="Helvetica" panose="020B0604020202020204" pitchFamily="34" charset="0"/>
                  <a:cs typeface="Helvetica" panose="020B0604020202020204" pitchFamily="34" charset="0"/>
                </a:rPr>
                <a:t>Vasculature cells</a:t>
              </a:r>
            </a:p>
          </p:txBody>
        </p:sp>
        <p:sp>
          <p:nvSpPr>
            <p:cNvPr id="27" name="TextBox 26">
              <a:extLst>
                <a:ext uri="{FF2B5EF4-FFF2-40B4-BE49-F238E27FC236}">
                  <a16:creationId xmlns:a16="http://schemas.microsoft.com/office/drawing/2014/main" id="{D57BCDEF-6E0F-0F5F-A093-225BF252614D}"/>
                </a:ext>
              </a:extLst>
            </p:cNvPr>
            <p:cNvSpPr txBox="1"/>
            <p:nvPr/>
          </p:nvSpPr>
          <p:spPr>
            <a:xfrm>
              <a:off x="6071002" y="5863422"/>
              <a:ext cx="242374" cy="153888"/>
            </a:xfrm>
            <a:prstGeom prst="rect">
              <a:avLst/>
            </a:prstGeom>
            <a:noFill/>
          </p:spPr>
          <p:txBody>
            <a:bodyPr wrap="none" rtlCol="0">
              <a:spAutoFit/>
            </a:bodyPr>
            <a:lstStyle/>
            <a:p>
              <a:r>
                <a:rPr lang="en-US" sz="400">
                  <a:latin typeface="Helvetica" panose="020B0604020202020204" pitchFamily="34" charset="0"/>
                  <a:cs typeface="Helvetica" panose="020B0604020202020204" pitchFamily="34" charset="0"/>
                </a:rPr>
                <a:t>10</a:t>
              </a:r>
              <a:endParaRPr lang="en-US" sz="1400">
                <a:latin typeface="Helvetica" panose="020B0604020202020204" pitchFamily="34" charset="0"/>
                <a:cs typeface="Helvetica" panose="020B0604020202020204" pitchFamily="34" charset="0"/>
              </a:endParaRPr>
            </a:p>
          </p:txBody>
        </p:sp>
      </p:grpSp>
      <p:pic>
        <p:nvPicPr>
          <p:cNvPr id="44" name="Picture 43">
            <a:extLst>
              <a:ext uri="{FF2B5EF4-FFF2-40B4-BE49-F238E27FC236}">
                <a16:creationId xmlns:a16="http://schemas.microsoft.com/office/drawing/2014/main" id="{A9781AED-3489-1DC9-E3FE-B9A63D310D4C}"/>
              </a:ext>
            </a:extLst>
          </p:cNvPr>
          <p:cNvPicPr>
            <a:picLocks noChangeAspect="1"/>
          </p:cNvPicPr>
          <p:nvPr/>
        </p:nvPicPr>
        <p:blipFill rotWithShape="1">
          <a:blip r:embed="rId2">
            <a:extLst>
              <a:ext uri="{28A0092B-C50C-407E-A947-70E740481C1C}">
                <a14:useLocalDpi xmlns:a14="http://schemas.microsoft.com/office/drawing/2010/main" val="0"/>
              </a:ext>
            </a:extLst>
          </a:blip>
          <a:srcRect b="5912"/>
          <a:stretch/>
        </p:blipFill>
        <p:spPr>
          <a:xfrm>
            <a:off x="3457230" y="187427"/>
            <a:ext cx="3241238" cy="2868451"/>
          </a:xfrm>
          <a:prstGeom prst="rect">
            <a:avLst/>
          </a:prstGeom>
        </p:spPr>
      </p:pic>
      <p:pic>
        <p:nvPicPr>
          <p:cNvPr id="10" name="Picture 9">
            <a:extLst>
              <a:ext uri="{FF2B5EF4-FFF2-40B4-BE49-F238E27FC236}">
                <a16:creationId xmlns:a16="http://schemas.microsoft.com/office/drawing/2014/main" id="{878DA4FE-FB76-4218-281C-4E9185D94F6A}"/>
              </a:ext>
            </a:extLst>
          </p:cNvPr>
          <p:cNvPicPr>
            <a:picLocks noChangeAspect="1"/>
          </p:cNvPicPr>
          <p:nvPr/>
        </p:nvPicPr>
        <p:blipFill>
          <a:blip r:embed="rId3"/>
          <a:stretch>
            <a:fillRect/>
          </a:stretch>
        </p:blipFill>
        <p:spPr>
          <a:xfrm>
            <a:off x="2224042" y="2949114"/>
            <a:ext cx="2346647" cy="333409"/>
          </a:xfrm>
          <a:prstGeom prst="rect">
            <a:avLst/>
          </a:prstGeom>
        </p:spPr>
      </p:pic>
      <p:pic>
        <p:nvPicPr>
          <p:cNvPr id="5" name="Picture 4">
            <a:extLst>
              <a:ext uri="{FF2B5EF4-FFF2-40B4-BE49-F238E27FC236}">
                <a16:creationId xmlns:a16="http://schemas.microsoft.com/office/drawing/2014/main" id="{67BA1CDC-EEFE-AD8C-D3DF-F549A0719965}"/>
              </a:ext>
            </a:extLst>
          </p:cNvPr>
          <p:cNvPicPr>
            <a:picLocks noChangeAspect="1"/>
          </p:cNvPicPr>
          <p:nvPr/>
        </p:nvPicPr>
        <p:blipFill rotWithShape="1">
          <a:blip r:embed="rId4">
            <a:extLst>
              <a:ext uri="{28A0092B-C50C-407E-A947-70E740481C1C}">
                <a14:useLocalDpi xmlns:a14="http://schemas.microsoft.com/office/drawing/2010/main" val="0"/>
              </a:ext>
            </a:extLst>
          </a:blip>
          <a:srcRect l="6890" t="924" r="1332" b="8600"/>
          <a:stretch/>
        </p:blipFill>
        <p:spPr>
          <a:xfrm>
            <a:off x="221995" y="237472"/>
            <a:ext cx="3103813" cy="2862953"/>
          </a:xfrm>
          <a:prstGeom prst="rect">
            <a:avLst/>
          </a:prstGeom>
        </p:spPr>
      </p:pic>
      <p:sp>
        <p:nvSpPr>
          <p:cNvPr id="11" name="Rectangle 10">
            <a:extLst>
              <a:ext uri="{FF2B5EF4-FFF2-40B4-BE49-F238E27FC236}">
                <a16:creationId xmlns:a16="http://schemas.microsoft.com/office/drawing/2014/main" id="{8CC0804C-C58D-8565-0819-AE4128730A64}"/>
              </a:ext>
            </a:extLst>
          </p:cNvPr>
          <p:cNvSpPr/>
          <p:nvPr/>
        </p:nvSpPr>
        <p:spPr>
          <a:xfrm>
            <a:off x="129008" y="237472"/>
            <a:ext cx="498238" cy="216627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i="1">
              <a:latin typeface="Helvetica" panose="020B0604020202020204" pitchFamily="34" charset="0"/>
              <a:cs typeface="Helvetica" panose="020B0604020202020204" pitchFamily="34" charset="0"/>
            </a:endParaRPr>
          </a:p>
        </p:txBody>
      </p:sp>
      <p:sp>
        <p:nvSpPr>
          <p:cNvPr id="14" name="Rectangle 13">
            <a:extLst>
              <a:ext uri="{FF2B5EF4-FFF2-40B4-BE49-F238E27FC236}">
                <a16:creationId xmlns:a16="http://schemas.microsoft.com/office/drawing/2014/main" id="{0BEC45F6-919B-5ED4-8982-07CE55AFA23B}"/>
              </a:ext>
            </a:extLst>
          </p:cNvPr>
          <p:cNvSpPr/>
          <p:nvPr/>
        </p:nvSpPr>
        <p:spPr>
          <a:xfrm>
            <a:off x="3451972" y="205134"/>
            <a:ext cx="591844" cy="221300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i="1">
              <a:latin typeface="Helvetica" panose="020B0604020202020204" pitchFamily="34" charset="0"/>
              <a:cs typeface="Helvetica" panose="020B0604020202020204" pitchFamily="34" charset="0"/>
            </a:endParaRPr>
          </a:p>
        </p:txBody>
      </p:sp>
      <p:sp>
        <p:nvSpPr>
          <p:cNvPr id="17" name="TextBox 16">
            <a:extLst>
              <a:ext uri="{FF2B5EF4-FFF2-40B4-BE49-F238E27FC236}">
                <a16:creationId xmlns:a16="http://schemas.microsoft.com/office/drawing/2014/main" id="{447966F1-473C-AEFB-276D-3B1100CFCB7F}"/>
              </a:ext>
            </a:extLst>
          </p:cNvPr>
          <p:cNvSpPr txBox="1"/>
          <p:nvPr/>
        </p:nvSpPr>
        <p:spPr>
          <a:xfrm>
            <a:off x="179186" y="320560"/>
            <a:ext cx="536648"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PAD4</a:t>
            </a:r>
            <a:r>
              <a:rPr lang="en-US" sz="600" i="1">
                <a:latin typeface="Helvetica" panose="020B0604020202020204" pitchFamily="34" charset="0"/>
                <a:cs typeface="Helvetica" panose="020B0604020202020204" pitchFamily="34" charset="0"/>
              </a:rPr>
              <a:t> </a:t>
            </a:r>
          </a:p>
        </p:txBody>
      </p:sp>
      <p:sp>
        <p:nvSpPr>
          <p:cNvPr id="18" name="TextBox 17">
            <a:extLst>
              <a:ext uri="{FF2B5EF4-FFF2-40B4-BE49-F238E27FC236}">
                <a16:creationId xmlns:a16="http://schemas.microsoft.com/office/drawing/2014/main" id="{C415C4D6-C72F-294C-AEB6-1B0B5D38AFF3}"/>
              </a:ext>
            </a:extLst>
          </p:cNvPr>
          <p:cNvSpPr txBox="1"/>
          <p:nvPr/>
        </p:nvSpPr>
        <p:spPr>
          <a:xfrm>
            <a:off x="78916" y="604615"/>
            <a:ext cx="691126" cy="184666"/>
          </a:xfrm>
          <a:prstGeom prst="rect">
            <a:avLst/>
          </a:prstGeom>
          <a:noFill/>
        </p:spPr>
        <p:txBody>
          <a:bodyPr wrap="square">
            <a:spAutoFit/>
          </a:bodyPr>
          <a:lstStyle/>
          <a:p>
            <a:r>
              <a:rPr lang="en-US" sz="600" b="0" i="1" u="none" strike="noStrike" dirty="0">
                <a:solidFill>
                  <a:srgbClr val="000000"/>
                </a:solidFill>
                <a:effectLst/>
                <a:latin typeface="Helvetica" panose="020B0604020202020204" pitchFamily="34" charset="0"/>
                <a:cs typeface="Helvetica" panose="020B0604020202020204" pitchFamily="34" charset="0"/>
              </a:rPr>
              <a:t>GmSARD1a</a:t>
            </a:r>
            <a:r>
              <a:rPr lang="en-US" sz="600" i="1" dirty="0">
                <a:latin typeface="Helvetica" panose="020B0604020202020204" pitchFamily="34" charset="0"/>
                <a:cs typeface="Helvetica" panose="020B0604020202020204" pitchFamily="34" charset="0"/>
              </a:rPr>
              <a:t> </a:t>
            </a:r>
          </a:p>
        </p:txBody>
      </p:sp>
      <p:sp>
        <p:nvSpPr>
          <p:cNvPr id="19" name="TextBox 18">
            <a:extLst>
              <a:ext uri="{FF2B5EF4-FFF2-40B4-BE49-F238E27FC236}">
                <a16:creationId xmlns:a16="http://schemas.microsoft.com/office/drawing/2014/main" id="{8955DEA9-AD69-6D12-A5D2-F6AD4D7542C9}"/>
              </a:ext>
            </a:extLst>
          </p:cNvPr>
          <p:cNvSpPr txBox="1"/>
          <p:nvPr/>
        </p:nvSpPr>
        <p:spPr>
          <a:xfrm>
            <a:off x="78442" y="740620"/>
            <a:ext cx="691126"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SARD1b</a:t>
            </a:r>
            <a:r>
              <a:rPr lang="en-US" sz="600" i="1">
                <a:latin typeface="Helvetica" panose="020B0604020202020204" pitchFamily="34" charset="0"/>
                <a:cs typeface="Helvetica" panose="020B0604020202020204" pitchFamily="34" charset="0"/>
              </a:rPr>
              <a:t> </a:t>
            </a:r>
          </a:p>
        </p:txBody>
      </p:sp>
      <p:sp>
        <p:nvSpPr>
          <p:cNvPr id="20" name="TextBox 19">
            <a:extLst>
              <a:ext uri="{FF2B5EF4-FFF2-40B4-BE49-F238E27FC236}">
                <a16:creationId xmlns:a16="http://schemas.microsoft.com/office/drawing/2014/main" id="{944C9719-4B31-8FD3-89CA-2C18C7858077}"/>
              </a:ext>
            </a:extLst>
          </p:cNvPr>
          <p:cNvSpPr txBox="1"/>
          <p:nvPr/>
        </p:nvSpPr>
        <p:spPr>
          <a:xfrm>
            <a:off x="65245" y="1050761"/>
            <a:ext cx="691126"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WRKY40</a:t>
            </a:r>
            <a:r>
              <a:rPr lang="en-US" sz="600" i="1">
                <a:latin typeface="Helvetica" panose="020B0604020202020204" pitchFamily="34" charset="0"/>
                <a:cs typeface="Helvetica" panose="020B0604020202020204" pitchFamily="34" charset="0"/>
              </a:rPr>
              <a:t> </a:t>
            </a:r>
          </a:p>
        </p:txBody>
      </p:sp>
      <p:sp>
        <p:nvSpPr>
          <p:cNvPr id="21" name="TextBox 20">
            <a:extLst>
              <a:ext uri="{FF2B5EF4-FFF2-40B4-BE49-F238E27FC236}">
                <a16:creationId xmlns:a16="http://schemas.microsoft.com/office/drawing/2014/main" id="{6C062BE2-F528-40C1-6AE7-EB44D8354782}"/>
              </a:ext>
            </a:extLst>
          </p:cNvPr>
          <p:cNvSpPr txBox="1"/>
          <p:nvPr/>
        </p:nvSpPr>
        <p:spPr>
          <a:xfrm>
            <a:off x="208358" y="1354916"/>
            <a:ext cx="498238"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ICS1</a:t>
            </a:r>
            <a:r>
              <a:rPr lang="en-US" sz="600" i="1">
                <a:latin typeface="Helvetica" panose="020B0604020202020204" pitchFamily="34" charset="0"/>
                <a:cs typeface="Helvetica" panose="020B0604020202020204" pitchFamily="34" charset="0"/>
              </a:rPr>
              <a:t> </a:t>
            </a:r>
          </a:p>
        </p:txBody>
      </p:sp>
      <p:sp>
        <p:nvSpPr>
          <p:cNvPr id="22" name="TextBox 21">
            <a:extLst>
              <a:ext uri="{FF2B5EF4-FFF2-40B4-BE49-F238E27FC236}">
                <a16:creationId xmlns:a16="http://schemas.microsoft.com/office/drawing/2014/main" id="{4EF055B9-3139-1580-6A88-CD9C82F73064}"/>
              </a:ext>
            </a:extLst>
          </p:cNvPr>
          <p:cNvSpPr txBox="1"/>
          <p:nvPr/>
        </p:nvSpPr>
        <p:spPr>
          <a:xfrm>
            <a:off x="208079" y="1474559"/>
            <a:ext cx="498238"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ICS2</a:t>
            </a:r>
            <a:r>
              <a:rPr lang="en-US" sz="600" i="1">
                <a:latin typeface="Helvetica" panose="020B0604020202020204" pitchFamily="34" charset="0"/>
                <a:cs typeface="Helvetica" panose="020B0604020202020204" pitchFamily="34" charset="0"/>
              </a:rPr>
              <a:t> </a:t>
            </a:r>
          </a:p>
        </p:txBody>
      </p:sp>
      <p:sp>
        <p:nvSpPr>
          <p:cNvPr id="23" name="TextBox 22">
            <a:extLst>
              <a:ext uri="{FF2B5EF4-FFF2-40B4-BE49-F238E27FC236}">
                <a16:creationId xmlns:a16="http://schemas.microsoft.com/office/drawing/2014/main" id="{AF58460E-B6DE-4C5D-BE0B-15D33B3C9924}"/>
              </a:ext>
            </a:extLst>
          </p:cNvPr>
          <p:cNvSpPr txBox="1"/>
          <p:nvPr/>
        </p:nvSpPr>
        <p:spPr>
          <a:xfrm>
            <a:off x="193664" y="1710571"/>
            <a:ext cx="498238"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PAL1</a:t>
            </a:r>
            <a:endParaRPr lang="en-US" sz="600" i="1">
              <a:latin typeface="Helvetica" panose="020B0604020202020204" pitchFamily="34" charset="0"/>
              <a:cs typeface="Helvetica" panose="020B0604020202020204" pitchFamily="34" charset="0"/>
            </a:endParaRPr>
          </a:p>
        </p:txBody>
      </p:sp>
      <p:sp>
        <p:nvSpPr>
          <p:cNvPr id="34" name="TextBox 33">
            <a:extLst>
              <a:ext uri="{FF2B5EF4-FFF2-40B4-BE49-F238E27FC236}">
                <a16:creationId xmlns:a16="http://schemas.microsoft.com/office/drawing/2014/main" id="{FAFBD998-8BE6-2779-A011-60DE9DC1B3DC}"/>
              </a:ext>
            </a:extLst>
          </p:cNvPr>
          <p:cNvSpPr txBox="1"/>
          <p:nvPr/>
        </p:nvSpPr>
        <p:spPr>
          <a:xfrm>
            <a:off x="193664" y="1851273"/>
            <a:ext cx="498238"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PAL2</a:t>
            </a:r>
            <a:endParaRPr lang="en-US" sz="600" i="1">
              <a:latin typeface="Helvetica" panose="020B0604020202020204" pitchFamily="34" charset="0"/>
              <a:cs typeface="Helvetica" panose="020B0604020202020204" pitchFamily="34" charset="0"/>
            </a:endParaRPr>
          </a:p>
        </p:txBody>
      </p:sp>
      <p:sp>
        <p:nvSpPr>
          <p:cNvPr id="35" name="TextBox 34">
            <a:extLst>
              <a:ext uri="{FF2B5EF4-FFF2-40B4-BE49-F238E27FC236}">
                <a16:creationId xmlns:a16="http://schemas.microsoft.com/office/drawing/2014/main" id="{C3A9FB89-5E86-173D-D67C-10506CCB5D4A}"/>
              </a:ext>
            </a:extLst>
          </p:cNvPr>
          <p:cNvSpPr txBox="1"/>
          <p:nvPr/>
        </p:nvSpPr>
        <p:spPr>
          <a:xfrm>
            <a:off x="174622" y="2147688"/>
            <a:ext cx="536322"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MES1</a:t>
            </a:r>
            <a:endParaRPr lang="en-US" sz="600" i="1">
              <a:latin typeface="Helvetica" panose="020B0604020202020204" pitchFamily="34" charset="0"/>
              <a:cs typeface="Helvetica" panose="020B0604020202020204" pitchFamily="34" charset="0"/>
            </a:endParaRPr>
          </a:p>
        </p:txBody>
      </p:sp>
      <p:sp>
        <p:nvSpPr>
          <p:cNvPr id="36" name="TextBox 35">
            <a:extLst>
              <a:ext uri="{FF2B5EF4-FFF2-40B4-BE49-F238E27FC236}">
                <a16:creationId xmlns:a16="http://schemas.microsoft.com/office/drawing/2014/main" id="{99078F0F-D8C7-9509-5AA3-395892F1249F}"/>
              </a:ext>
            </a:extLst>
          </p:cNvPr>
          <p:cNvSpPr txBox="1"/>
          <p:nvPr/>
        </p:nvSpPr>
        <p:spPr>
          <a:xfrm>
            <a:off x="3497919" y="1485895"/>
            <a:ext cx="622793"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WRKY70</a:t>
            </a:r>
            <a:endParaRPr lang="en-US" sz="600" i="1">
              <a:latin typeface="Helvetica" panose="020B0604020202020204" pitchFamily="34" charset="0"/>
              <a:cs typeface="Helvetica" panose="020B0604020202020204" pitchFamily="34" charset="0"/>
            </a:endParaRPr>
          </a:p>
        </p:txBody>
      </p:sp>
      <p:sp>
        <p:nvSpPr>
          <p:cNvPr id="37" name="TextBox 36">
            <a:extLst>
              <a:ext uri="{FF2B5EF4-FFF2-40B4-BE49-F238E27FC236}">
                <a16:creationId xmlns:a16="http://schemas.microsoft.com/office/drawing/2014/main" id="{F7820877-798A-BF31-5206-FEE89DACD1A6}"/>
              </a:ext>
            </a:extLst>
          </p:cNvPr>
          <p:cNvSpPr txBox="1"/>
          <p:nvPr/>
        </p:nvSpPr>
        <p:spPr>
          <a:xfrm>
            <a:off x="3622128" y="1876793"/>
            <a:ext cx="536322"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PR1a</a:t>
            </a:r>
            <a:endParaRPr lang="en-US" sz="600" i="1">
              <a:latin typeface="Helvetica" panose="020B0604020202020204" pitchFamily="34" charset="0"/>
              <a:cs typeface="Helvetica" panose="020B0604020202020204" pitchFamily="34" charset="0"/>
            </a:endParaRPr>
          </a:p>
        </p:txBody>
      </p:sp>
      <p:sp>
        <p:nvSpPr>
          <p:cNvPr id="38" name="TextBox 37">
            <a:extLst>
              <a:ext uri="{FF2B5EF4-FFF2-40B4-BE49-F238E27FC236}">
                <a16:creationId xmlns:a16="http://schemas.microsoft.com/office/drawing/2014/main" id="{709FC594-9532-6634-2186-9F66211AE1F7}"/>
              </a:ext>
            </a:extLst>
          </p:cNvPr>
          <p:cNvSpPr txBox="1"/>
          <p:nvPr/>
        </p:nvSpPr>
        <p:spPr>
          <a:xfrm>
            <a:off x="3625270" y="2046639"/>
            <a:ext cx="536322"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PR1b</a:t>
            </a:r>
            <a:endParaRPr lang="en-US" sz="600" i="1">
              <a:latin typeface="Helvetica" panose="020B0604020202020204" pitchFamily="34" charset="0"/>
              <a:cs typeface="Helvetica" panose="020B0604020202020204" pitchFamily="34" charset="0"/>
            </a:endParaRPr>
          </a:p>
        </p:txBody>
      </p:sp>
      <p:sp>
        <p:nvSpPr>
          <p:cNvPr id="39" name="TextBox 38">
            <a:extLst>
              <a:ext uri="{FF2B5EF4-FFF2-40B4-BE49-F238E27FC236}">
                <a16:creationId xmlns:a16="http://schemas.microsoft.com/office/drawing/2014/main" id="{C6354B1A-3D7E-2793-B296-A00940812151}"/>
              </a:ext>
            </a:extLst>
          </p:cNvPr>
          <p:cNvSpPr txBox="1"/>
          <p:nvPr/>
        </p:nvSpPr>
        <p:spPr>
          <a:xfrm>
            <a:off x="3629860" y="2192173"/>
            <a:ext cx="536322"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PR1c</a:t>
            </a:r>
            <a:endParaRPr lang="en-US" sz="600" i="1">
              <a:latin typeface="Helvetica" panose="020B0604020202020204" pitchFamily="34" charset="0"/>
              <a:cs typeface="Helvetica" panose="020B0604020202020204" pitchFamily="34" charset="0"/>
            </a:endParaRPr>
          </a:p>
        </p:txBody>
      </p:sp>
      <p:sp>
        <p:nvSpPr>
          <p:cNvPr id="40" name="TextBox 39">
            <a:extLst>
              <a:ext uri="{FF2B5EF4-FFF2-40B4-BE49-F238E27FC236}">
                <a16:creationId xmlns:a16="http://schemas.microsoft.com/office/drawing/2014/main" id="{7AD1DEDE-1212-2E0B-7FFF-B0ECA8E8EB8C}"/>
              </a:ext>
            </a:extLst>
          </p:cNvPr>
          <p:cNvSpPr txBox="1"/>
          <p:nvPr/>
        </p:nvSpPr>
        <p:spPr>
          <a:xfrm>
            <a:off x="3562635" y="243418"/>
            <a:ext cx="591844" cy="184666"/>
          </a:xfrm>
          <a:prstGeom prst="rect">
            <a:avLst/>
          </a:prstGeom>
          <a:noFill/>
        </p:spPr>
        <p:txBody>
          <a:bodyPr wrap="square">
            <a:spAutoFit/>
          </a:bodyPr>
          <a:lstStyle/>
          <a:p>
            <a:r>
              <a:rPr lang="en-US" sz="600" b="0" i="1" u="none" strike="noStrike" dirty="0">
                <a:solidFill>
                  <a:srgbClr val="000000"/>
                </a:solidFill>
                <a:effectLst/>
                <a:latin typeface="Helvetica" panose="020B0604020202020204" pitchFamily="34" charset="0"/>
                <a:cs typeface="Helvetica" panose="020B0604020202020204" pitchFamily="34" charset="0"/>
              </a:rPr>
              <a:t>GmNPR3a</a:t>
            </a:r>
            <a:endParaRPr lang="en-US" sz="600" i="1" dirty="0">
              <a:latin typeface="Helvetica" panose="020B0604020202020204" pitchFamily="34" charset="0"/>
              <a:cs typeface="Helvetica" panose="020B0604020202020204" pitchFamily="34" charset="0"/>
            </a:endParaRPr>
          </a:p>
        </p:txBody>
      </p:sp>
      <p:sp>
        <p:nvSpPr>
          <p:cNvPr id="41" name="TextBox 40">
            <a:extLst>
              <a:ext uri="{FF2B5EF4-FFF2-40B4-BE49-F238E27FC236}">
                <a16:creationId xmlns:a16="http://schemas.microsoft.com/office/drawing/2014/main" id="{141E5450-3917-22B2-B21F-B9D069AA22BE}"/>
              </a:ext>
            </a:extLst>
          </p:cNvPr>
          <p:cNvSpPr txBox="1"/>
          <p:nvPr/>
        </p:nvSpPr>
        <p:spPr>
          <a:xfrm>
            <a:off x="3572026" y="551451"/>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NPR3c</a:t>
            </a:r>
            <a:endParaRPr lang="en-US" sz="600" i="1">
              <a:latin typeface="Helvetica" panose="020B0604020202020204" pitchFamily="34" charset="0"/>
              <a:cs typeface="Helvetica" panose="020B0604020202020204" pitchFamily="34" charset="0"/>
            </a:endParaRPr>
          </a:p>
        </p:txBody>
      </p:sp>
      <p:sp>
        <p:nvSpPr>
          <p:cNvPr id="42" name="TextBox 41">
            <a:extLst>
              <a:ext uri="{FF2B5EF4-FFF2-40B4-BE49-F238E27FC236}">
                <a16:creationId xmlns:a16="http://schemas.microsoft.com/office/drawing/2014/main" id="{E3E8A54A-32AF-E185-F0C8-8AE13780008A}"/>
              </a:ext>
            </a:extLst>
          </p:cNvPr>
          <p:cNvSpPr txBox="1"/>
          <p:nvPr/>
        </p:nvSpPr>
        <p:spPr>
          <a:xfrm>
            <a:off x="3572026" y="392571"/>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NPR3b</a:t>
            </a:r>
            <a:endParaRPr lang="en-US" sz="600" i="1">
              <a:latin typeface="Helvetica" panose="020B0604020202020204" pitchFamily="34" charset="0"/>
              <a:cs typeface="Helvetica" panose="020B0604020202020204" pitchFamily="34" charset="0"/>
            </a:endParaRPr>
          </a:p>
        </p:txBody>
      </p:sp>
      <p:sp>
        <p:nvSpPr>
          <p:cNvPr id="43" name="TextBox 42">
            <a:extLst>
              <a:ext uri="{FF2B5EF4-FFF2-40B4-BE49-F238E27FC236}">
                <a16:creationId xmlns:a16="http://schemas.microsoft.com/office/drawing/2014/main" id="{68884778-9AA0-6DB5-2A40-E501E0E8ED61}"/>
              </a:ext>
            </a:extLst>
          </p:cNvPr>
          <p:cNvSpPr txBox="1"/>
          <p:nvPr/>
        </p:nvSpPr>
        <p:spPr>
          <a:xfrm>
            <a:off x="3574449" y="707518"/>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2a</a:t>
            </a:r>
            <a:endParaRPr lang="en-US" sz="600" i="1">
              <a:latin typeface="Helvetica" panose="020B0604020202020204" pitchFamily="34" charset="0"/>
              <a:cs typeface="Helvetica" panose="020B0604020202020204" pitchFamily="34" charset="0"/>
            </a:endParaRPr>
          </a:p>
        </p:txBody>
      </p:sp>
      <p:sp>
        <p:nvSpPr>
          <p:cNvPr id="45" name="TextBox 44">
            <a:extLst>
              <a:ext uri="{FF2B5EF4-FFF2-40B4-BE49-F238E27FC236}">
                <a16:creationId xmlns:a16="http://schemas.microsoft.com/office/drawing/2014/main" id="{383EE8E3-DD5D-AEE8-D3F0-71D1CFCBBFCE}"/>
              </a:ext>
            </a:extLst>
          </p:cNvPr>
          <p:cNvSpPr txBox="1"/>
          <p:nvPr/>
        </p:nvSpPr>
        <p:spPr>
          <a:xfrm>
            <a:off x="3572362" y="772193"/>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2b</a:t>
            </a:r>
            <a:endParaRPr lang="en-US" sz="600" i="1">
              <a:latin typeface="Helvetica" panose="020B0604020202020204" pitchFamily="34" charset="0"/>
              <a:cs typeface="Helvetica" panose="020B0604020202020204" pitchFamily="34" charset="0"/>
            </a:endParaRPr>
          </a:p>
        </p:txBody>
      </p:sp>
      <p:sp>
        <p:nvSpPr>
          <p:cNvPr id="46" name="TextBox 45">
            <a:extLst>
              <a:ext uri="{FF2B5EF4-FFF2-40B4-BE49-F238E27FC236}">
                <a16:creationId xmlns:a16="http://schemas.microsoft.com/office/drawing/2014/main" id="{2CBAFBF7-13A2-5347-B1A6-440A099F4BCC}"/>
              </a:ext>
            </a:extLst>
          </p:cNvPr>
          <p:cNvSpPr txBox="1"/>
          <p:nvPr/>
        </p:nvSpPr>
        <p:spPr>
          <a:xfrm>
            <a:off x="3571649" y="840153"/>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2c</a:t>
            </a:r>
            <a:endParaRPr lang="en-US" sz="600" i="1">
              <a:latin typeface="Helvetica" panose="020B0604020202020204" pitchFamily="34" charset="0"/>
              <a:cs typeface="Helvetica" panose="020B0604020202020204" pitchFamily="34" charset="0"/>
            </a:endParaRPr>
          </a:p>
        </p:txBody>
      </p:sp>
      <p:sp>
        <p:nvSpPr>
          <p:cNvPr id="47" name="TextBox 46">
            <a:extLst>
              <a:ext uri="{FF2B5EF4-FFF2-40B4-BE49-F238E27FC236}">
                <a16:creationId xmlns:a16="http://schemas.microsoft.com/office/drawing/2014/main" id="{4DBDEFDC-A96A-DC15-A973-45E469764A2B}"/>
              </a:ext>
            </a:extLst>
          </p:cNvPr>
          <p:cNvSpPr txBox="1"/>
          <p:nvPr/>
        </p:nvSpPr>
        <p:spPr>
          <a:xfrm>
            <a:off x="3571649" y="903097"/>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3a</a:t>
            </a:r>
            <a:endParaRPr lang="en-US" sz="600" i="1">
              <a:latin typeface="Helvetica" panose="020B0604020202020204" pitchFamily="34" charset="0"/>
              <a:cs typeface="Helvetica" panose="020B0604020202020204" pitchFamily="34" charset="0"/>
            </a:endParaRPr>
          </a:p>
        </p:txBody>
      </p:sp>
      <p:sp>
        <p:nvSpPr>
          <p:cNvPr id="59" name="TextBox 58">
            <a:extLst>
              <a:ext uri="{FF2B5EF4-FFF2-40B4-BE49-F238E27FC236}">
                <a16:creationId xmlns:a16="http://schemas.microsoft.com/office/drawing/2014/main" id="{B69D8266-F48A-E479-352B-74E5C3C031AF}"/>
              </a:ext>
            </a:extLst>
          </p:cNvPr>
          <p:cNvSpPr txBox="1"/>
          <p:nvPr/>
        </p:nvSpPr>
        <p:spPr>
          <a:xfrm>
            <a:off x="3571649" y="967668"/>
            <a:ext cx="591844" cy="184666"/>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3b</a:t>
            </a:r>
            <a:endParaRPr lang="en-US" sz="600" i="1">
              <a:latin typeface="Helvetica" panose="020B0604020202020204" pitchFamily="34" charset="0"/>
              <a:cs typeface="Helvetica" panose="020B0604020202020204" pitchFamily="34" charset="0"/>
            </a:endParaRPr>
          </a:p>
        </p:txBody>
      </p:sp>
      <p:sp>
        <p:nvSpPr>
          <p:cNvPr id="62" name="TextBox 61">
            <a:extLst>
              <a:ext uri="{FF2B5EF4-FFF2-40B4-BE49-F238E27FC236}">
                <a16:creationId xmlns:a16="http://schemas.microsoft.com/office/drawing/2014/main" id="{55969B5E-C7A9-22E9-5E9B-024D2E37E2E9}"/>
              </a:ext>
            </a:extLst>
          </p:cNvPr>
          <p:cNvSpPr txBox="1"/>
          <p:nvPr/>
        </p:nvSpPr>
        <p:spPr>
          <a:xfrm>
            <a:off x="3617599" y="1027564"/>
            <a:ext cx="591844" cy="190068"/>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4</a:t>
            </a:r>
            <a:endParaRPr lang="en-US" sz="600" i="1">
              <a:latin typeface="Helvetica" panose="020B0604020202020204" pitchFamily="34" charset="0"/>
              <a:cs typeface="Helvetica" panose="020B0604020202020204" pitchFamily="34" charset="0"/>
            </a:endParaRPr>
          </a:p>
        </p:txBody>
      </p:sp>
      <p:sp>
        <p:nvSpPr>
          <p:cNvPr id="68" name="TextBox 67">
            <a:extLst>
              <a:ext uri="{FF2B5EF4-FFF2-40B4-BE49-F238E27FC236}">
                <a16:creationId xmlns:a16="http://schemas.microsoft.com/office/drawing/2014/main" id="{41D3BC48-3653-6BB1-DCFC-EA8CB476F8D1}"/>
              </a:ext>
            </a:extLst>
          </p:cNvPr>
          <p:cNvSpPr txBox="1"/>
          <p:nvPr/>
        </p:nvSpPr>
        <p:spPr>
          <a:xfrm>
            <a:off x="3617599" y="1087303"/>
            <a:ext cx="591844" cy="190068"/>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5</a:t>
            </a:r>
            <a:endParaRPr lang="en-US" sz="600" i="1">
              <a:latin typeface="Helvetica" panose="020B0604020202020204" pitchFamily="34" charset="0"/>
              <a:cs typeface="Helvetica" panose="020B0604020202020204" pitchFamily="34" charset="0"/>
            </a:endParaRPr>
          </a:p>
        </p:txBody>
      </p:sp>
      <p:sp>
        <p:nvSpPr>
          <p:cNvPr id="72" name="TextBox 71">
            <a:extLst>
              <a:ext uri="{FF2B5EF4-FFF2-40B4-BE49-F238E27FC236}">
                <a16:creationId xmlns:a16="http://schemas.microsoft.com/office/drawing/2014/main" id="{92061860-2EAF-B105-B181-23F50AE89B59}"/>
              </a:ext>
            </a:extLst>
          </p:cNvPr>
          <p:cNvSpPr txBox="1"/>
          <p:nvPr/>
        </p:nvSpPr>
        <p:spPr>
          <a:xfrm>
            <a:off x="3618157" y="1152622"/>
            <a:ext cx="591844" cy="190068"/>
          </a:xfrm>
          <a:prstGeom prst="rect">
            <a:avLst/>
          </a:prstGeom>
          <a:noFill/>
        </p:spPr>
        <p:txBody>
          <a:bodyPr wrap="square">
            <a:spAutoFit/>
          </a:bodyPr>
          <a:lstStyle/>
          <a:p>
            <a:r>
              <a:rPr lang="en-US" sz="600" b="0" i="1" u="none" strike="noStrike">
                <a:solidFill>
                  <a:srgbClr val="000000"/>
                </a:solidFill>
                <a:effectLst/>
                <a:latin typeface="Helvetica" panose="020B0604020202020204" pitchFamily="34" charset="0"/>
                <a:cs typeface="Helvetica" panose="020B0604020202020204" pitchFamily="34" charset="0"/>
              </a:rPr>
              <a:t>GmTGA6</a:t>
            </a:r>
            <a:endParaRPr lang="en-US" sz="600" i="1">
              <a:latin typeface="Helvetica" panose="020B0604020202020204" pitchFamily="34" charset="0"/>
              <a:cs typeface="Helvetica" panose="020B0604020202020204" pitchFamily="34" charset="0"/>
            </a:endParaRPr>
          </a:p>
        </p:txBody>
      </p:sp>
      <p:sp>
        <p:nvSpPr>
          <p:cNvPr id="2" name="TextBox 1">
            <a:extLst>
              <a:ext uri="{FF2B5EF4-FFF2-40B4-BE49-F238E27FC236}">
                <a16:creationId xmlns:a16="http://schemas.microsoft.com/office/drawing/2014/main" id="{95DE3980-1221-E768-B463-21755D594504}"/>
              </a:ext>
            </a:extLst>
          </p:cNvPr>
          <p:cNvSpPr txBox="1"/>
          <p:nvPr/>
        </p:nvSpPr>
        <p:spPr>
          <a:xfrm>
            <a:off x="155839" y="7916157"/>
            <a:ext cx="6390868" cy="1938992"/>
          </a:xfrm>
          <a:prstGeom prst="rect">
            <a:avLst/>
          </a:prstGeom>
          <a:noFill/>
        </p:spPr>
        <p:txBody>
          <a:bodyPr wrap="square" rtlCol="0">
            <a:spAutoFit/>
          </a:bodyPr>
          <a:lstStyle/>
          <a:p>
            <a:r>
              <a:rPr lang="en-US" sz="1200" b="1">
                <a:latin typeface="Times New Roman" panose="02020603050405020304" pitchFamily="18" charset="0"/>
                <a:cs typeface="Times New Roman" panose="02020603050405020304" pitchFamily="18" charset="0"/>
              </a:rPr>
              <a:t>Supplementary Figure S10. SnRNA-Seq reveals transcriptional regulation of salicylic acid (SA) biosynthesis and signaling pathway genes in different cell types upon Si treatment. (A)</a:t>
            </a:r>
            <a:r>
              <a:rPr lang="en-US" sz="1200">
                <a:latin typeface="Times New Roman" panose="02020603050405020304" pitchFamily="18" charset="0"/>
                <a:cs typeface="Times New Roman" panose="02020603050405020304" pitchFamily="18" charset="0"/>
              </a:rPr>
              <a:t> Dot plot analysis depicts expression of SA biosynthesis and signaling genes in soybean leaves after Si- (control) and Si+ treatment. The size of the dots depicts the percentage of cells in each clusters that express the gene. The colors exhibit the relative expression. The red dot represents S (-) sample, while blue dot represents Si (+) treated sample. </a:t>
            </a:r>
            <a:r>
              <a:rPr lang="en-US" sz="1200" b="1">
                <a:latin typeface="Times New Roman" panose="02020603050405020304" pitchFamily="18" charset="0"/>
                <a:cs typeface="Times New Roman" panose="02020603050405020304" pitchFamily="18" charset="0"/>
              </a:rPr>
              <a:t>(B)</a:t>
            </a:r>
            <a:r>
              <a:rPr lang="en-US" sz="1200">
                <a:latin typeface="Times New Roman" panose="02020603050405020304" pitchFamily="18" charset="0"/>
                <a:cs typeface="Times New Roman" panose="02020603050405020304" pitchFamily="18" charset="0"/>
              </a:rPr>
              <a:t> Figure depicts the genes involved in SA biosynthesis and signal transduction pathway network with representation of  their expression patterns in various cell types in soybean leaves. Different colored circles indicate expression of genes in respective tissue type clusters. Genes in blue boxes are differentially expressed in snRNA-seq dataset in soybean leaves upon Si treatment.  </a:t>
            </a:r>
          </a:p>
        </p:txBody>
      </p:sp>
    </p:spTree>
    <p:extLst>
      <p:ext uri="{BB962C8B-B14F-4D97-AF65-F5344CB8AC3E}">
        <p14:creationId xmlns:p14="http://schemas.microsoft.com/office/powerpoint/2010/main" val="7722561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3EA40E7-3DC9-F6DF-3063-78739A2ED3A9}"/>
              </a:ext>
            </a:extLst>
          </p:cNvPr>
          <p:cNvPicPr>
            <a:picLocks noChangeAspect="1"/>
          </p:cNvPicPr>
          <p:nvPr/>
        </p:nvPicPr>
        <p:blipFill rotWithShape="1">
          <a:blip r:embed="rId2" cstate="print"/>
          <a:srcRect l="8449" t="4467" r="8132" b="703"/>
          <a:stretch/>
        </p:blipFill>
        <p:spPr bwMode="auto">
          <a:xfrm>
            <a:off x="3429000" y="308874"/>
            <a:ext cx="2658171" cy="1892501"/>
          </a:xfrm>
          <a:prstGeom prst="rect">
            <a:avLst/>
          </a:prstGeom>
          <a:noFill/>
          <a:ln w="9525">
            <a:noFill/>
            <a:miter lim="800000"/>
            <a:headEnd/>
            <a:tailEnd/>
          </a:ln>
        </p:spPr>
      </p:pic>
      <p:pic>
        <p:nvPicPr>
          <p:cNvPr id="5" name="Picture 4">
            <a:extLst>
              <a:ext uri="{FF2B5EF4-FFF2-40B4-BE49-F238E27FC236}">
                <a16:creationId xmlns:a16="http://schemas.microsoft.com/office/drawing/2014/main" id="{BC4B593B-F9F9-3162-DCA4-E49944D47FA7}"/>
              </a:ext>
            </a:extLst>
          </p:cNvPr>
          <p:cNvPicPr>
            <a:picLocks noChangeAspect="1"/>
          </p:cNvPicPr>
          <p:nvPr/>
        </p:nvPicPr>
        <p:blipFill>
          <a:blip r:embed="rId3" cstate="print"/>
          <a:srcRect/>
          <a:stretch>
            <a:fillRect/>
          </a:stretch>
        </p:blipFill>
        <p:spPr bwMode="auto">
          <a:xfrm>
            <a:off x="3429000" y="2220134"/>
            <a:ext cx="2639649" cy="1580013"/>
          </a:xfrm>
          <a:prstGeom prst="rect">
            <a:avLst/>
          </a:prstGeom>
          <a:noFill/>
          <a:ln w="9525">
            <a:noFill/>
            <a:miter lim="800000"/>
            <a:headEnd/>
            <a:tailEnd/>
          </a:ln>
        </p:spPr>
      </p:pic>
      <p:pic>
        <p:nvPicPr>
          <p:cNvPr id="6" name="Picture 5">
            <a:extLst>
              <a:ext uri="{FF2B5EF4-FFF2-40B4-BE49-F238E27FC236}">
                <a16:creationId xmlns:a16="http://schemas.microsoft.com/office/drawing/2014/main" id="{ACEADD36-435A-706A-0AE9-EBEEFE9AF23F}"/>
              </a:ext>
            </a:extLst>
          </p:cNvPr>
          <p:cNvPicPr>
            <a:picLocks noChangeAspect="1"/>
          </p:cNvPicPr>
          <p:nvPr/>
        </p:nvPicPr>
        <p:blipFill rotWithShape="1">
          <a:blip r:embed="rId4" cstate="print"/>
          <a:srcRect l="8390" t="4440" r="8347" b="772"/>
          <a:stretch/>
        </p:blipFill>
        <p:spPr bwMode="auto">
          <a:xfrm>
            <a:off x="603321" y="306173"/>
            <a:ext cx="2658171" cy="1895202"/>
          </a:xfrm>
          <a:prstGeom prst="rect">
            <a:avLst/>
          </a:prstGeom>
          <a:noFill/>
          <a:ln w="9525">
            <a:noFill/>
            <a:miter lim="800000"/>
            <a:headEnd/>
            <a:tailEnd/>
          </a:ln>
        </p:spPr>
      </p:pic>
      <p:pic>
        <p:nvPicPr>
          <p:cNvPr id="7" name="Picture 6">
            <a:extLst>
              <a:ext uri="{FF2B5EF4-FFF2-40B4-BE49-F238E27FC236}">
                <a16:creationId xmlns:a16="http://schemas.microsoft.com/office/drawing/2014/main" id="{E389C274-F48A-AD44-02D3-D878D9D08361}"/>
              </a:ext>
            </a:extLst>
          </p:cNvPr>
          <p:cNvPicPr>
            <a:picLocks noChangeAspect="1"/>
          </p:cNvPicPr>
          <p:nvPr/>
        </p:nvPicPr>
        <p:blipFill>
          <a:blip r:embed="rId5" cstate="print"/>
          <a:srcRect/>
          <a:stretch>
            <a:fillRect/>
          </a:stretch>
        </p:blipFill>
        <p:spPr bwMode="auto">
          <a:xfrm>
            <a:off x="603321" y="2220135"/>
            <a:ext cx="2639648" cy="1580012"/>
          </a:xfrm>
          <a:prstGeom prst="rect">
            <a:avLst/>
          </a:prstGeom>
          <a:noFill/>
          <a:ln w="9525">
            <a:noFill/>
            <a:miter lim="800000"/>
            <a:headEnd/>
            <a:tailEnd/>
          </a:ln>
        </p:spPr>
      </p:pic>
      <p:pic>
        <p:nvPicPr>
          <p:cNvPr id="8" name="Picture 7">
            <a:extLst>
              <a:ext uri="{FF2B5EF4-FFF2-40B4-BE49-F238E27FC236}">
                <a16:creationId xmlns:a16="http://schemas.microsoft.com/office/drawing/2014/main" id="{42BD8504-A15A-0C1F-A71B-97100C7768C1}"/>
              </a:ext>
            </a:extLst>
          </p:cNvPr>
          <p:cNvPicPr>
            <a:picLocks noChangeAspect="1"/>
          </p:cNvPicPr>
          <p:nvPr/>
        </p:nvPicPr>
        <p:blipFill rotWithShape="1">
          <a:blip r:embed="rId6" cstate="print"/>
          <a:srcRect l="7905" t="4467" r="8132" b="1427"/>
          <a:stretch/>
        </p:blipFill>
        <p:spPr bwMode="auto">
          <a:xfrm>
            <a:off x="3430776" y="4241214"/>
            <a:ext cx="2656395" cy="1864640"/>
          </a:xfrm>
          <a:prstGeom prst="rect">
            <a:avLst/>
          </a:prstGeom>
          <a:noFill/>
          <a:ln w="9525">
            <a:noFill/>
            <a:miter lim="800000"/>
            <a:headEnd/>
            <a:tailEnd/>
          </a:ln>
        </p:spPr>
      </p:pic>
      <p:pic>
        <p:nvPicPr>
          <p:cNvPr id="9" name="Picture 8">
            <a:extLst>
              <a:ext uri="{FF2B5EF4-FFF2-40B4-BE49-F238E27FC236}">
                <a16:creationId xmlns:a16="http://schemas.microsoft.com/office/drawing/2014/main" id="{1B540D38-7D7A-2DBE-4294-66636BAA9EFB}"/>
              </a:ext>
            </a:extLst>
          </p:cNvPr>
          <p:cNvPicPr>
            <a:picLocks noChangeAspect="1"/>
          </p:cNvPicPr>
          <p:nvPr/>
        </p:nvPicPr>
        <p:blipFill>
          <a:blip r:embed="rId7" cstate="print"/>
          <a:srcRect/>
          <a:stretch>
            <a:fillRect/>
          </a:stretch>
        </p:blipFill>
        <p:spPr bwMode="auto">
          <a:xfrm>
            <a:off x="3401093" y="6143663"/>
            <a:ext cx="2653740" cy="1588448"/>
          </a:xfrm>
          <a:prstGeom prst="rect">
            <a:avLst/>
          </a:prstGeom>
          <a:noFill/>
          <a:ln w="9525">
            <a:noFill/>
            <a:miter lim="800000"/>
            <a:headEnd/>
            <a:tailEnd/>
          </a:ln>
        </p:spPr>
      </p:pic>
      <p:pic>
        <p:nvPicPr>
          <p:cNvPr id="10" name="Picture 9">
            <a:extLst>
              <a:ext uri="{FF2B5EF4-FFF2-40B4-BE49-F238E27FC236}">
                <a16:creationId xmlns:a16="http://schemas.microsoft.com/office/drawing/2014/main" id="{4A96A991-9253-EBE7-A0C6-5E298683CF46}"/>
              </a:ext>
            </a:extLst>
          </p:cNvPr>
          <p:cNvPicPr>
            <a:picLocks noChangeAspect="1"/>
          </p:cNvPicPr>
          <p:nvPr/>
        </p:nvPicPr>
        <p:blipFill>
          <a:blip r:embed="rId8" cstate="print"/>
          <a:srcRect/>
          <a:stretch>
            <a:fillRect/>
          </a:stretch>
        </p:blipFill>
        <p:spPr bwMode="auto">
          <a:xfrm>
            <a:off x="638599" y="6143663"/>
            <a:ext cx="2653740" cy="1588448"/>
          </a:xfrm>
          <a:prstGeom prst="rect">
            <a:avLst/>
          </a:prstGeom>
          <a:noFill/>
          <a:ln w="9525">
            <a:noFill/>
            <a:miter lim="800000"/>
            <a:headEnd/>
            <a:tailEnd/>
          </a:ln>
        </p:spPr>
      </p:pic>
      <p:pic>
        <p:nvPicPr>
          <p:cNvPr id="11" name="Picture 10">
            <a:extLst>
              <a:ext uri="{FF2B5EF4-FFF2-40B4-BE49-F238E27FC236}">
                <a16:creationId xmlns:a16="http://schemas.microsoft.com/office/drawing/2014/main" id="{5AE816F1-0434-E091-206B-91B592A351E4}"/>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sharpenSoften amount="50000"/>
                    </a14:imgEffect>
                  </a14:imgLayer>
                </a14:imgProps>
              </a:ext>
            </a:extLst>
          </a:blip>
          <a:srcRect l="8267" t="4606" r="8314" b="847"/>
          <a:stretch/>
        </p:blipFill>
        <p:spPr bwMode="auto">
          <a:xfrm>
            <a:off x="636824" y="4241214"/>
            <a:ext cx="2653740" cy="1883689"/>
          </a:xfrm>
          <a:prstGeom prst="rect">
            <a:avLst/>
          </a:prstGeom>
          <a:noFill/>
          <a:ln w="9525">
            <a:noFill/>
            <a:miter lim="800000"/>
            <a:headEnd/>
            <a:tailEnd/>
          </a:ln>
        </p:spPr>
      </p:pic>
      <p:sp>
        <p:nvSpPr>
          <p:cNvPr id="2" name="TextBox 1">
            <a:extLst>
              <a:ext uri="{FF2B5EF4-FFF2-40B4-BE49-F238E27FC236}">
                <a16:creationId xmlns:a16="http://schemas.microsoft.com/office/drawing/2014/main" id="{D6AA2FB8-1CA5-F197-0DE2-487B4877882F}"/>
              </a:ext>
            </a:extLst>
          </p:cNvPr>
          <p:cNvSpPr txBox="1"/>
          <p:nvPr/>
        </p:nvSpPr>
        <p:spPr>
          <a:xfrm>
            <a:off x="159792" y="128311"/>
            <a:ext cx="414941"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A</a:t>
            </a:r>
          </a:p>
        </p:txBody>
      </p:sp>
      <p:sp>
        <p:nvSpPr>
          <p:cNvPr id="12" name="TextBox 11">
            <a:extLst>
              <a:ext uri="{FF2B5EF4-FFF2-40B4-BE49-F238E27FC236}">
                <a16:creationId xmlns:a16="http://schemas.microsoft.com/office/drawing/2014/main" id="{EE11CAC0-AEDE-94C8-41CC-3FE479E6E222}"/>
              </a:ext>
            </a:extLst>
          </p:cNvPr>
          <p:cNvSpPr txBox="1"/>
          <p:nvPr/>
        </p:nvSpPr>
        <p:spPr>
          <a:xfrm>
            <a:off x="159792" y="3964215"/>
            <a:ext cx="338333"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B</a:t>
            </a:r>
          </a:p>
        </p:txBody>
      </p:sp>
      <p:sp>
        <p:nvSpPr>
          <p:cNvPr id="13" name="TextBox 12">
            <a:extLst>
              <a:ext uri="{FF2B5EF4-FFF2-40B4-BE49-F238E27FC236}">
                <a16:creationId xmlns:a16="http://schemas.microsoft.com/office/drawing/2014/main" id="{1E8A8E73-D593-34F9-B40C-79F2F7DDC6DE}"/>
              </a:ext>
            </a:extLst>
          </p:cNvPr>
          <p:cNvSpPr txBox="1"/>
          <p:nvPr/>
        </p:nvSpPr>
        <p:spPr>
          <a:xfrm>
            <a:off x="302213" y="7816613"/>
            <a:ext cx="6253574" cy="1384995"/>
          </a:xfrm>
          <a:prstGeom prst="rect">
            <a:avLst/>
          </a:prstGeom>
          <a:noFill/>
        </p:spPr>
        <p:txBody>
          <a:bodyPr wrap="square" rtlCol="0">
            <a:spAutoFit/>
          </a:bodyPr>
          <a:lstStyle/>
          <a:p>
            <a:r>
              <a:rPr lang="en-US" sz="1400" b="1">
                <a:latin typeface="Times New Roman" panose="02020603050405020304" pitchFamily="18" charset="0"/>
                <a:cs typeface="Times New Roman" panose="02020603050405020304" pitchFamily="18" charset="0"/>
              </a:rPr>
              <a:t>Supplementary Figure S2. Detection of Silicon by SEM-SDS microscopy. (A) S</a:t>
            </a:r>
            <a:r>
              <a:rPr lang="en-US" sz="1400">
                <a:latin typeface="Times New Roman" panose="02020603050405020304" pitchFamily="18" charset="0"/>
                <a:cs typeface="Times New Roman" panose="02020603050405020304" pitchFamily="18" charset="0"/>
              </a:rPr>
              <a:t>canning electron microscopy (SEM) combined with EDS spectroscopy imaging of soybean leaves with different elemental profiling in Si- and Si+ treated plants. </a:t>
            </a:r>
            <a:r>
              <a:rPr lang="en-US" sz="1400" b="1">
                <a:latin typeface="Times New Roman" panose="02020603050405020304" pitchFamily="18" charset="0"/>
                <a:cs typeface="Times New Roman" panose="02020603050405020304" pitchFamily="18" charset="0"/>
              </a:rPr>
              <a:t>(B) </a:t>
            </a:r>
            <a:r>
              <a:rPr lang="en-US" sz="1400">
                <a:latin typeface="Times New Roman" panose="02020603050405020304" pitchFamily="18" charset="0"/>
                <a:cs typeface="Times New Roman" panose="02020603050405020304" pitchFamily="18" charset="0"/>
              </a:rPr>
              <a:t>Electron micrograph of  soybean leaf trichome and its base area. Bottom graphs exhibit level of different elements including Si in scanned soybean leaf area. Red boxes highlights the presence of Si element. </a:t>
            </a:r>
            <a:endParaRPr lang="en-US" sz="1400" b="1">
              <a:latin typeface="Times New Roman" panose="02020603050405020304" pitchFamily="18" charset="0"/>
              <a:cs typeface="Times New Roman" panose="02020603050405020304" pitchFamily="18" charset="0"/>
            </a:endParaRPr>
          </a:p>
        </p:txBody>
      </p:sp>
      <p:sp>
        <p:nvSpPr>
          <p:cNvPr id="3" name="Rectangle 2">
            <a:extLst>
              <a:ext uri="{FF2B5EF4-FFF2-40B4-BE49-F238E27FC236}">
                <a16:creationId xmlns:a16="http://schemas.microsoft.com/office/drawing/2014/main" id="{816778EE-91FC-3D08-8425-BCBB166A26BA}"/>
              </a:ext>
            </a:extLst>
          </p:cNvPr>
          <p:cNvSpPr/>
          <p:nvPr/>
        </p:nvSpPr>
        <p:spPr>
          <a:xfrm>
            <a:off x="3865912" y="3162300"/>
            <a:ext cx="45719" cy="55245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5" name="Rectangle 14">
            <a:extLst>
              <a:ext uri="{FF2B5EF4-FFF2-40B4-BE49-F238E27FC236}">
                <a16:creationId xmlns:a16="http://schemas.microsoft.com/office/drawing/2014/main" id="{F9003170-D647-71D3-CF8B-F63811A341C0}"/>
              </a:ext>
            </a:extLst>
          </p:cNvPr>
          <p:cNvSpPr/>
          <p:nvPr/>
        </p:nvSpPr>
        <p:spPr>
          <a:xfrm>
            <a:off x="3801142" y="6228165"/>
            <a:ext cx="36576" cy="1426745"/>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1EA374B2-14F2-4536-7E84-18424D1DA4EB}"/>
              </a:ext>
            </a:extLst>
          </p:cNvPr>
          <p:cNvSpPr txBox="1"/>
          <p:nvPr/>
        </p:nvSpPr>
        <p:spPr>
          <a:xfrm>
            <a:off x="1638605" y="83899"/>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20" name="TextBox 19">
            <a:extLst>
              <a:ext uri="{FF2B5EF4-FFF2-40B4-BE49-F238E27FC236}">
                <a16:creationId xmlns:a16="http://schemas.microsoft.com/office/drawing/2014/main" id="{CD67D92E-49AE-E245-FABF-B36F3E3DC670}"/>
              </a:ext>
            </a:extLst>
          </p:cNvPr>
          <p:cNvSpPr txBox="1"/>
          <p:nvPr/>
        </p:nvSpPr>
        <p:spPr>
          <a:xfrm>
            <a:off x="4529460" y="83978"/>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21" name="TextBox 20">
            <a:extLst>
              <a:ext uri="{FF2B5EF4-FFF2-40B4-BE49-F238E27FC236}">
                <a16:creationId xmlns:a16="http://schemas.microsoft.com/office/drawing/2014/main" id="{B60197F2-AF6F-DCBC-166C-37EC30FDF5E3}"/>
              </a:ext>
            </a:extLst>
          </p:cNvPr>
          <p:cNvSpPr txBox="1"/>
          <p:nvPr/>
        </p:nvSpPr>
        <p:spPr>
          <a:xfrm>
            <a:off x="1638605" y="4026108"/>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22" name="TextBox 21">
            <a:extLst>
              <a:ext uri="{FF2B5EF4-FFF2-40B4-BE49-F238E27FC236}">
                <a16:creationId xmlns:a16="http://schemas.microsoft.com/office/drawing/2014/main" id="{C3D70D76-B4B6-8731-A53B-D09F9225598C}"/>
              </a:ext>
            </a:extLst>
          </p:cNvPr>
          <p:cNvSpPr txBox="1"/>
          <p:nvPr/>
        </p:nvSpPr>
        <p:spPr>
          <a:xfrm>
            <a:off x="4529460" y="4026187"/>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23534962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Box 38">
            <a:extLst>
              <a:ext uri="{FF2B5EF4-FFF2-40B4-BE49-F238E27FC236}">
                <a16:creationId xmlns:a16="http://schemas.microsoft.com/office/drawing/2014/main" id="{2D981907-DEF4-28AB-4F9E-121EFA7BA0D3}"/>
              </a:ext>
            </a:extLst>
          </p:cNvPr>
          <p:cNvSpPr txBox="1"/>
          <p:nvPr/>
        </p:nvSpPr>
        <p:spPr>
          <a:xfrm>
            <a:off x="67216" y="166300"/>
            <a:ext cx="411598"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A</a:t>
            </a:r>
          </a:p>
        </p:txBody>
      </p:sp>
      <p:sp>
        <p:nvSpPr>
          <p:cNvPr id="40" name="TextBox 39">
            <a:extLst>
              <a:ext uri="{FF2B5EF4-FFF2-40B4-BE49-F238E27FC236}">
                <a16:creationId xmlns:a16="http://schemas.microsoft.com/office/drawing/2014/main" id="{53751EA1-1890-A682-31A3-D98ECB5B17CD}"/>
              </a:ext>
            </a:extLst>
          </p:cNvPr>
          <p:cNvSpPr txBox="1"/>
          <p:nvPr/>
        </p:nvSpPr>
        <p:spPr>
          <a:xfrm>
            <a:off x="67216" y="2244149"/>
            <a:ext cx="411598" cy="276999"/>
          </a:xfrm>
          <a:prstGeom prst="rect">
            <a:avLst/>
          </a:prstGeom>
          <a:noFill/>
        </p:spPr>
        <p:txBody>
          <a:bodyPr wrap="square" rtlCol="0">
            <a:spAutoFit/>
          </a:bodyPr>
          <a:lstStyle/>
          <a:p>
            <a:r>
              <a:rPr lang="en-US" sz="1200" b="1">
                <a:latin typeface="Helvetica" panose="020B0604020202020204" pitchFamily="34" charset="0"/>
                <a:cs typeface="Helvetica" panose="020B0604020202020204" pitchFamily="34" charset="0"/>
              </a:rPr>
              <a:t>B</a:t>
            </a:r>
          </a:p>
        </p:txBody>
      </p:sp>
      <p:sp>
        <p:nvSpPr>
          <p:cNvPr id="42" name="TextBox 41">
            <a:extLst>
              <a:ext uri="{FF2B5EF4-FFF2-40B4-BE49-F238E27FC236}">
                <a16:creationId xmlns:a16="http://schemas.microsoft.com/office/drawing/2014/main" id="{28F568E8-3645-BB50-A71F-27BA32D8D5C2}"/>
              </a:ext>
            </a:extLst>
          </p:cNvPr>
          <p:cNvSpPr txBox="1"/>
          <p:nvPr/>
        </p:nvSpPr>
        <p:spPr>
          <a:xfrm>
            <a:off x="276224" y="6113406"/>
            <a:ext cx="6352979" cy="1169551"/>
          </a:xfrm>
          <a:prstGeom prst="rect">
            <a:avLst/>
          </a:prstGeom>
          <a:noFill/>
        </p:spPr>
        <p:txBody>
          <a:bodyPr wrap="square" rtlCol="0">
            <a:spAutoFit/>
          </a:bodyPr>
          <a:lstStyle/>
          <a:p>
            <a:r>
              <a:rPr lang="en-US" sz="1400" b="1">
                <a:latin typeface="Times New Roman" panose="02020603050405020304" pitchFamily="18" charset="0"/>
                <a:cs typeface="Times New Roman" panose="02020603050405020304" pitchFamily="18" charset="0"/>
              </a:rPr>
              <a:t>Supplementary Figure S3. SnRNA-seq analysis reveals distinct clusters in soybean leaves. (A) </a:t>
            </a:r>
            <a:r>
              <a:rPr lang="en-US" sz="1400">
                <a:latin typeface="Times New Roman" panose="02020603050405020304" pitchFamily="18" charset="0"/>
                <a:cs typeface="Times New Roman" panose="02020603050405020304" pitchFamily="18" charset="0"/>
              </a:rPr>
              <a:t>Image depicts number of nuclei, detected genes, mean UMI and mean number of genes in soybean SnRNA-seq dataset.</a:t>
            </a:r>
            <a:r>
              <a:rPr lang="en-US" sz="1400" b="1">
                <a:latin typeface="Times New Roman" panose="02020603050405020304" pitchFamily="18" charset="0"/>
                <a:cs typeface="Times New Roman" panose="02020603050405020304" pitchFamily="18" charset="0"/>
              </a:rPr>
              <a:t> (B) </a:t>
            </a:r>
            <a:r>
              <a:rPr lang="en-US" sz="1400">
                <a:latin typeface="Times New Roman" panose="02020603050405020304" pitchFamily="18" charset="0"/>
                <a:cs typeface="Times New Roman" panose="02020603050405020304" pitchFamily="18" charset="0"/>
              </a:rPr>
              <a:t>Color-coded visualization of soybean leaf nuclei by Uniform Manifold Approximation and Projection (UMAP) plot based on transcriptomic profiles.</a:t>
            </a:r>
          </a:p>
        </p:txBody>
      </p:sp>
      <p:pic>
        <p:nvPicPr>
          <p:cNvPr id="3" name="Picture 2">
            <a:extLst>
              <a:ext uri="{FF2B5EF4-FFF2-40B4-BE49-F238E27FC236}">
                <a16:creationId xmlns:a16="http://schemas.microsoft.com/office/drawing/2014/main" id="{A7FE0156-B454-678F-37C3-F9D56CBA9AC0}"/>
              </a:ext>
            </a:extLst>
          </p:cNvPr>
          <p:cNvPicPr>
            <a:picLocks noChangeAspect="1"/>
          </p:cNvPicPr>
          <p:nvPr/>
        </p:nvPicPr>
        <p:blipFill>
          <a:blip r:embed="rId2"/>
          <a:stretch>
            <a:fillRect/>
          </a:stretch>
        </p:blipFill>
        <p:spPr>
          <a:xfrm>
            <a:off x="417797" y="2644477"/>
            <a:ext cx="3647384" cy="3173815"/>
          </a:xfrm>
          <a:prstGeom prst="rect">
            <a:avLst/>
          </a:prstGeom>
        </p:spPr>
      </p:pic>
      <p:grpSp>
        <p:nvGrpSpPr>
          <p:cNvPr id="4" name="Group 3">
            <a:extLst>
              <a:ext uri="{FF2B5EF4-FFF2-40B4-BE49-F238E27FC236}">
                <a16:creationId xmlns:a16="http://schemas.microsoft.com/office/drawing/2014/main" id="{4C12F03E-9E8E-ECF2-F61F-6F06DEFF4081}"/>
              </a:ext>
            </a:extLst>
          </p:cNvPr>
          <p:cNvGrpSpPr/>
          <p:nvPr/>
        </p:nvGrpSpPr>
        <p:grpSpPr>
          <a:xfrm>
            <a:off x="4065868" y="2911324"/>
            <a:ext cx="2563335" cy="2532892"/>
            <a:chOff x="5314155" y="3121826"/>
            <a:chExt cx="1364806" cy="1099740"/>
          </a:xfrm>
        </p:grpSpPr>
        <p:sp>
          <p:nvSpPr>
            <p:cNvPr id="7" name="TextBox 6">
              <a:extLst>
                <a:ext uri="{FF2B5EF4-FFF2-40B4-BE49-F238E27FC236}">
                  <a16:creationId xmlns:a16="http://schemas.microsoft.com/office/drawing/2014/main" id="{5551FD6D-A974-5B2F-06D6-39C5B15287E5}"/>
                </a:ext>
              </a:extLst>
            </p:cNvPr>
            <p:cNvSpPr txBox="1"/>
            <p:nvPr/>
          </p:nvSpPr>
          <p:spPr>
            <a:xfrm>
              <a:off x="5325232" y="3750707"/>
              <a:ext cx="891553"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8. Companion cells</a:t>
              </a:r>
            </a:p>
          </p:txBody>
        </p:sp>
        <p:sp>
          <p:nvSpPr>
            <p:cNvPr id="9" name="TextBox 8">
              <a:extLst>
                <a:ext uri="{FF2B5EF4-FFF2-40B4-BE49-F238E27FC236}">
                  <a16:creationId xmlns:a16="http://schemas.microsoft.com/office/drawing/2014/main" id="{FDE99791-FD49-3011-4C78-96B02C0A5A8F}"/>
                </a:ext>
              </a:extLst>
            </p:cNvPr>
            <p:cNvSpPr txBox="1"/>
            <p:nvPr/>
          </p:nvSpPr>
          <p:spPr>
            <a:xfrm>
              <a:off x="5322116" y="3121826"/>
              <a:ext cx="1033257"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1. Epidermis cells-I</a:t>
              </a:r>
            </a:p>
          </p:txBody>
        </p:sp>
        <p:sp>
          <p:nvSpPr>
            <p:cNvPr id="22" name="TextBox 21">
              <a:extLst>
                <a:ext uri="{FF2B5EF4-FFF2-40B4-BE49-F238E27FC236}">
                  <a16:creationId xmlns:a16="http://schemas.microsoft.com/office/drawing/2014/main" id="{F45B774E-352B-D2F0-59CE-3F403547A606}"/>
                </a:ext>
              </a:extLst>
            </p:cNvPr>
            <p:cNvSpPr txBox="1"/>
            <p:nvPr/>
          </p:nvSpPr>
          <p:spPr>
            <a:xfrm>
              <a:off x="5323711" y="3209468"/>
              <a:ext cx="1147894"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2. Vascular bundle cells </a:t>
              </a:r>
            </a:p>
          </p:txBody>
        </p:sp>
        <p:sp>
          <p:nvSpPr>
            <p:cNvPr id="23" name="TextBox 22">
              <a:extLst>
                <a:ext uri="{FF2B5EF4-FFF2-40B4-BE49-F238E27FC236}">
                  <a16:creationId xmlns:a16="http://schemas.microsoft.com/office/drawing/2014/main" id="{B96FC619-0C39-0BD7-3C82-79163AEE558A}"/>
                </a:ext>
              </a:extLst>
            </p:cNvPr>
            <p:cNvSpPr txBox="1"/>
            <p:nvPr/>
          </p:nvSpPr>
          <p:spPr>
            <a:xfrm>
              <a:off x="5323711" y="3297110"/>
              <a:ext cx="1221310"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3. Palisade mesophyll cells-I </a:t>
              </a:r>
            </a:p>
          </p:txBody>
        </p:sp>
        <p:sp>
          <p:nvSpPr>
            <p:cNvPr id="24" name="TextBox 23">
              <a:extLst>
                <a:ext uri="{FF2B5EF4-FFF2-40B4-BE49-F238E27FC236}">
                  <a16:creationId xmlns:a16="http://schemas.microsoft.com/office/drawing/2014/main" id="{CF95B481-9423-1BA2-A6AE-3168412DA92C}"/>
                </a:ext>
              </a:extLst>
            </p:cNvPr>
            <p:cNvSpPr txBox="1"/>
            <p:nvPr/>
          </p:nvSpPr>
          <p:spPr>
            <a:xfrm>
              <a:off x="5323711" y="3390632"/>
              <a:ext cx="1221310"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4. Spongy mesophyll cells-I </a:t>
              </a:r>
            </a:p>
          </p:txBody>
        </p:sp>
        <p:sp>
          <p:nvSpPr>
            <p:cNvPr id="25" name="TextBox 24">
              <a:extLst>
                <a:ext uri="{FF2B5EF4-FFF2-40B4-BE49-F238E27FC236}">
                  <a16:creationId xmlns:a16="http://schemas.microsoft.com/office/drawing/2014/main" id="{060AC8CA-83D7-B03F-8D61-3B566DDE6E52}"/>
                </a:ext>
              </a:extLst>
            </p:cNvPr>
            <p:cNvSpPr txBox="1"/>
            <p:nvPr/>
          </p:nvSpPr>
          <p:spPr>
            <a:xfrm>
              <a:off x="5323711" y="3481114"/>
              <a:ext cx="891553"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5. Si induced cells</a:t>
              </a:r>
            </a:p>
          </p:txBody>
        </p:sp>
        <p:sp>
          <p:nvSpPr>
            <p:cNvPr id="26" name="TextBox 25">
              <a:extLst>
                <a:ext uri="{FF2B5EF4-FFF2-40B4-BE49-F238E27FC236}">
                  <a16:creationId xmlns:a16="http://schemas.microsoft.com/office/drawing/2014/main" id="{C2102C78-BD49-0370-8108-0C8BB76C276E}"/>
                </a:ext>
              </a:extLst>
            </p:cNvPr>
            <p:cNvSpPr txBox="1"/>
            <p:nvPr/>
          </p:nvSpPr>
          <p:spPr>
            <a:xfrm>
              <a:off x="5322117" y="3566344"/>
              <a:ext cx="1284093"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6. Spongy Mesophyll cells-II</a:t>
              </a:r>
            </a:p>
          </p:txBody>
        </p:sp>
        <p:sp>
          <p:nvSpPr>
            <p:cNvPr id="27" name="TextBox 26">
              <a:extLst>
                <a:ext uri="{FF2B5EF4-FFF2-40B4-BE49-F238E27FC236}">
                  <a16:creationId xmlns:a16="http://schemas.microsoft.com/office/drawing/2014/main" id="{04E25290-5D07-D968-2B23-FA447187C6EA}"/>
                </a:ext>
              </a:extLst>
            </p:cNvPr>
            <p:cNvSpPr txBox="1"/>
            <p:nvPr/>
          </p:nvSpPr>
          <p:spPr>
            <a:xfrm>
              <a:off x="5314155" y="3929683"/>
              <a:ext cx="1317870"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10. Xylem parenchyma cells</a:t>
              </a:r>
            </a:p>
          </p:txBody>
        </p:sp>
        <p:sp>
          <p:nvSpPr>
            <p:cNvPr id="28" name="TextBox 27">
              <a:extLst>
                <a:ext uri="{FF2B5EF4-FFF2-40B4-BE49-F238E27FC236}">
                  <a16:creationId xmlns:a16="http://schemas.microsoft.com/office/drawing/2014/main" id="{61C17996-2D3F-3557-196F-0403431021D7}"/>
                </a:ext>
              </a:extLst>
            </p:cNvPr>
            <p:cNvSpPr txBox="1"/>
            <p:nvPr/>
          </p:nvSpPr>
          <p:spPr>
            <a:xfrm>
              <a:off x="5323471" y="3837756"/>
              <a:ext cx="1226508"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9. Phloem parenchyma cells</a:t>
              </a:r>
            </a:p>
          </p:txBody>
        </p:sp>
        <p:sp>
          <p:nvSpPr>
            <p:cNvPr id="29" name="TextBox 28">
              <a:extLst>
                <a:ext uri="{FF2B5EF4-FFF2-40B4-BE49-F238E27FC236}">
                  <a16:creationId xmlns:a16="http://schemas.microsoft.com/office/drawing/2014/main" id="{80B6CD38-054E-2E08-C89C-5F5E17A800D2}"/>
                </a:ext>
              </a:extLst>
            </p:cNvPr>
            <p:cNvSpPr txBox="1"/>
            <p:nvPr/>
          </p:nvSpPr>
          <p:spPr>
            <a:xfrm>
              <a:off x="5322117" y="3658271"/>
              <a:ext cx="1356844"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7. Palisade mesophyll cells-II </a:t>
              </a:r>
            </a:p>
          </p:txBody>
        </p:sp>
        <p:sp>
          <p:nvSpPr>
            <p:cNvPr id="30" name="TextBox 29">
              <a:extLst>
                <a:ext uri="{FF2B5EF4-FFF2-40B4-BE49-F238E27FC236}">
                  <a16:creationId xmlns:a16="http://schemas.microsoft.com/office/drawing/2014/main" id="{412A6116-AD7C-DDA5-0273-749813721AB6}"/>
                </a:ext>
              </a:extLst>
            </p:cNvPr>
            <p:cNvSpPr txBox="1"/>
            <p:nvPr/>
          </p:nvSpPr>
          <p:spPr>
            <a:xfrm>
              <a:off x="5314155" y="4025260"/>
              <a:ext cx="1317870"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11. Epidermis cells-II</a:t>
              </a:r>
            </a:p>
          </p:txBody>
        </p:sp>
        <p:sp>
          <p:nvSpPr>
            <p:cNvPr id="31" name="TextBox 30">
              <a:extLst>
                <a:ext uri="{FF2B5EF4-FFF2-40B4-BE49-F238E27FC236}">
                  <a16:creationId xmlns:a16="http://schemas.microsoft.com/office/drawing/2014/main" id="{47565931-FFBD-FEF3-8ADB-65035CAF414A}"/>
                </a:ext>
              </a:extLst>
            </p:cNvPr>
            <p:cNvSpPr txBox="1"/>
            <p:nvPr/>
          </p:nvSpPr>
          <p:spPr>
            <a:xfrm>
              <a:off x="5314887" y="4111320"/>
              <a:ext cx="1317870" cy="110246"/>
            </a:xfrm>
            <a:prstGeom prst="rect">
              <a:avLst/>
            </a:prstGeom>
            <a:noFill/>
          </p:spPr>
          <p:txBody>
            <a:bodyPr wrap="square" rtlCol="0">
              <a:spAutoFit/>
            </a:bodyPr>
            <a:lstStyle/>
            <a:p>
              <a:r>
                <a:rPr lang="en-US" sz="1050">
                  <a:latin typeface="Helvetica" panose="020B0604020202020204" pitchFamily="34" charset="0"/>
                  <a:cs typeface="Helvetica" panose="020B0604020202020204" pitchFamily="34" charset="0"/>
                </a:rPr>
                <a:t>12. Guard cells</a:t>
              </a:r>
            </a:p>
          </p:txBody>
        </p:sp>
      </p:grpSp>
      <p:pic>
        <p:nvPicPr>
          <p:cNvPr id="8" name="Picture 7" descr="A screenshot of a computer&#10;&#10;Description automatically generated">
            <a:extLst>
              <a:ext uri="{FF2B5EF4-FFF2-40B4-BE49-F238E27FC236}">
                <a16:creationId xmlns:a16="http://schemas.microsoft.com/office/drawing/2014/main" id="{DC6ADC5E-E3E6-698E-6996-F364912B794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07031" y="386008"/>
            <a:ext cx="3677419" cy="1790704"/>
          </a:xfrm>
          <a:prstGeom prst="rect">
            <a:avLst/>
          </a:prstGeom>
        </p:spPr>
      </p:pic>
    </p:spTree>
    <p:extLst>
      <p:ext uri="{BB962C8B-B14F-4D97-AF65-F5344CB8AC3E}">
        <p14:creationId xmlns:p14="http://schemas.microsoft.com/office/powerpoint/2010/main" val="14378108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of a number of cells&#10;&#10;Description automatically generated with medium confidence">
            <a:extLst>
              <a:ext uri="{FF2B5EF4-FFF2-40B4-BE49-F238E27FC236}">
                <a16:creationId xmlns:a16="http://schemas.microsoft.com/office/drawing/2014/main" id="{AA86745D-3D68-E449-B450-B838D6F49851}"/>
              </a:ext>
            </a:extLst>
          </p:cNvPr>
          <p:cNvPicPr>
            <a:picLocks noChangeAspect="1"/>
          </p:cNvPicPr>
          <p:nvPr/>
        </p:nvPicPr>
        <p:blipFill rotWithShape="1">
          <a:blip r:embed="rId2">
            <a:extLst>
              <a:ext uri="{28A0092B-C50C-407E-A947-70E740481C1C}">
                <a14:useLocalDpi xmlns:a14="http://schemas.microsoft.com/office/drawing/2010/main" val="0"/>
              </a:ext>
            </a:extLst>
          </a:blip>
          <a:srcRect b="7032"/>
          <a:stretch/>
        </p:blipFill>
        <p:spPr>
          <a:xfrm>
            <a:off x="45209" y="1457674"/>
            <a:ext cx="2043159" cy="3693446"/>
          </a:xfrm>
          <a:prstGeom prst="rect">
            <a:avLst/>
          </a:prstGeom>
        </p:spPr>
      </p:pic>
      <p:pic>
        <p:nvPicPr>
          <p:cNvPr id="7" name="Picture 6" descr="A screenshot of a graph&#10;&#10;Description automatically generated">
            <a:extLst>
              <a:ext uri="{FF2B5EF4-FFF2-40B4-BE49-F238E27FC236}">
                <a16:creationId xmlns:a16="http://schemas.microsoft.com/office/drawing/2014/main" id="{60CF31E5-4C3A-F7A3-4BCF-F8236B1D265F}"/>
              </a:ext>
            </a:extLst>
          </p:cNvPr>
          <p:cNvPicPr>
            <a:picLocks noChangeAspect="1"/>
          </p:cNvPicPr>
          <p:nvPr/>
        </p:nvPicPr>
        <p:blipFill rotWithShape="1">
          <a:blip r:embed="rId3">
            <a:extLst>
              <a:ext uri="{28A0092B-C50C-407E-A947-70E740481C1C}">
                <a14:useLocalDpi xmlns:a14="http://schemas.microsoft.com/office/drawing/2010/main" val="0"/>
              </a:ext>
            </a:extLst>
          </a:blip>
          <a:srcRect b="7051"/>
          <a:stretch/>
        </p:blipFill>
        <p:spPr>
          <a:xfrm>
            <a:off x="2164626" y="1457674"/>
            <a:ext cx="2103101" cy="3801028"/>
          </a:xfrm>
          <a:prstGeom prst="rect">
            <a:avLst/>
          </a:prstGeom>
        </p:spPr>
      </p:pic>
      <p:sp>
        <p:nvSpPr>
          <p:cNvPr id="8" name="TextBox 7">
            <a:extLst>
              <a:ext uri="{FF2B5EF4-FFF2-40B4-BE49-F238E27FC236}">
                <a16:creationId xmlns:a16="http://schemas.microsoft.com/office/drawing/2014/main" id="{A373B488-B0CF-2144-1213-219AA7C07B87}"/>
              </a:ext>
            </a:extLst>
          </p:cNvPr>
          <p:cNvSpPr txBox="1"/>
          <p:nvPr/>
        </p:nvSpPr>
        <p:spPr>
          <a:xfrm>
            <a:off x="187978" y="5694784"/>
            <a:ext cx="6697980" cy="276999"/>
          </a:xfrm>
          <a:prstGeom prst="rect">
            <a:avLst/>
          </a:prstGeom>
          <a:noFill/>
        </p:spPr>
        <p:txBody>
          <a:bodyPr wrap="square" rtlCol="0">
            <a:spAutoFit/>
          </a:bodyPr>
          <a:lstStyle/>
          <a:p>
            <a:r>
              <a:rPr lang="en-US" sz="1200" b="1">
                <a:latin typeface="Times New Roman" panose="02020603050405020304" pitchFamily="18" charset="0"/>
                <a:cs typeface="Times New Roman" panose="02020603050405020304" pitchFamily="18" charset="0"/>
              </a:rPr>
              <a:t>Supplementary figure S4. </a:t>
            </a:r>
            <a:r>
              <a:rPr lang="en-US" sz="1200">
                <a:latin typeface="Times New Roman" panose="02020603050405020304" pitchFamily="18" charset="0"/>
                <a:cs typeface="Times New Roman" panose="02020603050405020304" pitchFamily="18" charset="0"/>
              </a:rPr>
              <a:t>Dot plot of GO term enrichments in xylem, phloem and Si-induced cell types. </a:t>
            </a:r>
          </a:p>
        </p:txBody>
      </p:sp>
      <p:sp>
        <p:nvSpPr>
          <p:cNvPr id="10" name="TextBox 9">
            <a:extLst>
              <a:ext uri="{FF2B5EF4-FFF2-40B4-BE49-F238E27FC236}">
                <a16:creationId xmlns:a16="http://schemas.microsoft.com/office/drawing/2014/main" id="{B5AED450-D013-032F-CB22-1E452FB97610}"/>
              </a:ext>
            </a:extLst>
          </p:cNvPr>
          <p:cNvSpPr txBox="1"/>
          <p:nvPr/>
        </p:nvSpPr>
        <p:spPr>
          <a:xfrm>
            <a:off x="2909435" y="1326868"/>
            <a:ext cx="876300" cy="261610"/>
          </a:xfrm>
          <a:prstGeom prst="rect">
            <a:avLst/>
          </a:prstGeom>
          <a:noFill/>
        </p:spPr>
        <p:txBody>
          <a:bodyPr wrap="square">
            <a:spAutoFit/>
          </a:bodyPr>
          <a:lstStyle/>
          <a:p>
            <a:r>
              <a:rPr lang="en-US" sz="1100" b="1">
                <a:latin typeface="Helvetica" panose="020B0604020202020204" pitchFamily="34" charset="0"/>
                <a:cs typeface="Helvetica" panose="020B0604020202020204" pitchFamily="34" charset="0"/>
              </a:rPr>
              <a:t>Phloem</a:t>
            </a:r>
            <a:endParaRPr lang="en-US" sz="1100">
              <a:latin typeface="Helvetica" panose="020B0604020202020204" pitchFamily="34" charset="0"/>
              <a:cs typeface="Helvetica" panose="020B0604020202020204" pitchFamily="34" charset="0"/>
            </a:endParaRPr>
          </a:p>
        </p:txBody>
      </p:sp>
      <p:sp>
        <p:nvSpPr>
          <p:cNvPr id="11" name="TextBox 10">
            <a:extLst>
              <a:ext uri="{FF2B5EF4-FFF2-40B4-BE49-F238E27FC236}">
                <a16:creationId xmlns:a16="http://schemas.microsoft.com/office/drawing/2014/main" id="{50C299BE-1C3F-2925-72B9-F8948525BD30}"/>
              </a:ext>
            </a:extLst>
          </p:cNvPr>
          <p:cNvSpPr txBox="1"/>
          <p:nvPr/>
        </p:nvSpPr>
        <p:spPr>
          <a:xfrm>
            <a:off x="817239" y="1326868"/>
            <a:ext cx="876300" cy="261610"/>
          </a:xfrm>
          <a:prstGeom prst="rect">
            <a:avLst/>
          </a:prstGeom>
          <a:noFill/>
        </p:spPr>
        <p:txBody>
          <a:bodyPr wrap="square">
            <a:spAutoFit/>
          </a:bodyPr>
          <a:lstStyle/>
          <a:p>
            <a:r>
              <a:rPr lang="en-US" sz="1100" b="1">
                <a:latin typeface="Helvetica" panose="020B0604020202020204" pitchFamily="34" charset="0"/>
                <a:cs typeface="Helvetica" panose="020B0604020202020204" pitchFamily="34" charset="0"/>
              </a:rPr>
              <a:t>Xylem</a:t>
            </a:r>
            <a:endParaRPr lang="en-US" sz="1100">
              <a:latin typeface="Helvetica" panose="020B0604020202020204" pitchFamily="34" charset="0"/>
              <a:cs typeface="Helvetica" panose="020B0604020202020204" pitchFamily="34" charset="0"/>
            </a:endParaRPr>
          </a:p>
        </p:txBody>
      </p:sp>
      <p:pic>
        <p:nvPicPr>
          <p:cNvPr id="2" name="Picture 1" descr="A graph of a number of dots&#10;&#10;Description automatically generated with medium confidence">
            <a:extLst>
              <a:ext uri="{FF2B5EF4-FFF2-40B4-BE49-F238E27FC236}">
                <a16:creationId xmlns:a16="http://schemas.microsoft.com/office/drawing/2014/main" id="{2643B9DB-271B-8EEF-6A22-874DD8D20787}"/>
              </a:ext>
            </a:extLst>
          </p:cNvPr>
          <p:cNvPicPr>
            <a:picLocks noChangeAspect="1"/>
          </p:cNvPicPr>
          <p:nvPr/>
        </p:nvPicPr>
        <p:blipFill rotWithShape="1">
          <a:blip r:embed="rId4">
            <a:extLst>
              <a:ext uri="{28A0092B-C50C-407E-A947-70E740481C1C}">
                <a14:useLocalDpi xmlns:a14="http://schemas.microsoft.com/office/drawing/2010/main" val="0"/>
              </a:ext>
            </a:extLst>
          </a:blip>
          <a:srcRect t="3363" r="2305" b="7207"/>
          <a:stretch/>
        </p:blipFill>
        <p:spPr>
          <a:xfrm>
            <a:off x="4192517" y="1625849"/>
            <a:ext cx="2620274" cy="3464677"/>
          </a:xfrm>
          <a:prstGeom prst="rect">
            <a:avLst/>
          </a:prstGeom>
        </p:spPr>
      </p:pic>
      <p:sp>
        <p:nvSpPr>
          <p:cNvPr id="3" name="TextBox 2">
            <a:extLst>
              <a:ext uri="{FF2B5EF4-FFF2-40B4-BE49-F238E27FC236}">
                <a16:creationId xmlns:a16="http://schemas.microsoft.com/office/drawing/2014/main" id="{853A69FC-E3DE-DF53-7C7B-54203620809C}"/>
              </a:ext>
            </a:extLst>
          </p:cNvPr>
          <p:cNvSpPr txBox="1"/>
          <p:nvPr/>
        </p:nvSpPr>
        <p:spPr>
          <a:xfrm>
            <a:off x="5011660" y="1326868"/>
            <a:ext cx="1271955" cy="261610"/>
          </a:xfrm>
          <a:prstGeom prst="rect">
            <a:avLst/>
          </a:prstGeom>
          <a:noFill/>
        </p:spPr>
        <p:txBody>
          <a:bodyPr wrap="square">
            <a:spAutoFit/>
          </a:bodyPr>
          <a:lstStyle/>
          <a:p>
            <a:r>
              <a:rPr lang="en-US" sz="1100" b="1">
                <a:latin typeface="Helvetica" panose="020B0604020202020204" pitchFamily="34" charset="0"/>
                <a:cs typeface="Helvetica" panose="020B0604020202020204" pitchFamily="34" charset="0"/>
              </a:rPr>
              <a:t>Si induced cells</a:t>
            </a:r>
            <a:endParaRPr lang="en-US" sz="1100">
              <a:latin typeface="Helvetica" panose="020B0604020202020204" pitchFamily="34" charset="0"/>
              <a:cs typeface="Helvetica" panose="020B0604020202020204" pitchFamily="34" charset="0"/>
            </a:endParaRPr>
          </a:p>
        </p:txBody>
      </p:sp>
      <p:sp>
        <p:nvSpPr>
          <p:cNvPr id="15" name="TextBox 14">
            <a:extLst>
              <a:ext uri="{FF2B5EF4-FFF2-40B4-BE49-F238E27FC236}">
                <a16:creationId xmlns:a16="http://schemas.microsoft.com/office/drawing/2014/main" id="{08F2D0CC-C185-67DD-F939-47DF98C212D5}"/>
              </a:ext>
            </a:extLst>
          </p:cNvPr>
          <p:cNvSpPr txBox="1"/>
          <p:nvPr/>
        </p:nvSpPr>
        <p:spPr>
          <a:xfrm>
            <a:off x="732900" y="5135591"/>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6" name="TextBox 15">
            <a:extLst>
              <a:ext uri="{FF2B5EF4-FFF2-40B4-BE49-F238E27FC236}">
                <a16:creationId xmlns:a16="http://schemas.microsoft.com/office/drawing/2014/main" id="{6A6E020C-0615-B183-C26A-550772B53CDD}"/>
              </a:ext>
            </a:extLst>
          </p:cNvPr>
          <p:cNvSpPr txBox="1"/>
          <p:nvPr/>
        </p:nvSpPr>
        <p:spPr>
          <a:xfrm>
            <a:off x="1138261" y="5135590"/>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7" name="TextBox 16">
            <a:extLst>
              <a:ext uri="{FF2B5EF4-FFF2-40B4-BE49-F238E27FC236}">
                <a16:creationId xmlns:a16="http://schemas.microsoft.com/office/drawing/2014/main" id="{C71765D5-0446-1E41-5E57-A5535276FBC7}"/>
              </a:ext>
            </a:extLst>
          </p:cNvPr>
          <p:cNvSpPr txBox="1"/>
          <p:nvPr/>
        </p:nvSpPr>
        <p:spPr>
          <a:xfrm>
            <a:off x="2860390" y="5229489"/>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8" name="TextBox 17">
            <a:extLst>
              <a:ext uri="{FF2B5EF4-FFF2-40B4-BE49-F238E27FC236}">
                <a16:creationId xmlns:a16="http://schemas.microsoft.com/office/drawing/2014/main" id="{01E12F72-E81A-6674-EE8E-24CF7C6E0999}"/>
              </a:ext>
            </a:extLst>
          </p:cNvPr>
          <p:cNvSpPr txBox="1"/>
          <p:nvPr/>
        </p:nvSpPr>
        <p:spPr>
          <a:xfrm>
            <a:off x="3280991" y="5229488"/>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9" name="TextBox 18">
            <a:extLst>
              <a:ext uri="{FF2B5EF4-FFF2-40B4-BE49-F238E27FC236}">
                <a16:creationId xmlns:a16="http://schemas.microsoft.com/office/drawing/2014/main" id="{1388A5AF-7740-49DB-3B68-CAF9E2AACFB9}"/>
              </a:ext>
            </a:extLst>
          </p:cNvPr>
          <p:cNvSpPr txBox="1"/>
          <p:nvPr/>
        </p:nvSpPr>
        <p:spPr>
          <a:xfrm>
            <a:off x="5048752" y="5061313"/>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20" name="TextBox 19">
            <a:extLst>
              <a:ext uri="{FF2B5EF4-FFF2-40B4-BE49-F238E27FC236}">
                <a16:creationId xmlns:a16="http://schemas.microsoft.com/office/drawing/2014/main" id="{2345B44C-34BF-075B-D926-A52D374933A0}"/>
              </a:ext>
            </a:extLst>
          </p:cNvPr>
          <p:cNvSpPr txBox="1"/>
          <p:nvPr/>
        </p:nvSpPr>
        <p:spPr>
          <a:xfrm>
            <a:off x="5732717" y="5061312"/>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9222894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7E1C263-20BF-3010-7C86-6DDDAB808C91}"/>
              </a:ext>
            </a:extLst>
          </p:cNvPr>
          <p:cNvSpPr txBox="1"/>
          <p:nvPr/>
        </p:nvSpPr>
        <p:spPr>
          <a:xfrm>
            <a:off x="266700" y="6194679"/>
            <a:ext cx="6362700" cy="276999"/>
          </a:xfrm>
          <a:prstGeom prst="rect">
            <a:avLst/>
          </a:prstGeom>
          <a:noFill/>
        </p:spPr>
        <p:txBody>
          <a:bodyPr wrap="square" rtlCol="0">
            <a:spAutoFit/>
          </a:bodyPr>
          <a:lstStyle/>
          <a:p>
            <a:r>
              <a:rPr lang="en-US" sz="1200" b="1">
                <a:latin typeface="Times New Roman" panose="02020603050405020304" pitchFamily="18" charset="0"/>
                <a:cs typeface="Times New Roman" panose="02020603050405020304" pitchFamily="18" charset="0"/>
              </a:rPr>
              <a:t>Supplementary figure S5. </a:t>
            </a:r>
            <a:r>
              <a:rPr lang="en-US" sz="1200">
                <a:latin typeface="Times New Roman" panose="02020603050405020304" pitchFamily="18" charset="0"/>
                <a:cs typeface="Times New Roman" panose="02020603050405020304" pitchFamily="18" charset="0"/>
              </a:rPr>
              <a:t>Dot plot of GO term enrichment in epidermal and guard cell types.</a:t>
            </a:r>
          </a:p>
        </p:txBody>
      </p:sp>
      <p:pic>
        <p:nvPicPr>
          <p:cNvPr id="6" name="Picture 5" descr="A screenshot of a graph&#10;&#10;Description automatically generated">
            <a:extLst>
              <a:ext uri="{FF2B5EF4-FFF2-40B4-BE49-F238E27FC236}">
                <a16:creationId xmlns:a16="http://schemas.microsoft.com/office/drawing/2014/main" id="{8918A5F2-2F5A-933D-0122-EE33CC2DE2E0}"/>
              </a:ext>
            </a:extLst>
          </p:cNvPr>
          <p:cNvPicPr>
            <a:picLocks noChangeAspect="1"/>
          </p:cNvPicPr>
          <p:nvPr/>
        </p:nvPicPr>
        <p:blipFill rotWithShape="1">
          <a:blip r:embed="rId2">
            <a:extLst>
              <a:ext uri="{28A0092B-C50C-407E-A947-70E740481C1C}">
                <a14:useLocalDpi xmlns:a14="http://schemas.microsoft.com/office/drawing/2010/main" val="0"/>
              </a:ext>
            </a:extLst>
          </a:blip>
          <a:srcRect b="7212"/>
          <a:stretch/>
        </p:blipFill>
        <p:spPr>
          <a:xfrm>
            <a:off x="266700" y="959784"/>
            <a:ext cx="2703205" cy="4877136"/>
          </a:xfrm>
          <a:prstGeom prst="rect">
            <a:avLst/>
          </a:prstGeom>
        </p:spPr>
      </p:pic>
      <p:sp>
        <p:nvSpPr>
          <p:cNvPr id="10" name="TextBox 9">
            <a:extLst>
              <a:ext uri="{FF2B5EF4-FFF2-40B4-BE49-F238E27FC236}">
                <a16:creationId xmlns:a16="http://schemas.microsoft.com/office/drawing/2014/main" id="{E3A8E084-561E-3CC7-26EA-CE7AB3B3808C}"/>
              </a:ext>
            </a:extLst>
          </p:cNvPr>
          <p:cNvSpPr txBox="1"/>
          <p:nvPr/>
        </p:nvSpPr>
        <p:spPr>
          <a:xfrm>
            <a:off x="1344411" y="828979"/>
            <a:ext cx="1246092" cy="261610"/>
          </a:xfrm>
          <a:prstGeom prst="rect">
            <a:avLst/>
          </a:prstGeom>
          <a:noFill/>
        </p:spPr>
        <p:txBody>
          <a:bodyPr wrap="square">
            <a:spAutoFit/>
          </a:bodyPr>
          <a:lstStyle/>
          <a:p>
            <a:r>
              <a:rPr lang="en-US" sz="1050" b="1">
                <a:latin typeface="Helvetica" panose="020B0604020202020204" pitchFamily="34" charset="0"/>
                <a:cs typeface="Helvetica" panose="020B0604020202020204" pitchFamily="34" charset="0"/>
              </a:rPr>
              <a:t>Epidermal cells</a:t>
            </a:r>
            <a:endParaRPr lang="en-US" sz="1050">
              <a:latin typeface="Helvetica" panose="020B0604020202020204" pitchFamily="34" charset="0"/>
              <a:cs typeface="Helvetica" panose="020B0604020202020204" pitchFamily="34" charset="0"/>
            </a:endParaRPr>
          </a:p>
        </p:txBody>
      </p:sp>
      <p:pic>
        <p:nvPicPr>
          <p:cNvPr id="2" name="Picture 1">
            <a:extLst>
              <a:ext uri="{FF2B5EF4-FFF2-40B4-BE49-F238E27FC236}">
                <a16:creationId xmlns:a16="http://schemas.microsoft.com/office/drawing/2014/main" id="{28FBD11A-D19F-DB78-8829-8C8157B0FAFF}"/>
              </a:ext>
            </a:extLst>
          </p:cNvPr>
          <p:cNvPicPr>
            <a:picLocks noChangeAspect="1"/>
          </p:cNvPicPr>
          <p:nvPr/>
        </p:nvPicPr>
        <p:blipFill rotWithShape="1">
          <a:blip r:embed="rId3"/>
          <a:srcRect t="2911" b="7341"/>
          <a:stretch/>
        </p:blipFill>
        <p:spPr>
          <a:xfrm>
            <a:off x="3347637" y="1348581"/>
            <a:ext cx="3162300" cy="4099541"/>
          </a:xfrm>
          <a:prstGeom prst="rect">
            <a:avLst/>
          </a:prstGeom>
        </p:spPr>
      </p:pic>
      <p:sp>
        <p:nvSpPr>
          <p:cNvPr id="3" name="TextBox 2">
            <a:extLst>
              <a:ext uri="{FF2B5EF4-FFF2-40B4-BE49-F238E27FC236}">
                <a16:creationId xmlns:a16="http://schemas.microsoft.com/office/drawing/2014/main" id="{0E1FCA99-A517-63DD-2962-C2E0926CFB1B}"/>
              </a:ext>
            </a:extLst>
          </p:cNvPr>
          <p:cNvSpPr txBox="1"/>
          <p:nvPr/>
        </p:nvSpPr>
        <p:spPr>
          <a:xfrm>
            <a:off x="4676604" y="1026921"/>
            <a:ext cx="1209846" cy="261610"/>
          </a:xfrm>
          <a:prstGeom prst="rect">
            <a:avLst/>
          </a:prstGeom>
          <a:noFill/>
        </p:spPr>
        <p:txBody>
          <a:bodyPr wrap="square">
            <a:spAutoFit/>
          </a:bodyPr>
          <a:lstStyle/>
          <a:p>
            <a:r>
              <a:rPr lang="en-US" sz="1050" b="1">
                <a:latin typeface="Helvetica" panose="020B0604020202020204" pitchFamily="34" charset="0"/>
                <a:cs typeface="Helvetica" panose="020B0604020202020204" pitchFamily="34" charset="0"/>
              </a:rPr>
              <a:t>Guard cells</a:t>
            </a:r>
            <a:endParaRPr lang="en-US" sz="1050">
              <a:latin typeface="Helvetica" panose="020B0604020202020204" pitchFamily="34" charset="0"/>
              <a:cs typeface="Helvetica" panose="020B0604020202020204" pitchFamily="34" charset="0"/>
            </a:endParaRPr>
          </a:p>
        </p:txBody>
      </p:sp>
      <p:sp>
        <p:nvSpPr>
          <p:cNvPr id="11" name="TextBox 10">
            <a:extLst>
              <a:ext uri="{FF2B5EF4-FFF2-40B4-BE49-F238E27FC236}">
                <a16:creationId xmlns:a16="http://schemas.microsoft.com/office/drawing/2014/main" id="{B2966683-21D0-76A1-166B-13D7A5E2C2EB}"/>
              </a:ext>
            </a:extLst>
          </p:cNvPr>
          <p:cNvSpPr txBox="1"/>
          <p:nvPr/>
        </p:nvSpPr>
        <p:spPr>
          <a:xfrm>
            <a:off x="4378405" y="5433715"/>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2" name="TextBox 11">
            <a:extLst>
              <a:ext uri="{FF2B5EF4-FFF2-40B4-BE49-F238E27FC236}">
                <a16:creationId xmlns:a16="http://schemas.microsoft.com/office/drawing/2014/main" id="{DF105A69-ED5A-E6A1-5492-712C35C7ABB6}"/>
              </a:ext>
            </a:extLst>
          </p:cNvPr>
          <p:cNvSpPr txBox="1"/>
          <p:nvPr/>
        </p:nvSpPr>
        <p:spPr>
          <a:xfrm>
            <a:off x="5163619" y="5448122"/>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3" name="TextBox 12">
            <a:extLst>
              <a:ext uri="{FF2B5EF4-FFF2-40B4-BE49-F238E27FC236}">
                <a16:creationId xmlns:a16="http://schemas.microsoft.com/office/drawing/2014/main" id="{6A9B68CA-D400-36D4-88CB-67F5BB5AE7A3}"/>
              </a:ext>
            </a:extLst>
          </p:cNvPr>
          <p:cNvSpPr txBox="1"/>
          <p:nvPr/>
        </p:nvSpPr>
        <p:spPr>
          <a:xfrm>
            <a:off x="1243440" y="5783291"/>
            <a:ext cx="492009"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
        <p:nvSpPr>
          <p:cNvPr id="14" name="TextBox 13">
            <a:extLst>
              <a:ext uri="{FF2B5EF4-FFF2-40B4-BE49-F238E27FC236}">
                <a16:creationId xmlns:a16="http://schemas.microsoft.com/office/drawing/2014/main" id="{5A725DE5-9187-BA40-134A-A9C92C580A23}"/>
              </a:ext>
            </a:extLst>
          </p:cNvPr>
          <p:cNvSpPr txBox="1"/>
          <p:nvPr/>
        </p:nvSpPr>
        <p:spPr>
          <a:xfrm>
            <a:off x="1801201" y="5783290"/>
            <a:ext cx="511954" cy="246221"/>
          </a:xfrm>
          <a:prstGeom prst="rect">
            <a:avLst/>
          </a:prstGeom>
          <a:noFill/>
        </p:spPr>
        <p:txBody>
          <a:bodyPr wrap="square">
            <a:spAutoFit/>
          </a:bodyPr>
          <a:lstStyle/>
          <a:p>
            <a:r>
              <a:rPr lang="en-US" sz="1000" b="1">
                <a:latin typeface="Helvetica" panose="020B0604020202020204" pitchFamily="34" charset="0"/>
                <a:cs typeface="Helvetica" panose="020B0604020202020204" pitchFamily="34" charset="0"/>
              </a:rPr>
              <a:t>Si (+)</a:t>
            </a:r>
            <a:endParaRPr lang="en-US" sz="100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8454448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1480AE0-CD30-03E5-6124-496AC4D0B0E4}"/>
              </a:ext>
            </a:extLst>
          </p:cNvPr>
          <p:cNvSpPr txBox="1"/>
          <p:nvPr/>
        </p:nvSpPr>
        <p:spPr>
          <a:xfrm>
            <a:off x="716773" y="6314313"/>
            <a:ext cx="6697980" cy="276999"/>
          </a:xfrm>
          <a:prstGeom prst="rect">
            <a:avLst/>
          </a:prstGeom>
          <a:noFill/>
        </p:spPr>
        <p:txBody>
          <a:bodyPr wrap="square" rtlCol="0">
            <a:spAutoFit/>
          </a:bodyPr>
          <a:lstStyle/>
          <a:p>
            <a:r>
              <a:rPr lang="en-US" sz="1200" b="1">
                <a:latin typeface="Times New Roman" panose="02020603050405020304" pitchFamily="18" charset="0"/>
                <a:cs typeface="Times New Roman" panose="02020603050405020304" pitchFamily="18" charset="0"/>
              </a:rPr>
              <a:t>Supplementary figure S6. </a:t>
            </a:r>
            <a:r>
              <a:rPr lang="en-US" sz="1200">
                <a:latin typeface="Times New Roman" panose="02020603050405020304" pitchFamily="18" charset="0"/>
                <a:cs typeface="Times New Roman" panose="02020603050405020304" pitchFamily="18" charset="0"/>
              </a:rPr>
              <a:t>Dot plot of GO term enrichment in mesophyll cells.</a:t>
            </a:r>
          </a:p>
        </p:txBody>
      </p:sp>
      <p:pic>
        <p:nvPicPr>
          <p:cNvPr id="5" name="Picture 4">
            <a:extLst>
              <a:ext uri="{FF2B5EF4-FFF2-40B4-BE49-F238E27FC236}">
                <a16:creationId xmlns:a16="http://schemas.microsoft.com/office/drawing/2014/main" id="{A6141967-F6D9-7A68-3840-66656DA838B0}"/>
              </a:ext>
            </a:extLst>
          </p:cNvPr>
          <p:cNvPicPr>
            <a:picLocks noChangeAspect="1"/>
          </p:cNvPicPr>
          <p:nvPr/>
        </p:nvPicPr>
        <p:blipFill rotWithShape="1">
          <a:blip r:embed="rId2"/>
          <a:srcRect b="6810"/>
          <a:stretch/>
        </p:blipFill>
        <p:spPr>
          <a:xfrm>
            <a:off x="1833961" y="859373"/>
            <a:ext cx="2814239" cy="5099467"/>
          </a:xfrm>
          <a:prstGeom prst="rect">
            <a:avLst/>
          </a:prstGeom>
        </p:spPr>
      </p:pic>
      <p:sp>
        <p:nvSpPr>
          <p:cNvPr id="7" name="TextBox 6">
            <a:extLst>
              <a:ext uri="{FF2B5EF4-FFF2-40B4-BE49-F238E27FC236}">
                <a16:creationId xmlns:a16="http://schemas.microsoft.com/office/drawing/2014/main" id="{E1BDD04C-A68A-4796-F239-C8C2E0278FBB}"/>
              </a:ext>
            </a:extLst>
          </p:cNvPr>
          <p:cNvSpPr txBox="1"/>
          <p:nvPr/>
        </p:nvSpPr>
        <p:spPr>
          <a:xfrm>
            <a:off x="2981538" y="821273"/>
            <a:ext cx="990388" cy="261610"/>
          </a:xfrm>
          <a:prstGeom prst="rect">
            <a:avLst/>
          </a:prstGeom>
          <a:noFill/>
        </p:spPr>
        <p:txBody>
          <a:bodyPr wrap="square">
            <a:spAutoFit/>
          </a:bodyPr>
          <a:lstStyle/>
          <a:p>
            <a:r>
              <a:rPr lang="en-US" sz="1100" b="1">
                <a:latin typeface="Helvetica" panose="020B0604020202020204" pitchFamily="34" charset="0"/>
                <a:cs typeface="Helvetica" panose="020B0604020202020204" pitchFamily="34" charset="0"/>
              </a:rPr>
              <a:t>Mesophyll</a:t>
            </a:r>
            <a:endParaRPr lang="en-US" sz="1100">
              <a:latin typeface="Helvetica" panose="020B0604020202020204" pitchFamily="34" charset="0"/>
              <a:cs typeface="Helvetica" panose="020B0604020202020204" pitchFamily="34" charset="0"/>
            </a:endParaRPr>
          </a:p>
        </p:txBody>
      </p:sp>
      <p:sp>
        <p:nvSpPr>
          <p:cNvPr id="2" name="TextBox 1">
            <a:extLst>
              <a:ext uri="{FF2B5EF4-FFF2-40B4-BE49-F238E27FC236}">
                <a16:creationId xmlns:a16="http://schemas.microsoft.com/office/drawing/2014/main" id="{947B93A9-A70A-A148-197E-C2100B867378}"/>
              </a:ext>
            </a:extLst>
          </p:cNvPr>
          <p:cNvSpPr txBox="1"/>
          <p:nvPr/>
        </p:nvSpPr>
        <p:spPr>
          <a:xfrm>
            <a:off x="2874155" y="5912004"/>
            <a:ext cx="492009" cy="230832"/>
          </a:xfrm>
          <a:prstGeom prst="rect">
            <a:avLst/>
          </a:prstGeom>
          <a:noFill/>
        </p:spPr>
        <p:txBody>
          <a:bodyPr wrap="square">
            <a:spAutoFit/>
          </a:bodyPr>
          <a:lstStyle/>
          <a:p>
            <a:r>
              <a:rPr lang="en-US" sz="900" b="1">
                <a:latin typeface="Helvetica" panose="020B0604020202020204" pitchFamily="34" charset="0"/>
                <a:cs typeface="Helvetica" panose="020B0604020202020204" pitchFamily="34" charset="0"/>
              </a:rPr>
              <a:t>Si (-)</a:t>
            </a:r>
            <a:endParaRPr lang="en-US" sz="900">
              <a:latin typeface="Helvetica" panose="020B0604020202020204" pitchFamily="34" charset="0"/>
              <a:cs typeface="Helvetica" panose="020B0604020202020204" pitchFamily="34" charset="0"/>
            </a:endParaRPr>
          </a:p>
        </p:txBody>
      </p:sp>
      <p:sp>
        <p:nvSpPr>
          <p:cNvPr id="3" name="TextBox 2">
            <a:extLst>
              <a:ext uri="{FF2B5EF4-FFF2-40B4-BE49-F238E27FC236}">
                <a16:creationId xmlns:a16="http://schemas.microsoft.com/office/drawing/2014/main" id="{34D27793-5376-A222-0EE6-6D27105549A1}"/>
              </a:ext>
            </a:extLst>
          </p:cNvPr>
          <p:cNvSpPr txBox="1"/>
          <p:nvPr/>
        </p:nvSpPr>
        <p:spPr>
          <a:xfrm>
            <a:off x="3428999" y="5912004"/>
            <a:ext cx="511954" cy="230832"/>
          </a:xfrm>
          <a:prstGeom prst="rect">
            <a:avLst/>
          </a:prstGeom>
          <a:noFill/>
        </p:spPr>
        <p:txBody>
          <a:bodyPr wrap="square">
            <a:spAutoFit/>
          </a:bodyPr>
          <a:lstStyle/>
          <a:p>
            <a:r>
              <a:rPr lang="en-US" sz="900" b="1">
                <a:latin typeface="Helvetica" panose="020B0604020202020204" pitchFamily="34" charset="0"/>
                <a:cs typeface="Helvetica" panose="020B0604020202020204" pitchFamily="34" charset="0"/>
              </a:rPr>
              <a:t>Si (+)</a:t>
            </a:r>
            <a:endParaRPr lang="en-US" sz="90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4175034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9ABEC9B-7711-5DEE-1919-B3C572856D23}"/>
              </a:ext>
            </a:extLst>
          </p:cNvPr>
          <p:cNvSpPr txBox="1"/>
          <p:nvPr/>
        </p:nvSpPr>
        <p:spPr>
          <a:xfrm>
            <a:off x="339282" y="6451381"/>
            <a:ext cx="5958792" cy="1077218"/>
          </a:xfrm>
          <a:prstGeom prst="rect">
            <a:avLst/>
          </a:prstGeom>
          <a:noFill/>
        </p:spPr>
        <p:txBody>
          <a:bodyPr wrap="square" rtlCol="0">
            <a:spAutoFit/>
          </a:bodyPr>
          <a:lstStyle/>
          <a:p>
            <a:r>
              <a:rPr lang="en-US" sz="1400" b="1">
                <a:latin typeface="Times New Roman" panose="02020603050405020304" pitchFamily="18" charset="0"/>
                <a:cs typeface="Times New Roman" panose="02020603050405020304" pitchFamily="18" charset="0"/>
              </a:rPr>
              <a:t>Supplementary Figure S7. UMAP plot depicts expression of  putative phytoalexin biosynthesis activator genes. (</a:t>
            </a:r>
            <a:r>
              <a:rPr lang="en-US" sz="1200" b="1">
                <a:latin typeface="Times New Roman" panose="02020603050405020304" pitchFamily="18" charset="0"/>
                <a:cs typeface="Times New Roman" panose="02020603050405020304" pitchFamily="18" charset="0"/>
              </a:rPr>
              <a:t>A) </a:t>
            </a:r>
            <a:r>
              <a:rPr lang="en-US" sz="1200">
                <a:latin typeface="Times New Roman" panose="02020603050405020304" pitchFamily="18" charset="0"/>
                <a:cs typeface="Times New Roman" panose="02020603050405020304" pitchFamily="18" charset="0"/>
              </a:rPr>
              <a:t>UMAP plot exhibits expression of </a:t>
            </a:r>
            <a:r>
              <a:rPr lang="en-US" sz="1200" i="1">
                <a:latin typeface="Times New Roman" panose="02020603050405020304" pitchFamily="18" charset="0"/>
                <a:cs typeface="Times New Roman" panose="02020603050405020304" pitchFamily="18" charset="0"/>
              </a:rPr>
              <a:t>GmWRKY33b</a:t>
            </a:r>
            <a:r>
              <a:rPr lang="en-US" sz="1200">
                <a:latin typeface="Times New Roman" panose="02020603050405020304" pitchFamily="18" charset="0"/>
                <a:cs typeface="Times New Roman" panose="02020603050405020304" pitchFamily="18" charset="0"/>
              </a:rPr>
              <a:t> and </a:t>
            </a:r>
            <a:r>
              <a:rPr lang="en-US" sz="1200" i="1">
                <a:latin typeface="Times New Roman" panose="02020603050405020304" pitchFamily="18" charset="0"/>
                <a:cs typeface="Times New Roman" panose="02020603050405020304" pitchFamily="18" charset="0"/>
              </a:rPr>
              <a:t>GmWRKY33c</a:t>
            </a:r>
            <a:r>
              <a:rPr lang="en-US" sz="1200">
                <a:latin typeface="Times New Roman" panose="02020603050405020304" pitchFamily="18" charset="0"/>
                <a:cs typeface="Times New Roman" panose="02020603050405020304" pitchFamily="18" charset="0"/>
              </a:rPr>
              <a:t>. </a:t>
            </a:r>
            <a:r>
              <a:rPr lang="en-US" sz="1200" b="1">
                <a:latin typeface="Times New Roman" panose="02020603050405020304" pitchFamily="18" charset="0"/>
                <a:cs typeface="Times New Roman" panose="02020603050405020304" pitchFamily="18" charset="0"/>
              </a:rPr>
              <a:t>(B) </a:t>
            </a:r>
            <a:r>
              <a:rPr lang="en-US" sz="1200">
                <a:latin typeface="Times New Roman" panose="02020603050405020304" pitchFamily="18" charset="0"/>
                <a:cs typeface="Times New Roman" panose="02020603050405020304" pitchFamily="18" charset="0"/>
              </a:rPr>
              <a:t>UMAP plot exhibits expression of </a:t>
            </a:r>
            <a:r>
              <a:rPr lang="en-US" sz="1200" i="1">
                <a:latin typeface="Times New Roman" panose="02020603050405020304" pitchFamily="18" charset="0"/>
                <a:cs typeface="Times New Roman" panose="02020603050405020304" pitchFamily="18" charset="0"/>
              </a:rPr>
              <a:t>GmCRT3b</a:t>
            </a:r>
            <a:r>
              <a:rPr lang="en-US" sz="1200">
                <a:latin typeface="Times New Roman" panose="02020603050405020304" pitchFamily="18" charset="0"/>
                <a:cs typeface="Times New Roman" panose="02020603050405020304" pitchFamily="18" charset="0"/>
              </a:rPr>
              <a:t> gene. The color depicts relative gene expression (dark purple = higher expression, Green = medium expression, Yellow = lower expression). </a:t>
            </a:r>
            <a:endParaRPr lang="en-US" sz="1600" b="1">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768ADAE3-6334-88B4-1D66-D57F1415B718}"/>
              </a:ext>
            </a:extLst>
          </p:cNvPr>
          <p:cNvSpPr txBox="1"/>
          <p:nvPr/>
        </p:nvSpPr>
        <p:spPr>
          <a:xfrm>
            <a:off x="529995" y="368565"/>
            <a:ext cx="427008" cy="338554"/>
          </a:xfrm>
          <a:prstGeom prst="rect">
            <a:avLst/>
          </a:prstGeom>
          <a:noFill/>
        </p:spPr>
        <p:txBody>
          <a:bodyPr wrap="square" rtlCol="0">
            <a:spAutoFit/>
          </a:bodyPr>
          <a:lstStyle/>
          <a:p>
            <a:r>
              <a:rPr lang="en-US" sz="1600" b="1">
                <a:latin typeface="Helvetica" panose="020B0604020202020204" pitchFamily="34" charset="0"/>
                <a:cs typeface="Helvetica" panose="020B0604020202020204" pitchFamily="34" charset="0"/>
              </a:rPr>
              <a:t>A</a:t>
            </a:r>
          </a:p>
        </p:txBody>
      </p:sp>
      <p:sp>
        <p:nvSpPr>
          <p:cNvPr id="7" name="TextBox 6">
            <a:extLst>
              <a:ext uri="{FF2B5EF4-FFF2-40B4-BE49-F238E27FC236}">
                <a16:creationId xmlns:a16="http://schemas.microsoft.com/office/drawing/2014/main" id="{687D80C2-7157-82E2-4F15-E738AACCD512}"/>
              </a:ext>
            </a:extLst>
          </p:cNvPr>
          <p:cNvSpPr txBox="1"/>
          <p:nvPr/>
        </p:nvSpPr>
        <p:spPr>
          <a:xfrm>
            <a:off x="529995" y="4333287"/>
            <a:ext cx="293021" cy="338554"/>
          </a:xfrm>
          <a:prstGeom prst="rect">
            <a:avLst/>
          </a:prstGeom>
          <a:noFill/>
          <a:ln>
            <a:noFill/>
          </a:ln>
        </p:spPr>
        <p:txBody>
          <a:bodyPr wrap="square" rtlCol="0">
            <a:spAutoFit/>
          </a:bodyPr>
          <a:lstStyle/>
          <a:p>
            <a:r>
              <a:rPr lang="en-US" sz="1600" b="1">
                <a:latin typeface="Helvetica" panose="020B0604020202020204" pitchFamily="34" charset="0"/>
                <a:cs typeface="Helvetica" panose="020B0604020202020204" pitchFamily="34" charset="0"/>
              </a:rPr>
              <a:t>B</a:t>
            </a:r>
          </a:p>
        </p:txBody>
      </p:sp>
      <p:grpSp>
        <p:nvGrpSpPr>
          <p:cNvPr id="27" name="Group 26">
            <a:extLst>
              <a:ext uri="{FF2B5EF4-FFF2-40B4-BE49-F238E27FC236}">
                <a16:creationId xmlns:a16="http://schemas.microsoft.com/office/drawing/2014/main" id="{67B25A3F-81F5-AA0C-689D-CB2DEE57F6E2}"/>
              </a:ext>
            </a:extLst>
          </p:cNvPr>
          <p:cNvGrpSpPr/>
          <p:nvPr/>
        </p:nvGrpSpPr>
        <p:grpSpPr>
          <a:xfrm>
            <a:off x="895607" y="630989"/>
            <a:ext cx="4608832" cy="3580228"/>
            <a:chOff x="794441" y="1554844"/>
            <a:chExt cx="4608832" cy="3580228"/>
          </a:xfrm>
        </p:grpSpPr>
        <p:pic>
          <p:nvPicPr>
            <p:cNvPr id="14" name="Picture 13" descr="A diagram of a graph&#10;&#10;Description automatically generated with medium confidence">
              <a:extLst>
                <a:ext uri="{FF2B5EF4-FFF2-40B4-BE49-F238E27FC236}">
                  <a16:creationId xmlns:a16="http://schemas.microsoft.com/office/drawing/2014/main" id="{18E808FE-3EC6-BFF3-1185-6BF7863BC5A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94441" y="3459133"/>
              <a:ext cx="4608832" cy="1675939"/>
            </a:xfrm>
            <a:prstGeom prst="rect">
              <a:avLst/>
            </a:prstGeom>
          </p:spPr>
        </p:pic>
        <p:pic>
          <p:nvPicPr>
            <p:cNvPr id="16" name="Picture 15" descr="A graph of different colors&#10;&#10;Description automatically generated with medium confidence">
              <a:extLst>
                <a:ext uri="{FF2B5EF4-FFF2-40B4-BE49-F238E27FC236}">
                  <a16:creationId xmlns:a16="http://schemas.microsoft.com/office/drawing/2014/main" id="{114B3300-01A6-F68F-BDC5-E897144152B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94441" y="1554844"/>
              <a:ext cx="4608832" cy="1675939"/>
            </a:xfrm>
            <a:prstGeom prst="rect">
              <a:avLst/>
            </a:prstGeom>
          </p:spPr>
        </p:pic>
        <p:sp>
          <p:nvSpPr>
            <p:cNvPr id="12" name="Rectangle 11">
              <a:extLst>
                <a:ext uri="{FF2B5EF4-FFF2-40B4-BE49-F238E27FC236}">
                  <a16:creationId xmlns:a16="http://schemas.microsoft.com/office/drawing/2014/main" id="{20CC143D-52B9-5A3A-2FE2-1A36A52483C7}"/>
                </a:ext>
              </a:extLst>
            </p:cNvPr>
            <p:cNvSpPr/>
            <p:nvPr/>
          </p:nvSpPr>
          <p:spPr>
            <a:xfrm>
              <a:off x="4222865" y="3895319"/>
              <a:ext cx="1129289" cy="29113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3" name="Rectangle 12">
              <a:extLst>
                <a:ext uri="{FF2B5EF4-FFF2-40B4-BE49-F238E27FC236}">
                  <a16:creationId xmlns:a16="http://schemas.microsoft.com/office/drawing/2014/main" id="{9BF13D69-9B0F-AA2D-89C7-FD50694D357B}"/>
                </a:ext>
              </a:extLst>
            </p:cNvPr>
            <p:cNvSpPr/>
            <p:nvPr/>
          </p:nvSpPr>
          <p:spPr>
            <a:xfrm>
              <a:off x="4222864" y="1987806"/>
              <a:ext cx="1129290" cy="29113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3" name="TextBox 2">
              <a:extLst>
                <a:ext uri="{FF2B5EF4-FFF2-40B4-BE49-F238E27FC236}">
                  <a16:creationId xmlns:a16="http://schemas.microsoft.com/office/drawing/2014/main" id="{844CC83F-FB26-61D6-19AD-52B1310FEFF8}"/>
                </a:ext>
              </a:extLst>
            </p:cNvPr>
            <p:cNvSpPr txBox="1"/>
            <p:nvPr/>
          </p:nvSpPr>
          <p:spPr>
            <a:xfrm>
              <a:off x="4086485" y="1879457"/>
              <a:ext cx="1172400" cy="253916"/>
            </a:xfrm>
            <a:prstGeom prst="rect">
              <a:avLst/>
            </a:prstGeom>
            <a:noFill/>
          </p:spPr>
          <p:txBody>
            <a:bodyPr wrap="square" rtlCol="0">
              <a:spAutoFit/>
            </a:bodyPr>
            <a:lstStyle/>
            <a:p>
              <a:r>
                <a:rPr lang="en-US" sz="1050" b="1" i="1">
                  <a:latin typeface="Helvetica" panose="020B0604020202020204" pitchFamily="34" charset="0"/>
                  <a:cs typeface="Helvetica" panose="020B0604020202020204" pitchFamily="34" charset="0"/>
                </a:rPr>
                <a:t>GmWRKY33b</a:t>
              </a:r>
            </a:p>
          </p:txBody>
        </p:sp>
        <p:sp>
          <p:nvSpPr>
            <p:cNvPr id="10" name="TextBox 9">
              <a:extLst>
                <a:ext uri="{FF2B5EF4-FFF2-40B4-BE49-F238E27FC236}">
                  <a16:creationId xmlns:a16="http://schemas.microsoft.com/office/drawing/2014/main" id="{A2A2E485-B177-38CE-A4D3-E66D355631FB}"/>
                </a:ext>
              </a:extLst>
            </p:cNvPr>
            <p:cNvSpPr txBox="1"/>
            <p:nvPr/>
          </p:nvSpPr>
          <p:spPr>
            <a:xfrm>
              <a:off x="4108041" y="3809530"/>
              <a:ext cx="1129289" cy="253916"/>
            </a:xfrm>
            <a:prstGeom prst="rect">
              <a:avLst/>
            </a:prstGeom>
            <a:noFill/>
          </p:spPr>
          <p:txBody>
            <a:bodyPr wrap="square" rtlCol="0">
              <a:spAutoFit/>
            </a:bodyPr>
            <a:lstStyle/>
            <a:p>
              <a:r>
                <a:rPr lang="en-US" sz="1050" b="1" i="1">
                  <a:latin typeface="Helvetica" panose="020B0604020202020204" pitchFamily="34" charset="0"/>
                  <a:cs typeface="Helvetica" panose="020B0604020202020204" pitchFamily="34" charset="0"/>
                </a:rPr>
                <a:t>GmWRKY33c</a:t>
              </a:r>
            </a:p>
          </p:txBody>
        </p:sp>
        <p:sp>
          <p:nvSpPr>
            <p:cNvPr id="11" name="Rectangle 10">
              <a:extLst>
                <a:ext uri="{FF2B5EF4-FFF2-40B4-BE49-F238E27FC236}">
                  <a16:creationId xmlns:a16="http://schemas.microsoft.com/office/drawing/2014/main" id="{2E373D25-1465-3B00-6D60-0393E93954B5}"/>
                </a:ext>
              </a:extLst>
            </p:cNvPr>
            <p:cNvSpPr/>
            <p:nvPr/>
          </p:nvSpPr>
          <p:spPr>
            <a:xfrm>
              <a:off x="1457325" y="3459133"/>
              <a:ext cx="685800" cy="2469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7" name="Rectangle 16">
              <a:extLst>
                <a:ext uri="{FF2B5EF4-FFF2-40B4-BE49-F238E27FC236}">
                  <a16:creationId xmlns:a16="http://schemas.microsoft.com/office/drawing/2014/main" id="{D114B789-559F-75F6-8FC6-CA9299F19C0B}"/>
                </a:ext>
              </a:extLst>
            </p:cNvPr>
            <p:cNvSpPr/>
            <p:nvPr/>
          </p:nvSpPr>
          <p:spPr>
            <a:xfrm>
              <a:off x="1468118" y="1581794"/>
              <a:ext cx="685800" cy="2469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8" name="Rectangle 17">
              <a:extLst>
                <a:ext uri="{FF2B5EF4-FFF2-40B4-BE49-F238E27FC236}">
                  <a16:creationId xmlns:a16="http://schemas.microsoft.com/office/drawing/2014/main" id="{960DF679-7213-653B-F493-8B5F28F4D5E8}"/>
                </a:ext>
              </a:extLst>
            </p:cNvPr>
            <p:cNvSpPr/>
            <p:nvPr/>
          </p:nvSpPr>
          <p:spPr>
            <a:xfrm>
              <a:off x="3098857" y="1605605"/>
              <a:ext cx="685800" cy="2469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19" name="Rectangle 18">
              <a:extLst>
                <a:ext uri="{FF2B5EF4-FFF2-40B4-BE49-F238E27FC236}">
                  <a16:creationId xmlns:a16="http://schemas.microsoft.com/office/drawing/2014/main" id="{B8E01842-BC3E-B15D-6CCB-C2981BD13501}"/>
                </a:ext>
              </a:extLst>
            </p:cNvPr>
            <p:cNvSpPr/>
            <p:nvPr/>
          </p:nvSpPr>
          <p:spPr>
            <a:xfrm>
              <a:off x="3098857" y="3459132"/>
              <a:ext cx="685800" cy="2469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5" name="TextBox 4">
              <a:extLst>
                <a:ext uri="{FF2B5EF4-FFF2-40B4-BE49-F238E27FC236}">
                  <a16:creationId xmlns:a16="http://schemas.microsoft.com/office/drawing/2014/main" id="{8960662B-F76F-2080-DE80-0C3E6D4E7450}"/>
                </a:ext>
              </a:extLst>
            </p:cNvPr>
            <p:cNvSpPr txBox="1"/>
            <p:nvPr/>
          </p:nvSpPr>
          <p:spPr>
            <a:xfrm>
              <a:off x="1560077" y="1605605"/>
              <a:ext cx="501882"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sp>
          <p:nvSpPr>
            <p:cNvPr id="6" name="TextBox 5">
              <a:extLst>
                <a:ext uri="{FF2B5EF4-FFF2-40B4-BE49-F238E27FC236}">
                  <a16:creationId xmlns:a16="http://schemas.microsoft.com/office/drawing/2014/main" id="{BAD975C2-5195-6554-8FD0-947A298FE51E}"/>
                </a:ext>
              </a:extLst>
            </p:cNvPr>
            <p:cNvSpPr txBox="1"/>
            <p:nvPr/>
          </p:nvSpPr>
          <p:spPr>
            <a:xfrm>
              <a:off x="3217512" y="1604861"/>
              <a:ext cx="515104"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sp>
          <p:nvSpPr>
            <p:cNvPr id="22" name="TextBox 21">
              <a:extLst>
                <a:ext uri="{FF2B5EF4-FFF2-40B4-BE49-F238E27FC236}">
                  <a16:creationId xmlns:a16="http://schemas.microsoft.com/office/drawing/2014/main" id="{4A4ABF86-6944-3665-C48A-F7A09380ECC1}"/>
                </a:ext>
              </a:extLst>
            </p:cNvPr>
            <p:cNvSpPr txBox="1"/>
            <p:nvPr/>
          </p:nvSpPr>
          <p:spPr>
            <a:xfrm>
              <a:off x="1526469" y="3453694"/>
              <a:ext cx="501882"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sp>
          <p:nvSpPr>
            <p:cNvPr id="23" name="TextBox 22">
              <a:extLst>
                <a:ext uri="{FF2B5EF4-FFF2-40B4-BE49-F238E27FC236}">
                  <a16:creationId xmlns:a16="http://schemas.microsoft.com/office/drawing/2014/main" id="{FB5CF552-A5E3-4F48-1AD1-D0608C575C78}"/>
                </a:ext>
              </a:extLst>
            </p:cNvPr>
            <p:cNvSpPr txBox="1"/>
            <p:nvPr/>
          </p:nvSpPr>
          <p:spPr>
            <a:xfrm>
              <a:off x="3171448" y="3453694"/>
              <a:ext cx="515104"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grpSp>
      <p:grpSp>
        <p:nvGrpSpPr>
          <p:cNvPr id="26" name="Group 25">
            <a:extLst>
              <a:ext uri="{FF2B5EF4-FFF2-40B4-BE49-F238E27FC236}">
                <a16:creationId xmlns:a16="http://schemas.microsoft.com/office/drawing/2014/main" id="{93FF2E7F-9493-4BB3-2936-2A170B084C33}"/>
              </a:ext>
            </a:extLst>
          </p:cNvPr>
          <p:cNvGrpSpPr/>
          <p:nvPr/>
        </p:nvGrpSpPr>
        <p:grpSpPr>
          <a:xfrm>
            <a:off x="836829" y="4647403"/>
            <a:ext cx="4557713" cy="1657350"/>
            <a:chOff x="794441" y="5610361"/>
            <a:chExt cx="4557713" cy="1657350"/>
          </a:xfrm>
        </p:grpSpPr>
        <p:pic>
          <p:nvPicPr>
            <p:cNvPr id="8" name="Picture 7" descr="A graph of different colors&#10;&#10;Description automatically generated with medium confidence">
              <a:extLst>
                <a:ext uri="{FF2B5EF4-FFF2-40B4-BE49-F238E27FC236}">
                  <a16:creationId xmlns:a16="http://schemas.microsoft.com/office/drawing/2014/main" id="{BCE986FA-D422-0FE5-E02A-652B88F0FD6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4441" y="5610361"/>
              <a:ext cx="4557713" cy="1657350"/>
            </a:xfrm>
            <a:prstGeom prst="rect">
              <a:avLst/>
            </a:prstGeom>
          </p:spPr>
        </p:pic>
        <p:sp>
          <p:nvSpPr>
            <p:cNvPr id="15" name="Rectangle 14">
              <a:extLst>
                <a:ext uri="{FF2B5EF4-FFF2-40B4-BE49-F238E27FC236}">
                  <a16:creationId xmlns:a16="http://schemas.microsoft.com/office/drawing/2014/main" id="{C42B5232-858A-FF08-0929-C04AC307F99E}"/>
                </a:ext>
              </a:extLst>
            </p:cNvPr>
            <p:cNvSpPr/>
            <p:nvPr/>
          </p:nvSpPr>
          <p:spPr>
            <a:xfrm>
              <a:off x="4222864" y="6014942"/>
              <a:ext cx="1129289" cy="32493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9" name="TextBox 8">
              <a:extLst>
                <a:ext uri="{FF2B5EF4-FFF2-40B4-BE49-F238E27FC236}">
                  <a16:creationId xmlns:a16="http://schemas.microsoft.com/office/drawing/2014/main" id="{A445E8BB-8C62-23B5-665E-0E77CE890546}"/>
                </a:ext>
              </a:extLst>
            </p:cNvPr>
            <p:cNvSpPr txBox="1"/>
            <p:nvPr/>
          </p:nvSpPr>
          <p:spPr>
            <a:xfrm>
              <a:off x="4092836" y="5931189"/>
              <a:ext cx="831014" cy="246221"/>
            </a:xfrm>
            <a:prstGeom prst="rect">
              <a:avLst/>
            </a:prstGeom>
            <a:noFill/>
          </p:spPr>
          <p:txBody>
            <a:bodyPr wrap="square" rtlCol="0">
              <a:spAutoFit/>
            </a:bodyPr>
            <a:lstStyle/>
            <a:p>
              <a:r>
                <a:rPr lang="en-US" sz="1000" b="1" i="1">
                  <a:latin typeface="Helvetica" panose="020B0604020202020204" pitchFamily="34" charset="0"/>
                  <a:cs typeface="Helvetica" panose="020B0604020202020204" pitchFamily="34" charset="0"/>
                </a:rPr>
                <a:t>GmCRT3b</a:t>
              </a:r>
            </a:p>
          </p:txBody>
        </p:sp>
        <p:sp>
          <p:nvSpPr>
            <p:cNvPr id="20" name="Rectangle 19">
              <a:extLst>
                <a:ext uri="{FF2B5EF4-FFF2-40B4-BE49-F238E27FC236}">
                  <a16:creationId xmlns:a16="http://schemas.microsoft.com/office/drawing/2014/main" id="{584CA6F3-4056-44C8-4705-A020560CEA68}"/>
                </a:ext>
              </a:extLst>
            </p:cNvPr>
            <p:cNvSpPr/>
            <p:nvPr/>
          </p:nvSpPr>
          <p:spPr>
            <a:xfrm>
              <a:off x="3098857" y="5619750"/>
              <a:ext cx="685800" cy="2469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21" name="Rectangle 20">
              <a:extLst>
                <a:ext uri="{FF2B5EF4-FFF2-40B4-BE49-F238E27FC236}">
                  <a16:creationId xmlns:a16="http://schemas.microsoft.com/office/drawing/2014/main" id="{F19AB2DB-42E8-1B34-0B27-FFE25348E6BF}"/>
                </a:ext>
              </a:extLst>
            </p:cNvPr>
            <p:cNvSpPr/>
            <p:nvPr/>
          </p:nvSpPr>
          <p:spPr>
            <a:xfrm>
              <a:off x="1457325" y="5644859"/>
              <a:ext cx="685800" cy="2469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sp>
          <p:nvSpPr>
            <p:cNvPr id="24" name="TextBox 23">
              <a:extLst>
                <a:ext uri="{FF2B5EF4-FFF2-40B4-BE49-F238E27FC236}">
                  <a16:creationId xmlns:a16="http://schemas.microsoft.com/office/drawing/2014/main" id="{A66CC2DF-12A6-0086-DDB5-997D388CA85E}"/>
                </a:ext>
              </a:extLst>
            </p:cNvPr>
            <p:cNvSpPr txBox="1"/>
            <p:nvPr/>
          </p:nvSpPr>
          <p:spPr>
            <a:xfrm>
              <a:off x="1585833" y="5644859"/>
              <a:ext cx="501882"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sp>
          <p:nvSpPr>
            <p:cNvPr id="25" name="TextBox 24">
              <a:extLst>
                <a:ext uri="{FF2B5EF4-FFF2-40B4-BE49-F238E27FC236}">
                  <a16:creationId xmlns:a16="http://schemas.microsoft.com/office/drawing/2014/main" id="{808A03A3-9D71-A24D-AC3D-D7C07236328A}"/>
                </a:ext>
              </a:extLst>
            </p:cNvPr>
            <p:cNvSpPr txBox="1"/>
            <p:nvPr/>
          </p:nvSpPr>
          <p:spPr>
            <a:xfrm>
              <a:off x="3171448" y="5617030"/>
              <a:ext cx="515104"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grpSp>
    </p:spTree>
    <p:extLst>
      <p:ext uri="{BB962C8B-B14F-4D97-AF65-F5344CB8AC3E}">
        <p14:creationId xmlns:p14="http://schemas.microsoft.com/office/powerpoint/2010/main" val="34369638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880AF6A-641C-F67F-BA37-ED8AA5C0C046}"/>
              </a:ext>
            </a:extLst>
          </p:cNvPr>
          <p:cNvSpPr txBox="1"/>
          <p:nvPr/>
        </p:nvSpPr>
        <p:spPr>
          <a:xfrm>
            <a:off x="210685" y="6379923"/>
            <a:ext cx="6436630" cy="523220"/>
          </a:xfrm>
          <a:prstGeom prst="rect">
            <a:avLst/>
          </a:prstGeom>
          <a:noFill/>
        </p:spPr>
        <p:txBody>
          <a:bodyPr wrap="square">
            <a:spAutoFit/>
          </a:bodyPr>
          <a:lstStyle/>
          <a:p>
            <a:pPr algn="just"/>
            <a:r>
              <a:rPr lang="en-US" sz="1400" b="1">
                <a:latin typeface="Times New Roman" panose="02020603050405020304" pitchFamily="18" charset="0"/>
                <a:cs typeface="Times New Roman" panose="02020603050405020304" pitchFamily="18" charset="0"/>
              </a:rPr>
              <a:t>Supplementary Figure S8. Heatmap and GO enrichment interactions of DEGs in Si-induced cell cluster. </a:t>
            </a:r>
            <a:r>
              <a:rPr lang="en-US" sz="1400">
                <a:latin typeface="Times New Roman" panose="02020603050405020304" pitchFamily="18" charset="0"/>
                <a:cs typeface="Times New Roman" panose="02020603050405020304" pitchFamily="18" charset="0"/>
              </a:rPr>
              <a:t>Dot size denotes enrichment of GO terms.</a:t>
            </a:r>
          </a:p>
        </p:txBody>
      </p:sp>
      <p:grpSp>
        <p:nvGrpSpPr>
          <p:cNvPr id="6" name="Group 5">
            <a:extLst>
              <a:ext uri="{FF2B5EF4-FFF2-40B4-BE49-F238E27FC236}">
                <a16:creationId xmlns:a16="http://schemas.microsoft.com/office/drawing/2014/main" id="{C8B11F69-8F86-4D40-56A4-13AE39FF4C0B}"/>
              </a:ext>
            </a:extLst>
          </p:cNvPr>
          <p:cNvGrpSpPr/>
          <p:nvPr/>
        </p:nvGrpSpPr>
        <p:grpSpPr>
          <a:xfrm>
            <a:off x="210685" y="936646"/>
            <a:ext cx="6515111" cy="4992857"/>
            <a:chOff x="147051" y="979318"/>
            <a:chExt cx="6515111" cy="4992857"/>
          </a:xfrm>
        </p:grpSpPr>
        <p:grpSp>
          <p:nvGrpSpPr>
            <p:cNvPr id="10" name="Group 9">
              <a:extLst>
                <a:ext uri="{FF2B5EF4-FFF2-40B4-BE49-F238E27FC236}">
                  <a16:creationId xmlns:a16="http://schemas.microsoft.com/office/drawing/2014/main" id="{8583F6A4-9124-5271-0AAB-B5DA6B0A3B0A}"/>
                </a:ext>
              </a:extLst>
            </p:cNvPr>
            <p:cNvGrpSpPr/>
            <p:nvPr/>
          </p:nvGrpSpPr>
          <p:grpSpPr>
            <a:xfrm>
              <a:off x="147051" y="979318"/>
              <a:ext cx="6436630" cy="4992857"/>
              <a:chOff x="1229438" y="1255854"/>
              <a:chExt cx="5124682" cy="4078147"/>
            </a:xfrm>
          </p:grpSpPr>
          <p:pic>
            <p:nvPicPr>
              <p:cNvPr id="8" name="Picture 7" descr="A diagram of a network&#10;&#10;Description automatically generated with medium confidence">
                <a:extLst>
                  <a:ext uri="{FF2B5EF4-FFF2-40B4-BE49-F238E27FC236}">
                    <a16:creationId xmlns:a16="http://schemas.microsoft.com/office/drawing/2014/main" id="{F28E4698-B4B2-FBFD-F248-233EAC108335}"/>
                  </a:ext>
                </a:extLst>
              </p:cNvPr>
              <p:cNvPicPr>
                <a:picLocks noChangeAspect="1"/>
              </p:cNvPicPr>
              <p:nvPr/>
            </p:nvPicPr>
            <p:blipFill rotWithShape="1">
              <a:blip r:embed="rId2">
                <a:extLst>
                  <a:ext uri="{28A0092B-C50C-407E-A947-70E740481C1C}">
                    <a14:useLocalDpi xmlns:a14="http://schemas.microsoft.com/office/drawing/2010/main" val="0"/>
                  </a:ext>
                </a:extLst>
              </a:blip>
              <a:srcRect l="13043" t="2255" r="12487" b="3621"/>
              <a:stretch/>
            </p:blipFill>
            <p:spPr>
              <a:xfrm>
                <a:off x="1229438" y="1255854"/>
                <a:ext cx="5124682" cy="4078147"/>
              </a:xfrm>
              <a:prstGeom prst="rect">
                <a:avLst/>
              </a:prstGeom>
            </p:spPr>
          </p:pic>
          <p:sp>
            <p:nvSpPr>
              <p:cNvPr id="9" name="Rectangle 8">
                <a:extLst>
                  <a:ext uri="{FF2B5EF4-FFF2-40B4-BE49-F238E27FC236}">
                    <a16:creationId xmlns:a16="http://schemas.microsoft.com/office/drawing/2014/main" id="{90EF4268-024E-FBBB-8A08-51E206243498}"/>
                  </a:ext>
                </a:extLst>
              </p:cNvPr>
              <p:cNvSpPr/>
              <p:nvPr/>
            </p:nvSpPr>
            <p:spPr>
              <a:xfrm>
                <a:off x="1285600" y="4975861"/>
                <a:ext cx="632460" cy="35814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Rectangle 1">
              <a:extLst>
                <a:ext uri="{FF2B5EF4-FFF2-40B4-BE49-F238E27FC236}">
                  <a16:creationId xmlns:a16="http://schemas.microsoft.com/office/drawing/2014/main" id="{2EB21F62-C436-6564-0995-ABB8D3D259F0}"/>
                </a:ext>
              </a:extLst>
            </p:cNvPr>
            <p:cNvSpPr/>
            <p:nvPr/>
          </p:nvSpPr>
          <p:spPr>
            <a:xfrm>
              <a:off x="6256020" y="3398520"/>
              <a:ext cx="327661" cy="37338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A0DFAA35-FB71-E974-E3E1-5430C9A1CFA2}"/>
                </a:ext>
              </a:extLst>
            </p:cNvPr>
            <p:cNvSpPr txBox="1"/>
            <p:nvPr/>
          </p:nvSpPr>
          <p:spPr>
            <a:xfrm>
              <a:off x="6149340" y="3375660"/>
              <a:ext cx="501882"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sp>
          <p:nvSpPr>
            <p:cNvPr id="4" name="TextBox 3">
              <a:extLst>
                <a:ext uri="{FF2B5EF4-FFF2-40B4-BE49-F238E27FC236}">
                  <a16:creationId xmlns:a16="http://schemas.microsoft.com/office/drawing/2014/main" id="{EB706579-382C-91AE-A253-8ABA917D46F5}"/>
                </a:ext>
              </a:extLst>
            </p:cNvPr>
            <p:cNvSpPr txBox="1"/>
            <p:nvPr/>
          </p:nvSpPr>
          <p:spPr>
            <a:xfrm>
              <a:off x="6147058" y="3527143"/>
              <a:ext cx="515104" cy="252377"/>
            </a:xfrm>
            <a:prstGeom prst="rect">
              <a:avLst/>
            </a:prstGeom>
            <a:noFill/>
            <a:ln>
              <a:noFill/>
            </a:ln>
          </p:spPr>
          <p:txBody>
            <a:bodyPr wrap="square" rtlCol="0">
              <a:spAutoFit/>
            </a:bodyPr>
            <a:lstStyle/>
            <a:p>
              <a:r>
                <a:rPr lang="en-US" sz="1040" b="1">
                  <a:latin typeface="Helvetica" panose="020B0604020202020204" pitchFamily="34" charset="0"/>
                  <a:cs typeface="Helvetica" panose="020B0604020202020204" pitchFamily="34" charset="0"/>
                </a:rPr>
                <a:t>Si (+)</a:t>
              </a:r>
            </a:p>
          </p:txBody>
        </p:sp>
      </p:grpSp>
    </p:spTree>
    <p:extLst>
      <p:ext uri="{BB962C8B-B14F-4D97-AF65-F5344CB8AC3E}">
        <p14:creationId xmlns:p14="http://schemas.microsoft.com/office/powerpoint/2010/main" val="94157076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1C45261-E6F1-BCD3-70E4-7B438A09B38F}"/>
              </a:ext>
            </a:extLst>
          </p:cNvPr>
          <p:cNvSpPr txBox="1"/>
          <p:nvPr/>
        </p:nvSpPr>
        <p:spPr>
          <a:xfrm>
            <a:off x="67216" y="8171048"/>
            <a:ext cx="6628859" cy="1446550"/>
          </a:xfrm>
          <a:prstGeom prst="rect">
            <a:avLst/>
          </a:prstGeom>
          <a:noFill/>
        </p:spPr>
        <p:txBody>
          <a:bodyPr wrap="square" rtlCol="0">
            <a:spAutoFit/>
          </a:bodyPr>
          <a:lstStyle/>
          <a:p>
            <a:r>
              <a:rPr lang="en-US" sz="1400" b="1">
                <a:latin typeface="Times New Roman" panose="02020603050405020304" pitchFamily="18" charset="0"/>
                <a:cs typeface="Times New Roman" panose="02020603050405020304" pitchFamily="18" charset="0"/>
              </a:rPr>
              <a:t>Supplementary Figure S9. UMAP plot showing expression of most exclusively expressed genes in Si induced cell cluster after Si treatment. (</a:t>
            </a:r>
            <a:r>
              <a:rPr lang="en-US" sz="1200" b="1">
                <a:latin typeface="Times New Roman" panose="02020603050405020304" pitchFamily="18" charset="0"/>
                <a:cs typeface="Times New Roman" panose="02020603050405020304" pitchFamily="18" charset="0"/>
              </a:rPr>
              <a:t>A) </a:t>
            </a:r>
            <a:r>
              <a:rPr lang="en-US" sz="1200">
                <a:latin typeface="Times New Roman" panose="02020603050405020304" pitchFamily="18" charset="0"/>
                <a:cs typeface="Times New Roman" panose="02020603050405020304" pitchFamily="18" charset="0"/>
              </a:rPr>
              <a:t>Association plot illustrate most distinct genes expressed (genes with red dots and IDs) exclusively in Si-induced cell cluster upon Si treatment. Red color denotes most distinctly expressed genes in Si-indued cell cluster while blue color denotes less distinctly expressed genes. </a:t>
            </a:r>
            <a:r>
              <a:rPr lang="en-US" sz="1200" b="1">
                <a:latin typeface="Times New Roman" panose="02020603050405020304" pitchFamily="18" charset="0"/>
                <a:cs typeface="Times New Roman" panose="02020603050405020304" pitchFamily="18" charset="0"/>
              </a:rPr>
              <a:t>(B) </a:t>
            </a:r>
            <a:r>
              <a:rPr lang="en-US" sz="1200">
                <a:latin typeface="Times New Roman" panose="02020603050405020304" pitchFamily="18" charset="0"/>
                <a:cs typeface="Times New Roman" panose="02020603050405020304" pitchFamily="18" charset="0"/>
              </a:rPr>
              <a:t>UMAP plot exhibits close-up view of expression of most distinctly expressed genes in Si-induced cells. The color depicts relative gene expression (dark purple = higher expression, Green = medium expression, Yellow = lower expression). </a:t>
            </a:r>
            <a:endParaRPr lang="en-US" sz="1200" b="1">
              <a:latin typeface="Times New Roman" panose="02020603050405020304" pitchFamily="18" charset="0"/>
              <a:cs typeface="Times New Roman" panose="02020603050405020304" pitchFamily="18" charset="0"/>
            </a:endParaRPr>
          </a:p>
        </p:txBody>
      </p:sp>
      <p:pic>
        <p:nvPicPr>
          <p:cNvPr id="2" name="Picture 1" descr="A graph with blue and red dots&#10;&#10;Description automatically generated">
            <a:extLst>
              <a:ext uri="{FF2B5EF4-FFF2-40B4-BE49-F238E27FC236}">
                <a16:creationId xmlns:a16="http://schemas.microsoft.com/office/drawing/2014/main" id="{7C34630E-173E-7746-C548-3D3C58E2580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52001" y="171456"/>
            <a:ext cx="4273067" cy="3733794"/>
          </a:xfrm>
          <a:prstGeom prst="rect">
            <a:avLst/>
          </a:prstGeom>
        </p:spPr>
      </p:pic>
      <p:sp>
        <p:nvSpPr>
          <p:cNvPr id="4" name="TextBox 3">
            <a:extLst>
              <a:ext uri="{FF2B5EF4-FFF2-40B4-BE49-F238E27FC236}">
                <a16:creationId xmlns:a16="http://schemas.microsoft.com/office/drawing/2014/main" id="{7D593560-ACFB-F8C2-73F4-168A14781887}"/>
              </a:ext>
            </a:extLst>
          </p:cNvPr>
          <p:cNvSpPr txBox="1"/>
          <p:nvPr/>
        </p:nvSpPr>
        <p:spPr>
          <a:xfrm>
            <a:off x="446093" y="0"/>
            <a:ext cx="405114" cy="276999"/>
          </a:xfrm>
          <a:prstGeom prst="rect">
            <a:avLst/>
          </a:prstGeom>
          <a:noFill/>
        </p:spPr>
        <p:txBody>
          <a:bodyPr wrap="square">
            <a:spAutoFit/>
          </a:bodyPr>
          <a:lstStyle/>
          <a:p>
            <a:r>
              <a:rPr lang="en-US" sz="1200" b="1">
                <a:latin typeface="Helvetica" panose="020B0604020202020204" pitchFamily="34" charset="0"/>
                <a:cs typeface="Helvetica" panose="020B0604020202020204" pitchFamily="34" charset="0"/>
              </a:rPr>
              <a:t>A</a:t>
            </a:r>
          </a:p>
        </p:txBody>
      </p:sp>
      <p:sp>
        <p:nvSpPr>
          <p:cNvPr id="5" name="TextBox 4">
            <a:extLst>
              <a:ext uri="{FF2B5EF4-FFF2-40B4-BE49-F238E27FC236}">
                <a16:creationId xmlns:a16="http://schemas.microsoft.com/office/drawing/2014/main" id="{92375EEC-00F9-91C1-1612-0917D283BA86}"/>
              </a:ext>
            </a:extLst>
          </p:cNvPr>
          <p:cNvSpPr txBox="1"/>
          <p:nvPr/>
        </p:nvSpPr>
        <p:spPr>
          <a:xfrm>
            <a:off x="444352" y="3814995"/>
            <a:ext cx="405114" cy="276999"/>
          </a:xfrm>
          <a:prstGeom prst="rect">
            <a:avLst/>
          </a:prstGeom>
          <a:noFill/>
        </p:spPr>
        <p:txBody>
          <a:bodyPr wrap="square">
            <a:spAutoFit/>
          </a:bodyPr>
          <a:lstStyle/>
          <a:p>
            <a:r>
              <a:rPr lang="en-US" sz="1200" b="1">
                <a:latin typeface="Helvetica" panose="020B0604020202020204" pitchFamily="34" charset="0"/>
                <a:cs typeface="Helvetica" panose="020B0604020202020204" pitchFamily="34" charset="0"/>
              </a:rPr>
              <a:t>B</a:t>
            </a:r>
          </a:p>
        </p:txBody>
      </p:sp>
      <p:grpSp>
        <p:nvGrpSpPr>
          <p:cNvPr id="22" name="Group 21">
            <a:extLst>
              <a:ext uri="{FF2B5EF4-FFF2-40B4-BE49-F238E27FC236}">
                <a16:creationId xmlns:a16="http://schemas.microsoft.com/office/drawing/2014/main" id="{6A30AD5B-F433-E2B2-1C77-6D871F50F4D0}"/>
              </a:ext>
            </a:extLst>
          </p:cNvPr>
          <p:cNvGrpSpPr/>
          <p:nvPr/>
        </p:nvGrpSpPr>
        <p:grpSpPr>
          <a:xfrm>
            <a:off x="849466" y="4012422"/>
            <a:ext cx="4922520" cy="4091940"/>
            <a:chOff x="1135380" y="5436523"/>
            <a:chExt cx="4922520" cy="4091940"/>
          </a:xfrm>
        </p:grpSpPr>
        <p:grpSp>
          <p:nvGrpSpPr>
            <p:cNvPr id="18" name="Group 17">
              <a:extLst>
                <a:ext uri="{FF2B5EF4-FFF2-40B4-BE49-F238E27FC236}">
                  <a16:creationId xmlns:a16="http://schemas.microsoft.com/office/drawing/2014/main" id="{EDB99B2A-34CA-9256-80DC-95B9C70BF965}"/>
                </a:ext>
              </a:extLst>
            </p:cNvPr>
            <p:cNvGrpSpPr/>
            <p:nvPr/>
          </p:nvGrpSpPr>
          <p:grpSpPr>
            <a:xfrm>
              <a:off x="1135380" y="5436523"/>
              <a:ext cx="4922520" cy="4091940"/>
              <a:chOff x="739140" y="1173480"/>
              <a:chExt cx="5257800" cy="4381500"/>
            </a:xfrm>
          </p:grpSpPr>
          <p:pic>
            <p:nvPicPr>
              <p:cNvPr id="3" name="Picture 2" descr="A group of images of numbers and letters&#10;&#10;Description automatically generated with medium confidence">
                <a:extLst>
                  <a:ext uri="{FF2B5EF4-FFF2-40B4-BE49-F238E27FC236}">
                    <a16:creationId xmlns:a16="http://schemas.microsoft.com/office/drawing/2014/main" id="{07755697-DC8E-4A18-1945-E47E8FBBC2F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9140" y="1173480"/>
                <a:ext cx="5257800" cy="4381500"/>
              </a:xfrm>
              <a:prstGeom prst="rect">
                <a:avLst/>
              </a:prstGeom>
            </p:spPr>
          </p:pic>
          <p:pic>
            <p:nvPicPr>
              <p:cNvPr id="15" name="Picture 14" descr="A map with numbers and a number on it&#10;&#10;Description automatically generated">
                <a:extLst>
                  <a:ext uri="{FF2B5EF4-FFF2-40B4-BE49-F238E27FC236}">
                    <a16:creationId xmlns:a16="http://schemas.microsoft.com/office/drawing/2014/main" id="{BF1C54FC-3637-A172-3B73-2C58D5331B6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39140" y="4107180"/>
                <a:ext cx="1767840" cy="1447800"/>
              </a:xfrm>
              <a:prstGeom prst="rect">
                <a:avLst/>
              </a:prstGeom>
            </p:spPr>
          </p:pic>
          <p:pic>
            <p:nvPicPr>
              <p:cNvPr id="17" name="Picture 16" descr="A map with numbers and a chart&#10;&#10;Description automatically generated">
                <a:extLst>
                  <a:ext uri="{FF2B5EF4-FFF2-40B4-BE49-F238E27FC236}">
                    <a16:creationId xmlns:a16="http://schemas.microsoft.com/office/drawing/2014/main" id="{143D57FF-D45A-B688-64E5-25D65526FCA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258492" y="4092566"/>
                <a:ext cx="1738448" cy="1462414"/>
              </a:xfrm>
              <a:prstGeom prst="rect">
                <a:avLst/>
              </a:prstGeom>
            </p:spPr>
          </p:pic>
        </p:grpSp>
        <p:sp>
          <p:nvSpPr>
            <p:cNvPr id="9" name="TextBox 8">
              <a:extLst>
                <a:ext uri="{FF2B5EF4-FFF2-40B4-BE49-F238E27FC236}">
                  <a16:creationId xmlns:a16="http://schemas.microsoft.com/office/drawing/2014/main" id="{57F3A884-8AEB-07EE-192A-2B1D2FBE1D10}"/>
                </a:ext>
              </a:extLst>
            </p:cNvPr>
            <p:cNvSpPr txBox="1"/>
            <p:nvPr/>
          </p:nvSpPr>
          <p:spPr>
            <a:xfrm>
              <a:off x="4641666" y="8308889"/>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AAE1</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6" name="TextBox 5">
              <a:extLst>
                <a:ext uri="{FF2B5EF4-FFF2-40B4-BE49-F238E27FC236}">
                  <a16:creationId xmlns:a16="http://schemas.microsoft.com/office/drawing/2014/main" id="{38BCA4B3-CB6B-DD90-0EA4-30EFC0AE81FF}"/>
                </a:ext>
              </a:extLst>
            </p:cNvPr>
            <p:cNvSpPr txBox="1"/>
            <p:nvPr/>
          </p:nvSpPr>
          <p:spPr>
            <a:xfrm>
              <a:off x="1370322" y="5576795"/>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LRR1</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10" name="TextBox 9">
              <a:extLst>
                <a:ext uri="{FF2B5EF4-FFF2-40B4-BE49-F238E27FC236}">
                  <a16:creationId xmlns:a16="http://schemas.microsoft.com/office/drawing/2014/main" id="{28792D60-7662-2731-A4C5-8568EB29E094}"/>
                </a:ext>
              </a:extLst>
            </p:cNvPr>
            <p:cNvSpPr txBox="1"/>
            <p:nvPr/>
          </p:nvSpPr>
          <p:spPr>
            <a:xfrm>
              <a:off x="2983230" y="5576795"/>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PKD1</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11" name="TextBox 10">
              <a:extLst>
                <a:ext uri="{FF2B5EF4-FFF2-40B4-BE49-F238E27FC236}">
                  <a16:creationId xmlns:a16="http://schemas.microsoft.com/office/drawing/2014/main" id="{6EB80DB2-23D9-81C0-2F0E-0358E0D1534D}"/>
                </a:ext>
              </a:extLst>
            </p:cNvPr>
            <p:cNvSpPr txBox="1"/>
            <p:nvPr/>
          </p:nvSpPr>
          <p:spPr>
            <a:xfrm>
              <a:off x="4596138" y="5576795"/>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a:t>
              </a:r>
              <a:r>
                <a:rPr lang="en-US" sz="900" b="1" i="1">
                  <a:latin typeface="Helvetica" panose="020B0604020202020204" pitchFamily="34" charset="0"/>
                  <a:cs typeface="Helvetica" panose="020B0604020202020204" pitchFamily="34" charset="0"/>
                </a:rPr>
                <a:t>PRK5</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14" name="TextBox 13">
              <a:extLst>
                <a:ext uri="{FF2B5EF4-FFF2-40B4-BE49-F238E27FC236}">
                  <a16:creationId xmlns:a16="http://schemas.microsoft.com/office/drawing/2014/main" id="{F045C686-C040-49CF-69B0-19B5E2D886FA}"/>
                </a:ext>
              </a:extLst>
            </p:cNvPr>
            <p:cNvSpPr txBox="1"/>
            <p:nvPr/>
          </p:nvSpPr>
          <p:spPr>
            <a:xfrm>
              <a:off x="1324794" y="6943121"/>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RHS16</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16" name="TextBox 15">
              <a:extLst>
                <a:ext uri="{FF2B5EF4-FFF2-40B4-BE49-F238E27FC236}">
                  <a16:creationId xmlns:a16="http://schemas.microsoft.com/office/drawing/2014/main" id="{629E4D14-D7DF-6A89-9284-BAEB693D6150}"/>
                </a:ext>
              </a:extLst>
            </p:cNvPr>
            <p:cNvSpPr txBox="1"/>
            <p:nvPr/>
          </p:nvSpPr>
          <p:spPr>
            <a:xfrm>
              <a:off x="2983229" y="6946235"/>
              <a:ext cx="952959"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PBP1B</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19" name="TextBox 18">
              <a:extLst>
                <a:ext uri="{FF2B5EF4-FFF2-40B4-BE49-F238E27FC236}">
                  <a16:creationId xmlns:a16="http://schemas.microsoft.com/office/drawing/2014/main" id="{D7E33E8B-BAE4-1EB3-213B-50151E3A697A}"/>
                </a:ext>
              </a:extLst>
            </p:cNvPr>
            <p:cNvSpPr txBox="1"/>
            <p:nvPr/>
          </p:nvSpPr>
          <p:spPr>
            <a:xfrm>
              <a:off x="4680669" y="6943121"/>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L60RF1</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20" name="TextBox 19">
              <a:extLst>
                <a:ext uri="{FF2B5EF4-FFF2-40B4-BE49-F238E27FC236}">
                  <a16:creationId xmlns:a16="http://schemas.microsoft.com/office/drawing/2014/main" id="{C9124F61-60B2-8DDB-D73F-C6CF7B041092}"/>
                </a:ext>
              </a:extLst>
            </p:cNvPr>
            <p:cNvSpPr txBox="1"/>
            <p:nvPr/>
          </p:nvSpPr>
          <p:spPr>
            <a:xfrm>
              <a:off x="1340034" y="8301083"/>
              <a:ext cx="1195161"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RPS3/RPM1</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sp>
          <p:nvSpPr>
            <p:cNvPr id="21" name="TextBox 20">
              <a:extLst>
                <a:ext uri="{FF2B5EF4-FFF2-40B4-BE49-F238E27FC236}">
                  <a16:creationId xmlns:a16="http://schemas.microsoft.com/office/drawing/2014/main" id="{D7934C8E-9AE4-D638-462C-FF718F6DEBA7}"/>
                </a:ext>
              </a:extLst>
            </p:cNvPr>
            <p:cNvSpPr txBox="1"/>
            <p:nvPr/>
          </p:nvSpPr>
          <p:spPr>
            <a:xfrm>
              <a:off x="3044649" y="8339183"/>
              <a:ext cx="891540" cy="230832"/>
            </a:xfrm>
            <a:prstGeom prst="rect">
              <a:avLst/>
            </a:prstGeom>
            <a:noFill/>
          </p:spPr>
          <p:txBody>
            <a:bodyPr wrap="square">
              <a:spAutoFit/>
            </a:bodyPr>
            <a:lstStyle/>
            <a:p>
              <a:pPr algn="ctr"/>
              <a:r>
                <a:rPr lang="en-US" sz="900" b="1" i="0" u="none" strike="noStrike">
                  <a:effectLst/>
                  <a:latin typeface="Helvetica" panose="020B0604020202020204" pitchFamily="34" charset="0"/>
                  <a:cs typeface="Helvetica" panose="020B0604020202020204" pitchFamily="34" charset="0"/>
                </a:rPr>
                <a:t>(</a:t>
              </a:r>
              <a:r>
                <a:rPr lang="en-US" sz="900" b="1" i="1" u="none" strike="noStrike">
                  <a:effectLst/>
                  <a:latin typeface="Helvetica" panose="020B0604020202020204" pitchFamily="34" charset="0"/>
                  <a:cs typeface="Helvetica" panose="020B0604020202020204" pitchFamily="34" charset="0"/>
                </a:rPr>
                <a:t>GmLRR2</a:t>
              </a:r>
              <a:r>
                <a:rPr lang="en-US" sz="900" b="1" i="0" u="none" strike="noStrike">
                  <a:effectLst/>
                  <a:latin typeface="Helvetica" panose="020B0604020202020204" pitchFamily="34" charset="0"/>
                  <a:cs typeface="Helvetica" panose="020B0604020202020204" pitchFamily="34" charset="0"/>
                </a:rPr>
                <a:t>)</a:t>
              </a:r>
              <a:r>
                <a:rPr lang="en-US" sz="900" b="1">
                  <a:latin typeface="Helvetica" panose="020B0604020202020204" pitchFamily="34" charset="0"/>
                  <a:cs typeface="Helvetica" panose="020B0604020202020204" pitchFamily="34" charset="0"/>
                </a:rPr>
                <a:t> </a:t>
              </a:r>
            </a:p>
          </p:txBody>
        </p:sp>
      </p:grpSp>
    </p:spTree>
    <p:extLst>
      <p:ext uri="{BB962C8B-B14F-4D97-AF65-F5344CB8AC3E}">
        <p14:creationId xmlns:p14="http://schemas.microsoft.com/office/powerpoint/2010/main" val="79484375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0</TotalTime>
  <Words>840</Words>
  <Application>Microsoft Office PowerPoint</Application>
  <PresentationFormat>A4 Paper (210x297 mm)</PresentationFormat>
  <Paragraphs>143</Paragraphs>
  <Slides>10</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0</vt:i4>
      </vt:variant>
    </vt:vector>
  </HeadingPairs>
  <TitlesOfParts>
    <vt:vector size="16" baseType="lpstr">
      <vt:lpstr>Arial</vt:lpstr>
      <vt:lpstr>Calibri</vt:lpstr>
      <vt:lpstr>Calibri Light</vt:lpstr>
      <vt:lpstr>Helvetic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vkar, Vikas</dc:creator>
  <cp:lastModifiedBy>Devkar, Vikas</cp:lastModifiedBy>
  <cp:revision>1</cp:revision>
  <dcterms:created xsi:type="dcterms:W3CDTF">2023-09-29T20:36:35Z</dcterms:created>
  <dcterms:modified xsi:type="dcterms:W3CDTF">2024-04-01T18:56:31Z</dcterms:modified>
</cp:coreProperties>
</file>